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theme/theme2.xml" ContentType="application/vnd.openxmlformats-officedocument.theme+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3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13" r:id="rId1"/>
    <p:sldMasterId id="2147483738" r:id="rId2"/>
    <p:sldMasterId id="2147483751" r:id="rId3"/>
  </p:sldMasterIdLst>
  <p:notesMasterIdLst>
    <p:notesMasterId r:id="rId39"/>
  </p:notesMasterIdLst>
  <p:sldIdLst>
    <p:sldId id="256" r:id="rId4"/>
    <p:sldId id="317" r:id="rId5"/>
    <p:sldId id="329" r:id="rId6"/>
    <p:sldId id="330" r:id="rId7"/>
    <p:sldId id="334" r:id="rId8"/>
    <p:sldId id="331" r:id="rId9"/>
    <p:sldId id="337" r:id="rId10"/>
    <p:sldId id="338" r:id="rId11"/>
    <p:sldId id="333" r:id="rId12"/>
    <p:sldId id="339" r:id="rId13"/>
    <p:sldId id="343" r:id="rId14"/>
    <p:sldId id="275" r:id="rId15"/>
    <p:sldId id="274" r:id="rId16"/>
    <p:sldId id="311" r:id="rId17"/>
    <p:sldId id="312" r:id="rId18"/>
    <p:sldId id="313" r:id="rId19"/>
    <p:sldId id="314" r:id="rId20"/>
    <p:sldId id="316" r:id="rId21"/>
    <p:sldId id="259" r:id="rId22"/>
    <p:sldId id="260" r:id="rId23"/>
    <p:sldId id="261" r:id="rId24"/>
    <p:sldId id="262" r:id="rId25"/>
    <p:sldId id="263" r:id="rId26"/>
    <p:sldId id="264" r:id="rId27"/>
    <p:sldId id="265" r:id="rId28"/>
    <p:sldId id="266" r:id="rId29"/>
    <p:sldId id="267" r:id="rId30"/>
    <p:sldId id="268" r:id="rId31"/>
    <p:sldId id="269" r:id="rId32"/>
    <p:sldId id="270" r:id="rId33"/>
    <p:sldId id="271" r:id="rId34"/>
    <p:sldId id="272" r:id="rId35"/>
    <p:sldId id="273" r:id="rId36"/>
    <p:sldId id="345" r:id="rId37"/>
    <p:sldId id="327" r:id="rId3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DE296"/>
    <a:srgbClr val="5CD3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1348"/>
    <p:restoredTop sz="94790"/>
  </p:normalViewPr>
  <p:slideViewPr>
    <p:cSldViewPr snapToGrid="0">
      <p:cViewPr varScale="1">
        <p:scale>
          <a:sx n="93" d="100"/>
          <a:sy n="93" d="100"/>
        </p:scale>
        <p:origin x="216" y="45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notesMaster" Target="notesMasters/notesMaster1.xml"/><Relationship Id="rId21" Type="http://schemas.openxmlformats.org/officeDocument/2006/relationships/slide" Target="slides/slide18.xml"/><Relationship Id="rId34" Type="http://schemas.openxmlformats.org/officeDocument/2006/relationships/slide" Target="slides/slide31.xml"/><Relationship Id="rId42" Type="http://schemas.openxmlformats.org/officeDocument/2006/relationships/theme" Target="theme/theme1.xml"/><Relationship Id="rId7" Type="http://schemas.openxmlformats.org/officeDocument/2006/relationships/slide" Target="slides/slide4.xml"/><Relationship Id="rId2" Type="http://schemas.openxmlformats.org/officeDocument/2006/relationships/slideMaster" Target="slideMasters/slideMaster2.xml"/><Relationship Id="rId16" Type="http://schemas.openxmlformats.org/officeDocument/2006/relationships/slide" Target="slides/slide13.xml"/><Relationship Id="rId20" Type="http://schemas.openxmlformats.org/officeDocument/2006/relationships/slide" Target="slides/slide17.xml"/><Relationship Id="rId29" Type="http://schemas.openxmlformats.org/officeDocument/2006/relationships/slide" Target="slides/slide26.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slide" Target="slides/slide34.xml"/><Relationship Id="rId40" Type="http://schemas.openxmlformats.org/officeDocument/2006/relationships/presProps" Target="presProp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slide" Target="slides/slide28.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 Id="rId43" Type="http://schemas.openxmlformats.org/officeDocument/2006/relationships/tableStyles" Target="tableStyles.xml"/><Relationship Id="rId8" Type="http://schemas.openxmlformats.org/officeDocument/2006/relationships/slide" Target="slides/slide5.xml"/><Relationship Id="rId3" Type="http://schemas.openxmlformats.org/officeDocument/2006/relationships/slideMaster" Target="slideMasters/slideMaster3.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slide" Target="slides/slide35.xml"/></Relationships>
</file>

<file path=ppt/diagrams/_rels/data1.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diagrams/_rels/data2.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diagrams/_rels/drawing1.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diagrams/_rels/drawing2.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svg"/><Relationship Id="rId1" Type="http://schemas.openxmlformats.org/officeDocument/2006/relationships/image" Target="../media/image1.png"/><Relationship Id="rId6" Type="http://schemas.openxmlformats.org/officeDocument/2006/relationships/image" Target="../media/image6.sv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B9791D9-E453-43DE-BEAA-7B0604E076A3}" type="doc">
      <dgm:prSet loTypeId="urn:microsoft.com/office/officeart/2018/2/layout/IconVerticalSolidList" loCatId="icon" qsTypeId="urn:microsoft.com/office/officeart/2005/8/quickstyle/simple1" qsCatId="simple" csTypeId="urn:microsoft.com/office/officeart/2005/8/colors/accent1_2" csCatId="accent1" phldr="1"/>
      <dgm:spPr/>
      <dgm:t>
        <a:bodyPr/>
        <a:lstStyle/>
        <a:p>
          <a:endParaRPr lang="en-US"/>
        </a:p>
      </dgm:t>
    </dgm:pt>
    <dgm:pt modelId="{17FF63A7-C289-414B-A3BD-F4340C07D604}">
      <dgm:prSet/>
      <dgm:spPr/>
      <dgm:t>
        <a:bodyPr/>
        <a:lstStyle/>
        <a:p>
          <a:pPr>
            <a:lnSpc>
              <a:spcPct val="100000"/>
            </a:lnSpc>
          </a:pPr>
          <a:r>
            <a:rPr lang="en-US"/>
            <a:t>Describe patient suffering through visual and narrative cues.</a:t>
          </a:r>
        </a:p>
      </dgm:t>
    </dgm:pt>
    <dgm:pt modelId="{60A4C878-84C6-45A2-90EA-1A6065FF9830}" type="parTrans" cxnId="{EFA4588E-F035-46A6-926E-E8901E7C078F}">
      <dgm:prSet/>
      <dgm:spPr/>
      <dgm:t>
        <a:bodyPr/>
        <a:lstStyle/>
        <a:p>
          <a:endParaRPr lang="en-US"/>
        </a:p>
      </dgm:t>
    </dgm:pt>
    <dgm:pt modelId="{683894EA-F214-4D99-8B86-B7383DDCEBB3}" type="sibTrans" cxnId="{EFA4588E-F035-46A6-926E-E8901E7C078F}">
      <dgm:prSet/>
      <dgm:spPr/>
      <dgm:t>
        <a:bodyPr/>
        <a:lstStyle/>
        <a:p>
          <a:endParaRPr lang="en-US"/>
        </a:p>
      </dgm:t>
    </dgm:pt>
    <dgm:pt modelId="{0F3FE2DD-861A-4E19-8096-4E1DC27FE111}">
      <dgm:prSet/>
      <dgm:spPr/>
      <dgm:t>
        <a:bodyPr/>
        <a:lstStyle/>
        <a:p>
          <a:pPr>
            <a:lnSpc>
              <a:spcPct val="100000"/>
            </a:lnSpc>
          </a:pPr>
          <a:r>
            <a:rPr lang="en-US"/>
            <a:t>Describe the biochemical basis and key clinical features of disease presented in the case scenarios</a:t>
          </a:r>
        </a:p>
      </dgm:t>
    </dgm:pt>
    <dgm:pt modelId="{E3CDFCAE-082E-4EC6-809C-A579C266C626}" type="parTrans" cxnId="{7FE0A4C0-224C-44CB-BEE5-06878421AEE4}">
      <dgm:prSet/>
      <dgm:spPr/>
      <dgm:t>
        <a:bodyPr/>
        <a:lstStyle/>
        <a:p>
          <a:endParaRPr lang="en-US"/>
        </a:p>
      </dgm:t>
    </dgm:pt>
    <dgm:pt modelId="{2BE36299-C2C6-4AE1-AC02-C8204D364284}" type="sibTrans" cxnId="{7FE0A4C0-224C-44CB-BEE5-06878421AEE4}">
      <dgm:prSet/>
      <dgm:spPr/>
      <dgm:t>
        <a:bodyPr/>
        <a:lstStyle/>
        <a:p>
          <a:endParaRPr lang="en-US"/>
        </a:p>
      </dgm:t>
    </dgm:pt>
    <dgm:pt modelId="{5029F0B0-8538-41C4-B7A8-86C3BE92ADC3}">
      <dgm:prSet/>
      <dgm:spPr/>
      <dgm:t>
        <a:bodyPr/>
        <a:lstStyle/>
        <a:p>
          <a:pPr>
            <a:lnSpc>
              <a:spcPct val="100000"/>
            </a:lnSpc>
          </a:pPr>
          <a:r>
            <a:rPr lang="en-US" dirty="0"/>
            <a:t>Use Visual Thinking Strategies (VTS) and structured peer roleplays to reflect on patient and caregiver perspectives on illness and suffering.</a:t>
          </a:r>
        </a:p>
      </dgm:t>
    </dgm:pt>
    <dgm:pt modelId="{8540E76E-EF52-46BB-B02A-5BB58AC37CD0}" type="parTrans" cxnId="{9CF21B20-6A47-4E1D-8735-A3B8C1689776}">
      <dgm:prSet/>
      <dgm:spPr/>
      <dgm:t>
        <a:bodyPr/>
        <a:lstStyle/>
        <a:p>
          <a:endParaRPr lang="en-US"/>
        </a:p>
      </dgm:t>
    </dgm:pt>
    <dgm:pt modelId="{CA102907-63F4-4223-B176-D6FDA880CF5B}" type="sibTrans" cxnId="{9CF21B20-6A47-4E1D-8735-A3B8C1689776}">
      <dgm:prSet/>
      <dgm:spPr/>
      <dgm:t>
        <a:bodyPr/>
        <a:lstStyle/>
        <a:p>
          <a:endParaRPr lang="en-US"/>
        </a:p>
      </dgm:t>
    </dgm:pt>
    <dgm:pt modelId="{F50607A5-265D-41DF-A5A9-91C8788D0858}">
      <dgm:prSet/>
      <dgm:spPr/>
      <dgm:t>
        <a:bodyPr/>
        <a:lstStyle/>
        <a:p>
          <a:pPr>
            <a:lnSpc>
              <a:spcPct val="100000"/>
            </a:lnSpc>
          </a:pPr>
          <a:r>
            <a:rPr lang="en-US" dirty="0"/>
            <a:t>Demonstrate empathetic communication, ethical reasoning, and collaborative clinical decision-making in the context of a biochemical disorder through a structured peer roleplay and guided reflection</a:t>
          </a:r>
        </a:p>
      </dgm:t>
    </dgm:pt>
    <dgm:pt modelId="{746E0E22-8629-4F67-A92F-F63FC55E9FA2}" type="parTrans" cxnId="{1D695921-2568-4ABD-8EE4-7E485AD73988}">
      <dgm:prSet/>
      <dgm:spPr/>
      <dgm:t>
        <a:bodyPr/>
        <a:lstStyle/>
        <a:p>
          <a:endParaRPr lang="en-US"/>
        </a:p>
      </dgm:t>
    </dgm:pt>
    <dgm:pt modelId="{242EA691-D07D-49E0-B16A-E74363E87851}" type="sibTrans" cxnId="{1D695921-2568-4ABD-8EE4-7E485AD73988}">
      <dgm:prSet/>
      <dgm:spPr/>
      <dgm:t>
        <a:bodyPr/>
        <a:lstStyle/>
        <a:p>
          <a:endParaRPr lang="en-US"/>
        </a:p>
      </dgm:t>
    </dgm:pt>
    <dgm:pt modelId="{2991BE90-7330-4ACE-A3A4-5F134781D542}">
      <dgm:prSet/>
      <dgm:spPr/>
      <dgm:t>
        <a:bodyPr/>
        <a:lstStyle/>
        <a:p>
          <a:pPr>
            <a:lnSpc>
              <a:spcPct val="100000"/>
            </a:lnSpc>
          </a:pPr>
          <a:r>
            <a:rPr lang="en-US"/>
            <a:t>Reflect on emotions, communication, and the meaning of suffering using a structured reflection format. </a:t>
          </a:r>
        </a:p>
      </dgm:t>
    </dgm:pt>
    <dgm:pt modelId="{D94BA60C-925A-42FA-9F48-CE1BEFAA4025}" type="parTrans" cxnId="{DB79208D-750D-4A0F-A7F0-A2A8FEAC13C3}">
      <dgm:prSet/>
      <dgm:spPr/>
      <dgm:t>
        <a:bodyPr/>
        <a:lstStyle/>
        <a:p>
          <a:endParaRPr lang="en-US"/>
        </a:p>
      </dgm:t>
    </dgm:pt>
    <dgm:pt modelId="{1CB7AA49-EE1A-4A77-BBB2-CB87F95B73A6}" type="sibTrans" cxnId="{DB79208D-750D-4A0F-A7F0-A2A8FEAC13C3}">
      <dgm:prSet/>
      <dgm:spPr/>
      <dgm:t>
        <a:bodyPr/>
        <a:lstStyle/>
        <a:p>
          <a:endParaRPr lang="en-US"/>
        </a:p>
      </dgm:t>
    </dgm:pt>
    <dgm:pt modelId="{80D42DA2-098A-42EE-BC11-47413DAE2874}" type="pres">
      <dgm:prSet presAssocID="{6B9791D9-E453-43DE-BEAA-7B0604E076A3}" presName="root" presStyleCnt="0">
        <dgm:presLayoutVars>
          <dgm:dir/>
          <dgm:resizeHandles val="exact"/>
        </dgm:presLayoutVars>
      </dgm:prSet>
      <dgm:spPr/>
    </dgm:pt>
    <dgm:pt modelId="{A8CB0DF1-F655-4863-910F-3238C1984716}" type="pres">
      <dgm:prSet presAssocID="{17FF63A7-C289-414B-A3BD-F4340C07D604}" presName="compNode" presStyleCnt="0"/>
      <dgm:spPr/>
    </dgm:pt>
    <dgm:pt modelId="{9B32EDF4-5FCF-4C51-B417-0B5FA52C81D0}" type="pres">
      <dgm:prSet presAssocID="{17FF63A7-C289-414B-A3BD-F4340C07D604}" presName="bgRect" presStyleLbl="bgShp" presStyleIdx="0" presStyleCnt="5"/>
      <dgm:spPr/>
    </dgm:pt>
    <dgm:pt modelId="{A867542F-99C7-496F-B62A-4AD7E730836B}" type="pres">
      <dgm:prSet presAssocID="{17FF63A7-C289-414B-A3BD-F4340C07D604}" presName="iconRect" presStyleLbl="node1" presStyleIdx="0" presStyleCnt="5"/>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dgm:spPr>
      <dgm:extLst>
        <a:ext uri="{E40237B7-FDA0-4F09-8148-C483321AD2D9}">
          <dgm14:cNvPr xmlns:dgm14="http://schemas.microsoft.com/office/drawing/2010/diagram" id="0" name="" descr="Eye"/>
        </a:ext>
      </dgm:extLst>
    </dgm:pt>
    <dgm:pt modelId="{EA66AD35-A189-491D-9F73-AB3F3EDC87E3}" type="pres">
      <dgm:prSet presAssocID="{17FF63A7-C289-414B-A3BD-F4340C07D604}" presName="spaceRect" presStyleCnt="0"/>
      <dgm:spPr/>
    </dgm:pt>
    <dgm:pt modelId="{F468B0E3-DA4C-4C37-991D-37E58AC5D03D}" type="pres">
      <dgm:prSet presAssocID="{17FF63A7-C289-414B-A3BD-F4340C07D604}" presName="parTx" presStyleLbl="revTx" presStyleIdx="0" presStyleCnt="5">
        <dgm:presLayoutVars>
          <dgm:chMax val="0"/>
          <dgm:chPref val="0"/>
        </dgm:presLayoutVars>
      </dgm:prSet>
      <dgm:spPr/>
    </dgm:pt>
    <dgm:pt modelId="{936EF26F-EAEC-4504-818F-705CE6B1A4A2}" type="pres">
      <dgm:prSet presAssocID="{683894EA-F214-4D99-8B86-B7383DDCEBB3}" presName="sibTrans" presStyleCnt="0"/>
      <dgm:spPr/>
    </dgm:pt>
    <dgm:pt modelId="{4510A288-8B18-43A8-B5BC-18C8057B5259}" type="pres">
      <dgm:prSet presAssocID="{0F3FE2DD-861A-4E19-8096-4E1DC27FE111}" presName="compNode" presStyleCnt="0"/>
      <dgm:spPr/>
    </dgm:pt>
    <dgm:pt modelId="{F248EDA1-054C-4499-B820-0B2D01DE1EE0}" type="pres">
      <dgm:prSet presAssocID="{0F3FE2DD-861A-4E19-8096-4E1DC27FE111}" presName="bgRect" presStyleLbl="bgShp" presStyleIdx="1" presStyleCnt="5"/>
      <dgm:spPr/>
    </dgm:pt>
    <dgm:pt modelId="{6104EBC7-22A0-413A-AA1A-2AF95D9EA014}" type="pres">
      <dgm:prSet presAssocID="{0F3FE2DD-861A-4E19-8096-4E1DC27FE111}" presName="iconRect" presStyleLbl="node1" presStyleIdx="1" presStyleCnt="5"/>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dgm:spPr>
      <dgm:extLst>
        <a:ext uri="{E40237B7-FDA0-4F09-8148-C483321AD2D9}">
          <dgm14:cNvPr xmlns:dgm14="http://schemas.microsoft.com/office/drawing/2010/diagram" id="0" name="" descr="Microscope"/>
        </a:ext>
      </dgm:extLst>
    </dgm:pt>
    <dgm:pt modelId="{C30FE4FB-3889-49E3-9CE5-2B97117296BF}" type="pres">
      <dgm:prSet presAssocID="{0F3FE2DD-861A-4E19-8096-4E1DC27FE111}" presName="spaceRect" presStyleCnt="0"/>
      <dgm:spPr/>
    </dgm:pt>
    <dgm:pt modelId="{8478D245-EE27-4966-8C66-3C9E1C97D7C2}" type="pres">
      <dgm:prSet presAssocID="{0F3FE2DD-861A-4E19-8096-4E1DC27FE111}" presName="parTx" presStyleLbl="revTx" presStyleIdx="1" presStyleCnt="5">
        <dgm:presLayoutVars>
          <dgm:chMax val="0"/>
          <dgm:chPref val="0"/>
        </dgm:presLayoutVars>
      </dgm:prSet>
      <dgm:spPr/>
    </dgm:pt>
    <dgm:pt modelId="{6911BF12-CA3E-4D7C-9F21-76D6E672EB5A}" type="pres">
      <dgm:prSet presAssocID="{2BE36299-C2C6-4AE1-AC02-C8204D364284}" presName="sibTrans" presStyleCnt="0"/>
      <dgm:spPr/>
    </dgm:pt>
    <dgm:pt modelId="{6B00B353-B41C-4F48-8231-EAF721204F21}" type="pres">
      <dgm:prSet presAssocID="{5029F0B0-8538-41C4-B7A8-86C3BE92ADC3}" presName="compNode" presStyleCnt="0"/>
      <dgm:spPr/>
    </dgm:pt>
    <dgm:pt modelId="{8ECD9F6A-E223-44FF-A706-13495A718931}" type="pres">
      <dgm:prSet presAssocID="{5029F0B0-8538-41C4-B7A8-86C3BE92ADC3}" presName="bgRect" presStyleLbl="bgShp" presStyleIdx="2" presStyleCnt="5"/>
      <dgm:spPr/>
    </dgm:pt>
    <dgm:pt modelId="{A4258B48-B7A2-415B-9D78-90A4FE2D10FD}" type="pres">
      <dgm:prSet presAssocID="{5029F0B0-8538-41C4-B7A8-86C3BE92ADC3}" presName="iconRect" presStyleLbl="node1" presStyleIdx="2" presStyleCnt="5"/>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dgm:spPr>
      <dgm:extLst>
        <a:ext uri="{E40237B7-FDA0-4F09-8148-C483321AD2D9}">
          <dgm14:cNvPr xmlns:dgm14="http://schemas.microsoft.com/office/drawing/2010/diagram" id="0" name="" descr="Hospital"/>
        </a:ext>
      </dgm:extLst>
    </dgm:pt>
    <dgm:pt modelId="{75BB3ACF-4B90-46EE-ABF7-2C41BFA0C81E}" type="pres">
      <dgm:prSet presAssocID="{5029F0B0-8538-41C4-B7A8-86C3BE92ADC3}" presName="spaceRect" presStyleCnt="0"/>
      <dgm:spPr/>
    </dgm:pt>
    <dgm:pt modelId="{061F49E9-9CB5-459C-BBF9-B3E7AD9F77D6}" type="pres">
      <dgm:prSet presAssocID="{5029F0B0-8538-41C4-B7A8-86C3BE92ADC3}" presName="parTx" presStyleLbl="revTx" presStyleIdx="2" presStyleCnt="5">
        <dgm:presLayoutVars>
          <dgm:chMax val="0"/>
          <dgm:chPref val="0"/>
        </dgm:presLayoutVars>
      </dgm:prSet>
      <dgm:spPr/>
    </dgm:pt>
    <dgm:pt modelId="{AA2E382A-1EC2-4E04-986C-0FF9C45A80D1}" type="pres">
      <dgm:prSet presAssocID="{CA102907-63F4-4223-B176-D6FDA880CF5B}" presName="sibTrans" presStyleCnt="0"/>
      <dgm:spPr/>
    </dgm:pt>
    <dgm:pt modelId="{66158313-EC02-4287-9E85-9494D2F6AC1D}" type="pres">
      <dgm:prSet presAssocID="{F50607A5-265D-41DF-A5A9-91C8788D0858}" presName="compNode" presStyleCnt="0"/>
      <dgm:spPr/>
    </dgm:pt>
    <dgm:pt modelId="{E8791A35-BA0D-4615-804C-5D602B43D1FD}" type="pres">
      <dgm:prSet presAssocID="{F50607A5-265D-41DF-A5A9-91C8788D0858}" presName="bgRect" presStyleLbl="bgShp" presStyleIdx="3" presStyleCnt="5"/>
      <dgm:spPr/>
    </dgm:pt>
    <dgm:pt modelId="{9CE926B3-8022-44B6-958B-16B76ED5140F}" type="pres">
      <dgm:prSet presAssocID="{F50607A5-265D-41DF-A5A9-91C8788D0858}" presName="iconRect" presStyleLbl="node1" presStyleIdx="3" presStyleCnt="5"/>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dgm:spPr>
      <dgm:extLst>
        <a:ext uri="{E40237B7-FDA0-4F09-8148-C483321AD2D9}">
          <dgm14:cNvPr xmlns:dgm14="http://schemas.microsoft.com/office/drawing/2010/diagram" id="0" name="" descr="Head with Gears"/>
        </a:ext>
      </dgm:extLst>
    </dgm:pt>
    <dgm:pt modelId="{4B50368A-100F-4410-9989-902F372EFA09}" type="pres">
      <dgm:prSet presAssocID="{F50607A5-265D-41DF-A5A9-91C8788D0858}" presName="spaceRect" presStyleCnt="0"/>
      <dgm:spPr/>
    </dgm:pt>
    <dgm:pt modelId="{8046A353-E5B6-409E-9CA5-D60D43A978F0}" type="pres">
      <dgm:prSet presAssocID="{F50607A5-265D-41DF-A5A9-91C8788D0858}" presName="parTx" presStyleLbl="revTx" presStyleIdx="3" presStyleCnt="5">
        <dgm:presLayoutVars>
          <dgm:chMax val="0"/>
          <dgm:chPref val="0"/>
        </dgm:presLayoutVars>
      </dgm:prSet>
      <dgm:spPr/>
    </dgm:pt>
    <dgm:pt modelId="{726F8E08-CD3C-4ED3-8FD4-E8A0EB62F19F}" type="pres">
      <dgm:prSet presAssocID="{242EA691-D07D-49E0-B16A-E74363E87851}" presName="sibTrans" presStyleCnt="0"/>
      <dgm:spPr/>
    </dgm:pt>
    <dgm:pt modelId="{7C49F249-F0D4-4BED-8508-E8C7C1DD937C}" type="pres">
      <dgm:prSet presAssocID="{2991BE90-7330-4ACE-A3A4-5F134781D542}" presName="compNode" presStyleCnt="0"/>
      <dgm:spPr/>
    </dgm:pt>
    <dgm:pt modelId="{5FABE087-36D9-4A98-BB89-38215F3A9867}" type="pres">
      <dgm:prSet presAssocID="{2991BE90-7330-4ACE-A3A4-5F134781D542}" presName="bgRect" presStyleLbl="bgShp" presStyleIdx="4" presStyleCnt="5"/>
      <dgm:spPr/>
    </dgm:pt>
    <dgm:pt modelId="{9920F5DB-B0FF-4886-A327-D5AAC8085054}" type="pres">
      <dgm:prSet presAssocID="{2991BE90-7330-4ACE-A3A4-5F134781D542}" presName="iconRect" presStyleLbl="node1" presStyleIdx="4" presStyleCnt="5"/>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dgm:spPr>
      <dgm:extLst>
        <a:ext uri="{E40237B7-FDA0-4F09-8148-C483321AD2D9}">
          <dgm14:cNvPr xmlns:dgm14="http://schemas.microsoft.com/office/drawing/2010/diagram" id="0" name="" descr="Person with Idea"/>
        </a:ext>
      </dgm:extLst>
    </dgm:pt>
    <dgm:pt modelId="{09F8FF25-5B7E-4056-AB5A-CB03D3B034EE}" type="pres">
      <dgm:prSet presAssocID="{2991BE90-7330-4ACE-A3A4-5F134781D542}" presName="spaceRect" presStyleCnt="0"/>
      <dgm:spPr/>
    </dgm:pt>
    <dgm:pt modelId="{C5DB7315-DC1F-481A-ACEF-1C4D779D5980}" type="pres">
      <dgm:prSet presAssocID="{2991BE90-7330-4ACE-A3A4-5F134781D542}" presName="parTx" presStyleLbl="revTx" presStyleIdx="4" presStyleCnt="5">
        <dgm:presLayoutVars>
          <dgm:chMax val="0"/>
          <dgm:chPref val="0"/>
        </dgm:presLayoutVars>
      </dgm:prSet>
      <dgm:spPr/>
    </dgm:pt>
  </dgm:ptLst>
  <dgm:cxnLst>
    <dgm:cxn modelId="{45C72008-2374-42C2-B8AF-5512571B1635}" type="presOf" srcId="{6B9791D9-E453-43DE-BEAA-7B0604E076A3}" destId="{80D42DA2-098A-42EE-BC11-47413DAE2874}" srcOrd="0" destOrd="0" presId="urn:microsoft.com/office/officeart/2018/2/layout/IconVerticalSolidList"/>
    <dgm:cxn modelId="{9CF21B20-6A47-4E1D-8735-A3B8C1689776}" srcId="{6B9791D9-E453-43DE-BEAA-7B0604E076A3}" destId="{5029F0B0-8538-41C4-B7A8-86C3BE92ADC3}" srcOrd="2" destOrd="0" parTransId="{8540E76E-EF52-46BB-B02A-5BB58AC37CD0}" sibTransId="{CA102907-63F4-4223-B176-D6FDA880CF5B}"/>
    <dgm:cxn modelId="{1D695921-2568-4ABD-8EE4-7E485AD73988}" srcId="{6B9791D9-E453-43DE-BEAA-7B0604E076A3}" destId="{F50607A5-265D-41DF-A5A9-91C8788D0858}" srcOrd="3" destOrd="0" parTransId="{746E0E22-8629-4F67-A92F-F63FC55E9FA2}" sibTransId="{242EA691-D07D-49E0-B16A-E74363E87851}"/>
    <dgm:cxn modelId="{AE411A3A-E66C-43AB-B74B-CF5E6EEFCAC0}" type="presOf" srcId="{0F3FE2DD-861A-4E19-8096-4E1DC27FE111}" destId="{8478D245-EE27-4966-8C66-3C9E1C97D7C2}" srcOrd="0" destOrd="0" presId="urn:microsoft.com/office/officeart/2018/2/layout/IconVerticalSolidList"/>
    <dgm:cxn modelId="{2534D763-2BA9-4CB4-846D-980ECBDF55AF}" type="presOf" srcId="{2991BE90-7330-4ACE-A3A4-5F134781D542}" destId="{C5DB7315-DC1F-481A-ACEF-1C4D779D5980}" srcOrd="0" destOrd="0" presId="urn:microsoft.com/office/officeart/2018/2/layout/IconVerticalSolidList"/>
    <dgm:cxn modelId="{DB79208D-750D-4A0F-A7F0-A2A8FEAC13C3}" srcId="{6B9791D9-E453-43DE-BEAA-7B0604E076A3}" destId="{2991BE90-7330-4ACE-A3A4-5F134781D542}" srcOrd="4" destOrd="0" parTransId="{D94BA60C-925A-42FA-9F48-CE1BEFAA4025}" sibTransId="{1CB7AA49-EE1A-4A77-BBB2-CB87F95B73A6}"/>
    <dgm:cxn modelId="{EFA4588E-F035-46A6-926E-E8901E7C078F}" srcId="{6B9791D9-E453-43DE-BEAA-7B0604E076A3}" destId="{17FF63A7-C289-414B-A3BD-F4340C07D604}" srcOrd="0" destOrd="0" parTransId="{60A4C878-84C6-45A2-90EA-1A6065FF9830}" sibTransId="{683894EA-F214-4D99-8B86-B7383DDCEBB3}"/>
    <dgm:cxn modelId="{2CC39899-89D6-49B4-8A47-19CA39F193FE}" type="presOf" srcId="{F50607A5-265D-41DF-A5A9-91C8788D0858}" destId="{8046A353-E5B6-409E-9CA5-D60D43A978F0}" srcOrd="0" destOrd="0" presId="urn:microsoft.com/office/officeart/2018/2/layout/IconVerticalSolidList"/>
    <dgm:cxn modelId="{F5B9749A-4B69-4CC4-AC89-152A1CEF972B}" type="presOf" srcId="{17FF63A7-C289-414B-A3BD-F4340C07D604}" destId="{F468B0E3-DA4C-4C37-991D-37E58AC5D03D}" srcOrd="0" destOrd="0" presId="urn:microsoft.com/office/officeart/2018/2/layout/IconVerticalSolidList"/>
    <dgm:cxn modelId="{609A75B4-2FD1-406A-9490-31168CC14924}" type="presOf" srcId="{5029F0B0-8538-41C4-B7A8-86C3BE92ADC3}" destId="{061F49E9-9CB5-459C-BBF9-B3E7AD9F77D6}" srcOrd="0" destOrd="0" presId="urn:microsoft.com/office/officeart/2018/2/layout/IconVerticalSolidList"/>
    <dgm:cxn modelId="{7FE0A4C0-224C-44CB-BEE5-06878421AEE4}" srcId="{6B9791D9-E453-43DE-BEAA-7B0604E076A3}" destId="{0F3FE2DD-861A-4E19-8096-4E1DC27FE111}" srcOrd="1" destOrd="0" parTransId="{E3CDFCAE-082E-4EC6-809C-A579C266C626}" sibTransId="{2BE36299-C2C6-4AE1-AC02-C8204D364284}"/>
    <dgm:cxn modelId="{6F7033A0-EB15-463E-9854-D8505C392D17}" type="presParOf" srcId="{80D42DA2-098A-42EE-BC11-47413DAE2874}" destId="{A8CB0DF1-F655-4863-910F-3238C1984716}" srcOrd="0" destOrd="0" presId="urn:microsoft.com/office/officeart/2018/2/layout/IconVerticalSolidList"/>
    <dgm:cxn modelId="{93ED861E-7960-4B3B-B4DE-F52BE65D022B}" type="presParOf" srcId="{A8CB0DF1-F655-4863-910F-3238C1984716}" destId="{9B32EDF4-5FCF-4C51-B417-0B5FA52C81D0}" srcOrd="0" destOrd="0" presId="urn:microsoft.com/office/officeart/2018/2/layout/IconVerticalSolidList"/>
    <dgm:cxn modelId="{7B47FB76-A5D6-4B65-A66A-6F5A8F96989E}" type="presParOf" srcId="{A8CB0DF1-F655-4863-910F-3238C1984716}" destId="{A867542F-99C7-496F-B62A-4AD7E730836B}" srcOrd="1" destOrd="0" presId="urn:microsoft.com/office/officeart/2018/2/layout/IconVerticalSolidList"/>
    <dgm:cxn modelId="{331E1251-1B00-4BF4-94C3-46C06F937F27}" type="presParOf" srcId="{A8CB0DF1-F655-4863-910F-3238C1984716}" destId="{EA66AD35-A189-491D-9F73-AB3F3EDC87E3}" srcOrd="2" destOrd="0" presId="urn:microsoft.com/office/officeart/2018/2/layout/IconVerticalSolidList"/>
    <dgm:cxn modelId="{3954E027-6080-4F97-8AC8-AC874A2AA370}" type="presParOf" srcId="{A8CB0DF1-F655-4863-910F-3238C1984716}" destId="{F468B0E3-DA4C-4C37-991D-37E58AC5D03D}" srcOrd="3" destOrd="0" presId="urn:microsoft.com/office/officeart/2018/2/layout/IconVerticalSolidList"/>
    <dgm:cxn modelId="{D443CC4C-79B2-4C1B-9FDE-7A6EA2413B59}" type="presParOf" srcId="{80D42DA2-098A-42EE-BC11-47413DAE2874}" destId="{936EF26F-EAEC-4504-818F-705CE6B1A4A2}" srcOrd="1" destOrd="0" presId="urn:microsoft.com/office/officeart/2018/2/layout/IconVerticalSolidList"/>
    <dgm:cxn modelId="{7704A2FB-44BC-4543-8F16-5AA4B24ADD2B}" type="presParOf" srcId="{80D42DA2-098A-42EE-BC11-47413DAE2874}" destId="{4510A288-8B18-43A8-B5BC-18C8057B5259}" srcOrd="2" destOrd="0" presId="urn:microsoft.com/office/officeart/2018/2/layout/IconVerticalSolidList"/>
    <dgm:cxn modelId="{B7833353-3359-4FA5-BA92-E3145D3D3B09}" type="presParOf" srcId="{4510A288-8B18-43A8-B5BC-18C8057B5259}" destId="{F248EDA1-054C-4499-B820-0B2D01DE1EE0}" srcOrd="0" destOrd="0" presId="urn:microsoft.com/office/officeart/2018/2/layout/IconVerticalSolidList"/>
    <dgm:cxn modelId="{C3FF4C2C-254E-4BDC-91BE-31FD365FE15D}" type="presParOf" srcId="{4510A288-8B18-43A8-B5BC-18C8057B5259}" destId="{6104EBC7-22A0-413A-AA1A-2AF95D9EA014}" srcOrd="1" destOrd="0" presId="urn:microsoft.com/office/officeart/2018/2/layout/IconVerticalSolidList"/>
    <dgm:cxn modelId="{C40436FC-5235-4968-AECF-0853D8C3D49B}" type="presParOf" srcId="{4510A288-8B18-43A8-B5BC-18C8057B5259}" destId="{C30FE4FB-3889-49E3-9CE5-2B97117296BF}" srcOrd="2" destOrd="0" presId="urn:microsoft.com/office/officeart/2018/2/layout/IconVerticalSolidList"/>
    <dgm:cxn modelId="{A3EDF83A-BFF2-455B-BA90-63988714173C}" type="presParOf" srcId="{4510A288-8B18-43A8-B5BC-18C8057B5259}" destId="{8478D245-EE27-4966-8C66-3C9E1C97D7C2}" srcOrd="3" destOrd="0" presId="urn:microsoft.com/office/officeart/2018/2/layout/IconVerticalSolidList"/>
    <dgm:cxn modelId="{7E7BC6C6-7049-4359-B729-A17338652BC1}" type="presParOf" srcId="{80D42DA2-098A-42EE-BC11-47413DAE2874}" destId="{6911BF12-CA3E-4D7C-9F21-76D6E672EB5A}" srcOrd="3" destOrd="0" presId="urn:microsoft.com/office/officeart/2018/2/layout/IconVerticalSolidList"/>
    <dgm:cxn modelId="{779D345F-EE4E-47BB-8DD1-B5039A7129F2}" type="presParOf" srcId="{80D42DA2-098A-42EE-BC11-47413DAE2874}" destId="{6B00B353-B41C-4F48-8231-EAF721204F21}" srcOrd="4" destOrd="0" presId="urn:microsoft.com/office/officeart/2018/2/layout/IconVerticalSolidList"/>
    <dgm:cxn modelId="{626C858A-541B-4B1A-8AAC-E7BB136AC986}" type="presParOf" srcId="{6B00B353-B41C-4F48-8231-EAF721204F21}" destId="{8ECD9F6A-E223-44FF-A706-13495A718931}" srcOrd="0" destOrd="0" presId="urn:microsoft.com/office/officeart/2018/2/layout/IconVerticalSolidList"/>
    <dgm:cxn modelId="{3B91EA99-D142-4BC7-B164-7A4407430196}" type="presParOf" srcId="{6B00B353-B41C-4F48-8231-EAF721204F21}" destId="{A4258B48-B7A2-415B-9D78-90A4FE2D10FD}" srcOrd="1" destOrd="0" presId="urn:microsoft.com/office/officeart/2018/2/layout/IconVerticalSolidList"/>
    <dgm:cxn modelId="{4358E4E6-88EA-462E-8CE9-68CBDF554D00}" type="presParOf" srcId="{6B00B353-B41C-4F48-8231-EAF721204F21}" destId="{75BB3ACF-4B90-46EE-ABF7-2C41BFA0C81E}" srcOrd="2" destOrd="0" presId="urn:microsoft.com/office/officeart/2018/2/layout/IconVerticalSolidList"/>
    <dgm:cxn modelId="{185EEE72-E68C-46BC-A725-255944C73E2F}" type="presParOf" srcId="{6B00B353-B41C-4F48-8231-EAF721204F21}" destId="{061F49E9-9CB5-459C-BBF9-B3E7AD9F77D6}" srcOrd="3" destOrd="0" presId="urn:microsoft.com/office/officeart/2018/2/layout/IconVerticalSolidList"/>
    <dgm:cxn modelId="{55D18BC3-7DDA-4FF8-B507-090CACD104A3}" type="presParOf" srcId="{80D42DA2-098A-42EE-BC11-47413DAE2874}" destId="{AA2E382A-1EC2-4E04-986C-0FF9C45A80D1}" srcOrd="5" destOrd="0" presId="urn:microsoft.com/office/officeart/2018/2/layout/IconVerticalSolidList"/>
    <dgm:cxn modelId="{D74491DF-819C-4B94-818B-62D468DFF053}" type="presParOf" srcId="{80D42DA2-098A-42EE-BC11-47413DAE2874}" destId="{66158313-EC02-4287-9E85-9494D2F6AC1D}" srcOrd="6" destOrd="0" presId="urn:microsoft.com/office/officeart/2018/2/layout/IconVerticalSolidList"/>
    <dgm:cxn modelId="{EEE98F02-08BA-4C29-95FE-52CA3DFC1282}" type="presParOf" srcId="{66158313-EC02-4287-9E85-9494D2F6AC1D}" destId="{E8791A35-BA0D-4615-804C-5D602B43D1FD}" srcOrd="0" destOrd="0" presId="urn:microsoft.com/office/officeart/2018/2/layout/IconVerticalSolidList"/>
    <dgm:cxn modelId="{4E99BBD9-7C72-4449-8D1A-95B9FCB6F7F0}" type="presParOf" srcId="{66158313-EC02-4287-9E85-9494D2F6AC1D}" destId="{9CE926B3-8022-44B6-958B-16B76ED5140F}" srcOrd="1" destOrd="0" presId="urn:microsoft.com/office/officeart/2018/2/layout/IconVerticalSolidList"/>
    <dgm:cxn modelId="{242622FD-B42E-4B08-98FF-5E9755A1D268}" type="presParOf" srcId="{66158313-EC02-4287-9E85-9494D2F6AC1D}" destId="{4B50368A-100F-4410-9989-902F372EFA09}" srcOrd="2" destOrd="0" presId="urn:microsoft.com/office/officeart/2018/2/layout/IconVerticalSolidList"/>
    <dgm:cxn modelId="{10C77FCE-CED5-4ECA-A340-22C893515ADC}" type="presParOf" srcId="{66158313-EC02-4287-9E85-9494D2F6AC1D}" destId="{8046A353-E5B6-409E-9CA5-D60D43A978F0}" srcOrd="3" destOrd="0" presId="urn:microsoft.com/office/officeart/2018/2/layout/IconVerticalSolidList"/>
    <dgm:cxn modelId="{D5EAA238-9326-45B8-8A9B-E573F21F0D21}" type="presParOf" srcId="{80D42DA2-098A-42EE-BC11-47413DAE2874}" destId="{726F8E08-CD3C-4ED3-8FD4-E8A0EB62F19F}" srcOrd="7" destOrd="0" presId="urn:microsoft.com/office/officeart/2018/2/layout/IconVerticalSolidList"/>
    <dgm:cxn modelId="{EDF02885-0453-4C86-A58B-34C974E2ECDF}" type="presParOf" srcId="{80D42DA2-098A-42EE-BC11-47413DAE2874}" destId="{7C49F249-F0D4-4BED-8508-E8C7C1DD937C}" srcOrd="8" destOrd="0" presId="urn:microsoft.com/office/officeart/2018/2/layout/IconVerticalSolidList"/>
    <dgm:cxn modelId="{FCE7B39E-FF11-4668-B955-296B27D5416D}" type="presParOf" srcId="{7C49F249-F0D4-4BED-8508-E8C7C1DD937C}" destId="{5FABE087-36D9-4A98-BB89-38215F3A9867}" srcOrd="0" destOrd="0" presId="urn:microsoft.com/office/officeart/2018/2/layout/IconVerticalSolidList"/>
    <dgm:cxn modelId="{F17CFCAB-D285-4E7F-B2BE-56C86DA7467B}" type="presParOf" srcId="{7C49F249-F0D4-4BED-8508-E8C7C1DD937C}" destId="{9920F5DB-B0FF-4886-A327-D5AAC8085054}" srcOrd="1" destOrd="0" presId="urn:microsoft.com/office/officeart/2018/2/layout/IconVerticalSolidList"/>
    <dgm:cxn modelId="{10A15378-154C-42CB-B661-92EE0118945F}" type="presParOf" srcId="{7C49F249-F0D4-4BED-8508-E8C7C1DD937C}" destId="{09F8FF25-5B7E-4056-AB5A-CB03D3B034EE}" srcOrd="2" destOrd="0" presId="urn:microsoft.com/office/officeart/2018/2/layout/IconVerticalSolidList"/>
    <dgm:cxn modelId="{C22D8B17-319B-49A2-9AD1-11D7A0409152}" type="presParOf" srcId="{7C49F249-F0D4-4BED-8508-E8C7C1DD937C}" destId="{C5DB7315-DC1F-481A-ACEF-1C4D779D5980}"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6B9791D9-E453-43DE-BEAA-7B0604E076A3}" type="doc">
      <dgm:prSet loTypeId="urn:microsoft.com/office/officeart/2018/2/layout/IconVerticalSolidList" loCatId="icon" qsTypeId="urn:microsoft.com/office/officeart/2005/8/quickstyle/simple1" qsCatId="simple" csTypeId="urn:microsoft.com/office/officeart/2005/8/colors/accent1_2" csCatId="accent1" phldr="1"/>
      <dgm:spPr/>
      <dgm:t>
        <a:bodyPr/>
        <a:lstStyle/>
        <a:p>
          <a:endParaRPr lang="en-US"/>
        </a:p>
      </dgm:t>
    </dgm:pt>
    <dgm:pt modelId="{17FF63A7-C289-414B-A3BD-F4340C07D604}">
      <dgm:prSet/>
      <dgm:spPr/>
      <dgm:t>
        <a:bodyPr/>
        <a:lstStyle/>
        <a:p>
          <a:pPr>
            <a:lnSpc>
              <a:spcPct val="100000"/>
            </a:lnSpc>
          </a:pPr>
          <a:r>
            <a:rPr lang="en-US"/>
            <a:t>Describe patient suffering through visual and narrative cues.</a:t>
          </a:r>
        </a:p>
      </dgm:t>
    </dgm:pt>
    <dgm:pt modelId="{60A4C878-84C6-45A2-90EA-1A6065FF9830}" type="parTrans" cxnId="{EFA4588E-F035-46A6-926E-E8901E7C078F}">
      <dgm:prSet/>
      <dgm:spPr/>
      <dgm:t>
        <a:bodyPr/>
        <a:lstStyle/>
        <a:p>
          <a:endParaRPr lang="en-US"/>
        </a:p>
      </dgm:t>
    </dgm:pt>
    <dgm:pt modelId="{683894EA-F214-4D99-8B86-B7383DDCEBB3}" type="sibTrans" cxnId="{EFA4588E-F035-46A6-926E-E8901E7C078F}">
      <dgm:prSet/>
      <dgm:spPr/>
      <dgm:t>
        <a:bodyPr/>
        <a:lstStyle/>
        <a:p>
          <a:endParaRPr lang="en-US"/>
        </a:p>
      </dgm:t>
    </dgm:pt>
    <dgm:pt modelId="{0F3FE2DD-861A-4E19-8096-4E1DC27FE111}">
      <dgm:prSet/>
      <dgm:spPr/>
      <dgm:t>
        <a:bodyPr/>
        <a:lstStyle/>
        <a:p>
          <a:pPr>
            <a:lnSpc>
              <a:spcPct val="100000"/>
            </a:lnSpc>
          </a:pPr>
          <a:r>
            <a:rPr lang="en-US"/>
            <a:t>Describe the biochemical basis and key clinical features of disease presented in the case scenarios</a:t>
          </a:r>
        </a:p>
      </dgm:t>
    </dgm:pt>
    <dgm:pt modelId="{E3CDFCAE-082E-4EC6-809C-A579C266C626}" type="parTrans" cxnId="{7FE0A4C0-224C-44CB-BEE5-06878421AEE4}">
      <dgm:prSet/>
      <dgm:spPr/>
      <dgm:t>
        <a:bodyPr/>
        <a:lstStyle/>
        <a:p>
          <a:endParaRPr lang="en-US"/>
        </a:p>
      </dgm:t>
    </dgm:pt>
    <dgm:pt modelId="{2BE36299-C2C6-4AE1-AC02-C8204D364284}" type="sibTrans" cxnId="{7FE0A4C0-224C-44CB-BEE5-06878421AEE4}">
      <dgm:prSet/>
      <dgm:spPr/>
      <dgm:t>
        <a:bodyPr/>
        <a:lstStyle/>
        <a:p>
          <a:endParaRPr lang="en-US"/>
        </a:p>
      </dgm:t>
    </dgm:pt>
    <dgm:pt modelId="{5029F0B0-8538-41C4-B7A8-86C3BE92ADC3}">
      <dgm:prSet/>
      <dgm:spPr/>
      <dgm:t>
        <a:bodyPr/>
        <a:lstStyle/>
        <a:p>
          <a:pPr>
            <a:lnSpc>
              <a:spcPct val="100000"/>
            </a:lnSpc>
          </a:pPr>
          <a:r>
            <a:rPr lang="en-US" dirty="0"/>
            <a:t>Use Visual Thinking Strategies (VTS) and structured peer roleplays to reflect on patient and caregiver perspectives on illness and suffering.</a:t>
          </a:r>
        </a:p>
      </dgm:t>
    </dgm:pt>
    <dgm:pt modelId="{8540E76E-EF52-46BB-B02A-5BB58AC37CD0}" type="parTrans" cxnId="{9CF21B20-6A47-4E1D-8735-A3B8C1689776}">
      <dgm:prSet/>
      <dgm:spPr/>
      <dgm:t>
        <a:bodyPr/>
        <a:lstStyle/>
        <a:p>
          <a:endParaRPr lang="en-US"/>
        </a:p>
      </dgm:t>
    </dgm:pt>
    <dgm:pt modelId="{CA102907-63F4-4223-B176-D6FDA880CF5B}" type="sibTrans" cxnId="{9CF21B20-6A47-4E1D-8735-A3B8C1689776}">
      <dgm:prSet/>
      <dgm:spPr/>
      <dgm:t>
        <a:bodyPr/>
        <a:lstStyle/>
        <a:p>
          <a:endParaRPr lang="en-US"/>
        </a:p>
      </dgm:t>
    </dgm:pt>
    <dgm:pt modelId="{F50607A5-265D-41DF-A5A9-91C8788D0858}">
      <dgm:prSet/>
      <dgm:spPr/>
      <dgm:t>
        <a:bodyPr/>
        <a:lstStyle/>
        <a:p>
          <a:pPr>
            <a:lnSpc>
              <a:spcPct val="100000"/>
            </a:lnSpc>
          </a:pPr>
          <a:r>
            <a:rPr lang="en-US" dirty="0"/>
            <a:t>Demonstrate empathetic communication, ethical reasoning, and collaborative clinical decision-making in the context of a biochemical disorder through a structured peer roleplay and guided reflection</a:t>
          </a:r>
        </a:p>
      </dgm:t>
    </dgm:pt>
    <dgm:pt modelId="{746E0E22-8629-4F67-A92F-F63FC55E9FA2}" type="parTrans" cxnId="{1D695921-2568-4ABD-8EE4-7E485AD73988}">
      <dgm:prSet/>
      <dgm:spPr/>
      <dgm:t>
        <a:bodyPr/>
        <a:lstStyle/>
        <a:p>
          <a:endParaRPr lang="en-US"/>
        </a:p>
      </dgm:t>
    </dgm:pt>
    <dgm:pt modelId="{242EA691-D07D-49E0-B16A-E74363E87851}" type="sibTrans" cxnId="{1D695921-2568-4ABD-8EE4-7E485AD73988}">
      <dgm:prSet/>
      <dgm:spPr/>
      <dgm:t>
        <a:bodyPr/>
        <a:lstStyle/>
        <a:p>
          <a:endParaRPr lang="en-US"/>
        </a:p>
      </dgm:t>
    </dgm:pt>
    <dgm:pt modelId="{2991BE90-7330-4ACE-A3A4-5F134781D542}">
      <dgm:prSet/>
      <dgm:spPr/>
      <dgm:t>
        <a:bodyPr/>
        <a:lstStyle/>
        <a:p>
          <a:pPr>
            <a:lnSpc>
              <a:spcPct val="100000"/>
            </a:lnSpc>
          </a:pPr>
          <a:r>
            <a:rPr lang="en-US"/>
            <a:t>Reflect on emotions, communication, and the meaning of suffering using a structured reflection format. </a:t>
          </a:r>
        </a:p>
      </dgm:t>
    </dgm:pt>
    <dgm:pt modelId="{D94BA60C-925A-42FA-9F48-CE1BEFAA4025}" type="parTrans" cxnId="{DB79208D-750D-4A0F-A7F0-A2A8FEAC13C3}">
      <dgm:prSet/>
      <dgm:spPr/>
      <dgm:t>
        <a:bodyPr/>
        <a:lstStyle/>
        <a:p>
          <a:endParaRPr lang="en-US"/>
        </a:p>
      </dgm:t>
    </dgm:pt>
    <dgm:pt modelId="{1CB7AA49-EE1A-4A77-BBB2-CB87F95B73A6}" type="sibTrans" cxnId="{DB79208D-750D-4A0F-A7F0-A2A8FEAC13C3}">
      <dgm:prSet/>
      <dgm:spPr/>
      <dgm:t>
        <a:bodyPr/>
        <a:lstStyle/>
        <a:p>
          <a:endParaRPr lang="en-US"/>
        </a:p>
      </dgm:t>
    </dgm:pt>
    <dgm:pt modelId="{80D42DA2-098A-42EE-BC11-47413DAE2874}" type="pres">
      <dgm:prSet presAssocID="{6B9791D9-E453-43DE-BEAA-7B0604E076A3}" presName="root" presStyleCnt="0">
        <dgm:presLayoutVars>
          <dgm:dir/>
          <dgm:resizeHandles val="exact"/>
        </dgm:presLayoutVars>
      </dgm:prSet>
      <dgm:spPr/>
    </dgm:pt>
    <dgm:pt modelId="{A8CB0DF1-F655-4863-910F-3238C1984716}" type="pres">
      <dgm:prSet presAssocID="{17FF63A7-C289-414B-A3BD-F4340C07D604}" presName="compNode" presStyleCnt="0"/>
      <dgm:spPr/>
    </dgm:pt>
    <dgm:pt modelId="{9B32EDF4-5FCF-4C51-B417-0B5FA52C81D0}" type="pres">
      <dgm:prSet presAssocID="{17FF63A7-C289-414B-A3BD-F4340C07D604}" presName="bgRect" presStyleLbl="bgShp" presStyleIdx="0" presStyleCnt="5"/>
      <dgm:spPr/>
    </dgm:pt>
    <dgm:pt modelId="{A867542F-99C7-496F-B62A-4AD7E730836B}" type="pres">
      <dgm:prSet presAssocID="{17FF63A7-C289-414B-A3BD-F4340C07D604}" presName="iconRect" presStyleLbl="node1" presStyleIdx="0" presStyleCnt="5"/>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dgm:spPr>
      <dgm:extLst>
        <a:ext uri="{E40237B7-FDA0-4F09-8148-C483321AD2D9}">
          <dgm14:cNvPr xmlns:dgm14="http://schemas.microsoft.com/office/drawing/2010/diagram" id="0" name="" descr="Eye"/>
        </a:ext>
      </dgm:extLst>
    </dgm:pt>
    <dgm:pt modelId="{EA66AD35-A189-491D-9F73-AB3F3EDC87E3}" type="pres">
      <dgm:prSet presAssocID="{17FF63A7-C289-414B-A3BD-F4340C07D604}" presName="spaceRect" presStyleCnt="0"/>
      <dgm:spPr/>
    </dgm:pt>
    <dgm:pt modelId="{F468B0E3-DA4C-4C37-991D-37E58AC5D03D}" type="pres">
      <dgm:prSet presAssocID="{17FF63A7-C289-414B-A3BD-F4340C07D604}" presName="parTx" presStyleLbl="revTx" presStyleIdx="0" presStyleCnt="5">
        <dgm:presLayoutVars>
          <dgm:chMax val="0"/>
          <dgm:chPref val="0"/>
        </dgm:presLayoutVars>
      </dgm:prSet>
      <dgm:spPr/>
    </dgm:pt>
    <dgm:pt modelId="{936EF26F-EAEC-4504-818F-705CE6B1A4A2}" type="pres">
      <dgm:prSet presAssocID="{683894EA-F214-4D99-8B86-B7383DDCEBB3}" presName="sibTrans" presStyleCnt="0"/>
      <dgm:spPr/>
    </dgm:pt>
    <dgm:pt modelId="{4510A288-8B18-43A8-B5BC-18C8057B5259}" type="pres">
      <dgm:prSet presAssocID="{0F3FE2DD-861A-4E19-8096-4E1DC27FE111}" presName="compNode" presStyleCnt="0"/>
      <dgm:spPr/>
    </dgm:pt>
    <dgm:pt modelId="{F248EDA1-054C-4499-B820-0B2D01DE1EE0}" type="pres">
      <dgm:prSet presAssocID="{0F3FE2DD-861A-4E19-8096-4E1DC27FE111}" presName="bgRect" presStyleLbl="bgShp" presStyleIdx="1" presStyleCnt="5"/>
      <dgm:spPr/>
    </dgm:pt>
    <dgm:pt modelId="{6104EBC7-22A0-413A-AA1A-2AF95D9EA014}" type="pres">
      <dgm:prSet presAssocID="{0F3FE2DD-861A-4E19-8096-4E1DC27FE111}" presName="iconRect" presStyleLbl="node1" presStyleIdx="1" presStyleCnt="5"/>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dgm:spPr>
      <dgm:extLst>
        <a:ext uri="{E40237B7-FDA0-4F09-8148-C483321AD2D9}">
          <dgm14:cNvPr xmlns:dgm14="http://schemas.microsoft.com/office/drawing/2010/diagram" id="0" name="" descr="Microscope"/>
        </a:ext>
      </dgm:extLst>
    </dgm:pt>
    <dgm:pt modelId="{C30FE4FB-3889-49E3-9CE5-2B97117296BF}" type="pres">
      <dgm:prSet presAssocID="{0F3FE2DD-861A-4E19-8096-4E1DC27FE111}" presName="spaceRect" presStyleCnt="0"/>
      <dgm:spPr/>
    </dgm:pt>
    <dgm:pt modelId="{8478D245-EE27-4966-8C66-3C9E1C97D7C2}" type="pres">
      <dgm:prSet presAssocID="{0F3FE2DD-861A-4E19-8096-4E1DC27FE111}" presName="parTx" presStyleLbl="revTx" presStyleIdx="1" presStyleCnt="5">
        <dgm:presLayoutVars>
          <dgm:chMax val="0"/>
          <dgm:chPref val="0"/>
        </dgm:presLayoutVars>
      </dgm:prSet>
      <dgm:spPr/>
    </dgm:pt>
    <dgm:pt modelId="{6911BF12-CA3E-4D7C-9F21-76D6E672EB5A}" type="pres">
      <dgm:prSet presAssocID="{2BE36299-C2C6-4AE1-AC02-C8204D364284}" presName="sibTrans" presStyleCnt="0"/>
      <dgm:spPr/>
    </dgm:pt>
    <dgm:pt modelId="{6B00B353-B41C-4F48-8231-EAF721204F21}" type="pres">
      <dgm:prSet presAssocID="{5029F0B0-8538-41C4-B7A8-86C3BE92ADC3}" presName="compNode" presStyleCnt="0"/>
      <dgm:spPr/>
    </dgm:pt>
    <dgm:pt modelId="{8ECD9F6A-E223-44FF-A706-13495A718931}" type="pres">
      <dgm:prSet presAssocID="{5029F0B0-8538-41C4-B7A8-86C3BE92ADC3}" presName="bgRect" presStyleLbl="bgShp" presStyleIdx="2" presStyleCnt="5"/>
      <dgm:spPr/>
    </dgm:pt>
    <dgm:pt modelId="{A4258B48-B7A2-415B-9D78-90A4FE2D10FD}" type="pres">
      <dgm:prSet presAssocID="{5029F0B0-8538-41C4-B7A8-86C3BE92ADC3}" presName="iconRect" presStyleLbl="node1" presStyleIdx="2" presStyleCnt="5"/>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dgm:spPr>
      <dgm:extLst>
        <a:ext uri="{E40237B7-FDA0-4F09-8148-C483321AD2D9}">
          <dgm14:cNvPr xmlns:dgm14="http://schemas.microsoft.com/office/drawing/2010/diagram" id="0" name="" descr="Hospital"/>
        </a:ext>
      </dgm:extLst>
    </dgm:pt>
    <dgm:pt modelId="{75BB3ACF-4B90-46EE-ABF7-2C41BFA0C81E}" type="pres">
      <dgm:prSet presAssocID="{5029F0B0-8538-41C4-B7A8-86C3BE92ADC3}" presName="spaceRect" presStyleCnt="0"/>
      <dgm:spPr/>
    </dgm:pt>
    <dgm:pt modelId="{061F49E9-9CB5-459C-BBF9-B3E7AD9F77D6}" type="pres">
      <dgm:prSet presAssocID="{5029F0B0-8538-41C4-B7A8-86C3BE92ADC3}" presName="parTx" presStyleLbl="revTx" presStyleIdx="2" presStyleCnt="5">
        <dgm:presLayoutVars>
          <dgm:chMax val="0"/>
          <dgm:chPref val="0"/>
        </dgm:presLayoutVars>
      </dgm:prSet>
      <dgm:spPr/>
    </dgm:pt>
    <dgm:pt modelId="{AA2E382A-1EC2-4E04-986C-0FF9C45A80D1}" type="pres">
      <dgm:prSet presAssocID="{CA102907-63F4-4223-B176-D6FDA880CF5B}" presName="sibTrans" presStyleCnt="0"/>
      <dgm:spPr/>
    </dgm:pt>
    <dgm:pt modelId="{66158313-EC02-4287-9E85-9494D2F6AC1D}" type="pres">
      <dgm:prSet presAssocID="{F50607A5-265D-41DF-A5A9-91C8788D0858}" presName="compNode" presStyleCnt="0"/>
      <dgm:spPr/>
    </dgm:pt>
    <dgm:pt modelId="{E8791A35-BA0D-4615-804C-5D602B43D1FD}" type="pres">
      <dgm:prSet presAssocID="{F50607A5-265D-41DF-A5A9-91C8788D0858}" presName="bgRect" presStyleLbl="bgShp" presStyleIdx="3" presStyleCnt="5"/>
      <dgm:spPr/>
    </dgm:pt>
    <dgm:pt modelId="{9CE926B3-8022-44B6-958B-16B76ED5140F}" type="pres">
      <dgm:prSet presAssocID="{F50607A5-265D-41DF-A5A9-91C8788D0858}" presName="iconRect" presStyleLbl="node1" presStyleIdx="3" presStyleCnt="5"/>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dgm:spPr>
      <dgm:extLst>
        <a:ext uri="{E40237B7-FDA0-4F09-8148-C483321AD2D9}">
          <dgm14:cNvPr xmlns:dgm14="http://schemas.microsoft.com/office/drawing/2010/diagram" id="0" name="" descr="Head with Gears"/>
        </a:ext>
      </dgm:extLst>
    </dgm:pt>
    <dgm:pt modelId="{4B50368A-100F-4410-9989-902F372EFA09}" type="pres">
      <dgm:prSet presAssocID="{F50607A5-265D-41DF-A5A9-91C8788D0858}" presName="spaceRect" presStyleCnt="0"/>
      <dgm:spPr/>
    </dgm:pt>
    <dgm:pt modelId="{8046A353-E5B6-409E-9CA5-D60D43A978F0}" type="pres">
      <dgm:prSet presAssocID="{F50607A5-265D-41DF-A5A9-91C8788D0858}" presName="parTx" presStyleLbl="revTx" presStyleIdx="3" presStyleCnt="5">
        <dgm:presLayoutVars>
          <dgm:chMax val="0"/>
          <dgm:chPref val="0"/>
        </dgm:presLayoutVars>
      </dgm:prSet>
      <dgm:spPr/>
    </dgm:pt>
    <dgm:pt modelId="{726F8E08-CD3C-4ED3-8FD4-E8A0EB62F19F}" type="pres">
      <dgm:prSet presAssocID="{242EA691-D07D-49E0-B16A-E74363E87851}" presName="sibTrans" presStyleCnt="0"/>
      <dgm:spPr/>
    </dgm:pt>
    <dgm:pt modelId="{7C49F249-F0D4-4BED-8508-E8C7C1DD937C}" type="pres">
      <dgm:prSet presAssocID="{2991BE90-7330-4ACE-A3A4-5F134781D542}" presName="compNode" presStyleCnt="0"/>
      <dgm:spPr/>
    </dgm:pt>
    <dgm:pt modelId="{5FABE087-36D9-4A98-BB89-38215F3A9867}" type="pres">
      <dgm:prSet presAssocID="{2991BE90-7330-4ACE-A3A4-5F134781D542}" presName="bgRect" presStyleLbl="bgShp" presStyleIdx="4" presStyleCnt="5"/>
      <dgm:spPr/>
    </dgm:pt>
    <dgm:pt modelId="{9920F5DB-B0FF-4886-A327-D5AAC8085054}" type="pres">
      <dgm:prSet presAssocID="{2991BE90-7330-4ACE-A3A4-5F134781D542}" presName="iconRect" presStyleLbl="node1" presStyleIdx="4" presStyleCnt="5"/>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dgm:spPr>
      <dgm:extLst>
        <a:ext uri="{E40237B7-FDA0-4F09-8148-C483321AD2D9}">
          <dgm14:cNvPr xmlns:dgm14="http://schemas.microsoft.com/office/drawing/2010/diagram" id="0" name="" descr="Person with Idea"/>
        </a:ext>
      </dgm:extLst>
    </dgm:pt>
    <dgm:pt modelId="{09F8FF25-5B7E-4056-AB5A-CB03D3B034EE}" type="pres">
      <dgm:prSet presAssocID="{2991BE90-7330-4ACE-A3A4-5F134781D542}" presName="spaceRect" presStyleCnt="0"/>
      <dgm:spPr/>
    </dgm:pt>
    <dgm:pt modelId="{C5DB7315-DC1F-481A-ACEF-1C4D779D5980}" type="pres">
      <dgm:prSet presAssocID="{2991BE90-7330-4ACE-A3A4-5F134781D542}" presName="parTx" presStyleLbl="revTx" presStyleIdx="4" presStyleCnt="5">
        <dgm:presLayoutVars>
          <dgm:chMax val="0"/>
          <dgm:chPref val="0"/>
        </dgm:presLayoutVars>
      </dgm:prSet>
      <dgm:spPr/>
    </dgm:pt>
  </dgm:ptLst>
  <dgm:cxnLst>
    <dgm:cxn modelId="{45C72008-2374-42C2-B8AF-5512571B1635}" type="presOf" srcId="{6B9791D9-E453-43DE-BEAA-7B0604E076A3}" destId="{80D42DA2-098A-42EE-BC11-47413DAE2874}" srcOrd="0" destOrd="0" presId="urn:microsoft.com/office/officeart/2018/2/layout/IconVerticalSolidList"/>
    <dgm:cxn modelId="{9CF21B20-6A47-4E1D-8735-A3B8C1689776}" srcId="{6B9791D9-E453-43DE-BEAA-7B0604E076A3}" destId="{5029F0B0-8538-41C4-B7A8-86C3BE92ADC3}" srcOrd="2" destOrd="0" parTransId="{8540E76E-EF52-46BB-B02A-5BB58AC37CD0}" sibTransId="{CA102907-63F4-4223-B176-D6FDA880CF5B}"/>
    <dgm:cxn modelId="{1D695921-2568-4ABD-8EE4-7E485AD73988}" srcId="{6B9791D9-E453-43DE-BEAA-7B0604E076A3}" destId="{F50607A5-265D-41DF-A5A9-91C8788D0858}" srcOrd="3" destOrd="0" parTransId="{746E0E22-8629-4F67-A92F-F63FC55E9FA2}" sibTransId="{242EA691-D07D-49E0-B16A-E74363E87851}"/>
    <dgm:cxn modelId="{AE411A3A-E66C-43AB-B74B-CF5E6EEFCAC0}" type="presOf" srcId="{0F3FE2DD-861A-4E19-8096-4E1DC27FE111}" destId="{8478D245-EE27-4966-8C66-3C9E1C97D7C2}" srcOrd="0" destOrd="0" presId="urn:microsoft.com/office/officeart/2018/2/layout/IconVerticalSolidList"/>
    <dgm:cxn modelId="{2534D763-2BA9-4CB4-846D-980ECBDF55AF}" type="presOf" srcId="{2991BE90-7330-4ACE-A3A4-5F134781D542}" destId="{C5DB7315-DC1F-481A-ACEF-1C4D779D5980}" srcOrd="0" destOrd="0" presId="urn:microsoft.com/office/officeart/2018/2/layout/IconVerticalSolidList"/>
    <dgm:cxn modelId="{DB79208D-750D-4A0F-A7F0-A2A8FEAC13C3}" srcId="{6B9791D9-E453-43DE-BEAA-7B0604E076A3}" destId="{2991BE90-7330-4ACE-A3A4-5F134781D542}" srcOrd="4" destOrd="0" parTransId="{D94BA60C-925A-42FA-9F48-CE1BEFAA4025}" sibTransId="{1CB7AA49-EE1A-4A77-BBB2-CB87F95B73A6}"/>
    <dgm:cxn modelId="{EFA4588E-F035-46A6-926E-E8901E7C078F}" srcId="{6B9791D9-E453-43DE-BEAA-7B0604E076A3}" destId="{17FF63A7-C289-414B-A3BD-F4340C07D604}" srcOrd="0" destOrd="0" parTransId="{60A4C878-84C6-45A2-90EA-1A6065FF9830}" sibTransId="{683894EA-F214-4D99-8B86-B7383DDCEBB3}"/>
    <dgm:cxn modelId="{2CC39899-89D6-49B4-8A47-19CA39F193FE}" type="presOf" srcId="{F50607A5-265D-41DF-A5A9-91C8788D0858}" destId="{8046A353-E5B6-409E-9CA5-D60D43A978F0}" srcOrd="0" destOrd="0" presId="urn:microsoft.com/office/officeart/2018/2/layout/IconVerticalSolidList"/>
    <dgm:cxn modelId="{F5B9749A-4B69-4CC4-AC89-152A1CEF972B}" type="presOf" srcId="{17FF63A7-C289-414B-A3BD-F4340C07D604}" destId="{F468B0E3-DA4C-4C37-991D-37E58AC5D03D}" srcOrd="0" destOrd="0" presId="urn:microsoft.com/office/officeart/2018/2/layout/IconVerticalSolidList"/>
    <dgm:cxn modelId="{609A75B4-2FD1-406A-9490-31168CC14924}" type="presOf" srcId="{5029F0B0-8538-41C4-B7A8-86C3BE92ADC3}" destId="{061F49E9-9CB5-459C-BBF9-B3E7AD9F77D6}" srcOrd="0" destOrd="0" presId="urn:microsoft.com/office/officeart/2018/2/layout/IconVerticalSolidList"/>
    <dgm:cxn modelId="{7FE0A4C0-224C-44CB-BEE5-06878421AEE4}" srcId="{6B9791D9-E453-43DE-BEAA-7B0604E076A3}" destId="{0F3FE2DD-861A-4E19-8096-4E1DC27FE111}" srcOrd="1" destOrd="0" parTransId="{E3CDFCAE-082E-4EC6-809C-A579C266C626}" sibTransId="{2BE36299-C2C6-4AE1-AC02-C8204D364284}"/>
    <dgm:cxn modelId="{6F7033A0-EB15-463E-9854-D8505C392D17}" type="presParOf" srcId="{80D42DA2-098A-42EE-BC11-47413DAE2874}" destId="{A8CB0DF1-F655-4863-910F-3238C1984716}" srcOrd="0" destOrd="0" presId="urn:microsoft.com/office/officeart/2018/2/layout/IconVerticalSolidList"/>
    <dgm:cxn modelId="{93ED861E-7960-4B3B-B4DE-F52BE65D022B}" type="presParOf" srcId="{A8CB0DF1-F655-4863-910F-3238C1984716}" destId="{9B32EDF4-5FCF-4C51-B417-0B5FA52C81D0}" srcOrd="0" destOrd="0" presId="urn:microsoft.com/office/officeart/2018/2/layout/IconVerticalSolidList"/>
    <dgm:cxn modelId="{7B47FB76-A5D6-4B65-A66A-6F5A8F96989E}" type="presParOf" srcId="{A8CB0DF1-F655-4863-910F-3238C1984716}" destId="{A867542F-99C7-496F-B62A-4AD7E730836B}" srcOrd="1" destOrd="0" presId="urn:microsoft.com/office/officeart/2018/2/layout/IconVerticalSolidList"/>
    <dgm:cxn modelId="{331E1251-1B00-4BF4-94C3-46C06F937F27}" type="presParOf" srcId="{A8CB0DF1-F655-4863-910F-3238C1984716}" destId="{EA66AD35-A189-491D-9F73-AB3F3EDC87E3}" srcOrd="2" destOrd="0" presId="urn:microsoft.com/office/officeart/2018/2/layout/IconVerticalSolidList"/>
    <dgm:cxn modelId="{3954E027-6080-4F97-8AC8-AC874A2AA370}" type="presParOf" srcId="{A8CB0DF1-F655-4863-910F-3238C1984716}" destId="{F468B0E3-DA4C-4C37-991D-37E58AC5D03D}" srcOrd="3" destOrd="0" presId="urn:microsoft.com/office/officeart/2018/2/layout/IconVerticalSolidList"/>
    <dgm:cxn modelId="{D443CC4C-79B2-4C1B-9FDE-7A6EA2413B59}" type="presParOf" srcId="{80D42DA2-098A-42EE-BC11-47413DAE2874}" destId="{936EF26F-EAEC-4504-818F-705CE6B1A4A2}" srcOrd="1" destOrd="0" presId="urn:microsoft.com/office/officeart/2018/2/layout/IconVerticalSolidList"/>
    <dgm:cxn modelId="{7704A2FB-44BC-4543-8F16-5AA4B24ADD2B}" type="presParOf" srcId="{80D42DA2-098A-42EE-BC11-47413DAE2874}" destId="{4510A288-8B18-43A8-B5BC-18C8057B5259}" srcOrd="2" destOrd="0" presId="urn:microsoft.com/office/officeart/2018/2/layout/IconVerticalSolidList"/>
    <dgm:cxn modelId="{B7833353-3359-4FA5-BA92-E3145D3D3B09}" type="presParOf" srcId="{4510A288-8B18-43A8-B5BC-18C8057B5259}" destId="{F248EDA1-054C-4499-B820-0B2D01DE1EE0}" srcOrd="0" destOrd="0" presId="urn:microsoft.com/office/officeart/2018/2/layout/IconVerticalSolidList"/>
    <dgm:cxn modelId="{C3FF4C2C-254E-4BDC-91BE-31FD365FE15D}" type="presParOf" srcId="{4510A288-8B18-43A8-B5BC-18C8057B5259}" destId="{6104EBC7-22A0-413A-AA1A-2AF95D9EA014}" srcOrd="1" destOrd="0" presId="urn:microsoft.com/office/officeart/2018/2/layout/IconVerticalSolidList"/>
    <dgm:cxn modelId="{C40436FC-5235-4968-AECF-0853D8C3D49B}" type="presParOf" srcId="{4510A288-8B18-43A8-B5BC-18C8057B5259}" destId="{C30FE4FB-3889-49E3-9CE5-2B97117296BF}" srcOrd="2" destOrd="0" presId="urn:microsoft.com/office/officeart/2018/2/layout/IconVerticalSolidList"/>
    <dgm:cxn modelId="{A3EDF83A-BFF2-455B-BA90-63988714173C}" type="presParOf" srcId="{4510A288-8B18-43A8-B5BC-18C8057B5259}" destId="{8478D245-EE27-4966-8C66-3C9E1C97D7C2}" srcOrd="3" destOrd="0" presId="urn:microsoft.com/office/officeart/2018/2/layout/IconVerticalSolidList"/>
    <dgm:cxn modelId="{7E7BC6C6-7049-4359-B729-A17338652BC1}" type="presParOf" srcId="{80D42DA2-098A-42EE-BC11-47413DAE2874}" destId="{6911BF12-CA3E-4D7C-9F21-76D6E672EB5A}" srcOrd="3" destOrd="0" presId="urn:microsoft.com/office/officeart/2018/2/layout/IconVerticalSolidList"/>
    <dgm:cxn modelId="{779D345F-EE4E-47BB-8DD1-B5039A7129F2}" type="presParOf" srcId="{80D42DA2-098A-42EE-BC11-47413DAE2874}" destId="{6B00B353-B41C-4F48-8231-EAF721204F21}" srcOrd="4" destOrd="0" presId="urn:microsoft.com/office/officeart/2018/2/layout/IconVerticalSolidList"/>
    <dgm:cxn modelId="{626C858A-541B-4B1A-8AAC-E7BB136AC986}" type="presParOf" srcId="{6B00B353-B41C-4F48-8231-EAF721204F21}" destId="{8ECD9F6A-E223-44FF-A706-13495A718931}" srcOrd="0" destOrd="0" presId="urn:microsoft.com/office/officeart/2018/2/layout/IconVerticalSolidList"/>
    <dgm:cxn modelId="{3B91EA99-D142-4BC7-B164-7A4407430196}" type="presParOf" srcId="{6B00B353-B41C-4F48-8231-EAF721204F21}" destId="{A4258B48-B7A2-415B-9D78-90A4FE2D10FD}" srcOrd="1" destOrd="0" presId="urn:microsoft.com/office/officeart/2018/2/layout/IconVerticalSolidList"/>
    <dgm:cxn modelId="{4358E4E6-88EA-462E-8CE9-68CBDF554D00}" type="presParOf" srcId="{6B00B353-B41C-4F48-8231-EAF721204F21}" destId="{75BB3ACF-4B90-46EE-ABF7-2C41BFA0C81E}" srcOrd="2" destOrd="0" presId="urn:microsoft.com/office/officeart/2018/2/layout/IconVerticalSolidList"/>
    <dgm:cxn modelId="{185EEE72-E68C-46BC-A725-255944C73E2F}" type="presParOf" srcId="{6B00B353-B41C-4F48-8231-EAF721204F21}" destId="{061F49E9-9CB5-459C-BBF9-B3E7AD9F77D6}" srcOrd="3" destOrd="0" presId="urn:microsoft.com/office/officeart/2018/2/layout/IconVerticalSolidList"/>
    <dgm:cxn modelId="{55D18BC3-7DDA-4FF8-B507-090CACD104A3}" type="presParOf" srcId="{80D42DA2-098A-42EE-BC11-47413DAE2874}" destId="{AA2E382A-1EC2-4E04-986C-0FF9C45A80D1}" srcOrd="5" destOrd="0" presId="urn:microsoft.com/office/officeart/2018/2/layout/IconVerticalSolidList"/>
    <dgm:cxn modelId="{D74491DF-819C-4B94-818B-62D468DFF053}" type="presParOf" srcId="{80D42DA2-098A-42EE-BC11-47413DAE2874}" destId="{66158313-EC02-4287-9E85-9494D2F6AC1D}" srcOrd="6" destOrd="0" presId="urn:microsoft.com/office/officeart/2018/2/layout/IconVerticalSolidList"/>
    <dgm:cxn modelId="{EEE98F02-08BA-4C29-95FE-52CA3DFC1282}" type="presParOf" srcId="{66158313-EC02-4287-9E85-9494D2F6AC1D}" destId="{E8791A35-BA0D-4615-804C-5D602B43D1FD}" srcOrd="0" destOrd="0" presId="urn:microsoft.com/office/officeart/2018/2/layout/IconVerticalSolidList"/>
    <dgm:cxn modelId="{4E99BBD9-7C72-4449-8D1A-95B9FCB6F7F0}" type="presParOf" srcId="{66158313-EC02-4287-9E85-9494D2F6AC1D}" destId="{9CE926B3-8022-44B6-958B-16B76ED5140F}" srcOrd="1" destOrd="0" presId="urn:microsoft.com/office/officeart/2018/2/layout/IconVerticalSolidList"/>
    <dgm:cxn modelId="{242622FD-B42E-4B08-98FF-5E9755A1D268}" type="presParOf" srcId="{66158313-EC02-4287-9E85-9494D2F6AC1D}" destId="{4B50368A-100F-4410-9989-902F372EFA09}" srcOrd="2" destOrd="0" presId="urn:microsoft.com/office/officeart/2018/2/layout/IconVerticalSolidList"/>
    <dgm:cxn modelId="{10C77FCE-CED5-4ECA-A340-22C893515ADC}" type="presParOf" srcId="{66158313-EC02-4287-9E85-9494D2F6AC1D}" destId="{8046A353-E5B6-409E-9CA5-D60D43A978F0}" srcOrd="3" destOrd="0" presId="urn:microsoft.com/office/officeart/2018/2/layout/IconVerticalSolidList"/>
    <dgm:cxn modelId="{D5EAA238-9326-45B8-8A9B-E573F21F0D21}" type="presParOf" srcId="{80D42DA2-098A-42EE-BC11-47413DAE2874}" destId="{726F8E08-CD3C-4ED3-8FD4-E8A0EB62F19F}" srcOrd="7" destOrd="0" presId="urn:microsoft.com/office/officeart/2018/2/layout/IconVerticalSolidList"/>
    <dgm:cxn modelId="{EDF02885-0453-4C86-A58B-34C974E2ECDF}" type="presParOf" srcId="{80D42DA2-098A-42EE-BC11-47413DAE2874}" destId="{7C49F249-F0D4-4BED-8508-E8C7C1DD937C}" srcOrd="8" destOrd="0" presId="urn:microsoft.com/office/officeart/2018/2/layout/IconVerticalSolidList"/>
    <dgm:cxn modelId="{FCE7B39E-FF11-4668-B955-296B27D5416D}" type="presParOf" srcId="{7C49F249-F0D4-4BED-8508-E8C7C1DD937C}" destId="{5FABE087-36D9-4A98-BB89-38215F3A9867}" srcOrd="0" destOrd="0" presId="urn:microsoft.com/office/officeart/2018/2/layout/IconVerticalSolidList"/>
    <dgm:cxn modelId="{F17CFCAB-D285-4E7F-B2BE-56C86DA7467B}" type="presParOf" srcId="{7C49F249-F0D4-4BED-8508-E8C7C1DD937C}" destId="{9920F5DB-B0FF-4886-A327-D5AAC8085054}" srcOrd="1" destOrd="0" presId="urn:microsoft.com/office/officeart/2018/2/layout/IconVerticalSolidList"/>
    <dgm:cxn modelId="{10A15378-154C-42CB-B661-92EE0118945F}" type="presParOf" srcId="{7C49F249-F0D4-4BED-8508-E8C7C1DD937C}" destId="{09F8FF25-5B7E-4056-AB5A-CB03D3B034EE}" srcOrd="2" destOrd="0" presId="urn:microsoft.com/office/officeart/2018/2/layout/IconVerticalSolidList"/>
    <dgm:cxn modelId="{C22D8B17-319B-49A2-9AD1-11D7A0409152}" type="presParOf" srcId="{7C49F249-F0D4-4BED-8508-E8C7C1DD937C}" destId="{C5DB7315-DC1F-481A-ACEF-1C4D779D5980}"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B32EDF4-5FCF-4C51-B417-0B5FA52C81D0}">
      <dsp:nvSpPr>
        <dsp:cNvPr id="0" name=""/>
        <dsp:cNvSpPr/>
      </dsp:nvSpPr>
      <dsp:spPr>
        <a:xfrm>
          <a:off x="0" y="3250"/>
          <a:ext cx="10515600" cy="692336"/>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867542F-99C7-496F-B62A-4AD7E730836B}">
      <dsp:nvSpPr>
        <dsp:cNvPr id="0" name=""/>
        <dsp:cNvSpPr/>
      </dsp:nvSpPr>
      <dsp:spPr>
        <a:xfrm>
          <a:off x="209431" y="159026"/>
          <a:ext cx="380785" cy="380785"/>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468B0E3-DA4C-4C37-991D-37E58AC5D03D}">
      <dsp:nvSpPr>
        <dsp:cNvPr id="0" name=""/>
        <dsp:cNvSpPr/>
      </dsp:nvSpPr>
      <dsp:spPr>
        <a:xfrm>
          <a:off x="799648" y="3250"/>
          <a:ext cx="9715951" cy="6923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72" tIns="73272" rIns="73272" bIns="73272" numCol="1" spcCol="1270" anchor="ctr" anchorCtr="0">
          <a:noAutofit/>
        </a:bodyPr>
        <a:lstStyle/>
        <a:p>
          <a:pPr marL="0" lvl="0" indent="0" algn="l" defTabSz="622300">
            <a:lnSpc>
              <a:spcPct val="100000"/>
            </a:lnSpc>
            <a:spcBef>
              <a:spcPct val="0"/>
            </a:spcBef>
            <a:spcAft>
              <a:spcPct val="35000"/>
            </a:spcAft>
            <a:buNone/>
          </a:pPr>
          <a:r>
            <a:rPr lang="en-US" sz="1400" kern="1200"/>
            <a:t>Describe patient suffering through visual and narrative cues.</a:t>
          </a:r>
        </a:p>
      </dsp:txBody>
      <dsp:txXfrm>
        <a:off x="799648" y="3250"/>
        <a:ext cx="9715951" cy="692336"/>
      </dsp:txXfrm>
    </dsp:sp>
    <dsp:sp modelId="{F248EDA1-054C-4499-B820-0B2D01DE1EE0}">
      <dsp:nvSpPr>
        <dsp:cNvPr id="0" name=""/>
        <dsp:cNvSpPr/>
      </dsp:nvSpPr>
      <dsp:spPr>
        <a:xfrm>
          <a:off x="0" y="868671"/>
          <a:ext cx="10515600" cy="692336"/>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6104EBC7-22A0-413A-AA1A-2AF95D9EA014}">
      <dsp:nvSpPr>
        <dsp:cNvPr id="0" name=""/>
        <dsp:cNvSpPr/>
      </dsp:nvSpPr>
      <dsp:spPr>
        <a:xfrm>
          <a:off x="209431" y="1024446"/>
          <a:ext cx="380785" cy="380785"/>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478D245-EE27-4966-8C66-3C9E1C97D7C2}">
      <dsp:nvSpPr>
        <dsp:cNvPr id="0" name=""/>
        <dsp:cNvSpPr/>
      </dsp:nvSpPr>
      <dsp:spPr>
        <a:xfrm>
          <a:off x="799648" y="868671"/>
          <a:ext cx="9715951" cy="6923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72" tIns="73272" rIns="73272" bIns="73272" numCol="1" spcCol="1270" anchor="ctr" anchorCtr="0">
          <a:noAutofit/>
        </a:bodyPr>
        <a:lstStyle/>
        <a:p>
          <a:pPr marL="0" lvl="0" indent="0" algn="l" defTabSz="622300">
            <a:lnSpc>
              <a:spcPct val="100000"/>
            </a:lnSpc>
            <a:spcBef>
              <a:spcPct val="0"/>
            </a:spcBef>
            <a:spcAft>
              <a:spcPct val="35000"/>
            </a:spcAft>
            <a:buNone/>
          </a:pPr>
          <a:r>
            <a:rPr lang="en-US" sz="1400" kern="1200"/>
            <a:t>Describe the biochemical basis and key clinical features of disease presented in the case scenarios</a:t>
          </a:r>
        </a:p>
      </dsp:txBody>
      <dsp:txXfrm>
        <a:off x="799648" y="868671"/>
        <a:ext cx="9715951" cy="692336"/>
      </dsp:txXfrm>
    </dsp:sp>
    <dsp:sp modelId="{8ECD9F6A-E223-44FF-A706-13495A718931}">
      <dsp:nvSpPr>
        <dsp:cNvPr id="0" name=""/>
        <dsp:cNvSpPr/>
      </dsp:nvSpPr>
      <dsp:spPr>
        <a:xfrm>
          <a:off x="0" y="1734091"/>
          <a:ext cx="10515600" cy="692336"/>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4258B48-B7A2-415B-9D78-90A4FE2D10FD}">
      <dsp:nvSpPr>
        <dsp:cNvPr id="0" name=""/>
        <dsp:cNvSpPr/>
      </dsp:nvSpPr>
      <dsp:spPr>
        <a:xfrm>
          <a:off x="209431" y="1889867"/>
          <a:ext cx="380785" cy="380785"/>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61F49E9-9CB5-459C-BBF9-B3E7AD9F77D6}">
      <dsp:nvSpPr>
        <dsp:cNvPr id="0" name=""/>
        <dsp:cNvSpPr/>
      </dsp:nvSpPr>
      <dsp:spPr>
        <a:xfrm>
          <a:off x="799648" y="1734091"/>
          <a:ext cx="9715951" cy="6923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72" tIns="73272" rIns="73272" bIns="73272" numCol="1" spcCol="1270" anchor="ctr" anchorCtr="0">
          <a:noAutofit/>
        </a:bodyPr>
        <a:lstStyle/>
        <a:p>
          <a:pPr marL="0" lvl="0" indent="0" algn="l" defTabSz="622300">
            <a:lnSpc>
              <a:spcPct val="100000"/>
            </a:lnSpc>
            <a:spcBef>
              <a:spcPct val="0"/>
            </a:spcBef>
            <a:spcAft>
              <a:spcPct val="35000"/>
            </a:spcAft>
            <a:buNone/>
          </a:pPr>
          <a:r>
            <a:rPr lang="en-US" sz="1400" kern="1200" dirty="0"/>
            <a:t>Use Visual Thinking Strategies (VTS) and structured peer roleplays to reflect on patient and caregiver perspectives on illness and suffering.</a:t>
          </a:r>
        </a:p>
      </dsp:txBody>
      <dsp:txXfrm>
        <a:off x="799648" y="1734091"/>
        <a:ext cx="9715951" cy="692336"/>
      </dsp:txXfrm>
    </dsp:sp>
    <dsp:sp modelId="{E8791A35-BA0D-4615-804C-5D602B43D1FD}">
      <dsp:nvSpPr>
        <dsp:cNvPr id="0" name=""/>
        <dsp:cNvSpPr/>
      </dsp:nvSpPr>
      <dsp:spPr>
        <a:xfrm>
          <a:off x="0" y="2599512"/>
          <a:ext cx="10515600" cy="692336"/>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9CE926B3-8022-44B6-958B-16B76ED5140F}">
      <dsp:nvSpPr>
        <dsp:cNvPr id="0" name=""/>
        <dsp:cNvSpPr/>
      </dsp:nvSpPr>
      <dsp:spPr>
        <a:xfrm>
          <a:off x="209431" y="2755288"/>
          <a:ext cx="380785" cy="380785"/>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046A353-E5B6-409E-9CA5-D60D43A978F0}">
      <dsp:nvSpPr>
        <dsp:cNvPr id="0" name=""/>
        <dsp:cNvSpPr/>
      </dsp:nvSpPr>
      <dsp:spPr>
        <a:xfrm>
          <a:off x="799648" y="2599512"/>
          <a:ext cx="9715951" cy="6923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72" tIns="73272" rIns="73272" bIns="73272" numCol="1" spcCol="1270" anchor="ctr" anchorCtr="0">
          <a:noAutofit/>
        </a:bodyPr>
        <a:lstStyle/>
        <a:p>
          <a:pPr marL="0" lvl="0" indent="0" algn="l" defTabSz="622300">
            <a:lnSpc>
              <a:spcPct val="100000"/>
            </a:lnSpc>
            <a:spcBef>
              <a:spcPct val="0"/>
            </a:spcBef>
            <a:spcAft>
              <a:spcPct val="35000"/>
            </a:spcAft>
            <a:buNone/>
          </a:pPr>
          <a:r>
            <a:rPr lang="en-US" sz="1400" kern="1200" dirty="0"/>
            <a:t>Demonstrate empathetic communication, ethical reasoning, and collaborative clinical decision-making in the context of a biochemical disorder through a structured peer roleplay and guided reflection</a:t>
          </a:r>
        </a:p>
      </dsp:txBody>
      <dsp:txXfrm>
        <a:off x="799648" y="2599512"/>
        <a:ext cx="9715951" cy="692336"/>
      </dsp:txXfrm>
    </dsp:sp>
    <dsp:sp modelId="{5FABE087-36D9-4A98-BB89-38215F3A9867}">
      <dsp:nvSpPr>
        <dsp:cNvPr id="0" name=""/>
        <dsp:cNvSpPr/>
      </dsp:nvSpPr>
      <dsp:spPr>
        <a:xfrm>
          <a:off x="0" y="3464933"/>
          <a:ext cx="10515600" cy="692336"/>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9920F5DB-B0FF-4886-A327-D5AAC8085054}">
      <dsp:nvSpPr>
        <dsp:cNvPr id="0" name=""/>
        <dsp:cNvSpPr/>
      </dsp:nvSpPr>
      <dsp:spPr>
        <a:xfrm>
          <a:off x="209431" y="3620708"/>
          <a:ext cx="380785" cy="380785"/>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5DB7315-DC1F-481A-ACEF-1C4D779D5980}">
      <dsp:nvSpPr>
        <dsp:cNvPr id="0" name=""/>
        <dsp:cNvSpPr/>
      </dsp:nvSpPr>
      <dsp:spPr>
        <a:xfrm>
          <a:off x="799648" y="3464933"/>
          <a:ext cx="9715951" cy="6923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72" tIns="73272" rIns="73272" bIns="73272" numCol="1" spcCol="1270" anchor="ctr" anchorCtr="0">
          <a:noAutofit/>
        </a:bodyPr>
        <a:lstStyle/>
        <a:p>
          <a:pPr marL="0" lvl="0" indent="0" algn="l" defTabSz="622300">
            <a:lnSpc>
              <a:spcPct val="100000"/>
            </a:lnSpc>
            <a:spcBef>
              <a:spcPct val="0"/>
            </a:spcBef>
            <a:spcAft>
              <a:spcPct val="35000"/>
            </a:spcAft>
            <a:buNone/>
          </a:pPr>
          <a:r>
            <a:rPr lang="en-US" sz="1400" kern="1200"/>
            <a:t>Reflect on emotions, communication, and the meaning of suffering using a structured reflection format. </a:t>
          </a:r>
        </a:p>
      </dsp:txBody>
      <dsp:txXfrm>
        <a:off x="799648" y="3464933"/>
        <a:ext cx="9715951" cy="69233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B32EDF4-5FCF-4C51-B417-0B5FA52C81D0}">
      <dsp:nvSpPr>
        <dsp:cNvPr id="0" name=""/>
        <dsp:cNvSpPr/>
      </dsp:nvSpPr>
      <dsp:spPr>
        <a:xfrm>
          <a:off x="0" y="3250"/>
          <a:ext cx="10515600" cy="692336"/>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867542F-99C7-496F-B62A-4AD7E730836B}">
      <dsp:nvSpPr>
        <dsp:cNvPr id="0" name=""/>
        <dsp:cNvSpPr/>
      </dsp:nvSpPr>
      <dsp:spPr>
        <a:xfrm>
          <a:off x="209431" y="159026"/>
          <a:ext cx="380785" cy="380785"/>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468B0E3-DA4C-4C37-991D-37E58AC5D03D}">
      <dsp:nvSpPr>
        <dsp:cNvPr id="0" name=""/>
        <dsp:cNvSpPr/>
      </dsp:nvSpPr>
      <dsp:spPr>
        <a:xfrm>
          <a:off x="799648" y="3250"/>
          <a:ext cx="9715951" cy="6923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72" tIns="73272" rIns="73272" bIns="73272" numCol="1" spcCol="1270" anchor="ctr" anchorCtr="0">
          <a:noAutofit/>
        </a:bodyPr>
        <a:lstStyle/>
        <a:p>
          <a:pPr marL="0" lvl="0" indent="0" algn="l" defTabSz="622300">
            <a:lnSpc>
              <a:spcPct val="100000"/>
            </a:lnSpc>
            <a:spcBef>
              <a:spcPct val="0"/>
            </a:spcBef>
            <a:spcAft>
              <a:spcPct val="35000"/>
            </a:spcAft>
            <a:buNone/>
          </a:pPr>
          <a:r>
            <a:rPr lang="en-US" sz="1400" kern="1200"/>
            <a:t>Describe patient suffering through visual and narrative cues.</a:t>
          </a:r>
        </a:p>
      </dsp:txBody>
      <dsp:txXfrm>
        <a:off x="799648" y="3250"/>
        <a:ext cx="9715951" cy="692336"/>
      </dsp:txXfrm>
    </dsp:sp>
    <dsp:sp modelId="{F248EDA1-054C-4499-B820-0B2D01DE1EE0}">
      <dsp:nvSpPr>
        <dsp:cNvPr id="0" name=""/>
        <dsp:cNvSpPr/>
      </dsp:nvSpPr>
      <dsp:spPr>
        <a:xfrm>
          <a:off x="0" y="868671"/>
          <a:ext cx="10515600" cy="692336"/>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6104EBC7-22A0-413A-AA1A-2AF95D9EA014}">
      <dsp:nvSpPr>
        <dsp:cNvPr id="0" name=""/>
        <dsp:cNvSpPr/>
      </dsp:nvSpPr>
      <dsp:spPr>
        <a:xfrm>
          <a:off x="209431" y="1024446"/>
          <a:ext cx="380785" cy="380785"/>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478D245-EE27-4966-8C66-3C9E1C97D7C2}">
      <dsp:nvSpPr>
        <dsp:cNvPr id="0" name=""/>
        <dsp:cNvSpPr/>
      </dsp:nvSpPr>
      <dsp:spPr>
        <a:xfrm>
          <a:off x="799648" y="868671"/>
          <a:ext cx="9715951" cy="6923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72" tIns="73272" rIns="73272" bIns="73272" numCol="1" spcCol="1270" anchor="ctr" anchorCtr="0">
          <a:noAutofit/>
        </a:bodyPr>
        <a:lstStyle/>
        <a:p>
          <a:pPr marL="0" lvl="0" indent="0" algn="l" defTabSz="622300">
            <a:lnSpc>
              <a:spcPct val="100000"/>
            </a:lnSpc>
            <a:spcBef>
              <a:spcPct val="0"/>
            </a:spcBef>
            <a:spcAft>
              <a:spcPct val="35000"/>
            </a:spcAft>
            <a:buNone/>
          </a:pPr>
          <a:r>
            <a:rPr lang="en-US" sz="1400" kern="1200"/>
            <a:t>Describe the biochemical basis and key clinical features of disease presented in the case scenarios</a:t>
          </a:r>
        </a:p>
      </dsp:txBody>
      <dsp:txXfrm>
        <a:off x="799648" y="868671"/>
        <a:ext cx="9715951" cy="692336"/>
      </dsp:txXfrm>
    </dsp:sp>
    <dsp:sp modelId="{8ECD9F6A-E223-44FF-A706-13495A718931}">
      <dsp:nvSpPr>
        <dsp:cNvPr id="0" name=""/>
        <dsp:cNvSpPr/>
      </dsp:nvSpPr>
      <dsp:spPr>
        <a:xfrm>
          <a:off x="0" y="1734091"/>
          <a:ext cx="10515600" cy="692336"/>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4258B48-B7A2-415B-9D78-90A4FE2D10FD}">
      <dsp:nvSpPr>
        <dsp:cNvPr id="0" name=""/>
        <dsp:cNvSpPr/>
      </dsp:nvSpPr>
      <dsp:spPr>
        <a:xfrm>
          <a:off x="209431" y="1889867"/>
          <a:ext cx="380785" cy="380785"/>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61F49E9-9CB5-459C-BBF9-B3E7AD9F77D6}">
      <dsp:nvSpPr>
        <dsp:cNvPr id="0" name=""/>
        <dsp:cNvSpPr/>
      </dsp:nvSpPr>
      <dsp:spPr>
        <a:xfrm>
          <a:off x="799648" y="1734091"/>
          <a:ext cx="9715951" cy="6923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72" tIns="73272" rIns="73272" bIns="73272" numCol="1" spcCol="1270" anchor="ctr" anchorCtr="0">
          <a:noAutofit/>
        </a:bodyPr>
        <a:lstStyle/>
        <a:p>
          <a:pPr marL="0" lvl="0" indent="0" algn="l" defTabSz="622300">
            <a:lnSpc>
              <a:spcPct val="100000"/>
            </a:lnSpc>
            <a:spcBef>
              <a:spcPct val="0"/>
            </a:spcBef>
            <a:spcAft>
              <a:spcPct val="35000"/>
            </a:spcAft>
            <a:buNone/>
          </a:pPr>
          <a:r>
            <a:rPr lang="en-US" sz="1400" kern="1200" dirty="0"/>
            <a:t>Use Visual Thinking Strategies (VTS) and structured peer roleplays to reflect on patient and caregiver perspectives on illness and suffering.</a:t>
          </a:r>
        </a:p>
      </dsp:txBody>
      <dsp:txXfrm>
        <a:off x="799648" y="1734091"/>
        <a:ext cx="9715951" cy="692336"/>
      </dsp:txXfrm>
    </dsp:sp>
    <dsp:sp modelId="{E8791A35-BA0D-4615-804C-5D602B43D1FD}">
      <dsp:nvSpPr>
        <dsp:cNvPr id="0" name=""/>
        <dsp:cNvSpPr/>
      </dsp:nvSpPr>
      <dsp:spPr>
        <a:xfrm>
          <a:off x="0" y="2599512"/>
          <a:ext cx="10515600" cy="692336"/>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9CE926B3-8022-44B6-958B-16B76ED5140F}">
      <dsp:nvSpPr>
        <dsp:cNvPr id="0" name=""/>
        <dsp:cNvSpPr/>
      </dsp:nvSpPr>
      <dsp:spPr>
        <a:xfrm>
          <a:off x="209431" y="2755288"/>
          <a:ext cx="380785" cy="380785"/>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046A353-E5B6-409E-9CA5-D60D43A978F0}">
      <dsp:nvSpPr>
        <dsp:cNvPr id="0" name=""/>
        <dsp:cNvSpPr/>
      </dsp:nvSpPr>
      <dsp:spPr>
        <a:xfrm>
          <a:off x="799648" y="2599512"/>
          <a:ext cx="9715951" cy="6923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72" tIns="73272" rIns="73272" bIns="73272" numCol="1" spcCol="1270" anchor="ctr" anchorCtr="0">
          <a:noAutofit/>
        </a:bodyPr>
        <a:lstStyle/>
        <a:p>
          <a:pPr marL="0" lvl="0" indent="0" algn="l" defTabSz="622300">
            <a:lnSpc>
              <a:spcPct val="100000"/>
            </a:lnSpc>
            <a:spcBef>
              <a:spcPct val="0"/>
            </a:spcBef>
            <a:spcAft>
              <a:spcPct val="35000"/>
            </a:spcAft>
            <a:buNone/>
          </a:pPr>
          <a:r>
            <a:rPr lang="en-US" sz="1400" kern="1200" dirty="0"/>
            <a:t>Demonstrate empathetic communication, ethical reasoning, and collaborative clinical decision-making in the context of a biochemical disorder through a structured peer roleplay and guided reflection</a:t>
          </a:r>
        </a:p>
      </dsp:txBody>
      <dsp:txXfrm>
        <a:off x="799648" y="2599512"/>
        <a:ext cx="9715951" cy="692336"/>
      </dsp:txXfrm>
    </dsp:sp>
    <dsp:sp modelId="{5FABE087-36D9-4A98-BB89-38215F3A9867}">
      <dsp:nvSpPr>
        <dsp:cNvPr id="0" name=""/>
        <dsp:cNvSpPr/>
      </dsp:nvSpPr>
      <dsp:spPr>
        <a:xfrm>
          <a:off x="0" y="3464933"/>
          <a:ext cx="10515600" cy="692336"/>
        </a:xfrm>
        <a:prstGeom prst="roundRect">
          <a:avLst>
            <a:gd name="adj" fmla="val 10000"/>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9920F5DB-B0FF-4886-A327-D5AAC8085054}">
      <dsp:nvSpPr>
        <dsp:cNvPr id="0" name=""/>
        <dsp:cNvSpPr/>
      </dsp:nvSpPr>
      <dsp:spPr>
        <a:xfrm>
          <a:off x="209431" y="3620708"/>
          <a:ext cx="380785" cy="380785"/>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5DB7315-DC1F-481A-ACEF-1C4D779D5980}">
      <dsp:nvSpPr>
        <dsp:cNvPr id="0" name=""/>
        <dsp:cNvSpPr/>
      </dsp:nvSpPr>
      <dsp:spPr>
        <a:xfrm>
          <a:off x="799648" y="3464933"/>
          <a:ext cx="9715951" cy="6923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72" tIns="73272" rIns="73272" bIns="73272" numCol="1" spcCol="1270" anchor="ctr" anchorCtr="0">
          <a:noAutofit/>
        </a:bodyPr>
        <a:lstStyle/>
        <a:p>
          <a:pPr marL="0" lvl="0" indent="0" algn="l" defTabSz="622300">
            <a:lnSpc>
              <a:spcPct val="100000"/>
            </a:lnSpc>
            <a:spcBef>
              <a:spcPct val="0"/>
            </a:spcBef>
            <a:spcAft>
              <a:spcPct val="35000"/>
            </a:spcAft>
            <a:buNone/>
          </a:pPr>
          <a:r>
            <a:rPr lang="en-US" sz="1400" kern="1200"/>
            <a:t>Reflect on emotions, communication, and the meaning of suffering using a structured reflection format. </a:t>
          </a:r>
        </a:p>
      </dsp:txBody>
      <dsp:txXfrm>
        <a:off x="799648" y="3464933"/>
        <a:ext cx="9715951" cy="692336"/>
      </dsp:txXfrm>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2.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AAFA2F3-D736-684A-A2B7-34D19BACFAF7}" type="datetimeFigureOut">
              <a:rPr lang="en-US" smtClean="0"/>
              <a:t>3/27/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547A087-2746-DD4E-989A-A86C67D906E2}" type="slidenum">
              <a:rPr lang="en-US" smtClean="0"/>
              <a:t>‹#›</a:t>
            </a:fld>
            <a:endParaRPr lang="en-US"/>
          </a:p>
        </p:txBody>
      </p:sp>
    </p:spTree>
    <p:extLst>
      <p:ext uri="{BB962C8B-B14F-4D97-AF65-F5344CB8AC3E}">
        <p14:creationId xmlns:p14="http://schemas.microsoft.com/office/powerpoint/2010/main" val="42888904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commons.wikimedia.org/wiki/File:Edvard_Munch_-_The_Sick_Child_-_NG.M.00839_-_National_Museum_of_Art,_Architecture_and_Design.jpg"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commons.wikimedia.org/wiki/File:La_miseria_(1886)._Cristobal_Rojas.jpg"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s://commons.wikimedia.org/wiki/File:A_man_surrounded_by_a_feast_while_professing_to_have_no_appe_Wellcome_V0010997.jpg" TargetMode="External"/><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www.wikiart.org/en/pavel-fedotov/it-is-cholera-to-blame"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3" Type="http://schemas.openxmlformats.org/officeDocument/2006/relationships/hyperlink" Target="https://commons.wikimedia.org/wiki/File:Edvard_Munch_-_Inheritance.jpg" TargetMode="External"/><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commons.wikimedia.org/wiki/File:Egon_Schiele_012.jpg"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www.wikiart.org/en/frida-kahlo/the-broken-column-1944" TargetMode="External"/><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3" Type="http://schemas.openxmlformats.org/officeDocument/2006/relationships/hyperlink" Target="https://commons.wikimedia.org/wiki/File:J._Bond_Francisco_-_The_Sick_Child_-_1991.9_-_Smithsonian_American_Art_Museum.jpg" TargetMode="External"/><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3" Type="http://schemas.openxmlformats.org/officeDocument/2006/relationships/hyperlink" Target="https://commons.wikimedia.org/wiki/File:Sick-girl-christian-krohg-1881.jpg" TargetMode="External"/><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3" Type="http://schemas.openxmlformats.org/officeDocument/2006/relationships/hyperlink" Target="https://commons.wikimedia.org/wiki/File:Gabri%C3%ABl_Metsu_-_Het_zieke_kind_-_Google_Art_Project.jpg" TargetMode="External"/><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3" Type="http://schemas.openxmlformats.org/officeDocument/2006/relationships/hyperlink" Target="https://www.wikiart.org/en/frida-kahlo/henry-ford-hospital-the-flying-bed-1932" TargetMode="External"/><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3" Type="http://schemas.openxmlformats.org/officeDocument/2006/relationships/hyperlink" Target="https://commons.wikimedia.org/wiki/File:Jan_steen,_la_malata,_1660_ca.jpg" TargetMode="External"/><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to today’s session on </a:t>
            </a:r>
            <a:r>
              <a:rPr lang="en-US" i="1" dirty="0"/>
              <a:t>Art-Based Learning (ABL) for Early Clinical Exposure in Biochemistry</a:t>
            </a:r>
            <a:r>
              <a:rPr lang="en-US" dirty="0"/>
              <a:t>. The theme we’ll be exploring together is </a:t>
            </a:r>
            <a:r>
              <a:rPr lang="en-US" i="1" dirty="0"/>
              <a:t>‘Disease and Suffering – from the eyes of a patient and caregiver.’</a:t>
            </a:r>
            <a:br>
              <a:rPr lang="en-US" dirty="0"/>
            </a:br>
            <a:r>
              <a:rPr lang="en-US" dirty="0"/>
              <a:t>This session is designed to help us look at illness not just as a biochemical process, but also as a lived human experience. Through art, case scenarios, and reflection, we will connect biochemical concepts with empathy, ethics, and patient-centered care</a:t>
            </a:r>
          </a:p>
        </p:txBody>
      </p:sp>
      <p:sp>
        <p:nvSpPr>
          <p:cNvPr id="4" name="Slide Number Placeholder 3"/>
          <p:cNvSpPr>
            <a:spLocks noGrp="1"/>
          </p:cNvSpPr>
          <p:nvPr>
            <p:ph type="sldNum" sz="quarter" idx="5"/>
          </p:nvPr>
        </p:nvSpPr>
        <p:spPr/>
        <p:txBody>
          <a:bodyPr/>
          <a:lstStyle/>
          <a:p>
            <a:fld id="{6547A087-2746-DD4E-989A-A86C67D906E2}" type="slidenum">
              <a:rPr lang="en-US" smtClean="0"/>
              <a:t>1</a:t>
            </a:fld>
            <a:endParaRPr lang="en-US"/>
          </a:p>
        </p:txBody>
      </p:sp>
    </p:spTree>
    <p:extLst>
      <p:ext uri="{BB962C8B-B14F-4D97-AF65-F5344CB8AC3E}">
        <p14:creationId xmlns:p14="http://schemas.microsoft.com/office/powerpoint/2010/main" val="131535491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early read all the instructions to the faculty and allow for Q&amp;A. This is for </a:t>
            </a:r>
            <a:r>
              <a:rPr lang="en-US" b="1" dirty="0">
                <a:solidFill>
                  <a:srgbClr val="FFC000"/>
                </a:solidFill>
              </a:rPr>
              <a:t>“Session Feedback </a:t>
            </a:r>
            <a:r>
              <a:rPr lang="en-US" b="1">
                <a:solidFill>
                  <a:srgbClr val="FFC000"/>
                </a:solidFill>
              </a:rPr>
              <a:t>&amp; Confidence” </a:t>
            </a:r>
            <a:r>
              <a:rPr lang="en-US" b="1" dirty="0">
                <a:solidFill>
                  <a:srgbClr val="FFC000"/>
                </a:solidFill>
              </a:rPr>
              <a:t>part of the activity</a:t>
            </a: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10</a:t>
            </a:fld>
            <a:endParaRPr lang="en-US"/>
          </a:p>
        </p:txBody>
      </p:sp>
    </p:spTree>
    <p:extLst>
      <p:ext uri="{BB962C8B-B14F-4D97-AF65-F5344CB8AC3E}">
        <p14:creationId xmlns:p14="http://schemas.microsoft.com/office/powerpoint/2010/main" val="298204072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3D67DED-B9DB-F6A9-A0C5-E99557BDCA36}"/>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8B3D245-8EFA-33E5-A013-3F913345054A}"/>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0D762116-2BD2-09E0-F672-B3C122F0AA46}"/>
              </a:ext>
            </a:extLst>
          </p:cNvPr>
          <p:cNvSpPr>
            <a:spLocks noGrp="1"/>
          </p:cNvSpPr>
          <p:nvPr>
            <p:ph type="body" idx="1"/>
          </p:nvPr>
        </p:nvSpPr>
        <p:spPr/>
        <p:txBody>
          <a:bodyPr/>
          <a:lstStyle/>
          <a:p>
            <a:r>
              <a:rPr lang="en-US" dirty="0"/>
              <a:t>This is for the plenary session &amp; post </a:t>
            </a:r>
            <a:r>
              <a:rPr lang="en-US"/>
              <a:t>session assessment</a:t>
            </a:r>
            <a:endParaRPr lang="en-US" dirty="0"/>
          </a:p>
        </p:txBody>
      </p:sp>
      <p:sp>
        <p:nvSpPr>
          <p:cNvPr id="4" name="Slide Number Placeholder 3">
            <a:extLst>
              <a:ext uri="{FF2B5EF4-FFF2-40B4-BE49-F238E27FC236}">
                <a16:creationId xmlns:a16="http://schemas.microsoft.com/office/drawing/2014/main" id="{6DAF5F18-33AA-91A9-7117-4392A1D374BA}"/>
              </a:ext>
            </a:extLst>
          </p:cNvPr>
          <p:cNvSpPr>
            <a:spLocks noGrp="1"/>
          </p:cNvSpPr>
          <p:nvPr>
            <p:ph type="sldNum" sz="quarter" idx="5"/>
          </p:nvPr>
        </p:nvSpPr>
        <p:spPr/>
        <p:txBody>
          <a:bodyPr/>
          <a:lstStyle/>
          <a:p>
            <a:fld id="{6547A087-2746-DD4E-989A-A86C67D906E2}" type="slidenum">
              <a:rPr lang="en-US" smtClean="0"/>
              <a:t>11</a:t>
            </a:fld>
            <a:endParaRPr lang="en-US"/>
          </a:p>
        </p:txBody>
      </p:sp>
    </p:spTree>
    <p:extLst>
      <p:ext uri="{BB962C8B-B14F-4D97-AF65-F5344CB8AC3E}">
        <p14:creationId xmlns:p14="http://schemas.microsoft.com/office/powerpoint/2010/main" val="243488855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we begin exploring the artwork, let’s remember to use </a:t>
            </a:r>
            <a:r>
              <a:rPr lang="en-US" i="1" dirty="0"/>
              <a:t>Visual Thinking Strategies</a:t>
            </a:r>
            <a:r>
              <a:rPr lang="en-US" dirty="0"/>
              <a:t>. This means holding a curious and open mindset. Try not to jump to conclusions or make judgments. Instead, appreciate each perspective and focus on careful observation. Our goal is to build understanding together, by asking questions and considering multiple viewpoints</a:t>
            </a:r>
          </a:p>
        </p:txBody>
      </p:sp>
      <p:sp>
        <p:nvSpPr>
          <p:cNvPr id="4" name="Slide Number Placeholder 3"/>
          <p:cNvSpPr>
            <a:spLocks noGrp="1"/>
          </p:cNvSpPr>
          <p:nvPr>
            <p:ph type="sldNum" sz="quarter" idx="5"/>
          </p:nvPr>
        </p:nvSpPr>
        <p:spPr/>
        <p:txBody>
          <a:bodyPr/>
          <a:lstStyle/>
          <a:p>
            <a:fld id="{6547A087-2746-DD4E-989A-A86C67D906E2}" type="slidenum">
              <a:rPr lang="en-US" smtClean="0"/>
              <a:t>12</a:t>
            </a:fld>
            <a:endParaRPr lang="en-US"/>
          </a:p>
        </p:txBody>
      </p:sp>
    </p:spTree>
    <p:extLst>
      <p:ext uri="{BB962C8B-B14F-4D97-AF65-F5344CB8AC3E}">
        <p14:creationId xmlns:p14="http://schemas.microsoft.com/office/powerpoint/2010/main" val="187277632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et’s begin with a moment of quiet looking. Please take about one to two minutes just to observe the image in silence. Notice details, shapes, colors, emotions, or anything that stands out to you, without analyzing or interpreting yet. This pause helps us slow down and truly see before we begin discussing</a:t>
            </a:r>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13</a:t>
            </a:fld>
            <a:endParaRPr lang="en-US"/>
          </a:p>
        </p:txBody>
      </p:sp>
    </p:spTree>
    <p:extLst>
      <p:ext uri="{BB962C8B-B14F-4D97-AF65-F5344CB8AC3E}">
        <p14:creationId xmlns:p14="http://schemas.microsoft.com/office/powerpoint/2010/main" val="421098779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300" b="1" dirty="0"/>
              <a:t>FIRST QUESTION</a:t>
            </a:r>
            <a:endParaRPr lang="en-IN" sz="1300" dirty="0"/>
          </a:p>
          <a:p>
            <a:r>
              <a:rPr lang="en-US" sz="1300" b="1" dirty="0"/>
              <a:t>1.</a:t>
            </a:r>
            <a:r>
              <a:rPr lang="en-US" sz="1300" dirty="0"/>
              <a:t> </a:t>
            </a:r>
            <a:r>
              <a:rPr lang="en-US" sz="1300" b="1" dirty="0"/>
              <a:t>What's going on in this picture?</a:t>
            </a:r>
            <a:endParaRPr lang="en-IN" sz="1300" dirty="0"/>
          </a:p>
          <a:p>
            <a:r>
              <a:rPr lang="en-US" sz="1300" dirty="0"/>
              <a:t>Observe all details without rushing.</a:t>
            </a:r>
            <a:endParaRPr lang="en-IN" sz="1300" dirty="0"/>
          </a:p>
          <a:p>
            <a:r>
              <a:rPr lang="en-US" sz="1300" dirty="0"/>
              <a:t>Describe what you see without judgments or assumptions.</a:t>
            </a:r>
            <a:endParaRPr lang="en-IN" sz="1300" dirty="0"/>
          </a:p>
          <a:p>
            <a:r>
              <a:rPr lang="en-US" sz="1300" dirty="0"/>
              <a:t>Allow others to share their observations for diverse inputs.</a:t>
            </a:r>
            <a:endParaRPr lang="en-IN" sz="1300" dirty="0"/>
          </a:p>
          <a:p>
            <a:r>
              <a:rPr lang="en-US" sz="1300" dirty="0"/>
              <a:t>Focus on visible elements, not imagined stories.</a:t>
            </a:r>
            <a:endParaRPr lang="en-IN" sz="1300" dirty="0"/>
          </a:p>
          <a:p>
            <a:endParaRPr lang="en-IN" dirty="0"/>
          </a:p>
        </p:txBody>
      </p:sp>
      <p:sp>
        <p:nvSpPr>
          <p:cNvPr id="4" name="Slide Number Placeholder 3"/>
          <p:cNvSpPr>
            <a:spLocks noGrp="1"/>
          </p:cNvSpPr>
          <p:nvPr>
            <p:ph type="sldNum" sz="quarter" idx="10"/>
          </p:nvPr>
        </p:nvSpPr>
        <p:spPr/>
        <p:txBody>
          <a:bodyPr/>
          <a:lstStyle/>
          <a:p>
            <a:fld id="{420A8A88-CBCF-4C81-B95E-852EB1664CB8}" type="slidenum">
              <a:rPr lang="en-IN" smtClean="0"/>
              <a:t>14</a:t>
            </a:fld>
            <a:endParaRPr lang="en-IN"/>
          </a:p>
        </p:txBody>
      </p:sp>
    </p:spTree>
    <p:extLst>
      <p:ext uri="{BB962C8B-B14F-4D97-AF65-F5344CB8AC3E}">
        <p14:creationId xmlns:p14="http://schemas.microsoft.com/office/powerpoint/2010/main" val="315641617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300" b="1" dirty="0"/>
              <a:t>SECOND QUESTION</a:t>
            </a:r>
            <a:endParaRPr lang="en-IN" sz="1300" dirty="0"/>
          </a:p>
          <a:p>
            <a:r>
              <a:rPr lang="en-US" sz="1300" b="1" dirty="0"/>
              <a:t>2.</a:t>
            </a:r>
            <a:r>
              <a:rPr lang="en-US" sz="1300" dirty="0"/>
              <a:t>  </a:t>
            </a:r>
            <a:r>
              <a:rPr lang="en-US" sz="1300" b="1" dirty="0"/>
              <a:t>What do you see what makes you say that?</a:t>
            </a:r>
            <a:endParaRPr lang="en-IN" sz="1300" dirty="0"/>
          </a:p>
          <a:p>
            <a:r>
              <a:rPr lang="en-US" sz="1300" dirty="0"/>
              <a:t>Identify specific details in the image that support your interpretation.</a:t>
            </a:r>
            <a:endParaRPr lang="en-IN" sz="1300" dirty="0"/>
          </a:p>
          <a:p>
            <a:r>
              <a:rPr lang="en-US" sz="1300" dirty="0"/>
              <a:t>Connect your observations to your reasoning.</a:t>
            </a:r>
            <a:endParaRPr lang="en-IN" sz="1300" dirty="0"/>
          </a:p>
          <a:p>
            <a:r>
              <a:rPr lang="en-US" sz="1300" dirty="0"/>
              <a:t>Avoid generalizations; focus on concrete elements.</a:t>
            </a:r>
            <a:endParaRPr lang="en-IN" sz="1300" dirty="0"/>
          </a:p>
          <a:p>
            <a:r>
              <a:rPr lang="en-US" sz="1300" dirty="0"/>
              <a:t>Explain the "why" to deepen understanding and discussion.</a:t>
            </a:r>
            <a:endParaRPr lang="en-IN" sz="1300" dirty="0"/>
          </a:p>
          <a:p>
            <a:endParaRPr lang="en-IN" dirty="0"/>
          </a:p>
        </p:txBody>
      </p:sp>
      <p:sp>
        <p:nvSpPr>
          <p:cNvPr id="4" name="Slide Number Placeholder 3"/>
          <p:cNvSpPr>
            <a:spLocks noGrp="1"/>
          </p:cNvSpPr>
          <p:nvPr>
            <p:ph type="sldNum" sz="quarter" idx="10"/>
          </p:nvPr>
        </p:nvSpPr>
        <p:spPr/>
        <p:txBody>
          <a:bodyPr/>
          <a:lstStyle/>
          <a:p>
            <a:fld id="{420A8A88-CBCF-4C81-B95E-852EB1664CB8}" type="slidenum">
              <a:rPr lang="en-IN" smtClean="0"/>
              <a:t>15</a:t>
            </a:fld>
            <a:endParaRPr lang="en-IN"/>
          </a:p>
        </p:txBody>
      </p:sp>
    </p:spTree>
    <p:extLst>
      <p:ext uri="{BB962C8B-B14F-4D97-AF65-F5344CB8AC3E}">
        <p14:creationId xmlns:p14="http://schemas.microsoft.com/office/powerpoint/2010/main" val="298552076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300" b="1" dirty="0"/>
              <a:t>THIRD QUESTION: </a:t>
            </a:r>
            <a:endParaRPr lang="en-IN" sz="1300" dirty="0"/>
          </a:p>
          <a:p>
            <a:r>
              <a:rPr lang="en-US" sz="1300" b="1" dirty="0"/>
              <a:t>3.  What more can we find?</a:t>
            </a:r>
            <a:endParaRPr lang="en-IN" sz="1300" dirty="0"/>
          </a:p>
          <a:p>
            <a:r>
              <a:rPr lang="en-US" sz="1300" dirty="0"/>
              <a:t>Look beyond your initial observations for additional details.</a:t>
            </a:r>
            <a:endParaRPr lang="en-IN" sz="1300" dirty="0"/>
          </a:p>
          <a:p>
            <a:r>
              <a:rPr lang="en-US" sz="1300" dirty="0"/>
              <a:t>Revisit the image with fresh eyes, focusing on overlooked elements.</a:t>
            </a:r>
            <a:endParaRPr lang="en-IN" sz="1300" dirty="0"/>
          </a:p>
          <a:p>
            <a:r>
              <a:rPr lang="en-US" sz="1300" dirty="0"/>
              <a:t>Encourage others to share their insights or perspectives.</a:t>
            </a:r>
            <a:endParaRPr lang="en-IN" sz="1300" dirty="0"/>
          </a:p>
          <a:p>
            <a:r>
              <a:rPr lang="en-US" sz="1300" dirty="0"/>
              <a:t>Explore new interpretations and deeper meanings as a group.</a:t>
            </a:r>
            <a:endParaRPr lang="en-IN" sz="1300" dirty="0"/>
          </a:p>
          <a:p>
            <a:endParaRPr lang="en-IN" dirty="0"/>
          </a:p>
        </p:txBody>
      </p:sp>
      <p:sp>
        <p:nvSpPr>
          <p:cNvPr id="4" name="Slide Number Placeholder 3"/>
          <p:cNvSpPr>
            <a:spLocks noGrp="1"/>
          </p:cNvSpPr>
          <p:nvPr>
            <p:ph type="sldNum" sz="quarter" idx="10"/>
          </p:nvPr>
        </p:nvSpPr>
        <p:spPr/>
        <p:txBody>
          <a:bodyPr/>
          <a:lstStyle/>
          <a:p>
            <a:fld id="{420A8A88-CBCF-4C81-B95E-852EB1664CB8}" type="slidenum">
              <a:rPr lang="en-IN" smtClean="0"/>
              <a:t>16</a:t>
            </a:fld>
            <a:endParaRPr lang="en-IN"/>
          </a:p>
        </p:txBody>
      </p:sp>
    </p:spTree>
    <p:extLst>
      <p:ext uri="{BB962C8B-B14F-4D97-AF65-F5344CB8AC3E}">
        <p14:creationId xmlns:p14="http://schemas.microsoft.com/office/powerpoint/2010/main" val="272094904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faculty should paraphrase each comment shared by learners. Restate their observation in simple terms, acknowledge it, and, where possible, connect it to earlier points. This reinforces active listening and encourages further contributions</a:t>
            </a:r>
          </a:p>
        </p:txBody>
      </p:sp>
      <p:sp>
        <p:nvSpPr>
          <p:cNvPr id="4" name="Slide Number Placeholder 3"/>
          <p:cNvSpPr>
            <a:spLocks noGrp="1"/>
          </p:cNvSpPr>
          <p:nvPr>
            <p:ph type="sldNum" sz="quarter" idx="5"/>
          </p:nvPr>
        </p:nvSpPr>
        <p:spPr/>
        <p:txBody>
          <a:bodyPr/>
          <a:lstStyle/>
          <a:p>
            <a:fld id="{6547A087-2746-DD4E-989A-A86C67D906E2}" type="slidenum">
              <a:rPr lang="en-US" smtClean="0"/>
              <a:t>17</a:t>
            </a:fld>
            <a:endParaRPr lang="en-US"/>
          </a:p>
        </p:txBody>
      </p:sp>
    </p:spTree>
    <p:extLst>
      <p:ext uri="{BB962C8B-B14F-4D97-AF65-F5344CB8AC3E}">
        <p14:creationId xmlns:p14="http://schemas.microsoft.com/office/powerpoint/2010/main" val="77068109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we begin our Art-Based Learning activity.</a:t>
            </a:r>
          </a:p>
        </p:txBody>
      </p:sp>
      <p:sp>
        <p:nvSpPr>
          <p:cNvPr id="4" name="Slide Number Placeholder 3"/>
          <p:cNvSpPr>
            <a:spLocks noGrp="1"/>
          </p:cNvSpPr>
          <p:nvPr>
            <p:ph type="sldNum" sz="quarter" idx="5"/>
          </p:nvPr>
        </p:nvSpPr>
        <p:spPr/>
        <p:txBody>
          <a:bodyPr/>
          <a:lstStyle/>
          <a:p>
            <a:fld id="{6547A087-2746-DD4E-989A-A86C67D906E2}" type="slidenum">
              <a:rPr lang="en-US" smtClean="0"/>
              <a:t>18</a:t>
            </a:fld>
            <a:endParaRPr lang="en-US"/>
          </a:p>
        </p:txBody>
      </p:sp>
    </p:spTree>
    <p:extLst>
      <p:ext uri="{BB962C8B-B14F-4D97-AF65-F5344CB8AC3E}">
        <p14:creationId xmlns:p14="http://schemas.microsoft.com/office/powerpoint/2010/main" val="334122976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RT 1, Group 1 will get this art and subsequent resources (appendix 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Image by [EASTMAN JOHNSON], retrieved from: [https://</a:t>
            </a:r>
            <a:r>
              <a:rPr lang="en-US" sz="1800" kern="100" dirty="0" err="1">
                <a:effectLst/>
                <a:latin typeface="Times New Roman" panose="02020603050405020304" pitchFamily="18" charset="0"/>
                <a:ea typeface="Aptos" panose="020B0004020202020204" pitchFamily="34" charset="0"/>
                <a:cs typeface="Times New Roman" panose="02020603050405020304" pitchFamily="18" charset="0"/>
              </a:rPr>
              <a:t>commons.wikimedia.org</a:t>
            </a: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wiki/File:Eastman_Johnson_-_The_Field_Hospital_-_48.434_-_Museum_of_Fine_Arts.jpg]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19</a:t>
            </a:fld>
            <a:endParaRPr lang="en-US"/>
          </a:p>
        </p:txBody>
      </p:sp>
    </p:spTree>
    <p:extLst>
      <p:ext uri="{BB962C8B-B14F-4D97-AF65-F5344CB8AC3E}">
        <p14:creationId xmlns:p14="http://schemas.microsoft.com/office/powerpoint/2010/main" val="192049333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out the learning objectives of the session</a:t>
            </a:r>
          </a:p>
        </p:txBody>
      </p:sp>
      <p:sp>
        <p:nvSpPr>
          <p:cNvPr id="4" name="Slide Number Placeholder 3"/>
          <p:cNvSpPr>
            <a:spLocks noGrp="1"/>
          </p:cNvSpPr>
          <p:nvPr>
            <p:ph type="sldNum" sz="quarter" idx="5"/>
          </p:nvPr>
        </p:nvSpPr>
        <p:spPr/>
        <p:txBody>
          <a:bodyPr/>
          <a:lstStyle/>
          <a:p>
            <a:fld id="{6547A087-2746-DD4E-989A-A86C67D906E2}" type="slidenum">
              <a:rPr lang="en-US" smtClean="0"/>
              <a:t>2</a:t>
            </a:fld>
            <a:endParaRPr lang="en-US"/>
          </a:p>
        </p:txBody>
      </p:sp>
    </p:spTree>
    <p:extLst>
      <p:ext uri="{BB962C8B-B14F-4D97-AF65-F5344CB8AC3E}">
        <p14:creationId xmlns:p14="http://schemas.microsoft.com/office/powerpoint/2010/main" val="20624758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2, Group 2 will get this art and subsequent resources (appendix 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EDVARD MUNCH],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commons.wikimedia.org/wiki/File:Edvard_Munch_-_The_Sick_Child_-_NG.M.00839_-_National_Museum_of_Art,_Architecture_and_Design.jp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20</a:t>
            </a:fld>
            <a:endParaRPr lang="en-US"/>
          </a:p>
        </p:txBody>
      </p:sp>
    </p:spTree>
    <p:extLst>
      <p:ext uri="{BB962C8B-B14F-4D97-AF65-F5344CB8AC3E}">
        <p14:creationId xmlns:p14="http://schemas.microsoft.com/office/powerpoint/2010/main" val="235111631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3,  Group 3 will get this art and subsequent resources (appendix 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CRISTOBAL ROJAS],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commons.wikimedia.org/wiki/File:La_miseria_(1886)._Cristobal_Rojas.jp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21</a:t>
            </a:fld>
            <a:endParaRPr lang="en-US"/>
          </a:p>
        </p:txBody>
      </p:sp>
    </p:spTree>
    <p:extLst>
      <p:ext uri="{BB962C8B-B14F-4D97-AF65-F5344CB8AC3E}">
        <p14:creationId xmlns:p14="http://schemas.microsoft.com/office/powerpoint/2010/main" val="227595923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4, Group 4 will get this art and subsequent resources (appendix D)</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a:t>
            </a:r>
            <a:r>
              <a:rPr lang="en-US" sz="1800" kern="100" dirty="0">
                <a:solidFill>
                  <a:srgbClr val="202122"/>
                </a:solidFill>
                <a:effectLst/>
                <a:latin typeface="Arial" panose="020B0604020202020204" pitchFamily="34" charset="0"/>
                <a:ea typeface="Aptos" panose="020B0004020202020204" pitchFamily="34" charset="0"/>
                <a:cs typeface="Times New Roman" panose="02020603050405020304" pitchFamily="18" charset="0"/>
              </a:rPr>
              <a:t>WELLCOME TRUST</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commons.wikimedia.org/wiki/File:A_man_surrounded_by_a_feast_while_professing_to_have_no_appe_Wellcome_V0010997.jp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Creative Commons License associated: [https://</a:t>
            </a:r>
            <a:r>
              <a:rPr lang="en-US" sz="1800" kern="100" dirty="0" err="1">
                <a:solidFill>
                  <a:srgbClr val="333333"/>
                </a:solidFill>
                <a:effectLst/>
                <a:latin typeface="Arial" panose="020B0604020202020204" pitchFamily="34" charset="0"/>
                <a:ea typeface="Aptos" panose="020B0004020202020204" pitchFamily="34" charset="0"/>
                <a:cs typeface="Times New Roman" panose="02020603050405020304" pitchFamily="18" charset="0"/>
              </a:rPr>
              <a:t>creativecommons.or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licenses/by/2.0/</a:t>
            </a:r>
            <a:r>
              <a:rPr lang="en-US" sz="1800" kern="100" dirty="0" err="1">
                <a:solidFill>
                  <a:srgbClr val="333333"/>
                </a:solidFill>
                <a:effectLst/>
                <a:latin typeface="Arial" panose="020B0604020202020204" pitchFamily="34" charset="0"/>
                <a:ea typeface="Aptos" panose="020B0004020202020204" pitchFamily="34" charset="0"/>
                <a:cs typeface="Times New Roman" panose="02020603050405020304" pitchFamily="18" charset="0"/>
              </a:rPr>
              <a:t>deed.en</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22</a:t>
            </a:fld>
            <a:endParaRPr lang="en-US"/>
          </a:p>
        </p:txBody>
      </p:sp>
    </p:spTree>
    <p:extLst>
      <p:ext uri="{BB962C8B-B14F-4D97-AF65-F5344CB8AC3E}">
        <p14:creationId xmlns:p14="http://schemas.microsoft.com/office/powerpoint/2010/main" val="174722854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5, Group 5 will get this art and subsequent resources (appendix 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PAVEL FEDOTOV],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www.wikiart.org/en/pavel-fedotov/it-is-cholera-to-blame</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23</a:t>
            </a:fld>
            <a:endParaRPr lang="en-US"/>
          </a:p>
        </p:txBody>
      </p:sp>
    </p:spTree>
    <p:extLst>
      <p:ext uri="{BB962C8B-B14F-4D97-AF65-F5344CB8AC3E}">
        <p14:creationId xmlns:p14="http://schemas.microsoft.com/office/powerpoint/2010/main" val="399142230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6, Group 6 will get this art and subsequent resources (appendix D)</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EDVARD MUNCH],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commons.wikimedia.org/wiki/File:Edvard_Munch_-_Inheritance.jp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24</a:t>
            </a:fld>
            <a:endParaRPr lang="en-US"/>
          </a:p>
        </p:txBody>
      </p:sp>
    </p:spTree>
    <p:extLst>
      <p:ext uri="{BB962C8B-B14F-4D97-AF65-F5344CB8AC3E}">
        <p14:creationId xmlns:p14="http://schemas.microsoft.com/office/powerpoint/2010/main" val="36011732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7, Group 7 will get this art and subsequent resources (appendix 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EGON SCHIELE],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commons.wikimedia.org/wiki/File:Egon_Schiele_012.jp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25</a:t>
            </a:fld>
            <a:endParaRPr lang="en-US"/>
          </a:p>
        </p:txBody>
      </p:sp>
    </p:spTree>
    <p:extLst>
      <p:ext uri="{BB962C8B-B14F-4D97-AF65-F5344CB8AC3E}">
        <p14:creationId xmlns:p14="http://schemas.microsoft.com/office/powerpoint/2010/main" val="35292962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8, Group 8 will get this art and subsequent resources (appendix 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FRIDA KAHLO],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www.wikiart.org/en/frida-kahlo/the-broken-column-1944</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26</a:t>
            </a:fld>
            <a:endParaRPr lang="en-US"/>
          </a:p>
        </p:txBody>
      </p:sp>
    </p:spTree>
    <p:extLst>
      <p:ext uri="{BB962C8B-B14F-4D97-AF65-F5344CB8AC3E}">
        <p14:creationId xmlns:p14="http://schemas.microsoft.com/office/powerpoint/2010/main" val="128878884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9, Group 9 will get this art and subsequent resources (appendix 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EGON SCHIELE], retrieved from: [https://</a:t>
            </a:r>
            <a:r>
              <a:rPr lang="en-US" sz="1800" kern="100" dirty="0" err="1">
                <a:solidFill>
                  <a:srgbClr val="333333"/>
                </a:solidFill>
                <a:effectLst/>
                <a:latin typeface="Arial" panose="020B0604020202020204" pitchFamily="34" charset="0"/>
                <a:ea typeface="Aptos" panose="020B0004020202020204" pitchFamily="34" charset="0"/>
                <a:cs typeface="Times New Roman" panose="02020603050405020304" pitchFamily="18" charset="0"/>
              </a:rPr>
              <a:t>commons.wikimedia.or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wiki/</a:t>
            </a:r>
            <a:r>
              <a:rPr lang="en-US" sz="1800" kern="100" dirty="0" err="1">
                <a:solidFill>
                  <a:srgbClr val="333333"/>
                </a:solidFill>
                <a:effectLst/>
                <a:latin typeface="Arial" panose="020B0604020202020204" pitchFamily="34" charset="0"/>
                <a:ea typeface="Aptos" panose="020B0004020202020204" pitchFamily="34" charset="0"/>
                <a:cs typeface="Times New Roman" panose="02020603050405020304" pitchFamily="18" charset="0"/>
              </a:rPr>
              <a:t>File:Schiele</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_-_</a:t>
            </a:r>
            <a:r>
              <a:rPr lang="en-US" sz="1800" kern="100" dirty="0" err="1">
                <a:solidFill>
                  <a:srgbClr val="333333"/>
                </a:solidFill>
                <a:effectLst/>
                <a:latin typeface="Arial" panose="020B0604020202020204" pitchFamily="34" charset="0"/>
                <a:ea typeface="Aptos" panose="020B0004020202020204" pitchFamily="34" charset="0"/>
                <a:cs typeface="Times New Roman" panose="02020603050405020304" pitchFamily="18" charset="0"/>
              </a:rPr>
              <a:t>Selbstbildnis_mit_Händen_vor_der_Brust.jp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27</a:t>
            </a:fld>
            <a:endParaRPr lang="en-US"/>
          </a:p>
        </p:txBody>
      </p:sp>
    </p:spTree>
    <p:extLst>
      <p:ext uri="{BB962C8B-B14F-4D97-AF65-F5344CB8AC3E}">
        <p14:creationId xmlns:p14="http://schemas.microsoft.com/office/powerpoint/2010/main" val="61245011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10, Group 10 will get this art and subsequent resources (appendix 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EGON SCHIELE], retrieved from: [https://</a:t>
            </a:r>
            <a:r>
              <a:rPr lang="en-US" sz="1800" kern="100" dirty="0" err="1">
                <a:solidFill>
                  <a:srgbClr val="333333"/>
                </a:solidFill>
                <a:effectLst/>
                <a:latin typeface="Arial" panose="020B0604020202020204" pitchFamily="34" charset="0"/>
                <a:ea typeface="Aptos" panose="020B0004020202020204" pitchFamily="34" charset="0"/>
                <a:cs typeface="Times New Roman" panose="02020603050405020304" pitchFamily="18" charset="0"/>
              </a:rPr>
              <a:t>commons.wikimedia.or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wiki/File:Egon_Schiele_-_</a:t>
            </a:r>
            <a:r>
              <a:rPr lang="en-US" sz="1800" kern="100" dirty="0" err="1">
                <a:solidFill>
                  <a:srgbClr val="333333"/>
                </a:solidFill>
                <a:effectLst/>
                <a:latin typeface="Arial" panose="020B0604020202020204" pitchFamily="34" charset="0"/>
                <a:ea typeface="Aptos" panose="020B0004020202020204" pitchFamily="34" charset="0"/>
                <a:cs typeface="Times New Roman" panose="02020603050405020304" pitchFamily="18" charset="0"/>
              </a:rPr>
              <a:t>Kauerndes_Menschenpaar</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_(</a:t>
            </a:r>
            <a:r>
              <a:rPr lang="en-US" sz="1800" kern="100" dirty="0" err="1">
                <a:solidFill>
                  <a:srgbClr val="333333"/>
                </a:solidFill>
                <a:effectLst/>
                <a:latin typeface="Arial" panose="020B0604020202020204" pitchFamily="34" charset="0"/>
                <a:ea typeface="Aptos" panose="020B0004020202020204" pitchFamily="34" charset="0"/>
                <a:cs typeface="Times New Roman" panose="02020603050405020304" pitchFamily="18" charset="0"/>
              </a:rPr>
              <a:t>Die_Familie</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_-_4277_-_Österreichische_Galerie_Belvedere.jpg]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28</a:t>
            </a:fld>
            <a:endParaRPr lang="en-US"/>
          </a:p>
        </p:txBody>
      </p:sp>
    </p:spTree>
    <p:extLst>
      <p:ext uri="{BB962C8B-B14F-4D97-AF65-F5344CB8AC3E}">
        <p14:creationId xmlns:p14="http://schemas.microsoft.com/office/powerpoint/2010/main" val="217281839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11, Group 11 will get this art and subsequent resources (appendix 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JOHN BOND FRANCISCO],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commons.wikimedia.org/wiki/File:J._Bond_Francisco_-_The_Sick_Child_-_1991.9_-_Smithsonian_American_Art_Museum.jp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29</a:t>
            </a:fld>
            <a:endParaRPr lang="en-US"/>
          </a:p>
        </p:txBody>
      </p:sp>
    </p:spTree>
    <p:extLst>
      <p:ext uri="{BB962C8B-B14F-4D97-AF65-F5344CB8AC3E}">
        <p14:creationId xmlns:p14="http://schemas.microsoft.com/office/powerpoint/2010/main" val="334714083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early read all the instructions to the faculty and allow for Q&amp;A</a:t>
            </a:r>
          </a:p>
        </p:txBody>
      </p:sp>
      <p:sp>
        <p:nvSpPr>
          <p:cNvPr id="4" name="Slide Number Placeholder 3"/>
          <p:cNvSpPr>
            <a:spLocks noGrp="1"/>
          </p:cNvSpPr>
          <p:nvPr>
            <p:ph type="sldNum" sz="quarter" idx="5"/>
          </p:nvPr>
        </p:nvSpPr>
        <p:spPr/>
        <p:txBody>
          <a:bodyPr/>
          <a:lstStyle/>
          <a:p>
            <a:fld id="{6547A087-2746-DD4E-989A-A86C67D906E2}" type="slidenum">
              <a:rPr lang="en-US" smtClean="0"/>
              <a:t>3</a:t>
            </a:fld>
            <a:endParaRPr lang="en-US"/>
          </a:p>
        </p:txBody>
      </p:sp>
    </p:spTree>
    <p:extLst>
      <p:ext uri="{BB962C8B-B14F-4D97-AF65-F5344CB8AC3E}">
        <p14:creationId xmlns:p14="http://schemas.microsoft.com/office/powerpoint/2010/main" val="76280402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12, Group 12 will get this art and subsequent resources (appendix 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CHRISTIAN KROHG],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commons.wikimedia.org/wiki/File:Sick-girl-christian-krohg-1881.jp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30</a:t>
            </a:fld>
            <a:endParaRPr lang="en-US"/>
          </a:p>
        </p:txBody>
      </p:sp>
    </p:spTree>
    <p:extLst>
      <p:ext uri="{BB962C8B-B14F-4D97-AF65-F5344CB8AC3E}">
        <p14:creationId xmlns:p14="http://schemas.microsoft.com/office/powerpoint/2010/main" val="413103411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13, Group 13 will get this art and subsequent resources (appendix D)</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GABRIËL METSU],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commons.wikimedia.org/wiki/File:Gabriël_Metsu_-_Het_zieke_kind_-_Google_Art_Project.jp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31</a:t>
            </a:fld>
            <a:endParaRPr lang="en-US"/>
          </a:p>
        </p:txBody>
      </p:sp>
    </p:spTree>
    <p:extLst>
      <p:ext uri="{BB962C8B-B14F-4D97-AF65-F5344CB8AC3E}">
        <p14:creationId xmlns:p14="http://schemas.microsoft.com/office/powerpoint/2010/main" val="2663004147"/>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14, Group 14 will get this art and subsequent resources (appendix D)</a:t>
            </a:r>
          </a:p>
          <a:p>
            <a:pPr marL="0" marR="0">
              <a:lnSpc>
                <a:spcPct val="115000"/>
              </a:lnSpc>
              <a:spcBef>
                <a:spcPts val="0"/>
              </a:spcBef>
              <a:spcAft>
                <a:spcPts val="800"/>
              </a:spcAft>
            </a:pPr>
            <a:r>
              <a:rPr lang="en-US" sz="1800" kern="100" dirty="0">
                <a:effectLst/>
                <a:latin typeface="Times New Roman" panose="02020603050405020304" pitchFamily="18" charset="0"/>
                <a:ea typeface="Aptos" panose="020B0004020202020204" pitchFamily="34" charset="0"/>
                <a:cs typeface="Times New Roman" panose="02020603050405020304" pitchFamily="18" charset="0"/>
              </a:rPr>
              <a:t> </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15000"/>
              </a:lnSpc>
              <a:spcBef>
                <a:spcPts val="0"/>
              </a:spcBef>
              <a:spcAft>
                <a:spcPts val="800"/>
              </a:spcAft>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FRIDA KAHLO],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www.wikiart.org/en/frida-kahlo/henry-ford-hospital-the-flying-bed-1932</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Image is in the public domain</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32</a:t>
            </a:fld>
            <a:endParaRPr lang="en-US"/>
          </a:p>
        </p:txBody>
      </p:sp>
    </p:spTree>
    <p:extLst>
      <p:ext uri="{BB962C8B-B14F-4D97-AF65-F5344CB8AC3E}">
        <p14:creationId xmlns:p14="http://schemas.microsoft.com/office/powerpoint/2010/main" val="3404836585"/>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RT 15, Group 15 will get this art and subsequent resources (appendix 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Image by [SAILKO], retrieved from: [</a:t>
            </a:r>
            <a:r>
              <a:rPr lang="en-US" sz="1800" u="sng" kern="100" dirty="0">
                <a:solidFill>
                  <a:srgbClr val="467886"/>
                </a:solidFill>
                <a:effectLst/>
                <a:latin typeface="Aptos" panose="020B0004020202020204" pitchFamily="34" charset="0"/>
                <a:ea typeface="Aptos" panose="020B0004020202020204" pitchFamily="34" charset="0"/>
                <a:cs typeface="Times New Roman" panose="02020603050405020304" pitchFamily="18" charset="0"/>
                <a:hlinkClick r:id="rId3"/>
              </a:rPr>
              <a:t>https://commons.wikimedia.org/wiki/File:Jan_steen,_la_malata,_1660_ca.jp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 on [12/09/2025]. Creative Commons License associated: [https://</a:t>
            </a:r>
            <a:r>
              <a:rPr lang="en-US" sz="1800" kern="100" dirty="0" err="1">
                <a:solidFill>
                  <a:srgbClr val="333333"/>
                </a:solidFill>
                <a:effectLst/>
                <a:latin typeface="Arial" panose="020B0604020202020204" pitchFamily="34" charset="0"/>
                <a:ea typeface="Aptos" panose="020B0004020202020204" pitchFamily="34" charset="0"/>
                <a:cs typeface="Times New Roman" panose="02020603050405020304" pitchFamily="18" charset="0"/>
              </a:rPr>
              <a:t>creativecommons.org</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licenses/by/3.0/</a:t>
            </a:r>
            <a:r>
              <a:rPr lang="en-US" sz="1800" kern="100" dirty="0" err="1">
                <a:solidFill>
                  <a:srgbClr val="333333"/>
                </a:solidFill>
                <a:effectLst/>
                <a:latin typeface="Arial" panose="020B0604020202020204" pitchFamily="34" charset="0"/>
                <a:ea typeface="Aptos" panose="020B0004020202020204" pitchFamily="34" charset="0"/>
                <a:cs typeface="Times New Roman" panose="02020603050405020304" pitchFamily="18" charset="0"/>
              </a:rPr>
              <a:t>deed.en</a:t>
            </a:r>
            <a:r>
              <a:rPr lang="en-US" sz="1800" kern="100" dirty="0">
                <a:solidFill>
                  <a:srgbClr val="333333"/>
                </a:solidFill>
                <a:effectLst/>
                <a:latin typeface="Arial" panose="020B0604020202020204" pitchFamily="34" charset="0"/>
                <a:ea typeface="Aptos" panose="020B0004020202020204" pitchFamily="34" charset="0"/>
                <a:cs typeface="Times New Roman" panose="02020603050405020304" pitchFamily="18" charset="0"/>
              </a:rPr>
              <a:t>].”</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33</a:t>
            </a:fld>
            <a:endParaRPr lang="en-US"/>
          </a:p>
        </p:txBody>
      </p:sp>
    </p:spTree>
    <p:extLst>
      <p:ext uri="{BB962C8B-B14F-4D97-AF65-F5344CB8AC3E}">
        <p14:creationId xmlns:p14="http://schemas.microsoft.com/office/powerpoint/2010/main" val="414047257"/>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4B4C939-A44A-05ED-7985-20EA77657665}"/>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745600F-8F6C-657F-4E6A-0EBAC80A080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21859289-B7BD-ADBC-B478-8208CE584F1E}"/>
              </a:ext>
            </a:extLst>
          </p:cNvPr>
          <p:cNvSpPr>
            <a:spLocks noGrp="1"/>
          </p:cNvSpPr>
          <p:nvPr>
            <p:ph type="body" idx="1"/>
          </p:nvPr>
        </p:nvSpPr>
        <p:spPr/>
        <p:txBody>
          <a:bodyPr/>
          <a:lstStyle/>
          <a:p>
            <a:r>
              <a:rPr lang="en-US" dirty="0"/>
              <a:t>Read out the learning objectives of the session</a:t>
            </a:r>
          </a:p>
        </p:txBody>
      </p:sp>
      <p:sp>
        <p:nvSpPr>
          <p:cNvPr id="4" name="Slide Number Placeholder 3">
            <a:extLst>
              <a:ext uri="{FF2B5EF4-FFF2-40B4-BE49-F238E27FC236}">
                <a16:creationId xmlns:a16="http://schemas.microsoft.com/office/drawing/2014/main" id="{965ADE2F-2704-F4F3-7005-2387709A522D}"/>
              </a:ext>
            </a:extLst>
          </p:cNvPr>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6547A087-2746-DD4E-989A-A86C67D906E2}" type="slidenum">
              <a:rPr kumimoji="0" lang="en-US" sz="1200" b="0" i="0" u="none" strike="noStrike" kern="1200" cap="none" spc="0" normalizeH="0" baseline="0" noProof="0" smtClean="0">
                <a:ln>
                  <a:noFill/>
                </a:ln>
                <a:solidFill>
                  <a:prstClr val="black"/>
                </a:solidFill>
                <a:effectLst/>
                <a:uLnTx/>
                <a:uFillTx/>
                <a:latin typeface="Aptos"/>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4</a:t>
            </a:fld>
            <a:endParaRPr kumimoji="0" lang="en-US" sz="1200" b="0" i="0" u="none" strike="noStrike" kern="1200" cap="none" spc="0" normalizeH="0" baseline="0" noProof="0">
              <a:ln>
                <a:noFill/>
              </a:ln>
              <a:solidFill>
                <a:prstClr val="black"/>
              </a:solidFill>
              <a:effectLst/>
              <a:uLnTx/>
              <a:uFillTx/>
              <a:latin typeface="Aptos"/>
              <a:ea typeface="+mn-ea"/>
              <a:cs typeface="+mn-cs"/>
            </a:endParaRPr>
          </a:p>
        </p:txBody>
      </p:sp>
    </p:spTree>
    <p:extLst>
      <p:ext uri="{BB962C8B-B14F-4D97-AF65-F5344CB8AC3E}">
        <p14:creationId xmlns:p14="http://schemas.microsoft.com/office/powerpoint/2010/main" val="263816823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35</a:t>
            </a:fld>
            <a:endParaRPr lang="en-US"/>
          </a:p>
        </p:txBody>
      </p:sp>
    </p:spTree>
    <p:extLst>
      <p:ext uri="{BB962C8B-B14F-4D97-AF65-F5344CB8AC3E}">
        <p14:creationId xmlns:p14="http://schemas.microsoft.com/office/powerpoint/2010/main" val="67704154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early read all the instructions to the faculty and allow for Q&amp;A. .</a:t>
            </a:r>
          </a:p>
        </p:txBody>
      </p:sp>
      <p:sp>
        <p:nvSpPr>
          <p:cNvPr id="4" name="Slide Number Placeholder 3"/>
          <p:cNvSpPr>
            <a:spLocks noGrp="1"/>
          </p:cNvSpPr>
          <p:nvPr>
            <p:ph type="sldNum" sz="quarter" idx="5"/>
          </p:nvPr>
        </p:nvSpPr>
        <p:spPr/>
        <p:txBody>
          <a:bodyPr/>
          <a:lstStyle/>
          <a:p>
            <a:fld id="{6547A087-2746-DD4E-989A-A86C67D906E2}" type="slidenum">
              <a:rPr lang="en-US" smtClean="0"/>
              <a:t>4</a:t>
            </a:fld>
            <a:endParaRPr lang="en-US"/>
          </a:p>
        </p:txBody>
      </p:sp>
    </p:spTree>
    <p:extLst>
      <p:ext uri="{BB962C8B-B14F-4D97-AF65-F5344CB8AC3E}">
        <p14:creationId xmlns:p14="http://schemas.microsoft.com/office/powerpoint/2010/main" val="249463452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early read all the instructions to the faculty and allow for Q&amp;A. This is for the VTS part of the activity</a:t>
            </a:r>
          </a:p>
        </p:txBody>
      </p:sp>
      <p:sp>
        <p:nvSpPr>
          <p:cNvPr id="4" name="Slide Number Placeholder 3"/>
          <p:cNvSpPr>
            <a:spLocks noGrp="1"/>
          </p:cNvSpPr>
          <p:nvPr>
            <p:ph type="sldNum" sz="quarter" idx="5"/>
          </p:nvPr>
        </p:nvSpPr>
        <p:spPr/>
        <p:txBody>
          <a:bodyPr/>
          <a:lstStyle/>
          <a:p>
            <a:fld id="{6547A087-2746-DD4E-989A-A86C67D906E2}" type="slidenum">
              <a:rPr lang="en-US" smtClean="0"/>
              <a:t>5</a:t>
            </a:fld>
            <a:endParaRPr lang="en-US"/>
          </a:p>
        </p:txBody>
      </p:sp>
    </p:spTree>
    <p:extLst>
      <p:ext uri="{BB962C8B-B14F-4D97-AF65-F5344CB8AC3E}">
        <p14:creationId xmlns:p14="http://schemas.microsoft.com/office/powerpoint/2010/main" val="139169403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early read all the instructions to the faculty and allow for Q&amp;A.. This is for the structured peer roleplay </a:t>
            </a:r>
            <a:r>
              <a:rPr lang="en-US" b="1" dirty="0">
                <a:solidFill>
                  <a:srgbClr val="FFFF00"/>
                </a:solidFill>
              </a:rPr>
              <a:t>Activity</a:t>
            </a: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t>6</a:t>
            </a:fld>
            <a:endParaRPr lang="en-US"/>
          </a:p>
        </p:txBody>
      </p:sp>
    </p:spTree>
    <p:extLst>
      <p:ext uri="{BB962C8B-B14F-4D97-AF65-F5344CB8AC3E}">
        <p14:creationId xmlns:p14="http://schemas.microsoft.com/office/powerpoint/2010/main" val="413238402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early read all the instructions to the faculty and allow for Q&amp;A. This is for the roleplay </a:t>
            </a:r>
            <a:r>
              <a:rPr lang="en-US" b="1" dirty="0">
                <a:solidFill>
                  <a:srgbClr val="FFFF00"/>
                </a:solidFill>
              </a:rPr>
              <a:t>Activity</a:t>
            </a: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solidFill>
                  <a:prstClr val="black"/>
                </a:solidFill>
                <a:latin typeface="Calibri"/>
              </a:rPr>
              <a:pPr/>
              <a:t>7</a:t>
            </a:fld>
            <a:endParaRPr lang="en-US">
              <a:solidFill>
                <a:prstClr val="black"/>
              </a:solidFill>
              <a:latin typeface="Calibri"/>
            </a:endParaRPr>
          </a:p>
        </p:txBody>
      </p:sp>
    </p:spTree>
    <p:extLst>
      <p:ext uri="{BB962C8B-B14F-4D97-AF65-F5344CB8AC3E}">
        <p14:creationId xmlns:p14="http://schemas.microsoft.com/office/powerpoint/2010/main" val="413238402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early read all the instructions to the faculty and allow for Q&amp;A. This is for the  roleplay </a:t>
            </a:r>
            <a:r>
              <a:rPr lang="en-US" b="1" dirty="0">
                <a:solidFill>
                  <a:srgbClr val="FFFF00"/>
                </a:solidFill>
              </a:rPr>
              <a:t>Activity</a:t>
            </a:r>
            <a:endParaRPr lang="en-US" dirty="0"/>
          </a:p>
          <a:p>
            <a:endParaRPr lang="en-US" dirty="0"/>
          </a:p>
        </p:txBody>
      </p:sp>
      <p:sp>
        <p:nvSpPr>
          <p:cNvPr id="4" name="Slide Number Placeholder 3"/>
          <p:cNvSpPr>
            <a:spLocks noGrp="1"/>
          </p:cNvSpPr>
          <p:nvPr>
            <p:ph type="sldNum" sz="quarter" idx="5"/>
          </p:nvPr>
        </p:nvSpPr>
        <p:spPr/>
        <p:txBody>
          <a:bodyPr/>
          <a:lstStyle/>
          <a:p>
            <a:fld id="{6547A087-2746-DD4E-989A-A86C67D906E2}" type="slidenum">
              <a:rPr lang="en-US" smtClean="0">
                <a:solidFill>
                  <a:prstClr val="black"/>
                </a:solidFill>
                <a:latin typeface="Calibri"/>
              </a:rPr>
              <a:pPr/>
              <a:t>8</a:t>
            </a:fld>
            <a:endParaRPr lang="en-US">
              <a:solidFill>
                <a:prstClr val="black"/>
              </a:solidFill>
              <a:latin typeface="Calibri"/>
            </a:endParaRPr>
          </a:p>
        </p:txBody>
      </p:sp>
    </p:spTree>
    <p:extLst>
      <p:ext uri="{BB962C8B-B14F-4D97-AF65-F5344CB8AC3E}">
        <p14:creationId xmlns:p14="http://schemas.microsoft.com/office/powerpoint/2010/main" val="413238402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early read all the instructions to the faculty and allow for Q&amp;A. This is for </a:t>
            </a:r>
            <a:r>
              <a:rPr lang="en-US" b="1" dirty="0">
                <a:solidFill>
                  <a:srgbClr val="FFC000"/>
                </a:solidFill>
              </a:rPr>
              <a:t>“I used to think, now I think and now I will….” part of the activity</a:t>
            </a:r>
            <a:endParaRPr lang="en-US" dirty="0"/>
          </a:p>
          <a:p>
            <a:r>
              <a:rPr lang="en-US" dirty="0"/>
              <a:t>.</a:t>
            </a:r>
          </a:p>
        </p:txBody>
      </p:sp>
      <p:sp>
        <p:nvSpPr>
          <p:cNvPr id="4" name="Slide Number Placeholder 3"/>
          <p:cNvSpPr>
            <a:spLocks noGrp="1"/>
          </p:cNvSpPr>
          <p:nvPr>
            <p:ph type="sldNum" sz="quarter" idx="5"/>
          </p:nvPr>
        </p:nvSpPr>
        <p:spPr/>
        <p:txBody>
          <a:bodyPr/>
          <a:lstStyle/>
          <a:p>
            <a:fld id="{6547A087-2746-DD4E-989A-A86C67D906E2}" type="slidenum">
              <a:rPr lang="en-US" smtClean="0"/>
              <a:t>9</a:t>
            </a:fld>
            <a:endParaRPr lang="en-US"/>
          </a:p>
        </p:txBody>
      </p:sp>
    </p:spTree>
    <p:extLst>
      <p:ext uri="{BB962C8B-B14F-4D97-AF65-F5344CB8AC3E}">
        <p14:creationId xmlns:p14="http://schemas.microsoft.com/office/powerpoint/2010/main" val="27988155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Graphic 1" descr="Tag=AccentColor&#10;Flavor=Light&#10;Target=Fill">
            <a:extLst>
              <a:ext uri="{FF2B5EF4-FFF2-40B4-BE49-F238E27FC236}">
                <a16:creationId xmlns:a16="http://schemas.microsoft.com/office/drawing/2014/main" id="{0D57E7FA-E8FC-45AC-868F-CDC8144939D6}"/>
              </a:ext>
            </a:extLst>
          </p:cNvPr>
          <p:cNvSpPr/>
          <p:nvPr/>
        </p:nvSpPr>
        <p:spPr>
          <a:xfrm rot="10800000" flipV="1">
            <a:off x="2599854" y="527562"/>
            <a:ext cx="6992292" cy="5102484"/>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807094A5-EB6F-441D-88F8-CD7A30C84707}"/>
              </a:ext>
            </a:extLst>
          </p:cNvPr>
          <p:cNvSpPr>
            <a:spLocks noGrp="1"/>
          </p:cNvSpPr>
          <p:nvPr>
            <p:ph type="ctrTitle"/>
          </p:nvPr>
        </p:nvSpPr>
        <p:spPr>
          <a:xfrm>
            <a:off x="1508760" y="1591056"/>
            <a:ext cx="5705856" cy="3264408"/>
          </a:xfrm>
        </p:spPr>
        <p:txBody>
          <a:bodyPr anchor="b">
            <a:normAutofit/>
          </a:bodyPr>
          <a:lstStyle>
            <a:lvl1pPr algn="l">
              <a:defRPr sz="4800"/>
            </a:lvl1pPr>
          </a:lstStyle>
          <a:p>
            <a:r>
              <a:rPr lang="en-US"/>
              <a:t>Click to edit Master title style</a:t>
            </a:r>
            <a:endParaRPr lang="en-US" dirty="0"/>
          </a:p>
        </p:txBody>
      </p:sp>
      <p:sp>
        <p:nvSpPr>
          <p:cNvPr id="3" name="Subtitle 2">
            <a:extLst>
              <a:ext uri="{FF2B5EF4-FFF2-40B4-BE49-F238E27FC236}">
                <a16:creationId xmlns:a16="http://schemas.microsoft.com/office/drawing/2014/main" id="{1C7CE1E3-3929-42A6-81B7-056BD88EF353}"/>
              </a:ext>
            </a:extLst>
          </p:cNvPr>
          <p:cNvSpPr>
            <a:spLocks noGrp="1"/>
          </p:cNvSpPr>
          <p:nvPr>
            <p:ph type="subTitle" idx="1"/>
          </p:nvPr>
        </p:nvSpPr>
        <p:spPr>
          <a:xfrm>
            <a:off x="1524000" y="4928616"/>
            <a:ext cx="5705856" cy="996696"/>
          </a:xfrm>
        </p:spPr>
        <p:txBody>
          <a:bodyPr/>
          <a:lstStyle>
            <a:lvl1pPr marL="0" indent="0" algn="l">
              <a:buNone/>
              <a:defRPr sz="2400" cap="all" baseline="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a:extLst>
              <a:ext uri="{FF2B5EF4-FFF2-40B4-BE49-F238E27FC236}">
                <a16:creationId xmlns:a16="http://schemas.microsoft.com/office/drawing/2014/main" id="{5CE951E3-0794-422C-AF76-0AD4A7FB19EB}"/>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5" name="Footer Placeholder 4">
            <a:extLst>
              <a:ext uri="{FF2B5EF4-FFF2-40B4-BE49-F238E27FC236}">
                <a16:creationId xmlns:a16="http://schemas.microsoft.com/office/drawing/2014/main" id="{114EBFA8-0291-4D77-A9D9-B17FC2382A8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57AC4D4-C4EE-4624-A329-C608A1D5AFE1}"/>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23986987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8" name="Graphic 1" descr="Tag=AccentColor&#10;Flavor=Light&#10;Target=Fill">
            <a:extLst>
              <a:ext uri="{FF2B5EF4-FFF2-40B4-BE49-F238E27FC236}">
                <a16:creationId xmlns:a16="http://schemas.microsoft.com/office/drawing/2014/main" id="{0EE21C0F-70D8-4F3C-9392-07559C90EE6E}"/>
              </a:ext>
            </a:extLst>
          </p:cNvPr>
          <p:cNvSpPr/>
          <p:nvPr/>
        </p:nvSpPr>
        <p:spPr>
          <a:xfrm rot="10800000" flipH="1" flipV="1">
            <a:off x="684965" y="1332237"/>
            <a:ext cx="5263732" cy="3841102"/>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48DB1DFE-8154-440D-93CF-FEF7860E897F}"/>
              </a:ext>
            </a:extLst>
          </p:cNvPr>
          <p:cNvSpPr>
            <a:spLocks noGrp="1"/>
          </p:cNvSpPr>
          <p:nvPr>
            <p:ph type="title"/>
          </p:nvPr>
        </p:nvSpPr>
        <p:spPr>
          <a:xfrm>
            <a:off x="1399032" y="2523744"/>
            <a:ext cx="3831336" cy="1453896"/>
          </a:xfrm>
        </p:spPr>
        <p:txBody>
          <a:bodyPr anchor="b"/>
          <a:lstStyle>
            <a:lvl1pPr algn="ctr">
              <a:defRPr sz="3200"/>
            </a:lvl1pPr>
          </a:lstStyle>
          <a:p>
            <a:r>
              <a:rPr lang="en-US"/>
              <a:t>Click to edit Master title style</a:t>
            </a:r>
            <a:endParaRPr lang="en-US" dirty="0"/>
          </a:p>
        </p:txBody>
      </p:sp>
      <p:sp>
        <p:nvSpPr>
          <p:cNvPr id="3" name="Picture Placeholder 2">
            <a:extLst>
              <a:ext uri="{FF2B5EF4-FFF2-40B4-BE49-F238E27FC236}">
                <a16:creationId xmlns:a16="http://schemas.microsoft.com/office/drawing/2014/main" id="{9CD9D1F5-05CC-48F3-A314-315EF1703043}"/>
              </a:ext>
            </a:extLst>
          </p:cNvPr>
          <p:cNvSpPr>
            <a:spLocks noGrp="1"/>
          </p:cNvSpPr>
          <p:nvPr>
            <p:ph type="pic" idx="1"/>
          </p:nvPr>
        </p:nvSpPr>
        <p:spPr>
          <a:xfrm>
            <a:off x="6711696" y="640079"/>
            <a:ext cx="4837176" cy="5568696"/>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a:extLst>
              <a:ext uri="{FF2B5EF4-FFF2-40B4-BE49-F238E27FC236}">
                <a16:creationId xmlns:a16="http://schemas.microsoft.com/office/drawing/2014/main" id="{211807DE-1178-4BBB-89D8-9046239C2DE9}"/>
              </a:ext>
            </a:extLst>
          </p:cNvPr>
          <p:cNvSpPr>
            <a:spLocks noGrp="1"/>
          </p:cNvSpPr>
          <p:nvPr>
            <p:ph type="body" sz="half" idx="2"/>
          </p:nvPr>
        </p:nvSpPr>
        <p:spPr>
          <a:xfrm>
            <a:off x="1655064" y="4087368"/>
            <a:ext cx="3319272" cy="649224"/>
          </a:xfrm>
        </p:spPr>
        <p:txBody>
          <a:bodyPr>
            <a:noAutofit/>
          </a:bodyPr>
          <a:lstStyle>
            <a:lvl1pPr marL="0" indent="0" algn="ctr">
              <a:buNone/>
              <a:defRPr sz="2000" cap="all" baseline="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D48EA59-A1BC-48B7-9495-6D5C6035B14B}"/>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6" name="Footer Placeholder 5">
            <a:extLst>
              <a:ext uri="{FF2B5EF4-FFF2-40B4-BE49-F238E27FC236}">
                <a16:creationId xmlns:a16="http://schemas.microsoft.com/office/drawing/2014/main" id="{49F85A72-B50F-440E-AAD3-53C099F6D9B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2C2D00B-4207-4720-8C68-605CAFDD5CA2}"/>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16482226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1C888B-58B8-4428-8B1D-4E26FC5DD59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314F67B-D516-42FA-A2CA-2DCD37CFE8D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82BA5FF-4919-4FF8-9C04-06CE156B762F}"/>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5" name="Footer Placeholder 4">
            <a:extLst>
              <a:ext uri="{FF2B5EF4-FFF2-40B4-BE49-F238E27FC236}">
                <a16:creationId xmlns:a16="http://schemas.microsoft.com/office/drawing/2014/main" id="{CBEDA970-128E-4150-8E5A-A1B056E8350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AEC6CD1-EE5E-42EF-B76D-BB803BA6AB5E}"/>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28215555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50C2A1B-34CA-4877-9435-D77DF325757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F255E5E-4A81-44CC-8D99-F56E625D463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19CEECF-A221-4ECC-AD9C-E197D516D24C}"/>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5" name="Footer Placeholder 4">
            <a:extLst>
              <a:ext uri="{FF2B5EF4-FFF2-40B4-BE49-F238E27FC236}">
                <a16:creationId xmlns:a16="http://schemas.microsoft.com/office/drawing/2014/main" id="{018F41AE-0DDE-49ED-9F0C-E0E16F599A0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7B47FB7-77F0-4C43-B81E-D04B31C953DA}"/>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63357131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Graphic 1" descr="Tag=AccentColor&#10;Flavor=Light&#10;Target=Fill">
            <a:extLst>
              <a:ext uri="{FF2B5EF4-FFF2-40B4-BE49-F238E27FC236}">
                <a16:creationId xmlns:a16="http://schemas.microsoft.com/office/drawing/2014/main" id="{0D57E7FA-E8FC-45AC-868F-CDC8144939D6}"/>
              </a:ext>
            </a:extLst>
          </p:cNvPr>
          <p:cNvSpPr/>
          <p:nvPr/>
        </p:nvSpPr>
        <p:spPr>
          <a:xfrm rot="10800000" flipV="1">
            <a:off x="2599854" y="527562"/>
            <a:ext cx="6992292" cy="5102484"/>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solidFill>
                <a:prstClr val="black"/>
              </a:solidFill>
            </a:endParaRPr>
          </a:p>
        </p:txBody>
      </p:sp>
      <p:sp>
        <p:nvSpPr>
          <p:cNvPr id="2" name="Title 1">
            <a:extLst>
              <a:ext uri="{FF2B5EF4-FFF2-40B4-BE49-F238E27FC236}">
                <a16:creationId xmlns:a16="http://schemas.microsoft.com/office/drawing/2014/main" id="{807094A5-EB6F-441D-88F8-CD7A30C84707}"/>
              </a:ext>
            </a:extLst>
          </p:cNvPr>
          <p:cNvSpPr>
            <a:spLocks noGrp="1"/>
          </p:cNvSpPr>
          <p:nvPr>
            <p:ph type="ctrTitle"/>
          </p:nvPr>
        </p:nvSpPr>
        <p:spPr>
          <a:xfrm>
            <a:off x="1508760" y="1591056"/>
            <a:ext cx="5705856" cy="3264408"/>
          </a:xfrm>
        </p:spPr>
        <p:txBody>
          <a:bodyPr anchor="b">
            <a:normAutofit/>
          </a:bodyPr>
          <a:lstStyle>
            <a:lvl1pPr algn="l">
              <a:defRPr sz="4800"/>
            </a:lvl1pPr>
          </a:lstStyle>
          <a:p>
            <a:r>
              <a:rPr lang="en-US"/>
              <a:t>Click to edit Master title style</a:t>
            </a:r>
            <a:endParaRPr lang="en-US" dirty="0"/>
          </a:p>
        </p:txBody>
      </p:sp>
      <p:sp>
        <p:nvSpPr>
          <p:cNvPr id="3" name="Subtitle 2">
            <a:extLst>
              <a:ext uri="{FF2B5EF4-FFF2-40B4-BE49-F238E27FC236}">
                <a16:creationId xmlns:a16="http://schemas.microsoft.com/office/drawing/2014/main" id="{1C7CE1E3-3929-42A6-81B7-056BD88EF353}"/>
              </a:ext>
            </a:extLst>
          </p:cNvPr>
          <p:cNvSpPr>
            <a:spLocks noGrp="1"/>
          </p:cNvSpPr>
          <p:nvPr>
            <p:ph type="subTitle" idx="1"/>
          </p:nvPr>
        </p:nvSpPr>
        <p:spPr>
          <a:xfrm>
            <a:off x="1524000" y="4928616"/>
            <a:ext cx="5705856" cy="996696"/>
          </a:xfrm>
        </p:spPr>
        <p:txBody>
          <a:bodyPr/>
          <a:lstStyle>
            <a:lvl1pPr marL="0" indent="0" algn="l">
              <a:buNone/>
              <a:defRPr sz="2400" cap="all" baseline="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a:extLst>
              <a:ext uri="{FF2B5EF4-FFF2-40B4-BE49-F238E27FC236}">
                <a16:creationId xmlns:a16="http://schemas.microsoft.com/office/drawing/2014/main" id="{5CE951E3-0794-422C-AF76-0AD4A7FB19EB}"/>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114EBFA8-0291-4D77-A9D9-B17FC2382A80}"/>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357AC4D4-C4EE-4624-A329-C608A1D5AFE1}"/>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39771601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7" name="Freeform: Shape 6" descr="Tag=AccentColor&#10;Flavor=Light&#10;Target=Fill">
            <a:extLst>
              <a:ext uri="{FF2B5EF4-FFF2-40B4-BE49-F238E27FC236}">
                <a16:creationId xmlns:a16="http://schemas.microsoft.com/office/drawing/2014/main" id="{13B7BB51-92B8-4089-8DAB-1202A4D1C6A3}"/>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a:solidFill>
                <a:prstClr val="black"/>
              </a:solidFill>
            </a:endParaRPr>
          </a:p>
        </p:txBody>
      </p:sp>
      <p:sp>
        <p:nvSpPr>
          <p:cNvPr id="2" name="Title 1">
            <a:extLst>
              <a:ext uri="{FF2B5EF4-FFF2-40B4-BE49-F238E27FC236}">
                <a16:creationId xmlns:a16="http://schemas.microsoft.com/office/drawing/2014/main" id="{26030E26-A86A-417A-AA64-699AA8DD3DA5}"/>
              </a:ext>
            </a:extLst>
          </p:cNvPr>
          <p:cNvSpPr>
            <a:spLocks noGrp="1"/>
          </p:cNvSpPr>
          <p:nvPr>
            <p:ph type="title"/>
          </p:nvPr>
        </p:nvSpPr>
        <p:spPr/>
        <p:txBody>
          <a:bodyPr>
            <a:normAutofit/>
          </a:bodyPr>
          <a:lstStyle>
            <a:lvl1pPr>
              <a:defRPr sz="40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D19CF97E-0E6E-41E9-B75B-0371E744D1E8}"/>
              </a:ext>
            </a:extLst>
          </p:cNvPr>
          <p:cNvSpPr>
            <a:spLocks noGrp="1"/>
          </p:cNvSpPr>
          <p:nvPr>
            <p:ph idx="1"/>
          </p:nvPr>
        </p:nvSpPr>
        <p:spPr>
          <a:xfrm>
            <a:off x="838200" y="2011680"/>
            <a:ext cx="1051560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70BAE770-8363-44CD-8A22-AB26C5C5361B}"/>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36E618F2-3B8E-4449-91E7-F8AA4960938F}"/>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063428F0-E5C2-42A1-AB2F-1A19FFAD19CF}"/>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79046162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7" name="Graphic 9" descr="Tag=AccentColor&#10;Flavor=Light&#10;Target=Fill">
            <a:extLst>
              <a:ext uri="{FF2B5EF4-FFF2-40B4-BE49-F238E27FC236}">
                <a16:creationId xmlns:a16="http://schemas.microsoft.com/office/drawing/2014/main" id="{DB2CE8D6-5B4E-4EBE-9ED5-A1DA7E2A5CDA}"/>
              </a:ext>
            </a:extLst>
          </p:cNvPr>
          <p:cNvSpPr/>
          <p:nvPr/>
        </p:nvSpPr>
        <p:spPr>
          <a:xfrm>
            <a:off x="7209816" y="0"/>
            <a:ext cx="4143984" cy="5747660"/>
          </a:xfrm>
          <a:custGeom>
            <a:avLst/>
            <a:gdLst>
              <a:gd name="connsiteX0" fmla="*/ 0 w 3843750"/>
              <a:gd name="connsiteY0" fmla="*/ 346 h 5956080"/>
              <a:gd name="connsiteX1" fmla="*/ 72373 w 3843750"/>
              <a:gd name="connsiteY1" fmla="*/ 2447534 h 5956080"/>
              <a:gd name="connsiteX2" fmla="*/ 145093 w 3843750"/>
              <a:gd name="connsiteY2" fmla="*/ 3878724 h 5956080"/>
              <a:gd name="connsiteX3" fmla="*/ 237897 w 3843750"/>
              <a:gd name="connsiteY3" fmla="*/ 4208041 h 5956080"/>
              <a:gd name="connsiteX4" fmla="*/ 281875 w 3843750"/>
              <a:gd name="connsiteY4" fmla="*/ 4677601 h 5956080"/>
              <a:gd name="connsiteX5" fmla="*/ 360135 w 3843750"/>
              <a:gd name="connsiteY5" fmla="*/ 5287407 h 5956080"/>
              <a:gd name="connsiteX6" fmla="*/ 414155 w 3843750"/>
              <a:gd name="connsiteY6" fmla="*/ 5817914 h 5956080"/>
              <a:gd name="connsiteX7" fmla="*/ 681487 w 3843750"/>
              <a:gd name="connsiteY7" fmla="*/ 5914873 h 5956080"/>
              <a:gd name="connsiteX8" fmla="*/ 892373 w 3843750"/>
              <a:gd name="connsiteY8" fmla="*/ 5605295 h 5956080"/>
              <a:gd name="connsiteX9" fmla="*/ 1027770 w 3843750"/>
              <a:gd name="connsiteY9" fmla="*/ 5804063 h 5956080"/>
              <a:gd name="connsiteX10" fmla="*/ 1200566 w 3843750"/>
              <a:gd name="connsiteY10" fmla="*/ 5527036 h 5956080"/>
              <a:gd name="connsiteX11" fmla="*/ 1348083 w 3843750"/>
              <a:gd name="connsiteY11" fmla="*/ 5363590 h 5956080"/>
              <a:gd name="connsiteX12" fmla="*/ 1425997 w 3843750"/>
              <a:gd name="connsiteY12" fmla="*/ 4800532 h 5956080"/>
              <a:gd name="connsiteX13" fmla="*/ 1517416 w 3843750"/>
              <a:gd name="connsiteY13" fmla="*/ 4640549 h 5956080"/>
              <a:gd name="connsiteX14" fmla="*/ 1569705 w 3843750"/>
              <a:gd name="connsiteY14" fmla="*/ 4803995 h 5956080"/>
              <a:gd name="connsiteX15" fmla="*/ 1530921 w 3843750"/>
              <a:gd name="connsiteY15" fmla="*/ 5433885 h 5956080"/>
              <a:gd name="connsiteX16" fmla="*/ 1614721 w 3843750"/>
              <a:gd name="connsiteY16" fmla="*/ 5319957 h 5956080"/>
              <a:gd name="connsiteX17" fmla="*/ 1800676 w 3843750"/>
              <a:gd name="connsiteY17" fmla="*/ 4608691 h 5956080"/>
              <a:gd name="connsiteX18" fmla="*/ 1918759 w 3843750"/>
              <a:gd name="connsiteY18" fmla="*/ 4486799 h 5956080"/>
              <a:gd name="connsiteX19" fmla="*/ 2009139 w 3843750"/>
              <a:gd name="connsiteY19" fmla="*/ 4715000 h 5956080"/>
              <a:gd name="connsiteX20" fmla="*/ 2135532 w 3843750"/>
              <a:gd name="connsiteY20" fmla="*/ 5321689 h 5956080"/>
              <a:gd name="connsiteX21" fmla="*/ 2209291 w 3843750"/>
              <a:gd name="connsiteY21" fmla="*/ 5028733 h 5956080"/>
              <a:gd name="connsiteX22" fmla="*/ 2501208 w 3843750"/>
              <a:gd name="connsiteY22" fmla="*/ 4457711 h 5956080"/>
              <a:gd name="connsiteX23" fmla="*/ 2695127 w 3843750"/>
              <a:gd name="connsiteY23" fmla="*/ 4973674 h 5956080"/>
              <a:gd name="connsiteX24" fmla="*/ 2825329 w 3843750"/>
              <a:gd name="connsiteY24" fmla="*/ 4563328 h 5956080"/>
              <a:gd name="connsiteX25" fmla="*/ 2904628 w 3843750"/>
              <a:gd name="connsiteY25" fmla="*/ 4466368 h 5956080"/>
              <a:gd name="connsiteX26" fmla="*/ 2922635 w 3843750"/>
              <a:gd name="connsiteY26" fmla="*/ 4519696 h 5956080"/>
              <a:gd name="connsiteX27" fmla="*/ 3089544 w 3843750"/>
              <a:gd name="connsiteY27" fmla="*/ 3606545 h 5956080"/>
              <a:gd name="connsiteX28" fmla="*/ 3150490 w 3843750"/>
              <a:gd name="connsiteY28" fmla="*/ 3989882 h 5956080"/>
              <a:gd name="connsiteX29" fmla="*/ 3755448 w 3843750"/>
              <a:gd name="connsiteY29" fmla="*/ 1538193 h 5956080"/>
              <a:gd name="connsiteX30" fmla="*/ 3850330 w 3843750"/>
              <a:gd name="connsiteY30" fmla="*/ 0 h 5956080"/>
              <a:gd name="connsiteX31" fmla="*/ 0 w 3843750"/>
              <a:gd name="connsiteY31" fmla="*/ 0 h 5956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Lst>
            <a:rect l="l" t="t" r="r" b="b"/>
            <a:pathLst>
              <a:path w="3843750" h="5956080">
                <a:moveTo>
                  <a:pt x="0" y="346"/>
                </a:moveTo>
                <a:cubicBezTo>
                  <a:pt x="12120" y="1234155"/>
                  <a:pt x="72720" y="2447534"/>
                  <a:pt x="72373" y="2447534"/>
                </a:cubicBezTo>
                <a:cubicBezTo>
                  <a:pt x="72720" y="2449265"/>
                  <a:pt x="114274" y="3641520"/>
                  <a:pt x="145093" y="3878724"/>
                </a:cubicBezTo>
                <a:cubicBezTo>
                  <a:pt x="176258" y="4119392"/>
                  <a:pt x="210194" y="3969797"/>
                  <a:pt x="237897" y="4208041"/>
                </a:cubicBezTo>
                <a:cubicBezTo>
                  <a:pt x="250017" y="4367677"/>
                  <a:pt x="237204" y="4527661"/>
                  <a:pt x="281875" y="4677601"/>
                </a:cubicBezTo>
                <a:cubicBezTo>
                  <a:pt x="278758" y="4908226"/>
                  <a:pt x="338319" y="5059552"/>
                  <a:pt x="360135" y="5287407"/>
                </a:cubicBezTo>
                <a:cubicBezTo>
                  <a:pt x="370177" y="5468860"/>
                  <a:pt x="348015" y="5649274"/>
                  <a:pt x="414155" y="5817914"/>
                </a:cubicBezTo>
                <a:cubicBezTo>
                  <a:pt x="467137" y="5947770"/>
                  <a:pt x="534662" y="6049578"/>
                  <a:pt x="681487" y="5914873"/>
                </a:cubicBezTo>
                <a:cubicBezTo>
                  <a:pt x="680448" y="5747964"/>
                  <a:pt x="925963" y="5772897"/>
                  <a:pt x="892373" y="5605295"/>
                </a:cubicBezTo>
                <a:cubicBezTo>
                  <a:pt x="1003184" y="5641309"/>
                  <a:pt x="945009" y="5759046"/>
                  <a:pt x="1027770" y="5804063"/>
                </a:cubicBezTo>
                <a:cubicBezTo>
                  <a:pt x="1099105" y="5719915"/>
                  <a:pt x="1051664" y="5551968"/>
                  <a:pt x="1200566" y="5527036"/>
                </a:cubicBezTo>
                <a:cubicBezTo>
                  <a:pt x="1352931" y="5564088"/>
                  <a:pt x="1336655" y="5453970"/>
                  <a:pt x="1348083" y="5363590"/>
                </a:cubicBezTo>
                <a:cubicBezTo>
                  <a:pt x="1370938" y="5149586"/>
                  <a:pt x="1389291" y="5009687"/>
                  <a:pt x="1425997" y="4800532"/>
                </a:cubicBezTo>
                <a:cubicBezTo>
                  <a:pt x="1436385" y="4748243"/>
                  <a:pt x="1415608" y="4628775"/>
                  <a:pt x="1517416" y="4640549"/>
                </a:cubicBezTo>
                <a:cubicBezTo>
                  <a:pt x="1596022" y="4651976"/>
                  <a:pt x="1566242" y="4746512"/>
                  <a:pt x="1569705" y="4803995"/>
                </a:cubicBezTo>
                <a:cubicBezTo>
                  <a:pt x="1600177" y="5128809"/>
                  <a:pt x="1532998" y="5109763"/>
                  <a:pt x="1530921" y="5433885"/>
                </a:cubicBezTo>
                <a:cubicBezTo>
                  <a:pt x="1530574" y="5446697"/>
                  <a:pt x="1580786" y="5458125"/>
                  <a:pt x="1614721" y="5319957"/>
                </a:cubicBezTo>
                <a:cubicBezTo>
                  <a:pt x="1681208" y="5047432"/>
                  <a:pt x="1760507" y="4832736"/>
                  <a:pt x="1800676" y="4608691"/>
                </a:cubicBezTo>
                <a:cubicBezTo>
                  <a:pt x="1848463" y="4656824"/>
                  <a:pt x="1889671" y="4439704"/>
                  <a:pt x="1918759" y="4486799"/>
                </a:cubicBezTo>
                <a:cubicBezTo>
                  <a:pt x="1932264" y="4566098"/>
                  <a:pt x="1956503" y="4642626"/>
                  <a:pt x="2009139" y="4715000"/>
                </a:cubicBezTo>
                <a:cubicBezTo>
                  <a:pt x="2054502" y="4933851"/>
                  <a:pt x="2004983" y="5137812"/>
                  <a:pt x="2135532" y="5321689"/>
                </a:cubicBezTo>
                <a:cubicBezTo>
                  <a:pt x="2135532" y="5321689"/>
                  <a:pt x="2137610" y="5265245"/>
                  <a:pt x="2209291" y="5028733"/>
                </a:cubicBezTo>
                <a:cubicBezTo>
                  <a:pt x="2267120" y="4838277"/>
                  <a:pt x="2341225" y="4936622"/>
                  <a:pt x="2501208" y="4457711"/>
                </a:cubicBezTo>
                <a:cubicBezTo>
                  <a:pt x="2545186" y="4641934"/>
                  <a:pt x="2446495" y="4877753"/>
                  <a:pt x="2695127" y="4973674"/>
                </a:cubicBezTo>
                <a:cubicBezTo>
                  <a:pt x="2743260" y="4833775"/>
                  <a:pt x="2706208" y="4662365"/>
                  <a:pt x="2825329" y="4563328"/>
                </a:cubicBezTo>
                <a:cubicBezTo>
                  <a:pt x="2859958" y="4534586"/>
                  <a:pt x="2884890" y="4501689"/>
                  <a:pt x="2904628" y="4466368"/>
                </a:cubicBezTo>
                <a:cubicBezTo>
                  <a:pt x="2910515" y="4484375"/>
                  <a:pt x="2916749" y="4503074"/>
                  <a:pt x="2922635" y="4519696"/>
                </a:cubicBezTo>
                <a:cubicBezTo>
                  <a:pt x="2946529" y="4491647"/>
                  <a:pt x="3082618" y="3784882"/>
                  <a:pt x="3089544" y="3606545"/>
                </a:cubicBezTo>
                <a:cubicBezTo>
                  <a:pt x="3124172" y="3733285"/>
                  <a:pt x="3150490" y="3989882"/>
                  <a:pt x="3150490" y="3989882"/>
                </a:cubicBezTo>
                <a:cubicBezTo>
                  <a:pt x="3150490" y="3989882"/>
                  <a:pt x="3300085" y="3936900"/>
                  <a:pt x="3755448" y="1538193"/>
                </a:cubicBezTo>
                <a:cubicBezTo>
                  <a:pt x="3791461" y="1348775"/>
                  <a:pt x="3824704" y="697762"/>
                  <a:pt x="3850330" y="0"/>
                </a:cubicBezTo>
                <a:lnTo>
                  <a:pt x="0" y="0"/>
                </a:lnTo>
                <a:close/>
              </a:path>
            </a:pathLst>
          </a:custGeom>
          <a:solidFill>
            <a:schemeClr val="accent1">
              <a:alpha val="20000"/>
            </a:schemeClr>
          </a:solidFill>
          <a:ln w="32707" cap="flat">
            <a:noFill/>
            <a:prstDash val="solid"/>
            <a:miter/>
          </a:ln>
        </p:spPr>
        <p:txBody>
          <a:bodyPr rtlCol="0" anchor="ctr"/>
          <a:lstStyle/>
          <a:p>
            <a:endParaRPr lang="en-US">
              <a:solidFill>
                <a:prstClr val="black"/>
              </a:solidFill>
            </a:endParaRPr>
          </a:p>
        </p:txBody>
      </p:sp>
      <p:sp>
        <p:nvSpPr>
          <p:cNvPr id="2" name="Title 1">
            <a:extLst>
              <a:ext uri="{FF2B5EF4-FFF2-40B4-BE49-F238E27FC236}">
                <a16:creationId xmlns:a16="http://schemas.microsoft.com/office/drawing/2014/main" id="{64AD5705-B027-4C44-B38A-60296E29EB12}"/>
              </a:ext>
            </a:extLst>
          </p:cNvPr>
          <p:cNvSpPr>
            <a:spLocks noGrp="1"/>
          </p:cNvSpPr>
          <p:nvPr>
            <p:ph type="title"/>
          </p:nvPr>
        </p:nvSpPr>
        <p:spPr>
          <a:xfrm>
            <a:off x="831850" y="1078991"/>
            <a:ext cx="5266944" cy="3136392"/>
          </a:xfrm>
        </p:spPr>
        <p:txBody>
          <a:bodyPr anchor="b">
            <a:normAutofit/>
          </a:bodyPr>
          <a:lstStyle>
            <a:lvl1pPr>
              <a:defRPr sz="4800"/>
            </a:lvl1p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BE8BBAC4-9088-44CF-BA2D-B8DD24FB5274}"/>
              </a:ext>
            </a:extLst>
          </p:cNvPr>
          <p:cNvSpPr>
            <a:spLocks noGrp="1"/>
          </p:cNvSpPr>
          <p:nvPr>
            <p:ph type="body" idx="1"/>
          </p:nvPr>
        </p:nvSpPr>
        <p:spPr>
          <a:xfrm>
            <a:off x="831850" y="4279392"/>
            <a:ext cx="5266944" cy="1500187"/>
          </a:xfrm>
        </p:spPr>
        <p:txBody>
          <a:bodyPr/>
          <a:lstStyle>
            <a:lvl1pPr marL="0" indent="0">
              <a:buNone/>
              <a:defRPr sz="2400" cap="all" baseline="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793FB3F-D2A6-4919-B57B-C08861D46303}"/>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989049E0-6BE5-43FA-A4D4-ACAFC871A79F}"/>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ADF8C28D-1479-4F15-B906-0AEBBCCA8CFA}"/>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55008875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Freeform: Shape 7" descr="Tag=AccentColor&#10;Flavor=Light&#10;Target=Fill">
            <a:extLst>
              <a:ext uri="{FF2B5EF4-FFF2-40B4-BE49-F238E27FC236}">
                <a16:creationId xmlns:a16="http://schemas.microsoft.com/office/drawing/2014/main" id="{FD51F360-8860-4FB5-A0A5-773473DD8B39}"/>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a:solidFill>
                <a:prstClr val="black"/>
              </a:solidFill>
            </a:endParaRPr>
          </a:p>
        </p:txBody>
      </p:sp>
      <p:sp>
        <p:nvSpPr>
          <p:cNvPr id="2" name="Title 1">
            <a:extLst>
              <a:ext uri="{FF2B5EF4-FFF2-40B4-BE49-F238E27FC236}">
                <a16:creationId xmlns:a16="http://schemas.microsoft.com/office/drawing/2014/main" id="{D2A77EC9-372A-4ECA-9088-780532AF057F}"/>
              </a:ext>
            </a:extLst>
          </p:cNvPr>
          <p:cNvSpPr>
            <a:spLocks noGrp="1"/>
          </p:cNvSpPr>
          <p:nvPr>
            <p:ph type="title"/>
          </p:nvPr>
        </p:nvSpPr>
        <p:spPr/>
        <p:txBody>
          <a:bodyPr>
            <a:normAutofit/>
          </a:bodyPr>
          <a:lstStyle>
            <a:lvl1pPr>
              <a:defRPr sz="40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57C882CE-1B27-414A-9B06-AA5D2DB683BA}"/>
              </a:ext>
            </a:extLst>
          </p:cNvPr>
          <p:cNvSpPr>
            <a:spLocks noGrp="1"/>
          </p:cNvSpPr>
          <p:nvPr>
            <p:ph sz="half" idx="1"/>
          </p:nvPr>
        </p:nvSpPr>
        <p:spPr>
          <a:xfrm>
            <a:off x="838200" y="2011680"/>
            <a:ext cx="493776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a:extLst>
              <a:ext uri="{FF2B5EF4-FFF2-40B4-BE49-F238E27FC236}">
                <a16:creationId xmlns:a16="http://schemas.microsoft.com/office/drawing/2014/main" id="{A0397E60-5D92-4530-96D1-FC09AF3C2742}"/>
              </a:ext>
            </a:extLst>
          </p:cNvPr>
          <p:cNvSpPr>
            <a:spLocks noGrp="1"/>
          </p:cNvSpPr>
          <p:nvPr>
            <p:ph sz="half" idx="2"/>
          </p:nvPr>
        </p:nvSpPr>
        <p:spPr>
          <a:xfrm>
            <a:off x="6419088" y="2011680"/>
            <a:ext cx="493776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a:extLst>
              <a:ext uri="{FF2B5EF4-FFF2-40B4-BE49-F238E27FC236}">
                <a16:creationId xmlns:a16="http://schemas.microsoft.com/office/drawing/2014/main" id="{034240FE-0C6A-47E9-9B0A-7B3C60877372}"/>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8671AE1B-BB18-4C7E-AA77-3A4D401A5F35}"/>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76FA7B1D-FEDD-4E29-A352-29E5F498B323}"/>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00309809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Freeform: Shape 9" descr="Tag=AccentColor&#10;Flavor=Light&#10;Target=Fill">
            <a:extLst>
              <a:ext uri="{FF2B5EF4-FFF2-40B4-BE49-F238E27FC236}">
                <a16:creationId xmlns:a16="http://schemas.microsoft.com/office/drawing/2014/main" id="{527D753D-3426-457C-9082-B92894509EC0}"/>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a:solidFill>
                <a:prstClr val="black"/>
              </a:solidFill>
            </a:endParaRPr>
          </a:p>
        </p:txBody>
      </p:sp>
      <p:sp>
        <p:nvSpPr>
          <p:cNvPr id="2" name="Title 1">
            <a:extLst>
              <a:ext uri="{FF2B5EF4-FFF2-40B4-BE49-F238E27FC236}">
                <a16:creationId xmlns:a16="http://schemas.microsoft.com/office/drawing/2014/main" id="{164D2B94-0682-4185-BCE3-89AF214A4FA8}"/>
              </a:ext>
            </a:extLst>
          </p:cNvPr>
          <p:cNvSpPr>
            <a:spLocks noGrp="1"/>
          </p:cNvSpPr>
          <p:nvPr>
            <p:ph type="title"/>
          </p:nvPr>
        </p:nvSpPr>
        <p:spPr>
          <a:xfrm>
            <a:off x="839788" y="365125"/>
            <a:ext cx="10515600" cy="1325563"/>
          </a:xfrm>
        </p:spPr>
        <p:txBody>
          <a:bodyPr>
            <a:normAutofit/>
          </a:bodyPr>
          <a:lstStyle>
            <a:lvl1pPr>
              <a:defRPr sz="4000"/>
            </a:lvl1p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8D65C47E-B85E-4B3E-A669-DEEC7F5DF2FB}"/>
              </a:ext>
            </a:extLst>
          </p:cNvPr>
          <p:cNvSpPr>
            <a:spLocks noGrp="1"/>
          </p:cNvSpPr>
          <p:nvPr>
            <p:ph type="body" idx="1"/>
          </p:nvPr>
        </p:nvSpPr>
        <p:spPr>
          <a:xfrm>
            <a:off x="839788" y="2011680"/>
            <a:ext cx="4937760" cy="950976"/>
          </a:xfrm>
        </p:spPr>
        <p:txBody>
          <a:bodyPr anchor="b">
            <a:normAutofit/>
          </a:bodyPr>
          <a:lstStyle>
            <a:lvl1pPr marL="0" indent="0">
              <a:buNone/>
              <a:defRPr sz="28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324517F-FE8C-49AD-9A52-0F4301052699}"/>
              </a:ext>
            </a:extLst>
          </p:cNvPr>
          <p:cNvSpPr>
            <a:spLocks noGrp="1"/>
          </p:cNvSpPr>
          <p:nvPr>
            <p:ph sz="half" idx="2"/>
          </p:nvPr>
        </p:nvSpPr>
        <p:spPr>
          <a:xfrm>
            <a:off x="839788" y="3127248"/>
            <a:ext cx="4937760" cy="30632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a:extLst>
              <a:ext uri="{FF2B5EF4-FFF2-40B4-BE49-F238E27FC236}">
                <a16:creationId xmlns:a16="http://schemas.microsoft.com/office/drawing/2014/main" id="{C80C73EC-7117-4DC2-9075-14102F2E282B}"/>
              </a:ext>
            </a:extLst>
          </p:cNvPr>
          <p:cNvSpPr>
            <a:spLocks noGrp="1"/>
          </p:cNvSpPr>
          <p:nvPr>
            <p:ph type="body" sz="quarter" idx="3"/>
          </p:nvPr>
        </p:nvSpPr>
        <p:spPr>
          <a:xfrm>
            <a:off x="6419088" y="2011680"/>
            <a:ext cx="4937760" cy="950976"/>
          </a:xfrm>
        </p:spPr>
        <p:txBody>
          <a:bodyPr anchor="b">
            <a:normAutofit/>
          </a:bodyPr>
          <a:lstStyle>
            <a:lvl1pPr marL="0" indent="0">
              <a:buNone/>
              <a:defRPr sz="28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DD9A323-865B-4177-8F98-9BA304E022E0}"/>
              </a:ext>
            </a:extLst>
          </p:cNvPr>
          <p:cNvSpPr>
            <a:spLocks noGrp="1"/>
          </p:cNvSpPr>
          <p:nvPr>
            <p:ph sz="quarter" idx="4"/>
          </p:nvPr>
        </p:nvSpPr>
        <p:spPr>
          <a:xfrm>
            <a:off x="6419088" y="3127248"/>
            <a:ext cx="4937760" cy="30632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a:extLst>
              <a:ext uri="{FF2B5EF4-FFF2-40B4-BE49-F238E27FC236}">
                <a16:creationId xmlns:a16="http://schemas.microsoft.com/office/drawing/2014/main" id="{2AA4E5D6-7075-4584-BD43-D966F0B58E6D}"/>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8" name="Footer Placeholder 7">
            <a:extLst>
              <a:ext uri="{FF2B5EF4-FFF2-40B4-BE49-F238E27FC236}">
                <a16:creationId xmlns:a16="http://schemas.microsoft.com/office/drawing/2014/main" id="{8C38B83D-8A05-4F3C-A409-1602C9630750}"/>
              </a:ext>
            </a:extLst>
          </p:cNvPr>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a:extLst>
              <a:ext uri="{FF2B5EF4-FFF2-40B4-BE49-F238E27FC236}">
                <a16:creationId xmlns:a16="http://schemas.microsoft.com/office/drawing/2014/main" id="{BAD250E7-8A73-449C-A140-A2A2582D7F33}"/>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51743547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Graphic 1" descr="Tag=AccentColor&#10;Flavor=Light&#10;Target=Fill">
            <a:extLst>
              <a:ext uri="{FF2B5EF4-FFF2-40B4-BE49-F238E27FC236}">
                <a16:creationId xmlns:a16="http://schemas.microsoft.com/office/drawing/2014/main" id="{AAFBE1F6-FC6D-4C3D-9AC3-97028E6F18C7}"/>
              </a:ext>
            </a:extLst>
          </p:cNvPr>
          <p:cNvSpPr/>
          <p:nvPr/>
        </p:nvSpPr>
        <p:spPr>
          <a:xfrm rot="10800000" flipV="1">
            <a:off x="1969639" y="181596"/>
            <a:ext cx="8252722" cy="6022258"/>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solidFill>
                <a:prstClr val="black"/>
              </a:solidFill>
            </a:endParaRPr>
          </a:p>
        </p:txBody>
      </p:sp>
      <p:sp>
        <p:nvSpPr>
          <p:cNvPr id="2" name="Title 1">
            <a:extLst>
              <a:ext uri="{FF2B5EF4-FFF2-40B4-BE49-F238E27FC236}">
                <a16:creationId xmlns:a16="http://schemas.microsoft.com/office/drawing/2014/main" id="{192825A4-268B-4301-8432-F9E9B2661AEC}"/>
              </a:ext>
            </a:extLst>
          </p:cNvPr>
          <p:cNvSpPr>
            <a:spLocks noGrp="1"/>
          </p:cNvSpPr>
          <p:nvPr>
            <p:ph type="title"/>
          </p:nvPr>
        </p:nvSpPr>
        <p:spPr>
          <a:xfrm>
            <a:off x="2843784" y="1572768"/>
            <a:ext cx="6501384" cy="4096512"/>
          </a:xfrm>
        </p:spPr>
        <p:txBody>
          <a:bodyPr>
            <a:normAutofit/>
          </a:bodyPr>
          <a:lstStyle>
            <a:lvl1pPr algn="ctr">
              <a:defRPr sz="4000"/>
            </a:lvl1pPr>
          </a:lstStyle>
          <a:p>
            <a:r>
              <a:rPr lang="en-US"/>
              <a:t>Click to edit Master title style</a:t>
            </a:r>
            <a:endParaRPr lang="en-US" dirty="0"/>
          </a:p>
        </p:txBody>
      </p:sp>
      <p:sp>
        <p:nvSpPr>
          <p:cNvPr id="3" name="Date Placeholder 2">
            <a:extLst>
              <a:ext uri="{FF2B5EF4-FFF2-40B4-BE49-F238E27FC236}">
                <a16:creationId xmlns:a16="http://schemas.microsoft.com/office/drawing/2014/main" id="{DA33410F-8A90-47F6-BD39-4AC0E4358351}"/>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4" name="Footer Placeholder 3">
            <a:extLst>
              <a:ext uri="{FF2B5EF4-FFF2-40B4-BE49-F238E27FC236}">
                <a16:creationId xmlns:a16="http://schemas.microsoft.com/office/drawing/2014/main" id="{D1D819A9-F8DE-4E5C-AFC3-E0105ACD8295}"/>
              </a:ext>
            </a:extLst>
          </p:cNvPr>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a:extLst>
              <a:ext uri="{FF2B5EF4-FFF2-40B4-BE49-F238E27FC236}">
                <a16:creationId xmlns:a16="http://schemas.microsoft.com/office/drawing/2014/main" id="{A4E25320-A12F-4F3E-8EC9-11292FF36BEA}"/>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821814016"/>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1">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1C9756B-145D-4BA8-AA43-904C1E7CB86D}"/>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3" name="Footer Placeholder 2">
            <a:extLst>
              <a:ext uri="{FF2B5EF4-FFF2-40B4-BE49-F238E27FC236}">
                <a16:creationId xmlns:a16="http://schemas.microsoft.com/office/drawing/2014/main" id="{B21DB60F-139E-4C44-89AF-3F8F5EC241FB}"/>
              </a:ext>
            </a:extLst>
          </p:cNvPr>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a:extLst>
              <a:ext uri="{FF2B5EF4-FFF2-40B4-BE49-F238E27FC236}">
                <a16:creationId xmlns:a16="http://schemas.microsoft.com/office/drawing/2014/main" id="{388226C9-C193-4B47-9717-4BC86C9092C7}"/>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1757156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7" name="Freeform: Shape 6" descr="Tag=AccentColor&#10;Flavor=Light&#10;Target=Fill">
            <a:extLst>
              <a:ext uri="{FF2B5EF4-FFF2-40B4-BE49-F238E27FC236}">
                <a16:creationId xmlns:a16="http://schemas.microsoft.com/office/drawing/2014/main" id="{13B7BB51-92B8-4089-8DAB-1202A4D1C6A3}"/>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a:p>
        </p:txBody>
      </p:sp>
      <p:sp>
        <p:nvSpPr>
          <p:cNvPr id="2" name="Title 1">
            <a:extLst>
              <a:ext uri="{FF2B5EF4-FFF2-40B4-BE49-F238E27FC236}">
                <a16:creationId xmlns:a16="http://schemas.microsoft.com/office/drawing/2014/main" id="{26030E26-A86A-417A-AA64-699AA8DD3DA5}"/>
              </a:ext>
            </a:extLst>
          </p:cNvPr>
          <p:cNvSpPr>
            <a:spLocks noGrp="1"/>
          </p:cNvSpPr>
          <p:nvPr>
            <p:ph type="title"/>
          </p:nvPr>
        </p:nvSpPr>
        <p:spPr/>
        <p:txBody>
          <a:bodyPr>
            <a:normAutofit/>
          </a:bodyPr>
          <a:lstStyle>
            <a:lvl1pPr>
              <a:defRPr sz="40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D19CF97E-0E6E-41E9-B75B-0371E744D1E8}"/>
              </a:ext>
            </a:extLst>
          </p:cNvPr>
          <p:cNvSpPr>
            <a:spLocks noGrp="1"/>
          </p:cNvSpPr>
          <p:nvPr>
            <p:ph idx="1"/>
          </p:nvPr>
        </p:nvSpPr>
        <p:spPr>
          <a:xfrm>
            <a:off x="838200" y="2011680"/>
            <a:ext cx="1051560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70BAE770-8363-44CD-8A22-AB26C5C5361B}"/>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5" name="Footer Placeholder 4">
            <a:extLst>
              <a:ext uri="{FF2B5EF4-FFF2-40B4-BE49-F238E27FC236}">
                <a16:creationId xmlns:a16="http://schemas.microsoft.com/office/drawing/2014/main" id="{36E618F2-3B8E-4449-91E7-F8AA496093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3428F0-E5C2-42A1-AB2F-1A19FFAD19CF}"/>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149713305"/>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blank" preserve="1">
  <p:cSld name="Blank 2">
    <p:spTree>
      <p:nvGrpSpPr>
        <p:cNvPr id="1" name=""/>
        <p:cNvGrpSpPr/>
        <p:nvPr/>
      </p:nvGrpSpPr>
      <p:grpSpPr>
        <a:xfrm>
          <a:off x="0" y="0"/>
          <a:ext cx="0" cy="0"/>
          <a:chOff x="0" y="0"/>
          <a:chExt cx="0" cy="0"/>
        </a:xfrm>
      </p:grpSpPr>
      <p:sp>
        <p:nvSpPr>
          <p:cNvPr id="6" name="Freeform: Shape 5" descr="Mask ID=&#10;Mask position=bottom, center&#10;Mask family= brushstroke, landscape, wide">
            <a:extLst>
              <a:ext uri="{FF2B5EF4-FFF2-40B4-BE49-F238E27FC236}">
                <a16:creationId xmlns:a16="http://schemas.microsoft.com/office/drawing/2014/main" id="{736BF44D-E8DD-45FA-931D-CBCC67D57944}"/>
              </a:ext>
            </a:extLst>
          </p:cNvPr>
          <p:cNvSpPr/>
          <p:nvPr/>
        </p:nvSpPr>
        <p:spPr>
          <a:xfrm>
            <a:off x="1768100" y="-1"/>
            <a:ext cx="10423900" cy="5920155"/>
          </a:xfrm>
          <a:custGeom>
            <a:avLst/>
            <a:gdLst>
              <a:gd name="connsiteX0" fmla="*/ 10423900 w 10423900"/>
              <a:gd name="connsiteY0" fmla="*/ 0 h 5491534"/>
              <a:gd name="connsiteX1" fmla="*/ 3493157 w 10423900"/>
              <a:gd name="connsiteY1" fmla="*/ 0 h 5491534"/>
              <a:gd name="connsiteX2" fmla="*/ 3493018 w 10423900"/>
              <a:gd name="connsiteY2" fmla="*/ 31 h 5491534"/>
              <a:gd name="connsiteX3" fmla="*/ 3245493 w 10423900"/>
              <a:gd name="connsiteY3" fmla="*/ 104839 h 5491534"/>
              <a:gd name="connsiteX4" fmla="*/ 4434802 w 10423900"/>
              <a:gd name="connsiteY4" fmla="*/ 284558 h 5491534"/>
              <a:gd name="connsiteX5" fmla="*/ 4011937 w 10423900"/>
              <a:gd name="connsiteY5" fmla="*/ 395559 h 5491534"/>
              <a:gd name="connsiteX6" fmla="*/ 3573213 w 10423900"/>
              <a:gd name="connsiteY6" fmla="*/ 474847 h 5491534"/>
              <a:gd name="connsiteX7" fmla="*/ 3097489 w 10423900"/>
              <a:gd name="connsiteY7" fmla="*/ 532990 h 5491534"/>
              <a:gd name="connsiteX8" fmla="*/ 2664052 w 10423900"/>
              <a:gd name="connsiteY8" fmla="*/ 649279 h 5491534"/>
              <a:gd name="connsiteX9" fmla="*/ 3795218 w 10423900"/>
              <a:gd name="connsiteY9" fmla="*/ 696852 h 5491534"/>
              <a:gd name="connsiteX10" fmla="*/ 3208492 w 10423900"/>
              <a:gd name="connsiteY10" fmla="*/ 802568 h 5491534"/>
              <a:gd name="connsiteX11" fmla="*/ 2727483 w 10423900"/>
              <a:gd name="connsiteY11" fmla="*/ 939999 h 5491534"/>
              <a:gd name="connsiteX12" fmla="*/ 2389190 w 10423900"/>
              <a:gd name="connsiteY12" fmla="*/ 1003429 h 5491534"/>
              <a:gd name="connsiteX13" fmla="*/ 2029754 w 10423900"/>
              <a:gd name="connsiteY13" fmla="*/ 1019287 h 5491534"/>
              <a:gd name="connsiteX14" fmla="*/ 1945181 w 10423900"/>
              <a:gd name="connsiteY14" fmla="*/ 1119716 h 5491534"/>
              <a:gd name="connsiteX15" fmla="*/ 2056184 w 10423900"/>
              <a:gd name="connsiteY15" fmla="*/ 1225434 h 5491534"/>
              <a:gd name="connsiteX16" fmla="*/ 2225329 w 10423900"/>
              <a:gd name="connsiteY16" fmla="*/ 1236004 h 5491534"/>
              <a:gd name="connsiteX17" fmla="*/ 3234920 w 10423900"/>
              <a:gd name="connsiteY17" fmla="*/ 1262435 h 5491534"/>
              <a:gd name="connsiteX18" fmla="*/ 0 w 10423900"/>
              <a:gd name="connsiteY18" fmla="*/ 1495009 h 5491534"/>
              <a:gd name="connsiteX19" fmla="*/ 438724 w 10423900"/>
              <a:gd name="connsiteY19" fmla="*/ 1637728 h 5491534"/>
              <a:gd name="connsiteX20" fmla="*/ 586726 w 10423900"/>
              <a:gd name="connsiteY20" fmla="*/ 2028877 h 5491534"/>
              <a:gd name="connsiteX21" fmla="*/ 1125878 w 10423900"/>
              <a:gd name="connsiteY21" fmla="*/ 2250882 h 5491534"/>
              <a:gd name="connsiteX22" fmla="*/ 1474744 w 10423900"/>
              <a:gd name="connsiteY22" fmla="*/ 2330169 h 5491534"/>
              <a:gd name="connsiteX23" fmla="*/ 2272901 w 10423900"/>
              <a:gd name="connsiteY23" fmla="*/ 2446458 h 5491534"/>
              <a:gd name="connsiteX24" fmla="*/ 2389190 w 10423900"/>
              <a:gd name="connsiteY24" fmla="*/ 2636747 h 5491534"/>
              <a:gd name="connsiteX25" fmla="*/ 2489621 w 10423900"/>
              <a:gd name="connsiteY25" fmla="*/ 2848179 h 5491534"/>
              <a:gd name="connsiteX26" fmla="*/ 2701053 w 10423900"/>
              <a:gd name="connsiteY26" fmla="*/ 2985611 h 5491534"/>
              <a:gd name="connsiteX27" fmla="*/ 1057165 w 10423900"/>
              <a:gd name="connsiteY27" fmla="*/ 2964468 h 5491534"/>
              <a:gd name="connsiteX28" fmla="*/ 2912485 w 10423900"/>
              <a:gd name="connsiteY28" fmla="*/ 3408477 h 5491534"/>
              <a:gd name="connsiteX29" fmla="*/ 2748626 w 10423900"/>
              <a:gd name="connsiteY29" fmla="*/ 3582909 h 5491534"/>
              <a:gd name="connsiteX30" fmla="*/ 3763503 w 10423900"/>
              <a:gd name="connsiteY30" fmla="*/ 3820771 h 5491534"/>
              <a:gd name="connsiteX31" fmla="*/ 3219063 w 10423900"/>
              <a:gd name="connsiteY31" fmla="*/ 3847199 h 5491534"/>
              <a:gd name="connsiteX32" fmla="*/ 6385269 w 10423900"/>
              <a:gd name="connsiteY32" fmla="*/ 4840933 h 5491534"/>
              <a:gd name="connsiteX33" fmla="*/ 10285854 w 10423900"/>
              <a:gd name="connsiteY33" fmla="*/ 5471118 h 5491534"/>
              <a:gd name="connsiteX34" fmla="*/ 10423900 w 10423900"/>
              <a:gd name="connsiteY34" fmla="*/ 5491534 h 54915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10423900" h="5491534">
                <a:moveTo>
                  <a:pt x="10423900" y="0"/>
                </a:moveTo>
                <a:lnTo>
                  <a:pt x="3493157" y="0"/>
                </a:lnTo>
                <a:lnTo>
                  <a:pt x="3493018" y="31"/>
                </a:lnTo>
                <a:cubicBezTo>
                  <a:pt x="3414969" y="12668"/>
                  <a:pt x="3328744" y="21588"/>
                  <a:pt x="3245493" y="104839"/>
                </a:cubicBezTo>
                <a:cubicBezTo>
                  <a:pt x="3668357" y="162984"/>
                  <a:pt x="4075366" y="51981"/>
                  <a:pt x="4434802" y="284558"/>
                </a:cubicBezTo>
                <a:cubicBezTo>
                  <a:pt x="4302656" y="400846"/>
                  <a:pt x="4154654" y="374416"/>
                  <a:pt x="4011937" y="395559"/>
                </a:cubicBezTo>
                <a:cubicBezTo>
                  <a:pt x="3863934" y="416704"/>
                  <a:pt x="3721217" y="453704"/>
                  <a:pt x="3573213" y="474847"/>
                </a:cubicBezTo>
                <a:cubicBezTo>
                  <a:pt x="3414639" y="501275"/>
                  <a:pt x="3256063" y="506562"/>
                  <a:pt x="3097489" y="532990"/>
                </a:cubicBezTo>
                <a:cubicBezTo>
                  <a:pt x="2965345" y="554135"/>
                  <a:pt x="2822627" y="517133"/>
                  <a:pt x="2664052" y="649279"/>
                </a:cubicBezTo>
                <a:cubicBezTo>
                  <a:pt x="3055203" y="744424"/>
                  <a:pt x="3409352" y="601706"/>
                  <a:pt x="3795218" y="696852"/>
                </a:cubicBezTo>
                <a:cubicBezTo>
                  <a:pt x="3567928" y="781425"/>
                  <a:pt x="3382924" y="754995"/>
                  <a:pt x="3208492" y="802568"/>
                </a:cubicBezTo>
                <a:cubicBezTo>
                  <a:pt x="3049916" y="850140"/>
                  <a:pt x="2859627" y="797282"/>
                  <a:pt x="2727483" y="939999"/>
                </a:cubicBezTo>
                <a:cubicBezTo>
                  <a:pt x="2627052" y="1051000"/>
                  <a:pt x="2521336" y="1066858"/>
                  <a:pt x="2389190" y="1003429"/>
                </a:cubicBezTo>
                <a:cubicBezTo>
                  <a:pt x="2272901" y="945284"/>
                  <a:pt x="2146043" y="961142"/>
                  <a:pt x="2029754" y="1019287"/>
                </a:cubicBezTo>
                <a:cubicBezTo>
                  <a:pt x="1987468" y="1040430"/>
                  <a:pt x="1945181" y="1066858"/>
                  <a:pt x="1945181" y="1119716"/>
                </a:cubicBezTo>
                <a:cubicBezTo>
                  <a:pt x="1945181" y="1193719"/>
                  <a:pt x="1998039" y="1214862"/>
                  <a:pt x="2056184" y="1225434"/>
                </a:cubicBezTo>
                <a:cubicBezTo>
                  <a:pt x="2109042" y="1236004"/>
                  <a:pt x="2172471" y="1246577"/>
                  <a:pt x="2225329" y="1236004"/>
                </a:cubicBezTo>
                <a:cubicBezTo>
                  <a:pt x="2563622" y="1177861"/>
                  <a:pt x="2896629" y="1273005"/>
                  <a:pt x="3234920" y="1262435"/>
                </a:cubicBezTo>
                <a:cubicBezTo>
                  <a:pt x="2172471" y="1489724"/>
                  <a:pt x="1099450" y="1415723"/>
                  <a:pt x="0" y="1495009"/>
                </a:cubicBezTo>
                <a:cubicBezTo>
                  <a:pt x="142717" y="1653583"/>
                  <a:pt x="327721" y="1521439"/>
                  <a:pt x="438724" y="1637728"/>
                </a:cubicBezTo>
                <a:cubicBezTo>
                  <a:pt x="333006" y="1880875"/>
                  <a:pt x="375293" y="2013020"/>
                  <a:pt x="586726" y="2028877"/>
                </a:cubicBezTo>
                <a:cubicBezTo>
                  <a:pt x="792873" y="2044734"/>
                  <a:pt x="1014877" y="1960161"/>
                  <a:pt x="1125878" y="2250882"/>
                </a:cubicBezTo>
                <a:cubicBezTo>
                  <a:pt x="1157593" y="2340740"/>
                  <a:pt x="1353170" y="2314312"/>
                  <a:pt x="1474744" y="2330169"/>
                </a:cubicBezTo>
                <a:cubicBezTo>
                  <a:pt x="1739034" y="2367170"/>
                  <a:pt x="2019183" y="2330169"/>
                  <a:pt x="2272901" y="2446458"/>
                </a:cubicBezTo>
                <a:cubicBezTo>
                  <a:pt x="2373332" y="2488744"/>
                  <a:pt x="2442048" y="2520459"/>
                  <a:pt x="2389190" y="2636747"/>
                </a:cubicBezTo>
                <a:cubicBezTo>
                  <a:pt x="2336332" y="2758321"/>
                  <a:pt x="2405048" y="2800607"/>
                  <a:pt x="2489621" y="2848179"/>
                </a:cubicBezTo>
                <a:cubicBezTo>
                  <a:pt x="2553051" y="2885180"/>
                  <a:pt x="2648195" y="2874609"/>
                  <a:pt x="2701053" y="2985611"/>
                </a:cubicBezTo>
                <a:cubicBezTo>
                  <a:pt x="2146043" y="2969753"/>
                  <a:pt x="1606888" y="2879895"/>
                  <a:pt x="1057165" y="2964468"/>
                </a:cubicBezTo>
                <a:cubicBezTo>
                  <a:pt x="1659748" y="3175900"/>
                  <a:pt x="2320474" y="3165328"/>
                  <a:pt x="2912485" y="3408477"/>
                </a:cubicBezTo>
                <a:cubicBezTo>
                  <a:pt x="2891342" y="3493050"/>
                  <a:pt x="2753911" y="3456048"/>
                  <a:pt x="2748626" y="3582909"/>
                </a:cubicBezTo>
                <a:cubicBezTo>
                  <a:pt x="3060489" y="3715055"/>
                  <a:pt x="3435782" y="3625195"/>
                  <a:pt x="3763503" y="3820771"/>
                </a:cubicBezTo>
                <a:cubicBezTo>
                  <a:pt x="3573213" y="3910629"/>
                  <a:pt x="3398782" y="3762626"/>
                  <a:pt x="3219063" y="3847199"/>
                </a:cubicBezTo>
                <a:cubicBezTo>
                  <a:pt x="3277208" y="3974060"/>
                  <a:pt x="5909545" y="4756360"/>
                  <a:pt x="6385269" y="4840933"/>
                </a:cubicBezTo>
                <a:cubicBezTo>
                  <a:pt x="7171204" y="4982659"/>
                  <a:pt x="9157515" y="5302348"/>
                  <a:pt x="10285854" y="5471118"/>
                </a:cubicBezTo>
                <a:lnTo>
                  <a:pt x="10423900" y="5491534"/>
                </a:lnTo>
                <a:close/>
              </a:path>
            </a:pathLst>
          </a:custGeom>
          <a:solidFill>
            <a:schemeClr val="accent1">
              <a:alpha val="20000"/>
            </a:schemeClr>
          </a:solidFill>
          <a:ln w="32707" cap="flat">
            <a:noFill/>
            <a:prstDash val="solid"/>
            <a:miter/>
          </a:ln>
        </p:spPr>
        <p:txBody>
          <a:bodyPr wrap="square" rtlCol="0" anchor="ctr">
            <a:noAutofit/>
          </a:bodyPr>
          <a:lstStyle/>
          <a:p>
            <a:endParaRPr lang="en-US">
              <a:solidFill>
                <a:prstClr val="black"/>
              </a:solidFill>
            </a:endParaRPr>
          </a:p>
        </p:txBody>
      </p:sp>
      <p:sp>
        <p:nvSpPr>
          <p:cNvPr id="2" name="Date Placeholder 1">
            <a:extLst>
              <a:ext uri="{FF2B5EF4-FFF2-40B4-BE49-F238E27FC236}">
                <a16:creationId xmlns:a16="http://schemas.microsoft.com/office/drawing/2014/main" id="{71C9756B-145D-4BA8-AA43-904C1E7CB86D}"/>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3" name="Footer Placeholder 2">
            <a:extLst>
              <a:ext uri="{FF2B5EF4-FFF2-40B4-BE49-F238E27FC236}">
                <a16:creationId xmlns:a16="http://schemas.microsoft.com/office/drawing/2014/main" id="{B21DB60F-139E-4C44-89AF-3F8F5EC241FB}"/>
              </a:ext>
            </a:extLst>
          </p:cNvPr>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a:extLst>
              <a:ext uri="{FF2B5EF4-FFF2-40B4-BE49-F238E27FC236}">
                <a16:creationId xmlns:a16="http://schemas.microsoft.com/office/drawing/2014/main" id="{388226C9-C193-4B47-9717-4BC86C9092C7}"/>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9544616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8" name="Freeform: Shape 7" descr="Tag=AccentColor&#10;Flavor=Light&#10;Target=Fill">
            <a:extLst>
              <a:ext uri="{FF2B5EF4-FFF2-40B4-BE49-F238E27FC236}">
                <a16:creationId xmlns:a16="http://schemas.microsoft.com/office/drawing/2014/main" id="{76C5A8FA-6B61-4934-AF55-C595090CA5DC}"/>
              </a:ext>
            </a:extLst>
          </p:cNvPr>
          <p:cNvSpPr/>
          <p:nvPr/>
        </p:nvSpPr>
        <p:spPr>
          <a:xfrm>
            <a:off x="4726728" y="0"/>
            <a:ext cx="7472381" cy="6858000"/>
          </a:xfrm>
          <a:custGeom>
            <a:avLst/>
            <a:gdLst>
              <a:gd name="connsiteX0" fmla="*/ 1232666 w 7472381"/>
              <a:gd name="connsiteY0" fmla="*/ 0 h 6886575"/>
              <a:gd name="connsiteX1" fmla="*/ 7472381 w 7472381"/>
              <a:gd name="connsiteY1" fmla="*/ 0 h 6886575"/>
              <a:gd name="connsiteX2" fmla="*/ 7472381 w 7472381"/>
              <a:gd name="connsiteY2" fmla="*/ 814388 h 6886575"/>
              <a:gd name="connsiteX3" fmla="*/ 7472381 w 7472381"/>
              <a:gd name="connsiteY3" fmla="*/ 6411516 h 6886575"/>
              <a:gd name="connsiteX4" fmla="*/ 7472381 w 7472381"/>
              <a:gd name="connsiteY4" fmla="*/ 6886575 h 6886575"/>
              <a:gd name="connsiteX5" fmla="*/ 6992676 w 7472381"/>
              <a:gd name="connsiteY5" fmla="*/ 6886575 h 6886575"/>
              <a:gd name="connsiteX6" fmla="*/ 1946893 w 7472381"/>
              <a:gd name="connsiteY6" fmla="*/ 6886575 h 6886575"/>
              <a:gd name="connsiteX7" fmla="*/ 1506276 w 7472381"/>
              <a:gd name="connsiteY7" fmla="*/ 6686550 h 6886575"/>
              <a:gd name="connsiteX8" fmla="*/ 1314394 w 7472381"/>
              <a:gd name="connsiteY8" fmla="*/ 6457949 h 6886575"/>
              <a:gd name="connsiteX9" fmla="*/ 1246880 w 7472381"/>
              <a:gd name="connsiteY9" fmla="*/ 6393656 h 6886575"/>
              <a:gd name="connsiteX10" fmla="*/ 1079872 w 7472381"/>
              <a:gd name="connsiteY10" fmla="*/ 6307931 h 6886575"/>
              <a:gd name="connsiteX11" fmla="*/ 788495 w 7472381"/>
              <a:gd name="connsiteY11" fmla="*/ 6125765 h 6886575"/>
              <a:gd name="connsiteX12" fmla="*/ 895097 w 7472381"/>
              <a:gd name="connsiteY12" fmla="*/ 6082903 h 6886575"/>
              <a:gd name="connsiteX13" fmla="*/ 1204239 w 7472381"/>
              <a:gd name="connsiteY13" fmla="*/ 6193631 h 6886575"/>
              <a:gd name="connsiteX14" fmla="*/ 1428102 w 7472381"/>
              <a:gd name="connsiteY14" fmla="*/ 6222206 h 6886575"/>
              <a:gd name="connsiteX15" fmla="*/ 1111852 w 7472381"/>
              <a:gd name="connsiteY15" fmla="*/ 6029325 h 6886575"/>
              <a:gd name="connsiteX16" fmla="*/ 806262 w 7472381"/>
              <a:gd name="connsiteY16" fmla="*/ 5779294 h 6886575"/>
              <a:gd name="connsiteX17" fmla="*/ 1040785 w 7472381"/>
              <a:gd name="connsiteY17" fmla="*/ 5825728 h 6886575"/>
              <a:gd name="connsiteX18" fmla="*/ 1051445 w 7472381"/>
              <a:gd name="connsiteY18" fmla="*/ 5793581 h 6886575"/>
              <a:gd name="connsiteX19" fmla="*/ 845349 w 7472381"/>
              <a:gd name="connsiteY19" fmla="*/ 5497115 h 6886575"/>
              <a:gd name="connsiteX20" fmla="*/ 745855 w 7472381"/>
              <a:gd name="connsiteY20" fmla="*/ 5375672 h 6886575"/>
              <a:gd name="connsiteX21" fmla="*/ 291024 w 7472381"/>
              <a:gd name="connsiteY21" fmla="*/ 5014913 h 6886575"/>
              <a:gd name="connsiteX22" fmla="*/ 724535 w 7472381"/>
              <a:gd name="connsiteY22" fmla="*/ 5175647 h 6886575"/>
              <a:gd name="connsiteX23" fmla="*/ 276811 w 7472381"/>
              <a:gd name="connsiteY23" fmla="*/ 4825603 h 6886575"/>
              <a:gd name="connsiteX24" fmla="*/ 60055 w 7472381"/>
              <a:gd name="connsiteY24" fmla="*/ 4697016 h 6886575"/>
              <a:gd name="connsiteX25" fmla="*/ 6755 w 7472381"/>
              <a:gd name="connsiteY25" fmla="*/ 4622006 h 6886575"/>
              <a:gd name="connsiteX26" fmla="*/ 102696 w 7472381"/>
              <a:gd name="connsiteY26" fmla="*/ 4604146 h 6886575"/>
              <a:gd name="connsiteX27" fmla="*/ 397625 w 7472381"/>
              <a:gd name="connsiteY27" fmla="*/ 4632722 h 6886575"/>
              <a:gd name="connsiteX28" fmla="*/ 31628 w 7472381"/>
              <a:gd name="connsiteY28" fmla="*/ 4396978 h 6886575"/>
              <a:gd name="connsiteX29" fmla="*/ 305237 w 7472381"/>
              <a:gd name="connsiteY29" fmla="*/ 4432697 h 6886575"/>
              <a:gd name="connsiteX30" fmla="*/ 383412 w 7472381"/>
              <a:gd name="connsiteY30" fmla="*/ 4339828 h 6886575"/>
              <a:gd name="connsiteX31" fmla="*/ 511333 w 7472381"/>
              <a:gd name="connsiteY31" fmla="*/ 4189810 h 6886575"/>
              <a:gd name="connsiteX32" fmla="*/ 600167 w 7472381"/>
              <a:gd name="connsiteY32" fmla="*/ 4107656 h 6886575"/>
              <a:gd name="connsiteX33" fmla="*/ 635701 w 7472381"/>
              <a:gd name="connsiteY33" fmla="*/ 3843337 h 6886575"/>
              <a:gd name="connsiteX34" fmla="*/ 561080 w 7472381"/>
              <a:gd name="connsiteY34" fmla="*/ 3554015 h 6886575"/>
              <a:gd name="connsiteX35" fmla="*/ 354985 w 7472381"/>
              <a:gd name="connsiteY35" fmla="*/ 3407569 h 6886575"/>
              <a:gd name="connsiteX36" fmla="*/ 415392 w 7472381"/>
              <a:gd name="connsiteY36" fmla="*/ 3243263 h 6886575"/>
              <a:gd name="connsiteX37" fmla="*/ 852456 w 7472381"/>
              <a:gd name="connsiteY37" fmla="*/ 3343275 h 6886575"/>
              <a:gd name="connsiteX38" fmla="*/ 202190 w 7472381"/>
              <a:gd name="connsiteY38" fmla="*/ 2953940 h 6886575"/>
              <a:gd name="connsiteX39" fmla="*/ 312344 w 7472381"/>
              <a:gd name="connsiteY39" fmla="*/ 2936081 h 6886575"/>
              <a:gd name="connsiteX40" fmla="*/ 706768 w 7472381"/>
              <a:gd name="connsiteY40" fmla="*/ 2714625 h 6886575"/>
              <a:gd name="connsiteX41" fmla="*/ 728088 w 7472381"/>
              <a:gd name="connsiteY41" fmla="*/ 2703909 h 6886575"/>
              <a:gd name="connsiteX42" fmla="*/ 795602 w 7472381"/>
              <a:gd name="connsiteY42" fmla="*/ 2564606 h 6886575"/>
              <a:gd name="connsiteX43" fmla="*/ 1008804 w 7472381"/>
              <a:gd name="connsiteY43" fmla="*/ 2543175 h 6886575"/>
              <a:gd name="connsiteX44" fmla="*/ 1186473 w 7472381"/>
              <a:gd name="connsiteY44" fmla="*/ 2575322 h 6886575"/>
              <a:gd name="connsiteX45" fmla="*/ 1378355 w 7472381"/>
              <a:gd name="connsiteY45" fmla="*/ 2536031 h 6886575"/>
              <a:gd name="connsiteX46" fmla="*/ 1548916 w 7472381"/>
              <a:gd name="connsiteY46" fmla="*/ 2553891 h 6886575"/>
              <a:gd name="connsiteX47" fmla="*/ 1694604 w 7472381"/>
              <a:gd name="connsiteY47" fmla="*/ 2528888 h 6886575"/>
              <a:gd name="connsiteX48" fmla="*/ 1552469 w 7472381"/>
              <a:gd name="connsiteY48" fmla="*/ 2411015 h 6886575"/>
              <a:gd name="connsiteX49" fmla="*/ 1353481 w 7472381"/>
              <a:gd name="connsiteY49" fmla="*/ 2411015 h 6886575"/>
              <a:gd name="connsiteX50" fmla="*/ 1211346 w 7472381"/>
              <a:gd name="connsiteY50" fmla="*/ 2336007 h 6886575"/>
              <a:gd name="connsiteX51" fmla="*/ 1076318 w 7472381"/>
              <a:gd name="connsiteY51" fmla="*/ 2200275 h 6886575"/>
              <a:gd name="connsiteX52" fmla="*/ 600167 w 7472381"/>
              <a:gd name="connsiteY52" fmla="*/ 1982390 h 6886575"/>
              <a:gd name="connsiteX53" fmla="*/ 514886 w 7472381"/>
              <a:gd name="connsiteY53" fmla="*/ 1900238 h 6886575"/>
              <a:gd name="connsiteX54" fmla="*/ 1872273 w 7472381"/>
              <a:gd name="connsiteY54" fmla="*/ 2218135 h 6886575"/>
              <a:gd name="connsiteX55" fmla="*/ 1452975 w 7472381"/>
              <a:gd name="connsiteY55" fmla="*/ 2085975 h 6886575"/>
              <a:gd name="connsiteX56" fmla="*/ 1737245 w 7472381"/>
              <a:gd name="connsiteY56" fmla="*/ 2110978 h 6886575"/>
              <a:gd name="connsiteX57" fmla="*/ 1893593 w 7472381"/>
              <a:gd name="connsiteY57" fmla="*/ 2021681 h 6886575"/>
              <a:gd name="connsiteX58" fmla="*/ 1893593 w 7472381"/>
              <a:gd name="connsiteY58" fmla="*/ 1993106 h 6886575"/>
              <a:gd name="connsiteX59" fmla="*/ 1776332 w 7472381"/>
              <a:gd name="connsiteY59" fmla="*/ 1910953 h 6886575"/>
              <a:gd name="connsiteX60" fmla="*/ 1708818 w 7472381"/>
              <a:gd name="connsiteY60" fmla="*/ 1857375 h 6886575"/>
              <a:gd name="connsiteX61" fmla="*/ 1524043 w 7472381"/>
              <a:gd name="connsiteY61" fmla="*/ 1664493 h 6886575"/>
              <a:gd name="connsiteX62" fmla="*/ 1655517 w 7472381"/>
              <a:gd name="connsiteY62" fmla="*/ 1643062 h 6886575"/>
              <a:gd name="connsiteX63" fmla="*/ 1705264 w 7472381"/>
              <a:gd name="connsiteY63" fmla="*/ 1603772 h 6886575"/>
              <a:gd name="connsiteX64" fmla="*/ 1669731 w 7472381"/>
              <a:gd name="connsiteY64" fmla="*/ 1546622 h 6886575"/>
              <a:gd name="connsiteX65" fmla="*/ 1261093 w 7472381"/>
              <a:gd name="connsiteY65" fmla="*/ 1371600 h 6886575"/>
              <a:gd name="connsiteX66" fmla="*/ 1229113 w 7472381"/>
              <a:gd name="connsiteY66" fmla="*/ 1235869 h 6886575"/>
              <a:gd name="connsiteX67" fmla="*/ 1307287 w 7472381"/>
              <a:gd name="connsiteY67" fmla="*/ 1214437 h 6886575"/>
              <a:gd name="connsiteX68" fmla="*/ 1396121 w 7472381"/>
              <a:gd name="connsiteY68" fmla="*/ 1225153 h 6886575"/>
              <a:gd name="connsiteX69" fmla="*/ 1325054 w 7472381"/>
              <a:gd name="connsiteY69" fmla="*/ 1117997 h 6886575"/>
              <a:gd name="connsiteX70" fmla="*/ 1037231 w 7472381"/>
              <a:gd name="connsiteY70" fmla="*/ 1010841 h 6886575"/>
              <a:gd name="connsiteX71" fmla="*/ 983931 w 7472381"/>
              <a:gd name="connsiteY71" fmla="*/ 953690 h 6886575"/>
              <a:gd name="connsiteX72" fmla="*/ 1054998 w 7472381"/>
              <a:gd name="connsiteY72" fmla="*/ 925115 h 6886575"/>
              <a:gd name="connsiteX73" fmla="*/ 1108299 w 7472381"/>
              <a:gd name="connsiteY73" fmla="*/ 914400 h 6886575"/>
              <a:gd name="connsiteX74" fmla="*/ 6755 w 7472381"/>
              <a:gd name="connsiteY74" fmla="*/ 467915 h 6886575"/>
              <a:gd name="connsiteX75" fmla="*/ 255490 w 7472381"/>
              <a:gd name="connsiteY75" fmla="*/ 464344 h 6886575"/>
              <a:gd name="connsiteX76" fmla="*/ 500673 w 7472381"/>
              <a:gd name="connsiteY76" fmla="*/ 535781 h 6886575"/>
              <a:gd name="connsiteX77" fmla="*/ 760069 w 7472381"/>
              <a:gd name="connsiteY77" fmla="*/ 525066 h 6886575"/>
              <a:gd name="connsiteX78" fmla="*/ 1005251 w 7472381"/>
              <a:gd name="connsiteY78" fmla="*/ 560785 h 6886575"/>
              <a:gd name="connsiteX79" fmla="*/ 1218453 w 7472381"/>
              <a:gd name="connsiteY79" fmla="*/ 560785 h 6886575"/>
              <a:gd name="connsiteX80" fmla="*/ 1019464 w 7472381"/>
              <a:gd name="connsiteY80" fmla="*/ 507206 h 6886575"/>
              <a:gd name="connsiteX81" fmla="*/ 944844 w 7472381"/>
              <a:gd name="connsiteY81" fmla="*/ 417909 h 6886575"/>
              <a:gd name="connsiteX82" fmla="*/ 969717 w 7472381"/>
              <a:gd name="connsiteY82" fmla="*/ 335757 h 6886575"/>
              <a:gd name="connsiteX83" fmla="*/ 1051445 w 7472381"/>
              <a:gd name="connsiteY83" fmla="*/ 360759 h 6886575"/>
              <a:gd name="connsiteX84" fmla="*/ 1147386 w 7472381"/>
              <a:gd name="connsiteY84" fmla="*/ 453629 h 6886575"/>
              <a:gd name="connsiteX85" fmla="*/ 1168706 w 7472381"/>
              <a:gd name="connsiteY85" fmla="*/ 396478 h 6886575"/>
              <a:gd name="connsiteX86" fmla="*/ 1225560 w 7472381"/>
              <a:gd name="connsiteY86" fmla="*/ 353615 h 6886575"/>
              <a:gd name="connsiteX87" fmla="*/ 1552469 w 7472381"/>
              <a:gd name="connsiteY87" fmla="*/ 375047 h 6886575"/>
              <a:gd name="connsiteX88" fmla="*/ 1335714 w 7472381"/>
              <a:gd name="connsiteY88" fmla="*/ 192881 h 6886575"/>
              <a:gd name="connsiteX89" fmla="*/ 1197133 w 7472381"/>
              <a:gd name="connsiteY89" fmla="*/ 164306 h 6886575"/>
              <a:gd name="connsiteX90" fmla="*/ 1165153 w 7472381"/>
              <a:gd name="connsiteY90" fmla="*/ 89297 h 6886575"/>
              <a:gd name="connsiteX91" fmla="*/ 1229113 w 7472381"/>
              <a:gd name="connsiteY91" fmla="*/ 71437 h 6886575"/>
              <a:gd name="connsiteX92" fmla="*/ 1548916 w 7472381"/>
              <a:gd name="connsiteY92" fmla="*/ 135731 h 6886575"/>
              <a:gd name="connsiteX93" fmla="*/ 1602217 w 7472381"/>
              <a:gd name="connsiteY93" fmla="*/ 110728 h 6886575"/>
              <a:gd name="connsiteX94" fmla="*/ 1232666 w 7472381"/>
              <a:gd name="connsiteY94" fmla="*/ 0 h 68865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Lst>
            <a:rect l="l" t="t" r="r" b="b"/>
            <a:pathLst>
              <a:path w="7472381" h="6886575">
                <a:moveTo>
                  <a:pt x="1232666" y="0"/>
                </a:moveTo>
                <a:lnTo>
                  <a:pt x="7472381" y="0"/>
                </a:lnTo>
                <a:lnTo>
                  <a:pt x="7472381" y="814388"/>
                </a:lnTo>
                <a:lnTo>
                  <a:pt x="7472381" y="6411516"/>
                </a:lnTo>
                <a:lnTo>
                  <a:pt x="7472381" y="6886575"/>
                </a:lnTo>
                <a:lnTo>
                  <a:pt x="6992676" y="6886575"/>
                </a:lnTo>
                <a:lnTo>
                  <a:pt x="1946893" y="6886575"/>
                </a:lnTo>
                <a:cubicBezTo>
                  <a:pt x="1801205" y="6815137"/>
                  <a:pt x="1662624" y="6729412"/>
                  <a:pt x="1506276" y="6686550"/>
                </a:cubicBezTo>
                <a:cubicBezTo>
                  <a:pt x="1399675" y="6657975"/>
                  <a:pt x="1296627" y="6607969"/>
                  <a:pt x="1314394" y="6457949"/>
                </a:cubicBezTo>
                <a:cubicBezTo>
                  <a:pt x="1317947" y="6415087"/>
                  <a:pt x="1289520" y="6382941"/>
                  <a:pt x="1246880" y="6393656"/>
                </a:cubicBezTo>
                <a:cubicBezTo>
                  <a:pt x="1165153" y="6415087"/>
                  <a:pt x="1126065" y="6354365"/>
                  <a:pt x="1079872" y="6307931"/>
                </a:cubicBezTo>
                <a:cubicBezTo>
                  <a:pt x="998144" y="6225779"/>
                  <a:pt x="919970" y="6140052"/>
                  <a:pt x="788495" y="6125765"/>
                </a:cubicBezTo>
                <a:cubicBezTo>
                  <a:pt x="813369" y="6061471"/>
                  <a:pt x="856009" y="6068615"/>
                  <a:pt x="895097" y="6082903"/>
                </a:cubicBezTo>
                <a:cubicBezTo>
                  <a:pt x="998144" y="6118622"/>
                  <a:pt x="1101192" y="6157912"/>
                  <a:pt x="1204239" y="6193631"/>
                </a:cubicBezTo>
                <a:cubicBezTo>
                  <a:pt x="1271754" y="6215062"/>
                  <a:pt x="1339267" y="6247209"/>
                  <a:pt x="1428102" y="6222206"/>
                </a:cubicBezTo>
                <a:cubicBezTo>
                  <a:pt x="1349928" y="6093619"/>
                  <a:pt x="1218453" y="6068615"/>
                  <a:pt x="1111852" y="6029325"/>
                </a:cubicBezTo>
                <a:cubicBezTo>
                  <a:pt x="980377" y="5979319"/>
                  <a:pt x="902203" y="5886450"/>
                  <a:pt x="806262" y="5779294"/>
                </a:cubicBezTo>
                <a:cubicBezTo>
                  <a:pt x="902203" y="5750719"/>
                  <a:pt x="962610" y="5829300"/>
                  <a:pt x="1040785" y="5825728"/>
                </a:cubicBezTo>
                <a:cubicBezTo>
                  <a:pt x="1044338" y="5815012"/>
                  <a:pt x="1051445" y="5793581"/>
                  <a:pt x="1051445" y="5793581"/>
                </a:cubicBezTo>
                <a:cubicBezTo>
                  <a:pt x="923523" y="5736431"/>
                  <a:pt x="866670" y="5629275"/>
                  <a:pt x="845349" y="5497115"/>
                </a:cubicBezTo>
                <a:cubicBezTo>
                  <a:pt x="838243" y="5429250"/>
                  <a:pt x="792049" y="5407819"/>
                  <a:pt x="745855" y="5375672"/>
                </a:cubicBezTo>
                <a:cubicBezTo>
                  <a:pt x="589507" y="5264943"/>
                  <a:pt x="422499" y="5164931"/>
                  <a:pt x="291024" y="5014913"/>
                </a:cubicBezTo>
                <a:cubicBezTo>
                  <a:pt x="443819" y="5032771"/>
                  <a:pt x="564633" y="5132784"/>
                  <a:pt x="724535" y="5175647"/>
                </a:cubicBezTo>
                <a:cubicBezTo>
                  <a:pt x="596614" y="5011340"/>
                  <a:pt x="429605" y="4925615"/>
                  <a:pt x="276811" y="4825603"/>
                </a:cubicBezTo>
                <a:cubicBezTo>
                  <a:pt x="205743" y="4779169"/>
                  <a:pt x="141783" y="4722018"/>
                  <a:pt x="60055" y="4697016"/>
                </a:cubicBezTo>
                <a:cubicBezTo>
                  <a:pt x="31628" y="4689872"/>
                  <a:pt x="-18119" y="4672013"/>
                  <a:pt x="6755" y="4622006"/>
                </a:cubicBezTo>
                <a:cubicBezTo>
                  <a:pt x="28075" y="4579144"/>
                  <a:pt x="67162" y="4593432"/>
                  <a:pt x="102696" y="4604146"/>
                </a:cubicBezTo>
                <a:cubicBezTo>
                  <a:pt x="187976" y="4632722"/>
                  <a:pt x="280364" y="4632722"/>
                  <a:pt x="397625" y="4632722"/>
                </a:cubicBezTo>
                <a:cubicBezTo>
                  <a:pt x="298131" y="4496990"/>
                  <a:pt x="116909" y="4539853"/>
                  <a:pt x="31628" y="4396978"/>
                </a:cubicBezTo>
                <a:cubicBezTo>
                  <a:pt x="138229" y="4371976"/>
                  <a:pt x="219957" y="4421982"/>
                  <a:pt x="305237" y="4432697"/>
                </a:cubicBezTo>
                <a:cubicBezTo>
                  <a:pt x="383412" y="4443413"/>
                  <a:pt x="401178" y="4418409"/>
                  <a:pt x="383412" y="4339828"/>
                </a:cubicBezTo>
                <a:cubicBezTo>
                  <a:pt x="354985" y="4218385"/>
                  <a:pt x="397625" y="4157662"/>
                  <a:pt x="511333" y="4189810"/>
                </a:cubicBezTo>
                <a:cubicBezTo>
                  <a:pt x="617934" y="4221956"/>
                  <a:pt x="628594" y="4175522"/>
                  <a:pt x="600167" y="4107656"/>
                </a:cubicBezTo>
                <a:cubicBezTo>
                  <a:pt x="557527" y="4007644"/>
                  <a:pt x="603720" y="3929063"/>
                  <a:pt x="635701" y="3843337"/>
                </a:cubicBezTo>
                <a:cubicBezTo>
                  <a:pt x="685448" y="3714750"/>
                  <a:pt x="664128" y="3650456"/>
                  <a:pt x="561080" y="3554015"/>
                </a:cubicBezTo>
                <a:cubicBezTo>
                  <a:pt x="500673" y="3500438"/>
                  <a:pt x="440265" y="3454003"/>
                  <a:pt x="354985" y="3407569"/>
                </a:cubicBezTo>
                <a:cubicBezTo>
                  <a:pt x="550420" y="3382565"/>
                  <a:pt x="347878" y="3296841"/>
                  <a:pt x="415392" y="3243263"/>
                </a:cubicBezTo>
                <a:cubicBezTo>
                  <a:pt x="553973" y="3221831"/>
                  <a:pt x="664128" y="3393282"/>
                  <a:pt x="852456" y="3343275"/>
                </a:cubicBezTo>
                <a:cubicBezTo>
                  <a:pt x="625041" y="3196828"/>
                  <a:pt x="369198" y="3150393"/>
                  <a:pt x="202190" y="2953940"/>
                </a:cubicBezTo>
                <a:cubicBezTo>
                  <a:pt x="241277" y="2911078"/>
                  <a:pt x="280364" y="2953940"/>
                  <a:pt x="312344" y="2936081"/>
                </a:cubicBezTo>
                <a:cubicBezTo>
                  <a:pt x="312344" y="2925365"/>
                  <a:pt x="685448" y="2993232"/>
                  <a:pt x="706768" y="2714625"/>
                </a:cubicBezTo>
                <a:cubicBezTo>
                  <a:pt x="713875" y="2714625"/>
                  <a:pt x="720982" y="2714625"/>
                  <a:pt x="728088" y="2703909"/>
                </a:cubicBezTo>
                <a:cubicBezTo>
                  <a:pt x="767175" y="2664619"/>
                  <a:pt x="731642" y="2571750"/>
                  <a:pt x="795602" y="2564606"/>
                </a:cubicBezTo>
                <a:cubicBezTo>
                  <a:pt x="866670" y="2557462"/>
                  <a:pt x="934184" y="2525315"/>
                  <a:pt x="1008804" y="2543175"/>
                </a:cubicBezTo>
                <a:cubicBezTo>
                  <a:pt x="1065658" y="2557462"/>
                  <a:pt x="1126065" y="2575322"/>
                  <a:pt x="1186473" y="2575322"/>
                </a:cubicBezTo>
                <a:cubicBezTo>
                  <a:pt x="1250433" y="2575322"/>
                  <a:pt x="1339267" y="2696766"/>
                  <a:pt x="1378355" y="2536031"/>
                </a:cubicBezTo>
                <a:cubicBezTo>
                  <a:pt x="1378355" y="2528888"/>
                  <a:pt x="1488509" y="2546747"/>
                  <a:pt x="1548916" y="2553891"/>
                </a:cubicBezTo>
                <a:cubicBezTo>
                  <a:pt x="1598663" y="2561035"/>
                  <a:pt x="1659071" y="2593181"/>
                  <a:pt x="1694604" y="2528888"/>
                </a:cubicBezTo>
                <a:cubicBezTo>
                  <a:pt x="1712371" y="2489596"/>
                  <a:pt x="1627090" y="2418159"/>
                  <a:pt x="1552469" y="2411015"/>
                </a:cubicBezTo>
                <a:cubicBezTo>
                  <a:pt x="1484956" y="2403872"/>
                  <a:pt x="1417442" y="2396728"/>
                  <a:pt x="1353481" y="2411015"/>
                </a:cubicBezTo>
                <a:cubicBezTo>
                  <a:pt x="1275307" y="2428875"/>
                  <a:pt x="1232666" y="2400300"/>
                  <a:pt x="1211346" y="2336007"/>
                </a:cubicBezTo>
                <a:cubicBezTo>
                  <a:pt x="1186473" y="2268141"/>
                  <a:pt x="1140279" y="2232422"/>
                  <a:pt x="1076318" y="2200275"/>
                </a:cubicBezTo>
                <a:cubicBezTo>
                  <a:pt x="919970" y="2121694"/>
                  <a:pt x="770729" y="2028825"/>
                  <a:pt x="600167" y="1982390"/>
                </a:cubicBezTo>
                <a:cubicBezTo>
                  <a:pt x="568187" y="1975246"/>
                  <a:pt x="529100" y="1960959"/>
                  <a:pt x="514886" y="1900238"/>
                </a:cubicBezTo>
                <a:cubicBezTo>
                  <a:pt x="976824" y="1993106"/>
                  <a:pt x="1396121" y="2232422"/>
                  <a:pt x="1872273" y="2218135"/>
                </a:cubicBezTo>
                <a:cubicBezTo>
                  <a:pt x="1744351" y="2143125"/>
                  <a:pt x="1591557" y="2139554"/>
                  <a:pt x="1452975" y="2085975"/>
                </a:cubicBezTo>
                <a:cubicBezTo>
                  <a:pt x="1552469" y="2046685"/>
                  <a:pt x="1644857" y="2089547"/>
                  <a:pt x="1737245" y="2110978"/>
                </a:cubicBezTo>
                <a:cubicBezTo>
                  <a:pt x="1815419" y="2128837"/>
                  <a:pt x="1886486" y="2132410"/>
                  <a:pt x="1893593" y="2021681"/>
                </a:cubicBezTo>
                <a:cubicBezTo>
                  <a:pt x="1893593" y="2010965"/>
                  <a:pt x="1893593" y="2003821"/>
                  <a:pt x="1893593" y="1993106"/>
                </a:cubicBezTo>
                <a:cubicBezTo>
                  <a:pt x="1865166" y="1946672"/>
                  <a:pt x="1826079" y="1925240"/>
                  <a:pt x="1776332" y="1910953"/>
                </a:cubicBezTo>
                <a:cubicBezTo>
                  <a:pt x="1747905" y="1903809"/>
                  <a:pt x="1708818" y="1889522"/>
                  <a:pt x="1708818" y="1857375"/>
                </a:cubicBezTo>
                <a:cubicBezTo>
                  <a:pt x="1712371" y="1735931"/>
                  <a:pt x="1616430" y="1700212"/>
                  <a:pt x="1524043" y="1664493"/>
                </a:cubicBezTo>
                <a:cubicBezTo>
                  <a:pt x="1573790" y="1603772"/>
                  <a:pt x="1616430" y="1646635"/>
                  <a:pt x="1655517" y="1643062"/>
                </a:cubicBezTo>
                <a:cubicBezTo>
                  <a:pt x="1680391" y="1639491"/>
                  <a:pt x="1705264" y="1635919"/>
                  <a:pt x="1705264" y="1603772"/>
                </a:cubicBezTo>
                <a:cubicBezTo>
                  <a:pt x="1705264" y="1578769"/>
                  <a:pt x="1694604" y="1546622"/>
                  <a:pt x="1669731" y="1546622"/>
                </a:cubicBezTo>
                <a:cubicBezTo>
                  <a:pt x="1513383" y="1543050"/>
                  <a:pt x="1424548" y="1371600"/>
                  <a:pt x="1261093" y="1371600"/>
                </a:cubicBezTo>
                <a:cubicBezTo>
                  <a:pt x="1161599" y="1371600"/>
                  <a:pt x="1310841" y="1275159"/>
                  <a:pt x="1229113" y="1235869"/>
                </a:cubicBezTo>
                <a:cubicBezTo>
                  <a:pt x="1211346" y="1225153"/>
                  <a:pt x="1278860" y="1210866"/>
                  <a:pt x="1307287" y="1214437"/>
                </a:cubicBezTo>
                <a:cubicBezTo>
                  <a:pt x="1335714" y="1218009"/>
                  <a:pt x="1360588" y="1243013"/>
                  <a:pt x="1396121" y="1225153"/>
                </a:cubicBezTo>
                <a:cubicBezTo>
                  <a:pt x="1413888" y="1160860"/>
                  <a:pt x="1367694" y="1135856"/>
                  <a:pt x="1325054" y="1117997"/>
                </a:cubicBezTo>
                <a:cubicBezTo>
                  <a:pt x="1232666" y="1075135"/>
                  <a:pt x="1140279" y="1025129"/>
                  <a:pt x="1037231" y="1010841"/>
                </a:cubicBezTo>
                <a:cubicBezTo>
                  <a:pt x="1001698" y="1007269"/>
                  <a:pt x="980377" y="989409"/>
                  <a:pt x="983931" y="953690"/>
                </a:cubicBezTo>
                <a:cubicBezTo>
                  <a:pt x="991037" y="907256"/>
                  <a:pt x="1026571" y="921544"/>
                  <a:pt x="1054998" y="925115"/>
                </a:cubicBezTo>
                <a:cubicBezTo>
                  <a:pt x="1072765" y="928688"/>
                  <a:pt x="1090532" y="939403"/>
                  <a:pt x="1108299" y="914400"/>
                </a:cubicBezTo>
                <a:cubicBezTo>
                  <a:pt x="692555" y="660797"/>
                  <a:pt x="472246" y="675085"/>
                  <a:pt x="6755" y="467915"/>
                </a:cubicBezTo>
                <a:cubicBezTo>
                  <a:pt x="109802" y="428625"/>
                  <a:pt x="184423" y="457200"/>
                  <a:pt x="255490" y="464344"/>
                </a:cubicBezTo>
                <a:cubicBezTo>
                  <a:pt x="433159" y="482203"/>
                  <a:pt x="323004" y="514350"/>
                  <a:pt x="500673" y="535781"/>
                </a:cubicBezTo>
                <a:cubicBezTo>
                  <a:pt x="585954" y="546497"/>
                  <a:pt x="664128" y="582216"/>
                  <a:pt x="760069" y="525066"/>
                </a:cubicBezTo>
                <a:cubicBezTo>
                  <a:pt x="824029" y="485775"/>
                  <a:pt x="927077" y="528637"/>
                  <a:pt x="1005251" y="560785"/>
                </a:cubicBezTo>
                <a:cubicBezTo>
                  <a:pt x="1069212" y="589360"/>
                  <a:pt x="1133172" y="596503"/>
                  <a:pt x="1218453" y="560785"/>
                </a:cubicBezTo>
                <a:cubicBezTo>
                  <a:pt x="1140279" y="539354"/>
                  <a:pt x="1079872" y="521494"/>
                  <a:pt x="1019464" y="507206"/>
                </a:cubicBezTo>
                <a:cubicBezTo>
                  <a:pt x="969717" y="496491"/>
                  <a:pt x="941290" y="471488"/>
                  <a:pt x="944844" y="417909"/>
                </a:cubicBezTo>
                <a:cubicBezTo>
                  <a:pt x="944844" y="389334"/>
                  <a:pt x="934184" y="350044"/>
                  <a:pt x="969717" y="335757"/>
                </a:cubicBezTo>
                <a:cubicBezTo>
                  <a:pt x="998144" y="321469"/>
                  <a:pt x="1037231" y="335757"/>
                  <a:pt x="1051445" y="360759"/>
                </a:cubicBezTo>
                <a:cubicBezTo>
                  <a:pt x="1069212" y="407194"/>
                  <a:pt x="1086978" y="450056"/>
                  <a:pt x="1147386" y="453629"/>
                </a:cubicBezTo>
                <a:cubicBezTo>
                  <a:pt x="1229113" y="460771"/>
                  <a:pt x="1182919" y="432197"/>
                  <a:pt x="1168706" y="396478"/>
                </a:cubicBezTo>
                <a:cubicBezTo>
                  <a:pt x="1154492" y="357188"/>
                  <a:pt x="1197133" y="346472"/>
                  <a:pt x="1225560" y="353615"/>
                </a:cubicBezTo>
                <a:cubicBezTo>
                  <a:pt x="1332161" y="385763"/>
                  <a:pt x="1442315" y="328613"/>
                  <a:pt x="1552469" y="375047"/>
                </a:cubicBezTo>
                <a:cubicBezTo>
                  <a:pt x="1524043" y="260747"/>
                  <a:pt x="1463635" y="210741"/>
                  <a:pt x="1335714" y="192881"/>
                </a:cubicBezTo>
                <a:cubicBezTo>
                  <a:pt x="1289520" y="189310"/>
                  <a:pt x="1239773" y="196453"/>
                  <a:pt x="1197133" y="164306"/>
                </a:cubicBezTo>
                <a:cubicBezTo>
                  <a:pt x="1172259" y="146447"/>
                  <a:pt x="1147386" y="125016"/>
                  <a:pt x="1165153" y="89297"/>
                </a:cubicBezTo>
                <a:cubicBezTo>
                  <a:pt x="1175813" y="64294"/>
                  <a:pt x="1204239" y="64294"/>
                  <a:pt x="1229113" y="71437"/>
                </a:cubicBezTo>
                <a:cubicBezTo>
                  <a:pt x="1332161" y="110728"/>
                  <a:pt x="1442315" y="121444"/>
                  <a:pt x="1548916" y="135731"/>
                </a:cubicBezTo>
                <a:cubicBezTo>
                  <a:pt x="1566683" y="139303"/>
                  <a:pt x="1584450" y="146447"/>
                  <a:pt x="1602217" y="110728"/>
                </a:cubicBezTo>
                <a:cubicBezTo>
                  <a:pt x="1477849" y="78581"/>
                  <a:pt x="1357034" y="35719"/>
                  <a:pt x="1232666" y="0"/>
                </a:cubicBezTo>
                <a:close/>
              </a:path>
            </a:pathLst>
          </a:custGeom>
          <a:solidFill>
            <a:schemeClr val="accent1">
              <a:alpha val="20000"/>
            </a:schemeClr>
          </a:solidFill>
          <a:ln w="32707" cap="flat">
            <a:noFill/>
            <a:prstDash val="solid"/>
            <a:miter/>
          </a:ln>
        </p:spPr>
        <p:txBody>
          <a:bodyPr rtlCol="0" anchor="ctr"/>
          <a:lstStyle/>
          <a:p>
            <a:endParaRPr lang="en-US">
              <a:solidFill>
                <a:prstClr val="black"/>
              </a:solidFill>
            </a:endParaRPr>
          </a:p>
        </p:txBody>
      </p:sp>
      <p:sp>
        <p:nvSpPr>
          <p:cNvPr id="2" name="Title 1">
            <a:extLst>
              <a:ext uri="{FF2B5EF4-FFF2-40B4-BE49-F238E27FC236}">
                <a16:creationId xmlns:a16="http://schemas.microsoft.com/office/drawing/2014/main" id="{146AD042-DE90-4088-8A07-B9A64C2CE03E}"/>
              </a:ext>
            </a:extLst>
          </p:cNvPr>
          <p:cNvSpPr>
            <a:spLocks noGrp="1"/>
          </p:cNvSpPr>
          <p:nvPr>
            <p:ph type="title"/>
          </p:nvPr>
        </p:nvSpPr>
        <p:spPr>
          <a:xfrm>
            <a:off x="839788" y="640080"/>
            <a:ext cx="3886200" cy="2953512"/>
          </a:xfrm>
        </p:spPr>
        <p:txBody>
          <a:bodyPr anchor="b"/>
          <a:lstStyle>
            <a:lvl1pPr>
              <a:defRPr sz="32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BF2FFC98-62A0-445A-BEDA-785BE925A1D8}"/>
              </a:ext>
            </a:extLst>
          </p:cNvPr>
          <p:cNvSpPr>
            <a:spLocks noGrp="1"/>
          </p:cNvSpPr>
          <p:nvPr>
            <p:ph idx="1"/>
          </p:nvPr>
        </p:nvSpPr>
        <p:spPr>
          <a:xfrm>
            <a:off x="7059168" y="640080"/>
            <a:ext cx="4489704" cy="5596128"/>
          </a:xfrm>
        </p:spPr>
        <p:txBody>
          <a:bodyPr anchor="ct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a:extLst>
              <a:ext uri="{FF2B5EF4-FFF2-40B4-BE49-F238E27FC236}">
                <a16:creationId xmlns:a16="http://schemas.microsoft.com/office/drawing/2014/main" id="{DB4D7827-8489-4EE4-88EE-16685FE6DE8A}"/>
              </a:ext>
            </a:extLst>
          </p:cNvPr>
          <p:cNvSpPr>
            <a:spLocks noGrp="1"/>
          </p:cNvSpPr>
          <p:nvPr>
            <p:ph type="body" sz="half" idx="2"/>
          </p:nvPr>
        </p:nvSpPr>
        <p:spPr>
          <a:xfrm>
            <a:off x="839788" y="3776472"/>
            <a:ext cx="3886200" cy="2468880"/>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C33534F-EA91-4A50-B0F6-10D689E458EF}"/>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6C20F3F7-8B4B-4015-AA9C-109D05B2F146}"/>
              </a:ext>
            </a:extLst>
          </p:cNvPr>
          <p:cNvSpPr>
            <a:spLocks noGrp="1"/>
          </p:cNvSpPr>
          <p:nvPr>
            <p:ph type="ftr" sz="quarter" idx="11"/>
          </p:nvPr>
        </p:nvSpPr>
        <p:spPr/>
        <p:txBody>
          <a:bodyPr/>
          <a:lstStyle>
            <a:lvl1pPr algn="l">
              <a:defRPr/>
            </a:lvl1p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910B6EE2-78A1-4D01-87BE-A1487FBD271F}"/>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838918082"/>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8" name="Graphic 1" descr="Tag=AccentColor&#10;Flavor=Light&#10;Target=Fill">
            <a:extLst>
              <a:ext uri="{FF2B5EF4-FFF2-40B4-BE49-F238E27FC236}">
                <a16:creationId xmlns:a16="http://schemas.microsoft.com/office/drawing/2014/main" id="{0EE21C0F-70D8-4F3C-9392-07559C90EE6E}"/>
              </a:ext>
            </a:extLst>
          </p:cNvPr>
          <p:cNvSpPr/>
          <p:nvPr/>
        </p:nvSpPr>
        <p:spPr>
          <a:xfrm rot="10800000" flipH="1" flipV="1">
            <a:off x="684965" y="1332237"/>
            <a:ext cx="5263732" cy="3841102"/>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solidFill>
                <a:prstClr val="black"/>
              </a:solidFill>
            </a:endParaRPr>
          </a:p>
        </p:txBody>
      </p:sp>
      <p:sp>
        <p:nvSpPr>
          <p:cNvPr id="2" name="Title 1">
            <a:extLst>
              <a:ext uri="{FF2B5EF4-FFF2-40B4-BE49-F238E27FC236}">
                <a16:creationId xmlns:a16="http://schemas.microsoft.com/office/drawing/2014/main" id="{48DB1DFE-8154-440D-93CF-FEF7860E897F}"/>
              </a:ext>
            </a:extLst>
          </p:cNvPr>
          <p:cNvSpPr>
            <a:spLocks noGrp="1"/>
          </p:cNvSpPr>
          <p:nvPr>
            <p:ph type="title"/>
          </p:nvPr>
        </p:nvSpPr>
        <p:spPr>
          <a:xfrm>
            <a:off x="1399032" y="2523744"/>
            <a:ext cx="3831336" cy="1453896"/>
          </a:xfrm>
        </p:spPr>
        <p:txBody>
          <a:bodyPr anchor="b"/>
          <a:lstStyle>
            <a:lvl1pPr algn="ctr">
              <a:defRPr sz="3200"/>
            </a:lvl1pPr>
          </a:lstStyle>
          <a:p>
            <a:r>
              <a:rPr lang="en-US"/>
              <a:t>Click to edit Master title style</a:t>
            </a:r>
            <a:endParaRPr lang="en-US" dirty="0"/>
          </a:p>
        </p:txBody>
      </p:sp>
      <p:sp>
        <p:nvSpPr>
          <p:cNvPr id="3" name="Picture Placeholder 2">
            <a:extLst>
              <a:ext uri="{FF2B5EF4-FFF2-40B4-BE49-F238E27FC236}">
                <a16:creationId xmlns:a16="http://schemas.microsoft.com/office/drawing/2014/main" id="{9CD9D1F5-05CC-48F3-A314-315EF1703043}"/>
              </a:ext>
            </a:extLst>
          </p:cNvPr>
          <p:cNvSpPr>
            <a:spLocks noGrp="1"/>
          </p:cNvSpPr>
          <p:nvPr>
            <p:ph type="pic" idx="1"/>
          </p:nvPr>
        </p:nvSpPr>
        <p:spPr>
          <a:xfrm>
            <a:off x="6711696" y="640079"/>
            <a:ext cx="4837176" cy="5568696"/>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a:extLst>
              <a:ext uri="{FF2B5EF4-FFF2-40B4-BE49-F238E27FC236}">
                <a16:creationId xmlns:a16="http://schemas.microsoft.com/office/drawing/2014/main" id="{211807DE-1178-4BBB-89D8-9046239C2DE9}"/>
              </a:ext>
            </a:extLst>
          </p:cNvPr>
          <p:cNvSpPr>
            <a:spLocks noGrp="1"/>
          </p:cNvSpPr>
          <p:nvPr>
            <p:ph type="body" sz="half" idx="2"/>
          </p:nvPr>
        </p:nvSpPr>
        <p:spPr>
          <a:xfrm>
            <a:off x="1655064" y="4087368"/>
            <a:ext cx="3319272" cy="649224"/>
          </a:xfrm>
        </p:spPr>
        <p:txBody>
          <a:bodyPr>
            <a:noAutofit/>
          </a:bodyPr>
          <a:lstStyle>
            <a:lvl1pPr marL="0" indent="0" algn="ctr">
              <a:buNone/>
              <a:defRPr sz="2000" cap="all" baseline="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D48EA59-A1BC-48B7-9495-6D5C6035B14B}"/>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49F85A72-B50F-440E-AAD3-53C099F6D9B6}"/>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72C2D00B-4207-4720-8C68-605CAFDD5CA2}"/>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079361498"/>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1C888B-58B8-4428-8B1D-4E26FC5DD59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314F67B-D516-42FA-A2CA-2DCD37CFE8D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82BA5FF-4919-4FF8-9C04-06CE156B762F}"/>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CBEDA970-128E-4150-8E5A-A1B056E83502}"/>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EAEC6CD1-EE5E-42EF-B76D-BB803BA6AB5E}"/>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30139267"/>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50C2A1B-34CA-4877-9435-D77DF325757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F255E5E-4A81-44CC-8D99-F56E625D463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19CEECF-A221-4ECC-AD9C-E197D516D24C}"/>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018F41AE-0DDE-49ED-9F0C-E0E16F599A0E}"/>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B7B47FB7-77F0-4C43-B81E-D04B31C953DA}"/>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44189498"/>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Graphic 1" descr="Tag=AccentColor&#10;Flavor=Light&#10;Target=Fill">
            <a:extLst>
              <a:ext uri="{FF2B5EF4-FFF2-40B4-BE49-F238E27FC236}">
                <a16:creationId xmlns:a16="http://schemas.microsoft.com/office/drawing/2014/main" id="{0D57E7FA-E8FC-45AC-868F-CDC8144939D6}"/>
              </a:ext>
            </a:extLst>
          </p:cNvPr>
          <p:cNvSpPr/>
          <p:nvPr/>
        </p:nvSpPr>
        <p:spPr>
          <a:xfrm rot="10800000" flipV="1">
            <a:off x="2599854" y="527562"/>
            <a:ext cx="6992292" cy="5102484"/>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solidFill>
                <a:prstClr val="black"/>
              </a:solidFill>
            </a:endParaRPr>
          </a:p>
        </p:txBody>
      </p:sp>
      <p:sp>
        <p:nvSpPr>
          <p:cNvPr id="2" name="Title 1">
            <a:extLst>
              <a:ext uri="{FF2B5EF4-FFF2-40B4-BE49-F238E27FC236}">
                <a16:creationId xmlns:a16="http://schemas.microsoft.com/office/drawing/2014/main" id="{807094A5-EB6F-441D-88F8-CD7A30C84707}"/>
              </a:ext>
            </a:extLst>
          </p:cNvPr>
          <p:cNvSpPr>
            <a:spLocks noGrp="1"/>
          </p:cNvSpPr>
          <p:nvPr>
            <p:ph type="ctrTitle"/>
          </p:nvPr>
        </p:nvSpPr>
        <p:spPr>
          <a:xfrm>
            <a:off x="1508760" y="1591056"/>
            <a:ext cx="5705856" cy="3264408"/>
          </a:xfrm>
        </p:spPr>
        <p:txBody>
          <a:bodyPr anchor="b">
            <a:normAutofit/>
          </a:bodyPr>
          <a:lstStyle>
            <a:lvl1pPr algn="l">
              <a:defRPr sz="4800"/>
            </a:lvl1pPr>
          </a:lstStyle>
          <a:p>
            <a:r>
              <a:rPr lang="en-US"/>
              <a:t>Click to edit Master title style</a:t>
            </a:r>
            <a:endParaRPr lang="en-US" dirty="0"/>
          </a:p>
        </p:txBody>
      </p:sp>
      <p:sp>
        <p:nvSpPr>
          <p:cNvPr id="3" name="Subtitle 2">
            <a:extLst>
              <a:ext uri="{FF2B5EF4-FFF2-40B4-BE49-F238E27FC236}">
                <a16:creationId xmlns:a16="http://schemas.microsoft.com/office/drawing/2014/main" id="{1C7CE1E3-3929-42A6-81B7-056BD88EF353}"/>
              </a:ext>
            </a:extLst>
          </p:cNvPr>
          <p:cNvSpPr>
            <a:spLocks noGrp="1"/>
          </p:cNvSpPr>
          <p:nvPr>
            <p:ph type="subTitle" idx="1"/>
          </p:nvPr>
        </p:nvSpPr>
        <p:spPr>
          <a:xfrm>
            <a:off x="1524000" y="4928616"/>
            <a:ext cx="5705856" cy="996696"/>
          </a:xfrm>
        </p:spPr>
        <p:txBody>
          <a:bodyPr/>
          <a:lstStyle>
            <a:lvl1pPr marL="0" indent="0" algn="l">
              <a:buNone/>
              <a:defRPr sz="2400" cap="all" baseline="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a:extLst>
              <a:ext uri="{FF2B5EF4-FFF2-40B4-BE49-F238E27FC236}">
                <a16:creationId xmlns:a16="http://schemas.microsoft.com/office/drawing/2014/main" id="{5CE951E3-0794-422C-AF76-0AD4A7FB19EB}"/>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114EBFA8-0291-4D77-A9D9-B17FC2382A80}"/>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357AC4D4-C4EE-4624-A329-C608A1D5AFE1}"/>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25359831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7" name="Freeform: Shape 6" descr="Tag=AccentColor&#10;Flavor=Light&#10;Target=Fill">
            <a:extLst>
              <a:ext uri="{FF2B5EF4-FFF2-40B4-BE49-F238E27FC236}">
                <a16:creationId xmlns:a16="http://schemas.microsoft.com/office/drawing/2014/main" id="{13B7BB51-92B8-4089-8DAB-1202A4D1C6A3}"/>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a:solidFill>
                <a:prstClr val="black"/>
              </a:solidFill>
            </a:endParaRPr>
          </a:p>
        </p:txBody>
      </p:sp>
      <p:sp>
        <p:nvSpPr>
          <p:cNvPr id="2" name="Title 1">
            <a:extLst>
              <a:ext uri="{FF2B5EF4-FFF2-40B4-BE49-F238E27FC236}">
                <a16:creationId xmlns:a16="http://schemas.microsoft.com/office/drawing/2014/main" id="{26030E26-A86A-417A-AA64-699AA8DD3DA5}"/>
              </a:ext>
            </a:extLst>
          </p:cNvPr>
          <p:cNvSpPr>
            <a:spLocks noGrp="1"/>
          </p:cNvSpPr>
          <p:nvPr>
            <p:ph type="title"/>
          </p:nvPr>
        </p:nvSpPr>
        <p:spPr/>
        <p:txBody>
          <a:bodyPr>
            <a:normAutofit/>
          </a:bodyPr>
          <a:lstStyle>
            <a:lvl1pPr>
              <a:defRPr sz="40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D19CF97E-0E6E-41E9-B75B-0371E744D1E8}"/>
              </a:ext>
            </a:extLst>
          </p:cNvPr>
          <p:cNvSpPr>
            <a:spLocks noGrp="1"/>
          </p:cNvSpPr>
          <p:nvPr>
            <p:ph idx="1"/>
          </p:nvPr>
        </p:nvSpPr>
        <p:spPr>
          <a:xfrm>
            <a:off x="838200" y="2011680"/>
            <a:ext cx="1051560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70BAE770-8363-44CD-8A22-AB26C5C5361B}"/>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36E618F2-3B8E-4449-91E7-F8AA4960938F}"/>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063428F0-E5C2-42A1-AB2F-1A19FFAD19CF}"/>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857536713"/>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7" name="Graphic 9" descr="Tag=AccentColor&#10;Flavor=Light&#10;Target=Fill">
            <a:extLst>
              <a:ext uri="{FF2B5EF4-FFF2-40B4-BE49-F238E27FC236}">
                <a16:creationId xmlns:a16="http://schemas.microsoft.com/office/drawing/2014/main" id="{DB2CE8D6-5B4E-4EBE-9ED5-A1DA7E2A5CDA}"/>
              </a:ext>
            </a:extLst>
          </p:cNvPr>
          <p:cNvSpPr/>
          <p:nvPr/>
        </p:nvSpPr>
        <p:spPr>
          <a:xfrm>
            <a:off x="7209816" y="0"/>
            <a:ext cx="4143984" cy="5747660"/>
          </a:xfrm>
          <a:custGeom>
            <a:avLst/>
            <a:gdLst>
              <a:gd name="connsiteX0" fmla="*/ 0 w 3843750"/>
              <a:gd name="connsiteY0" fmla="*/ 346 h 5956080"/>
              <a:gd name="connsiteX1" fmla="*/ 72373 w 3843750"/>
              <a:gd name="connsiteY1" fmla="*/ 2447534 h 5956080"/>
              <a:gd name="connsiteX2" fmla="*/ 145093 w 3843750"/>
              <a:gd name="connsiteY2" fmla="*/ 3878724 h 5956080"/>
              <a:gd name="connsiteX3" fmla="*/ 237897 w 3843750"/>
              <a:gd name="connsiteY3" fmla="*/ 4208041 h 5956080"/>
              <a:gd name="connsiteX4" fmla="*/ 281875 w 3843750"/>
              <a:gd name="connsiteY4" fmla="*/ 4677601 h 5956080"/>
              <a:gd name="connsiteX5" fmla="*/ 360135 w 3843750"/>
              <a:gd name="connsiteY5" fmla="*/ 5287407 h 5956080"/>
              <a:gd name="connsiteX6" fmla="*/ 414155 w 3843750"/>
              <a:gd name="connsiteY6" fmla="*/ 5817914 h 5956080"/>
              <a:gd name="connsiteX7" fmla="*/ 681487 w 3843750"/>
              <a:gd name="connsiteY7" fmla="*/ 5914873 h 5956080"/>
              <a:gd name="connsiteX8" fmla="*/ 892373 w 3843750"/>
              <a:gd name="connsiteY8" fmla="*/ 5605295 h 5956080"/>
              <a:gd name="connsiteX9" fmla="*/ 1027770 w 3843750"/>
              <a:gd name="connsiteY9" fmla="*/ 5804063 h 5956080"/>
              <a:gd name="connsiteX10" fmla="*/ 1200566 w 3843750"/>
              <a:gd name="connsiteY10" fmla="*/ 5527036 h 5956080"/>
              <a:gd name="connsiteX11" fmla="*/ 1348083 w 3843750"/>
              <a:gd name="connsiteY11" fmla="*/ 5363590 h 5956080"/>
              <a:gd name="connsiteX12" fmla="*/ 1425997 w 3843750"/>
              <a:gd name="connsiteY12" fmla="*/ 4800532 h 5956080"/>
              <a:gd name="connsiteX13" fmla="*/ 1517416 w 3843750"/>
              <a:gd name="connsiteY13" fmla="*/ 4640549 h 5956080"/>
              <a:gd name="connsiteX14" fmla="*/ 1569705 w 3843750"/>
              <a:gd name="connsiteY14" fmla="*/ 4803995 h 5956080"/>
              <a:gd name="connsiteX15" fmla="*/ 1530921 w 3843750"/>
              <a:gd name="connsiteY15" fmla="*/ 5433885 h 5956080"/>
              <a:gd name="connsiteX16" fmla="*/ 1614721 w 3843750"/>
              <a:gd name="connsiteY16" fmla="*/ 5319957 h 5956080"/>
              <a:gd name="connsiteX17" fmla="*/ 1800676 w 3843750"/>
              <a:gd name="connsiteY17" fmla="*/ 4608691 h 5956080"/>
              <a:gd name="connsiteX18" fmla="*/ 1918759 w 3843750"/>
              <a:gd name="connsiteY18" fmla="*/ 4486799 h 5956080"/>
              <a:gd name="connsiteX19" fmla="*/ 2009139 w 3843750"/>
              <a:gd name="connsiteY19" fmla="*/ 4715000 h 5956080"/>
              <a:gd name="connsiteX20" fmla="*/ 2135532 w 3843750"/>
              <a:gd name="connsiteY20" fmla="*/ 5321689 h 5956080"/>
              <a:gd name="connsiteX21" fmla="*/ 2209291 w 3843750"/>
              <a:gd name="connsiteY21" fmla="*/ 5028733 h 5956080"/>
              <a:gd name="connsiteX22" fmla="*/ 2501208 w 3843750"/>
              <a:gd name="connsiteY22" fmla="*/ 4457711 h 5956080"/>
              <a:gd name="connsiteX23" fmla="*/ 2695127 w 3843750"/>
              <a:gd name="connsiteY23" fmla="*/ 4973674 h 5956080"/>
              <a:gd name="connsiteX24" fmla="*/ 2825329 w 3843750"/>
              <a:gd name="connsiteY24" fmla="*/ 4563328 h 5956080"/>
              <a:gd name="connsiteX25" fmla="*/ 2904628 w 3843750"/>
              <a:gd name="connsiteY25" fmla="*/ 4466368 h 5956080"/>
              <a:gd name="connsiteX26" fmla="*/ 2922635 w 3843750"/>
              <a:gd name="connsiteY26" fmla="*/ 4519696 h 5956080"/>
              <a:gd name="connsiteX27" fmla="*/ 3089544 w 3843750"/>
              <a:gd name="connsiteY27" fmla="*/ 3606545 h 5956080"/>
              <a:gd name="connsiteX28" fmla="*/ 3150490 w 3843750"/>
              <a:gd name="connsiteY28" fmla="*/ 3989882 h 5956080"/>
              <a:gd name="connsiteX29" fmla="*/ 3755448 w 3843750"/>
              <a:gd name="connsiteY29" fmla="*/ 1538193 h 5956080"/>
              <a:gd name="connsiteX30" fmla="*/ 3850330 w 3843750"/>
              <a:gd name="connsiteY30" fmla="*/ 0 h 5956080"/>
              <a:gd name="connsiteX31" fmla="*/ 0 w 3843750"/>
              <a:gd name="connsiteY31" fmla="*/ 0 h 5956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Lst>
            <a:rect l="l" t="t" r="r" b="b"/>
            <a:pathLst>
              <a:path w="3843750" h="5956080">
                <a:moveTo>
                  <a:pt x="0" y="346"/>
                </a:moveTo>
                <a:cubicBezTo>
                  <a:pt x="12120" y="1234155"/>
                  <a:pt x="72720" y="2447534"/>
                  <a:pt x="72373" y="2447534"/>
                </a:cubicBezTo>
                <a:cubicBezTo>
                  <a:pt x="72720" y="2449265"/>
                  <a:pt x="114274" y="3641520"/>
                  <a:pt x="145093" y="3878724"/>
                </a:cubicBezTo>
                <a:cubicBezTo>
                  <a:pt x="176258" y="4119392"/>
                  <a:pt x="210194" y="3969797"/>
                  <a:pt x="237897" y="4208041"/>
                </a:cubicBezTo>
                <a:cubicBezTo>
                  <a:pt x="250017" y="4367677"/>
                  <a:pt x="237204" y="4527661"/>
                  <a:pt x="281875" y="4677601"/>
                </a:cubicBezTo>
                <a:cubicBezTo>
                  <a:pt x="278758" y="4908226"/>
                  <a:pt x="338319" y="5059552"/>
                  <a:pt x="360135" y="5287407"/>
                </a:cubicBezTo>
                <a:cubicBezTo>
                  <a:pt x="370177" y="5468860"/>
                  <a:pt x="348015" y="5649274"/>
                  <a:pt x="414155" y="5817914"/>
                </a:cubicBezTo>
                <a:cubicBezTo>
                  <a:pt x="467137" y="5947770"/>
                  <a:pt x="534662" y="6049578"/>
                  <a:pt x="681487" y="5914873"/>
                </a:cubicBezTo>
                <a:cubicBezTo>
                  <a:pt x="680448" y="5747964"/>
                  <a:pt x="925963" y="5772897"/>
                  <a:pt x="892373" y="5605295"/>
                </a:cubicBezTo>
                <a:cubicBezTo>
                  <a:pt x="1003184" y="5641309"/>
                  <a:pt x="945009" y="5759046"/>
                  <a:pt x="1027770" y="5804063"/>
                </a:cubicBezTo>
                <a:cubicBezTo>
                  <a:pt x="1099105" y="5719915"/>
                  <a:pt x="1051664" y="5551968"/>
                  <a:pt x="1200566" y="5527036"/>
                </a:cubicBezTo>
                <a:cubicBezTo>
                  <a:pt x="1352931" y="5564088"/>
                  <a:pt x="1336655" y="5453970"/>
                  <a:pt x="1348083" y="5363590"/>
                </a:cubicBezTo>
                <a:cubicBezTo>
                  <a:pt x="1370938" y="5149586"/>
                  <a:pt x="1389291" y="5009687"/>
                  <a:pt x="1425997" y="4800532"/>
                </a:cubicBezTo>
                <a:cubicBezTo>
                  <a:pt x="1436385" y="4748243"/>
                  <a:pt x="1415608" y="4628775"/>
                  <a:pt x="1517416" y="4640549"/>
                </a:cubicBezTo>
                <a:cubicBezTo>
                  <a:pt x="1596022" y="4651976"/>
                  <a:pt x="1566242" y="4746512"/>
                  <a:pt x="1569705" y="4803995"/>
                </a:cubicBezTo>
                <a:cubicBezTo>
                  <a:pt x="1600177" y="5128809"/>
                  <a:pt x="1532998" y="5109763"/>
                  <a:pt x="1530921" y="5433885"/>
                </a:cubicBezTo>
                <a:cubicBezTo>
                  <a:pt x="1530574" y="5446697"/>
                  <a:pt x="1580786" y="5458125"/>
                  <a:pt x="1614721" y="5319957"/>
                </a:cubicBezTo>
                <a:cubicBezTo>
                  <a:pt x="1681208" y="5047432"/>
                  <a:pt x="1760507" y="4832736"/>
                  <a:pt x="1800676" y="4608691"/>
                </a:cubicBezTo>
                <a:cubicBezTo>
                  <a:pt x="1848463" y="4656824"/>
                  <a:pt x="1889671" y="4439704"/>
                  <a:pt x="1918759" y="4486799"/>
                </a:cubicBezTo>
                <a:cubicBezTo>
                  <a:pt x="1932264" y="4566098"/>
                  <a:pt x="1956503" y="4642626"/>
                  <a:pt x="2009139" y="4715000"/>
                </a:cubicBezTo>
                <a:cubicBezTo>
                  <a:pt x="2054502" y="4933851"/>
                  <a:pt x="2004983" y="5137812"/>
                  <a:pt x="2135532" y="5321689"/>
                </a:cubicBezTo>
                <a:cubicBezTo>
                  <a:pt x="2135532" y="5321689"/>
                  <a:pt x="2137610" y="5265245"/>
                  <a:pt x="2209291" y="5028733"/>
                </a:cubicBezTo>
                <a:cubicBezTo>
                  <a:pt x="2267120" y="4838277"/>
                  <a:pt x="2341225" y="4936622"/>
                  <a:pt x="2501208" y="4457711"/>
                </a:cubicBezTo>
                <a:cubicBezTo>
                  <a:pt x="2545186" y="4641934"/>
                  <a:pt x="2446495" y="4877753"/>
                  <a:pt x="2695127" y="4973674"/>
                </a:cubicBezTo>
                <a:cubicBezTo>
                  <a:pt x="2743260" y="4833775"/>
                  <a:pt x="2706208" y="4662365"/>
                  <a:pt x="2825329" y="4563328"/>
                </a:cubicBezTo>
                <a:cubicBezTo>
                  <a:pt x="2859958" y="4534586"/>
                  <a:pt x="2884890" y="4501689"/>
                  <a:pt x="2904628" y="4466368"/>
                </a:cubicBezTo>
                <a:cubicBezTo>
                  <a:pt x="2910515" y="4484375"/>
                  <a:pt x="2916749" y="4503074"/>
                  <a:pt x="2922635" y="4519696"/>
                </a:cubicBezTo>
                <a:cubicBezTo>
                  <a:pt x="2946529" y="4491647"/>
                  <a:pt x="3082618" y="3784882"/>
                  <a:pt x="3089544" y="3606545"/>
                </a:cubicBezTo>
                <a:cubicBezTo>
                  <a:pt x="3124172" y="3733285"/>
                  <a:pt x="3150490" y="3989882"/>
                  <a:pt x="3150490" y="3989882"/>
                </a:cubicBezTo>
                <a:cubicBezTo>
                  <a:pt x="3150490" y="3989882"/>
                  <a:pt x="3300085" y="3936900"/>
                  <a:pt x="3755448" y="1538193"/>
                </a:cubicBezTo>
                <a:cubicBezTo>
                  <a:pt x="3791461" y="1348775"/>
                  <a:pt x="3824704" y="697762"/>
                  <a:pt x="3850330" y="0"/>
                </a:cubicBezTo>
                <a:lnTo>
                  <a:pt x="0" y="0"/>
                </a:lnTo>
                <a:close/>
              </a:path>
            </a:pathLst>
          </a:custGeom>
          <a:solidFill>
            <a:schemeClr val="accent1">
              <a:alpha val="20000"/>
            </a:schemeClr>
          </a:solidFill>
          <a:ln w="32707" cap="flat">
            <a:noFill/>
            <a:prstDash val="solid"/>
            <a:miter/>
          </a:ln>
        </p:spPr>
        <p:txBody>
          <a:bodyPr rtlCol="0" anchor="ctr"/>
          <a:lstStyle/>
          <a:p>
            <a:endParaRPr lang="en-US">
              <a:solidFill>
                <a:prstClr val="black"/>
              </a:solidFill>
            </a:endParaRPr>
          </a:p>
        </p:txBody>
      </p:sp>
      <p:sp>
        <p:nvSpPr>
          <p:cNvPr id="2" name="Title 1">
            <a:extLst>
              <a:ext uri="{FF2B5EF4-FFF2-40B4-BE49-F238E27FC236}">
                <a16:creationId xmlns:a16="http://schemas.microsoft.com/office/drawing/2014/main" id="{64AD5705-B027-4C44-B38A-60296E29EB12}"/>
              </a:ext>
            </a:extLst>
          </p:cNvPr>
          <p:cNvSpPr>
            <a:spLocks noGrp="1"/>
          </p:cNvSpPr>
          <p:nvPr>
            <p:ph type="title"/>
          </p:nvPr>
        </p:nvSpPr>
        <p:spPr>
          <a:xfrm>
            <a:off x="831850" y="1078991"/>
            <a:ext cx="5266944" cy="3136392"/>
          </a:xfrm>
        </p:spPr>
        <p:txBody>
          <a:bodyPr anchor="b">
            <a:normAutofit/>
          </a:bodyPr>
          <a:lstStyle>
            <a:lvl1pPr>
              <a:defRPr sz="4800"/>
            </a:lvl1p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BE8BBAC4-9088-44CF-BA2D-B8DD24FB5274}"/>
              </a:ext>
            </a:extLst>
          </p:cNvPr>
          <p:cNvSpPr>
            <a:spLocks noGrp="1"/>
          </p:cNvSpPr>
          <p:nvPr>
            <p:ph type="body" idx="1"/>
          </p:nvPr>
        </p:nvSpPr>
        <p:spPr>
          <a:xfrm>
            <a:off x="831850" y="4279392"/>
            <a:ext cx="5266944" cy="1500187"/>
          </a:xfrm>
        </p:spPr>
        <p:txBody>
          <a:bodyPr/>
          <a:lstStyle>
            <a:lvl1pPr marL="0" indent="0">
              <a:buNone/>
              <a:defRPr sz="2400" cap="all" baseline="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793FB3F-D2A6-4919-B57B-C08861D46303}"/>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989049E0-6BE5-43FA-A4D4-ACAFC871A79F}"/>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ADF8C28D-1479-4F15-B906-0AEBBCCA8CFA}"/>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137835642"/>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Freeform: Shape 7" descr="Tag=AccentColor&#10;Flavor=Light&#10;Target=Fill">
            <a:extLst>
              <a:ext uri="{FF2B5EF4-FFF2-40B4-BE49-F238E27FC236}">
                <a16:creationId xmlns:a16="http://schemas.microsoft.com/office/drawing/2014/main" id="{FD51F360-8860-4FB5-A0A5-773473DD8B39}"/>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a:solidFill>
                <a:prstClr val="black"/>
              </a:solidFill>
            </a:endParaRPr>
          </a:p>
        </p:txBody>
      </p:sp>
      <p:sp>
        <p:nvSpPr>
          <p:cNvPr id="2" name="Title 1">
            <a:extLst>
              <a:ext uri="{FF2B5EF4-FFF2-40B4-BE49-F238E27FC236}">
                <a16:creationId xmlns:a16="http://schemas.microsoft.com/office/drawing/2014/main" id="{D2A77EC9-372A-4ECA-9088-780532AF057F}"/>
              </a:ext>
            </a:extLst>
          </p:cNvPr>
          <p:cNvSpPr>
            <a:spLocks noGrp="1"/>
          </p:cNvSpPr>
          <p:nvPr>
            <p:ph type="title"/>
          </p:nvPr>
        </p:nvSpPr>
        <p:spPr/>
        <p:txBody>
          <a:bodyPr>
            <a:normAutofit/>
          </a:bodyPr>
          <a:lstStyle>
            <a:lvl1pPr>
              <a:defRPr sz="40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57C882CE-1B27-414A-9B06-AA5D2DB683BA}"/>
              </a:ext>
            </a:extLst>
          </p:cNvPr>
          <p:cNvSpPr>
            <a:spLocks noGrp="1"/>
          </p:cNvSpPr>
          <p:nvPr>
            <p:ph sz="half" idx="1"/>
          </p:nvPr>
        </p:nvSpPr>
        <p:spPr>
          <a:xfrm>
            <a:off x="838200" y="2011680"/>
            <a:ext cx="493776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a:extLst>
              <a:ext uri="{FF2B5EF4-FFF2-40B4-BE49-F238E27FC236}">
                <a16:creationId xmlns:a16="http://schemas.microsoft.com/office/drawing/2014/main" id="{A0397E60-5D92-4530-96D1-FC09AF3C2742}"/>
              </a:ext>
            </a:extLst>
          </p:cNvPr>
          <p:cNvSpPr>
            <a:spLocks noGrp="1"/>
          </p:cNvSpPr>
          <p:nvPr>
            <p:ph sz="half" idx="2"/>
          </p:nvPr>
        </p:nvSpPr>
        <p:spPr>
          <a:xfrm>
            <a:off x="6419088" y="2011680"/>
            <a:ext cx="493776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a:extLst>
              <a:ext uri="{FF2B5EF4-FFF2-40B4-BE49-F238E27FC236}">
                <a16:creationId xmlns:a16="http://schemas.microsoft.com/office/drawing/2014/main" id="{034240FE-0C6A-47E9-9B0A-7B3C60877372}"/>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8671AE1B-BB18-4C7E-AA77-3A4D401A5F35}"/>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76FA7B1D-FEDD-4E29-A352-29E5F498B323}"/>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59689634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Freeform: Shape 9" descr="Tag=AccentColor&#10;Flavor=Light&#10;Target=Fill">
            <a:extLst>
              <a:ext uri="{FF2B5EF4-FFF2-40B4-BE49-F238E27FC236}">
                <a16:creationId xmlns:a16="http://schemas.microsoft.com/office/drawing/2014/main" id="{527D753D-3426-457C-9082-B92894509EC0}"/>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a:solidFill>
                <a:prstClr val="black"/>
              </a:solidFill>
            </a:endParaRPr>
          </a:p>
        </p:txBody>
      </p:sp>
      <p:sp>
        <p:nvSpPr>
          <p:cNvPr id="2" name="Title 1">
            <a:extLst>
              <a:ext uri="{FF2B5EF4-FFF2-40B4-BE49-F238E27FC236}">
                <a16:creationId xmlns:a16="http://schemas.microsoft.com/office/drawing/2014/main" id="{164D2B94-0682-4185-BCE3-89AF214A4FA8}"/>
              </a:ext>
            </a:extLst>
          </p:cNvPr>
          <p:cNvSpPr>
            <a:spLocks noGrp="1"/>
          </p:cNvSpPr>
          <p:nvPr>
            <p:ph type="title"/>
          </p:nvPr>
        </p:nvSpPr>
        <p:spPr>
          <a:xfrm>
            <a:off x="839788" y="365125"/>
            <a:ext cx="10515600" cy="1325563"/>
          </a:xfrm>
        </p:spPr>
        <p:txBody>
          <a:bodyPr>
            <a:normAutofit/>
          </a:bodyPr>
          <a:lstStyle>
            <a:lvl1pPr>
              <a:defRPr sz="4000"/>
            </a:lvl1p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8D65C47E-B85E-4B3E-A669-DEEC7F5DF2FB}"/>
              </a:ext>
            </a:extLst>
          </p:cNvPr>
          <p:cNvSpPr>
            <a:spLocks noGrp="1"/>
          </p:cNvSpPr>
          <p:nvPr>
            <p:ph type="body" idx="1"/>
          </p:nvPr>
        </p:nvSpPr>
        <p:spPr>
          <a:xfrm>
            <a:off x="839788" y="2011680"/>
            <a:ext cx="4937760" cy="950976"/>
          </a:xfrm>
        </p:spPr>
        <p:txBody>
          <a:bodyPr anchor="b">
            <a:normAutofit/>
          </a:bodyPr>
          <a:lstStyle>
            <a:lvl1pPr marL="0" indent="0">
              <a:buNone/>
              <a:defRPr sz="28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324517F-FE8C-49AD-9A52-0F4301052699}"/>
              </a:ext>
            </a:extLst>
          </p:cNvPr>
          <p:cNvSpPr>
            <a:spLocks noGrp="1"/>
          </p:cNvSpPr>
          <p:nvPr>
            <p:ph sz="half" idx="2"/>
          </p:nvPr>
        </p:nvSpPr>
        <p:spPr>
          <a:xfrm>
            <a:off x="839788" y="3127248"/>
            <a:ext cx="4937760" cy="30632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a:extLst>
              <a:ext uri="{FF2B5EF4-FFF2-40B4-BE49-F238E27FC236}">
                <a16:creationId xmlns:a16="http://schemas.microsoft.com/office/drawing/2014/main" id="{C80C73EC-7117-4DC2-9075-14102F2E282B}"/>
              </a:ext>
            </a:extLst>
          </p:cNvPr>
          <p:cNvSpPr>
            <a:spLocks noGrp="1"/>
          </p:cNvSpPr>
          <p:nvPr>
            <p:ph type="body" sz="quarter" idx="3"/>
          </p:nvPr>
        </p:nvSpPr>
        <p:spPr>
          <a:xfrm>
            <a:off x="6419088" y="2011680"/>
            <a:ext cx="4937760" cy="950976"/>
          </a:xfrm>
        </p:spPr>
        <p:txBody>
          <a:bodyPr anchor="b">
            <a:normAutofit/>
          </a:bodyPr>
          <a:lstStyle>
            <a:lvl1pPr marL="0" indent="0">
              <a:buNone/>
              <a:defRPr sz="28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DD9A323-865B-4177-8F98-9BA304E022E0}"/>
              </a:ext>
            </a:extLst>
          </p:cNvPr>
          <p:cNvSpPr>
            <a:spLocks noGrp="1"/>
          </p:cNvSpPr>
          <p:nvPr>
            <p:ph sz="quarter" idx="4"/>
          </p:nvPr>
        </p:nvSpPr>
        <p:spPr>
          <a:xfrm>
            <a:off x="6419088" y="3127248"/>
            <a:ext cx="4937760" cy="30632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a:extLst>
              <a:ext uri="{FF2B5EF4-FFF2-40B4-BE49-F238E27FC236}">
                <a16:creationId xmlns:a16="http://schemas.microsoft.com/office/drawing/2014/main" id="{2AA4E5D6-7075-4584-BD43-D966F0B58E6D}"/>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8" name="Footer Placeholder 7">
            <a:extLst>
              <a:ext uri="{FF2B5EF4-FFF2-40B4-BE49-F238E27FC236}">
                <a16:creationId xmlns:a16="http://schemas.microsoft.com/office/drawing/2014/main" id="{8C38B83D-8A05-4F3C-A409-1602C9630750}"/>
              </a:ext>
            </a:extLst>
          </p:cNvPr>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a:extLst>
              <a:ext uri="{FF2B5EF4-FFF2-40B4-BE49-F238E27FC236}">
                <a16:creationId xmlns:a16="http://schemas.microsoft.com/office/drawing/2014/main" id="{BAD250E7-8A73-449C-A140-A2A2582D7F33}"/>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6198831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7" name="Graphic 9" descr="Tag=AccentColor&#10;Flavor=Light&#10;Target=Fill">
            <a:extLst>
              <a:ext uri="{FF2B5EF4-FFF2-40B4-BE49-F238E27FC236}">
                <a16:creationId xmlns:a16="http://schemas.microsoft.com/office/drawing/2014/main" id="{DB2CE8D6-5B4E-4EBE-9ED5-A1DA7E2A5CDA}"/>
              </a:ext>
            </a:extLst>
          </p:cNvPr>
          <p:cNvSpPr/>
          <p:nvPr/>
        </p:nvSpPr>
        <p:spPr>
          <a:xfrm>
            <a:off x="7209816" y="0"/>
            <a:ext cx="4143984" cy="5747660"/>
          </a:xfrm>
          <a:custGeom>
            <a:avLst/>
            <a:gdLst>
              <a:gd name="connsiteX0" fmla="*/ 0 w 3843750"/>
              <a:gd name="connsiteY0" fmla="*/ 346 h 5956080"/>
              <a:gd name="connsiteX1" fmla="*/ 72373 w 3843750"/>
              <a:gd name="connsiteY1" fmla="*/ 2447534 h 5956080"/>
              <a:gd name="connsiteX2" fmla="*/ 145093 w 3843750"/>
              <a:gd name="connsiteY2" fmla="*/ 3878724 h 5956080"/>
              <a:gd name="connsiteX3" fmla="*/ 237897 w 3843750"/>
              <a:gd name="connsiteY3" fmla="*/ 4208041 h 5956080"/>
              <a:gd name="connsiteX4" fmla="*/ 281875 w 3843750"/>
              <a:gd name="connsiteY4" fmla="*/ 4677601 h 5956080"/>
              <a:gd name="connsiteX5" fmla="*/ 360135 w 3843750"/>
              <a:gd name="connsiteY5" fmla="*/ 5287407 h 5956080"/>
              <a:gd name="connsiteX6" fmla="*/ 414155 w 3843750"/>
              <a:gd name="connsiteY6" fmla="*/ 5817914 h 5956080"/>
              <a:gd name="connsiteX7" fmla="*/ 681487 w 3843750"/>
              <a:gd name="connsiteY7" fmla="*/ 5914873 h 5956080"/>
              <a:gd name="connsiteX8" fmla="*/ 892373 w 3843750"/>
              <a:gd name="connsiteY8" fmla="*/ 5605295 h 5956080"/>
              <a:gd name="connsiteX9" fmla="*/ 1027770 w 3843750"/>
              <a:gd name="connsiteY9" fmla="*/ 5804063 h 5956080"/>
              <a:gd name="connsiteX10" fmla="*/ 1200566 w 3843750"/>
              <a:gd name="connsiteY10" fmla="*/ 5527036 h 5956080"/>
              <a:gd name="connsiteX11" fmla="*/ 1348083 w 3843750"/>
              <a:gd name="connsiteY11" fmla="*/ 5363590 h 5956080"/>
              <a:gd name="connsiteX12" fmla="*/ 1425997 w 3843750"/>
              <a:gd name="connsiteY12" fmla="*/ 4800532 h 5956080"/>
              <a:gd name="connsiteX13" fmla="*/ 1517416 w 3843750"/>
              <a:gd name="connsiteY13" fmla="*/ 4640549 h 5956080"/>
              <a:gd name="connsiteX14" fmla="*/ 1569705 w 3843750"/>
              <a:gd name="connsiteY14" fmla="*/ 4803995 h 5956080"/>
              <a:gd name="connsiteX15" fmla="*/ 1530921 w 3843750"/>
              <a:gd name="connsiteY15" fmla="*/ 5433885 h 5956080"/>
              <a:gd name="connsiteX16" fmla="*/ 1614721 w 3843750"/>
              <a:gd name="connsiteY16" fmla="*/ 5319957 h 5956080"/>
              <a:gd name="connsiteX17" fmla="*/ 1800676 w 3843750"/>
              <a:gd name="connsiteY17" fmla="*/ 4608691 h 5956080"/>
              <a:gd name="connsiteX18" fmla="*/ 1918759 w 3843750"/>
              <a:gd name="connsiteY18" fmla="*/ 4486799 h 5956080"/>
              <a:gd name="connsiteX19" fmla="*/ 2009139 w 3843750"/>
              <a:gd name="connsiteY19" fmla="*/ 4715000 h 5956080"/>
              <a:gd name="connsiteX20" fmla="*/ 2135532 w 3843750"/>
              <a:gd name="connsiteY20" fmla="*/ 5321689 h 5956080"/>
              <a:gd name="connsiteX21" fmla="*/ 2209291 w 3843750"/>
              <a:gd name="connsiteY21" fmla="*/ 5028733 h 5956080"/>
              <a:gd name="connsiteX22" fmla="*/ 2501208 w 3843750"/>
              <a:gd name="connsiteY22" fmla="*/ 4457711 h 5956080"/>
              <a:gd name="connsiteX23" fmla="*/ 2695127 w 3843750"/>
              <a:gd name="connsiteY23" fmla="*/ 4973674 h 5956080"/>
              <a:gd name="connsiteX24" fmla="*/ 2825329 w 3843750"/>
              <a:gd name="connsiteY24" fmla="*/ 4563328 h 5956080"/>
              <a:gd name="connsiteX25" fmla="*/ 2904628 w 3843750"/>
              <a:gd name="connsiteY25" fmla="*/ 4466368 h 5956080"/>
              <a:gd name="connsiteX26" fmla="*/ 2922635 w 3843750"/>
              <a:gd name="connsiteY26" fmla="*/ 4519696 h 5956080"/>
              <a:gd name="connsiteX27" fmla="*/ 3089544 w 3843750"/>
              <a:gd name="connsiteY27" fmla="*/ 3606545 h 5956080"/>
              <a:gd name="connsiteX28" fmla="*/ 3150490 w 3843750"/>
              <a:gd name="connsiteY28" fmla="*/ 3989882 h 5956080"/>
              <a:gd name="connsiteX29" fmla="*/ 3755448 w 3843750"/>
              <a:gd name="connsiteY29" fmla="*/ 1538193 h 5956080"/>
              <a:gd name="connsiteX30" fmla="*/ 3850330 w 3843750"/>
              <a:gd name="connsiteY30" fmla="*/ 0 h 5956080"/>
              <a:gd name="connsiteX31" fmla="*/ 0 w 3843750"/>
              <a:gd name="connsiteY31" fmla="*/ 0 h 59560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Lst>
            <a:rect l="l" t="t" r="r" b="b"/>
            <a:pathLst>
              <a:path w="3843750" h="5956080">
                <a:moveTo>
                  <a:pt x="0" y="346"/>
                </a:moveTo>
                <a:cubicBezTo>
                  <a:pt x="12120" y="1234155"/>
                  <a:pt x="72720" y="2447534"/>
                  <a:pt x="72373" y="2447534"/>
                </a:cubicBezTo>
                <a:cubicBezTo>
                  <a:pt x="72720" y="2449265"/>
                  <a:pt x="114274" y="3641520"/>
                  <a:pt x="145093" y="3878724"/>
                </a:cubicBezTo>
                <a:cubicBezTo>
                  <a:pt x="176258" y="4119392"/>
                  <a:pt x="210194" y="3969797"/>
                  <a:pt x="237897" y="4208041"/>
                </a:cubicBezTo>
                <a:cubicBezTo>
                  <a:pt x="250017" y="4367677"/>
                  <a:pt x="237204" y="4527661"/>
                  <a:pt x="281875" y="4677601"/>
                </a:cubicBezTo>
                <a:cubicBezTo>
                  <a:pt x="278758" y="4908226"/>
                  <a:pt x="338319" y="5059552"/>
                  <a:pt x="360135" y="5287407"/>
                </a:cubicBezTo>
                <a:cubicBezTo>
                  <a:pt x="370177" y="5468860"/>
                  <a:pt x="348015" y="5649274"/>
                  <a:pt x="414155" y="5817914"/>
                </a:cubicBezTo>
                <a:cubicBezTo>
                  <a:pt x="467137" y="5947770"/>
                  <a:pt x="534662" y="6049578"/>
                  <a:pt x="681487" y="5914873"/>
                </a:cubicBezTo>
                <a:cubicBezTo>
                  <a:pt x="680448" y="5747964"/>
                  <a:pt x="925963" y="5772897"/>
                  <a:pt x="892373" y="5605295"/>
                </a:cubicBezTo>
                <a:cubicBezTo>
                  <a:pt x="1003184" y="5641309"/>
                  <a:pt x="945009" y="5759046"/>
                  <a:pt x="1027770" y="5804063"/>
                </a:cubicBezTo>
                <a:cubicBezTo>
                  <a:pt x="1099105" y="5719915"/>
                  <a:pt x="1051664" y="5551968"/>
                  <a:pt x="1200566" y="5527036"/>
                </a:cubicBezTo>
                <a:cubicBezTo>
                  <a:pt x="1352931" y="5564088"/>
                  <a:pt x="1336655" y="5453970"/>
                  <a:pt x="1348083" y="5363590"/>
                </a:cubicBezTo>
                <a:cubicBezTo>
                  <a:pt x="1370938" y="5149586"/>
                  <a:pt x="1389291" y="5009687"/>
                  <a:pt x="1425997" y="4800532"/>
                </a:cubicBezTo>
                <a:cubicBezTo>
                  <a:pt x="1436385" y="4748243"/>
                  <a:pt x="1415608" y="4628775"/>
                  <a:pt x="1517416" y="4640549"/>
                </a:cubicBezTo>
                <a:cubicBezTo>
                  <a:pt x="1596022" y="4651976"/>
                  <a:pt x="1566242" y="4746512"/>
                  <a:pt x="1569705" y="4803995"/>
                </a:cubicBezTo>
                <a:cubicBezTo>
                  <a:pt x="1600177" y="5128809"/>
                  <a:pt x="1532998" y="5109763"/>
                  <a:pt x="1530921" y="5433885"/>
                </a:cubicBezTo>
                <a:cubicBezTo>
                  <a:pt x="1530574" y="5446697"/>
                  <a:pt x="1580786" y="5458125"/>
                  <a:pt x="1614721" y="5319957"/>
                </a:cubicBezTo>
                <a:cubicBezTo>
                  <a:pt x="1681208" y="5047432"/>
                  <a:pt x="1760507" y="4832736"/>
                  <a:pt x="1800676" y="4608691"/>
                </a:cubicBezTo>
                <a:cubicBezTo>
                  <a:pt x="1848463" y="4656824"/>
                  <a:pt x="1889671" y="4439704"/>
                  <a:pt x="1918759" y="4486799"/>
                </a:cubicBezTo>
                <a:cubicBezTo>
                  <a:pt x="1932264" y="4566098"/>
                  <a:pt x="1956503" y="4642626"/>
                  <a:pt x="2009139" y="4715000"/>
                </a:cubicBezTo>
                <a:cubicBezTo>
                  <a:pt x="2054502" y="4933851"/>
                  <a:pt x="2004983" y="5137812"/>
                  <a:pt x="2135532" y="5321689"/>
                </a:cubicBezTo>
                <a:cubicBezTo>
                  <a:pt x="2135532" y="5321689"/>
                  <a:pt x="2137610" y="5265245"/>
                  <a:pt x="2209291" y="5028733"/>
                </a:cubicBezTo>
                <a:cubicBezTo>
                  <a:pt x="2267120" y="4838277"/>
                  <a:pt x="2341225" y="4936622"/>
                  <a:pt x="2501208" y="4457711"/>
                </a:cubicBezTo>
                <a:cubicBezTo>
                  <a:pt x="2545186" y="4641934"/>
                  <a:pt x="2446495" y="4877753"/>
                  <a:pt x="2695127" y="4973674"/>
                </a:cubicBezTo>
                <a:cubicBezTo>
                  <a:pt x="2743260" y="4833775"/>
                  <a:pt x="2706208" y="4662365"/>
                  <a:pt x="2825329" y="4563328"/>
                </a:cubicBezTo>
                <a:cubicBezTo>
                  <a:pt x="2859958" y="4534586"/>
                  <a:pt x="2884890" y="4501689"/>
                  <a:pt x="2904628" y="4466368"/>
                </a:cubicBezTo>
                <a:cubicBezTo>
                  <a:pt x="2910515" y="4484375"/>
                  <a:pt x="2916749" y="4503074"/>
                  <a:pt x="2922635" y="4519696"/>
                </a:cubicBezTo>
                <a:cubicBezTo>
                  <a:pt x="2946529" y="4491647"/>
                  <a:pt x="3082618" y="3784882"/>
                  <a:pt x="3089544" y="3606545"/>
                </a:cubicBezTo>
                <a:cubicBezTo>
                  <a:pt x="3124172" y="3733285"/>
                  <a:pt x="3150490" y="3989882"/>
                  <a:pt x="3150490" y="3989882"/>
                </a:cubicBezTo>
                <a:cubicBezTo>
                  <a:pt x="3150490" y="3989882"/>
                  <a:pt x="3300085" y="3936900"/>
                  <a:pt x="3755448" y="1538193"/>
                </a:cubicBezTo>
                <a:cubicBezTo>
                  <a:pt x="3791461" y="1348775"/>
                  <a:pt x="3824704" y="697762"/>
                  <a:pt x="3850330" y="0"/>
                </a:cubicBezTo>
                <a:lnTo>
                  <a:pt x="0" y="0"/>
                </a:lnTo>
                <a:close/>
              </a:path>
            </a:pathLst>
          </a:custGeom>
          <a:solidFill>
            <a:schemeClr val="accent1">
              <a:alpha val="20000"/>
            </a:schemeClr>
          </a:solidFill>
          <a:ln w="32707" cap="flat">
            <a:noFill/>
            <a:prstDash val="solid"/>
            <a:miter/>
          </a:ln>
        </p:spPr>
        <p:txBody>
          <a:bodyPr rtlCol="0" anchor="ctr"/>
          <a:lstStyle/>
          <a:p>
            <a:endParaRPr lang="en-US"/>
          </a:p>
        </p:txBody>
      </p:sp>
      <p:sp>
        <p:nvSpPr>
          <p:cNvPr id="2" name="Title 1">
            <a:extLst>
              <a:ext uri="{FF2B5EF4-FFF2-40B4-BE49-F238E27FC236}">
                <a16:creationId xmlns:a16="http://schemas.microsoft.com/office/drawing/2014/main" id="{64AD5705-B027-4C44-B38A-60296E29EB12}"/>
              </a:ext>
            </a:extLst>
          </p:cNvPr>
          <p:cNvSpPr>
            <a:spLocks noGrp="1"/>
          </p:cNvSpPr>
          <p:nvPr>
            <p:ph type="title"/>
          </p:nvPr>
        </p:nvSpPr>
        <p:spPr>
          <a:xfrm>
            <a:off x="831850" y="1078991"/>
            <a:ext cx="5266944" cy="3136392"/>
          </a:xfrm>
        </p:spPr>
        <p:txBody>
          <a:bodyPr anchor="b">
            <a:normAutofit/>
          </a:bodyPr>
          <a:lstStyle>
            <a:lvl1pPr>
              <a:defRPr sz="4800"/>
            </a:lvl1p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BE8BBAC4-9088-44CF-BA2D-B8DD24FB5274}"/>
              </a:ext>
            </a:extLst>
          </p:cNvPr>
          <p:cNvSpPr>
            <a:spLocks noGrp="1"/>
          </p:cNvSpPr>
          <p:nvPr>
            <p:ph type="body" idx="1"/>
          </p:nvPr>
        </p:nvSpPr>
        <p:spPr>
          <a:xfrm>
            <a:off x="831850" y="4279392"/>
            <a:ext cx="5266944" cy="1500187"/>
          </a:xfrm>
        </p:spPr>
        <p:txBody>
          <a:bodyPr/>
          <a:lstStyle>
            <a:lvl1pPr marL="0" indent="0">
              <a:buNone/>
              <a:defRPr sz="2400" cap="all" baseline="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793FB3F-D2A6-4919-B57B-C08861D46303}"/>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5" name="Footer Placeholder 4">
            <a:extLst>
              <a:ext uri="{FF2B5EF4-FFF2-40B4-BE49-F238E27FC236}">
                <a16:creationId xmlns:a16="http://schemas.microsoft.com/office/drawing/2014/main" id="{989049E0-6BE5-43FA-A4D4-ACAFC871A79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F8C28D-1479-4F15-B906-0AEBBCCA8CFA}"/>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2746617095"/>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Graphic 1" descr="Tag=AccentColor&#10;Flavor=Light&#10;Target=Fill">
            <a:extLst>
              <a:ext uri="{FF2B5EF4-FFF2-40B4-BE49-F238E27FC236}">
                <a16:creationId xmlns:a16="http://schemas.microsoft.com/office/drawing/2014/main" id="{AAFBE1F6-FC6D-4C3D-9AC3-97028E6F18C7}"/>
              </a:ext>
            </a:extLst>
          </p:cNvPr>
          <p:cNvSpPr/>
          <p:nvPr/>
        </p:nvSpPr>
        <p:spPr>
          <a:xfrm rot="10800000" flipV="1">
            <a:off x="1969639" y="181596"/>
            <a:ext cx="8252722" cy="6022258"/>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solidFill>
                <a:prstClr val="black"/>
              </a:solidFill>
            </a:endParaRPr>
          </a:p>
        </p:txBody>
      </p:sp>
      <p:sp>
        <p:nvSpPr>
          <p:cNvPr id="2" name="Title 1">
            <a:extLst>
              <a:ext uri="{FF2B5EF4-FFF2-40B4-BE49-F238E27FC236}">
                <a16:creationId xmlns:a16="http://schemas.microsoft.com/office/drawing/2014/main" id="{192825A4-268B-4301-8432-F9E9B2661AEC}"/>
              </a:ext>
            </a:extLst>
          </p:cNvPr>
          <p:cNvSpPr>
            <a:spLocks noGrp="1"/>
          </p:cNvSpPr>
          <p:nvPr>
            <p:ph type="title"/>
          </p:nvPr>
        </p:nvSpPr>
        <p:spPr>
          <a:xfrm>
            <a:off x="2843784" y="1572768"/>
            <a:ext cx="6501384" cy="4096512"/>
          </a:xfrm>
        </p:spPr>
        <p:txBody>
          <a:bodyPr>
            <a:normAutofit/>
          </a:bodyPr>
          <a:lstStyle>
            <a:lvl1pPr algn="ctr">
              <a:defRPr sz="4000"/>
            </a:lvl1pPr>
          </a:lstStyle>
          <a:p>
            <a:r>
              <a:rPr lang="en-US"/>
              <a:t>Click to edit Master title style</a:t>
            </a:r>
            <a:endParaRPr lang="en-US" dirty="0"/>
          </a:p>
        </p:txBody>
      </p:sp>
      <p:sp>
        <p:nvSpPr>
          <p:cNvPr id="3" name="Date Placeholder 2">
            <a:extLst>
              <a:ext uri="{FF2B5EF4-FFF2-40B4-BE49-F238E27FC236}">
                <a16:creationId xmlns:a16="http://schemas.microsoft.com/office/drawing/2014/main" id="{DA33410F-8A90-47F6-BD39-4AC0E4358351}"/>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4" name="Footer Placeholder 3">
            <a:extLst>
              <a:ext uri="{FF2B5EF4-FFF2-40B4-BE49-F238E27FC236}">
                <a16:creationId xmlns:a16="http://schemas.microsoft.com/office/drawing/2014/main" id="{D1D819A9-F8DE-4E5C-AFC3-E0105ACD8295}"/>
              </a:ext>
            </a:extLst>
          </p:cNvPr>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a:extLst>
              <a:ext uri="{FF2B5EF4-FFF2-40B4-BE49-F238E27FC236}">
                <a16:creationId xmlns:a16="http://schemas.microsoft.com/office/drawing/2014/main" id="{A4E25320-A12F-4F3E-8EC9-11292FF36BEA}"/>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701782771"/>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blank" preserve="1">
  <p:cSld name="Blank 1">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1C9756B-145D-4BA8-AA43-904C1E7CB86D}"/>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3" name="Footer Placeholder 2">
            <a:extLst>
              <a:ext uri="{FF2B5EF4-FFF2-40B4-BE49-F238E27FC236}">
                <a16:creationId xmlns:a16="http://schemas.microsoft.com/office/drawing/2014/main" id="{B21DB60F-139E-4C44-89AF-3F8F5EC241FB}"/>
              </a:ext>
            </a:extLst>
          </p:cNvPr>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a:extLst>
              <a:ext uri="{FF2B5EF4-FFF2-40B4-BE49-F238E27FC236}">
                <a16:creationId xmlns:a16="http://schemas.microsoft.com/office/drawing/2014/main" id="{388226C9-C193-4B47-9717-4BC86C9092C7}"/>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2748924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blank" preserve="1">
  <p:cSld name="Blank 2">
    <p:spTree>
      <p:nvGrpSpPr>
        <p:cNvPr id="1" name=""/>
        <p:cNvGrpSpPr/>
        <p:nvPr/>
      </p:nvGrpSpPr>
      <p:grpSpPr>
        <a:xfrm>
          <a:off x="0" y="0"/>
          <a:ext cx="0" cy="0"/>
          <a:chOff x="0" y="0"/>
          <a:chExt cx="0" cy="0"/>
        </a:xfrm>
      </p:grpSpPr>
      <p:sp>
        <p:nvSpPr>
          <p:cNvPr id="6" name="Freeform: Shape 5" descr="Mask ID=&#10;Mask position=bottom, center&#10;Mask family= brushstroke, landscape, wide">
            <a:extLst>
              <a:ext uri="{FF2B5EF4-FFF2-40B4-BE49-F238E27FC236}">
                <a16:creationId xmlns:a16="http://schemas.microsoft.com/office/drawing/2014/main" id="{736BF44D-E8DD-45FA-931D-CBCC67D57944}"/>
              </a:ext>
            </a:extLst>
          </p:cNvPr>
          <p:cNvSpPr/>
          <p:nvPr/>
        </p:nvSpPr>
        <p:spPr>
          <a:xfrm>
            <a:off x="1768100" y="-1"/>
            <a:ext cx="10423900" cy="5920155"/>
          </a:xfrm>
          <a:custGeom>
            <a:avLst/>
            <a:gdLst>
              <a:gd name="connsiteX0" fmla="*/ 10423900 w 10423900"/>
              <a:gd name="connsiteY0" fmla="*/ 0 h 5491534"/>
              <a:gd name="connsiteX1" fmla="*/ 3493157 w 10423900"/>
              <a:gd name="connsiteY1" fmla="*/ 0 h 5491534"/>
              <a:gd name="connsiteX2" fmla="*/ 3493018 w 10423900"/>
              <a:gd name="connsiteY2" fmla="*/ 31 h 5491534"/>
              <a:gd name="connsiteX3" fmla="*/ 3245493 w 10423900"/>
              <a:gd name="connsiteY3" fmla="*/ 104839 h 5491534"/>
              <a:gd name="connsiteX4" fmla="*/ 4434802 w 10423900"/>
              <a:gd name="connsiteY4" fmla="*/ 284558 h 5491534"/>
              <a:gd name="connsiteX5" fmla="*/ 4011937 w 10423900"/>
              <a:gd name="connsiteY5" fmla="*/ 395559 h 5491534"/>
              <a:gd name="connsiteX6" fmla="*/ 3573213 w 10423900"/>
              <a:gd name="connsiteY6" fmla="*/ 474847 h 5491534"/>
              <a:gd name="connsiteX7" fmla="*/ 3097489 w 10423900"/>
              <a:gd name="connsiteY7" fmla="*/ 532990 h 5491534"/>
              <a:gd name="connsiteX8" fmla="*/ 2664052 w 10423900"/>
              <a:gd name="connsiteY8" fmla="*/ 649279 h 5491534"/>
              <a:gd name="connsiteX9" fmla="*/ 3795218 w 10423900"/>
              <a:gd name="connsiteY9" fmla="*/ 696852 h 5491534"/>
              <a:gd name="connsiteX10" fmla="*/ 3208492 w 10423900"/>
              <a:gd name="connsiteY10" fmla="*/ 802568 h 5491534"/>
              <a:gd name="connsiteX11" fmla="*/ 2727483 w 10423900"/>
              <a:gd name="connsiteY11" fmla="*/ 939999 h 5491534"/>
              <a:gd name="connsiteX12" fmla="*/ 2389190 w 10423900"/>
              <a:gd name="connsiteY12" fmla="*/ 1003429 h 5491534"/>
              <a:gd name="connsiteX13" fmla="*/ 2029754 w 10423900"/>
              <a:gd name="connsiteY13" fmla="*/ 1019287 h 5491534"/>
              <a:gd name="connsiteX14" fmla="*/ 1945181 w 10423900"/>
              <a:gd name="connsiteY14" fmla="*/ 1119716 h 5491534"/>
              <a:gd name="connsiteX15" fmla="*/ 2056184 w 10423900"/>
              <a:gd name="connsiteY15" fmla="*/ 1225434 h 5491534"/>
              <a:gd name="connsiteX16" fmla="*/ 2225329 w 10423900"/>
              <a:gd name="connsiteY16" fmla="*/ 1236004 h 5491534"/>
              <a:gd name="connsiteX17" fmla="*/ 3234920 w 10423900"/>
              <a:gd name="connsiteY17" fmla="*/ 1262435 h 5491534"/>
              <a:gd name="connsiteX18" fmla="*/ 0 w 10423900"/>
              <a:gd name="connsiteY18" fmla="*/ 1495009 h 5491534"/>
              <a:gd name="connsiteX19" fmla="*/ 438724 w 10423900"/>
              <a:gd name="connsiteY19" fmla="*/ 1637728 h 5491534"/>
              <a:gd name="connsiteX20" fmla="*/ 586726 w 10423900"/>
              <a:gd name="connsiteY20" fmla="*/ 2028877 h 5491534"/>
              <a:gd name="connsiteX21" fmla="*/ 1125878 w 10423900"/>
              <a:gd name="connsiteY21" fmla="*/ 2250882 h 5491534"/>
              <a:gd name="connsiteX22" fmla="*/ 1474744 w 10423900"/>
              <a:gd name="connsiteY22" fmla="*/ 2330169 h 5491534"/>
              <a:gd name="connsiteX23" fmla="*/ 2272901 w 10423900"/>
              <a:gd name="connsiteY23" fmla="*/ 2446458 h 5491534"/>
              <a:gd name="connsiteX24" fmla="*/ 2389190 w 10423900"/>
              <a:gd name="connsiteY24" fmla="*/ 2636747 h 5491534"/>
              <a:gd name="connsiteX25" fmla="*/ 2489621 w 10423900"/>
              <a:gd name="connsiteY25" fmla="*/ 2848179 h 5491534"/>
              <a:gd name="connsiteX26" fmla="*/ 2701053 w 10423900"/>
              <a:gd name="connsiteY26" fmla="*/ 2985611 h 5491534"/>
              <a:gd name="connsiteX27" fmla="*/ 1057165 w 10423900"/>
              <a:gd name="connsiteY27" fmla="*/ 2964468 h 5491534"/>
              <a:gd name="connsiteX28" fmla="*/ 2912485 w 10423900"/>
              <a:gd name="connsiteY28" fmla="*/ 3408477 h 5491534"/>
              <a:gd name="connsiteX29" fmla="*/ 2748626 w 10423900"/>
              <a:gd name="connsiteY29" fmla="*/ 3582909 h 5491534"/>
              <a:gd name="connsiteX30" fmla="*/ 3763503 w 10423900"/>
              <a:gd name="connsiteY30" fmla="*/ 3820771 h 5491534"/>
              <a:gd name="connsiteX31" fmla="*/ 3219063 w 10423900"/>
              <a:gd name="connsiteY31" fmla="*/ 3847199 h 5491534"/>
              <a:gd name="connsiteX32" fmla="*/ 6385269 w 10423900"/>
              <a:gd name="connsiteY32" fmla="*/ 4840933 h 5491534"/>
              <a:gd name="connsiteX33" fmla="*/ 10285854 w 10423900"/>
              <a:gd name="connsiteY33" fmla="*/ 5471118 h 5491534"/>
              <a:gd name="connsiteX34" fmla="*/ 10423900 w 10423900"/>
              <a:gd name="connsiteY34" fmla="*/ 5491534 h 54915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10423900" h="5491534">
                <a:moveTo>
                  <a:pt x="10423900" y="0"/>
                </a:moveTo>
                <a:lnTo>
                  <a:pt x="3493157" y="0"/>
                </a:lnTo>
                <a:lnTo>
                  <a:pt x="3493018" y="31"/>
                </a:lnTo>
                <a:cubicBezTo>
                  <a:pt x="3414969" y="12668"/>
                  <a:pt x="3328744" y="21588"/>
                  <a:pt x="3245493" y="104839"/>
                </a:cubicBezTo>
                <a:cubicBezTo>
                  <a:pt x="3668357" y="162984"/>
                  <a:pt x="4075366" y="51981"/>
                  <a:pt x="4434802" y="284558"/>
                </a:cubicBezTo>
                <a:cubicBezTo>
                  <a:pt x="4302656" y="400846"/>
                  <a:pt x="4154654" y="374416"/>
                  <a:pt x="4011937" y="395559"/>
                </a:cubicBezTo>
                <a:cubicBezTo>
                  <a:pt x="3863934" y="416704"/>
                  <a:pt x="3721217" y="453704"/>
                  <a:pt x="3573213" y="474847"/>
                </a:cubicBezTo>
                <a:cubicBezTo>
                  <a:pt x="3414639" y="501275"/>
                  <a:pt x="3256063" y="506562"/>
                  <a:pt x="3097489" y="532990"/>
                </a:cubicBezTo>
                <a:cubicBezTo>
                  <a:pt x="2965345" y="554135"/>
                  <a:pt x="2822627" y="517133"/>
                  <a:pt x="2664052" y="649279"/>
                </a:cubicBezTo>
                <a:cubicBezTo>
                  <a:pt x="3055203" y="744424"/>
                  <a:pt x="3409352" y="601706"/>
                  <a:pt x="3795218" y="696852"/>
                </a:cubicBezTo>
                <a:cubicBezTo>
                  <a:pt x="3567928" y="781425"/>
                  <a:pt x="3382924" y="754995"/>
                  <a:pt x="3208492" y="802568"/>
                </a:cubicBezTo>
                <a:cubicBezTo>
                  <a:pt x="3049916" y="850140"/>
                  <a:pt x="2859627" y="797282"/>
                  <a:pt x="2727483" y="939999"/>
                </a:cubicBezTo>
                <a:cubicBezTo>
                  <a:pt x="2627052" y="1051000"/>
                  <a:pt x="2521336" y="1066858"/>
                  <a:pt x="2389190" y="1003429"/>
                </a:cubicBezTo>
                <a:cubicBezTo>
                  <a:pt x="2272901" y="945284"/>
                  <a:pt x="2146043" y="961142"/>
                  <a:pt x="2029754" y="1019287"/>
                </a:cubicBezTo>
                <a:cubicBezTo>
                  <a:pt x="1987468" y="1040430"/>
                  <a:pt x="1945181" y="1066858"/>
                  <a:pt x="1945181" y="1119716"/>
                </a:cubicBezTo>
                <a:cubicBezTo>
                  <a:pt x="1945181" y="1193719"/>
                  <a:pt x="1998039" y="1214862"/>
                  <a:pt x="2056184" y="1225434"/>
                </a:cubicBezTo>
                <a:cubicBezTo>
                  <a:pt x="2109042" y="1236004"/>
                  <a:pt x="2172471" y="1246577"/>
                  <a:pt x="2225329" y="1236004"/>
                </a:cubicBezTo>
                <a:cubicBezTo>
                  <a:pt x="2563622" y="1177861"/>
                  <a:pt x="2896629" y="1273005"/>
                  <a:pt x="3234920" y="1262435"/>
                </a:cubicBezTo>
                <a:cubicBezTo>
                  <a:pt x="2172471" y="1489724"/>
                  <a:pt x="1099450" y="1415723"/>
                  <a:pt x="0" y="1495009"/>
                </a:cubicBezTo>
                <a:cubicBezTo>
                  <a:pt x="142717" y="1653583"/>
                  <a:pt x="327721" y="1521439"/>
                  <a:pt x="438724" y="1637728"/>
                </a:cubicBezTo>
                <a:cubicBezTo>
                  <a:pt x="333006" y="1880875"/>
                  <a:pt x="375293" y="2013020"/>
                  <a:pt x="586726" y="2028877"/>
                </a:cubicBezTo>
                <a:cubicBezTo>
                  <a:pt x="792873" y="2044734"/>
                  <a:pt x="1014877" y="1960161"/>
                  <a:pt x="1125878" y="2250882"/>
                </a:cubicBezTo>
                <a:cubicBezTo>
                  <a:pt x="1157593" y="2340740"/>
                  <a:pt x="1353170" y="2314312"/>
                  <a:pt x="1474744" y="2330169"/>
                </a:cubicBezTo>
                <a:cubicBezTo>
                  <a:pt x="1739034" y="2367170"/>
                  <a:pt x="2019183" y="2330169"/>
                  <a:pt x="2272901" y="2446458"/>
                </a:cubicBezTo>
                <a:cubicBezTo>
                  <a:pt x="2373332" y="2488744"/>
                  <a:pt x="2442048" y="2520459"/>
                  <a:pt x="2389190" y="2636747"/>
                </a:cubicBezTo>
                <a:cubicBezTo>
                  <a:pt x="2336332" y="2758321"/>
                  <a:pt x="2405048" y="2800607"/>
                  <a:pt x="2489621" y="2848179"/>
                </a:cubicBezTo>
                <a:cubicBezTo>
                  <a:pt x="2553051" y="2885180"/>
                  <a:pt x="2648195" y="2874609"/>
                  <a:pt x="2701053" y="2985611"/>
                </a:cubicBezTo>
                <a:cubicBezTo>
                  <a:pt x="2146043" y="2969753"/>
                  <a:pt x="1606888" y="2879895"/>
                  <a:pt x="1057165" y="2964468"/>
                </a:cubicBezTo>
                <a:cubicBezTo>
                  <a:pt x="1659748" y="3175900"/>
                  <a:pt x="2320474" y="3165328"/>
                  <a:pt x="2912485" y="3408477"/>
                </a:cubicBezTo>
                <a:cubicBezTo>
                  <a:pt x="2891342" y="3493050"/>
                  <a:pt x="2753911" y="3456048"/>
                  <a:pt x="2748626" y="3582909"/>
                </a:cubicBezTo>
                <a:cubicBezTo>
                  <a:pt x="3060489" y="3715055"/>
                  <a:pt x="3435782" y="3625195"/>
                  <a:pt x="3763503" y="3820771"/>
                </a:cubicBezTo>
                <a:cubicBezTo>
                  <a:pt x="3573213" y="3910629"/>
                  <a:pt x="3398782" y="3762626"/>
                  <a:pt x="3219063" y="3847199"/>
                </a:cubicBezTo>
                <a:cubicBezTo>
                  <a:pt x="3277208" y="3974060"/>
                  <a:pt x="5909545" y="4756360"/>
                  <a:pt x="6385269" y="4840933"/>
                </a:cubicBezTo>
                <a:cubicBezTo>
                  <a:pt x="7171204" y="4982659"/>
                  <a:pt x="9157515" y="5302348"/>
                  <a:pt x="10285854" y="5471118"/>
                </a:cubicBezTo>
                <a:lnTo>
                  <a:pt x="10423900" y="5491534"/>
                </a:lnTo>
                <a:close/>
              </a:path>
            </a:pathLst>
          </a:custGeom>
          <a:solidFill>
            <a:schemeClr val="accent1">
              <a:alpha val="20000"/>
            </a:schemeClr>
          </a:solidFill>
          <a:ln w="32707" cap="flat">
            <a:noFill/>
            <a:prstDash val="solid"/>
            <a:miter/>
          </a:ln>
        </p:spPr>
        <p:txBody>
          <a:bodyPr wrap="square" rtlCol="0" anchor="ctr">
            <a:noAutofit/>
          </a:bodyPr>
          <a:lstStyle/>
          <a:p>
            <a:endParaRPr lang="en-US">
              <a:solidFill>
                <a:prstClr val="black"/>
              </a:solidFill>
            </a:endParaRPr>
          </a:p>
        </p:txBody>
      </p:sp>
      <p:sp>
        <p:nvSpPr>
          <p:cNvPr id="2" name="Date Placeholder 1">
            <a:extLst>
              <a:ext uri="{FF2B5EF4-FFF2-40B4-BE49-F238E27FC236}">
                <a16:creationId xmlns:a16="http://schemas.microsoft.com/office/drawing/2014/main" id="{71C9756B-145D-4BA8-AA43-904C1E7CB86D}"/>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3" name="Footer Placeholder 2">
            <a:extLst>
              <a:ext uri="{FF2B5EF4-FFF2-40B4-BE49-F238E27FC236}">
                <a16:creationId xmlns:a16="http://schemas.microsoft.com/office/drawing/2014/main" id="{B21DB60F-139E-4C44-89AF-3F8F5EC241FB}"/>
              </a:ext>
            </a:extLst>
          </p:cNvPr>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a:extLst>
              <a:ext uri="{FF2B5EF4-FFF2-40B4-BE49-F238E27FC236}">
                <a16:creationId xmlns:a16="http://schemas.microsoft.com/office/drawing/2014/main" id="{388226C9-C193-4B47-9717-4BC86C9092C7}"/>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270882486"/>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8" name="Freeform: Shape 7" descr="Tag=AccentColor&#10;Flavor=Light&#10;Target=Fill">
            <a:extLst>
              <a:ext uri="{FF2B5EF4-FFF2-40B4-BE49-F238E27FC236}">
                <a16:creationId xmlns:a16="http://schemas.microsoft.com/office/drawing/2014/main" id="{76C5A8FA-6B61-4934-AF55-C595090CA5DC}"/>
              </a:ext>
            </a:extLst>
          </p:cNvPr>
          <p:cNvSpPr/>
          <p:nvPr/>
        </p:nvSpPr>
        <p:spPr>
          <a:xfrm>
            <a:off x="4726728" y="0"/>
            <a:ext cx="7472381" cy="6858000"/>
          </a:xfrm>
          <a:custGeom>
            <a:avLst/>
            <a:gdLst>
              <a:gd name="connsiteX0" fmla="*/ 1232666 w 7472381"/>
              <a:gd name="connsiteY0" fmla="*/ 0 h 6886575"/>
              <a:gd name="connsiteX1" fmla="*/ 7472381 w 7472381"/>
              <a:gd name="connsiteY1" fmla="*/ 0 h 6886575"/>
              <a:gd name="connsiteX2" fmla="*/ 7472381 w 7472381"/>
              <a:gd name="connsiteY2" fmla="*/ 814388 h 6886575"/>
              <a:gd name="connsiteX3" fmla="*/ 7472381 w 7472381"/>
              <a:gd name="connsiteY3" fmla="*/ 6411516 h 6886575"/>
              <a:gd name="connsiteX4" fmla="*/ 7472381 w 7472381"/>
              <a:gd name="connsiteY4" fmla="*/ 6886575 h 6886575"/>
              <a:gd name="connsiteX5" fmla="*/ 6992676 w 7472381"/>
              <a:gd name="connsiteY5" fmla="*/ 6886575 h 6886575"/>
              <a:gd name="connsiteX6" fmla="*/ 1946893 w 7472381"/>
              <a:gd name="connsiteY6" fmla="*/ 6886575 h 6886575"/>
              <a:gd name="connsiteX7" fmla="*/ 1506276 w 7472381"/>
              <a:gd name="connsiteY7" fmla="*/ 6686550 h 6886575"/>
              <a:gd name="connsiteX8" fmla="*/ 1314394 w 7472381"/>
              <a:gd name="connsiteY8" fmla="*/ 6457949 h 6886575"/>
              <a:gd name="connsiteX9" fmla="*/ 1246880 w 7472381"/>
              <a:gd name="connsiteY9" fmla="*/ 6393656 h 6886575"/>
              <a:gd name="connsiteX10" fmla="*/ 1079872 w 7472381"/>
              <a:gd name="connsiteY10" fmla="*/ 6307931 h 6886575"/>
              <a:gd name="connsiteX11" fmla="*/ 788495 w 7472381"/>
              <a:gd name="connsiteY11" fmla="*/ 6125765 h 6886575"/>
              <a:gd name="connsiteX12" fmla="*/ 895097 w 7472381"/>
              <a:gd name="connsiteY12" fmla="*/ 6082903 h 6886575"/>
              <a:gd name="connsiteX13" fmla="*/ 1204239 w 7472381"/>
              <a:gd name="connsiteY13" fmla="*/ 6193631 h 6886575"/>
              <a:gd name="connsiteX14" fmla="*/ 1428102 w 7472381"/>
              <a:gd name="connsiteY14" fmla="*/ 6222206 h 6886575"/>
              <a:gd name="connsiteX15" fmla="*/ 1111852 w 7472381"/>
              <a:gd name="connsiteY15" fmla="*/ 6029325 h 6886575"/>
              <a:gd name="connsiteX16" fmla="*/ 806262 w 7472381"/>
              <a:gd name="connsiteY16" fmla="*/ 5779294 h 6886575"/>
              <a:gd name="connsiteX17" fmla="*/ 1040785 w 7472381"/>
              <a:gd name="connsiteY17" fmla="*/ 5825728 h 6886575"/>
              <a:gd name="connsiteX18" fmla="*/ 1051445 w 7472381"/>
              <a:gd name="connsiteY18" fmla="*/ 5793581 h 6886575"/>
              <a:gd name="connsiteX19" fmla="*/ 845349 w 7472381"/>
              <a:gd name="connsiteY19" fmla="*/ 5497115 h 6886575"/>
              <a:gd name="connsiteX20" fmla="*/ 745855 w 7472381"/>
              <a:gd name="connsiteY20" fmla="*/ 5375672 h 6886575"/>
              <a:gd name="connsiteX21" fmla="*/ 291024 w 7472381"/>
              <a:gd name="connsiteY21" fmla="*/ 5014913 h 6886575"/>
              <a:gd name="connsiteX22" fmla="*/ 724535 w 7472381"/>
              <a:gd name="connsiteY22" fmla="*/ 5175647 h 6886575"/>
              <a:gd name="connsiteX23" fmla="*/ 276811 w 7472381"/>
              <a:gd name="connsiteY23" fmla="*/ 4825603 h 6886575"/>
              <a:gd name="connsiteX24" fmla="*/ 60055 w 7472381"/>
              <a:gd name="connsiteY24" fmla="*/ 4697016 h 6886575"/>
              <a:gd name="connsiteX25" fmla="*/ 6755 w 7472381"/>
              <a:gd name="connsiteY25" fmla="*/ 4622006 h 6886575"/>
              <a:gd name="connsiteX26" fmla="*/ 102696 w 7472381"/>
              <a:gd name="connsiteY26" fmla="*/ 4604146 h 6886575"/>
              <a:gd name="connsiteX27" fmla="*/ 397625 w 7472381"/>
              <a:gd name="connsiteY27" fmla="*/ 4632722 h 6886575"/>
              <a:gd name="connsiteX28" fmla="*/ 31628 w 7472381"/>
              <a:gd name="connsiteY28" fmla="*/ 4396978 h 6886575"/>
              <a:gd name="connsiteX29" fmla="*/ 305237 w 7472381"/>
              <a:gd name="connsiteY29" fmla="*/ 4432697 h 6886575"/>
              <a:gd name="connsiteX30" fmla="*/ 383412 w 7472381"/>
              <a:gd name="connsiteY30" fmla="*/ 4339828 h 6886575"/>
              <a:gd name="connsiteX31" fmla="*/ 511333 w 7472381"/>
              <a:gd name="connsiteY31" fmla="*/ 4189810 h 6886575"/>
              <a:gd name="connsiteX32" fmla="*/ 600167 w 7472381"/>
              <a:gd name="connsiteY32" fmla="*/ 4107656 h 6886575"/>
              <a:gd name="connsiteX33" fmla="*/ 635701 w 7472381"/>
              <a:gd name="connsiteY33" fmla="*/ 3843337 h 6886575"/>
              <a:gd name="connsiteX34" fmla="*/ 561080 w 7472381"/>
              <a:gd name="connsiteY34" fmla="*/ 3554015 h 6886575"/>
              <a:gd name="connsiteX35" fmla="*/ 354985 w 7472381"/>
              <a:gd name="connsiteY35" fmla="*/ 3407569 h 6886575"/>
              <a:gd name="connsiteX36" fmla="*/ 415392 w 7472381"/>
              <a:gd name="connsiteY36" fmla="*/ 3243263 h 6886575"/>
              <a:gd name="connsiteX37" fmla="*/ 852456 w 7472381"/>
              <a:gd name="connsiteY37" fmla="*/ 3343275 h 6886575"/>
              <a:gd name="connsiteX38" fmla="*/ 202190 w 7472381"/>
              <a:gd name="connsiteY38" fmla="*/ 2953940 h 6886575"/>
              <a:gd name="connsiteX39" fmla="*/ 312344 w 7472381"/>
              <a:gd name="connsiteY39" fmla="*/ 2936081 h 6886575"/>
              <a:gd name="connsiteX40" fmla="*/ 706768 w 7472381"/>
              <a:gd name="connsiteY40" fmla="*/ 2714625 h 6886575"/>
              <a:gd name="connsiteX41" fmla="*/ 728088 w 7472381"/>
              <a:gd name="connsiteY41" fmla="*/ 2703909 h 6886575"/>
              <a:gd name="connsiteX42" fmla="*/ 795602 w 7472381"/>
              <a:gd name="connsiteY42" fmla="*/ 2564606 h 6886575"/>
              <a:gd name="connsiteX43" fmla="*/ 1008804 w 7472381"/>
              <a:gd name="connsiteY43" fmla="*/ 2543175 h 6886575"/>
              <a:gd name="connsiteX44" fmla="*/ 1186473 w 7472381"/>
              <a:gd name="connsiteY44" fmla="*/ 2575322 h 6886575"/>
              <a:gd name="connsiteX45" fmla="*/ 1378355 w 7472381"/>
              <a:gd name="connsiteY45" fmla="*/ 2536031 h 6886575"/>
              <a:gd name="connsiteX46" fmla="*/ 1548916 w 7472381"/>
              <a:gd name="connsiteY46" fmla="*/ 2553891 h 6886575"/>
              <a:gd name="connsiteX47" fmla="*/ 1694604 w 7472381"/>
              <a:gd name="connsiteY47" fmla="*/ 2528888 h 6886575"/>
              <a:gd name="connsiteX48" fmla="*/ 1552469 w 7472381"/>
              <a:gd name="connsiteY48" fmla="*/ 2411015 h 6886575"/>
              <a:gd name="connsiteX49" fmla="*/ 1353481 w 7472381"/>
              <a:gd name="connsiteY49" fmla="*/ 2411015 h 6886575"/>
              <a:gd name="connsiteX50" fmla="*/ 1211346 w 7472381"/>
              <a:gd name="connsiteY50" fmla="*/ 2336007 h 6886575"/>
              <a:gd name="connsiteX51" fmla="*/ 1076318 w 7472381"/>
              <a:gd name="connsiteY51" fmla="*/ 2200275 h 6886575"/>
              <a:gd name="connsiteX52" fmla="*/ 600167 w 7472381"/>
              <a:gd name="connsiteY52" fmla="*/ 1982390 h 6886575"/>
              <a:gd name="connsiteX53" fmla="*/ 514886 w 7472381"/>
              <a:gd name="connsiteY53" fmla="*/ 1900238 h 6886575"/>
              <a:gd name="connsiteX54" fmla="*/ 1872273 w 7472381"/>
              <a:gd name="connsiteY54" fmla="*/ 2218135 h 6886575"/>
              <a:gd name="connsiteX55" fmla="*/ 1452975 w 7472381"/>
              <a:gd name="connsiteY55" fmla="*/ 2085975 h 6886575"/>
              <a:gd name="connsiteX56" fmla="*/ 1737245 w 7472381"/>
              <a:gd name="connsiteY56" fmla="*/ 2110978 h 6886575"/>
              <a:gd name="connsiteX57" fmla="*/ 1893593 w 7472381"/>
              <a:gd name="connsiteY57" fmla="*/ 2021681 h 6886575"/>
              <a:gd name="connsiteX58" fmla="*/ 1893593 w 7472381"/>
              <a:gd name="connsiteY58" fmla="*/ 1993106 h 6886575"/>
              <a:gd name="connsiteX59" fmla="*/ 1776332 w 7472381"/>
              <a:gd name="connsiteY59" fmla="*/ 1910953 h 6886575"/>
              <a:gd name="connsiteX60" fmla="*/ 1708818 w 7472381"/>
              <a:gd name="connsiteY60" fmla="*/ 1857375 h 6886575"/>
              <a:gd name="connsiteX61" fmla="*/ 1524043 w 7472381"/>
              <a:gd name="connsiteY61" fmla="*/ 1664493 h 6886575"/>
              <a:gd name="connsiteX62" fmla="*/ 1655517 w 7472381"/>
              <a:gd name="connsiteY62" fmla="*/ 1643062 h 6886575"/>
              <a:gd name="connsiteX63" fmla="*/ 1705264 w 7472381"/>
              <a:gd name="connsiteY63" fmla="*/ 1603772 h 6886575"/>
              <a:gd name="connsiteX64" fmla="*/ 1669731 w 7472381"/>
              <a:gd name="connsiteY64" fmla="*/ 1546622 h 6886575"/>
              <a:gd name="connsiteX65" fmla="*/ 1261093 w 7472381"/>
              <a:gd name="connsiteY65" fmla="*/ 1371600 h 6886575"/>
              <a:gd name="connsiteX66" fmla="*/ 1229113 w 7472381"/>
              <a:gd name="connsiteY66" fmla="*/ 1235869 h 6886575"/>
              <a:gd name="connsiteX67" fmla="*/ 1307287 w 7472381"/>
              <a:gd name="connsiteY67" fmla="*/ 1214437 h 6886575"/>
              <a:gd name="connsiteX68" fmla="*/ 1396121 w 7472381"/>
              <a:gd name="connsiteY68" fmla="*/ 1225153 h 6886575"/>
              <a:gd name="connsiteX69" fmla="*/ 1325054 w 7472381"/>
              <a:gd name="connsiteY69" fmla="*/ 1117997 h 6886575"/>
              <a:gd name="connsiteX70" fmla="*/ 1037231 w 7472381"/>
              <a:gd name="connsiteY70" fmla="*/ 1010841 h 6886575"/>
              <a:gd name="connsiteX71" fmla="*/ 983931 w 7472381"/>
              <a:gd name="connsiteY71" fmla="*/ 953690 h 6886575"/>
              <a:gd name="connsiteX72" fmla="*/ 1054998 w 7472381"/>
              <a:gd name="connsiteY72" fmla="*/ 925115 h 6886575"/>
              <a:gd name="connsiteX73" fmla="*/ 1108299 w 7472381"/>
              <a:gd name="connsiteY73" fmla="*/ 914400 h 6886575"/>
              <a:gd name="connsiteX74" fmla="*/ 6755 w 7472381"/>
              <a:gd name="connsiteY74" fmla="*/ 467915 h 6886575"/>
              <a:gd name="connsiteX75" fmla="*/ 255490 w 7472381"/>
              <a:gd name="connsiteY75" fmla="*/ 464344 h 6886575"/>
              <a:gd name="connsiteX76" fmla="*/ 500673 w 7472381"/>
              <a:gd name="connsiteY76" fmla="*/ 535781 h 6886575"/>
              <a:gd name="connsiteX77" fmla="*/ 760069 w 7472381"/>
              <a:gd name="connsiteY77" fmla="*/ 525066 h 6886575"/>
              <a:gd name="connsiteX78" fmla="*/ 1005251 w 7472381"/>
              <a:gd name="connsiteY78" fmla="*/ 560785 h 6886575"/>
              <a:gd name="connsiteX79" fmla="*/ 1218453 w 7472381"/>
              <a:gd name="connsiteY79" fmla="*/ 560785 h 6886575"/>
              <a:gd name="connsiteX80" fmla="*/ 1019464 w 7472381"/>
              <a:gd name="connsiteY80" fmla="*/ 507206 h 6886575"/>
              <a:gd name="connsiteX81" fmla="*/ 944844 w 7472381"/>
              <a:gd name="connsiteY81" fmla="*/ 417909 h 6886575"/>
              <a:gd name="connsiteX82" fmla="*/ 969717 w 7472381"/>
              <a:gd name="connsiteY82" fmla="*/ 335757 h 6886575"/>
              <a:gd name="connsiteX83" fmla="*/ 1051445 w 7472381"/>
              <a:gd name="connsiteY83" fmla="*/ 360759 h 6886575"/>
              <a:gd name="connsiteX84" fmla="*/ 1147386 w 7472381"/>
              <a:gd name="connsiteY84" fmla="*/ 453629 h 6886575"/>
              <a:gd name="connsiteX85" fmla="*/ 1168706 w 7472381"/>
              <a:gd name="connsiteY85" fmla="*/ 396478 h 6886575"/>
              <a:gd name="connsiteX86" fmla="*/ 1225560 w 7472381"/>
              <a:gd name="connsiteY86" fmla="*/ 353615 h 6886575"/>
              <a:gd name="connsiteX87" fmla="*/ 1552469 w 7472381"/>
              <a:gd name="connsiteY87" fmla="*/ 375047 h 6886575"/>
              <a:gd name="connsiteX88" fmla="*/ 1335714 w 7472381"/>
              <a:gd name="connsiteY88" fmla="*/ 192881 h 6886575"/>
              <a:gd name="connsiteX89" fmla="*/ 1197133 w 7472381"/>
              <a:gd name="connsiteY89" fmla="*/ 164306 h 6886575"/>
              <a:gd name="connsiteX90" fmla="*/ 1165153 w 7472381"/>
              <a:gd name="connsiteY90" fmla="*/ 89297 h 6886575"/>
              <a:gd name="connsiteX91" fmla="*/ 1229113 w 7472381"/>
              <a:gd name="connsiteY91" fmla="*/ 71437 h 6886575"/>
              <a:gd name="connsiteX92" fmla="*/ 1548916 w 7472381"/>
              <a:gd name="connsiteY92" fmla="*/ 135731 h 6886575"/>
              <a:gd name="connsiteX93" fmla="*/ 1602217 w 7472381"/>
              <a:gd name="connsiteY93" fmla="*/ 110728 h 6886575"/>
              <a:gd name="connsiteX94" fmla="*/ 1232666 w 7472381"/>
              <a:gd name="connsiteY94" fmla="*/ 0 h 68865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Lst>
            <a:rect l="l" t="t" r="r" b="b"/>
            <a:pathLst>
              <a:path w="7472381" h="6886575">
                <a:moveTo>
                  <a:pt x="1232666" y="0"/>
                </a:moveTo>
                <a:lnTo>
                  <a:pt x="7472381" y="0"/>
                </a:lnTo>
                <a:lnTo>
                  <a:pt x="7472381" y="814388"/>
                </a:lnTo>
                <a:lnTo>
                  <a:pt x="7472381" y="6411516"/>
                </a:lnTo>
                <a:lnTo>
                  <a:pt x="7472381" y="6886575"/>
                </a:lnTo>
                <a:lnTo>
                  <a:pt x="6992676" y="6886575"/>
                </a:lnTo>
                <a:lnTo>
                  <a:pt x="1946893" y="6886575"/>
                </a:lnTo>
                <a:cubicBezTo>
                  <a:pt x="1801205" y="6815137"/>
                  <a:pt x="1662624" y="6729412"/>
                  <a:pt x="1506276" y="6686550"/>
                </a:cubicBezTo>
                <a:cubicBezTo>
                  <a:pt x="1399675" y="6657975"/>
                  <a:pt x="1296627" y="6607969"/>
                  <a:pt x="1314394" y="6457949"/>
                </a:cubicBezTo>
                <a:cubicBezTo>
                  <a:pt x="1317947" y="6415087"/>
                  <a:pt x="1289520" y="6382941"/>
                  <a:pt x="1246880" y="6393656"/>
                </a:cubicBezTo>
                <a:cubicBezTo>
                  <a:pt x="1165153" y="6415087"/>
                  <a:pt x="1126065" y="6354365"/>
                  <a:pt x="1079872" y="6307931"/>
                </a:cubicBezTo>
                <a:cubicBezTo>
                  <a:pt x="998144" y="6225779"/>
                  <a:pt x="919970" y="6140052"/>
                  <a:pt x="788495" y="6125765"/>
                </a:cubicBezTo>
                <a:cubicBezTo>
                  <a:pt x="813369" y="6061471"/>
                  <a:pt x="856009" y="6068615"/>
                  <a:pt x="895097" y="6082903"/>
                </a:cubicBezTo>
                <a:cubicBezTo>
                  <a:pt x="998144" y="6118622"/>
                  <a:pt x="1101192" y="6157912"/>
                  <a:pt x="1204239" y="6193631"/>
                </a:cubicBezTo>
                <a:cubicBezTo>
                  <a:pt x="1271754" y="6215062"/>
                  <a:pt x="1339267" y="6247209"/>
                  <a:pt x="1428102" y="6222206"/>
                </a:cubicBezTo>
                <a:cubicBezTo>
                  <a:pt x="1349928" y="6093619"/>
                  <a:pt x="1218453" y="6068615"/>
                  <a:pt x="1111852" y="6029325"/>
                </a:cubicBezTo>
                <a:cubicBezTo>
                  <a:pt x="980377" y="5979319"/>
                  <a:pt x="902203" y="5886450"/>
                  <a:pt x="806262" y="5779294"/>
                </a:cubicBezTo>
                <a:cubicBezTo>
                  <a:pt x="902203" y="5750719"/>
                  <a:pt x="962610" y="5829300"/>
                  <a:pt x="1040785" y="5825728"/>
                </a:cubicBezTo>
                <a:cubicBezTo>
                  <a:pt x="1044338" y="5815012"/>
                  <a:pt x="1051445" y="5793581"/>
                  <a:pt x="1051445" y="5793581"/>
                </a:cubicBezTo>
                <a:cubicBezTo>
                  <a:pt x="923523" y="5736431"/>
                  <a:pt x="866670" y="5629275"/>
                  <a:pt x="845349" y="5497115"/>
                </a:cubicBezTo>
                <a:cubicBezTo>
                  <a:pt x="838243" y="5429250"/>
                  <a:pt x="792049" y="5407819"/>
                  <a:pt x="745855" y="5375672"/>
                </a:cubicBezTo>
                <a:cubicBezTo>
                  <a:pt x="589507" y="5264943"/>
                  <a:pt x="422499" y="5164931"/>
                  <a:pt x="291024" y="5014913"/>
                </a:cubicBezTo>
                <a:cubicBezTo>
                  <a:pt x="443819" y="5032771"/>
                  <a:pt x="564633" y="5132784"/>
                  <a:pt x="724535" y="5175647"/>
                </a:cubicBezTo>
                <a:cubicBezTo>
                  <a:pt x="596614" y="5011340"/>
                  <a:pt x="429605" y="4925615"/>
                  <a:pt x="276811" y="4825603"/>
                </a:cubicBezTo>
                <a:cubicBezTo>
                  <a:pt x="205743" y="4779169"/>
                  <a:pt x="141783" y="4722018"/>
                  <a:pt x="60055" y="4697016"/>
                </a:cubicBezTo>
                <a:cubicBezTo>
                  <a:pt x="31628" y="4689872"/>
                  <a:pt x="-18119" y="4672013"/>
                  <a:pt x="6755" y="4622006"/>
                </a:cubicBezTo>
                <a:cubicBezTo>
                  <a:pt x="28075" y="4579144"/>
                  <a:pt x="67162" y="4593432"/>
                  <a:pt x="102696" y="4604146"/>
                </a:cubicBezTo>
                <a:cubicBezTo>
                  <a:pt x="187976" y="4632722"/>
                  <a:pt x="280364" y="4632722"/>
                  <a:pt x="397625" y="4632722"/>
                </a:cubicBezTo>
                <a:cubicBezTo>
                  <a:pt x="298131" y="4496990"/>
                  <a:pt x="116909" y="4539853"/>
                  <a:pt x="31628" y="4396978"/>
                </a:cubicBezTo>
                <a:cubicBezTo>
                  <a:pt x="138229" y="4371976"/>
                  <a:pt x="219957" y="4421982"/>
                  <a:pt x="305237" y="4432697"/>
                </a:cubicBezTo>
                <a:cubicBezTo>
                  <a:pt x="383412" y="4443413"/>
                  <a:pt x="401178" y="4418409"/>
                  <a:pt x="383412" y="4339828"/>
                </a:cubicBezTo>
                <a:cubicBezTo>
                  <a:pt x="354985" y="4218385"/>
                  <a:pt x="397625" y="4157662"/>
                  <a:pt x="511333" y="4189810"/>
                </a:cubicBezTo>
                <a:cubicBezTo>
                  <a:pt x="617934" y="4221956"/>
                  <a:pt x="628594" y="4175522"/>
                  <a:pt x="600167" y="4107656"/>
                </a:cubicBezTo>
                <a:cubicBezTo>
                  <a:pt x="557527" y="4007644"/>
                  <a:pt x="603720" y="3929063"/>
                  <a:pt x="635701" y="3843337"/>
                </a:cubicBezTo>
                <a:cubicBezTo>
                  <a:pt x="685448" y="3714750"/>
                  <a:pt x="664128" y="3650456"/>
                  <a:pt x="561080" y="3554015"/>
                </a:cubicBezTo>
                <a:cubicBezTo>
                  <a:pt x="500673" y="3500438"/>
                  <a:pt x="440265" y="3454003"/>
                  <a:pt x="354985" y="3407569"/>
                </a:cubicBezTo>
                <a:cubicBezTo>
                  <a:pt x="550420" y="3382565"/>
                  <a:pt x="347878" y="3296841"/>
                  <a:pt x="415392" y="3243263"/>
                </a:cubicBezTo>
                <a:cubicBezTo>
                  <a:pt x="553973" y="3221831"/>
                  <a:pt x="664128" y="3393282"/>
                  <a:pt x="852456" y="3343275"/>
                </a:cubicBezTo>
                <a:cubicBezTo>
                  <a:pt x="625041" y="3196828"/>
                  <a:pt x="369198" y="3150393"/>
                  <a:pt x="202190" y="2953940"/>
                </a:cubicBezTo>
                <a:cubicBezTo>
                  <a:pt x="241277" y="2911078"/>
                  <a:pt x="280364" y="2953940"/>
                  <a:pt x="312344" y="2936081"/>
                </a:cubicBezTo>
                <a:cubicBezTo>
                  <a:pt x="312344" y="2925365"/>
                  <a:pt x="685448" y="2993232"/>
                  <a:pt x="706768" y="2714625"/>
                </a:cubicBezTo>
                <a:cubicBezTo>
                  <a:pt x="713875" y="2714625"/>
                  <a:pt x="720982" y="2714625"/>
                  <a:pt x="728088" y="2703909"/>
                </a:cubicBezTo>
                <a:cubicBezTo>
                  <a:pt x="767175" y="2664619"/>
                  <a:pt x="731642" y="2571750"/>
                  <a:pt x="795602" y="2564606"/>
                </a:cubicBezTo>
                <a:cubicBezTo>
                  <a:pt x="866670" y="2557462"/>
                  <a:pt x="934184" y="2525315"/>
                  <a:pt x="1008804" y="2543175"/>
                </a:cubicBezTo>
                <a:cubicBezTo>
                  <a:pt x="1065658" y="2557462"/>
                  <a:pt x="1126065" y="2575322"/>
                  <a:pt x="1186473" y="2575322"/>
                </a:cubicBezTo>
                <a:cubicBezTo>
                  <a:pt x="1250433" y="2575322"/>
                  <a:pt x="1339267" y="2696766"/>
                  <a:pt x="1378355" y="2536031"/>
                </a:cubicBezTo>
                <a:cubicBezTo>
                  <a:pt x="1378355" y="2528888"/>
                  <a:pt x="1488509" y="2546747"/>
                  <a:pt x="1548916" y="2553891"/>
                </a:cubicBezTo>
                <a:cubicBezTo>
                  <a:pt x="1598663" y="2561035"/>
                  <a:pt x="1659071" y="2593181"/>
                  <a:pt x="1694604" y="2528888"/>
                </a:cubicBezTo>
                <a:cubicBezTo>
                  <a:pt x="1712371" y="2489596"/>
                  <a:pt x="1627090" y="2418159"/>
                  <a:pt x="1552469" y="2411015"/>
                </a:cubicBezTo>
                <a:cubicBezTo>
                  <a:pt x="1484956" y="2403872"/>
                  <a:pt x="1417442" y="2396728"/>
                  <a:pt x="1353481" y="2411015"/>
                </a:cubicBezTo>
                <a:cubicBezTo>
                  <a:pt x="1275307" y="2428875"/>
                  <a:pt x="1232666" y="2400300"/>
                  <a:pt x="1211346" y="2336007"/>
                </a:cubicBezTo>
                <a:cubicBezTo>
                  <a:pt x="1186473" y="2268141"/>
                  <a:pt x="1140279" y="2232422"/>
                  <a:pt x="1076318" y="2200275"/>
                </a:cubicBezTo>
                <a:cubicBezTo>
                  <a:pt x="919970" y="2121694"/>
                  <a:pt x="770729" y="2028825"/>
                  <a:pt x="600167" y="1982390"/>
                </a:cubicBezTo>
                <a:cubicBezTo>
                  <a:pt x="568187" y="1975246"/>
                  <a:pt x="529100" y="1960959"/>
                  <a:pt x="514886" y="1900238"/>
                </a:cubicBezTo>
                <a:cubicBezTo>
                  <a:pt x="976824" y="1993106"/>
                  <a:pt x="1396121" y="2232422"/>
                  <a:pt x="1872273" y="2218135"/>
                </a:cubicBezTo>
                <a:cubicBezTo>
                  <a:pt x="1744351" y="2143125"/>
                  <a:pt x="1591557" y="2139554"/>
                  <a:pt x="1452975" y="2085975"/>
                </a:cubicBezTo>
                <a:cubicBezTo>
                  <a:pt x="1552469" y="2046685"/>
                  <a:pt x="1644857" y="2089547"/>
                  <a:pt x="1737245" y="2110978"/>
                </a:cubicBezTo>
                <a:cubicBezTo>
                  <a:pt x="1815419" y="2128837"/>
                  <a:pt x="1886486" y="2132410"/>
                  <a:pt x="1893593" y="2021681"/>
                </a:cubicBezTo>
                <a:cubicBezTo>
                  <a:pt x="1893593" y="2010965"/>
                  <a:pt x="1893593" y="2003821"/>
                  <a:pt x="1893593" y="1993106"/>
                </a:cubicBezTo>
                <a:cubicBezTo>
                  <a:pt x="1865166" y="1946672"/>
                  <a:pt x="1826079" y="1925240"/>
                  <a:pt x="1776332" y="1910953"/>
                </a:cubicBezTo>
                <a:cubicBezTo>
                  <a:pt x="1747905" y="1903809"/>
                  <a:pt x="1708818" y="1889522"/>
                  <a:pt x="1708818" y="1857375"/>
                </a:cubicBezTo>
                <a:cubicBezTo>
                  <a:pt x="1712371" y="1735931"/>
                  <a:pt x="1616430" y="1700212"/>
                  <a:pt x="1524043" y="1664493"/>
                </a:cubicBezTo>
                <a:cubicBezTo>
                  <a:pt x="1573790" y="1603772"/>
                  <a:pt x="1616430" y="1646635"/>
                  <a:pt x="1655517" y="1643062"/>
                </a:cubicBezTo>
                <a:cubicBezTo>
                  <a:pt x="1680391" y="1639491"/>
                  <a:pt x="1705264" y="1635919"/>
                  <a:pt x="1705264" y="1603772"/>
                </a:cubicBezTo>
                <a:cubicBezTo>
                  <a:pt x="1705264" y="1578769"/>
                  <a:pt x="1694604" y="1546622"/>
                  <a:pt x="1669731" y="1546622"/>
                </a:cubicBezTo>
                <a:cubicBezTo>
                  <a:pt x="1513383" y="1543050"/>
                  <a:pt x="1424548" y="1371600"/>
                  <a:pt x="1261093" y="1371600"/>
                </a:cubicBezTo>
                <a:cubicBezTo>
                  <a:pt x="1161599" y="1371600"/>
                  <a:pt x="1310841" y="1275159"/>
                  <a:pt x="1229113" y="1235869"/>
                </a:cubicBezTo>
                <a:cubicBezTo>
                  <a:pt x="1211346" y="1225153"/>
                  <a:pt x="1278860" y="1210866"/>
                  <a:pt x="1307287" y="1214437"/>
                </a:cubicBezTo>
                <a:cubicBezTo>
                  <a:pt x="1335714" y="1218009"/>
                  <a:pt x="1360588" y="1243013"/>
                  <a:pt x="1396121" y="1225153"/>
                </a:cubicBezTo>
                <a:cubicBezTo>
                  <a:pt x="1413888" y="1160860"/>
                  <a:pt x="1367694" y="1135856"/>
                  <a:pt x="1325054" y="1117997"/>
                </a:cubicBezTo>
                <a:cubicBezTo>
                  <a:pt x="1232666" y="1075135"/>
                  <a:pt x="1140279" y="1025129"/>
                  <a:pt x="1037231" y="1010841"/>
                </a:cubicBezTo>
                <a:cubicBezTo>
                  <a:pt x="1001698" y="1007269"/>
                  <a:pt x="980377" y="989409"/>
                  <a:pt x="983931" y="953690"/>
                </a:cubicBezTo>
                <a:cubicBezTo>
                  <a:pt x="991037" y="907256"/>
                  <a:pt x="1026571" y="921544"/>
                  <a:pt x="1054998" y="925115"/>
                </a:cubicBezTo>
                <a:cubicBezTo>
                  <a:pt x="1072765" y="928688"/>
                  <a:pt x="1090532" y="939403"/>
                  <a:pt x="1108299" y="914400"/>
                </a:cubicBezTo>
                <a:cubicBezTo>
                  <a:pt x="692555" y="660797"/>
                  <a:pt x="472246" y="675085"/>
                  <a:pt x="6755" y="467915"/>
                </a:cubicBezTo>
                <a:cubicBezTo>
                  <a:pt x="109802" y="428625"/>
                  <a:pt x="184423" y="457200"/>
                  <a:pt x="255490" y="464344"/>
                </a:cubicBezTo>
                <a:cubicBezTo>
                  <a:pt x="433159" y="482203"/>
                  <a:pt x="323004" y="514350"/>
                  <a:pt x="500673" y="535781"/>
                </a:cubicBezTo>
                <a:cubicBezTo>
                  <a:pt x="585954" y="546497"/>
                  <a:pt x="664128" y="582216"/>
                  <a:pt x="760069" y="525066"/>
                </a:cubicBezTo>
                <a:cubicBezTo>
                  <a:pt x="824029" y="485775"/>
                  <a:pt x="927077" y="528637"/>
                  <a:pt x="1005251" y="560785"/>
                </a:cubicBezTo>
                <a:cubicBezTo>
                  <a:pt x="1069212" y="589360"/>
                  <a:pt x="1133172" y="596503"/>
                  <a:pt x="1218453" y="560785"/>
                </a:cubicBezTo>
                <a:cubicBezTo>
                  <a:pt x="1140279" y="539354"/>
                  <a:pt x="1079872" y="521494"/>
                  <a:pt x="1019464" y="507206"/>
                </a:cubicBezTo>
                <a:cubicBezTo>
                  <a:pt x="969717" y="496491"/>
                  <a:pt x="941290" y="471488"/>
                  <a:pt x="944844" y="417909"/>
                </a:cubicBezTo>
                <a:cubicBezTo>
                  <a:pt x="944844" y="389334"/>
                  <a:pt x="934184" y="350044"/>
                  <a:pt x="969717" y="335757"/>
                </a:cubicBezTo>
                <a:cubicBezTo>
                  <a:pt x="998144" y="321469"/>
                  <a:pt x="1037231" y="335757"/>
                  <a:pt x="1051445" y="360759"/>
                </a:cubicBezTo>
                <a:cubicBezTo>
                  <a:pt x="1069212" y="407194"/>
                  <a:pt x="1086978" y="450056"/>
                  <a:pt x="1147386" y="453629"/>
                </a:cubicBezTo>
                <a:cubicBezTo>
                  <a:pt x="1229113" y="460771"/>
                  <a:pt x="1182919" y="432197"/>
                  <a:pt x="1168706" y="396478"/>
                </a:cubicBezTo>
                <a:cubicBezTo>
                  <a:pt x="1154492" y="357188"/>
                  <a:pt x="1197133" y="346472"/>
                  <a:pt x="1225560" y="353615"/>
                </a:cubicBezTo>
                <a:cubicBezTo>
                  <a:pt x="1332161" y="385763"/>
                  <a:pt x="1442315" y="328613"/>
                  <a:pt x="1552469" y="375047"/>
                </a:cubicBezTo>
                <a:cubicBezTo>
                  <a:pt x="1524043" y="260747"/>
                  <a:pt x="1463635" y="210741"/>
                  <a:pt x="1335714" y="192881"/>
                </a:cubicBezTo>
                <a:cubicBezTo>
                  <a:pt x="1289520" y="189310"/>
                  <a:pt x="1239773" y="196453"/>
                  <a:pt x="1197133" y="164306"/>
                </a:cubicBezTo>
                <a:cubicBezTo>
                  <a:pt x="1172259" y="146447"/>
                  <a:pt x="1147386" y="125016"/>
                  <a:pt x="1165153" y="89297"/>
                </a:cubicBezTo>
                <a:cubicBezTo>
                  <a:pt x="1175813" y="64294"/>
                  <a:pt x="1204239" y="64294"/>
                  <a:pt x="1229113" y="71437"/>
                </a:cubicBezTo>
                <a:cubicBezTo>
                  <a:pt x="1332161" y="110728"/>
                  <a:pt x="1442315" y="121444"/>
                  <a:pt x="1548916" y="135731"/>
                </a:cubicBezTo>
                <a:cubicBezTo>
                  <a:pt x="1566683" y="139303"/>
                  <a:pt x="1584450" y="146447"/>
                  <a:pt x="1602217" y="110728"/>
                </a:cubicBezTo>
                <a:cubicBezTo>
                  <a:pt x="1477849" y="78581"/>
                  <a:pt x="1357034" y="35719"/>
                  <a:pt x="1232666" y="0"/>
                </a:cubicBezTo>
                <a:close/>
              </a:path>
            </a:pathLst>
          </a:custGeom>
          <a:solidFill>
            <a:schemeClr val="accent1">
              <a:alpha val="20000"/>
            </a:schemeClr>
          </a:solidFill>
          <a:ln w="32707" cap="flat">
            <a:noFill/>
            <a:prstDash val="solid"/>
            <a:miter/>
          </a:ln>
        </p:spPr>
        <p:txBody>
          <a:bodyPr rtlCol="0" anchor="ctr"/>
          <a:lstStyle/>
          <a:p>
            <a:endParaRPr lang="en-US">
              <a:solidFill>
                <a:prstClr val="black"/>
              </a:solidFill>
            </a:endParaRPr>
          </a:p>
        </p:txBody>
      </p:sp>
      <p:sp>
        <p:nvSpPr>
          <p:cNvPr id="2" name="Title 1">
            <a:extLst>
              <a:ext uri="{FF2B5EF4-FFF2-40B4-BE49-F238E27FC236}">
                <a16:creationId xmlns:a16="http://schemas.microsoft.com/office/drawing/2014/main" id="{146AD042-DE90-4088-8A07-B9A64C2CE03E}"/>
              </a:ext>
            </a:extLst>
          </p:cNvPr>
          <p:cNvSpPr>
            <a:spLocks noGrp="1"/>
          </p:cNvSpPr>
          <p:nvPr>
            <p:ph type="title"/>
          </p:nvPr>
        </p:nvSpPr>
        <p:spPr>
          <a:xfrm>
            <a:off x="839788" y="640080"/>
            <a:ext cx="3886200" cy="2953512"/>
          </a:xfrm>
        </p:spPr>
        <p:txBody>
          <a:bodyPr anchor="b"/>
          <a:lstStyle>
            <a:lvl1pPr>
              <a:defRPr sz="32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BF2FFC98-62A0-445A-BEDA-785BE925A1D8}"/>
              </a:ext>
            </a:extLst>
          </p:cNvPr>
          <p:cNvSpPr>
            <a:spLocks noGrp="1"/>
          </p:cNvSpPr>
          <p:nvPr>
            <p:ph idx="1"/>
          </p:nvPr>
        </p:nvSpPr>
        <p:spPr>
          <a:xfrm>
            <a:off x="7059168" y="640080"/>
            <a:ext cx="4489704" cy="5596128"/>
          </a:xfrm>
        </p:spPr>
        <p:txBody>
          <a:bodyPr anchor="ct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a:extLst>
              <a:ext uri="{FF2B5EF4-FFF2-40B4-BE49-F238E27FC236}">
                <a16:creationId xmlns:a16="http://schemas.microsoft.com/office/drawing/2014/main" id="{DB4D7827-8489-4EE4-88EE-16685FE6DE8A}"/>
              </a:ext>
            </a:extLst>
          </p:cNvPr>
          <p:cNvSpPr>
            <a:spLocks noGrp="1"/>
          </p:cNvSpPr>
          <p:nvPr>
            <p:ph type="body" sz="half" idx="2"/>
          </p:nvPr>
        </p:nvSpPr>
        <p:spPr>
          <a:xfrm>
            <a:off x="839788" y="3776472"/>
            <a:ext cx="3886200" cy="2468880"/>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C33534F-EA91-4A50-B0F6-10D689E458EF}"/>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6C20F3F7-8B4B-4015-AA9C-109D05B2F146}"/>
              </a:ext>
            </a:extLst>
          </p:cNvPr>
          <p:cNvSpPr>
            <a:spLocks noGrp="1"/>
          </p:cNvSpPr>
          <p:nvPr>
            <p:ph type="ftr" sz="quarter" idx="11"/>
          </p:nvPr>
        </p:nvSpPr>
        <p:spPr/>
        <p:txBody>
          <a:bodyPr/>
          <a:lstStyle>
            <a:lvl1pPr algn="l">
              <a:defRPr/>
            </a:lvl1p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910B6EE2-78A1-4D01-87BE-A1487FBD271F}"/>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450608310"/>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8" name="Graphic 1" descr="Tag=AccentColor&#10;Flavor=Light&#10;Target=Fill">
            <a:extLst>
              <a:ext uri="{FF2B5EF4-FFF2-40B4-BE49-F238E27FC236}">
                <a16:creationId xmlns:a16="http://schemas.microsoft.com/office/drawing/2014/main" id="{0EE21C0F-70D8-4F3C-9392-07559C90EE6E}"/>
              </a:ext>
            </a:extLst>
          </p:cNvPr>
          <p:cNvSpPr/>
          <p:nvPr/>
        </p:nvSpPr>
        <p:spPr>
          <a:xfrm rot="10800000" flipH="1" flipV="1">
            <a:off x="684965" y="1332237"/>
            <a:ext cx="5263732" cy="3841102"/>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solidFill>
                <a:prstClr val="black"/>
              </a:solidFill>
            </a:endParaRPr>
          </a:p>
        </p:txBody>
      </p:sp>
      <p:sp>
        <p:nvSpPr>
          <p:cNvPr id="2" name="Title 1">
            <a:extLst>
              <a:ext uri="{FF2B5EF4-FFF2-40B4-BE49-F238E27FC236}">
                <a16:creationId xmlns:a16="http://schemas.microsoft.com/office/drawing/2014/main" id="{48DB1DFE-8154-440D-93CF-FEF7860E897F}"/>
              </a:ext>
            </a:extLst>
          </p:cNvPr>
          <p:cNvSpPr>
            <a:spLocks noGrp="1"/>
          </p:cNvSpPr>
          <p:nvPr>
            <p:ph type="title"/>
          </p:nvPr>
        </p:nvSpPr>
        <p:spPr>
          <a:xfrm>
            <a:off x="1399032" y="2523744"/>
            <a:ext cx="3831336" cy="1453896"/>
          </a:xfrm>
        </p:spPr>
        <p:txBody>
          <a:bodyPr anchor="b"/>
          <a:lstStyle>
            <a:lvl1pPr algn="ctr">
              <a:defRPr sz="3200"/>
            </a:lvl1pPr>
          </a:lstStyle>
          <a:p>
            <a:r>
              <a:rPr lang="en-US"/>
              <a:t>Click to edit Master title style</a:t>
            </a:r>
            <a:endParaRPr lang="en-US" dirty="0"/>
          </a:p>
        </p:txBody>
      </p:sp>
      <p:sp>
        <p:nvSpPr>
          <p:cNvPr id="3" name="Picture Placeholder 2">
            <a:extLst>
              <a:ext uri="{FF2B5EF4-FFF2-40B4-BE49-F238E27FC236}">
                <a16:creationId xmlns:a16="http://schemas.microsoft.com/office/drawing/2014/main" id="{9CD9D1F5-05CC-48F3-A314-315EF1703043}"/>
              </a:ext>
            </a:extLst>
          </p:cNvPr>
          <p:cNvSpPr>
            <a:spLocks noGrp="1"/>
          </p:cNvSpPr>
          <p:nvPr>
            <p:ph type="pic" idx="1"/>
          </p:nvPr>
        </p:nvSpPr>
        <p:spPr>
          <a:xfrm>
            <a:off x="6711696" y="640079"/>
            <a:ext cx="4837176" cy="5568696"/>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a:extLst>
              <a:ext uri="{FF2B5EF4-FFF2-40B4-BE49-F238E27FC236}">
                <a16:creationId xmlns:a16="http://schemas.microsoft.com/office/drawing/2014/main" id="{211807DE-1178-4BBB-89D8-9046239C2DE9}"/>
              </a:ext>
            </a:extLst>
          </p:cNvPr>
          <p:cNvSpPr>
            <a:spLocks noGrp="1"/>
          </p:cNvSpPr>
          <p:nvPr>
            <p:ph type="body" sz="half" idx="2"/>
          </p:nvPr>
        </p:nvSpPr>
        <p:spPr>
          <a:xfrm>
            <a:off x="1655064" y="4087368"/>
            <a:ext cx="3319272" cy="649224"/>
          </a:xfrm>
        </p:spPr>
        <p:txBody>
          <a:bodyPr>
            <a:noAutofit/>
          </a:bodyPr>
          <a:lstStyle>
            <a:lvl1pPr marL="0" indent="0" algn="ctr">
              <a:buNone/>
              <a:defRPr sz="2000" cap="all" baseline="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D48EA59-A1BC-48B7-9495-6D5C6035B14B}"/>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6" name="Footer Placeholder 5">
            <a:extLst>
              <a:ext uri="{FF2B5EF4-FFF2-40B4-BE49-F238E27FC236}">
                <a16:creationId xmlns:a16="http://schemas.microsoft.com/office/drawing/2014/main" id="{49F85A72-B50F-440E-AAD3-53C099F6D9B6}"/>
              </a:ext>
            </a:extLst>
          </p:cNvPr>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a:extLst>
              <a:ext uri="{FF2B5EF4-FFF2-40B4-BE49-F238E27FC236}">
                <a16:creationId xmlns:a16="http://schemas.microsoft.com/office/drawing/2014/main" id="{72C2D00B-4207-4720-8C68-605CAFDD5CA2}"/>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717185979"/>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1C888B-58B8-4428-8B1D-4E26FC5DD59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314F67B-D516-42FA-A2CA-2DCD37CFE8D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82BA5FF-4919-4FF8-9C04-06CE156B762F}"/>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CBEDA970-128E-4150-8E5A-A1B056E83502}"/>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EAEC6CD1-EE5E-42EF-B76D-BB803BA6AB5E}"/>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135014818"/>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50C2A1B-34CA-4877-9435-D77DF325757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F255E5E-4A81-44CC-8D99-F56E625D463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19CEECF-A221-4ECC-AD9C-E197D516D24C}"/>
              </a:ext>
            </a:extLst>
          </p:cNvPr>
          <p:cNvSpPr>
            <a:spLocks noGrp="1"/>
          </p:cNvSpPr>
          <p:nvPr>
            <p:ph type="dt" sz="half" idx="10"/>
          </p:nvPr>
        </p:nvSpPr>
        <p:spPr/>
        <p:txBody>
          <a:body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018F41AE-0DDE-49ED-9F0C-E0E16F599A0E}"/>
              </a:ext>
            </a:extLst>
          </p:cNvPr>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B7B47FB7-77F0-4C43-B81E-D04B31C953DA}"/>
              </a:ext>
            </a:extLst>
          </p:cNvPr>
          <p:cNvSpPr>
            <a:spLocks noGrp="1"/>
          </p:cNvSpPr>
          <p:nvPr>
            <p:ph type="sldNum" sz="quarter" idx="12"/>
          </p:nvPr>
        </p:nvSpPr>
        <p:spPr/>
        <p:txBody>
          <a:body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8574533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Freeform: Shape 7" descr="Tag=AccentColor&#10;Flavor=Light&#10;Target=Fill">
            <a:extLst>
              <a:ext uri="{FF2B5EF4-FFF2-40B4-BE49-F238E27FC236}">
                <a16:creationId xmlns:a16="http://schemas.microsoft.com/office/drawing/2014/main" id="{FD51F360-8860-4FB5-A0A5-773473DD8B39}"/>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a:p>
        </p:txBody>
      </p:sp>
      <p:sp>
        <p:nvSpPr>
          <p:cNvPr id="2" name="Title 1">
            <a:extLst>
              <a:ext uri="{FF2B5EF4-FFF2-40B4-BE49-F238E27FC236}">
                <a16:creationId xmlns:a16="http://schemas.microsoft.com/office/drawing/2014/main" id="{D2A77EC9-372A-4ECA-9088-780532AF057F}"/>
              </a:ext>
            </a:extLst>
          </p:cNvPr>
          <p:cNvSpPr>
            <a:spLocks noGrp="1"/>
          </p:cNvSpPr>
          <p:nvPr>
            <p:ph type="title"/>
          </p:nvPr>
        </p:nvSpPr>
        <p:spPr/>
        <p:txBody>
          <a:bodyPr>
            <a:normAutofit/>
          </a:bodyPr>
          <a:lstStyle>
            <a:lvl1pPr>
              <a:defRPr sz="40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57C882CE-1B27-414A-9B06-AA5D2DB683BA}"/>
              </a:ext>
            </a:extLst>
          </p:cNvPr>
          <p:cNvSpPr>
            <a:spLocks noGrp="1"/>
          </p:cNvSpPr>
          <p:nvPr>
            <p:ph sz="half" idx="1"/>
          </p:nvPr>
        </p:nvSpPr>
        <p:spPr>
          <a:xfrm>
            <a:off x="838200" y="2011680"/>
            <a:ext cx="493776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a:extLst>
              <a:ext uri="{FF2B5EF4-FFF2-40B4-BE49-F238E27FC236}">
                <a16:creationId xmlns:a16="http://schemas.microsoft.com/office/drawing/2014/main" id="{A0397E60-5D92-4530-96D1-FC09AF3C2742}"/>
              </a:ext>
            </a:extLst>
          </p:cNvPr>
          <p:cNvSpPr>
            <a:spLocks noGrp="1"/>
          </p:cNvSpPr>
          <p:nvPr>
            <p:ph sz="half" idx="2"/>
          </p:nvPr>
        </p:nvSpPr>
        <p:spPr>
          <a:xfrm>
            <a:off x="6419088" y="2011680"/>
            <a:ext cx="4937760" cy="4160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a:extLst>
              <a:ext uri="{FF2B5EF4-FFF2-40B4-BE49-F238E27FC236}">
                <a16:creationId xmlns:a16="http://schemas.microsoft.com/office/drawing/2014/main" id="{034240FE-0C6A-47E9-9B0A-7B3C60877372}"/>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6" name="Footer Placeholder 5">
            <a:extLst>
              <a:ext uri="{FF2B5EF4-FFF2-40B4-BE49-F238E27FC236}">
                <a16:creationId xmlns:a16="http://schemas.microsoft.com/office/drawing/2014/main" id="{8671AE1B-BB18-4C7E-AA77-3A4D401A5F3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6FA7B1D-FEDD-4E29-A352-29E5F498B323}"/>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10565186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Freeform: Shape 9" descr="Tag=AccentColor&#10;Flavor=Light&#10;Target=Fill">
            <a:extLst>
              <a:ext uri="{FF2B5EF4-FFF2-40B4-BE49-F238E27FC236}">
                <a16:creationId xmlns:a16="http://schemas.microsoft.com/office/drawing/2014/main" id="{527D753D-3426-457C-9082-B92894509EC0}"/>
              </a:ext>
            </a:extLst>
          </p:cNvPr>
          <p:cNvSpPr/>
          <p:nvPr/>
        </p:nvSpPr>
        <p:spPr>
          <a:xfrm flipH="1">
            <a:off x="1" y="315111"/>
            <a:ext cx="3021543" cy="1435442"/>
          </a:xfrm>
          <a:custGeom>
            <a:avLst/>
            <a:gdLst>
              <a:gd name="connsiteX0" fmla="*/ 3021543 w 3021543"/>
              <a:gd name="connsiteY0" fmla="*/ 0 h 1435442"/>
              <a:gd name="connsiteX1" fmla="*/ 2963800 w 3021543"/>
              <a:gd name="connsiteY1" fmla="*/ 7242 h 1435442"/>
              <a:gd name="connsiteX2" fmla="*/ 2793803 w 3021543"/>
              <a:gd name="connsiteY2" fmla="*/ 24082 h 1435442"/>
              <a:gd name="connsiteX3" fmla="*/ 2414348 w 3021543"/>
              <a:gd name="connsiteY3" fmla="*/ 29696 h 1435442"/>
              <a:gd name="connsiteX4" fmla="*/ 2091558 w 3021543"/>
              <a:gd name="connsiteY4" fmla="*/ 27450 h 1435442"/>
              <a:gd name="connsiteX5" fmla="*/ 1645319 w 3021543"/>
              <a:gd name="connsiteY5" fmla="*/ 28573 h 1435442"/>
              <a:gd name="connsiteX6" fmla="*/ 1243602 w 3021543"/>
              <a:gd name="connsiteY6" fmla="*/ 60008 h 1435442"/>
              <a:gd name="connsiteX7" fmla="*/ 753851 w 3021543"/>
              <a:gd name="connsiteY7" fmla="*/ 57763 h 1435442"/>
              <a:gd name="connsiteX8" fmla="*/ 465465 w 3021543"/>
              <a:gd name="connsiteY8" fmla="*/ 116142 h 1435442"/>
              <a:gd name="connsiteX9" fmla="*/ 546416 w 3021543"/>
              <a:gd name="connsiteY9" fmla="*/ 136351 h 1435442"/>
              <a:gd name="connsiteX10" fmla="*/ 689091 w 3021543"/>
              <a:gd name="connsiteY10" fmla="*/ 180136 h 1435442"/>
              <a:gd name="connsiteX11" fmla="*/ 704269 w 3021543"/>
              <a:gd name="connsiteY11" fmla="*/ 208203 h 1435442"/>
              <a:gd name="connsiteX12" fmla="*/ 683020 w 3021543"/>
              <a:gd name="connsiteY12" fmla="*/ 221675 h 1435442"/>
              <a:gd name="connsiteX13" fmla="*/ 621295 w 3021543"/>
              <a:gd name="connsiteY13" fmla="*/ 247496 h 1435442"/>
              <a:gd name="connsiteX14" fmla="*/ 848968 w 3021543"/>
              <a:gd name="connsiteY14" fmla="*/ 285668 h 1435442"/>
              <a:gd name="connsiteX15" fmla="*/ 768018 w 3021543"/>
              <a:gd name="connsiteY15" fmla="*/ 309244 h 1435442"/>
              <a:gd name="connsiteX16" fmla="*/ 684032 w 3021543"/>
              <a:gd name="connsiteY16" fmla="*/ 326085 h 1435442"/>
              <a:gd name="connsiteX17" fmla="*/ 592962 w 3021543"/>
              <a:gd name="connsiteY17" fmla="*/ 338434 h 1435442"/>
              <a:gd name="connsiteX18" fmla="*/ 509988 w 3021543"/>
              <a:gd name="connsiteY18" fmla="*/ 363133 h 1435442"/>
              <a:gd name="connsiteX19" fmla="*/ 726531 w 3021543"/>
              <a:gd name="connsiteY19" fmla="*/ 373237 h 1435442"/>
              <a:gd name="connsiteX20" fmla="*/ 614212 w 3021543"/>
              <a:gd name="connsiteY20" fmla="*/ 395691 h 1435442"/>
              <a:gd name="connsiteX21" fmla="*/ 522131 w 3021543"/>
              <a:gd name="connsiteY21" fmla="*/ 424881 h 1435442"/>
              <a:gd name="connsiteX22" fmla="*/ 457370 w 3021543"/>
              <a:gd name="connsiteY22" fmla="*/ 438353 h 1435442"/>
              <a:gd name="connsiteX23" fmla="*/ 388562 w 3021543"/>
              <a:gd name="connsiteY23" fmla="*/ 441721 h 1435442"/>
              <a:gd name="connsiteX24" fmla="*/ 372372 w 3021543"/>
              <a:gd name="connsiteY24" fmla="*/ 463052 h 1435442"/>
              <a:gd name="connsiteX25" fmla="*/ 393622 w 3021543"/>
              <a:gd name="connsiteY25" fmla="*/ 485506 h 1435442"/>
              <a:gd name="connsiteX26" fmla="*/ 426002 w 3021543"/>
              <a:gd name="connsiteY26" fmla="*/ 487751 h 1435442"/>
              <a:gd name="connsiteX27" fmla="*/ 619271 w 3021543"/>
              <a:gd name="connsiteY27" fmla="*/ 493365 h 1435442"/>
              <a:gd name="connsiteX28" fmla="*/ 0 w 3021543"/>
              <a:gd name="connsiteY28" fmla="*/ 542762 h 1435442"/>
              <a:gd name="connsiteX29" fmla="*/ 83986 w 3021543"/>
              <a:gd name="connsiteY29" fmla="*/ 573075 h 1435442"/>
              <a:gd name="connsiteX30" fmla="*/ 112319 w 3021543"/>
              <a:gd name="connsiteY30" fmla="*/ 656154 h 1435442"/>
              <a:gd name="connsiteX31" fmla="*/ 215531 w 3021543"/>
              <a:gd name="connsiteY31" fmla="*/ 703306 h 1435442"/>
              <a:gd name="connsiteX32" fmla="*/ 282315 w 3021543"/>
              <a:gd name="connsiteY32" fmla="*/ 720147 h 1435442"/>
              <a:gd name="connsiteX33" fmla="*/ 435109 w 3021543"/>
              <a:gd name="connsiteY33" fmla="*/ 744846 h 1435442"/>
              <a:gd name="connsiteX34" fmla="*/ 457370 w 3021543"/>
              <a:gd name="connsiteY34" fmla="*/ 785263 h 1435442"/>
              <a:gd name="connsiteX35" fmla="*/ 476596 w 3021543"/>
              <a:gd name="connsiteY35" fmla="*/ 830170 h 1435442"/>
              <a:gd name="connsiteX36" fmla="*/ 517071 w 3021543"/>
              <a:gd name="connsiteY36" fmla="*/ 859360 h 1435442"/>
              <a:gd name="connsiteX37" fmla="*/ 202377 w 3021543"/>
              <a:gd name="connsiteY37" fmla="*/ 854869 h 1435442"/>
              <a:gd name="connsiteX38" fmla="*/ 557546 w 3021543"/>
              <a:gd name="connsiteY38" fmla="*/ 949175 h 1435442"/>
              <a:gd name="connsiteX39" fmla="*/ 526178 w 3021543"/>
              <a:gd name="connsiteY39" fmla="*/ 986223 h 1435442"/>
              <a:gd name="connsiteX40" fmla="*/ 720459 w 3021543"/>
              <a:gd name="connsiteY40" fmla="*/ 1036744 h 1435442"/>
              <a:gd name="connsiteX41" fmla="*/ 616236 w 3021543"/>
              <a:gd name="connsiteY41" fmla="*/ 1042357 h 1435442"/>
              <a:gd name="connsiteX42" fmla="*/ 1222353 w 3021543"/>
              <a:gd name="connsiteY42" fmla="*/ 1253422 h 1435442"/>
              <a:gd name="connsiteX43" fmla="*/ 2087511 w 3021543"/>
              <a:gd name="connsiteY43" fmla="*/ 1406107 h 1435442"/>
              <a:gd name="connsiteX44" fmla="*/ 2425479 w 3021543"/>
              <a:gd name="connsiteY44" fmla="*/ 1435297 h 1435442"/>
              <a:gd name="connsiteX45" fmla="*/ 2809994 w 3021543"/>
              <a:gd name="connsiteY45" fmla="*/ 1426315 h 1435442"/>
              <a:gd name="connsiteX46" fmla="*/ 2953618 w 3021543"/>
              <a:gd name="connsiteY46" fmla="*/ 1417071 h 1435442"/>
              <a:gd name="connsiteX47" fmla="*/ 3021543 w 3021543"/>
              <a:gd name="connsiteY47" fmla="*/ 1407897 h 1435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3021543" h="1435442">
                <a:moveTo>
                  <a:pt x="3021543" y="0"/>
                </a:moveTo>
                <a:lnTo>
                  <a:pt x="2963800" y="7242"/>
                </a:lnTo>
                <a:cubicBezTo>
                  <a:pt x="2907134" y="13978"/>
                  <a:pt x="2850469" y="22960"/>
                  <a:pt x="2793803" y="24082"/>
                </a:cubicBezTo>
                <a:cubicBezTo>
                  <a:pt x="2667318" y="27450"/>
                  <a:pt x="2539821" y="19592"/>
                  <a:pt x="2414348" y="29696"/>
                </a:cubicBezTo>
                <a:cubicBezTo>
                  <a:pt x="2307089" y="38677"/>
                  <a:pt x="2198818" y="28573"/>
                  <a:pt x="2091558" y="27450"/>
                </a:cubicBezTo>
                <a:cubicBezTo>
                  <a:pt x="1942812" y="26328"/>
                  <a:pt x="1793053" y="18469"/>
                  <a:pt x="1645319" y="28573"/>
                </a:cubicBezTo>
                <a:cubicBezTo>
                  <a:pt x="1510738" y="36432"/>
                  <a:pt x="1376158" y="38677"/>
                  <a:pt x="1243602" y="60008"/>
                </a:cubicBezTo>
                <a:cubicBezTo>
                  <a:pt x="1079677" y="71235"/>
                  <a:pt x="916765" y="64499"/>
                  <a:pt x="753851" y="57763"/>
                </a:cubicBezTo>
                <a:cubicBezTo>
                  <a:pt x="653675" y="53272"/>
                  <a:pt x="554511" y="38677"/>
                  <a:pt x="465465" y="116142"/>
                </a:cubicBezTo>
                <a:cubicBezTo>
                  <a:pt x="489751" y="134105"/>
                  <a:pt x="519095" y="130737"/>
                  <a:pt x="546416" y="136351"/>
                </a:cubicBezTo>
                <a:cubicBezTo>
                  <a:pt x="594986" y="147578"/>
                  <a:pt x="643557" y="158804"/>
                  <a:pt x="689091" y="180136"/>
                </a:cubicBezTo>
                <a:cubicBezTo>
                  <a:pt x="699210" y="184626"/>
                  <a:pt x="708317" y="193608"/>
                  <a:pt x="704269" y="208203"/>
                </a:cubicBezTo>
                <a:cubicBezTo>
                  <a:pt x="701234" y="219430"/>
                  <a:pt x="691115" y="219430"/>
                  <a:pt x="683020" y="221675"/>
                </a:cubicBezTo>
                <a:cubicBezTo>
                  <a:pt x="664806" y="228411"/>
                  <a:pt x="642545" y="223920"/>
                  <a:pt x="621295" y="247496"/>
                </a:cubicBezTo>
                <a:cubicBezTo>
                  <a:pt x="702245" y="259846"/>
                  <a:pt x="780160" y="236270"/>
                  <a:pt x="848968" y="285668"/>
                </a:cubicBezTo>
                <a:cubicBezTo>
                  <a:pt x="823671" y="310367"/>
                  <a:pt x="795339" y="304753"/>
                  <a:pt x="768018" y="309244"/>
                </a:cubicBezTo>
                <a:cubicBezTo>
                  <a:pt x="739685" y="313735"/>
                  <a:pt x="712365" y="321594"/>
                  <a:pt x="684032" y="326085"/>
                </a:cubicBezTo>
                <a:cubicBezTo>
                  <a:pt x="653675" y="331698"/>
                  <a:pt x="623319" y="332821"/>
                  <a:pt x="592962" y="338434"/>
                </a:cubicBezTo>
                <a:cubicBezTo>
                  <a:pt x="567666" y="342925"/>
                  <a:pt x="540345" y="335066"/>
                  <a:pt x="509988" y="363133"/>
                </a:cubicBezTo>
                <a:cubicBezTo>
                  <a:pt x="584867" y="383342"/>
                  <a:pt x="652663" y="353029"/>
                  <a:pt x="726531" y="373237"/>
                </a:cubicBezTo>
                <a:cubicBezTo>
                  <a:pt x="683020" y="391200"/>
                  <a:pt x="647604" y="385587"/>
                  <a:pt x="614212" y="395691"/>
                </a:cubicBezTo>
                <a:cubicBezTo>
                  <a:pt x="583855" y="405795"/>
                  <a:pt x="547428" y="394568"/>
                  <a:pt x="522131" y="424881"/>
                </a:cubicBezTo>
                <a:cubicBezTo>
                  <a:pt x="502905" y="448457"/>
                  <a:pt x="482668" y="451825"/>
                  <a:pt x="457370" y="438353"/>
                </a:cubicBezTo>
                <a:cubicBezTo>
                  <a:pt x="435109" y="426003"/>
                  <a:pt x="410824" y="429371"/>
                  <a:pt x="388562" y="441721"/>
                </a:cubicBezTo>
                <a:cubicBezTo>
                  <a:pt x="380468" y="446212"/>
                  <a:pt x="372372" y="451825"/>
                  <a:pt x="372372" y="463052"/>
                </a:cubicBezTo>
                <a:cubicBezTo>
                  <a:pt x="372372" y="478770"/>
                  <a:pt x="382491" y="483260"/>
                  <a:pt x="393622" y="485506"/>
                </a:cubicBezTo>
                <a:cubicBezTo>
                  <a:pt x="403741" y="487751"/>
                  <a:pt x="415883" y="489997"/>
                  <a:pt x="426002" y="487751"/>
                </a:cubicBezTo>
                <a:cubicBezTo>
                  <a:pt x="490762" y="475402"/>
                  <a:pt x="554511" y="495610"/>
                  <a:pt x="619271" y="493365"/>
                </a:cubicBezTo>
                <a:cubicBezTo>
                  <a:pt x="415883" y="541640"/>
                  <a:pt x="210471" y="525922"/>
                  <a:pt x="0" y="542762"/>
                </a:cubicBezTo>
                <a:cubicBezTo>
                  <a:pt x="27321" y="576443"/>
                  <a:pt x="62737" y="548376"/>
                  <a:pt x="83986" y="573075"/>
                </a:cubicBezTo>
                <a:cubicBezTo>
                  <a:pt x="63748" y="624719"/>
                  <a:pt x="71844" y="652785"/>
                  <a:pt x="112319" y="656154"/>
                </a:cubicBezTo>
                <a:cubicBezTo>
                  <a:pt x="151782" y="659522"/>
                  <a:pt x="194281" y="641559"/>
                  <a:pt x="215531" y="703306"/>
                </a:cubicBezTo>
                <a:cubicBezTo>
                  <a:pt x="221602" y="722392"/>
                  <a:pt x="259042" y="716779"/>
                  <a:pt x="282315" y="720147"/>
                </a:cubicBezTo>
                <a:cubicBezTo>
                  <a:pt x="332909" y="728005"/>
                  <a:pt x="386539" y="720147"/>
                  <a:pt x="435109" y="744846"/>
                </a:cubicBezTo>
                <a:cubicBezTo>
                  <a:pt x="454335" y="753827"/>
                  <a:pt x="467489" y="760563"/>
                  <a:pt x="457370" y="785263"/>
                </a:cubicBezTo>
                <a:cubicBezTo>
                  <a:pt x="447252" y="811084"/>
                  <a:pt x="460406" y="820066"/>
                  <a:pt x="476596" y="830170"/>
                </a:cubicBezTo>
                <a:cubicBezTo>
                  <a:pt x="488739" y="838028"/>
                  <a:pt x="506953" y="835783"/>
                  <a:pt x="517071" y="859360"/>
                </a:cubicBezTo>
                <a:cubicBezTo>
                  <a:pt x="410824" y="855992"/>
                  <a:pt x="307612" y="836906"/>
                  <a:pt x="202377" y="854869"/>
                </a:cubicBezTo>
                <a:cubicBezTo>
                  <a:pt x="317731" y="899776"/>
                  <a:pt x="444216" y="897531"/>
                  <a:pt x="557546" y="949175"/>
                </a:cubicBezTo>
                <a:cubicBezTo>
                  <a:pt x="553499" y="967137"/>
                  <a:pt x="527190" y="959278"/>
                  <a:pt x="526178" y="986223"/>
                </a:cubicBezTo>
                <a:cubicBezTo>
                  <a:pt x="585879" y="1014290"/>
                  <a:pt x="657723" y="995204"/>
                  <a:pt x="720459" y="1036744"/>
                </a:cubicBezTo>
                <a:cubicBezTo>
                  <a:pt x="684032" y="1055829"/>
                  <a:pt x="650640" y="1024394"/>
                  <a:pt x="616236" y="1042357"/>
                </a:cubicBezTo>
                <a:cubicBezTo>
                  <a:pt x="627367" y="1069302"/>
                  <a:pt x="1131283" y="1235459"/>
                  <a:pt x="1222353" y="1253422"/>
                </a:cubicBezTo>
                <a:cubicBezTo>
                  <a:pt x="1407527" y="1290470"/>
                  <a:pt x="1940788" y="1384776"/>
                  <a:pt x="2087511" y="1406107"/>
                </a:cubicBezTo>
                <a:cubicBezTo>
                  <a:pt x="2200841" y="1421824"/>
                  <a:pt x="2313160" y="1434174"/>
                  <a:pt x="2425479" y="1435297"/>
                </a:cubicBezTo>
                <a:cubicBezTo>
                  <a:pt x="2553988" y="1436419"/>
                  <a:pt x="2681485" y="1430806"/>
                  <a:pt x="2809994" y="1426315"/>
                </a:cubicBezTo>
                <a:cubicBezTo>
                  <a:pt x="2858058" y="1424631"/>
                  <a:pt x="2905933" y="1421684"/>
                  <a:pt x="2953618" y="1417071"/>
                </a:cubicBezTo>
                <a:lnTo>
                  <a:pt x="3021543" y="1407897"/>
                </a:lnTo>
                <a:close/>
              </a:path>
            </a:pathLst>
          </a:custGeom>
          <a:solidFill>
            <a:schemeClr val="accent1">
              <a:alpha val="20000"/>
            </a:schemeClr>
          </a:solidFill>
          <a:ln w="32707" cap="flat">
            <a:noFill/>
            <a:prstDash val="solid"/>
            <a:miter/>
          </a:ln>
        </p:spPr>
        <p:txBody>
          <a:bodyPr wrap="square" rtlCol="0" anchor="ctr">
            <a:noAutofit/>
          </a:bodyPr>
          <a:lstStyle/>
          <a:p>
            <a:endParaRPr lang="en-US"/>
          </a:p>
        </p:txBody>
      </p:sp>
      <p:sp>
        <p:nvSpPr>
          <p:cNvPr id="2" name="Title 1">
            <a:extLst>
              <a:ext uri="{FF2B5EF4-FFF2-40B4-BE49-F238E27FC236}">
                <a16:creationId xmlns:a16="http://schemas.microsoft.com/office/drawing/2014/main" id="{164D2B94-0682-4185-BCE3-89AF214A4FA8}"/>
              </a:ext>
            </a:extLst>
          </p:cNvPr>
          <p:cNvSpPr>
            <a:spLocks noGrp="1"/>
          </p:cNvSpPr>
          <p:nvPr>
            <p:ph type="title"/>
          </p:nvPr>
        </p:nvSpPr>
        <p:spPr>
          <a:xfrm>
            <a:off x="839788" y="365125"/>
            <a:ext cx="10515600" cy="1325563"/>
          </a:xfrm>
        </p:spPr>
        <p:txBody>
          <a:bodyPr>
            <a:normAutofit/>
          </a:bodyPr>
          <a:lstStyle>
            <a:lvl1pPr>
              <a:defRPr sz="4000"/>
            </a:lvl1p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8D65C47E-B85E-4B3E-A669-DEEC7F5DF2FB}"/>
              </a:ext>
            </a:extLst>
          </p:cNvPr>
          <p:cNvSpPr>
            <a:spLocks noGrp="1"/>
          </p:cNvSpPr>
          <p:nvPr>
            <p:ph type="body" idx="1"/>
          </p:nvPr>
        </p:nvSpPr>
        <p:spPr>
          <a:xfrm>
            <a:off x="839788" y="2011680"/>
            <a:ext cx="4937760" cy="950976"/>
          </a:xfrm>
        </p:spPr>
        <p:txBody>
          <a:bodyPr anchor="b">
            <a:normAutofit/>
          </a:bodyPr>
          <a:lstStyle>
            <a:lvl1pPr marL="0" indent="0">
              <a:buNone/>
              <a:defRPr sz="28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324517F-FE8C-49AD-9A52-0F4301052699}"/>
              </a:ext>
            </a:extLst>
          </p:cNvPr>
          <p:cNvSpPr>
            <a:spLocks noGrp="1"/>
          </p:cNvSpPr>
          <p:nvPr>
            <p:ph sz="half" idx="2"/>
          </p:nvPr>
        </p:nvSpPr>
        <p:spPr>
          <a:xfrm>
            <a:off x="839788" y="3127248"/>
            <a:ext cx="4937760" cy="30632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a:extLst>
              <a:ext uri="{FF2B5EF4-FFF2-40B4-BE49-F238E27FC236}">
                <a16:creationId xmlns:a16="http://schemas.microsoft.com/office/drawing/2014/main" id="{C80C73EC-7117-4DC2-9075-14102F2E282B}"/>
              </a:ext>
            </a:extLst>
          </p:cNvPr>
          <p:cNvSpPr>
            <a:spLocks noGrp="1"/>
          </p:cNvSpPr>
          <p:nvPr>
            <p:ph type="body" sz="quarter" idx="3"/>
          </p:nvPr>
        </p:nvSpPr>
        <p:spPr>
          <a:xfrm>
            <a:off x="6419088" y="2011680"/>
            <a:ext cx="4937760" cy="950976"/>
          </a:xfrm>
        </p:spPr>
        <p:txBody>
          <a:bodyPr anchor="b">
            <a:normAutofit/>
          </a:bodyPr>
          <a:lstStyle>
            <a:lvl1pPr marL="0" indent="0">
              <a:buNone/>
              <a:defRPr sz="28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DD9A323-865B-4177-8F98-9BA304E022E0}"/>
              </a:ext>
            </a:extLst>
          </p:cNvPr>
          <p:cNvSpPr>
            <a:spLocks noGrp="1"/>
          </p:cNvSpPr>
          <p:nvPr>
            <p:ph sz="quarter" idx="4"/>
          </p:nvPr>
        </p:nvSpPr>
        <p:spPr>
          <a:xfrm>
            <a:off x="6419088" y="3127248"/>
            <a:ext cx="4937760" cy="30632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a:extLst>
              <a:ext uri="{FF2B5EF4-FFF2-40B4-BE49-F238E27FC236}">
                <a16:creationId xmlns:a16="http://schemas.microsoft.com/office/drawing/2014/main" id="{2AA4E5D6-7075-4584-BD43-D966F0B58E6D}"/>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8" name="Footer Placeholder 7">
            <a:extLst>
              <a:ext uri="{FF2B5EF4-FFF2-40B4-BE49-F238E27FC236}">
                <a16:creationId xmlns:a16="http://schemas.microsoft.com/office/drawing/2014/main" id="{8C38B83D-8A05-4F3C-A409-1602C963075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AD250E7-8A73-449C-A140-A2A2582D7F33}"/>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30828987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Graphic 1" descr="Tag=AccentColor&#10;Flavor=Light&#10;Target=Fill">
            <a:extLst>
              <a:ext uri="{FF2B5EF4-FFF2-40B4-BE49-F238E27FC236}">
                <a16:creationId xmlns:a16="http://schemas.microsoft.com/office/drawing/2014/main" id="{AAFBE1F6-FC6D-4C3D-9AC3-97028E6F18C7}"/>
              </a:ext>
            </a:extLst>
          </p:cNvPr>
          <p:cNvSpPr/>
          <p:nvPr/>
        </p:nvSpPr>
        <p:spPr>
          <a:xfrm rot="10800000" flipV="1">
            <a:off x="1969639" y="181596"/>
            <a:ext cx="8252722" cy="6022258"/>
          </a:xfrm>
          <a:custGeom>
            <a:avLst/>
            <a:gdLst>
              <a:gd name="connsiteX0" fmla="*/ 5458905 w 6886274"/>
              <a:gd name="connsiteY0" fmla="*/ 754119 h 5025119"/>
              <a:gd name="connsiteX1" fmla="*/ 3455557 w 6886274"/>
              <a:gd name="connsiteY1" fmla="*/ 1027709 h 5025119"/>
              <a:gd name="connsiteX2" fmla="*/ 3338677 w 6886274"/>
              <a:gd name="connsiteY2" fmla="*/ 1021381 h 5025119"/>
              <a:gd name="connsiteX3" fmla="*/ 2518280 w 6886274"/>
              <a:gd name="connsiteY3" fmla="*/ 980435 h 5025119"/>
              <a:gd name="connsiteX4" fmla="*/ 1673687 w 6886274"/>
              <a:gd name="connsiteY4" fmla="*/ 739229 h 5025119"/>
              <a:gd name="connsiteX5" fmla="*/ 1183459 w 6886274"/>
              <a:gd name="connsiteY5" fmla="*/ 397149 h 5025119"/>
              <a:gd name="connsiteX6" fmla="*/ 977987 w 6886274"/>
              <a:gd name="connsiteY6" fmla="*/ 241184 h 5025119"/>
              <a:gd name="connsiteX7" fmla="*/ 788150 w 6886274"/>
              <a:gd name="connsiteY7" fmla="*/ 66980 h 5025119"/>
              <a:gd name="connsiteX8" fmla="*/ 721148 w 6886274"/>
              <a:gd name="connsiteY8" fmla="*/ 31990 h 5025119"/>
              <a:gd name="connsiteX9" fmla="*/ 701792 w 6886274"/>
              <a:gd name="connsiteY9" fmla="*/ 32362 h 5025119"/>
              <a:gd name="connsiteX10" fmla="*/ 686530 w 6886274"/>
              <a:gd name="connsiteY10" fmla="*/ 43157 h 5025119"/>
              <a:gd name="connsiteX11" fmla="*/ 693603 w 6886274"/>
              <a:gd name="connsiteY11" fmla="*/ 58046 h 5025119"/>
              <a:gd name="connsiteX12" fmla="*/ 705886 w 6886274"/>
              <a:gd name="connsiteY12" fmla="*/ 65491 h 5025119"/>
              <a:gd name="connsiteX13" fmla="*/ 762838 w 6886274"/>
              <a:gd name="connsiteY13" fmla="*/ 112764 h 5025119"/>
              <a:gd name="connsiteX14" fmla="*/ 764327 w 6886274"/>
              <a:gd name="connsiteY14" fmla="*/ 140309 h 5025119"/>
              <a:gd name="connsiteX15" fmla="*/ 775121 w 6886274"/>
              <a:gd name="connsiteY15" fmla="*/ 159666 h 5025119"/>
              <a:gd name="connsiteX16" fmla="*/ 823139 w 6886274"/>
              <a:gd name="connsiteY16" fmla="*/ 176416 h 5025119"/>
              <a:gd name="connsiteX17" fmla="*/ 707748 w 6886274"/>
              <a:gd name="connsiteY17" fmla="*/ 109414 h 5025119"/>
              <a:gd name="connsiteX18" fmla="*/ 681319 w 6886274"/>
              <a:gd name="connsiteY18" fmla="*/ 69958 h 5025119"/>
              <a:gd name="connsiteX19" fmla="*/ 640746 w 6886274"/>
              <a:gd name="connsiteY19" fmla="*/ 67352 h 5025119"/>
              <a:gd name="connsiteX20" fmla="*/ 614318 w 6886274"/>
              <a:gd name="connsiteY20" fmla="*/ 61396 h 5025119"/>
              <a:gd name="connsiteX21" fmla="*/ 560716 w 6886274"/>
              <a:gd name="connsiteY21" fmla="*/ 3701 h 5025119"/>
              <a:gd name="connsiteX22" fmla="*/ 540616 w 6886274"/>
              <a:gd name="connsiteY22" fmla="*/ 3701 h 5025119"/>
              <a:gd name="connsiteX23" fmla="*/ 543594 w 6886274"/>
              <a:gd name="connsiteY23" fmla="*/ 21940 h 5025119"/>
              <a:gd name="connsiteX24" fmla="*/ 558855 w 6886274"/>
              <a:gd name="connsiteY24" fmla="*/ 51346 h 5025119"/>
              <a:gd name="connsiteX25" fmla="*/ 557366 w 6886274"/>
              <a:gd name="connsiteY25" fmla="*/ 72563 h 5025119"/>
              <a:gd name="connsiteX26" fmla="*/ 570022 w 6886274"/>
              <a:gd name="connsiteY26" fmla="*/ 120209 h 5025119"/>
              <a:gd name="connsiteX27" fmla="*/ 599801 w 6886274"/>
              <a:gd name="connsiteY27" fmla="*/ 192794 h 5025119"/>
              <a:gd name="connsiteX28" fmla="*/ 614318 w 6886274"/>
              <a:gd name="connsiteY28" fmla="*/ 212150 h 5025119"/>
              <a:gd name="connsiteX29" fmla="*/ 623996 w 6886274"/>
              <a:gd name="connsiteY29" fmla="*/ 220711 h 5025119"/>
              <a:gd name="connsiteX30" fmla="*/ 821278 w 6886274"/>
              <a:gd name="connsiteY30" fmla="*/ 503235 h 5025119"/>
              <a:gd name="connsiteX31" fmla="*/ 1033822 w 6886274"/>
              <a:gd name="connsiteY31" fmla="*/ 694562 h 5025119"/>
              <a:gd name="connsiteX32" fmla="*/ 1039406 w 6886274"/>
              <a:gd name="connsiteY32" fmla="*/ 702378 h 5025119"/>
              <a:gd name="connsiteX33" fmla="*/ 944114 w 6886274"/>
              <a:gd name="connsiteY33" fmla="*/ 662550 h 5025119"/>
              <a:gd name="connsiteX34" fmla="*/ 733432 w 6886274"/>
              <a:gd name="connsiteY34" fmla="*/ 500629 h 5025119"/>
              <a:gd name="connsiteX35" fmla="*/ 606501 w 6886274"/>
              <a:gd name="connsiteY35" fmla="*/ 399755 h 5025119"/>
              <a:gd name="connsiteX36" fmla="*/ 588634 w 6886274"/>
              <a:gd name="connsiteY36" fmla="*/ 381143 h 5025119"/>
              <a:gd name="connsiteX37" fmla="*/ 575978 w 6886274"/>
              <a:gd name="connsiteY37" fmla="*/ 375560 h 5025119"/>
              <a:gd name="connsiteX38" fmla="*/ 567044 w 6886274"/>
              <a:gd name="connsiteY38" fmla="*/ 388588 h 5025119"/>
              <a:gd name="connsiteX39" fmla="*/ 578956 w 6886274"/>
              <a:gd name="connsiteY39" fmla="*/ 437722 h 5025119"/>
              <a:gd name="connsiteX40" fmla="*/ 675736 w 6886274"/>
              <a:gd name="connsiteY40" fmla="*/ 535619 h 5025119"/>
              <a:gd name="connsiteX41" fmla="*/ 811600 w 6886274"/>
              <a:gd name="connsiteY41" fmla="*/ 652872 h 5025119"/>
              <a:gd name="connsiteX42" fmla="*/ 818300 w 6886274"/>
              <a:gd name="connsiteY42" fmla="*/ 666272 h 5025119"/>
              <a:gd name="connsiteX43" fmla="*/ 741621 w 6886274"/>
              <a:gd name="connsiteY43" fmla="*/ 608576 h 5025119"/>
              <a:gd name="connsiteX44" fmla="*/ 666430 w 6886274"/>
              <a:gd name="connsiteY44" fmla="*/ 553114 h 5025119"/>
              <a:gd name="connsiteX45" fmla="*/ 645585 w 6886274"/>
              <a:gd name="connsiteY45" fmla="*/ 547903 h 5025119"/>
              <a:gd name="connsiteX46" fmla="*/ 640002 w 6886274"/>
              <a:gd name="connsiteY46" fmla="*/ 570236 h 5025119"/>
              <a:gd name="connsiteX47" fmla="*/ 675736 w 6886274"/>
              <a:gd name="connsiteY47" fmla="*/ 628677 h 5025119"/>
              <a:gd name="connsiteX48" fmla="*/ 855896 w 6886274"/>
              <a:gd name="connsiteY48" fmla="*/ 786875 h 5025119"/>
              <a:gd name="connsiteX49" fmla="*/ 946348 w 6886274"/>
              <a:gd name="connsiteY49" fmla="*/ 877699 h 5025119"/>
              <a:gd name="connsiteX50" fmla="*/ 950442 w 6886274"/>
              <a:gd name="connsiteY50" fmla="*/ 899661 h 5025119"/>
              <a:gd name="connsiteX51" fmla="*/ 991760 w 6886274"/>
              <a:gd name="connsiteY51" fmla="*/ 937629 h 5025119"/>
              <a:gd name="connsiteX52" fmla="*/ 1018188 w 6886274"/>
              <a:gd name="connsiteY52" fmla="*/ 945445 h 5025119"/>
              <a:gd name="connsiteX53" fmla="*/ 1315601 w 6886274"/>
              <a:gd name="connsiteY53" fmla="*/ 1196329 h 5025119"/>
              <a:gd name="connsiteX54" fmla="*/ 1454443 w 6886274"/>
              <a:gd name="connsiteY54" fmla="*/ 1279709 h 5025119"/>
              <a:gd name="connsiteX55" fmla="*/ 1454443 w 6886274"/>
              <a:gd name="connsiteY55" fmla="*/ 1285665 h 5025119"/>
              <a:gd name="connsiteX56" fmla="*/ 1453327 w 6886274"/>
              <a:gd name="connsiteY56" fmla="*/ 1291993 h 5025119"/>
              <a:gd name="connsiteX57" fmla="*/ 1256416 w 6886274"/>
              <a:gd name="connsiteY57" fmla="*/ 1166923 h 5025119"/>
              <a:gd name="connsiteX58" fmla="*/ 745715 w 6886274"/>
              <a:gd name="connsiteY58" fmla="*/ 798786 h 5025119"/>
              <a:gd name="connsiteX59" fmla="*/ 592356 w 6886274"/>
              <a:gd name="connsiteY59" fmla="*/ 656966 h 5025119"/>
              <a:gd name="connsiteX60" fmla="*/ 485526 w 6886274"/>
              <a:gd name="connsiteY60" fmla="*/ 567259 h 5025119"/>
              <a:gd name="connsiteX61" fmla="*/ 430063 w 6886274"/>
              <a:gd name="connsiteY61" fmla="*/ 550136 h 5025119"/>
              <a:gd name="connsiteX62" fmla="*/ 408846 w 6886274"/>
              <a:gd name="connsiteY62" fmla="*/ 563164 h 5025119"/>
              <a:gd name="connsiteX63" fmla="*/ 421130 w 6886274"/>
              <a:gd name="connsiteY63" fmla="*/ 581403 h 5025119"/>
              <a:gd name="connsiteX64" fmla="*/ 426713 w 6886274"/>
              <a:gd name="connsiteY64" fmla="*/ 584009 h 5025119"/>
              <a:gd name="connsiteX65" fmla="*/ 487015 w 6886274"/>
              <a:gd name="connsiteY65" fmla="*/ 635005 h 5025119"/>
              <a:gd name="connsiteX66" fmla="*/ 487015 w 6886274"/>
              <a:gd name="connsiteY66" fmla="*/ 655105 h 5025119"/>
              <a:gd name="connsiteX67" fmla="*/ 497437 w 6886274"/>
              <a:gd name="connsiteY67" fmla="*/ 678183 h 5025119"/>
              <a:gd name="connsiteX68" fmla="*/ 539871 w 6886274"/>
              <a:gd name="connsiteY68" fmla="*/ 691584 h 5025119"/>
              <a:gd name="connsiteX69" fmla="*/ 485898 w 6886274"/>
              <a:gd name="connsiteY69" fmla="*/ 681906 h 5025119"/>
              <a:gd name="connsiteX70" fmla="*/ 410335 w 6886274"/>
              <a:gd name="connsiteY70" fmla="*/ 600387 h 5025119"/>
              <a:gd name="connsiteX71" fmla="*/ 397307 w 6886274"/>
              <a:gd name="connsiteY71" fmla="*/ 582892 h 5025119"/>
              <a:gd name="connsiteX72" fmla="*/ 363062 w 6886274"/>
              <a:gd name="connsiteY72" fmla="*/ 584009 h 5025119"/>
              <a:gd name="connsiteX73" fmla="*/ 334772 w 6886274"/>
              <a:gd name="connsiteY73" fmla="*/ 578426 h 5025119"/>
              <a:gd name="connsiteX74" fmla="*/ 281915 w 6886274"/>
              <a:gd name="connsiteY74" fmla="*/ 522219 h 5025119"/>
              <a:gd name="connsiteX75" fmla="*/ 263304 w 6886274"/>
              <a:gd name="connsiteY75" fmla="*/ 521846 h 5025119"/>
              <a:gd name="connsiteX76" fmla="*/ 263676 w 6886274"/>
              <a:gd name="connsiteY76" fmla="*/ 538225 h 5025119"/>
              <a:gd name="connsiteX77" fmla="*/ 275215 w 6886274"/>
              <a:gd name="connsiteY77" fmla="*/ 563164 h 5025119"/>
              <a:gd name="connsiteX78" fmla="*/ 271121 w 6886274"/>
              <a:gd name="connsiteY78" fmla="*/ 604854 h 5025119"/>
              <a:gd name="connsiteX79" fmla="*/ 274471 w 6886274"/>
              <a:gd name="connsiteY79" fmla="*/ 627560 h 5025119"/>
              <a:gd name="connsiteX80" fmla="*/ 319138 w 6886274"/>
              <a:gd name="connsiteY80" fmla="*/ 718012 h 5025119"/>
              <a:gd name="connsiteX81" fmla="*/ 326583 w 6886274"/>
              <a:gd name="connsiteY81" fmla="*/ 729551 h 5025119"/>
              <a:gd name="connsiteX82" fmla="*/ 349289 w 6886274"/>
              <a:gd name="connsiteY82" fmla="*/ 748163 h 5025119"/>
              <a:gd name="connsiteX83" fmla="*/ 528332 w 6886274"/>
              <a:gd name="connsiteY83" fmla="*/ 1007608 h 5025119"/>
              <a:gd name="connsiteX84" fmla="*/ 766932 w 6886274"/>
              <a:gd name="connsiteY84" fmla="*/ 1222758 h 5025119"/>
              <a:gd name="connsiteX85" fmla="*/ 681319 w 6886274"/>
              <a:gd name="connsiteY85" fmla="*/ 1190746 h 5025119"/>
              <a:gd name="connsiteX86" fmla="*/ 469520 w 6886274"/>
              <a:gd name="connsiteY86" fmla="*/ 1032920 h 5025119"/>
              <a:gd name="connsiteX87" fmla="*/ 325466 w 6886274"/>
              <a:gd name="connsiteY87" fmla="*/ 917900 h 5025119"/>
              <a:gd name="connsiteX88" fmla="*/ 312066 w 6886274"/>
              <a:gd name="connsiteY88" fmla="*/ 903383 h 5025119"/>
              <a:gd name="connsiteX89" fmla="*/ 296805 w 6886274"/>
              <a:gd name="connsiteY89" fmla="*/ 895566 h 5025119"/>
              <a:gd name="connsiteX90" fmla="*/ 288243 w 6886274"/>
              <a:gd name="connsiteY90" fmla="*/ 910828 h 5025119"/>
              <a:gd name="connsiteX91" fmla="*/ 309460 w 6886274"/>
              <a:gd name="connsiteY91" fmla="*/ 971129 h 5025119"/>
              <a:gd name="connsiteX92" fmla="*/ 407729 w 6886274"/>
              <a:gd name="connsiteY92" fmla="*/ 1062698 h 5025119"/>
              <a:gd name="connsiteX93" fmla="*/ 544338 w 6886274"/>
              <a:gd name="connsiteY93" fmla="*/ 1189257 h 5025119"/>
              <a:gd name="connsiteX94" fmla="*/ 454630 w 6886274"/>
              <a:gd name="connsiteY94" fmla="*/ 1120766 h 5025119"/>
              <a:gd name="connsiteX95" fmla="*/ 385396 w 6886274"/>
              <a:gd name="connsiteY95" fmla="*/ 1070515 h 5025119"/>
              <a:gd name="connsiteX96" fmla="*/ 366040 w 6886274"/>
              <a:gd name="connsiteY96" fmla="*/ 1067537 h 5025119"/>
              <a:gd name="connsiteX97" fmla="*/ 361573 w 6886274"/>
              <a:gd name="connsiteY97" fmla="*/ 1086149 h 5025119"/>
              <a:gd name="connsiteX98" fmla="*/ 402146 w 6886274"/>
              <a:gd name="connsiteY98" fmla="*/ 1152778 h 5025119"/>
              <a:gd name="connsiteX99" fmla="*/ 475475 w 6886274"/>
              <a:gd name="connsiteY99" fmla="*/ 1218663 h 5025119"/>
              <a:gd name="connsiteX100" fmla="*/ 393957 w 6886274"/>
              <a:gd name="connsiteY100" fmla="*/ 1201913 h 5025119"/>
              <a:gd name="connsiteX101" fmla="*/ 460586 w 6886274"/>
              <a:gd name="connsiteY101" fmla="*/ 1260353 h 5025119"/>
              <a:gd name="connsiteX102" fmla="*/ 561089 w 6886274"/>
              <a:gd name="connsiteY102" fmla="*/ 1291993 h 5025119"/>
              <a:gd name="connsiteX103" fmla="*/ 602034 w 6886274"/>
              <a:gd name="connsiteY103" fmla="*/ 1328843 h 5025119"/>
              <a:gd name="connsiteX104" fmla="*/ 641863 w 6886274"/>
              <a:gd name="connsiteY104" fmla="*/ 1368672 h 5025119"/>
              <a:gd name="connsiteX105" fmla="*/ 651541 w 6886274"/>
              <a:gd name="connsiteY105" fmla="*/ 1404406 h 5025119"/>
              <a:gd name="connsiteX106" fmla="*/ 688392 w 6886274"/>
              <a:gd name="connsiteY106" fmla="*/ 1457263 h 5025119"/>
              <a:gd name="connsiteX107" fmla="*/ 692486 w 6886274"/>
              <a:gd name="connsiteY107" fmla="*/ 1458008 h 5025119"/>
              <a:gd name="connsiteX108" fmla="*/ 719287 w 6886274"/>
              <a:gd name="connsiteY108" fmla="*/ 1485181 h 5025119"/>
              <a:gd name="connsiteX109" fmla="*/ 745343 w 6886274"/>
              <a:gd name="connsiteY109" fmla="*/ 1512353 h 5025119"/>
              <a:gd name="connsiteX110" fmla="*/ 750926 w 6886274"/>
              <a:gd name="connsiteY110" fmla="*/ 1516448 h 5025119"/>
              <a:gd name="connsiteX111" fmla="*/ 890141 w 6886274"/>
              <a:gd name="connsiteY111" fmla="*/ 1685813 h 5025119"/>
              <a:gd name="connsiteX112" fmla="*/ 899074 w 6886274"/>
              <a:gd name="connsiteY112" fmla="*/ 1693630 h 5025119"/>
              <a:gd name="connsiteX113" fmla="*/ 605012 w 6886274"/>
              <a:gd name="connsiteY113" fmla="*/ 1669435 h 5025119"/>
              <a:gd name="connsiteX114" fmla="*/ 229431 w 6886274"/>
              <a:gd name="connsiteY114" fmla="*/ 1545110 h 5025119"/>
              <a:gd name="connsiteX115" fmla="*/ 251765 w 6886274"/>
              <a:gd name="connsiteY115" fmla="*/ 1614717 h 5025119"/>
              <a:gd name="connsiteX116" fmla="*/ 237992 w 6886274"/>
              <a:gd name="connsiteY116" fmla="*/ 1675391 h 5025119"/>
              <a:gd name="connsiteX117" fmla="*/ 232781 w 6886274"/>
              <a:gd name="connsiteY117" fmla="*/ 1807160 h 5025119"/>
              <a:gd name="connsiteX118" fmla="*/ 236131 w 6886274"/>
              <a:gd name="connsiteY118" fmla="*/ 1828750 h 5025119"/>
              <a:gd name="connsiteX119" fmla="*/ 152007 w 6886274"/>
              <a:gd name="connsiteY119" fmla="*/ 1842150 h 5025119"/>
              <a:gd name="connsiteX120" fmla="*/ 653030 w 6886274"/>
              <a:gd name="connsiteY120" fmla="*/ 2213265 h 5025119"/>
              <a:gd name="connsiteX121" fmla="*/ 318394 w 6886274"/>
              <a:gd name="connsiteY121" fmla="*/ 2143285 h 5025119"/>
              <a:gd name="connsiteX122" fmla="*/ 272982 w 6886274"/>
              <a:gd name="connsiteY122" fmla="*/ 2258305 h 5025119"/>
              <a:gd name="connsiteX123" fmla="*/ 430435 w 6886274"/>
              <a:gd name="connsiteY123" fmla="*/ 2360668 h 5025119"/>
              <a:gd name="connsiteX124" fmla="*/ 488876 w 6886274"/>
              <a:gd name="connsiteY124" fmla="*/ 2563162 h 5025119"/>
              <a:gd name="connsiteX125" fmla="*/ 460586 w 6886274"/>
              <a:gd name="connsiteY125" fmla="*/ 2748533 h 5025119"/>
              <a:gd name="connsiteX126" fmla="*/ 393212 w 6886274"/>
              <a:gd name="connsiteY126" fmla="*/ 2807345 h 5025119"/>
              <a:gd name="connsiteX127" fmla="*/ 295688 w 6886274"/>
              <a:gd name="connsiteY127" fmla="*/ 2913059 h 5025119"/>
              <a:gd name="connsiteX128" fmla="*/ 235386 w 6886274"/>
              <a:gd name="connsiteY128" fmla="*/ 2978572 h 5025119"/>
              <a:gd name="connsiteX129" fmla="*/ 25448 w 6886274"/>
              <a:gd name="connsiteY129" fmla="*/ 2952888 h 5025119"/>
              <a:gd name="connsiteX130" fmla="*/ 305738 w 6886274"/>
              <a:gd name="connsiteY130" fmla="*/ 3119275 h 5025119"/>
              <a:gd name="connsiteX131" fmla="*/ 79049 w 6886274"/>
              <a:gd name="connsiteY131" fmla="*/ 3098430 h 5025119"/>
              <a:gd name="connsiteX132" fmla="*/ 4975 w 6886274"/>
              <a:gd name="connsiteY132" fmla="*/ 3109969 h 5025119"/>
              <a:gd name="connsiteX133" fmla="*/ 47037 w 6886274"/>
              <a:gd name="connsiteY133" fmla="*/ 3163943 h 5025119"/>
              <a:gd name="connsiteX134" fmla="*/ 213425 w 6886274"/>
              <a:gd name="connsiteY134" fmla="*/ 3255139 h 5025119"/>
              <a:gd name="connsiteX135" fmla="*/ 556622 w 6886274"/>
              <a:gd name="connsiteY135" fmla="*/ 3502301 h 5025119"/>
              <a:gd name="connsiteX136" fmla="*/ 224592 w 6886274"/>
              <a:gd name="connsiteY136" fmla="*/ 3388771 h 5025119"/>
              <a:gd name="connsiteX137" fmla="*/ 574861 w 6886274"/>
              <a:gd name="connsiteY137" fmla="*/ 3643004 h 5025119"/>
              <a:gd name="connsiteX138" fmla="*/ 652657 w 6886274"/>
              <a:gd name="connsiteY138" fmla="*/ 3727501 h 5025119"/>
              <a:gd name="connsiteX139" fmla="*/ 810111 w 6886274"/>
              <a:gd name="connsiteY139" fmla="*/ 3937067 h 5025119"/>
              <a:gd name="connsiteX140" fmla="*/ 802294 w 6886274"/>
              <a:gd name="connsiteY140" fmla="*/ 3960890 h 5025119"/>
              <a:gd name="connsiteX141" fmla="*/ 620646 w 6886274"/>
              <a:gd name="connsiteY141" fmla="*/ 3927017 h 5025119"/>
              <a:gd name="connsiteX142" fmla="*/ 856268 w 6886274"/>
              <a:gd name="connsiteY142" fmla="*/ 4103082 h 5025119"/>
              <a:gd name="connsiteX143" fmla="*/ 1099707 w 6886274"/>
              <a:gd name="connsiteY143" fmla="*/ 4238574 h 5025119"/>
              <a:gd name="connsiteX144" fmla="*/ 926992 w 6886274"/>
              <a:gd name="connsiteY144" fmla="*/ 4218102 h 5025119"/>
              <a:gd name="connsiteX145" fmla="*/ 689508 w 6886274"/>
              <a:gd name="connsiteY145" fmla="*/ 4140677 h 5025119"/>
              <a:gd name="connsiteX146" fmla="*/ 606873 w 6886274"/>
              <a:gd name="connsiteY146" fmla="*/ 4169711 h 5025119"/>
              <a:gd name="connsiteX147" fmla="*/ 831701 w 6886274"/>
              <a:gd name="connsiteY147" fmla="*/ 4297759 h 5025119"/>
              <a:gd name="connsiteX148" fmla="*/ 960493 w 6886274"/>
              <a:gd name="connsiteY148" fmla="*/ 4356944 h 5025119"/>
              <a:gd name="connsiteX149" fmla="*/ 1012233 w 6886274"/>
              <a:gd name="connsiteY149" fmla="*/ 4402356 h 5025119"/>
              <a:gd name="connsiteX150" fmla="*/ 1159636 w 6886274"/>
              <a:gd name="connsiteY150" fmla="*/ 4564276 h 5025119"/>
              <a:gd name="connsiteX151" fmla="*/ 1592169 w 6886274"/>
              <a:gd name="connsiteY151" fmla="*/ 4741458 h 5025119"/>
              <a:gd name="connsiteX152" fmla="*/ 3110499 w 6886274"/>
              <a:gd name="connsiteY152" fmla="*/ 5032171 h 5025119"/>
              <a:gd name="connsiteX153" fmla="*/ 6033630 w 6886274"/>
              <a:gd name="connsiteY153" fmla="*/ 4091915 h 5025119"/>
              <a:gd name="connsiteX154" fmla="*/ 6180661 w 6886274"/>
              <a:gd name="connsiteY154" fmla="*/ 3957912 h 5025119"/>
              <a:gd name="connsiteX155" fmla="*/ 6305359 w 6886274"/>
              <a:gd name="connsiteY155" fmla="*/ 3837309 h 5025119"/>
              <a:gd name="connsiteX156" fmla="*/ 6240218 w 6886274"/>
              <a:gd name="connsiteY156" fmla="*/ 3796364 h 5025119"/>
              <a:gd name="connsiteX157" fmla="*/ 6328437 w 6886274"/>
              <a:gd name="connsiteY157" fmla="*/ 3681344 h 5025119"/>
              <a:gd name="connsiteX158" fmla="*/ 6608355 w 6886274"/>
              <a:gd name="connsiteY158" fmla="*/ 3326236 h 5025119"/>
              <a:gd name="connsiteX159" fmla="*/ 6731191 w 6886274"/>
              <a:gd name="connsiteY159" fmla="*/ 3248067 h 5025119"/>
              <a:gd name="connsiteX160" fmla="*/ 6880456 w 6886274"/>
              <a:gd name="connsiteY160" fmla="*/ 3051529 h 5025119"/>
              <a:gd name="connsiteX161" fmla="*/ 6901673 w 6886274"/>
              <a:gd name="connsiteY161" fmla="*/ 2763795 h 5025119"/>
              <a:gd name="connsiteX162" fmla="*/ 6871150 w 6886274"/>
              <a:gd name="connsiteY162" fmla="*/ 2948421 h 5025119"/>
              <a:gd name="connsiteX163" fmla="*/ 6848444 w 6886274"/>
              <a:gd name="connsiteY163" fmla="*/ 2890353 h 5025119"/>
              <a:gd name="connsiteX164" fmla="*/ 6878223 w 6886274"/>
              <a:gd name="connsiteY164" fmla="*/ 2873230 h 5025119"/>
              <a:gd name="connsiteX165" fmla="*/ 6762459 w 6886274"/>
              <a:gd name="connsiteY165" fmla="*/ 2568745 h 5025119"/>
              <a:gd name="connsiteX166" fmla="*/ 6673123 w 6886274"/>
              <a:gd name="connsiteY166" fmla="*/ 2451493 h 5025119"/>
              <a:gd name="connsiteX167" fmla="*/ 6662700 w 6886274"/>
              <a:gd name="connsiteY167" fmla="*/ 2346896 h 5025119"/>
              <a:gd name="connsiteX168" fmla="*/ 6487752 w 6886274"/>
              <a:gd name="connsiteY168" fmla="*/ 2285105 h 5025119"/>
              <a:gd name="connsiteX169" fmla="*/ 6652278 w 6886274"/>
              <a:gd name="connsiteY169" fmla="*/ 2063628 h 5025119"/>
              <a:gd name="connsiteX170" fmla="*/ 6668656 w 6886274"/>
              <a:gd name="connsiteY170" fmla="*/ 2017843 h 5025119"/>
              <a:gd name="connsiteX171" fmla="*/ 6570015 w 6886274"/>
              <a:gd name="connsiteY171" fmla="*/ 1854062 h 5025119"/>
              <a:gd name="connsiteX172" fmla="*/ 6554009 w 6886274"/>
              <a:gd name="connsiteY172" fmla="*/ 1827633 h 5025119"/>
              <a:gd name="connsiteX173" fmla="*/ 6517531 w 6886274"/>
              <a:gd name="connsiteY173" fmla="*/ 1775149 h 5025119"/>
              <a:gd name="connsiteX174" fmla="*/ 6412934 w 6886274"/>
              <a:gd name="connsiteY174" fmla="*/ 1762493 h 5025119"/>
              <a:gd name="connsiteX175" fmla="*/ 6467279 w 6886274"/>
              <a:gd name="connsiteY175" fmla="*/ 1725642 h 5025119"/>
              <a:gd name="connsiteX176" fmla="*/ 6572621 w 6886274"/>
              <a:gd name="connsiteY176" fmla="*/ 1600200 h 5025119"/>
              <a:gd name="connsiteX177" fmla="*/ 6502641 w 6886274"/>
              <a:gd name="connsiteY177" fmla="*/ 1480341 h 5025119"/>
              <a:gd name="connsiteX178" fmla="*/ 6481796 w 6886274"/>
              <a:gd name="connsiteY178" fmla="*/ 1461358 h 5025119"/>
              <a:gd name="connsiteX179" fmla="*/ 6509713 w 6886274"/>
              <a:gd name="connsiteY179" fmla="*/ 1436418 h 5025119"/>
              <a:gd name="connsiteX180" fmla="*/ 6567037 w 6886274"/>
              <a:gd name="connsiteY180" fmla="*/ 1348199 h 5025119"/>
              <a:gd name="connsiteX181" fmla="*/ 6596816 w 6886274"/>
              <a:gd name="connsiteY181" fmla="*/ 1286781 h 5025119"/>
              <a:gd name="connsiteX182" fmla="*/ 6632178 w 6886274"/>
              <a:gd name="connsiteY182" fmla="*/ 1261842 h 5025119"/>
              <a:gd name="connsiteX183" fmla="*/ 6639994 w 6886274"/>
              <a:gd name="connsiteY183" fmla="*/ 1240625 h 5025119"/>
              <a:gd name="connsiteX184" fmla="*/ 6622127 w 6886274"/>
              <a:gd name="connsiteY184" fmla="*/ 1136400 h 5025119"/>
              <a:gd name="connsiteX185" fmla="*/ 6612077 w 6886274"/>
              <a:gd name="connsiteY185" fmla="*/ 1109599 h 5025119"/>
              <a:gd name="connsiteX186" fmla="*/ 6531675 w 6886274"/>
              <a:gd name="connsiteY186" fmla="*/ 1009469 h 5025119"/>
              <a:gd name="connsiteX187" fmla="*/ 6456113 w 6886274"/>
              <a:gd name="connsiteY187" fmla="*/ 845315 h 5025119"/>
              <a:gd name="connsiteX188" fmla="*/ 6440851 w 6886274"/>
              <a:gd name="connsiteY188" fmla="*/ 739229 h 5025119"/>
              <a:gd name="connsiteX189" fmla="*/ 6434523 w 6886274"/>
              <a:gd name="connsiteY189" fmla="*/ 715034 h 5025119"/>
              <a:gd name="connsiteX190" fmla="*/ 6432290 w 6886274"/>
              <a:gd name="connsiteY190" fmla="*/ 617510 h 5025119"/>
              <a:gd name="connsiteX191" fmla="*/ 6416284 w 6886274"/>
              <a:gd name="connsiteY191" fmla="*/ 595176 h 5025119"/>
              <a:gd name="connsiteX192" fmla="*/ 6267763 w 6886274"/>
              <a:gd name="connsiteY192" fmla="*/ 591826 h 5025119"/>
              <a:gd name="connsiteX193" fmla="*/ 6236496 w 6886274"/>
              <a:gd name="connsiteY193" fmla="*/ 521102 h 5025119"/>
              <a:gd name="connsiteX194" fmla="*/ 6257341 w 6886274"/>
              <a:gd name="connsiteY194" fmla="*/ 487229 h 5025119"/>
              <a:gd name="connsiteX195" fmla="*/ 6248780 w 6886274"/>
              <a:gd name="connsiteY195" fmla="*/ 465267 h 5025119"/>
              <a:gd name="connsiteX196" fmla="*/ 6226818 w 6886274"/>
              <a:gd name="connsiteY196" fmla="*/ 473456 h 5025119"/>
              <a:gd name="connsiteX197" fmla="*/ 6115149 w 6886274"/>
              <a:gd name="connsiteY197" fmla="*/ 551625 h 5025119"/>
              <a:gd name="connsiteX198" fmla="*/ 5951739 w 6886274"/>
              <a:gd name="connsiteY198" fmla="*/ 659944 h 5025119"/>
              <a:gd name="connsiteX199" fmla="*/ 5917122 w 6886274"/>
              <a:gd name="connsiteY199" fmla="*/ 644310 h 5025119"/>
              <a:gd name="connsiteX200" fmla="*/ 5890694 w 6886274"/>
              <a:gd name="connsiteY200" fmla="*/ 630538 h 5025119"/>
              <a:gd name="connsiteX201" fmla="*/ 5837464 w 6886274"/>
              <a:gd name="connsiteY201" fmla="*/ 646916 h 5025119"/>
              <a:gd name="connsiteX202" fmla="*/ 5809175 w 6886274"/>
              <a:gd name="connsiteY202" fmla="*/ 683395 h 5025119"/>
              <a:gd name="connsiteX203" fmla="*/ 5815503 w 6886274"/>
              <a:gd name="connsiteY203" fmla="*/ 698656 h 5025119"/>
              <a:gd name="connsiteX204" fmla="*/ 5746268 w 6886274"/>
              <a:gd name="connsiteY204" fmla="*/ 667389 h 5025119"/>
              <a:gd name="connsiteX205" fmla="*/ 5458905 w 6886274"/>
              <a:gd name="connsiteY205" fmla="*/ 754119 h 5025119"/>
              <a:gd name="connsiteX206" fmla="*/ 885302 w 6886274"/>
              <a:gd name="connsiteY206" fmla="*/ 1333310 h 5025119"/>
              <a:gd name="connsiteX207" fmla="*/ 862596 w 6886274"/>
              <a:gd name="connsiteY207" fmla="*/ 1314326 h 5025119"/>
              <a:gd name="connsiteX208" fmla="*/ 866318 w 6886274"/>
              <a:gd name="connsiteY208" fmla="*/ 1309860 h 5025119"/>
              <a:gd name="connsiteX209" fmla="*/ 912103 w 6886274"/>
              <a:gd name="connsiteY209" fmla="*/ 1341127 h 5025119"/>
              <a:gd name="connsiteX210" fmla="*/ 885302 w 6886274"/>
              <a:gd name="connsiteY210" fmla="*/ 1333310 h 5025119"/>
              <a:gd name="connsiteX211" fmla="*/ 1140280 w 6886274"/>
              <a:gd name="connsiteY211" fmla="*/ 787619 h 5025119"/>
              <a:gd name="connsiteX212" fmla="*/ 1414987 w 6886274"/>
              <a:gd name="connsiteY212" fmla="*/ 975596 h 5025119"/>
              <a:gd name="connsiteX213" fmla="*/ 1410892 w 6886274"/>
              <a:gd name="connsiteY213" fmla="*/ 980063 h 5025119"/>
              <a:gd name="connsiteX214" fmla="*/ 1140280 w 6886274"/>
              <a:gd name="connsiteY214" fmla="*/ 787619 h 502511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 ang="0">
                <a:pos x="connsiteX195" y="connsiteY195"/>
              </a:cxn>
              <a:cxn ang="0">
                <a:pos x="connsiteX196" y="connsiteY196"/>
              </a:cxn>
              <a:cxn ang="0">
                <a:pos x="connsiteX197" y="connsiteY197"/>
              </a:cxn>
              <a:cxn ang="0">
                <a:pos x="connsiteX198" y="connsiteY198"/>
              </a:cxn>
              <a:cxn ang="0">
                <a:pos x="connsiteX199" y="connsiteY199"/>
              </a:cxn>
              <a:cxn ang="0">
                <a:pos x="connsiteX200" y="connsiteY200"/>
              </a:cxn>
              <a:cxn ang="0">
                <a:pos x="connsiteX201" y="connsiteY201"/>
              </a:cxn>
              <a:cxn ang="0">
                <a:pos x="connsiteX202" y="connsiteY202"/>
              </a:cxn>
              <a:cxn ang="0">
                <a:pos x="connsiteX203" y="connsiteY203"/>
              </a:cxn>
              <a:cxn ang="0">
                <a:pos x="connsiteX204" y="connsiteY204"/>
              </a:cxn>
              <a:cxn ang="0">
                <a:pos x="connsiteX205" y="connsiteY205"/>
              </a:cxn>
              <a:cxn ang="0">
                <a:pos x="connsiteX206" y="connsiteY206"/>
              </a:cxn>
              <a:cxn ang="0">
                <a:pos x="connsiteX207" y="connsiteY207"/>
              </a:cxn>
              <a:cxn ang="0">
                <a:pos x="connsiteX208" y="connsiteY208"/>
              </a:cxn>
              <a:cxn ang="0">
                <a:pos x="connsiteX209" y="connsiteY209"/>
              </a:cxn>
              <a:cxn ang="0">
                <a:pos x="connsiteX210" y="connsiteY210"/>
              </a:cxn>
              <a:cxn ang="0">
                <a:pos x="connsiteX211" y="connsiteY211"/>
              </a:cxn>
              <a:cxn ang="0">
                <a:pos x="connsiteX212" y="connsiteY212"/>
              </a:cxn>
              <a:cxn ang="0">
                <a:pos x="connsiteX213" y="connsiteY213"/>
              </a:cxn>
              <a:cxn ang="0">
                <a:pos x="connsiteX214" y="connsiteY214"/>
              </a:cxn>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192825A4-268B-4301-8432-F9E9B2661AEC}"/>
              </a:ext>
            </a:extLst>
          </p:cNvPr>
          <p:cNvSpPr>
            <a:spLocks noGrp="1"/>
          </p:cNvSpPr>
          <p:nvPr>
            <p:ph type="title"/>
          </p:nvPr>
        </p:nvSpPr>
        <p:spPr>
          <a:xfrm>
            <a:off x="2843784" y="1572768"/>
            <a:ext cx="6501384" cy="4096512"/>
          </a:xfrm>
        </p:spPr>
        <p:txBody>
          <a:bodyPr>
            <a:normAutofit/>
          </a:bodyPr>
          <a:lstStyle>
            <a:lvl1pPr algn="ctr">
              <a:defRPr sz="4000"/>
            </a:lvl1pPr>
          </a:lstStyle>
          <a:p>
            <a:r>
              <a:rPr lang="en-US"/>
              <a:t>Click to edit Master title style</a:t>
            </a:r>
            <a:endParaRPr lang="en-US" dirty="0"/>
          </a:p>
        </p:txBody>
      </p:sp>
      <p:sp>
        <p:nvSpPr>
          <p:cNvPr id="3" name="Date Placeholder 2">
            <a:extLst>
              <a:ext uri="{FF2B5EF4-FFF2-40B4-BE49-F238E27FC236}">
                <a16:creationId xmlns:a16="http://schemas.microsoft.com/office/drawing/2014/main" id="{DA33410F-8A90-47F6-BD39-4AC0E4358351}"/>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4" name="Footer Placeholder 3">
            <a:extLst>
              <a:ext uri="{FF2B5EF4-FFF2-40B4-BE49-F238E27FC236}">
                <a16:creationId xmlns:a16="http://schemas.microsoft.com/office/drawing/2014/main" id="{D1D819A9-F8DE-4E5C-AFC3-E0105ACD829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4E25320-A12F-4F3E-8EC9-11292FF36BEA}"/>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18325382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1">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1C9756B-145D-4BA8-AA43-904C1E7CB86D}"/>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3" name="Footer Placeholder 2">
            <a:extLst>
              <a:ext uri="{FF2B5EF4-FFF2-40B4-BE49-F238E27FC236}">
                <a16:creationId xmlns:a16="http://schemas.microsoft.com/office/drawing/2014/main" id="{B21DB60F-139E-4C44-89AF-3F8F5EC241F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88226C9-C193-4B47-9717-4BC86C9092C7}"/>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40429513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2">
    <p:spTree>
      <p:nvGrpSpPr>
        <p:cNvPr id="1" name=""/>
        <p:cNvGrpSpPr/>
        <p:nvPr/>
      </p:nvGrpSpPr>
      <p:grpSpPr>
        <a:xfrm>
          <a:off x="0" y="0"/>
          <a:ext cx="0" cy="0"/>
          <a:chOff x="0" y="0"/>
          <a:chExt cx="0" cy="0"/>
        </a:xfrm>
      </p:grpSpPr>
      <p:sp>
        <p:nvSpPr>
          <p:cNvPr id="6" name="Freeform: Shape 5" descr="Mask ID=&#10;Mask position=bottom, center&#10;Mask family= brushstroke, landscape, wide">
            <a:extLst>
              <a:ext uri="{FF2B5EF4-FFF2-40B4-BE49-F238E27FC236}">
                <a16:creationId xmlns:a16="http://schemas.microsoft.com/office/drawing/2014/main" id="{736BF44D-E8DD-45FA-931D-CBCC67D57944}"/>
              </a:ext>
            </a:extLst>
          </p:cNvPr>
          <p:cNvSpPr/>
          <p:nvPr/>
        </p:nvSpPr>
        <p:spPr>
          <a:xfrm>
            <a:off x="1768100" y="-1"/>
            <a:ext cx="10423900" cy="5920155"/>
          </a:xfrm>
          <a:custGeom>
            <a:avLst/>
            <a:gdLst>
              <a:gd name="connsiteX0" fmla="*/ 10423900 w 10423900"/>
              <a:gd name="connsiteY0" fmla="*/ 0 h 5491534"/>
              <a:gd name="connsiteX1" fmla="*/ 3493157 w 10423900"/>
              <a:gd name="connsiteY1" fmla="*/ 0 h 5491534"/>
              <a:gd name="connsiteX2" fmla="*/ 3493018 w 10423900"/>
              <a:gd name="connsiteY2" fmla="*/ 31 h 5491534"/>
              <a:gd name="connsiteX3" fmla="*/ 3245493 w 10423900"/>
              <a:gd name="connsiteY3" fmla="*/ 104839 h 5491534"/>
              <a:gd name="connsiteX4" fmla="*/ 4434802 w 10423900"/>
              <a:gd name="connsiteY4" fmla="*/ 284558 h 5491534"/>
              <a:gd name="connsiteX5" fmla="*/ 4011937 w 10423900"/>
              <a:gd name="connsiteY5" fmla="*/ 395559 h 5491534"/>
              <a:gd name="connsiteX6" fmla="*/ 3573213 w 10423900"/>
              <a:gd name="connsiteY6" fmla="*/ 474847 h 5491534"/>
              <a:gd name="connsiteX7" fmla="*/ 3097489 w 10423900"/>
              <a:gd name="connsiteY7" fmla="*/ 532990 h 5491534"/>
              <a:gd name="connsiteX8" fmla="*/ 2664052 w 10423900"/>
              <a:gd name="connsiteY8" fmla="*/ 649279 h 5491534"/>
              <a:gd name="connsiteX9" fmla="*/ 3795218 w 10423900"/>
              <a:gd name="connsiteY9" fmla="*/ 696852 h 5491534"/>
              <a:gd name="connsiteX10" fmla="*/ 3208492 w 10423900"/>
              <a:gd name="connsiteY10" fmla="*/ 802568 h 5491534"/>
              <a:gd name="connsiteX11" fmla="*/ 2727483 w 10423900"/>
              <a:gd name="connsiteY11" fmla="*/ 939999 h 5491534"/>
              <a:gd name="connsiteX12" fmla="*/ 2389190 w 10423900"/>
              <a:gd name="connsiteY12" fmla="*/ 1003429 h 5491534"/>
              <a:gd name="connsiteX13" fmla="*/ 2029754 w 10423900"/>
              <a:gd name="connsiteY13" fmla="*/ 1019287 h 5491534"/>
              <a:gd name="connsiteX14" fmla="*/ 1945181 w 10423900"/>
              <a:gd name="connsiteY14" fmla="*/ 1119716 h 5491534"/>
              <a:gd name="connsiteX15" fmla="*/ 2056184 w 10423900"/>
              <a:gd name="connsiteY15" fmla="*/ 1225434 h 5491534"/>
              <a:gd name="connsiteX16" fmla="*/ 2225329 w 10423900"/>
              <a:gd name="connsiteY16" fmla="*/ 1236004 h 5491534"/>
              <a:gd name="connsiteX17" fmla="*/ 3234920 w 10423900"/>
              <a:gd name="connsiteY17" fmla="*/ 1262435 h 5491534"/>
              <a:gd name="connsiteX18" fmla="*/ 0 w 10423900"/>
              <a:gd name="connsiteY18" fmla="*/ 1495009 h 5491534"/>
              <a:gd name="connsiteX19" fmla="*/ 438724 w 10423900"/>
              <a:gd name="connsiteY19" fmla="*/ 1637728 h 5491534"/>
              <a:gd name="connsiteX20" fmla="*/ 586726 w 10423900"/>
              <a:gd name="connsiteY20" fmla="*/ 2028877 h 5491534"/>
              <a:gd name="connsiteX21" fmla="*/ 1125878 w 10423900"/>
              <a:gd name="connsiteY21" fmla="*/ 2250882 h 5491534"/>
              <a:gd name="connsiteX22" fmla="*/ 1474744 w 10423900"/>
              <a:gd name="connsiteY22" fmla="*/ 2330169 h 5491534"/>
              <a:gd name="connsiteX23" fmla="*/ 2272901 w 10423900"/>
              <a:gd name="connsiteY23" fmla="*/ 2446458 h 5491534"/>
              <a:gd name="connsiteX24" fmla="*/ 2389190 w 10423900"/>
              <a:gd name="connsiteY24" fmla="*/ 2636747 h 5491534"/>
              <a:gd name="connsiteX25" fmla="*/ 2489621 w 10423900"/>
              <a:gd name="connsiteY25" fmla="*/ 2848179 h 5491534"/>
              <a:gd name="connsiteX26" fmla="*/ 2701053 w 10423900"/>
              <a:gd name="connsiteY26" fmla="*/ 2985611 h 5491534"/>
              <a:gd name="connsiteX27" fmla="*/ 1057165 w 10423900"/>
              <a:gd name="connsiteY27" fmla="*/ 2964468 h 5491534"/>
              <a:gd name="connsiteX28" fmla="*/ 2912485 w 10423900"/>
              <a:gd name="connsiteY28" fmla="*/ 3408477 h 5491534"/>
              <a:gd name="connsiteX29" fmla="*/ 2748626 w 10423900"/>
              <a:gd name="connsiteY29" fmla="*/ 3582909 h 5491534"/>
              <a:gd name="connsiteX30" fmla="*/ 3763503 w 10423900"/>
              <a:gd name="connsiteY30" fmla="*/ 3820771 h 5491534"/>
              <a:gd name="connsiteX31" fmla="*/ 3219063 w 10423900"/>
              <a:gd name="connsiteY31" fmla="*/ 3847199 h 5491534"/>
              <a:gd name="connsiteX32" fmla="*/ 6385269 w 10423900"/>
              <a:gd name="connsiteY32" fmla="*/ 4840933 h 5491534"/>
              <a:gd name="connsiteX33" fmla="*/ 10285854 w 10423900"/>
              <a:gd name="connsiteY33" fmla="*/ 5471118 h 5491534"/>
              <a:gd name="connsiteX34" fmla="*/ 10423900 w 10423900"/>
              <a:gd name="connsiteY34" fmla="*/ 5491534 h 54915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10423900" h="5491534">
                <a:moveTo>
                  <a:pt x="10423900" y="0"/>
                </a:moveTo>
                <a:lnTo>
                  <a:pt x="3493157" y="0"/>
                </a:lnTo>
                <a:lnTo>
                  <a:pt x="3493018" y="31"/>
                </a:lnTo>
                <a:cubicBezTo>
                  <a:pt x="3414969" y="12668"/>
                  <a:pt x="3328744" y="21588"/>
                  <a:pt x="3245493" y="104839"/>
                </a:cubicBezTo>
                <a:cubicBezTo>
                  <a:pt x="3668357" y="162984"/>
                  <a:pt x="4075366" y="51981"/>
                  <a:pt x="4434802" y="284558"/>
                </a:cubicBezTo>
                <a:cubicBezTo>
                  <a:pt x="4302656" y="400846"/>
                  <a:pt x="4154654" y="374416"/>
                  <a:pt x="4011937" y="395559"/>
                </a:cubicBezTo>
                <a:cubicBezTo>
                  <a:pt x="3863934" y="416704"/>
                  <a:pt x="3721217" y="453704"/>
                  <a:pt x="3573213" y="474847"/>
                </a:cubicBezTo>
                <a:cubicBezTo>
                  <a:pt x="3414639" y="501275"/>
                  <a:pt x="3256063" y="506562"/>
                  <a:pt x="3097489" y="532990"/>
                </a:cubicBezTo>
                <a:cubicBezTo>
                  <a:pt x="2965345" y="554135"/>
                  <a:pt x="2822627" y="517133"/>
                  <a:pt x="2664052" y="649279"/>
                </a:cubicBezTo>
                <a:cubicBezTo>
                  <a:pt x="3055203" y="744424"/>
                  <a:pt x="3409352" y="601706"/>
                  <a:pt x="3795218" y="696852"/>
                </a:cubicBezTo>
                <a:cubicBezTo>
                  <a:pt x="3567928" y="781425"/>
                  <a:pt x="3382924" y="754995"/>
                  <a:pt x="3208492" y="802568"/>
                </a:cubicBezTo>
                <a:cubicBezTo>
                  <a:pt x="3049916" y="850140"/>
                  <a:pt x="2859627" y="797282"/>
                  <a:pt x="2727483" y="939999"/>
                </a:cubicBezTo>
                <a:cubicBezTo>
                  <a:pt x="2627052" y="1051000"/>
                  <a:pt x="2521336" y="1066858"/>
                  <a:pt x="2389190" y="1003429"/>
                </a:cubicBezTo>
                <a:cubicBezTo>
                  <a:pt x="2272901" y="945284"/>
                  <a:pt x="2146043" y="961142"/>
                  <a:pt x="2029754" y="1019287"/>
                </a:cubicBezTo>
                <a:cubicBezTo>
                  <a:pt x="1987468" y="1040430"/>
                  <a:pt x="1945181" y="1066858"/>
                  <a:pt x="1945181" y="1119716"/>
                </a:cubicBezTo>
                <a:cubicBezTo>
                  <a:pt x="1945181" y="1193719"/>
                  <a:pt x="1998039" y="1214862"/>
                  <a:pt x="2056184" y="1225434"/>
                </a:cubicBezTo>
                <a:cubicBezTo>
                  <a:pt x="2109042" y="1236004"/>
                  <a:pt x="2172471" y="1246577"/>
                  <a:pt x="2225329" y="1236004"/>
                </a:cubicBezTo>
                <a:cubicBezTo>
                  <a:pt x="2563622" y="1177861"/>
                  <a:pt x="2896629" y="1273005"/>
                  <a:pt x="3234920" y="1262435"/>
                </a:cubicBezTo>
                <a:cubicBezTo>
                  <a:pt x="2172471" y="1489724"/>
                  <a:pt x="1099450" y="1415723"/>
                  <a:pt x="0" y="1495009"/>
                </a:cubicBezTo>
                <a:cubicBezTo>
                  <a:pt x="142717" y="1653583"/>
                  <a:pt x="327721" y="1521439"/>
                  <a:pt x="438724" y="1637728"/>
                </a:cubicBezTo>
                <a:cubicBezTo>
                  <a:pt x="333006" y="1880875"/>
                  <a:pt x="375293" y="2013020"/>
                  <a:pt x="586726" y="2028877"/>
                </a:cubicBezTo>
                <a:cubicBezTo>
                  <a:pt x="792873" y="2044734"/>
                  <a:pt x="1014877" y="1960161"/>
                  <a:pt x="1125878" y="2250882"/>
                </a:cubicBezTo>
                <a:cubicBezTo>
                  <a:pt x="1157593" y="2340740"/>
                  <a:pt x="1353170" y="2314312"/>
                  <a:pt x="1474744" y="2330169"/>
                </a:cubicBezTo>
                <a:cubicBezTo>
                  <a:pt x="1739034" y="2367170"/>
                  <a:pt x="2019183" y="2330169"/>
                  <a:pt x="2272901" y="2446458"/>
                </a:cubicBezTo>
                <a:cubicBezTo>
                  <a:pt x="2373332" y="2488744"/>
                  <a:pt x="2442048" y="2520459"/>
                  <a:pt x="2389190" y="2636747"/>
                </a:cubicBezTo>
                <a:cubicBezTo>
                  <a:pt x="2336332" y="2758321"/>
                  <a:pt x="2405048" y="2800607"/>
                  <a:pt x="2489621" y="2848179"/>
                </a:cubicBezTo>
                <a:cubicBezTo>
                  <a:pt x="2553051" y="2885180"/>
                  <a:pt x="2648195" y="2874609"/>
                  <a:pt x="2701053" y="2985611"/>
                </a:cubicBezTo>
                <a:cubicBezTo>
                  <a:pt x="2146043" y="2969753"/>
                  <a:pt x="1606888" y="2879895"/>
                  <a:pt x="1057165" y="2964468"/>
                </a:cubicBezTo>
                <a:cubicBezTo>
                  <a:pt x="1659748" y="3175900"/>
                  <a:pt x="2320474" y="3165328"/>
                  <a:pt x="2912485" y="3408477"/>
                </a:cubicBezTo>
                <a:cubicBezTo>
                  <a:pt x="2891342" y="3493050"/>
                  <a:pt x="2753911" y="3456048"/>
                  <a:pt x="2748626" y="3582909"/>
                </a:cubicBezTo>
                <a:cubicBezTo>
                  <a:pt x="3060489" y="3715055"/>
                  <a:pt x="3435782" y="3625195"/>
                  <a:pt x="3763503" y="3820771"/>
                </a:cubicBezTo>
                <a:cubicBezTo>
                  <a:pt x="3573213" y="3910629"/>
                  <a:pt x="3398782" y="3762626"/>
                  <a:pt x="3219063" y="3847199"/>
                </a:cubicBezTo>
                <a:cubicBezTo>
                  <a:pt x="3277208" y="3974060"/>
                  <a:pt x="5909545" y="4756360"/>
                  <a:pt x="6385269" y="4840933"/>
                </a:cubicBezTo>
                <a:cubicBezTo>
                  <a:pt x="7171204" y="4982659"/>
                  <a:pt x="9157515" y="5302348"/>
                  <a:pt x="10285854" y="5471118"/>
                </a:cubicBezTo>
                <a:lnTo>
                  <a:pt x="10423900" y="5491534"/>
                </a:lnTo>
                <a:close/>
              </a:path>
            </a:pathLst>
          </a:custGeom>
          <a:solidFill>
            <a:schemeClr val="accent1">
              <a:alpha val="20000"/>
            </a:schemeClr>
          </a:solidFill>
          <a:ln w="32707" cap="flat">
            <a:noFill/>
            <a:prstDash val="solid"/>
            <a:miter/>
          </a:ln>
        </p:spPr>
        <p:txBody>
          <a:bodyPr wrap="square" rtlCol="0" anchor="ctr">
            <a:noAutofit/>
          </a:bodyPr>
          <a:lstStyle/>
          <a:p>
            <a:endParaRPr lang="en-US"/>
          </a:p>
        </p:txBody>
      </p:sp>
      <p:sp>
        <p:nvSpPr>
          <p:cNvPr id="2" name="Date Placeholder 1">
            <a:extLst>
              <a:ext uri="{FF2B5EF4-FFF2-40B4-BE49-F238E27FC236}">
                <a16:creationId xmlns:a16="http://schemas.microsoft.com/office/drawing/2014/main" id="{71C9756B-145D-4BA8-AA43-904C1E7CB86D}"/>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3" name="Footer Placeholder 2">
            <a:extLst>
              <a:ext uri="{FF2B5EF4-FFF2-40B4-BE49-F238E27FC236}">
                <a16:creationId xmlns:a16="http://schemas.microsoft.com/office/drawing/2014/main" id="{B21DB60F-139E-4C44-89AF-3F8F5EC241F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88226C9-C193-4B47-9717-4BC86C9092C7}"/>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25794690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8" name="Freeform: Shape 7" descr="Tag=AccentColor&#10;Flavor=Light&#10;Target=Fill">
            <a:extLst>
              <a:ext uri="{FF2B5EF4-FFF2-40B4-BE49-F238E27FC236}">
                <a16:creationId xmlns:a16="http://schemas.microsoft.com/office/drawing/2014/main" id="{76C5A8FA-6B61-4934-AF55-C595090CA5DC}"/>
              </a:ext>
            </a:extLst>
          </p:cNvPr>
          <p:cNvSpPr/>
          <p:nvPr/>
        </p:nvSpPr>
        <p:spPr>
          <a:xfrm>
            <a:off x="4726728" y="0"/>
            <a:ext cx="7472381" cy="6858000"/>
          </a:xfrm>
          <a:custGeom>
            <a:avLst/>
            <a:gdLst>
              <a:gd name="connsiteX0" fmla="*/ 1232666 w 7472381"/>
              <a:gd name="connsiteY0" fmla="*/ 0 h 6886575"/>
              <a:gd name="connsiteX1" fmla="*/ 7472381 w 7472381"/>
              <a:gd name="connsiteY1" fmla="*/ 0 h 6886575"/>
              <a:gd name="connsiteX2" fmla="*/ 7472381 w 7472381"/>
              <a:gd name="connsiteY2" fmla="*/ 814388 h 6886575"/>
              <a:gd name="connsiteX3" fmla="*/ 7472381 w 7472381"/>
              <a:gd name="connsiteY3" fmla="*/ 6411516 h 6886575"/>
              <a:gd name="connsiteX4" fmla="*/ 7472381 w 7472381"/>
              <a:gd name="connsiteY4" fmla="*/ 6886575 h 6886575"/>
              <a:gd name="connsiteX5" fmla="*/ 6992676 w 7472381"/>
              <a:gd name="connsiteY5" fmla="*/ 6886575 h 6886575"/>
              <a:gd name="connsiteX6" fmla="*/ 1946893 w 7472381"/>
              <a:gd name="connsiteY6" fmla="*/ 6886575 h 6886575"/>
              <a:gd name="connsiteX7" fmla="*/ 1506276 w 7472381"/>
              <a:gd name="connsiteY7" fmla="*/ 6686550 h 6886575"/>
              <a:gd name="connsiteX8" fmla="*/ 1314394 w 7472381"/>
              <a:gd name="connsiteY8" fmla="*/ 6457949 h 6886575"/>
              <a:gd name="connsiteX9" fmla="*/ 1246880 w 7472381"/>
              <a:gd name="connsiteY9" fmla="*/ 6393656 h 6886575"/>
              <a:gd name="connsiteX10" fmla="*/ 1079872 w 7472381"/>
              <a:gd name="connsiteY10" fmla="*/ 6307931 h 6886575"/>
              <a:gd name="connsiteX11" fmla="*/ 788495 w 7472381"/>
              <a:gd name="connsiteY11" fmla="*/ 6125765 h 6886575"/>
              <a:gd name="connsiteX12" fmla="*/ 895097 w 7472381"/>
              <a:gd name="connsiteY12" fmla="*/ 6082903 h 6886575"/>
              <a:gd name="connsiteX13" fmla="*/ 1204239 w 7472381"/>
              <a:gd name="connsiteY13" fmla="*/ 6193631 h 6886575"/>
              <a:gd name="connsiteX14" fmla="*/ 1428102 w 7472381"/>
              <a:gd name="connsiteY14" fmla="*/ 6222206 h 6886575"/>
              <a:gd name="connsiteX15" fmla="*/ 1111852 w 7472381"/>
              <a:gd name="connsiteY15" fmla="*/ 6029325 h 6886575"/>
              <a:gd name="connsiteX16" fmla="*/ 806262 w 7472381"/>
              <a:gd name="connsiteY16" fmla="*/ 5779294 h 6886575"/>
              <a:gd name="connsiteX17" fmla="*/ 1040785 w 7472381"/>
              <a:gd name="connsiteY17" fmla="*/ 5825728 h 6886575"/>
              <a:gd name="connsiteX18" fmla="*/ 1051445 w 7472381"/>
              <a:gd name="connsiteY18" fmla="*/ 5793581 h 6886575"/>
              <a:gd name="connsiteX19" fmla="*/ 845349 w 7472381"/>
              <a:gd name="connsiteY19" fmla="*/ 5497115 h 6886575"/>
              <a:gd name="connsiteX20" fmla="*/ 745855 w 7472381"/>
              <a:gd name="connsiteY20" fmla="*/ 5375672 h 6886575"/>
              <a:gd name="connsiteX21" fmla="*/ 291024 w 7472381"/>
              <a:gd name="connsiteY21" fmla="*/ 5014913 h 6886575"/>
              <a:gd name="connsiteX22" fmla="*/ 724535 w 7472381"/>
              <a:gd name="connsiteY22" fmla="*/ 5175647 h 6886575"/>
              <a:gd name="connsiteX23" fmla="*/ 276811 w 7472381"/>
              <a:gd name="connsiteY23" fmla="*/ 4825603 h 6886575"/>
              <a:gd name="connsiteX24" fmla="*/ 60055 w 7472381"/>
              <a:gd name="connsiteY24" fmla="*/ 4697016 h 6886575"/>
              <a:gd name="connsiteX25" fmla="*/ 6755 w 7472381"/>
              <a:gd name="connsiteY25" fmla="*/ 4622006 h 6886575"/>
              <a:gd name="connsiteX26" fmla="*/ 102696 w 7472381"/>
              <a:gd name="connsiteY26" fmla="*/ 4604146 h 6886575"/>
              <a:gd name="connsiteX27" fmla="*/ 397625 w 7472381"/>
              <a:gd name="connsiteY27" fmla="*/ 4632722 h 6886575"/>
              <a:gd name="connsiteX28" fmla="*/ 31628 w 7472381"/>
              <a:gd name="connsiteY28" fmla="*/ 4396978 h 6886575"/>
              <a:gd name="connsiteX29" fmla="*/ 305237 w 7472381"/>
              <a:gd name="connsiteY29" fmla="*/ 4432697 h 6886575"/>
              <a:gd name="connsiteX30" fmla="*/ 383412 w 7472381"/>
              <a:gd name="connsiteY30" fmla="*/ 4339828 h 6886575"/>
              <a:gd name="connsiteX31" fmla="*/ 511333 w 7472381"/>
              <a:gd name="connsiteY31" fmla="*/ 4189810 h 6886575"/>
              <a:gd name="connsiteX32" fmla="*/ 600167 w 7472381"/>
              <a:gd name="connsiteY32" fmla="*/ 4107656 h 6886575"/>
              <a:gd name="connsiteX33" fmla="*/ 635701 w 7472381"/>
              <a:gd name="connsiteY33" fmla="*/ 3843337 h 6886575"/>
              <a:gd name="connsiteX34" fmla="*/ 561080 w 7472381"/>
              <a:gd name="connsiteY34" fmla="*/ 3554015 h 6886575"/>
              <a:gd name="connsiteX35" fmla="*/ 354985 w 7472381"/>
              <a:gd name="connsiteY35" fmla="*/ 3407569 h 6886575"/>
              <a:gd name="connsiteX36" fmla="*/ 415392 w 7472381"/>
              <a:gd name="connsiteY36" fmla="*/ 3243263 h 6886575"/>
              <a:gd name="connsiteX37" fmla="*/ 852456 w 7472381"/>
              <a:gd name="connsiteY37" fmla="*/ 3343275 h 6886575"/>
              <a:gd name="connsiteX38" fmla="*/ 202190 w 7472381"/>
              <a:gd name="connsiteY38" fmla="*/ 2953940 h 6886575"/>
              <a:gd name="connsiteX39" fmla="*/ 312344 w 7472381"/>
              <a:gd name="connsiteY39" fmla="*/ 2936081 h 6886575"/>
              <a:gd name="connsiteX40" fmla="*/ 706768 w 7472381"/>
              <a:gd name="connsiteY40" fmla="*/ 2714625 h 6886575"/>
              <a:gd name="connsiteX41" fmla="*/ 728088 w 7472381"/>
              <a:gd name="connsiteY41" fmla="*/ 2703909 h 6886575"/>
              <a:gd name="connsiteX42" fmla="*/ 795602 w 7472381"/>
              <a:gd name="connsiteY42" fmla="*/ 2564606 h 6886575"/>
              <a:gd name="connsiteX43" fmla="*/ 1008804 w 7472381"/>
              <a:gd name="connsiteY43" fmla="*/ 2543175 h 6886575"/>
              <a:gd name="connsiteX44" fmla="*/ 1186473 w 7472381"/>
              <a:gd name="connsiteY44" fmla="*/ 2575322 h 6886575"/>
              <a:gd name="connsiteX45" fmla="*/ 1378355 w 7472381"/>
              <a:gd name="connsiteY45" fmla="*/ 2536031 h 6886575"/>
              <a:gd name="connsiteX46" fmla="*/ 1548916 w 7472381"/>
              <a:gd name="connsiteY46" fmla="*/ 2553891 h 6886575"/>
              <a:gd name="connsiteX47" fmla="*/ 1694604 w 7472381"/>
              <a:gd name="connsiteY47" fmla="*/ 2528888 h 6886575"/>
              <a:gd name="connsiteX48" fmla="*/ 1552469 w 7472381"/>
              <a:gd name="connsiteY48" fmla="*/ 2411015 h 6886575"/>
              <a:gd name="connsiteX49" fmla="*/ 1353481 w 7472381"/>
              <a:gd name="connsiteY49" fmla="*/ 2411015 h 6886575"/>
              <a:gd name="connsiteX50" fmla="*/ 1211346 w 7472381"/>
              <a:gd name="connsiteY50" fmla="*/ 2336007 h 6886575"/>
              <a:gd name="connsiteX51" fmla="*/ 1076318 w 7472381"/>
              <a:gd name="connsiteY51" fmla="*/ 2200275 h 6886575"/>
              <a:gd name="connsiteX52" fmla="*/ 600167 w 7472381"/>
              <a:gd name="connsiteY52" fmla="*/ 1982390 h 6886575"/>
              <a:gd name="connsiteX53" fmla="*/ 514886 w 7472381"/>
              <a:gd name="connsiteY53" fmla="*/ 1900238 h 6886575"/>
              <a:gd name="connsiteX54" fmla="*/ 1872273 w 7472381"/>
              <a:gd name="connsiteY54" fmla="*/ 2218135 h 6886575"/>
              <a:gd name="connsiteX55" fmla="*/ 1452975 w 7472381"/>
              <a:gd name="connsiteY55" fmla="*/ 2085975 h 6886575"/>
              <a:gd name="connsiteX56" fmla="*/ 1737245 w 7472381"/>
              <a:gd name="connsiteY56" fmla="*/ 2110978 h 6886575"/>
              <a:gd name="connsiteX57" fmla="*/ 1893593 w 7472381"/>
              <a:gd name="connsiteY57" fmla="*/ 2021681 h 6886575"/>
              <a:gd name="connsiteX58" fmla="*/ 1893593 w 7472381"/>
              <a:gd name="connsiteY58" fmla="*/ 1993106 h 6886575"/>
              <a:gd name="connsiteX59" fmla="*/ 1776332 w 7472381"/>
              <a:gd name="connsiteY59" fmla="*/ 1910953 h 6886575"/>
              <a:gd name="connsiteX60" fmla="*/ 1708818 w 7472381"/>
              <a:gd name="connsiteY60" fmla="*/ 1857375 h 6886575"/>
              <a:gd name="connsiteX61" fmla="*/ 1524043 w 7472381"/>
              <a:gd name="connsiteY61" fmla="*/ 1664493 h 6886575"/>
              <a:gd name="connsiteX62" fmla="*/ 1655517 w 7472381"/>
              <a:gd name="connsiteY62" fmla="*/ 1643062 h 6886575"/>
              <a:gd name="connsiteX63" fmla="*/ 1705264 w 7472381"/>
              <a:gd name="connsiteY63" fmla="*/ 1603772 h 6886575"/>
              <a:gd name="connsiteX64" fmla="*/ 1669731 w 7472381"/>
              <a:gd name="connsiteY64" fmla="*/ 1546622 h 6886575"/>
              <a:gd name="connsiteX65" fmla="*/ 1261093 w 7472381"/>
              <a:gd name="connsiteY65" fmla="*/ 1371600 h 6886575"/>
              <a:gd name="connsiteX66" fmla="*/ 1229113 w 7472381"/>
              <a:gd name="connsiteY66" fmla="*/ 1235869 h 6886575"/>
              <a:gd name="connsiteX67" fmla="*/ 1307287 w 7472381"/>
              <a:gd name="connsiteY67" fmla="*/ 1214437 h 6886575"/>
              <a:gd name="connsiteX68" fmla="*/ 1396121 w 7472381"/>
              <a:gd name="connsiteY68" fmla="*/ 1225153 h 6886575"/>
              <a:gd name="connsiteX69" fmla="*/ 1325054 w 7472381"/>
              <a:gd name="connsiteY69" fmla="*/ 1117997 h 6886575"/>
              <a:gd name="connsiteX70" fmla="*/ 1037231 w 7472381"/>
              <a:gd name="connsiteY70" fmla="*/ 1010841 h 6886575"/>
              <a:gd name="connsiteX71" fmla="*/ 983931 w 7472381"/>
              <a:gd name="connsiteY71" fmla="*/ 953690 h 6886575"/>
              <a:gd name="connsiteX72" fmla="*/ 1054998 w 7472381"/>
              <a:gd name="connsiteY72" fmla="*/ 925115 h 6886575"/>
              <a:gd name="connsiteX73" fmla="*/ 1108299 w 7472381"/>
              <a:gd name="connsiteY73" fmla="*/ 914400 h 6886575"/>
              <a:gd name="connsiteX74" fmla="*/ 6755 w 7472381"/>
              <a:gd name="connsiteY74" fmla="*/ 467915 h 6886575"/>
              <a:gd name="connsiteX75" fmla="*/ 255490 w 7472381"/>
              <a:gd name="connsiteY75" fmla="*/ 464344 h 6886575"/>
              <a:gd name="connsiteX76" fmla="*/ 500673 w 7472381"/>
              <a:gd name="connsiteY76" fmla="*/ 535781 h 6886575"/>
              <a:gd name="connsiteX77" fmla="*/ 760069 w 7472381"/>
              <a:gd name="connsiteY77" fmla="*/ 525066 h 6886575"/>
              <a:gd name="connsiteX78" fmla="*/ 1005251 w 7472381"/>
              <a:gd name="connsiteY78" fmla="*/ 560785 h 6886575"/>
              <a:gd name="connsiteX79" fmla="*/ 1218453 w 7472381"/>
              <a:gd name="connsiteY79" fmla="*/ 560785 h 6886575"/>
              <a:gd name="connsiteX80" fmla="*/ 1019464 w 7472381"/>
              <a:gd name="connsiteY80" fmla="*/ 507206 h 6886575"/>
              <a:gd name="connsiteX81" fmla="*/ 944844 w 7472381"/>
              <a:gd name="connsiteY81" fmla="*/ 417909 h 6886575"/>
              <a:gd name="connsiteX82" fmla="*/ 969717 w 7472381"/>
              <a:gd name="connsiteY82" fmla="*/ 335757 h 6886575"/>
              <a:gd name="connsiteX83" fmla="*/ 1051445 w 7472381"/>
              <a:gd name="connsiteY83" fmla="*/ 360759 h 6886575"/>
              <a:gd name="connsiteX84" fmla="*/ 1147386 w 7472381"/>
              <a:gd name="connsiteY84" fmla="*/ 453629 h 6886575"/>
              <a:gd name="connsiteX85" fmla="*/ 1168706 w 7472381"/>
              <a:gd name="connsiteY85" fmla="*/ 396478 h 6886575"/>
              <a:gd name="connsiteX86" fmla="*/ 1225560 w 7472381"/>
              <a:gd name="connsiteY86" fmla="*/ 353615 h 6886575"/>
              <a:gd name="connsiteX87" fmla="*/ 1552469 w 7472381"/>
              <a:gd name="connsiteY87" fmla="*/ 375047 h 6886575"/>
              <a:gd name="connsiteX88" fmla="*/ 1335714 w 7472381"/>
              <a:gd name="connsiteY88" fmla="*/ 192881 h 6886575"/>
              <a:gd name="connsiteX89" fmla="*/ 1197133 w 7472381"/>
              <a:gd name="connsiteY89" fmla="*/ 164306 h 6886575"/>
              <a:gd name="connsiteX90" fmla="*/ 1165153 w 7472381"/>
              <a:gd name="connsiteY90" fmla="*/ 89297 h 6886575"/>
              <a:gd name="connsiteX91" fmla="*/ 1229113 w 7472381"/>
              <a:gd name="connsiteY91" fmla="*/ 71437 h 6886575"/>
              <a:gd name="connsiteX92" fmla="*/ 1548916 w 7472381"/>
              <a:gd name="connsiteY92" fmla="*/ 135731 h 6886575"/>
              <a:gd name="connsiteX93" fmla="*/ 1602217 w 7472381"/>
              <a:gd name="connsiteY93" fmla="*/ 110728 h 6886575"/>
              <a:gd name="connsiteX94" fmla="*/ 1232666 w 7472381"/>
              <a:gd name="connsiteY94" fmla="*/ 0 h 68865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Lst>
            <a:rect l="l" t="t" r="r" b="b"/>
            <a:pathLst>
              <a:path w="7472381" h="6886575">
                <a:moveTo>
                  <a:pt x="1232666" y="0"/>
                </a:moveTo>
                <a:lnTo>
                  <a:pt x="7472381" y="0"/>
                </a:lnTo>
                <a:lnTo>
                  <a:pt x="7472381" y="814388"/>
                </a:lnTo>
                <a:lnTo>
                  <a:pt x="7472381" y="6411516"/>
                </a:lnTo>
                <a:lnTo>
                  <a:pt x="7472381" y="6886575"/>
                </a:lnTo>
                <a:lnTo>
                  <a:pt x="6992676" y="6886575"/>
                </a:lnTo>
                <a:lnTo>
                  <a:pt x="1946893" y="6886575"/>
                </a:lnTo>
                <a:cubicBezTo>
                  <a:pt x="1801205" y="6815137"/>
                  <a:pt x="1662624" y="6729412"/>
                  <a:pt x="1506276" y="6686550"/>
                </a:cubicBezTo>
                <a:cubicBezTo>
                  <a:pt x="1399675" y="6657975"/>
                  <a:pt x="1296627" y="6607969"/>
                  <a:pt x="1314394" y="6457949"/>
                </a:cubicBezTo>
                <a:cubicBezTo>
                  <a:pt x="1317947" y="6415087"/>
                  <a:pt x="1289520" y="6382941"/>
                  <a:pt x="1246880" y="6393656"/>
                </a:cubicBezTo>
                <a:cubicBezTo>
                  <a:pt x="1165153" y="6415087"/>
                  <a:pt x="1126065" y="6354365"/>
                  <a:pt x="1079872" y="6307931"/>
                </a:cubicBezTo>
                <a:cubicBezTo>
                  <a:pt x="998144" y="6225779"/>
                  <a:pt x="919970" y="6140052"/>
                  <a:pt x="788495" y="6125765"/>
                </a:cubicBezTo>
                <a:cubicBezTo>
                  <a:pt x="813369" y="6061471"/>
                  <a:pt x="856009" y="6068615"/>
                  <a:pt x="895097" y="6082903"/>
                </a:cubicBezTo>
                <a:cubicBezTo>
                  <a:pt x="998144" y="6118622"/>
                  <a:pt x="1101192" y="6157912"/>
                  <a:pt x="1204239" y="6193631"/>
                </a:cubicBezTo>
                <a:cubicBezTo>
                  <a:pt x="1271754" y="6215062"/>
                  <a:pt x="1339267" y="6247209"/>
                  <a:pt x="1428102" y="6222206"/>
                </a:cubicBezTo>
                <a:cubicBezTo>
                  <a:pt x="1349928" y="6093619"/>
                  <a:pt x="1218453" y="6068615"/>
                  <a:pt x="1111852" y="6029325"/>
                </a:cubicBezTo>
                <a:cubicBezTo>
                  <a:pt x="980377" y="5979319"/>
                  <a:pt x="902203" y="5886450"/>
                  <a:pt x="806262" y="5779294"/>
                </a:cubicBezTo>
                <a:cubicBezTo>
                  <a:pt x="902203" y="5750719"/>
                  <a:pt x="962610" y="5829300"/>
                  <a:pt x="1040785" y="5825728"/>
                </a:cubicBezTo>
                <a:cubicBezTo>
                  <a:pt x="1044338" y="5815012"/>
                  <a:pt x="1051445" y="5793581"/>
                  <a:pt x="1051445" y="5793581"/>
                </a:cubicBezTo>
                <a:cubicBezTo>
                  <a:pt x="923523" y="5736431"/>
                  <a:pt x="866670" y="5629275"/>
                  <a:pt x="845349" y="5497115"/>
                </a:cubicBezTo>
                <a:cubicBezTo>
                  <a:pt x="838243" y="5429250"/>
                  <a:pt x="792049" y="5407819"/>
                  <a:pt x="745855" y="5375672"/>
                </a:cubicBezTo>
                <a:cubicBezTo>
                  <a:pt x="589507" y="5264943"/>
                  <a:pt x="422499" y="5164931"/>
                  <a:pt x="291024" y="5014913"/>
                </a:cubicBezTo>
                <a:cubicBezTo>
                  <a:pt x="443819" y="5032771"/>
                  <a:pt x="564633" y="5132784"/>
                  <a:pt x="724535" y="5175647"/>
                </a:cubicBezTo>
                <a:cubicBezTo>
                  <a:pt x="596614" y="5011340"/>
                  <a:pt x="429605" y="4925615"/>
                  <a:pt x="276811" y="4825603"/>
                </a:cubicBezTo>
                <a:cubicBezTo>
                  <a:pt x="205743" y="4779169"/>
                  <a:pt x="141783" y="4722018"/>
                  <a:pt x="60055" y="4697016"/>
                </a:cubicBezTo>
                <a:cubicBezTo>
                  <a:pt x="31628" y="4689872"/>
                  <a:pt x="-18119" y="4672013"/>
                  <a:pt x="6755" y="4622006"/>
                </a:cubicBezTo>
                <a:cubicBezTo>
                  <a:pt x="28075" y="4579144"/>
                  <a:pt x="67162" y="4593432"/>
                  <a:pt x="102696" y="4604146"/>
                </a:cubicBezTo>
                <a:cubicBezTo>
                  <a:pt x="187976" y="4632722"/>
                  <a:pt x="280364" y="4632722"/>
                  <a:pt x="397625" y="4632722"/>
                </a:cubicBezTo>
                <a:cubicBezTo>
                  <a:pt x="298131" y="4496990"/>
                  <a:pt x="116909" y="4539853"/>
                  <a:pt x="31628" y="4396978"/>
                </a:cubicBezTo>
                <a:cubicBezTo>
                  <a:pt x="138229" y="4371976"/>
                  <a:pt x="219957" y="4421982"/>
                  <a:pt x="305237" y="4432697"/>
                </a:cubicBezTo>
                <a:cubicBezTo>
                  <a:pt x="383412" y="4443413"/>
                  <a:pt x="401178" y="4418409"/>
                  <a:pt x="383412" y="4339828"/>
                </a:cubicBezTo>
                <a:cubicBezTo>
                  <a:pt x="354985" y="4218385"/>
                  <a:pt x="397625" y="4157662"/>
                  <a:pt x="511333" y="4189810"/>
                </a:cubicBezTo>
                <a:cubicBezTo>
                  <a:pt x="617934" y="4221956"/>
                  <a:pt x="628594" y="4175522"/>
                  <a:pt x="600167" y="4107656"/>
                </a:cubicBezTo>
                <a:cubicBezTo>
                  <a:pt x="557527" y="4007644"/>
                  <a:pt x="603720" y="3929063"/>
                  <a:pt x="635701" y="3843337"/>
                </a:cubicBezTo>
                <a:cubicBezTo>
                  <a:pt x="685448" y="3714750"/>
                  <a:pt x="664128" y="3650456"/>
                  <a:pt x="561080" y="3554015"/>
                </a:cubicBezTo>
                <a:cubicBezTo>
                  <a:pt x="500673" y="3500438"/>
                  <a:pt x="440265" y="3454003"/>
                  <a:pt x="354985" y="3407569"/>
                </a:cubicBezTo>
                <a:cubicBezTo>
                  <a:pt x="550420" y="3382565"/>
                  <a:pt x="347878" y="3296841"/>
                  <a:pt x="415392" y="3243263"/>
                </a:cubicBezTo>
                <a:cubicBezTo>
                  <a:pt x="553973" y="3221831"/>
                  <a:pt x="664128" y="3393282"/>
                  <a:pt x="852456" y="3343275"/>
                </a:cubicBezTo>
                <a:cubicBezTo>
                  <a:pt x="625041" y="3196828"/>
                  <a:pt x="369198" y="3150393"/>
                  <a:pt x="202190" y="2953940"/>
                </a:cubicBezTo>
                <a:cubicBezTo>
                  <a:pt x="241277" y="2911078"/>
                  <a:pt x="280364" y="2953940"/>
                  <a:pt x="312344" y="2936081"/>
                </a:cubicBezTo>
                <a:cubicBezTo>
                  <a:pt x="312344" y="2925365"/>
                  <a:pt x="685448" y="2993232"/>
                  <a:pt x="706768" y="2714625"/>
                </a:cubicBezTo>
                <a:cubicBezTo>
                  <a:pt x="713875" y="2714625"/>
                  <a:pt x="720982" y="2714625"/>
                  <a:pt x="728088" y="2703909"/>
                </a:cubicBezTo>
                <a:cubicBezTo>
                  <a:pt x="767175" y="2664619"/>
                  <a:pt x="731642" y="2571750"/>
                  <a:pt x="795602" y="2564606"/>
                </a:cubicBezTo>
                <a:cubicBezTo>
                  <a:pt x="866670" y="2557462"/>
                  <a:pt x="934184" y="2525315"/>
                  <a:pt x="1008804" y="2543175"/>
                </a:cubicBezTo>
                <a:cubicBezTo>
                  <a:pt x="1065658" y="2557462"/>
                  <a:pt x="1126065" y="2575322"/>
                  <a:pt x="1186473" y="2575322"/>
                </a:cubicBezTo>
                <a:cubicBezTo>
                  <a:pt x="1250433" y="2575322"/>
                  <a:pt x="1339267" y="2696766"/>
                  <a:pt x="1378355" y="2536031"/>
                </a:cubicBezTo>
                <a:cubicBezTo>
                  <a:pt x="1378355" y="2528888"/>
                  <a:pt x="1488509" y="2546747"/>
                  <a:pt x="1548916" y="2553891"/>
                </a:cubicBezTo>
                <a:cubicBezTo>
                  <a:pt x="1598663" y="2561035"/>
                  <a:pt x="1659071" y="2593181"/>
                  <a:pt x="1694604" y="2528888"/>
                </a:cubicBezTo>
                <a:cubicBezTo>
                  <a:pt x="1712371" y="2489596"/>
                  <a:pt x="1627090" y="2418159"/>
                  <a:pt x="1552469" y="2411015"/>
                </a:cubicBezTo>
                <a:cubicBezTo>
                  <a:pt x="1484956" y="2403872"/>
                  <a:pt x="1417442" y="2396728"/>
                  <a:pt x="1353481" y="2411015"/>
                </a:cubicBezTo>
                <a:cubicBezTo>
                  <a:pt x="1275307" y="2428875"/>
                  <a:pt x="1232666" y="2400300"/>
                  <a:pt x="1211346" y="2336007"/>
                </a:cubicBezTo>
                <a:cubicBezTo>
                  <a:pt x="1186473" y="2268141"/>
                  <a:pt x="1140279" y="2232422"/>
                  <a:pt x="1076318" y="2200275"/>
                </a:cubicBezTo>
                <a:cubicBezTo>
                  <a:pt x="919970" y="2121694"/>
                  <a:pt x="770729" y="2028825"/>
                  <a:pt x="600167" y="1982390"/>
                </a:cubicBezTo>
                <a:cubicBezTo>
                  <a:pt x="568187" y="1975246"/>
                  <a:pt x="529100" y="1960959"/>
                  <a:pt x="514886" y="1900238"/>
                </a:cubicBezTo>
                <a:cubicBezTo>
                  <a:pt x="976824" y="1993106"/>
                  <a:pt x="1396121" y="2232422"/>
                  <a:pt x="1872273" y="2218135"/>
                </a:cubicBezTo>
                <a:cubicBezTo>
                  <a:pt x="1744351" y="2143125"/>
                  <a:pt x="1591557" y="2139554"/>
                  <a:pt x="1452975" y="2085975"/>
                </a:cubicBezTo>
                <a:cubicBezTo>
                  <a:pt x="1552469" y="2046685"/>
                  <a:pt x="1644857" y="2089547"/>
                  <a:pt x="1737245" y="2110978"/>
                </a:cubicBezTo>
                <a:cubicBezTo>
                  <a:pt x="1815419" y="2128837"/>
                  <a:pt x="1886486" y="2132410"/>
                  <a:pt x="1893593" y="2021681"/>
                </a:cubicBezTo>
                <a:cubicBezTo>
                  <a:pt x="1893593" y="2010965"/>
                  <a:pt x="1893593" y="2003821"/>
                  <a:pt x="1893593" y="1993106"/>
                </a:cubicBezTo>
                <a:cubicBezTo>
                  <a:pt x="1865166" y="1946672"/>
                  <a:pt x="1826079" y="1925240"/>
                  <a:pt x="1776332" y="1910953"/>
                </a:cubicBezTo>
                <a:cubicBezTo>
                  <a:pt x="1747905" y="1903809"/>
                  <a:pt x="1708818" y="1889522"/>
                  <a:pt x="1708818" y="1857375"/>
                </a:cubicBezTo>
                <a:cubicBezTo>
                  <a:pt x="1712371" y="1735931"/>
                  <a:pt x="1616430" y="1700212"/>
                  <a:pt x="1524043" y="1664493"/>
                </a:cubicBezTo>
                <a:cubicBezTo>
                  <a:pt x="1573790" y="1603772"/>
                  <a:pt x="1616430" y="1646635"/>
                  <a:pt x="1655517" y="1643062"/>
                </a:cubicBezTo>
                <a:cubicBezTo>
                  <a:pt x="1680391" y="1639491"/>
                  <a:pt x="1705264" y="1635919"/>
                  <a:pt x="1705264" y="1603772"/>
                </a:cubicBezTo>
                <a:cubicBezTo>
                  <a:pt x="1705264" y="1578769"/>
                  <a:pt x="1694604" y="1546622"/>
                  <a:pt x="1669731" y="1546622"/>
                </a:cubicBezTo>
                <a:cubicBezTo>
                  <a:pt x="1513383" y="1543050"/>
                  <a:pt x="1424548" y="1371600"/>
                  <a:pt x="1261093" y="1371600"/>
                </a:cubicBezTo>
                <a:cubicBezTo>
                  <a:pt x="1161599" y="1371600"/>
                  <a:pt x="1310841" y="1275159"/>
                  <a:pt x="1229113" y="1235869"/>
                </a:cubicBezTo>
                <a:cubicBezTo>
                  <a:pt x="1211346" y="1225153"/>
                  <a:pt x="1278860" y="1210866"/>
                  <a:pt x="1307287" y="1214437"/>
                </a:cubicBezTo>
                <a:cubicBezTo>
                  <a:pt x="1335714" y="1218009"/>
                  <a:pt x="1360588" y="1243013"/>
                  <a:pt x="1396121" y="1225153"/>
                </a:cubicBezTo>
                <a:cubicBezTo>
                  <a:pt x="1413888" y="1160860"/>
                  <a:pt x="1367694" y="1135856"/>
                  <a:pt x="1325054" y="1117997"/>
                </a:cubicBezTo>
                <a:cubicBezTo>
                  <a:pt x="1232666" y="1075135"/>
                  <a:pt x="1140279" y="1025129"/>
                  <a:pt x="1037231" y="1010841"/>
                </a:cubicBezTo>
                <a:cubicBezTo>
                  <a:pt x="1001698" y="1007269"/>
                  <a:pt x="980377" y="989409"/>
                  <a:pt x="983931" y="953690"/>
                </a:cubicBezTo>
                <a:cubicBezTo>
                  <a:pt x="991037" y="907256"/>
                  <a:pt x="1026571" y="921544"/>
                  <a:pt x="1054998" y="925115"/>
                </a:cubicBezTo>
                <a:cubicBezTo>
                  <a:pt x="1072765" y="928688"/>
                  <a:pt x="1090532" y="939403"/>
                  <a:pt x="1108299" y="914400"/>
                </a:cubicBezTo>
                <a:cubicBezTo>
                  <a:pt x="692555" y="660797"/>
                  <a:pt x="472246" y="675085"/>
                  <a:pt x="6755" y="467915"/>
                </a:cubicBezTo>
                <a:cubicBezTo>
                  <a:pt x="109802" y="428625"/>
                  <a:pt x="184423" y="457200"/>
                  <a:pt x="255490" y="464344"/>
                </a:cubicBezTo>
                <a:cubicBezTo>
                  <a:pt x="433159" y="482203"/>
                  <a:pt x="323004" y="514350"/>
                  <a:pt x="500673" y="535781"/>
                </a:cubicBezTo>
                <a:cubicBezTo>
                  <a:pt x="585954" y="546497"/>
                  <a:pt x="664128" y="582216"/>
                  <a:pt x="760069" y="525066"/>
                </a:cubicBezTo>
                <a:cubicBezTo>
                  <a:pt x="824029" y="485775"/>
                  <a:pt x="927077" y="528637"/>
                  <a:pt x="1005251" y="560785"/>
                </a:cubicBezTo>
                <a:cubicBezTo>
                  <a:pt x="1069212" y="589360"/>
                  <a:pt x="1133172" y="596503"/>
                  <a:pt x="1218453" y="560785"/>
                </a:cubicBezTo>
                <a:cubicBezTo>
                  <a:pt x="1140279" y="539354"/>
                  <a:pt x="1079872" y="521494"/>
                  <a:pt x="1019464" y="507206"/>
                </a:cubicBezTo>
                <a:cubicBezTo>
                  <a:pt x="969717" y="496491"/>
                  <a:pt x="941290" y="471488"/>
                  <a:pt x="944844" y="417909"/>
                </a:cubicBezTo>
                <a:cubicBezTo>
                  <a:pt x="944844" y="389334"/>
                  <a:pt x="934184" y="350044"/>
                  <a:pt x="969717" y="335757"/>
                </a:cubicBezTo>
                <a:cubicBezTo>
                  <a:pt x="998144" y="321469"/>
                  <a:pt x="1037231" y="335757"/>
                  <a:pt x="1051445" y="360759"/>
                </a:cubicBezTo>
                <a:cubicBezTo>
                  <a:pt x="1069212" y="407194"/>
                  <a:pt x="1086978" y="450056"/>
                  <a:pt x="1147386" y="453629"/>
                </a:cubicBezTo>
                <a:cubicBezTo>
                  <a:pt x="1229113" y="460771"/>
                  <a:pt x="1182919" y="432197"/>
                  <a:pt x="1168706" y="396478"/>
                </a:cubicBezTo>
                <a:cubicBezTo>
                  <a:pt x="1154492" y="357188"/>
                  <a:pt x="1197133" y="346472"/>
                  <a:pt x="1225560" y="353615"/>
                </a:cubicBezTo>
                <a:cubicBezTo>
                  <a:pt x="1332161" y="385763"/>
                  <a:pt x="1442315" y="328613"/>
                  <a:pt x="1552469" y="375047"/>
                </a:cubicBezTo>
                <a:cubicBezTo>
                  <a:pt x="1524043" y="260747"/>
                  <a:pt x="1463635" y="210741"/>
                  <a:pt x="1335714" y="192881"/>
                </a:cubicBezTo>
                <a:cubicBezTo>
                  <a:pt x="1289520" y="189310"/>
                  <a:pt x="1239773" y="196453"/>
                  <a:pt x="1197133" y="164306"/>
                </a:cubicBezTo>
                <a:cubicBezTo>
                  <a:pt x="1172259" y="146447"/>
                  <a:pt x="1147386" y="125016"/>
                  <a:pt x="1165153" y="89297"/>
                </a:cubicBezTo>
                <a:cubicBezTo>
                  <a:pt x="1175813" y="64294"/>
                  <a:pt x="1204239" y="64294"/>
                  <a:pt x="1229113" y="71437"/>
                </a:cubicBezTo>
                <a:cubicBezTo>
                  <a:pt x="1332161" y="110728"/>
                  <a:pt x="1442315" y="121444"/>
                  <a:pt x="1548916" y="135731"/>
                </a:cubicBezTo>
                <a:cubicBezTo>
                  <a:pt x="1566683" y="139303"/>
                  <a:pt x="1584450" y="146447"/>
                  <a:pt x="1602217" y="110728"/>
                </a:cubicBezTo>
                <a:cubicBezTo>
                  <a:pt x="1477849" y="78581"/>
                  <a:pt x="1357034" y="35719"/>
                  <a:pt x="1232666" y="0"/>
                </a:cubicBezTo>
                <a:close/>
              </a:path>
            </a:pathLst>
          </a:custGeom>
          <a:solidFill>
            <a:schemeClr val="accent1">
              <a:alpha val="20000"/>
            </a:schemeClr>
          </a:solidFill>
          <a:ln w="32707" cap="flat">
            <a:noFill/>
            <a:prstDash val="solid"/>
            <a:miter/>
          </a:ln>
        </p:spPr>
        <p:txBody>
          <a:bodyPr rtlCol="0" anchor="ctr"/>
          <a:lstStyle/>
          <a:p>
            <a:endParaRPr lang="en-US">
              <a:solidFill>
                <a:schemeClr val="tx1"/>
              </a:solidFill>
            </a:endParaRPr>
          </a:p>
        </p:txBody>
      </p:sp>
      <p:sp>
        <p:nvSpPr>
          <p:cNvPr id="2" name="Title 1">
            <a:extLst>
              <a:ext uri="{FF2B5EF4-FFF2-40B4-BE49-F238E27FC236}">
                <a16:creationId xmlns:a16="http://schemas.microsoft.com/office/drawing/2014/main" id="{146AD042-DE90-4088-8A07-B9A64C2CE03E}"/>
              </a:ext>
            </a:extLst>
          </p:cNvPr>
          <p:cNvSpPr>
            <a:spLocks noGrp="1"/>
          </p:cNvSpPr>
          <p:nvPr>
            <p:ph type="title"/>
          </p:nvPr>
        </p:nvSpPr>
        <p:spPr>
          <a:xfrm>
            <a:off x="839788" y="640080"/>
            <a:ext cx="3886200" cy="2953512"/>
          </a:xfrm>
        </p:spPr>
        <p:txBody>
          <a:bodyPr anchor="b"/>
          <a:lstStyle>
            <a:lvl1pPr>
              <a:defRPr sz="32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BF2FFC98-62A0-445A-BEDA-785BE925A1D8}"/>
              </a:ext>
            </a:extLst>
          </p:cNvPr>
          <p:cNvSpPr>
            <a:spLocks noGrp="1"/>
          </p:cNvSpPr>
          <p:nvPr>
            <p:ph idx="1"/>
          </p:nvPr>
        </p:nvSpPr>
        <p:spPr>
          <a:xfrm>
            <a:off x="7059168" y="640080"/>
            <a:ext cx="4489704" cy="5596128"/>
          </a:xfrm>
        </p:spPr>
        <p:txBody>
          <a:bodyPr anchor="ct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a:extLst>
              <a:ext uri="{FF2B5EF4-FFF2-40B4-BE49-F238E27FC236}">
                <a16:creationId xmlns:a16="http://schemas.microsoft.com/office/drawing/2014/main" id="{DB4D7827-8489-4EE4-88EE-16685FE6DE8A}"/>
              </a:ext>
            </a:extLst>
          </p:cNvPr>
          <p:cNvSpPr>
            <a:spLocks noGrp="1"/>
          </p:cNvSpPr>
          <p:nvPr>
            <p:ph type="body" sz="half" idx="2"/>
          </p:nvPr>
        </p:nvSpPr>
        <p:spPr>
          <a:xfrm>
            <a:off x="839788" y="3776472"/>
            <a:ext cx="3886200" cy="2468880"/>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C33534F-EA91-4A50-B0F6-10D689E458EF}"/>
              </a:ext>
            </a:extLst>
          </p:cNvPr>
          <p:cNvSpPr>
            <a:spLocks noGrp="1"/>
          </p:cNvSpPr>
          <p:nvPr>
            <p:ph type="dt" sz="half" idx="10"/>
          </p:nvPr>
        </p:nvSpPr>
        <p:spPr/>
        <p:txBody>
          <a:bodyPr/>
          <a:lstStyle/>
          <a:p>
            <a:fld id="{3C04E684-10F4-4CC3-A0B9-F03AA7BE37CF}" type="datetimeFigureOut">
              <a:rPr lang="en-US" smtClean="0"/>
              <a:t>3/27/26</a:t>
            </a:fld>
            <a:endParaRPr lang="en-US"/>
          </a:p>
        </p:txBody>
      </p:sp>
      <p:sp>
        <p:nvSpPr>
          <p:cNvPr id="6" name="Footer Placeholder 5">
            <a:extLst>
              <a:ext uri="{FF2B5EF4-FFF2-40B4-BE49-F238E27FC236}">
                <a16:creationId xmlns:a16="http://schemas.microsoft.com/office/drawing/2014/main" id="{6C20F3F7-8B4B-4015-AA9C-109D05B2F146}"/>
              </a:ext>
            </a:extLst>
          </p:cNvPr>
          <p:cNvSpPr>
            <a:spLocks noGrp="1"/>
          </p:cNvSpPr>
          <p:nvPr>
            <p:ph type="ftr" sz="quarter" idx="11"/>
          </p:nvPr>
        </p:nvSpPr>
        <p:spPr/>
        <p:txBody>
          <a:bodyPr/>
          <a:lstStyle>
            <a:lvl1pPr algn="l">
              <a:defRPr/>
            </a:lvl1pPr>
          </a:lstStyle>
          <a:p>
            <a:endParaRPr lang="en-US"/>
          </a:p>
        </p:txBody>
      </p:sp>
      <p:sp>
        <p:nvSpPr>
          <p:cNvPr id="7" name="Slide Number Placeholder 6">
            <a:extLst>
              <a:ext uri="{FF2B5EF4-FFF2-40B4-BE49-F238E27FC236}">
                <a16:creationId xmlns:a16="http://schemas.microsoft.com/office/drawing/2014/main" id="{910B6EE2-78A1-4D01-87BE-A1487FBD271F}"/>
              </a:ext>
            </a:extLst>
          </p:cNvPr>
          <p:cNvSpPr>
            <a:spLocks noGrp="1"/>
          </p:cNvSpPr>
          <p:nvPr>
            <p:ph type="sldNum" sz="quarter" idx="12"/>
          </p:nvPr>
        </p:nvSpPr>
        <p:spPr/>
        <p:txBody>
          <a:bodyPr/>
          <a:lstStyle/>
          <a:p>
            <a:fld id="{51845F5A-061D-4825-9AE9-D7794091C6CF}" type="slidenum">
              <a:rPr lang="en-US" smtClean="0"/>
              <a:t>‹#›</a:t>
            </a:fld>
            <a:endParaRPr lang="en-US"/>
          </a:p>
        </p:txBody>
      </p:sp>
    </p:spTree>
    <p:extLst>
      <p:ext uri="{BB962C8B-B14F-4D97-AF65-F5344CB8AC3E}">
        <p14:creationId xmlns:p14="http://schemas.microsoft.com/office/powerpoint/2010/main" val="11894576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13" Type="http://schemas.openxmlformats.org/officeDocument/2006/relationships/theme" Target="../theme/theme2.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slideLayout" Target="../slideLayouts/slideLayout24.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2.xml"/><Relationship Id="rId13" Type="http://schemas.openxmlformats.org/officeDocument/2006/relationships/theme" Target="../theme/theme3.xml"/><Relationship Id="rId3" Type="http://schemas.openxmlformats.org/officeDocument/2006/relationships/slideLayout" Target="../slideLayouts/slideLayout27.xml"/><Relationship Id="rId7" Type="http://schemas.openxmlformats.org/officeDocument/2006/relationships/slideLayout" Target="../slideLayouts/slideLayout31.xml"/><Relationship Id="rId12" Type="http://schemas.openxmlformats.org/officeDocument/2006/relationships/slideLayout" Target="../slideLayouts/slideLayout36.xml"/><Relationship Id="rId2" Type="http://schemas.openxmlformats.org/officeDocument/2006/relationships/slideLayout" Target="../slideLayouts/slideLayout26.xml"/><Relationship Id="rId1" Type="http://schemas.openxmlformats.org/officeDocument/2006/relationships/slideLayout" Target="../slideLayouts/slideLayout25.xml"/><Relationship Id="rId6" Type="http://schemas.openxmlformats.org/officeDocument/2006/relationships/slideLayout" Target="../slideLayouts/slideLayout30.xml"/><Relationship Id="rId11" Type="http://schemas.openxmlformats.org/officeDocument/2006/relationships/slideLayout" Target="../slideLayouts/slideLayout35.xml"/><Relationship Id="rId5" Type="http://schemas.openxmlformats.org/officeDocument/2006/relationships/slideLayout" Target="../slideLayouts/slideLayout29.xml"/><Relationship Id="rId10" Type="http://schemas.openxmlformats.org/officeDocument/2006/relationships/slideLayout" Target="../slideLayouts/slideLayout34.xml"/><Relationship Id="rId4" Type="http://schemas.openxmlformats.org/officeDocument/2006/relationships/slideLayout" Target="../slideLayouts/slideLayout28.xml"/><Relationship Id="rId9" Type="http://schemas.openxmlformats.org/officeDocument/2006/relationships/slideLayout" Target="../slideLayouts/slideLayout33.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8615C6B-1C98-4B1C-AB4B-1E1898E593B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2E8DFF97-B7FD-47F9-BC7F-DD4B4C5EA2F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A1831D22-079E-43E3-86A4-BA12DB888C7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C04E684-10F4-4CC3-A0B9-F03AA7BE37CF}" type="datetimeFigureOut">
              <a:rPr lang="en-US" smtClean="0"/>
              <a:t>3/27/26</a:t>
            </a:fld>
            <a:endParaRPr lang="en-US"/>
          </a:p>
        </p:txBody>
      </p:sp>
      <p:sp>
        <p:nvSpPr>
          <p:cNvPr id="5" name="Footer Placeholder 4">
            <a:extLst>
              <a:ext uri="{FF2B5EF4-FFF2-40B4-BE49-F238E27FC236}">
                <a16:creationId xmlns:a16="http://schemas.microsoft.com/office/drawing/2014/main" id="{A14C30A2-140B-4A5D-BEEC-C1314AF1F3F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B71BA8F-7826-496D-91F8-B3ECDF34DA7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1845F5A-061D-4825-9AE9-D7794091C6CF}" type="slidenum">
              <a:rPr lang="en-US" smtClean="0"/>
              <a:t>‹#›</a:t>
            </a:fld>
            <a:endParaRPr lang="en-US"/>
          </a:p>
        </p:txBody>
      </p:sp>
    </p:spTree>
    <p:extLst>
      <p:ext uri="{BB962C8B-B14F-4D97-AF65-F5344CB8AC3E}">
        <p14:creationId xmlns:p14="http://schemas.microsoft.com/office/powerpoint/2010/main" val="371994077"/>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01" r:id="rId5"/>
    <p:sldLayoutId id="2147483702" r:id="rId6"/>
    <p:sldLayoutId id="2147483708" r:id="rId7"/>
    <p:sldLayoutId id="2147483703" r:id="rId8"/>
    <p:sldLayoutId id="2147483704" r:id="rId9"/>
    <p:sldLayoutId id="2147483705" r:id="rId10"/>
    <p:sldLayoutId id="2147483706" r:id="rId11"/>
    <p:sldLayoutId id="2147483707" r:id="rId12"/>
  </p:sldLayoutIdLst>
  <p:txStyles>
    <p:titleStyle>
      <a:lvl1pPr algn="l" defTabSz="914400" rtl="0" eaLnBrk="1" latinLnBrk="0" hangingPunct="1">
        <a:lnSpc>
          <a:spcPct val="90000"/>
        </a:lnSpc>
        <a:spcBef>
          <a:spcPct val="0"/>
        </a:spcBef>
        <a:buNone/>
        <a:defRPr sz="4000" i="0" kern="1200">
          <a:solidFill>
            <a:schemeClr val="tx1"/>
          </a:solidFill>
          <a:latin typeface="+mj-lt"/>
          <a:ea typeface="+mj-ea"/>
          <a:cs typeface="+mj-cs"/>
        </a:defRPr>
      </a:lvl1pPr>
    </p:titleStyle>
    <p:bodyStyle>
      <a:lvl1pPr marL="228600" indent="-228600" algn="l" defTabSz="914400" rtl="0" eaLnBrk="1" latinLnBrk="0" hangingPunct="1">
        <a:lnSpc>
          <a:spcPct val="10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10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10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8615C6B-1C98-4B1C-AB4B-1E1898E593B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2E8DFF97-B7FD-47F9-BC7F-DD4B4C5EA2F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A1831D22-079E-43E3-86A4-BA12DB888C7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A14C30A2-140B-4A5D-BEEC-C1314AF1F3F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1B71BA8F-7826-496D-91F8-B3ECDF34DA7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751563125"/>
      </p:ext>
    </p:extLst>
  </p:cSld>
  <p:clrMap bg1="lt1" tx1="dk1" bg2="lt2" tx2="dk2" accent1="accent1" accent2="accent2" accent3="accent3" accent4="accent4" accent5="accent5" accent6="accent6" hlink="hlink" folHlink="folHlink"/>
  <p:sldLayoutIdLst>
    <p:sldLayoutId id="2147483739" r:id="rId1"/>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 id="2147483750" r:id="rId12"/>
  </p:sldLayoutIdLst>
  <p:txStyles>
    <p:titleStyle>
      <a:lvl1pPr algn="l" defTabSz="914400" rtl="0" eaLnBrk="1" latinLnBrk="0" hangingPunct="1">
        <a:lnSpc>
          <a:spcPct val="90000"/>
        </a:lnSpc>
        <a:spcBef>
          <a:spcPct val="0"/>
        </a:spcBef>
        <a:buNone/>
        <a:defRPr sz="4000" i="0" kern="1200">
          <a:solidFill>
            <a:schemeClr val="tx1"/>
          </a:solidFill>
          <a:latin typeface="+mj-lt"/>
          <a:ea typeface="+mj-ea"/>
          <a:cs typeface="+mj-cs"/>
        </a:defRPr>
      </a:lvl1pPr>
    </p:titleStyle>
    <p:bodyStyle>
      <a:lvl1pPr marL="228600" indent="-228600" algn="l" defTabSz="914400" rtl="0" eaLnBrk="1" latinLnBrk="0" hangingPunct="1">
        <a:lnSpc>
          <a:spcPct val="10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10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10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8615C6B-1C98-4B1C-AB4B-1E1898E593B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2E8DFF97-B7FD-47F9-BC7F-DD4B4C5EA2F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A1831D22-079E-43E3-86A4-BA12DB888C7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C04E684-10F4-4CC3-A0B9-F03AA7BE37CF}" type="datetimeFigureOut">
              <a:rPr lang="en-US" smtClean="0">
                <a:solidFill>
                  <a:prstClr val="black">
                    <a:tint val="75000"/>
                  </a:prstClr>
                </a:solidFill>
              </a:rPr>
              <a:pPr/>
              <a:t>3/27/26</a:t>
            </a:fld>
            <a:endParaRPr lang="en-US">
              <a:solidFill>
                <a:prstClr val="black">
                  <a:tint val="75000"/>
                </a:prstClr>
              </a:solidFill>
            </a:endParaRPr>
          </a:p>
        </p:txBody>
      </p:sp>
      <p:sp>
        <p:nvSpPr>
          <p:cNvPr id="5" name="Footer Placeholder 4">
            <a:extLst>
              <a:ext uri="{FF2B5EF4-FFF2-40B4-BE49-F238E27FC236}">
                <a16:creationId xmlns:a16="http://schemas.microsoft.com/office/drawing/2014/main" id="{A14C30A2-140B-4A5D-BEEC-C1314AF1F3F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endParaRPr>
          </a:p>
        </p:txBody>
      </p:sp>
      <p:sp>
        <p:nvSpPr>
          <p:cNvPr id="6" name="Slide Number Placeholder 5">
            <a:extLst>
              <a:ext uri="{FF2B5EF4-FFF2-40B4-BE49-F238E27FC236}">
                <a16:creationId xmlns:a16="http://schemas.microsoft.com/office/drawing/2014/main" id="{1B71BA8F-7826-496D-91F8-B3ECDF34DA7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1845F5A-061D-4825-9AE9-D7794091C6CF}"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372091965"/>
      </p:ext>
    </p:extLst>
  </p:cSld>
  <p:clrMap bg1="lt1" tx1="dk1" bg2="lt2" tx2="dk2" accent1="accent1" accent2="accent2" accent3="accent3" accent4="accent4" accent5="accent5" accent6="accent6" hlink="hlink" folHlink="folHlink"/>
  <p:sldLayoutIdLst>
    <p:sldLayoutId id="2147483752" r:id="rId1"/>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 id="2147483763" r:id="rId12"/>
  </p:sldLayoutIdLst>
  <p:txStyles>
    <p:titleStyle>
      <a:lvl1pPr algn="l" defTabSz="914400" rtl="0" eaLnBrk="1" latinLnBrk="0" hangingPunct="1">
        <a:lnSpc>
          <a:spcPct val="90000"/>
        </a:lnSpc>
        <a:spcBef>
          <a:spcPct val="0"/>
        </a:spcBef>
        <a:buNone/>
        <a:defRPr sz="4000" i="0" kern="1200">
          <a:solidFill>
            <a:schemeClr val="tx1"/>
          </a:solidFill>
          <a:latin typeface="+mj-lt"/>
          <a:ea typeface="+mj-ea"/>
          <a:cs typeface="+mj-cs"/>
        </a:defRPr>
      </a:lvl1pPr>
    </p:titleStyle>
    <p:bodyStyle>
      <a:lvl1pPr marL="228600" indent="-228600" algn="l" defTabSz="914400" rtl="0" eaLnBrk="1" latinLnBrk="0" hangingPunct="1">
        <a:lnSpc>
          <a:spcPct val="10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10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10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image" Target="../media/image12.svg"/></Relationships>
</file>

<file path=ppt/slides/_rels/slide13.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image" Target="../media/image14.svg"/></Relationships>
</file>

<file path=ppt/slides/_rels/slide1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16.svg"/></Relationships>
</file>

<file path=ppt/slides/_rels/slide1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image" Target="../media/image18.svg"/></Relationships>
</file>

<file path=ppt/slides/_rels/slide16.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image" Target="../media/image20.svg"/></Relationships>
</file>

<file path=ppt/slides/_rels/slide17.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image" Target="../media/image22.svg"/></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3" Type="http://schemas.openxmlformats.org/officeDocument/2006/relationships/hyperlink" Target="https://collections.mfa.org/advancedsearch/Objects/peopleSearch:Eastman%20Johnson" TargetMode="External"/><Relationship Id="rId2" Type="http://schemas.openxmlformats.org/officeDocument/2006/relationships/notesSlide" Target="../notesSlides/notesSlide19.xml"/><Relationship Id="rId1" Type="http://schemas.openxmlformats.org/officeDocument/2006/relationships/slideLayout" Target="../slideLayouts/slideLayout2.xml"/><Relationship Id="rId4" Type="http://schemas.openxmlformats.org/officeDocument/2006/relationships/image" Target="../media/image23.jpg"/></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0.xml.rels><?xml version="1.0" encoding="UTF-8" standalone="yes"?>
<Relationships xmlns="http://schemas.openxmlformats.org/package/2006/relationships"><Relationship Id="rId3" Type="http://schemas.openxmlformats.org/officeDocument/2006/relationships/image" Target="../media/image24.jpe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25.jpe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26.jpe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27.jpe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28.jpeg"/><Relationship Id="rId2" Type="http://schemas.openxmlformats.org/officeDocument/2006/relationships/notesSlide" Target="../notesSlides/notesSlide24.xml"/><Relationship Id="rId1" Type="http://schemas.openxmlformats.org/officeDocument/2006/relationships/slideLayout" Target="../slideLayouts/slideLayout2.xml"/><Relationship Id="rId4" Type="http://schemas.openxmlformats.org/officeDocument/2006/relationships/image" Target="https://upload.wikimedia.org/wikipedia/commons/thumb/5/53/Edvard_Munch_-_Inheritance.jpg/500px-Edvard_Munch_-_Inheritance.jpg?20190509073538" TargetMode="External"/></Relationships>
</file>

<file path=ppt/slides/_rels/slide25.xml.rels><?xml version="1.0" encoding="UTF-8" standalone="yes"?>
<Relationships xmlns="http://schemas.openxmlformats.org/package/2006/relationships"><Relationship Id="rId3" Type="http://schemas.openxmlformats.org/officeDocument/2006/relationships/image" Target="../media/image29.jpe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30.jpe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31.jpe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32.jpeg"/><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33.jpeg"/><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34.jpe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35.jpeg"/><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36.jpeg"/><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37.jpeg"/><Relationship Id="rId2" Type="http://schemas.openxmlformats.org/officeDocument/2006/relationships/notesSlide" Target="../notesSlides/notesSlide33.xml"/><Relationship Id="rId1" Type="http://schemas.openxmlformats.org/officeDocument/2006/relationships/slideLayout" Target="../slideLayouts/slideLayout2.xml"/><Relationship Id="rId4" Type="http://schemas.openxmlformats.org/officeDocument/2006/relationships/image" Target="https://upload.wikimedia.org/wikipedia/commons/thumb/8/82/Jan_steen%2C_la_malata%2C_1660_ca.jpg/960px-Jan_steen%2C_la_malata%2C_1660_ca.jpg?20180311151457" TargetMode="External"/></Relationships>
</file>

<file path=ppt/slides/_rels/slide34.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4.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35.xml"/><Relationship Id="rId1" Type="http://schemas.openxmlformats.org/officeDocument/2006/relationships/slideLayout" Target="../slideLayouts/slideLayout2.xml"/><Relationship Id="rId4" Type="http://schemas.openxmlformats.org/officeDocument/2006/relationships/image" Target="../media/image39.sv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0" name="Rectangle 19">
            <a:extLst>
              <a:ext uri="{FF2B5EF4-FFF2-40B4-BE49-F238E27FC236}">
                <a16:creationId xmlns:a16="http://schemas.microsoft.com/office/drawing/2014/main" id="{8A8E2B3D-9013-49DD-AD19-465E6B843E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Freeform: Shape 17">
            <a:extLst>
              <a:ext uri="{FF2B5EF4-FFF2-40B4-BE49-F238E27FC236}">
                <a16:creationId xmlns:a16="http://schemas.microsoft.com/office/drawing/2014/main" id="{9420F6C3-AAF3-4091-9B71-5FB534BD49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6169896" y="0"/>
            <a:ext cx="6022105" cy="6858000"/>
          </a:xfrm>
          <a:custGeom>
            <a:avLst/>
            <a:gdLst>
              <a:gd name="connsiteX0" fmla="*/ 606846 w 6022105"/>
              <a:gd name="connsiteY0" fmla="*/ 0 h 6858000"/>
              <a:gd name="connsiteX1" fmla="*/ 6022105 w 6022105"/>
              <a:gd name="connsiteY1" fmla="*/ 0 h 6858000"/>
              <a:gd name="connsiteX2" fmla="*/ 6022105 w 6022105"/>
              <a:gd name="connsiteY2" fmla="*/ 6858000 h 6858000"/>
              <a:gd name="connsiteX3" fmla="*/ 0 w 6022105"/>
              <a:gd name="connsiteY3" fmla="*/ 6858000 h 6858000"/>
              <a:gd name="connsiteX4" fmla="*/ 374372 w 6022105"/>
              <a:gd name="connsiteY4" fmla="*/ 6658805 h 6858000"/>
              <a:gd name="connsiteX5" fmla="*/ 537405 w 6022105"/>
              <a:gd name="connsiteY5" fmla="*/ 6431153 h 6858000"/>
              <a:gd name="connsiteX6" fmla="*/ 594769 w 6022105"/>
              <a:gd name="connsiteY6" fmla="*/ 6367127 h 6858000"/>
              <a:gd name="connsiteX7" fmla="*/ 736668 w 6022105"/>
              <a:gd name="connsiteY7" fmla="*/ 6281757 h 6858000"/>
              <a:gd name="connsiteX8" fmla="*/ 984239 w 6022105"/>
              <a:gd name="connsiteY8" fmla="*/ 6100347 h 6858000"/>
              <a:gd name="connsiteX9" fmla="*/ 893664 w 6022105"/>
              <a:gd name="connsiteY9" fmla="*/ 6057663 h 6858000"/>
              <a:gd name="connsiteX10" fmla="*/ 631000 w 6022105"/>
              <a:gd name="connsiteY10" fmla="*/ 6167932 h 6858000"/>
              <a:gd name="connsiteX11" fmla="*/ 440793 w 6022105"/>
              <a:gd name="connsiteY11" fmla="*/ 6196388 h 6858000"/>
              <a:gd name="connsiteX12" fmla="*/ 709496 w 6022105"/>
              <a:gd name="connsiteY12" fmla="*/ 6004307 h 6858000"/>
              <a:gd name="connsiteX13" fmla="*/ 969143 w 6022105"/>
              <a:gd name="connsiteY13" fmla="*/ 5755314 h 6858000"/>
              <a:gd name="connsiteX14" fmla="*/ 769879 w 6022105"/>
              <a:gd name="connsiteY14" fmla="*/ 5801555 h 6858000"/>
              <a:gd name="connsiteX15" fmla="*/ 760822 w 6022105"/>
              <a:gd name="connsiteY15" fmla="*/ 5769542 h 6858000"/>
              <a:gd name="connsiteX16" fmla="*/ 935933 w 6022105"/>
              <a:gd name="connsiteY16" fmla="*/ 5474306 h 6858000"/>
              <a:gd name="connsiteX17" fmla="*/ 1020468 w 6022105"/>
              <a:gd name="connsiteY17" fmla="*/ 5353367 h 6858000"/>
              <a:gd name="connsiteX18" fmla="*/ 1406918 w 6022105"/>
              <a:gd name="connsiteY18" fmla="*/ 4994104 h 6858000"/>
              <a:gd name="connsiteX19" fmla="*/ 1038583 w 6022105"/>
              <a:gd name="connsiteY19" fmla="*/ 5154171 h 6858000"/>
              <a:gd name="connsiteX20" fmla="*/ 1418994 w 6022105"/>
              <a:gd name="connsiteY20" fmla="*/ 4805580 h 6858000"/>
              <a:gd name="connsiteX21" fmla="*/ 1603162 w 6022105"/>
              <a:gd name="connsiteY21" fmla="*/ 4677526 h 6858000"/>
              <a:gd name="connsiteX22" fmla="*/ 1648449 w 6022105"/>
              <a:gd name="connsiteY22" fmla="*/ 4602828 h 6858000"/>
              <a:gd name="connsiteX23" fmla="*/ 1566931 w 6022105"/>
              <a:gd name="connsiteY23" fmla="*/ 4585042 h 6858000"/>
              <a:gd name="connsiteX24" fmla="*/ 1316344 w 6022105"/>
              <a:gd name="connsiteY24" fmla="*/ 4613499 h 6858000"/>
              <a:gd name="connsiteX25" fmla="*/ 1627315 w 6022105"/>
              <a:gd name="connsiteY25" fmla="*/ 4378734 h 6858000"/>
              <a:gd name="connsiteX26" fmla="*/ 1394842 w 6022105"/>
              <a:gd name="connsiteY26" fmla="*/ 4414305 h 6858000"/>
              <a:gd name="connsiteX27" fmla="*/ 1328419 w 6022105"/>
              <a:gd name="connsiteY27" fmla="*/ 4321821 h 6858000"/>
              <a:gd name="connsiteX28" fmla="*/ 1219731 w 6022105"/>
              <a:gd name="connsiteY28" fmla="*/ 4172424 h 6858000"/>
              <a:gd name="connsiteX29" fmla="*/ 1144253 w 6022105"/>
              <a:gd name="connsiteY29" fmla="*/ 4090612 h 6858000"/>
              <a:gd name="connsiteX30" fmla="*/ 1114061 w 6022105"/>
              <a:gd name="connsiteY30" fmla="*/ 3827390 h 6858000"/>
              <a:gd name="connsiteX31" fmla="*/ 1177463 w 6022105"/>
              <a:gd name="connsiteY31" fmla="*/ 3539269 h 6858000"/>
              <a:gd name="connsiteX32" fmla="*/ 1352573 w 6022105"/>
              <a:gd name="connsiteY32" fmla="*/ 3393429 h 6858000"/>
              <a:gd name="connsiteX33" fmla="*/ 1301248 w 6022105"/>
              <a:gd name="connsiteY33" fmla="*/ 3229805 h 6858000"/>
              <a:gd name="connsiteX34" fmla="*/ 929894 w 6022105"/>
              <a:gd name="connsiteY34" fmla="*/ 3329402 h 6858000"/>
              <a:gd name="connsiteX35" fmla="*/ 1482396 w 6022105"/>
              <a:gd name="connsiteY35" fmla="*/ 2941684 h 6858000"/>
              <a:gd name="connsiteX36" fmla="*/ 1388803 w 6022105"/>
              <a:gd name="connsiteY36" fmla="*/ 2923898 h 6858000"/>
              <a:gd name="connsiteX37" fmla="*/ 1053678 w 6022105"/>
              <a:gd name="connsiteY37" fmla="*/ 2703362 h 6858000"/>
              <a:gd name="connsiteX38" fmla="*/ 1035564 w 6022105"/>
              <a:gd name="connsiteY38" fmla="*/ 2692689 h 6858000"/>
              <a:gd name="connsiteX39" fmla="*/ 978200 w 6022105"/>
              <a:gd name="connsiteY39" fmla="*/ 2553965 h 6858000"/>
              <a:gd name="connsiteX40" fmla="*/ 797052 w 6022105"/>
              <a:gd name="connsiteY40" fmla="*/ 2532623 h 6858000"/>
              <a:gd name="connsiteX41" fmla="*/ 646095 w 6022105"/>
              <a:gd name="connsiteY41" fmla="*/ 2564636 h 6858000"/>
              <a:gd name="connsiteX42" fmla="*/ 483061 w 6022105"/>
              <a:gd name="connsiteY42" fmla="*/ 2525509 h 6858000"/>
              <a:gd name="connsiteX43" fmla="*/ 338143 w 6022105"/>
              <a:gd name="connsiteY43" fmla="*/ 2543294 h 6858000"/>
              <a:gd name="connsiteX44" fmla="*/ 214358 w 6022105"/>
              <a:gd name="connsiteY44" fmla="*/ 2518395 h 6858000"/>
              <a:gd name="connsiteX45" fmla="*/ 335123 w 6022105"/>
              <a:gd name="connsiteY45" fmla="*/ 2401012 h 6858000"/>
              <a:gd name="connsiteX46" fmla="*/ 504195 w 6022105"/>
              <a:gd name="connsiteY46" fmla="*/ 2401012 h 6858000"/>
              <a:gd name="connsiteX47" fmla="*/ 624961 w 6022105"/>
              <a:gd name="connsiteY47" fmla="*/ 2326314 h 6858000"/>
              <a:gd name="connsiteX48" fmla="*/ 739688 w 6022105"/>
              <a:gd name="connsiteY48" fmla="*/ 2191146 h 6858000"/>
              <a:gd name="connsiteX49" fmla="*/ 1144253 w 6022105"/>
              <a:gd name="connsiteY49" fmla="*/ 1974165 h 6858000"/>
              <a:gd name="connsiteX50" fmla="*/ 1216712 w 6022105"/>
              <a:gd name="connsiteY50" fmla="*/ 1892353 h 6858000"/>
              <a:gd name="connsiteX51" fmla="*/ 63401 w 6022105"/>
              <a:gd name="connsiteY51" fmla="*/ 2208931 h 6858000"/>
              <a:gd name="connsiteX52" fmla="*/ 419660 w 6022105"/>
              <a:gd name="connsiteY52" fmla="*/ 2077320 h 6858000"/>
              <a:gd name="connsiteX53" fmla="*/ 178128 w 6022105"/>
              <a:gd name="connsiteY53" fmla="*/ 2102219 h 6858000"/>
              <a:gd name="connsiteX54" fmla="*/ 45286 w 6022105"/>
              <a:gd name="connsiteY54" fmla="*/ 2013292 h 6858000"/>
              <a:gd name="connsiteX55" fmla="*/ 45286 w 6022105"/>
              <a:gd name="connsiteY55" fmla="*/ 1984836 h 6858000"/>
              <a:gd name="connsiteX56" fmla="*/ 144917 w 6022105"/>
              <a:gd name="connsiteY56" fmla="*/ 1903025 h 6858000"/>
              <a:gd name="connsiteX57" fmla="*/ 202281 w 6022105"/>
              <a:gd name="connsiteY57" fmla="*/ 1849668 h 6858000"/>
              <a:gd name="connsiteX58" fmla="*/ 359276 w 6022105"/>
              <a:gd name="connsiteY58" fmla="*/ 1657587 h 6858000"/>
              <a:gd name="connsiteX59" fmla="*/ 247569 w 6022105"/>
              <a:gd name="connsiteY59" fmla="*/ 1636245 h 6858000"/>
              <a:gd name="connsiteX60" fmla="*/ 205301 w 6022105"/>
              <a:gd name="connsiteY60" fmla="*/ 1597117 h 6858000"/>
              <a:gd name="connsiteX61" fmla="*/ 235492 w 6022105"/>
              <a:gd name="connsiteY61" fmla="*/ 1540204 h 6858000"/>
              <a:gd name="connsiteX62" fmla="*/ 582694 w 6022105"/>
              <a:gd name="connsiteY62" fmla="*/ 1365909 h 6858000"/>
              <a:gd name="connsiteX63" fmla="*/ 609865 w 6022105"/>
              <a:gd name="connsiteY63" fmla="*/ 1230741 h 6858000"/>
              <a:gd name="connsiteX64" fmla="*/ 543445 w 6022105"/>
              <a:gd name="connsiteY64" fmla="*/ 1209399 h 6858000"/>
              <a:gd name="connsiteX65" fmla="*/ 467966 w 6022105"/>
              <a:gd name="connsiteY65" fmla="*/ 1220069 h 6858000"/>
              <a:gd name="connsiteX66" fmla="*/ 528348 w 6022105"/>
              <a:gd name="connsiteY66" fmla="*/ 1113358 h 6858000"/>
              <a:gd name="connsiteX67" fmla="*/ 772899 w 6022105"/>
              <a:gd name="connsiteY67" fmla="*/ 1006647 h 6858000"/>
              <a:gd name="connsiteX68" fmla="*/ 818186 w 6022105"/>
              <a:gd name="connsiteY68" fmla="*/ 949734 h 6858000"/>
              <a:gd name="connsiteX69" fmla="*/ 757803 w 6022105"/>
              <a:gd name="connsiteY69" fmla="*/ 921277 h 6858000"/>
              <a:gd name="connsiteX70" fmla="*/ 712516 w 6022105"/>
              <a:gd name="connsiteY70" fmla="*/ 910606 h 6858000"/>
              <a:gd name="connsiteX71" fmla="*/ 1648449 w 6022105"/>
              <a:gd name="connsiteY71" fmla="*/ 465975 h 6858000"/>
              <a:gd name="connsiteX72" fmla="*/ 1437109 w 6022105"/>
              <a:gd name="connsiteY72" fmla="*/ 462417 h 6858000"/>
              <a:gd name="connsiteX73" fmla="*/ 1228788 w 6022105"/>
              <a:gd name="connsiteY73" fmla="*/ 533558 h 6858000"/>
              <a:gd name="connsiteX74" fmla="*/ 1008391 w 6022105"/>
              <a:gd name="connsiteY74" fmla="*/ 522887 h 6858000"/>
              <a:gd name="connsiteX75" fmla="*/ 800071 w 6022105"/>
              <a:gd name="connsiteY75" fmla="*/ 558458 h 6858000"/>
              <a:gd name="connsiteX76" fmla="*/ 618923 w 6022105"/>
              <a:gd name="connsiteY76" fmla="*/ 558458 h 6858000"/>
              <a:gd name="connsiteX77" fmla="*/ 787995 w 6022105"/>
              <a:gd name="connsiteY77" fmla="*/ 505101 h 6858000"/>
              <a:gd name="connsiteX78" fmla="*/ 851396 w 6022105"/>
              <a:gd name="connsiteY78" fmla="*/ 416176 h 6858000"/>
              <a:gd name="connsiteX79" fmla="*/ 830263 w 6022105"/>
              <a:gd name="connsiteY79" fmla="*/ 334364 h 6858000"/>
              <a:gd name="connsiteX80" fmla="*/ 760822 w 6022105"/>
              <a:gd name="connsiteY80" fmla="*/ 359262 h 6858000"/>
              <a:gd name="connsiteX81" fmla="*/ 679305 w 6022105"/>
              <a:gd name="connsiteY81" fmla="*/ 451747 h 6858000"/>
              <a:gd name="connsiteX82" fmla="*/ 661190 w 6022105"/>
              <a:gd name="connsiteY82" fmla="*/ 394834 h 6858000"/>
              <a:gd name="connsiteX83" fmla="*/ 612884 w 6022105"/>
              <a:gd name="connsiteY83" fmla="*/ 352148 h 6858000"/>
              <a:gd name="connsiteX84" fmla="*/ 335123 w 6022105"/>
              <a:gd name="connsiteY84" fmla="*/ 373491 h 6858000"/>
              <a:gd name="connsiteX85" fmla="*/ 519291 w 6022105"/>
              <a:gd name="connsiteY85" fmla="*/ 192082 h 6858000"/>
              <a:gd name="connsiteX86" fmla="*/ 637037 w 6022105"/>
              <a:gd name="connsiteY86" fmla="*/ 163625 h 6858000"/>
              <a:gd name="connsiteX87" fmla="*/ 664209 w 6022105"/>
              <a:gd name="connsiteY87" fmla="*/ 88927 h 6858000"/>
              <a:gd name="connsiteX88" fmla="*/ 609865 w 6022105"/>
              <a:gd name="connsiteY88" fmla="*/ 71141 h 6858000"/>
              <a:gd name="connsiteX89" fmla="*/ 338143 w 6022105"/>
              <a:gd name="connsiteY89" fmla="*/ 135168 h 6858000"/>
              <a:gd name="connsiteX90" fmla="*/ 292855 w 6022105"/>
              <a:gd name="connsiteY90" fmla="*/ 110269 h 6858000"/>
              <a:gd name="connsiteX91" fmla="*/ 606846 w 6022105"/>
              <a:gd name="connsiteY91" fmla="*/ 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Lst>
            <a:rect l="l" t="t" r="r" b="b"/>
            <a:pathLst>
              <a:path w="6022105" h="6858000">
                <a:moveTo>
                  <a:pt x="606846" y="0"/>
                </a:moveTo>
                <a:lnTo>
                  <a:pt x="6022105" y="0"/>
                </a:lnTo>
                <a:lnTo>
                  <a:pt x="6022105" y="6858000"/>
                </a:lnTo>
                <a:lnTo>
                  <a:pt x="0" y="6858000"/>
                </a:lnTo>
                <a:cubicBezTo>
                  <a:pt x="123784" y="6786859"/>
                  <a:pt x="241530" y="6701489"/>
                  <a:pt x="374372" y="6658805"/>
                </a:cubicBezTo>
                <a:cubicBezTo>
                  <a:pt x="464946" y="6630349"/>
                  <a:pt x="552502" y="6580550"/>
                  <a:pt x="537405" y="6431153"/>
                </a:cubicBezTo>
                <a:cubicBezTo>
                  <a:pt x="534387" y="6388469"/>
                  <a:pt x="558540" y="6356456"/>
                  <a:pt x="594769" y="6367127"/>
                </a:cubicBezTo>
                <a:cubicBezTo>
                  <a:pt x="664209" y="6388469"/>
                  <a:pt x="697421" y="6327999"/>
                  <a:pt x="736668" y="6281757"/>
                </a:cubicBezTo>
                <a:cubicBezTo>
                  <a:pt x="806109" y="6199945"/>
                  <a:pt x="872530" y="6114575"/>
                  <a:pt x="984239" y="6100347"/>
                </a:cubicBezTo>
                <a:cubicBezTo>
                  <a:pt x="963105" y="6036320"/>
                  <a:pt x="926876" y="6043434"/>
                  <a:pt x="893664" y="6057663"/>
                </a:cubicBezTo>
                <a:cubicBezTo>
                  <a:pt x="806109" y="6093234"/>
                  <a:pt x="718554" y="6132361"/>
                  <a:pt x="631000" y="6167932"/>
                </a:cubicBezTo>
                <a:cubicBezTo>
                  <a:pt x="573636" y="6189274"/>
                  <a:pt x="516273" y="6221287"/>
                  <a:pt x="440793" y="6196388"/>
                </a:cubicBezTo>
                <a:cubicBezTo>
                  <a:pt x="507214" y="6068335"/>
                  <a:pt x="618923" y="6043434"/>
                  <a:pt x="709496" y="6004307"/>
                </a:cubicBezTo>
                <a:cubicBezTo>
                  <a:pt x="821206" y="5954508"/>
                  <a:pt x="887626" y="5862025"/>
                  <a:pt x="969143" y="5755314"/>
                </a:cubicBezTo>
                <a:cubicBezTo>
                  <a:pt x="887626" y="5726858"/>
                  <a:pt x="836301" y="5805112"/>
                  <a:pt x="769879" y="5801555"/>
                </a:cubicBezTo>
                <a:cubicBezTo>
                  <a:pt x="766860" y="5790884"/>
                  <a:pt x="760822" y="5769542"/>
                  <a:pt x="760822" y="5769542"/>
                </a:cubicBezTo>
                <a:cubicBezTo>
                  <a:pt x="869512" y="5712629"/>
                  <a:pt x="917816" y="5605917"/>
                  <a:pt x="935933" y="5474306"/>
                </a:cubicBezTo>
                <a:cubicBezTo>
                  <a:pt x="941970" y="5406721"/>
                  <a:pt x="981219" y="5385379"/>
                  <a:pt x="1020468" y="5353367"/>
                </a:cubicBezTo>
                <a:cubicBezTo>
                  <a:pt x="1153310" y="5243097"/>
                  <a:pt x="1295209" y="5143500"/>
                  <a:pt x="1406918" y="4994104"/>
                </a:cubicBezTo>
                <a:cubicBezTo>
                  <a:pt x="1277095" y="5011889"/>
                  <a:pt x="1174445" y="5111487"/>
                  <a:pt x="1038583" y="5154171"/>
                </a:cubicBezTo>
                <a:cubicBezTo>
                  <a:pt x="1147271" y="4990547"/>
                  <a:pt x="1289172" y="4905177"/>
                  <a:pt x="1418994" y="4805580"/>
                </a:cubicBezTo>
                <a:cubicBezTo>
                  <a:pt x="1479378" y="4759339"/>
                  <a:pt x="1533721" y="4702425"/>
                  <a:pt x="1603162" y="4677526"/>
                </a:cubicBezTo>
                <a:cubicBezTo>
                  <a:pt x="1627315" y="4670412"/>
                  <a:pt x="1669584" y="4652628"/>
                  <a:pt x="1648449" y="4602828"/>
                </a:cubicBezTo>
                <a:cubicBezTo>
                  <a:pt x="1630334" y="4560144"/>
                  <a:pt x="1597123" y="4574373"/>
                  <a:pt x="1566931" y="4585042"/>
                </a:cubicBezTo>
                <a:cubicBezTo>
                  <a:pt x="1494473" y="4613499"/>
                  <a:pt x="1415975" y="4613499"/>
                  <a:pt x="1316344" y="4613499"/>
                </a:cubicBezTo>
                <a:cubicBezTo>
                  <a:pt x="1400879" y="4478331"/>
                  <a:pt x="1554856" y="4521016"/>
                  <a:pt x="1627315" y="4378734"/>
                </a:cubicBezTo>
                <a:cubicBezTo>
                  <a:pt x="1536741" y="4353835"/>
                  <a:pt x="1467300" y="4403633"/>
                  <a:pt x="1394842" y="4414305"/>
                </a:cubicBezTo>
                <a:cubicBezTo>
                  <a:pt x="1328419" y="4424975"/>
                  <a:pt x="1313325" y="4400076"/>
                  <a:pt x="1328419" y="4321821"/>
                </a:cubicBezTo>
                <a:cubicBezTo>
                  <a:pt x="1352573" y="4200882"/>
                  <a:pt x="1316344" y="4140411"/>
                  <a:pt x="1219731" y="4172424"/>
                </a:cubicBezTo>
                <a:cubicBezTo>
                  <a:pt x="1129157" y="4204438"/>
                  <a:pt x="1120099" y="4158196"/>
                  <a:pt x="1144253" y="4090612"/>
                </a:cubicBezTo>
                <a:cubicBezTo>
                  <a:pt x="1180482" y="3991015"/>
                  <a:pt x="1141234" y="3912759"/>
                  <a:pt x="1114061" y="3827390"/>
                </a:cubicBezTo>
                <a:cubicBezTo>
                  <a:pt x="1071793" y="3699337"/>
                  <a:pt x="1089907" y="3635309"/>
                  <a:pt x="1177463" y="3539269"/>
                </a:cubicBezTo>
                <a:cubicBezTo>
                  <a:pt x="1228788" y="3485914"/>
                  <a:pt x="1280115" y="3439672"/>
                  <a:pt x="1352573" y="3393429"/>
                </a:cubicBezTo>
                <a:cubicBezTo>
                  <a:pt x="1186520" y="3368530"/>
                  <a:pt x="1358611" y="3283162"/>
                  <a:pt x="1301248" y="3229805"/>
                </a:cubicBezTo>
                <a:cubicBezTo>
                  <a:pt x="1183502" y="3208463"/>
                  <a:pt x="1089907" y="3379202"/>
                  <a:pt x="929894" y="3329402"/>
                </a:cubicBezTo>
                <a:cubicBezTo>
                  <a:pt x="1123118" y="3183563"/>
                  <a:pt x="1340497" y="3137322"/>
                  <a:pt x="1482396" y="2941684"/>
                </a:cubicBezTo>
                <a:cubicBezTo>
                  <a:pt x="1449186" y="2899000"/>
                  <a:pt x="1415975" y="2941684"/>
                  <a:pt x="1388803" y="2923898"/>
                </a:cubicBezTo>
                <a:cubicBezTo>
                  <a:pt x="1388803" y="2913227"/>
                  <a:pt x="1071793" y="2980812"/>
                  <a:pt x="1053678" y="2703362"/>
                </a:cubicBezTo>
                <a:cubicBezTo>
                  <a:pt x="1047640" y="2703362"/>
                  <a:pt x="1041601" y="2703362"/>
                  <a:pt x="1035564" y="2692689"/>
                </a:cubicBezTo>
                <a:cubicBezTo>
                  <a:pt x="1002354" y="2653563"/>
                  <a:pt x="1032544" y="2561080"/>
                  <a:pt x="978200" y="2553965"/>
                </a:cubicBezTo>
                <a:cubicBezTo>
                  <a:pt x="917816" y="2546851"/>
                  <a:pt x="860453" y="2514837"/>
                  <a:pt x="797052" y="2532623"/>
                </a:cubicBezTo>
                <a:cubicBezTo>
                  <a:pt x="748745" y="2546851"/>
                  <a:pt x="697421" y="2564636"/>
                  <a:pt x="646095" y="2564636"/>
                </a:cubicBezTo>
                <a:cubicBezTo>
                  <a:pt x="591751" y="2564636"/>
                  <a:pt x="516273" y="2685576"/>
                  <a:pt x="483061" y="2525509"/>
                </a:cubicBezTo>
                <a:cubicBezTo>
                  <a:pt x="483061" y="2518395"/>
                  <a:pt x="389468" y="2536181"/>
                  <a:pt x="338143" y="2543294"/>
                </a:cubicBezTo>
                <a:cubicBezTo>
                  <a:pt x="295875" y="2550408"/>
                  <a:pt x="244549" y="2582422"/>
                  <a:pt x="214358" y="2518395"/>
                </a:cubicBezTo>
                <a:cubicBezTo>
                  <a:pt x="199263" y="2479267"/>
                  <a:pt x="271722" y="2408126"/>
                  <a:pt x="335123" y="2401012"/>
                </a:cubicBezTo>
                <a:cubicBezTo>
                  <a:pt x="392486" y="2393898"/>
                  <a:pt x="449850" y="2386784"/>
                  <a:pt x="504195" y="2401012"/>
                </a:cubicBezTo>
                <a:cubicBezTo>
                  <a:pt x="570616" y="2418796"/>
                  <a:pt x="606846" y="2390340"/>
                  <a:pt x="624961" y="2326314"/>
                </a:cubicBezTo>
                <a:cubicBezTo>
                  <a:pt x="646095" y="2258731"/>
                  <a:pt x="685344" y="2223159"/>
                  <a:pt x="739688" y="2191146"/>
                </a:cubicBezTo>
                <a:cubicBezTo>
                  <a:pt x="872530" y="2112891"/>
                  <a:pt x="999334" y="2020407"/>
                  <a:pt x="1144253" y="1974165"/>
                </a:cubicBezTo>
                <a:cubicBezTo>
                  <a:pt x="1171425" y="1967051"/>
                  <a:pt x="1204635" y="1952823"/>
                  <a:pt x="1216712" y="1892353"/>
                </a:cubicBezTo>
                <a:cubicBezTo>
                  <a:pt x="824224" y="1984836"/>
                  <a:pt x="467966" y="2223159"/>
                  <a:pt x="63401" y="2208931"/>
                </a:cubicBezTo>
                <a:cubicBezTo>
                  <a:pt x="172091" y="2134233"/>
                  <a:pt x="301913" y="2130676"/>
                  <a:pt x="419660" y="2077320"/>
                </a:cubicBezTo>
                <a:cubicBezTo>
                  <a:pt x="335123" y="2038192"/>
                  <a:pt x="256626" y="2080877"/>
                  <a:pt x="178128" y="2102219"/>
                </a:cubicBezTo>
                <a:cubicBezTo>
                  <a:pt x="111707" y="2120004"/>
                  <a:pt x="51324" y="2123562"/>
                  <a:pt x="45286" y="2013292"/>
                </a:cubicBezTo>
                <a:cubicBezTo>
                  <a:pt x="45286" y="2002622"/>
                  <a:pt x="45286" y="1995507"/>
                  <a:pt x="45286" y="1984836"/>
                </a:cubicBezTo>
                <a:cubicBezTo>
                  <a:pt x="69439" y="1938595"/>
                  <a:pt x="102650" y="1917252"/>
                  <a:pt x="144917" y="1903025"/>
                </a:cubicBezTo>
                <a:cubicBezTo>
                  <a:pt x="169071" y="1895910"/>
                  <a:pt x="202281" y="1881683"/>
                  <a:pt x="202281" y="1849668"/>
                </a:cubicBezTo>
                <a:cubicBezTo>
                  <a:pt x="199263" y="1728729"/>
                  <a:pt x="280779" y="1693158"/>
                  <a:pt x="359276" y="1657587"/>
                </a:cubicBezTo>
                <a:cubicBezTo>
                  <a:pt x="317008" y="1597117"/>
                  <a:pt x="280779" y="1639802"/>
                  <a:pt x="247569" y="1636245"/>
                </a:cubicBezTo>
                <a:cubicBezTo>
                  <a:pt x="226434" y="1632688"/>
                  <a:pt x="205301" y="1629132"/>
                  <a:pt x="205301" y="1597117"/>
                </a:cubicBezTo>
                <a:cubicBezTo>
                  <a:pt x="205301" y="1572219"/>
                  <a:pt x="214358" y="1540204"/>
                  <a:pt x="235492" y="1540204"/>
                </a:cubicBezTo>
                <a:cubicBezTo>
                  <a:pt x="368334" y="1536647"/>
                  <a:pt x="443813" y="1365909"/>
                  <a:pt x="582694" y="1365909"/>
                </a:cubicBezTo>
                <a:cubicBezTo>
                  <a:pt x="667229" y="1365909"/>
                  <a:pt x="540425" y="1269868"/>
                  <a:pt x="609865" y="1230741"/>
                </a:cubicBezTo>
                <a:cubicBezTo>
                  <a:pt x="624961" y="1220069"/>
                  <a:pt x="567597" y="1205842"/>
                  <a:pt x="543445" y="1209399"/>
                </a:cubicBezTo>
                <a:cubicBezTo>
                  <a:pt x="519291" y="1212955"/>
                  <a:pt x="498156" y="1237855"/>
                  <a:pt x="467966" y="1220069"/>
                </a:cubicBezTo>
                <a:cubicBezTo>
                  <a:pt x="452870" y="1156043"/>
                  <a:pt x="492119" y="1131144"/>
                  <a:pt x="528348" y="1113358"/>
                </a:cubicBezTo>
                <a:cubicBezTo>
                  <a:pt x="606846" y="1070674"/>
                  <a:pt x="685344" y="1020875"/>
                  <a:pt x="772899" y="1006647"/>
                </a:cubicBezTo>
                <a:cubicBezTo>
                  <a:pt x="803089" y="1003089"/>
                  <a:pt x="821206" y="985305"/>
                  <a:pt x="818186" y="949734"/>
                </a:cubicBezTo>
                <a:cubicBezTo>
                  <a:pt x="812148" y="903491"/>
                  <a:pt x="781956" y="917720"/>
                  <a:pt x="757803" y="921277"/>
                </a:cubicBezTo>
                <a:cubicBezTo>
                  <a:pt x="742707" y="924835"/>
                  <a:pt x="727611" y="935506"/>
                  <a:pt x="712516" y="910606"/>
                </a:cubicBezTo>
                <a:cubicBezTo>
                  <a:pt x="1065755" y="658055"/>
                  <a:pt x="1252941" y="672284"/>
                  <a:pt x="1648449" y="465975"/>
                </a:cubicBezTo>
                <a:cubicBezTo>
                  <a:pt x="1560894" y="426847"/>
                  <a:pt x="1497492" y="455303"/>
                  <a:pt x="1437109" y="462417"/>
                </a:cubicBezTo>
                <a:cubicBezTo>
                  <a:pt x="1286152" y="480203"/>
                  <a:pt x="1379746" y="512216"/>
                  <a:pt x="1228788" y="533558"/>
                </a:cubicBezTo>
                <a:cubicBezTo>
                  <a:pt x="1156328" y="544229"/>
                  <a:pt x="1089907" y="579800"/>
                  <a:pt x="1008391" y="522887"/>
                </a:cubicBezTo>
                <a:cubicBezTo>
                  <a:pt x="954047" y="483759"/>
                  <a:pt x="866492" y="526444"/>
                  <a:pt x="800071" y="558458"/>
                </a:cubicBezTo>
                <a:cubicBezTo>
                  <a:pt x="745726" y="586915"/>
                  <a:pt x="691382" y="594028"/>
                  <a:pt x="618923" y="558458"/>
                </a:cubicBezTo>
                <a:cubicBezTo>
                  <a:pt x="685344" y="537116"/>
                  <a:pt x="736668" y="519330"/>
                  <a:pt x="787995" y="505101"/>
                </a:cubicBezTo>
                <a:cubicBezTo>
                  <a:pt x="830263" y="494431"/>
                  <a:pt x="854416" y="469532"/>
                  <a:pt x="851396" y="416176"/>
                </a:cubicBezTo>
                <a:cubicBezTo>
                  <a:pt x="851396" y="387720"/>
                  <a:pt x="860453" y="348592"/>
                  <a:pt x="830263" y="334364"/>
                </a:cubicBezTo>
                <a:cubicBezTo>
                  <a:pt x="806109" y="320135"/>
                  <a:pt x="772899" y="334364"/>
                  <a:pt x="760822" y="359262"/>
                </a:cubicBezTo>
                <a:cubicBezTo>
                  <a:pt x="745726" y="405504"/>
                  <a:pt x="730631" y="448189"/>
                  <a:pt x="679305" y="451747"/>
                </a:cubicBezTo>
                <a:cubicBezTo>
                  <a:pt x="609865" y="458860"/>
                  <a:pt x="649115" y="430405"/>
                  <a:pt x="661190" y="394834"/>
                </a:cubicBezTo>
                <a:cubicBezTo>
                  <a:pt x="673267" y="355706"/>
                  <a:pt x="637037" y="345034"/>
                  <a:pt x="612884" y="352148"/>
                </a:cubicBezTo>
                <a:cubicBezTo>
                  <a:pt x="522310" y="384162"/>
                  <a:pt x="428717" y="327250"/>
                  <a:pt x="335123" y="373491"/>
                </a:cubicBezTo>
                <a:cubicBezTo>
                  <a:pt x="359276" y="259665"/>
                  <a:pt x="410603" y="209867"/>
                  <a:pt x="519291" y="192082"/>
                </a:cubicBezTo>
                <a:cubicBezTo>
                  <a:pt x="558540" y="188525"/>
                  <a:pt x="600808" y="195638"/>
                  <a:pt x="637037" y="163625"/>
                </a:cubicBezTo>
                <a:cubicBezTo>
                  <a:pt x="658172" y="145839"/>
                  <a:pt x="679305" y="124497"/>
                  <a:pt x="664209" y="88927"/>
                </a:cubicBezTo>
                <a:cubicBezTo>
                  <a:pt x="655152" y="64027"/>
                  <a:pt x="631000" y="64027"/>
                  <a:pt x="609865" y="71141"/>
                </a:cubicBezTo>
                <a:cubicBezTo>
                  <a:pt x="522310" y="110269"/>
                  <a:pt x="428717" y="120941"/>
                  <a:pt x="338143" y="135168"/>
                </a:cubicBezTo>
                <a:cubicBezTo>
                  <a:pt x="323047" y="138725"/>
                  <a:pt x="307951" y="145839"/>
                  <a:pt x="292855" y="110269"/>
                </a:cubicBezTo>
                <a:cubicBezTo>
                  <a:pt x="398525" y="78255"/>
                  <a:pt x="501176" y="35571"/>
                  <a:pt x="606846" y="0"/>
                </a:cubicBez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 name="Title 1">
            <a:extLst>
              <a:ext uri="{FF2B5EF4-FFF2-40B4-BE49-F238E27FC236}">
                <a16:creationId xmlns:a16="http://schemas.microsoft.com/office/drawing/2014/main" id="{FEA7831C-2863-5307-0A54-FE32D68C5A8C}"/>
              </a:ext>
            </a:extLst>
          </p:cNvPr>
          <p:cNvSpPr>
            <a:spLocks noGrp="1"/>
          </p:cNvSpPr>
          <p:nvPr>
            <p:ph type="ctrTitle"/>
          </p:nvPr>
        </p:nvSpPr>
        <p:spPr>
          <a:xfrm>
            <a:off x="934873" y="1674546"/>
            <a:ext cx="5594224" cy="3508908"/>
          </a:xfrm>
          <a:noFill/>
        </p:spPr>
        <p:txBody>
          <a:bodyPr anchor="ctr">
            <a:normAutofit/>
          </a:bodyPr>
          <a:lstStyle/>
          <a:p>
            <a:r>
              <a:rPr lang="en-US" b="1"/>
              <a:t>Art-Based Learning (ABL) for Early Clinical Exposure in Biochemistry </a:t>
            </a:r>
          </a:p>
        </p:txBody>
      </p:sp>
      <p:sp>
        <p:nvSpPr>
          <p:cNvPr id="3" name="Subtitle 2">
            <a:extLst>
              <a:ext uri="{FF2B5EF4-FFF2-40B4-BE49-F238E27FC236}">
                <a16:creationId xmlns:a16="http://schemas.microsoft.com/office/drawing/2014/main" id="{C4B2D055-D1D8-F0F9-63A6-304FA67A6C1D}"/>
              </a:ext>
            </a:extLst>
          </p:cNvPr>
          <p:cNvSpPr>
            <a:spLocks noGrp="1"/>
          </p:cNvSpPr>
          <p:nvPr>
            <p:ph type="subTitle" idx="1"/>
          </p:nvPr>
        </p:nvSpPr>
        <p:spPr>
          <a:xfrm>
            <a:off x="8109284" y="1674546"/>
            <a:ext cx="3404938" cy="3508908"/>
          </a:xfrm>
        </p:spPr>
        <p:txBody>
          <a:bodyPr anchor="ctr">
            <a:normAutofit/>
          </a:bodyPr>
          <a:lstStyle/>
          <a:p>
            <a:r>
              <a:rPr lang="en-US" sz="2800" b="1">
                <a:solidFill>
                  <a:srgbClr val="FFFFFF"/>
                </a:solidFill>
              </a:rPr>
              <a:t>“Disease &amp; SUFFERING” </a:t>
            </a:r>
            <a:r>
              <a:rPr lang="en-US" sz="2800">
                <a:solidFill>
                  <a:srgbClr val="FFFFFF"/>
                </a:solidFill>
              </a:rPr>
              <a:t>– FROM THE EYES OF A PATIENT &amp; CAREGIVER</a:t>
            </a:r>
          </a:p>
        </p:txBody>
      </p:sp>
    </p:spTree>
    <p:extLst>
      <p:ext uri="{BB962C8B-B14F-4D97-AF65-F5344CB8AC3E}">
        <p14:creationId xmlns:p14="http://schemas.microsoft.com/office/powerpoint/2010/main" val="2594858310"/>
      </p:ext>
    </p:extLst>
  </p:cSld>
  <p:clrMapOvr>
    <a:overrideClrMapping bg1="lt1" tx1="dk1" bg2="lt2" tx2="dk2" accent1="accent1" accent2="accent2" accent3="accent3" accent4="accent4" accent5="accent5" accent6="accent6" hlink="hlink" folHlink="folHlink"/>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7718681-A12E-49D6-9925-DD7C68176D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FBD77573-9EF2-4C35-8285-A1CF6FBB0E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 y="0"/>
            <a:ext cx="5511704" cy="6858000"/>
          </a:xfrm>
          <a:custGeom>
            <a:avLst/>
            <a:gdLst>
              <a:gd name="connsiteX0" fmla="*/ 5511704 w 5511704"/>
              <a:gd name="connsiteY0" fmla="*/ 0 h 6886576"/>
              <a:gd name="connsiteX1" fmla="*/ 1008599 w 5511704"/>
              <a:gd name="connsiteY1" fmla="*/ 0 h 6886576"/>
              <a:gd name="connsiteX2" fmla="*/ 1310975 w 5511704"/>
              <a:gd name="connsiteY2" fmla="*/ 110728 h 6886576"/>
              <a:gd name="connsiteX3" fmla="*/ 1267362 w 5511704"/>
              <a:gd name="connsiteY3" fmla="*/ 135731 h 6886576"/>
              <a:gd name="connsiteX4" fmla="*/ 1005692 w 5511704"/>
              <a:gd name="connsiteY4" fmla="*/ 71437 h 6886576"/>
              <a:gd name="connsiteX5" fmla="*/ 953358 w 5511704"/>
              <a:gd name="connsiteY5" fmla="*/ 89297 h 6886576"/>
              <a:gd name="connsiteX6" fmla="*/ 979525 w 5511704"/>
              <a:gd name="connsiteY6" fmla="*/ 164307 h 6886576"/>
              <a:gd name="connsiteX7" fmla="*/ 1092915 w 5511704"/>
              <a:gd name="connsiteY7" fmla="*/ 192882 h 6886576"/>
              <a:gd name="connsiteX8" fmla="*/ 1270270 w 5511704"/>
              <a:gd name="connsiteY8" fmla="*/ 375047 h 6886576"/>
              <a:gd name="connsiteX9" fmla="*/ 1002784 w 5511704"/>
              <a:gd name="connsiteY9" fmla="*/ 353615 h 6886576"/>
              <a:gd name="connsiteX10" fmla="*/ 956265 w 5511704"/>
              <a:gd name="connsiteY10" fmla="*/ 396479 h 6886576"/>
              <a:gd name="connsiteX11" fmla="*/ 938820 w 5511704"/>
              <a:gd name="connsiteY11" fmla="*/ 453629 h 6886576"/>
              <a:gd name="connsiteX12" fmla="*/ 860319 w 5511704"/>
              <a:gd name="connsiteY12" fmla="*/ 360759 h 6886576"/>
              <a:gd name="connsiteX13" fmla="*/ 793447 w 5511704"/>
              <a:gd name="connsiteY13" fmla="*/ 335757 h 6886576"/>
              <a:gd name="connsiteX14" fmla="*/ 773095 w 5511704"/>
              <a:gd name="connsiteY14" fmla="*/ 417910 h 6886576"/>
              <a:gd name="connsiteX15" fmla="*/ 834151 w 5511704"/>
              <a:gd name="connsiteY15" fmla="*/ 507206 h 6886576"/>
              <a:gd name="connsiteX16" fmla="*/ 996969 w 5511704"/>
              <a:gd name="connsiteY16" fmla="*/ 560785 h 6886576"/>
              <a:gd name="connsiteX17" fmla="*/ 822522 w 5511704"/>
              <a:gd name="connsiteY17" fmla="*/ 560785 h 6886576"/>
              <a:gd name="connsiteX18" fmla="*/ 621908 w 5511704"/>
              <a:gd name="connsiteY18" fmla="*/ 525066 h 6886576"/>
              <a:gd name="connsiteX19" fmla="*/ 409664 w 5511704"/>
              <a:gd name="connsiteY19" fmla="*/ 535781 h 6886576"/>
              <a:gd name="connsiteX20" fmla="*/ 209049 w 5511704"/>
              <a:gd name="connsiteY20" fmla="*/ 464344 h 6886576"/>
              <a:gd name="connsiteX21" fmla="*/ 5527 w 5511704"/>
              <a:gd name="connsiteY21" fmla="*/ 467916 h 6886576"/>
              <a:gd name="connsiteX22" fmla="*/ 906838 w 5511704"/>
              <a:gd name="connsiteY22" fmla="*/ 914400 h 6886576"/>
              <a:gd name="connsiteX23" fmla="*/ 863226 w 5511704"/>
              <a:gd name="connsiteY23" fmla="*/ 925116 h 6886576"/>
              <a:gd name="connsiteX24" fmla="*/ 805077 w 5511704"/>
              <a:gd name="connsiteY24" fmla="*/ 953691 h 6886576"/>
              <a:gd name="connsiteX25" fmla="*/ 848689 w 5511704"/>
              <a:gd name="connsiteY25" fmla="*/ 1010841 h 6886576"/>
              <a:gd name="connsiteX26" fmla="*/ 1084193 w 5511704"/>
              <a:gd name="connsiteY26" fmla="*/ 1117997 h 6886576"/>
              <a:gd name="connsiteX27" fmla="*/ 1142342 w 5511704"/>
              <a:gd name="connsiteY27" fmla="*/ 1225153 h 6886576"/>
              <a:gd name="connsiteX28" fmla="*/ 1069655 w 5511704"/>
              <a:gd name="connsiteY28" fmla="*/ 1214438 h 6886576"/>
              <a:gd name="connsiteX29" fmla="*/ 1005692 w 5511704"/>
              <a:gd name="connsiteY29" fmla="*/ 1235869 h 6886576"/>
              <a:gd name="connsiteX30" fmla="*/ 1031858 w 5511704"/>
              <a:gd name="connsiteY30" fmla="*/ 1371600 h 6886576"/>
              <a:gd name="connsiteX31" fmla="*/ 1366216 w 5511704"/>
              <a:gd name="connsiteY31" fmla="*/ 1546622 h 6886576"/>
              <a:gd name="connsiteX32" fmla="*/ 1395290 w 5511704"/>
              <a:gd name="connsiteY32" fmla="*/ 1603772 h 6886576"/>
              <a:gd name="connsiteX33" fmla="*/ 1354586 w 5511704"/>
              <a:gd name="connsiteY33" fmla="*/ 1643063 h 6886576"/>
              <a:gd name="connsiteX34" fmla="*/ 1247011 w 5511704"/>
              <a:gd name="connsiteY34" fmla="*/ 1664494 h 6886576"/>
              <a:gd name="connsiteX35" fmla="*/ 1398198 w 5511704"/>
              <a:gd name="connsiteY35" fmla="*/ 1857375 h 6886576"/>
              <a:gd name="connsiteX36" fmla="*/ 1453440 w 5511704"/>
              <a:gd name="connsiteY36" fmla="*/ 1910954 h 6886576"/>
              <a:gd name="connsiteX37" fmla="*/ 1549386 w 5511704"/>
              <a:gd name="connsiteY37" fmla="*/ 1993106 h 6886576"/>
              <a:gd name="connsiteX38" fmla="*/ 1549386 w 5511704"/>
              <a:gd name="connsiteY38" fmla="*/ 2021681 h 6886576"/>
              <a:gd name="connsiteX39" fmla="*/ 1421458 w 5511704"/>
              <a:gd name="connsiteY39" fmla="*/ 2110978 h 6886576"/>
              <a:gd name="connsiteX40" fmla="*/ 1188861 w 5511704"/>
              <a:gd name="connsiteY40" fmla="*/ 2085976 h 6886576"/>
              <a:gd name="connsiteX41" fmla="*/ 1531941 w 5511704"/>
              <a:gd name="connsiteY41" fmla="*/ 2218135 h 6886576"/>
              <a:gd name="connsiteX42" fmla="*/ 421293 w 5511704"/>
              <a:gd name="connsiteY42" fmla="*/ 1900238 h 6886576"/>
              <a:gd name="connsiteX43" fmla="*/ 491072 w 5511704"/>
              <a:gd name="connsiteY43" fmla="*/ 1982391 h 6886576"/>
              <a:gd name="connsiteX44" fmla="*/ 880671 w 5511704"/>
              <a:gd name="connsiteY44" fmla="*/ 2200276 h 6886576"/>
              <a:gd name="connsiteX45" fmla="*/ 991154 w 5511704"/>
              <a:gd name="connsiteY45" fmla="*/ 2336007 h 6886576"/>
              <a:gd name="connsiteX46" fmla="*/ 1107453 w 5511704"/>
              <a:gd name="connsiteY46" fmla="*/ 2411016 h 6886576"/>
              <a:gd name="connsiteX47" fmla="*/ 1270270 w 5511704"/>
              <a:gd name="connsiteY47" fmla="*/ 2411016 h 6886576"/>
              <a:gd name="connsiteX48" fmla="*/ 1386568 w 5511704"/>
              <a:gd name="connsiteY48" fmla="*/ 2528889 h 6886576"/>
              <a:gd name="connsiteX49" fmla="*/ 1267362 w 5511704"/>
              <a:gd name="connsiteY49" fmla="*/ 2553891 h 6886576"/>
              <a:gd name="connsiteX50" fmla="*/ 1127805 w 5511704"/>
              <a:gd name="connsiteY50" fmla="*/ 2536032 h 6886576"/>
              <a:gd name="connsiteX51" fmla="*/ 970802 w 5511704"/>
              <a:gd name="connsiteY51" fmla="*/ 2575322 h 6886576"/>
              <a:gd name="connsiteX52" fmla="*/ 825429 w 5511704"/>
              <a:gd name="connsiteY52" fmla="*/ 2543176 h 6886576"/>
              <a:gd name="connsiteX53" fmla="*/ 650982 w 5511704"/>
              <a:gd name="connsiteY53" fmla="*/ 2564607 h 6886576"/>
              <a:gd name="connsiteX54" fmla="*/ 595740 w 5511704"/>
              <a:gd name="connsiteY54" fmla="*/ 2703909 h 6886576"/>
              <a:gd name="connsiteX55" fmla="*/ 578296 w 5511704"/>
              <a:gd name="connsiteY55" fmla="*/ 2714626 h 6886576"/>
              <a:gd name="connsiteX56" fmla="*/ 255568 w 5511704"/>
              <a:gd name="connsiteY56" fmla="*/ 2936081 h 6886576"/>
              <a:gd name="connsiteX57" fmla="*/ 165437 w 5511704"/>
              <a:gd name="connsiteY57" fmla="*/ 2953941 h 6886576"/>
              <a:gd name="connsiteX58" fmla="*/ 697501 w 5511704"/>
              <a:gd name="connsiteY58" fmla="*/ 3343275 h 6886576"/>
              <a:gd name="connsiteX59" fmla="*/ 339884 w 5511704"/>
              <a:gd name="connsiteY59" fmla="*/ 3243263 h 6886576"/>
              <a:gd name="connsiteX60" fmla="*/ 290458 w 5511704"/>
              <a:gd name="connsiteY60" fmla="*/ 3407569 h 6886576"/>
              <a:gd name="connsiteX61" fmla="*/ 459090 w 5511704"/>
              <a:gd name="connsiteY61" fmla="*/ 3554016 h 6886576"/>
              <a:gd name="connsiteX62" fmla="*/ 520147 w 5511704"/>
              <a:gd name="connsiteY62" fmla="*/ 3843338 h 6886576"/>
              <a:gd name="connsiteX63" fmla="*/ 491072 w 5511704"/>
              <a:gd name="connsiteY63" fmla="*/ 4107657 h 6886576"/>
              <a:gd name="connsiteX64" fmla="*/ 418386 w 5511704"/>
              <a:gd name="connsiteY64" fmla="*/ 4189810 h 6886576"/>
              <a:gd name="connsiteX65" fmla="*/ 313718 w 5511704"/>
              <a:gd name="connsiteY65" fmla="*/ 4339829 h 6886576"/>
              <a:gd name="connsiteX66" fmla="*/ 249753 w 5511704"/>
              <a:gd name="connsiteY66" fmla="*/ 4432698 h 6886576"/>
              <a:gd name="connsiteX67" fmla="*/ 25879 w 5511704"/>
              <a:gd name="connsiteY67" fmla="*/ 4396979 h 6886576"/>
              <a:gd name="connsiteX68" fmla="*/ 325347 w 5511704"/>
              <a:gd name="connsiteY68" fmla="*/ 4632722 h 6886576"/>
              <a:gd name="connsiteX69" fmla="*/ 84029 w 5511704"/>
              <a:gd name="connsiteY69" fmla="*/ 4604147 h 6886576"/>
              <a:gd name="connsiteX70" fmla="*/ 5527 w 5511704"/>
              <a:gd name="connsiteY70" fmla="*/ 4622007 h 6886576"/>
              <a:gd name="connsiteX71" fmla="*/ 49139 w 5511704"/>
              <a:gd name="connsiteY71" fmla="*/ 4697016 h 6886576"/>
              <a:gd name="connsiteX72" fmla="*/ 226494 w 5511704"/>
              <a:gd name="connsiteY72" fmla="*/ 4825604 h 6886576"/>
              <a:gd name="connsiteX73" fmla="*/ 592833 w 5511704"/>
              <a:gd name="connsiteY73" fmla="*/ 5175647 h 6886576"/>
              <a:gd name="connsiteX74" fmla="*/ 238123 w 5511704"/>
              <a:gd name="connsiteY74" fmla="*/ 5014913 h 6886576"/>
              <a:gd name="connsiteX75" fmla="*/ 610278 w 5511704"/>
              <a:gd name="connsiteY75" fmla="*/ 5375673 h 6886576"/>
              <a:gd name="connsiteX76" fmla="*/ 691686 w 5511704"/>
              <a:gd name="connsiteY76" fmla="*/ 5497116 h 6886576"/>
              <a:gd name="connsiteX77" fmla="*/ 860319 w 5511704"/>
              <a:gd name="connsiteY77" fmla="*/ 5793582 h 6886576"/>
              <a:gd name="connsiteX78" fmla="*/ 851597 w 5511704"/>
              <a:gd name="connsiteY78" fmla="*/ 5825729 h 6886576"/>
              <a:gd name="connsiteX79" fmla="*/ 659704 w 5511704"/>
              <a:gd name="connsiteY79" fmla="*/ 5779295 h 6886576"/>
              <a:gd name="connsiteX80" fmla="*/ 909746 w 5511704"/>
              <a:gd name="connsiteY80" fmla="*/ 6029326 h 6886576"/>
              <a:gd name="connsiteX81" fmla="*/ 1168509 w 5511704"/>
              <a:gd name="connsiteY81" fmla="*/ 6222207 h 6886576"/>
              <a:gd name="connsiteX82" fmla="*/ 985339 w 5511704"/>
              <a:gd name="connsiteY82" fmla="*/ 6193632 h 6886576"/>
              <a:gd name="connsiteX83" fmla="*/ 732391 w 5511704"/>
              <a:gd name="connsiteY83" fmla="*/ 6082904 h 6886576"/>
              <a:gd name="connsiteX84" fmla="*/ 645167 w 5511704"/>
              <a:gd name="connsiteY84" fmla="*/ 6125766 h 6886576"/>
              <a:gd name="connsiteX85" fmla="*/ 883579 w 5511704"/>
              <a:gd name="connsiteY85" fmla="*/ 6307932 h 6886576"/>
              <a:gd name="connsiteX86" fmla="*/ 1020229 w 5511704"/>
              <a:gd name="connsiteY86" fmla="*/ 6393657 h 6886576"/>
              <a:gd name="connsiteX87" fmla="*/ 1075471 w 5511704"/>
              <a:gd name="connsiteY87" fmla="*/ 6457950 h 6886576"/>
              <a:gd name="connsiteX88" fmla="*/ 1232473 w 5511704"/>
              <a:gd name="connsiteY88" fmla="*/ 6686551 h 6886576"/>
              <a:gd name="connsiteX89" fmla="*/ 1592997 w 5511704"/>
              <a:gd name="connsiteY89" fmla="*/ 6886576 h 6886576"/>
              <a:gd name="connsiteX90" fmla="*/ 5511704 w 5511704"/>
              <a:gd name="connsiteY90" fmla="*/ 6886576 h 68865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Lst>
            <a:rect l="l" t="t" r="r" b="b"/>
            <a:pathLst>
              <a:path w="5511704" h="6886576">
                <a:moveTo>
                  <a:pt x="5511704" y="0"/>
                </a:moveTo>
                <a:lnTo>
                  <a:pt x="1008599" y="0"/>
                </a:lnTo>
                <a:cubicBezTo>
                  <a:pt x="1110360" y="35719"/>
                  <a:pt x="1209214" y="78581"/>
                  <a:pt x="1310975" y="110728"/>
                </a:cubicBezTo>
                <a:cubicBezTo>
                  <a:pt x="1296437" y="146447"/>
                  <a:pt x="1281900" y="139303"/>
                  <a:pt x="1267362" y="135731"/>
                </a:cubicBezTo>
                <a:cubicBezTo>
                  <a:pt x="1180139" y="121445"/>
                  <a:pt x="1090008" y="110728"/>
                  <a:pt x="1005692" y="71437"/>
                </a:cubicBezTo>
                <a:cubicBezTo>
                  <a:pt x="985339" y="64294"/>
                  <a:pt x="962080" y="64294"/>
                  <a:pt x="953358" y="89297"/>
                </a:cubicBezTo>
                <a:cubicBezTo>
                  <a:pt x="938820" y="125016"/>
                  <a:pt x="959172" y="146447"/>
                  <a:pt x="979525" y="164307"/>
                </a:cubicBezTo>
                <a:cubicBezTo>
                  <a:pt x="1014414" y="196453"/>
                  <a:pt x="1055118" y="189310"/>
                  <a:pt x="1092915" y="192882"/>
                </a:cubicBezTo>
                <a:cubicBezTo>
                  <a:pt x="1197583" y="210741"/>
                  <a:pt x="1247011" y="260747"/>
                  <a:pt x="1270270" y="375047"/>
                </a:cubicBezTo>
                <a:cubicBezTo>
                  <a:pt x="1180139" y="328613"/>
                  <a:pt x="1090008" y="385763"/>
                  <a:pt x="1002784" y="353615"/>
                </a:cubicBezTo>
                <a:cubicBezTo>
                  <a:pt x="979525" y="346472"/>
                  <a:pt x="944635" y="357188"/>
                  <a:pt x="956265" y="396479"/>
                </a:cubicBezTo>
                <a:cubicBezTo>
                  <a:pt x="967894" y="432198"/>
                  <a:pt x="1005692" y="460772"/>
                  <a:pt x="938820" y="453629"/>
                </a:cubicBezTo>
                <a:cubicBezTo>
                  <a:pt x="889393" y="450056"/>
                  <a:pt x="874856" y="407194"/>
                  <a:pt x="860319" y="360759"/>
                </a:cubicBezTo>
                <a:cubicBezTo>
                  <a:pt x="848689" y="335757"/>
                  <a:pt x="816707" y="321469"/>
                  <a:pt x="793447" y="335757"/>
                </a:cubicBezTo>
                <a:cubicBezTo>
                  <a:pt x="764373" y="350044"/>
                  <a:pt x="773095" y="389335"/>
                  <a:pt x="773095" y="417910"/>
                </a:cubicBezTo>
                <a:cubicBezTo>
                  <a:pt x="770187" y="471488"/>
                  <a:pt x="793447" y="496491"/>
                  <a:pt x="834151" y="507206"/>
                </a:cubicBezTo>
                <a:cubicBezTo>
                  <a:pt x="883579" y="521494"/>
                  <a:pt x="933005" y="539354"/>
                  <a:pt x="996969" y="560785"/>
                </a:cubicBezTo>
                <a:cubicBezTo>
                  <a:pt x="927190" y="596503"/>
                  <a:pt x="874856" y="589360"/>
                  <a:pt x="822522" y="560785"/>
                </a:cubicBezTo>
                <a:cubicBezTo>
                  <a:pt x="758558" y="528637"/>
                  <a:pt x="674242" y="485775"/>
                  <a:pt x="621908" y="525066"/>
                </a:cubicBezTo>
                <a:cubicBezTo>
                  <a:pt x="543407" y="582216"/>
                  <a:pt x="479443" y="546497"/>
                  <a:pt x="409664" y="535781"/>
                </a:cubicBezTo>
                <a:cubicBezTo>
                  <a:pt x="264290" y="514350"/>
                  <a:pt x="354422" y="482204"/>
                  <a:pt x="209049" y="464344"/>
                </a:cubicBezTo>
                <a:cubicBezTo>
                  <a:pt x="150900" y="457200"/>
                  <a:pt x="89843" y="428625"/>
                  <a:pt x="5527" y="467916"/>
                </a:cubicBezTo>
                <a:cubicBezTo>
                  <a:pt x="386404" y="675085"/>
                  <a:pt x="566666" y="660797"/>
                  <a:pt x="906838" y="914400"/>
                </a:cubicBezTo>
                <a:cubicBezTo>
                  <a:pt x="892301" y="939404"/>
                  <a:pt x="877764" y="928688"/>
                  <a:pt x="863226" y="925116"/>
                </a:cubicBezTo>
                <a:cubicBezTo>
                  <a:pt x="839967" y="921544"/>
                  <a:pt x="810892" y="907256"/>
                  <a:pt x="805077" y="953691"/>
                </a:cubicBezTo>
                <a:cubicBezTo>
                  <a:pt x="802169" y="989410"/>
                  <a:pt x="819615" y="1007269"/>
                  <a:pt x="848689" y="1010841"/>
                </a:cubicBezTo>
                <a:cubicBezTo>
                  <a:pt x="933005" y="1025129"/>
                  <a:pt x="1008599" y="1075135"/>
                  <a:pt x="1084193" y="1117997"/>
                </a:cubicBezTo>
                <a:cubicBezTo>
                  <a:pt x="1119082" y="1135857"/>
                  <a:pt x="1156879" y="1160860"/>
                  <a:pt x="1142342" y="1225153"/>
                </a:cubicBezTo>
                <a:cubicBezTo>
                  <a:pt x="1113268" y="1243013"/>
                  <a:pt x="1092915" y="1218009"/>
                  <a:pt x="1069655" y="1214438"/>
                </a:cubicBezTo>
                <a:cubicBezTo>
                  <a:pt x="1046396" y="1210866"/>
                  <a:pt x="991154" y="1225153"/>
                  <a:pt x="1005692" y="1235869"/>
                </a:cubicBezTo>
                <a:cubicBezTo>
                  <a:pt x="1072563" y="1275159"/>
                  <a:pt x="950450" y="1371600"/>
                  <a:pt x="1031858" y="1371600"/>
                </a:cubicBezTo>
                <a:cubicBezTo>
                  <a:pt x="1165601" y="1371600"/>
                  <a:pt x="1238288" y="1543050"/>
                  <a:pt x="1366216" y="1546622"/>
                </a:cubicBezTo>
                <a:cubicBezTo>
                  <a:pt x="1386568" y="1546622"/>
                  <a:pt x="1395290" y="1578770"/>
                  <a:pt x="1395290" y="1603772"/>
                </a:cubicBezTo>
                <a:cubicBezTo>
                  <a:pt x="1395290" y="1635920"/>
                  <a:pt x="1374939" y="1639491"/>
                  <a:pt x="1354586" y="1643063"/>
                </a:cubicBezTo>
                <a:cubicBezTo>
                  <a:pt x="1322604" y="1646635"/>
                  <a:pt x="1287715" y="1603772"/>
                  <a:pt x="1247011" y="1664494"/>
                </a:cubicBezTo>
                <a:cubicBezTo>
                  <a:pt x="1322604" y="1700213"/>
                  <a:pt x="1401105" y="1735932"/>
                  <a:pt x="1398198" y="1857375"/>
                </a:cubicBezTo>
                <a:cubicBezTo>
                  <a:pt x="1398198" y="1889523"/>
                  <a:pt x="1430180" y="1903810"/>
                  <a:pt x="1453440" y="1910954"/>
                </a:cubicBezTo>
                <a:cubicBezTo>
                  <a:pt x="1494144" y="1925241"/>
                  <a:pt x="1526126" y="1946673"/>
                  <a:pt x="1549386" y="1993106"/>
                </a:cubicBezTo>
                <a:cubicBezTo>
                  <a:pt x="1549386" y="2003822"/>
                  <a:pt x="1549386" y="2010966"/>
                  <a:pt x="1549386" y="2021681"/>
                </a:cubicBezTo>
                <a:cubicBezTo>
                  <a:pt x="1543571" y="2132410"/>
                  <a:pt x="1485422" y="2128838"/>
                  <a:pt x="1421458" y="2110978"/>
                </a:cubicBezTo>
                <a:cubicBezTo>
                  <a:pt x="1345864" y="2089547"/>
                  <a:pt x="1270270" y="2046685"/>
                  <a:pt x="1188861" y="2085976"/>
                </a:cubicBezTo>
                <a:cubicBezTo>
                  <a:pt x="1302252" y="2139554"/>
                  <a:pt x="1427272" y="2143126"/>
                  <a:pt x="1531941" y="2218135"/>
                </a:cubicBezTo>
                <a:cubicBezTo>
                  <a:pt x="1142342" y="2232422"/>
                  <a:pt x="799262" y="1993106"/>
                  <a:pt x="421293" y="1900238"/>
                </a:cubicBezTo>
                <a:cubicBezTo>
                  <a:pt x="432923" y="1960960"/>
                  <a:pt x="464905" y="1975247"/>
                  <a:pt x="491072" y="1982391"/>
                </a:cubicBezTo>
                <a:cubicBezTo>
                  <a:pt x="630630" y="2028825"/>
                  <a:pt x="752743" y="2121695"/>
                  <a:pt x="880671" y="2200276"/>
                </a:cubicBezTo>
                <a:cubicBezTo>
                  <a:pt x="933005" y="2232422"/>
                  <a:pt x="970802" y="2268142"/>
                  <a:pt x="991154" y="2336007"/>
                </a:cubicBezTo>
                <a:cubicBezTo>
                  <a:pt x="1008599" y="2400300"/>
                  <a:pt x="1043489" y="2428875"/>
                  <a:pt x="1107453" y="2411016"/>
                </a:cubicBezTo>
                <a:cubicBezTo>
                  <a:pt x="1159787" y="2396729"/>
                  <a:pt x="1215029" y="2403873"/>
                  <a:pt x="1270270" y="2411016"/>
                </a:cubicBezTo>
                <a:cubicBezTo>
                  <a:pt x="1331326" y="2418160"/>
                  <a:pt x="1401105" y="2489597"/>
                  <a:pt x="1386568" y="2528889"/>
                </a:cubicBezTo>
                <a:cubicBezTo>
                  <a:pt x="1357494" y="2593182"/>
                  <a:pt x="1308067" y="2561035"/>
                  <a:pt x="1267362" y="2553891"/>
                </a:cubicBezTo>
                <a:cubicBezTo>
                  <a:pt x="1217936" y="2546748"/>
                  <a:pt x="1127805" y="2528889"/>
                  <a:pt x="1127805" y="2536032"/>
                </a:cubicBezTo>
                <a:cubicBezTo>
                  <a:pt x="1095822" y="2696766"/>
                  <a:pt x="1023136" y="2575322"/>
                  <a:pt x="970802" y="2575322"/>
                </a:cubicBezTo>
                <a:cubicBezTo>
                  <a:pt x="921375" y="2575322"/>
                  <a:pt x="871949" y="2557463"/>
                  <a:pt x="825429" y="2543176"/>
                </a:cubicBezTo>
                <a:cubicBezTo>
                  <a:pt x="764373" y="2525316"/>
                  <a:pt x="709132" y="2557463"/>
                  <a:pt x="650982" y="2564607"/>
                </a:cubicBezTo>
                <a:cubicBezTo>
                  <a:pt x="598648" y="2571751"/>
                  <a:pt x="627722" y="2664620"/>
                  <a:pt x="595740" y="2703909"/>
                </a:cubicBezTo>
                <a:cubicBezTo>
                  <a:pt x="589926" y="2714626"/>
                  <a:pt x="584111" y="2714626"/>
                  <a:pt x="578296" y="2714626"/>
                </a:cubicBezTo>
                <a:cubicBezTo>
                  <a:pt x="560851" y="2993232"/>
                  <a:pt x="255568" y="2925366"/>
                  <a:pt x="255568" y="2936081"/>
                </a:cubicBezTo>
                <a:cubicBezTo>
                  <a:pt x="229401" y="2953941"/>
                  <a:pt x="197419" y="2911079"/>
                  <a:pt x="165437" y="2953941"/>
                </a:cubicBezTo>
                <a:cubicBezTo>
                  <a:pt x="302087" y="3150394"/>
                  <a:pt x="511425" y="3196828"/>
                  <a:pt x="697501" y="3343275"/>
                </a:cubicBezTo>
                <a:cubicBezTo>
                  <a:pt x="543407" y="3393282"/>
                  <a:pt x="453275" y="3221832"/>
                  <a:pt x="339884" y="3243263"/>
                </a:cubicBezTo>
                <a:cubicBezTo>
                  <a:pt x="284643" y="3296842"/>
                  <a:pt x="450368" y="3382566"/>
                  <a:pt x="290458" y="3407569"/>
                </a:cubicBezTo>
                <a:cubicBezTo>
                  <a:pt x="360236" y="3454004"/>
                  <a:pt x="409664" y="3500439"/>
                  <a:pt x="459090" y="3554016"/>
                </a:cubicBezTo>
                <a:cubicBezTo>
                  <a:pt x="543407" y="3650457"/>
                  <a:pt x="560851" y="3714751"/>
                  <a:pt x="520147" y="3843338"/>
                </a:cubicBezTo>
                <a:cubicBezTo>
                  <a:pt x="493979" y="3929063"/>
                  <a:pt x="456183" y="4007645"/>
                  <a:pt x="491072" y="4107657"/>
                </a:cubicBezTo>
                <a:cubicBezTo>
                  <a:pt x="514332" y="4175522"/>
                  <a:pt x="505609" y="4221957"/>
                  <a:pt x="418386" y="4189810"/>
                </a:cubicBezTo>
                <a:cubicBezTo>
                  <a:pt x="325347" y="4157663"/>
                  <a:pt x="290458" y="4218386"/>
                  <a:pt x="313718" y="4339829"/>
                </a:cubicBezTo>
                <a:cubicBezTo>
                  <a:pt x="328254" y="4418410"/>
                  <a:pt x="313718" y="4443413"/>
                  <a:pt x="249753" y="4432698"/>
                </a:cubicBezTo>
                <a:cubicBezTo>
                  <a:pt x="179975" y="4421982"/>
                  <a:pt x="113103" y="4371976"/>
                  <a:pt x="25879" y="4396979"/>
                </a:cubicBezTo>
                <a:cubicBezTo>
                  <a:pt x="95658" y="4539854"/>
                  <a:pt x="243939" y="4496991"/>
                  <a:pt x="325347" y="4632722"/>
                </a:cubicBezTo>
                <a:cubicBezTo>
                  <a:pt x="229401" y="4632722"/>
                  <a:pt x="153807" y="4632722"/>
                  <a:pt x="84029" y="4604147"/>
                </a:cubicBezTo>
                <a:cubicBezTo>
                  <a:pt x="54954" y="4593433"/>
                  <a:pt x="22972" y="4579145"/>
                  <a:pt x="5527" y="4622007"/>
                </a:cubicBezTo>
                <a:cubicBezTo>
                  <a:pt x="-14826" y="4672014"/>
                  <a:pt x="25879" y="4689872"/>
                  <a:pt x="49139" y="4697016"/>
                </a:cubicBezTo>
                <a:cubicBezTo>
                  <a:pt x="116011" y="4722019"/>
                  <a:pt x="168344" y="4779170"/>
                  <a:pt x="226494" y="4825604"/>
                </a:cubicBezTo>
                <a:cubicBezTo>
                  <a:pt x="351514" y="4925616"/>
                  <a:pt x="488165" y="5011341"/>
                  <a:pt x="592833" y="5175647"/>
                </a:cubicBezTo>
                <a:cubicBezTo>
                  <a:pt x="461997" y="5132785"/>
                  <a:pt x="363144" y="5032772"/>
                  <a:pt x="238123" y="5014913"/>
                </a:cubicBezTo>
                <a:cubicBezTo>
                  <a:pt x="345700" y="5164932"/>
                  <a:pt x="482350" y="5264944"/>
                  <a:pt x="610278" y="5375673"/>
                </a:cubicBezTo>
                <a:cubicBezTo>
                  <a:pt x="648075" y="5407819"/>
                  <a:pt x="685872" y="5429250"/>
                  <a:pt x="691686" y="5497116"/>
                </a:cubicBezTo>
                <a:cubicBezTo>
                  <a:pt x="709132" y="5629276"/>
                  <a:pt x="755650" y="5736432"/>
                  <a:pt x="860319" y="5793582"/>
                </a:cubicBezTo>
                <a:cubicBezTo>
                  <a:pt x="860319" y="5793582"/>
                  <a:pt x="854504" y="5815013"/>
                  <a:pt x="851597" y="5825729"/>
                </a:cubicBezTo>
                <a:cubicBezTo>
                  <a:pt x="787632" y="5829301"/>
                  <a:pt x="738206" y="5750720"/>
                  <a:pt x="659704" y="5779295"/>
                </a:cubicBezTo>
                <a:cubicBezTo>
                  <a:pt x="738206" y="5886451"/>
                  <a:pt x="802169" y="5979319"/>
                  <a:pt x="909746" y="6029326"/>
                </a:cubicBezTo>
                <a:cubicBezTo>
                  <a:pt x="996969" y="6068616"/>
                  <a:pt x="1104545" y="6093620"/>
                  <a:pt x="1168509" y="6222207"/>
                </a:cubicBezTo>
                <a:cubicBezTo>
                  <a:pt x="1095822" y="6247210"/>
                  <a:pt x="1040581" y="6215063"/>
                  <a:pt x="985339" y="6193632"/>
                </a:cubicBezTo>
                <a:cubicBezTo>
                  <a:pt x="901023" y="6157913"/>
                  <a:pt x="816707" y="6118623"/>
                  <a:pt x="732391" y="6082904"/>
                </a:cubicBezTo>
                <a:cubicBezTo>
                  <a:pt x="700408" y="6068616"/>
                  <a:pt x="665519" y="6061472"/>
                  <a:pt x="645167" y="6125766"/>
                </a:cubicBezTo>
                <a:cubicBezTo>
                  <a:pt x="752743" y="6140053"/>
                  <a:pt x="816707" y="6225779"/>
                  <a:pt x="883579" y="6307932"/>
                </a:cubicBezTo>
                <a:cubicBezTo>
                  <a:pt x="921375" y="6354366"/>
                  <a:pt x="953358" y="6415088"/>
                  <a:pt x="1020229" y="6393657"/>
                </a:cubicBezTo>
                <a:cubicBezTo>
                  <a:pt x="1055118" y="6382942"/>
                  <a:pt x="1078378" y="6415088"/>
                  <a:pt x="1075471" y="6457950"/>
                </a:cubicBezTo>
                <a:cubicBezTo>
                  <a:pt x="1060933" y="6607970"/>
                  <a:pt x="1145250" y="6657976"/>
                  <a:pt x="1232473" y="6686551"/>
                </a:cubicBezTo>
                <a:cubicBezTo>
                  <a:pt x="1360401" y="6729413"/>
                  <a:pt x="1473792" y="6815138"/>
                  <a:pt x="1592997" y="6886576"/>
                </a:cubicBezTo>
                <a:lnTo>
                  <a:pt x="5511704" y="6886576"/>
                </a:lnTo>
                <a:close/>
              </a:path>
            </a:pathLst>
          </a:custGeom>
          <a:solidFill>
            <a:schemeClr val="accent1"/>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F3AFC17F-A47A-A7D8-8D33-F2DC13DD4EA6}"/>
              </a:ext>
            </a:extLst>
          </p:cNvPr>
          <p:cNvSpPr>
            <a:spLocks noGrp="1"/>
          </p:cNvSpPr>
          <p:nvPr>
            <p:ph type="title"/>
          </p:nvPr>
        </p:nvSpPr>
        <p:spPr>
          <a:xfrm>
            <a:off x="838200" y="713312"/>
            <a:ext cx="3461084" cy="5431376"/>
          </a:xfrm>
        </p:spPr>
        <p:txBody>
          <a:bodyPr>
            <a:normAutofit/>
          </a:bodyPr>
          <a:lstStyle/>
          <a:p>
            <a:r>
              <a:rPr lang="en-US" b="1" dirty="0">
                <a:solidFill>
                  <a:srgbClr val="FFFFFF"/>
                </a:solidFill>
              </a:rPr>
              <a:t>Instructions:</a:t>
            </a:r>
            <a:br>
              <a:rPr lang="en-US" b="1" dirty="0">
                <a:solidFill>
                  <a:srgbClr val="FFFFFF"/>
                </a:solidFill>
              </a:rPr>
            </a:br>
            <a:r>
              <a:rPr lang="en-US" b="1" dirty="0">
                <a:solidFill>
                  <a:srgbClr val="FFC000"/>
                </a:solidFill>
              </a:rPr>
              <a:t>“Session Feedback &amp; Confidence”</a:t>
            </a:r>
          </a:p>
        </p:txBody>
      </p:sp>
      <p:sp>
        <p:nvSpPr>
          <p:cNvPr id="7" name="Content Placeholder 2">
            <a:extLst>
              <a:ext uri="{FF2B5EF4-FFF2-40B4-BE49-F238E27FC236}">
                <a16:creationId xmlns:a16="http://schemas.microsoft.com/office/drawing/2014/main" id="{A5736F61-91AC-32AF-15B4-6D9043A6376B}"/>
              </a:ext>
            </a:extLst>
          </p:cNvPr>
          <p:cNvSpPr>
            <a:spLocks noGrp="1"/>
          </p:cNvSpPr>
          <p:nvPr>
            <p:ph idx="1"/>
          </p:nvPr>
        </p:nvSpPr>
        <p:spPr>
          <a:xfrm>
            <a:off x="5511705" y="536448"/>
            <a:ext cx="6388924" cy="6108192"/>
          </a:xfrm>
        </p:spPr>
        <p:txBody>
          <a:bodyPr anchor="ctr">
            <a:noAutofit/>
          </a:bodyPr>
          <a:lstStyle/>
          <a:p>
            <a:pPr>
              <a:spcBef>
                <a:spcPts val="0"/>
              </a:spcBef>
            </a:pPr>
            <a:r>
              <a:rPr lang="en-US" sz="2700" kern="100" dirty="0">
                <a:effectLst/>
                <a:latin typeface="Calibri" panose="020F0502020204030204" pitchFamily="34" charset="0"/>
                <a:ea typeface="Aptos" panose="020B0004020202020204" pitchFamily="34" charset="0"/>
                <a:cs typeface="Calibri" panose="020F0502020204030204" pitchFamily="34" charset="0"/>
              </a:rPr>
              <a:t>The aim of this is to encourage personal reflection on emotions, the concept of suffering, and communication. </a:t>
            </a:r>
          </a:p>
          <a:p>
            <a:pPr>
              <a:spcBef>
                <a:spcPts val="0"/>
              </a:spcBef>
            </a:pPr>
            <a:endParaRPr lang="en-US" sz="2700" kern="100" dirty="0">
              <a:effectLst/>
              <a:latin typeface="Calibri" panose="020F0502020204030204" pitchFamily="34" charset="0"/>
              <a:ea typeface="Aptos" panose="020B0004020202020204" pitchFamily="34" charset="0"/>
              <a:cs typeface="Calibri" panose="020F0502020204030204" pitchFamily="34" charset="0"/>
            </a:endParaRPr>
          </a:p>
          <a:p>
            <a:pPr>
              <a:spcBef>
                <a:spcPts val="0"/>
              </a:spcBef>
            </a:pPr>
            <a:r>
              <a:rPr lang="en-US" sz="2700" kern="100" dirty="0">
                <a:effectLst/>
                <a:latin typeface="Calibri" panose="020F0502020204030204" pitchFamily="34" charset="0"/>
                <a:ea typeface="Aptos" panose="020B0004020202020204" pitchFamily="34" charset="0"/>
                <a:cs typeface="Calibri" panose="020F0502020204030204" pitchFamily="34" charset="0"/>
              </a:rPr>
              <a:t>Finally, the students will complete the evaluation and confidence questionnaire online. </a:t>
            </a:r>
          </a:p>
        </p:txBody>
      </p:sp>
    </p:spTree>
    <p:extLst>
      <p:ext uri="{BB962C8B-B14F-4D97-AF65-F5344CB8AC3E}">
        <p14:creationId xmlns:p14="http://schemas.microsoft.com/office/powerpoint/2010/main" val="216157568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8456E49-5B27-386D-59DC-9A165CA03871}"/>
            </a:ext>
          </a:extLst>
        </p:cNvPr>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6C6696F-98E5-1989-04C7-6D95A949CB2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499AA791-3518-2C6D-0ECA-76CE2A9A39A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 y="0"/>
            <a:ext cx="5511704" cy="6858000"/>
          </a:xfrm>
          <a:custGeom>
            <a:avLst/>
            <a:gdLst>
              <a:gd name="connsiteX0" fmla="*/ 5511704 w 5511704"/>
              <a:gd name="connsiteY0" fmla="*/ 0 h 6886576"/>
              <a:gd name="connsiteX1" fmla="*/ 1008599 w 5511704"/>
              <a:gd name="connsiteY1" fmla="*/ 0 h 6886576"/>
              <a:gd name="connsiteX2" fmla="*/ 1310975 w 5511704"/>
              <a:gd name="connsiteY2" fmla="*/ 110728 h 6886576"/>
              <a:gd name="connsiteX3" fmla="*/ 1267362 w 5511704"/>
              <a:gd name="connsiteY3" fmla="*/ 135731 h 6886576"/>
              <a:gd name="connsiteX4" fmla="*/ 1005692 w 5511704"/>
              <a:gd name="connsiteY4" fmla="*/ 71437 h 6886576"/>
              <a:gd name="connsiteX5" fmla="*/ 953358 w 5511704"/>
              <a:gd name="connsiteY5" fmla="*/ 89297 h 6886576"/>
              <a:gd name="connsiteX6" fmla="*/ 979525 w 5511704"/>
              <a:gd name="connsiteY6" fmla="*/ 164307 h 6886576"/>
              <a:gd name="connsiteX7" fmla="*/ 1092915 w 5511704"/>
              <a:gd name="connsiteY7" fmla="*/ 192882 h 6886576"/>
              <a:gd name="connsiteX8" fmla="*/ 1270270 w 5511704"/>
              <a:gd name="connsiteY8" fmla="*/ 375047 h 6886576"/>
              <a:gd name="connsiteX9" fmla="*/ 1002784 w 5511704"/>
              <a:gd name="connsiteY9" fmla="*/ 353615 h 6886576"/>
              <a:gd name="connsiteX10" fmla="*/ 956265 w 5511704"/>
              <a:gd name="connsiteY10" fmla="*/ 396479 h 6886576"/>
              <a:gd name="connsiteX11" fmla="*/ 938820 w 5511704"/>
              <a:gd name="connsiteY11" fmla="*/ 453629 h 6886576"/>
              <a:gd name="connsiteX12" fmla="*/ 860319 w 5511704"/>
              <a:gd name="connsiteY12" fmla="*/ 360759 h 6886576"/>
              <a:gd name="connsiteX13" fmla="*/ 793447 w 5511704"/>
              <a:gd name="connsiteY13" fmla="*/ 335757 h 6886576"/>
              <a:gd name="connsiteX14" fmla="*/ 773095 w 5511704"/>
              <a:gd name="connsiteY14" fmla="*/ 417910 h 6886576"/>
              <a:gd name="connsiteX15" fmla="*/ 834151 w 5511704"/>
              <a:gd name="connsiteY15" fmla="*/ 507206 h 6886576"/>
              <a:gd name="connsiteX16" fmla="*/ 996969 w 5511704"/>
              <a:gd name="connsiteY16" fmla="*/ 560785 h 6886576"/>
              <a:gd name="connsiteX17" fmla="*/ 822522 w 5511704"/>
              <a:gd name="connsiteY17" fmla="*/ 560785 h 6886576"/>
              <a:gd name="connsiteX18" fmla="*/ 621908 w 5511704"/>
              <a:gd name="connsiteY18" fmla="*/ 525066 h 6886576"/>
              <a:gd name="connsiteX19" fmla="*/ 409664 w 5511704"/>
              <a:gd name="connsiteY19" fmla="*/ 535781 h 6886576"/>
              <a:gd name="connsiteX20" fmla="*/ 209049 w 5511704"/>
              <a:gd name="connsiteY20" fmla="*/ 464344 h 6886576"/>
              <a:gd name="connsiteX21" fmla="*/ 5527 w 5511704"/>
              <a:gd name="connsiteY21" fmla="*/ 467916 h 6886576"/>
              <a:gd name="connsiteX22" fmla="*/ 906838 w 5511704"/>
              <a:gd name="connsiteY22" fmla="*/ 914400 h 6886576"/>
              <a:gd name="connsiteX23" fmla="*/ 863226 w 5511704"/>
              <a:gd name="connsiteY23" fmla="*/ 925116 h 6886576"/>
              <a:gd name="connsiteX24" fmla="*/ 805077 w 5511704"/>
              <a:gd name="connsiteY24" fmla="*/ 953691 h 6886576"/>
              <a:gd name="connsiteX25" fmla="*/ 848689 w 5511704"/>
              <a:gd name="connsiteY25" fmla="*/ 1010841 h 6886576"/>
              <a:gd name="connsiteX26" fmla="*/ 1084193 w 5511704"/>
              <a:gd name="connsiteY26" fmla="*/ 1117997 h 6886576"/>
              <a:gd name="connsiteX27" fmla="*/ 1142342 w 5511704"/>
              <a:gd name="connsiteY27" fmla="*/ 1225153 h 6886576"/>
              <a:gd name="connsiteX28" fmla="*/ 1069655 w 5511704"/>
              <a:gd name="connsiteY28" fmla="*/ 1214438 h 6886576"/>
              <a:gd name="connsiteX29" fmla="*/ 1005692 w 5511704"/>
              <a:gd name="connsiteY29" fmla="*/ 1235869 h 6886576"/>
              <a:gd name="connsiteX30" fmla="*/ 1031858 w 5511704"/>
              <a:gd name="connsiteY30" fmla="*/ 1371600 h 6886576"/>
              <a:gd name="connsiteX31" fmla="*/ 1366216 w 5511704"/>
              <a:gd name="connsiteY31" fmla="*/ 1546622 h 6886576"/>
              <a:gd name="connsiteX32" fmla="*/ 1395290 w 5511704"/>
              <a:gd name="connsiteY32" fmla="*/ 1603772 h 6886576"/>
              <a:gd name="connsiteX33" fmla="*/ 1354586 w 5511704"/>
              <a:gd name="connsiteY33" fmla="*/ 1643063 h 6886576"/>
              <a:gd name="connsiteX34" fmla="*/ 1247011 w 5511704"/>
              <a:gd name="connsiteY34" fmla="*/ 1664494 h 6886576"/>
              <a:gd name="connsiteX35" fmla="*/ 1398198 w 5511704"/>
              <a:gd name="connsiteY35" fmla="*/ 1857375 h 6886576"/>
              <a:gd name="connsiteX36" fmla="*/ 1453440 w 5511704"/>
              <a:gd name="connsiteY36" fmla="*/ 1910954 h 6886576"/>
              <a:gd name="connsiteX37" fmla="*/ 1549386 w 5511704"/>
              <a:gd name="connsiteY37" fmla="*/ 1993106 h 6886576"/>
              <a:gd name="connsiteX38" fmla="*/ 1549386 w 5511704"/>
              <a:gd name="connsiteY38" fmla="*/ 2021681 h 6886576"/>
              <a:gd name="connsiteX39" fmla="*/ 1421458 w 5511704"/>
              <a:gd name="connsiteY39" fmla="*/ 2110978 h 6886576"/>
              <a:gd name="connsiteX40" fmla="*/ 1188861 w 5511704"/>
              <a:gd name="connsiteY40" fmla="*/ 2085976 h 6886576"/>
              <a:gd name="connsiteX41" fmla="*/ 1531941 w 5511704"/>
              <a:gd name="connsiteY41" fmla="*/ 2218135 h 6886576"/>
              <a:gd name="connsiteX42" fmla="*/ 421293 w 5511704"/>
              <a:gd name="connsiteY42" fmla="*/ 1900238 h 6886576"/>
              <a:gd name="connsiteX43" fmla="*/ 491072 w 5511704"/>
              <a:gd name="connsiteY43" fmla="*/ 1982391 h 6886576"/>
              <a:gd name="connsiteX44" fmla="*/ 880671 w 5511704"/>
              <a:gd name="connsiteY44" fmla="*/ 2200276 h 6886576"/>
              <a:gd name="connsiteX45" fmla="*/ 991154 w 5511704"/>
              <a:gd name="connsiteY45" fmla="*/ 2336007 h 6886576"/>
              <a:gd name="connsiteX46" fmla="*/ 1107453 w 5511704"/>
              <a:gd name="connsiteY46" fmla="*/ 2411016 h 6886576"/>
              <a:gd name="connsiteX47" fmla="*/ 1270270 w 5511704"/>
              <a:gd name="connsiteY47" fmla="*/ 2411016 h 6886576"/>
              <a:gd name="connsiteX48" fmla="*/ 1386568 w 5511704"/>
              <a:gd name="connsiteY48" fmla="*/ 2528889 h 6886576"/>
              <a:gd name="connsiteX49" fmla="*/ 1267362 w 5511704"/>
              <a:gd name="connsiteY49" fmla="*/ 2553891 h 6886576"/>
              <a:gd name="connsiteX50" fmla="*/ 1127805 w 5511704"/>
              <a:gd name="connsiteY50" fmla="*/ 2536032 h 6886576"/>
              <a:gd name="connsiteX51" fmla="*/ 970802 w 5511704"/>
              <a:gd name="connsiteY51" fmla="*/ 2575322 h 6886576"/>
              <a:gd name="connsiteX52" fmla="*/ 825429 w 5511704"/>
              <a:gd name="connsiteY52" fmla="*/ 2543176 h 6886576"/>
              <a:gd name="connsiteX53" fmla="*/ 650982 w 5511704"/>
              <a:gd name="connsiteY53" fmla="*/ 2564607 h 6886576"/>
              <a:gd name="connsiteX54" fmla="*/ 595740 w 5511704"/>
              <a:gd name="connsiteY54" fmla="*/ 2703909 h 6886576"/>
              <a:gd name="connsiteX55" fmla="*/ 578296 w 5511704"/>
              <a:gd name="connsiteY55" fmla="*/ 2714626 h 6886576"/>
              <a:gd name="connsiteX56" fmla="*/ 255568 w 5511704"/>
              <a:gd name="connsiteY56" fmla="*/ 2936081 h 6886576"/>
              <a:gd name="connsiteX57" fmla="*/ 165437 w 5511704"/>
              <a:gd name="connsiteY57" fmla="*/ 2953941 h 6886576"/>
              <a:gd name="connsiteX58" fmla="*/ 697501 w 5511704"/>
              <a:gd name="connsiteY58" fmla="*/ 3343275 h 6886576"/>
              <a:gd name="connsiteX59" fmla="*/ 339884 w 5511704"/>
              <a:gd name="connsiteY59" fmla="*/ 3243263 h 6886576"/>
              <a:gd name="connsiteX60" fmla="*/ 290458 w 5511704"/>
              <a:gd name="connsiteY60" fmla="*/ 3407569 h 6886576"/>
              <a:gd name="connsiteX61" fmla="*/ 459090 w 5511704"/>
              <a:gd name="connsiteY61" fmla="*/ 3554016 h 6886576"/>
              <a:gd name="connsiteX62" fmla="*/ 520147 w 5511704"/>
              <a:gd name="connsiteY62" fmla="*/ 3843338 h 6886576"/>
              <a:gd name="connsiteX63" fmla="*/ 491072 w 5511704"/>
              <a:gd name="connsiteY63" fmla="*/ 4107657 h 6886576"/>
              <a:gd name="connsiteX64" fmla="*/ 418386 w 5511704"/>
              <a:gd name="connsiteY64" fmla="*/ 4189810 h 6886576"/>
              <a:gd name="connsiteX65" fmla="*/ 313718 w 5511704"/>
              <a:gd name="connsiteY65" fmla="*/ 4339829 h 6886576"/>
              <a:gd name="connsiteX66" fmla="*/ 249753 w 5511704"/>
              <a:gd name="connsiteY66" fmla="*/ 4432698 h 6886576"/>
              <a:gd name="connsiteX67" fmla="*/ 25879 w 5511704"/>
              <a:gd name="connsiteY67" fmla="*/ 4396979 h 6886576"/>
              <a:gd name="connsiteX68" fmla="*/ 325347 w 5511704"/>
              <a:gd name="connsiteY68" fmla="*/ 4632722 h 6886576"/>
              <a:gd name="connsiteX69" fmla="*/ 84029 w 5511704"/>
              <a:gd name="connsiteY69" fmla="*/ 4604147 h 6886576"/>
              <a:gd name="connsiteX70" fmla="*/ 5527 w 5511704"/>
              <a:gd name="connsiteY70" fmla="*/ 4622007 h 6886576"/>
              <a:gd name="connsiteX71" fmla="*/ 49139 w 5511704"/>
              <a:gd name="connsiteY71" fmla="*/ 4697016 h 6886576"/>
              <a:gd name="connsiteX72" fmla="*/ 226494 w 5511704"/>
              <a:gd name="connsiteY72" fmla="*/ 4825604 h 6886576"/>
              <a:gd name="connsiteX73" fmla="*/ 592833 w 5511704"/>
              <a:gd name="connsiteY73" fmla="*/ 5175647 h 6886576"/>
              <a:gd name="connsiteX74" fmla="*/ 238123 w 5511704"/>
              <a:gd name="connsiteY74" fmla="*/ 5014913 h 6886576"/>
              <a:gd name="connsiteX75" fmla="*/ 610278 w 5511704"/>
              <a:gd name="connsiteY75" fmla="*/ 5375673 h 6886576"/>
              <a:gd name="connsiteX76" fmla="*/ 691686 w 5511704"/>
              <a:gd name="connsiteY76" fmla="*/ 5497116 h 6886576"/>
              <a:gd name="connsiteX77" fmla="*/ 860319 w 5511704"/>
              <a:gd name="connsiteY77" fmla="*/ 5793582 h 6886576"/>
              <a:gd name="connsiteX78" fmla="*/ 851597 w 5511704"/>
              <a:gd name="connsiteY78" fmla="*/ 5825729 h 6886576"/>
              <a:gd name="connsiteX79" fmla="*/ 659704 w 5511704"/>
              <a:gd name="connsiteY79" fmla="*/ 5779295 h 6886576"/>
              <a:gd name="connsiteX80" fmla="*/ 909746 w 5511704"/>
              <a:gd name="connsiteY80" fmla="*/ 6029326 h 6886576"/>
              <a:gd name="connsiteX81" fmla="*/ 1168509 w 5511704"/>
              <a:gd name="connsiteY81" fmla="*/ 6222207 h 6886576"/>
              <a:gd name="connsiteX82" fmla="*/ 985339 w 5511704"/>
              <a:gd name="connsiteY82" fmla="*/ 6193632 h 6886576"/>
              <a:gd name="connsiteX83" fmla="*/ 732391 w 5511704"/>
              <a:gd name="connsiteY83" fmla="*/ 6082904 h 6886576"/>
              <a:gd name="connsiteX84" fmla="*/ 645167 w 5511704"/>
              <a:gd name="connsiteY84" fmla="*/ 6125766 h 6886576"/>
              <a:gd name="connsiteX85" fmla="*/ 883579 w 5511704"/>
              <a:gd name="connsiteY85" fmla="*/ 6307932 h 6886576"/>
              <a:gd name="connsiteX86" fmla="*/ 1020229 w 5511704"/>
              <a:gd name="connsiteY86" fmla="*/ 6393657 h 6886576"/>
              <a:gd name="connsiteX87" fmla="*/ 1075471 w 5511704"/>
              <a:gd name="connsiteY87" fmla="*/ 6457950 h 6886576"/>
              <a:gd name="connsiteX88" fmla="*/ 1232473 w 5511704"/>
              <a:gd name="connsiteY88" fmla="*/ 6686551 h 6886576"/>
              <a:gd name="connsiteX89" fmla="*/ 1592997 w 5511704"/>
              <a:gd name="connsiteY89" fmla="*/ 6886576 h 6886576"/>
              <a:gd name="connsiteX90" fmla="*/ 5511704 w 5511704"/>
              <a:gd name="connsiteY90" fmla="*/ 6886576 h 68865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Lst>
            <a:rect l="l" t="t" r="r" b="b"/>
            <a:pathLst>
              <a:path w="5511704" h="6886576">
                <a:moveTo>
                  <a:pt x="5511704" y="0"/>
                </a:moveTo>
                <a:lnTo>
                  <a:pt x="1008599" y="0"/>
                </a:lnTo>
                <a:cubicBezTo>
                  <a:pt x="1110360" y="35719"/>
                  <a:pt x="1209214" y="78581"/>
                  <a:pt x="1310975" y="110728"/>
                </a:cubicBezTo>
                <a:cubicBezTo>
                  <a:pt x="1296437" y="146447"/>
                  <a:pt x="1281900" y="139303"/>
                  <a:pt x="1267362" y="135731"/>
                </a:cubicBezTo>
                <a:cubicBezTo>
                  <a:pt x="1180139" y="121445"/>
                  <a:pt x="1090008" y="110728"/>
                  <a:pt x="1005692" y="71437"/>
                </a:cubicBezTo>
                <a:cubicBezTo>
                  <a:pt x="985339" y="64294"/>
                  <a:pt x="962080" y="64294"/>
                  <a:pt x="953358" y="89297"/>
                </a:cubicBezTo>
                <a:cubicBezTo>
                  <a:pt x="938820" y="125016"/>
                  <a:pt x="959172" y="146447"/>
                  <a:pt x="979525" y="164307"/>
                </a:cubicBezTo>
                <a:cubicBezTo>
                  <a:pt x="1014414" y="196453"/>
                  <a:pt x="1055118" y="189310"/>
                  <a:pt x="1092915" y="192882"/>
                </a:cubicBezTo>
                <a:cubicBezTo>
                  <a:pt x="1197583" y="210741"/>
                  <a:pt x="1247011" y="260747"/>
                  <a:pt x="1270270" y="375047"/>
                </a:cubicBezTo>
                <a:cubicBezTo>
                  <a:pt x="1180139" y="328613"/>
                  <a:pt x="1090008" y="385763"/>
                  <a:pt x="1002784" y="353615"/>
                </a:cubicBezTo>
                <a:cubicBezTo>
                  <a:pt x="979525" y="346472"/>
                  <a:pt x="944635" y="357188"/>
                  <a:pt x="956265" y="396479"/>
                </a:cubicBezTo>
                <a:cubicBezTo>
                  <a:pt x="967894" y="432198"/>
                  <a:pt x="1005692" y="460772"/>
                  <a:pt x="938820" y="453629"/>
                </a:cubicBezTo>
                <a:cubicBezTo>
                  <a:pt x="889393" y="450056"/>
                  <a:pt x="874856" y="407194"/>
                  <a:pt x="860319" y="360759"/>
                </a:cubicBezTo>
                <a:cubicBezTo>
                  <a:pt x="848689" y="335757"/>
                  <a:pt x="816707" y="321469"/>
                  <a:pt x="793447" y="335757"/>
                </a:cubicBezTo>
                <a:cubicBezTo>
                  <a:pt x="764373" y="350044"/>
                  <a:pt x="773095" y="389335"/>
                  <a:pt x="773095" y="417910"/>
                </a:cubicBezTo>
                <a:cubicBezTo>
                  <a:pt x="770187" y="471488"/>
                  <a:pt x="793447" y="496491"/>
                  <a:pt x="834151" y="507206"/>
                </a:cubicBezTo>
                <a:cubicBezTo>
                  <a:pt x="883579" y="521494"/>
                  <a:pt x="933005" y="539354"/>
                  <a:pt x="996969" y="560785"/>
                </a:cubicBezTo>
                <a:cubicBezTo>
                  <a:pt x="927190" y="596503"/>
                  <a:pt x="874856" y="589360"/>
                  <a:pt x="822522" y="560785"/>
                </a:cubicBezTo>
                <a:cubicBezTo>
                  <a:pt x="758558" y="528637"/>
                  <a:pt x="674242" y="485775"/>
                  <a:pt x="621908" y="525066"/>
                </a:cubicBezTo>
                <a:cubicBezTo>
                  <a:pt x="543407" y="582216"/>
                  <a:pt x="479443" y="546497"/>
                  <a:pt x="409664" y="535781"/>
                </a:cubicBezTo>
                <a:cubicBezTo>
                  <a:pt x="264290" y="514350"/>
                  <a:pt x="354422" y="482204"/>
                  <a:pt x="209049" y="464344"/>
                </a:cubicBezTo>
                <a:cubicBezTo>
                  <a:pt x="150900" y="457200"/>
                  <a:pt x="89843" y="428625"/>
                  <a:pt x="5527" y="467916"/>
                </a:cubicBezTo>
                <a:cubicBezTo>
                  <a:pt x="386404" y="675085"/>
                  <a:pt x="566666" y="660797"/>
                  <a:pt x="906838" y="914400"/>
                </a:cubicBezTo>
                <a:cubicBezTo>
                  <a:pt x="892301" y="939404"/>
                  <a:pt x="877764" y="928688"/>
                  <a:pt x="863226" y="925116"/>
                </a:cubicBezTo>
                <a:cubicBezTo>
                  <a:pt x="839967" y="921544"/>
                  <a:pt x="810892" y="907256"/>
                  <a:pt x="805077" y="953691"/>
                </a:cubicBezTo>
                <a:cubicBezTo>
                  <a:pt x="802169" y="989410"/>
                  <a:pt x="819615" y="1007269"/>
                  <a:pt x="848689" y="1010841"/>
                </a:cubicBezTo>
                <a:cubicBezTo>
                  <a:pt x="933005" y="1025129"/>
                  <a:pt x="1008599" y="1075135"/>
                  <a:pt x="1084193" y="1117997"/>
                </a:cubicBezTo>
                <a:cubicBezTo>
                  <a:pt x="1119082" y="1135857"/>
                  <a:pt x="1156879" y="1160860"/>
                  <a:pt x="1142342" y="1225153"/>
                </a:cubicBezTo>
                <a:cubicBezTo>
                  <a:pt x="1113268" y="1243013"/>
                  <a:pt x="1092915" y="1218009"/>
                  <a:pt x="1069655" y="1214438"/>
                </a:cubicBezTo>
                <a:cubicBezTo>
                  <a:pt x="1046396" y="1210866"/>
                  <a:pt x="991154" y="1225153"/>
                  <a:pt x="1005692" y="1235869"/>
                </a:cubicBezTo>
                <a:cubicBezTo>
                  <a:pt x="1072563" y="1275159"/>
                  <a:pt x="950450" y="1371600"/>
                  <a:pt x="1031858" y="1371600"/>
                </a:cubicBezTo>
                <a:cubicBezTo>
                  <a:pt x="1165601" y="1371600"/>
                  <a:pt x="1238288" y="1543050"/>
                  <a:pt x="1366216" y="1546622"/>
                </a:cubicBezTo>
                <a:cubicBezTo>
                  <a:pt x="1386568" y="1546622"/>
                  <a:pt x="1395290" y="1578770"/>
                  <a:pt x="1395290" y="1603772"/>
                </a:cubicBezTo>
                <a:cubicBezTo>
                  <a:pt x="1395290" y="1635920"/>
                  <a:pt x="1374939" y="1639491"/>
                  <a:pt x="1354586" y="1643063"/>
                </a:cubicBezTo>
                <a:cubicBezTo>
                  <a:pt x="1322604" y="1646635"/>
                  <a:pt x="1287715" y="1603772"/>
                  <a:pt x="1247011" y="1664494"/>
                </a:cubicBezTo>
                <a:cubicBezTo>
                  <a:pt x="1322604" y="1700213"/>
                  <a:pt x="1401105" y="1735932"/>
                  <a:pt x="1398198" y="1857375"/>
                </a:cubicBezTo>
                <a:cubicBezTo>
                  <a:pt x="1398198" y="1889523"/>
                  <a:pt x="1430180" y="1903810"/>
                  <a:pt x="1453440" y="1910954"/>
                </a:cubicBezTo>
                <a:cubicBezTo>
                  <a:pt x="1494144" y="1925241"/>
                  <a:pt x="1526126" y="1946673"/>
                  <a:pt x="1549386" y="1993106"/>
                </a:cubicBezTo>
                <a:cubicBezTo>
                  <a:pt x="1549386" y="2003822"/>
                  <a:pt x="1549386" y="2010966"/>
                  <a:pt x="1549386" y="2021681"/>
                </a:cubicBezTo>
                <a:cubicBezTo>
                  <a:pt x="1543571" y="2132410"/>
                  <a:pt x="1485422" y="2128838"/>
                  <a:pt x="1421458" y="2110978"/>
                </a:cubicBezTo>
                <a:cubicBezTo>
                  <a:pt x="1345864" y="2089547"/>
                  <a:pt x="1270270" y="2046685"/>
                  <a:pt x="1188861" y="2085976"/>
                </a:cubicBezTo>
                <a:cubicBezTo>
                  <a:pt x="1302252" y="2139554"/>
                  <a:pt x="1427272" y="2143126"/>
                  <a:pt x="1531941" y="2218135"/>
                </a:cubicBezTo>
                <a:cubicBezTo>
                  <a:pt x="1142342" y="2232422"/>
                  <a:pt x="799262" y="1993106"/>
                  <a:pt x="421293" y="1900238"/>
                </a:cubicBezTo>
                <a:cubicBezTo>
                  <a:pt x="432923" y="1960960"/>
                  <a:pt x="464905" y="1975247"/>
                  <a:pt x="491072" y="1982391"/>
                </a:cubicBezTo>
                <a:cubicBezTo>
                  <a:pt x="630630" y="2028825"/>
                  <a:pt x="752743" y="2121695"/>
                  <a:pt x="880671" y="2200276"/>
                </a:cubicBezTo>
                <a:cubicBezTo>
                  <a:pt x="933005" y="2232422"/>
                  <a:pt x="970802" y="2268142"/>
                  <a:pt x="991154" y="2336007"/>
                </a:cubicBezTo>
                <a:cubicBezTo>
                  <a:pt x="1008599" y="2400300"/>
                  <a:pt x="1043489" y="2428875"/>
                  <a:pt x="1107453" y="2411016"/>
                </a:cubicBezTo>
                <a:cubicBezTo>
                  <a:pt x="1159787" y="2396729"/>
                  <a:pt x="1215029" y="2403873"/>
                  <a:pt x="1270270" y="2411016"/>
                </a:cubicBezTo>
                <a:cubicBezTo>
                  <a:pt x="1331326" y="2418160"/>
                  <a:pt x="1401105" y="2489597"/>
                  <a:pt x="1386568" y="2528889"/>
                </a:cubicBezTo>
                <a:cubicBezTo>
                  <a:pt x="1357494" y="2593182"/>
                  <a:pt x="1308067" y="2561035"/>
                  <a:pt x="1267362" y="2553891"/>
                </a:cubicBezTo>
                <a:cubicBezTo>
                  <a:pt x="1217936" y="2546748"/>
                  <a:pt x="1127805" y="2528889"/>
                  <a:pt x="1127805" y="2536032"/>
                </a:cubicBezTo>
                <a:cubicBezTo>
                  <a:pt x="1095822" y="2696766"/>
                  <a:pt x="1023136" y="2575322"/>
                  <a:pt x="970802" y="2575322"/>
                </a:cubicBezTo>
                <a:cubicBezTo>
                  <a:pt x="921375" y="2575322"/>
                  <a:pt x="871949" y="2557463"/>
                  <a:pt x="825429" y="2543176"/>
                </a:cubicBezTo>
                <a:cubicBezTo>
                  <a:pt x="764373" y="2525316"/>
                  <a:pt x="709132" y="2557463"/>
                  <a:pt x="650982" y="2564607"/>
                </a:cubicBezTo>
                <a:cubicBezTo>
                  <a:pt x="598648" y="2571751"/>
                  <a:pt x="627722" y="2664620"/>
                  <a:pt x="595740" y="2703909"/>
                </a:cubicBezTo>
                <a:cubicBezTo>
                  <a:pt x="589926" y="2714626"/>
                  <a:pt x="584111" y="2714626"/>
                  <a:pt x="578296" y="2714626"/>
                </a:cubicBezTo>
                <a:cubicBezTo>
                  <a:pt x="560851" y="2993232"/>
                  <a:pt x="255568" y="2925366"/>
                  <a:pt x="255568" y="2936081"/>
                </a:cubicBezTo>
                <a:cubicBezTo>
                  <a:pt x="229401" y="2953941"/>
                  <a:pt x="197419" y="2911079"/>
                  <a:pt x="165437" y="2953941"/>
                </a:cubicBezTo>
                <a:cubicBezTo>
                  <a:pt x="302087" y="3150394"/>
                  <a:pt x="511425" y="3196828"/>
                  <a:pt x="697501" y="3343275"/>
                </a:cubicBezTo>
                <a:cubicBezTo>
                  <a:pt x="543407" y="3393282"/>
                  <a:pt x="453275" y="3221832"/>
                  <a:pt x="339884" y="3243263"/>
                </a:cubicBezTo>
                <a:cubicBezTo>
                  <a:pt x="284643" y="3296842"/>
                  <a:pt x="450368" y="3382566"/>
                  <a:pt x="290458" y="3407569"/>
                </a:cubicBezTo>
                <a:cubicBezTo>
                  <a:pt x="360236" y="3454004"/>
                  <a:pt x="409664" y="3500439"/>
                  <a:pt x="459090" y="3554016"/>
                </a:cubicBezTo>
                <a:cubicBezTo>
                  <a:pt x="543407" y="3650457"/>
                  <a:pt x="560851" y="3714751"/>
                  <a:pt x="520147" y="3843338"/>
                </a:cubicBezTo>
                <a:cubicBezTo>
                  <a:pt x="493979" y="3929063"/>
                  <a:pt x="456183" y="4007645"/>
                  <a:pt x="491072" y="4107657"/>
                </a:cubicBezTo>
                <a:cubicBezTo>
                  <a:pt x="514332" y="4175522"/>
                  <a:pt x="505609" y="4221957"/>
                  <a:pt x="418386" y="4189810"/>
                </a:cubicBezTo>
                <a:cubicBezTo>
                  <a:pt x="325347" y="4157663"/>
                  <a:pt x="290458" y="4218386"/>
                  <a:pt x="313718" y="4339829"/>
                </a:cubicBezTo>
                <a:cubicBezTo>
                  <a:pt x="328254" y="4418410"/>
                  <a:pt x="313718" y="4443413"/>
                  <a:pt x="249753" y="4432698"/>
                </a:cubicBezTo>
                <a:cubicBezTo>
                  <a:pt x="179975" y="4421982"/>
                  <a:pt x="113103" y="4371976"/>
                  <a:pt x="25879" y="4396979"/>
                </a:cubicBezTo>
                <a:cubicBezTo>
                  <a:pt x="95658" y="4539854"/>
                  <a:pt x="243939" y="4496991"/>
                  <a:pt x="325347" y="4632722"/>
                </a:cubicBezTo>
                <a:cubicBezTo>
                  <a:pt x="229401" y="4632722"/>
                  <a:pt x="153807" y="4632722"/>
                  <a:pt x="84029" y="4604147"/>
                </a:cubicBezTo>
                <a:cubicBezTo>
                  <a:pt x="54954" y="4593433"/>
                  <a:pt x="22972" y="4579145"/>
                  <a:pt x="5527" y="4622007"/>
                </a:cubicBezTo>
                <a:cubicBezTo>
                  <a:pt x="-14826" y="4672014"/>
                  <a:pt x="25879" y="4689872"/>
                  <a:pt x="49139" y="4697016"/>
                </a:cubicBezTo>
                <a:cubicBezTo>
                  <a:pt x="116011" y="4722019"/>
                  <a:pt x="168344" y="4779170"/>
                  <a:pt x="226494" y="4825604"/>
                </a:cubicBezTo>
                <a:cubicBezTo>
                  <a:pt x="351514" y="4925616"/>
                  <a:pt x="488165" y="5011341"/>
                  <a:pt x="592833" y="5175647"/>
                </a:cubicBezTo>
                <a:cubicBezTo>
                  <a:pt x="461997" y="5132785"/>
                  <a:pt x="363144" y="5032772"/>
                  <a:pt x="238123" y="5014913"/>
                </a:cubicBezTo>
                <a:cubicBezTo>
                  <a:pt x="345700" y="5164932"/>
                  <a:pt x="482350" y="5264944"/>
                  <a:pt x="610278" y="5375673"/>
                </a:cubicBezTo>
                <a:cubicBezTo>
                  <a:pt x="648075" y="5407819"/>
                  <a:pt x="685872" y="5429250"/>
                  <a:pt x="691686" y="5497116"/>
                </a:cubicBezTo>
                <a:cubicBezTo>
                  <a:pt x="709132" y="5629276"/>
                  <a:pt x="755650" y="5736432"/>
                  <a:pt x="860319" y="5793582"/>
                </a:cubicBezTo>
                <a:cubicBezTo>
                  <a:pt x="860319" y="5793582"/>
                  <a:pt x="854504" y="5815013"/>
                  <a:pt x="851597" y="5825729"/>
                </a:cubicBezTo>
                <a:cubicBezTo>
                  <a:pt x="787632" y="5829301"/>
                  <a:pt x="738206" y="5750720"/>
                  <a:pt x="659704" y="5779295"/>
                </a:cubicBezTo>
                <a:cubicBezTo>
                  <a:pt x="738206" y="5886451"/>
                  <a:pt x="802169" y="5979319"/>
                  <a:pt x="909746" y="6029326"/>
                </a:cubicBezTo>
                <a:cubicBezTo>
                  <a:pt x="996969" y="6068616"/>
                  <a:pt x="1104545" y="6093620"/>
                  <a:pt x="1168509" y="6222207"/>
                </a:cubicBezTo>
                <a:cubicBezTo>
                  <a:pt x="1095822" y="6247210"/>
                  <a:pt x="1040581" y="6215063"/>
                  <a:pt x="985339" y="6193632"/>
                </a:cubicBezTo>
                <a:cubicBezTo>
                  <a:pt x="901023" y="6157913"/>
                  <a:pt x="816707" y="6118623"/>
                  <a:pt x="732391" y="6082904"/>
                </a:cubicBezTo>
                <a:cubicBezTo>
                  <a:pt x="700408" y="6068616"/>
                  <a:pt x="665519" y="6061472"/>
                  <a:pt x="645167" y="6125766"/>
                </a:cubicBezTo>
                <a:cubicBezTo>
                  <a:pt x="752743" y="6140053"/>
                  <a:pt x="816707" y="6225779"/>
                  <a:pt x="883579" y="6307932"/>
                </a:cubicBezTo>
                <a:cubicBezTo>
                  <a:pt x="921375" y="6354366"/>
                  <a:pt x="953358" y="6415088"/>
                  <a:pt x="1020229" y="6393657"/>
                </a:cubicBezTo>
                <a:cubicBezTo>
                  <a:pt x="1055118" y="6382942"/>
                  <a:pt x="1078378" y="6415088"/>
                  <a:pt x="1075471" y="6457950"/>
                </a:cubicBezTo>
                <a:cubicBezTo>
                  <a:pt x="1060933" y="6607970"/>
                  <a:pt x="1145250" y="6657976"/>
                  <a:pt x="1232473" y="6686551"/>
                </a:cubicBezTo>
                <a:cubicBezTo>
                  <a:pt x="1360401" y="6729413"/>
                  <a:pt x="1473792" y="6815138"/>
                  <a:pt x="1592997" y="6886576"/>
                </a:cubicBezTo>
                <a:lnTo>
                  <a:pt x="5511704" y="6886576"/>
                </a:lnTo>
                <a:close/>
              </a:path>
            </a:pathLst>
          </a:custGeom>
          <a:solidFill>
            <a:schemeClr val="accent1"/>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0C4B6199-722F-00F1-909C-9A7427FDE0AC}"/>
              </a:ext>
            </a:extLst>
          </p:cNvPr>
          <p:cNvSpPr>
            <a:spLocks noGrp="1"/>
          </p:cNvSpPr>
          <p:nvPr>
            <p:ph type="title"/>
          </p:nvPr>
        </p:nvSpPr>
        <p:spPr>
          <a:xfrm>
            <a:off x="838200" y="713312"/>
            <a:ext cx="3461084" cy="5431376"/>
          </a:xfrm>
        </p:spPr>
        <p:txBody>
          <a:bodyPr>
            <a:normAutofit/>
          </a:bodyPr>
          <a:lstStyle/>
          <a:p>
            <a:r>
              <a:rPr lang="en-US" b="1" dirty="0">
                <a:solidFill>
                  <a:srgbClr val="FFFFFF"/>
                </a:solidFill>
              </a:rPr>
              <a:t>Instructions:</a:t>
            </a:r>
            <a:br>
              <a:rPr lang="en-US" b="1" dirty="0">
                <a:solidFill>
                  <a:srgbClr val="FFFFFF"/>
                </a:solidFill>
              </a:rPr>
            </a:br>
            <a:r>
              <a:rPr lang="en-US" b="1" dirty="0">
                <a:solidFill>
                  <a:srgbClr val="FFC000"/>
                </a:solidFill>
              </a:rPr>
              <a:t>“Plenary Session”</a:t>
            </a:r>
          </a:p>
        </p:txBody>
      </p:sp>
      <p:sp>
        <p:nvSpPr>
          <p:cNvPr id="7" name="Content Placeholder 2">
            <a:extLst>
              <a:ext uri="{FF2B5EF4-FFF2-40B4-BE49-F238E27FC236}">
                <a16:creationId xmlns:a16="http://schemas.microsoft.com/office/drawing/2014/main" id="{8CBD4BDE-9FF4-BEBE-BAB0-1360E64AEE9D}"/>
              </a:ext>
            </a:extLst>
          </p:cNvPr>
          <p:cNvSpPr>
            <a:spLocks noGrp="1"/>
          </p:cNvSpPr>
          <p:nvPr>
            <p:ph idx="1"/>
          </p:nvPr>
        </p:nvSpPr>
        <p:spPr>
          <a:xfrm>
            <a:off x="5511705" y="536448"/>
            <a:ext cx="6388924" cy="6108192"/>
          </a:xfrm>
        </p:spPr>
        <p:txBody>
          <a:bodyPr anchor="ctr">
            <a:noAutofit/>
          </a:bodyPr>
          <a:lstStyle/>
          <a:p>
            <a:pPr>
              <a:spcBef>
                <a:spcPts val="0"/>
              </a:spcBef>
            </a:pPr>
            <a:r>
              <a:rPr lang="en-US" sz="2700" kern="100" dirty="0">
                <a:effectLst/>
                <a:latin typeface="Calibri" panose="020F0502020204030204" pitchFamily="34" charset="0"/>
                <a:ea typeface="Aptos" panose="020B0004020202020204" pitchFamily="34" charset="0"/>
                <a:cs typeface="Calibri" panose="020F0502020204030204" pitchFamily="34" charset="0"/>
              </a:rPr>
              <a:t>In the final 60-80 minutes, groups will pair together (groups with same artwork &amp; case scenario) </a:t>
            </a:r>
          </a:p>
          <a:p>
            <a:pPr>
              <a:spcBef>
                <a:spcPts val="0"/>
              </a:spcBef>
            </a:pPr>
            <a:r>
              <a:rPr lang="en-US" sz="2700" kern="100" dirty="0">
                <a:effectLst/>
                <a:latin typeface="Calibri" panose="020F0502020204030204" pitchFamily="34" charset="0"/>
                <a:ea typeface="Aptos" panose="020B0004020202020204" pitchFamily="34" charset="0"/>
                <a:cs typeface="Calibri" panose="020F0502020204030204" pitchFamily="34" charset="0"/>
              </a:rPr>
              <a:t>Present their case summary and the biochemical reasoning for the conditions given in the case</a:t>
            </a:r>
          </a:p>
          <a:p>
            <a:pPr>
              <a:spcBef>
                <a:spcPts val="0"/>
              </a:spcBef>
            </a:pPr>
            <a:r>
              <a:rPr lang="en-US" sz="2700" kern="100" dirty="0">
                <a:latin typeface="Calibri" panose="020F0502020204030204" pitchFamily="34" charset="0"/>
                <a:ea typeface="Aptos" panose="020B0004020202020204" pitchFamily="34" charset="0"/>
                <a:cs typeface="Calibri" panose="020F0502020204030204" pitchFamily="34" charset="0"/>
              </a:rPr>
              <a:t>After all groups present the cases, a post-session assessment with 15 reasoning type of question. (Short answer type)</a:t>
            </a:r>
            <a:endParaRPr lang="en-US" sz="2700" kern="100" dirty="0">
              <a:effectLst/>
              <a:latin typeface="Calibri" panose="020F0502020204030204" pitchFamily="34" charset="0"/>
              <a:ea typeface="Aptos" panose="020B0004020202020204" pitchFamily="34" charset="0"/>
              <a:cs typeface="Calibri" panose="020F0502020204030204" pitchFamily="34" charset="0"/>
            </a:endParaRPr>
          </a:p>
        </p:txBody>
      </p:sp>
    </p:spTree>
    <p:extLst>
      <p:ext uri="{BB962C8B-B14F-4D97-AF65-F5344CB8AC3E}">
        <p14:creationId xmlns:p14="http://schemas.microsoft.com/office/powerpoint/2010/main" val="14591872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useBgFill="1">
        <p:nvSpPr>
          <p:cNvPr id="21" name="Rectangle 20">
            <a:extLst>
              <a:ext uri="{FF2B5EF4-FFF2-40B4-BE49-F238E27FC236}">
                <a16:creationId xmlns:a16="http://schemas.microsoft.com/office/drawing/2014/main" id="{AA866F0E-F54B-4BF5-8A88-7D97BD45FC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a:extLst>
              <a:ext uri="{FF2B5EF4-FFF2-40B4-BE49-F238E27FC236}">
                <a16:creationId xmlns:a16="http://schemas.microsoft.com/office/drawing/2014/main" id="{536F6B5C-2B5F-4FEE-8263-34996D29DC5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Freeform: Shape 24">
            <a:extLst>
              <a:ext uri="{FF2B5EF4-FFF2-40B4-BE49-F238E27FC236}">
                <a16:creationId xmlns:a16="http://schemas.microsoft.com/office/drawing/2014/main" id="{8229EC50-E910-4AE2-9EEA-604A81EF614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custGeom>
            <a:avLst/>
            <a:gdLst>
              <a:gd name="connsiteX0" fmla="*/ 6941221 w 12192000"/>
              <a:gd name="connsiteY0" fmla="*/ 2015186 h 6858000"/>
              <a:gd name="connsiteX1" fmla="*/ 6907857 w 12192000"/>
              <a:gd name="connsiteY1" fmla="*/ 2033351 h 6858000"/>
              <a:gd name="connsiteX2" fmla="*/ 7093700 w 12192000"/>
              <a:gd name="connsiteY2" fmla="*/ 2101457 h 6858000"/>
              <a:gd name="connsiteX3" fmla="*/ 6803079 w 12192000"/>
              <a:gd name="connsiteY3" fmla="*/ 2065612 h 6858000"/>
              <a:gd name="connsiteX4" fmla="*/ 6798115 w 12192000"/>
              <a:gd name="connsiteY4" fmla="*/ 2088772 h 6858000"/>
              <a:gd name="connsiteX5" fmla="*/ 7128167 w 12192000"/>
              <a:gd name="connsiteY5" fmla="*/ 2176455 h 6858000"/>
              <a:gd name="connsiteX6" fmla="*/ 7098663 w 12192000"/>
              <a:gd name="connsiteY6" fmla="*/ 2189968 h 6858000"/>
              <a:gd name="connsiteX7" fmla="*/ 6923298 w 12192000"/>
              <a:gd name="connsiteY7" fmla="*/ 2156052 h 6858000"/>
              <a:gd name="connsiteX8" fmla="*/ 6888004 w 12192000"/>
              <a:gd name="connsiteY8" fmla="*/ 2164875 h 6858000"/>
              <a:gd name="connsiteX9" fmla="*/ 6905375 w 12192000"/>
              <a:gd name="connsiteY9" fmla="*/ 2205958 h 6858000"/>
              <a:gd name="connsiteX10" fmla="*/ 6981477 w 12192000"/>
              <a:gd name="connsiteY10" fmla="*/ 2221951 h 6858000"/>
              <a:gd name="connsiteX11" fmla="*/ 7100043 w 12192000"/>
              <a:gd name="connsiteY11" fmla="*/ 2318459 h 6858000"/>
              <a:gd name="connsiteX12" fmla="*/ 6920540 w 12192000"/>
              <a:gd name="connsiteY12" fmla="*/ 2306877 h 6858000"/>
              <a:gd name="connsiteX13" fmla="*/ 6888831 w 12192000"/>
              <a:gd name="connsiteY13" fmla="*/ 2330314 h 6858000"/>
              <a:gd name="connsiteX14" fmla="*/ 6876698 w 12192000"/>
              <a:gd name="connsiteY14" fmla="*/ 2360645 h 6858000"/>
              <a:gd name="connsiteX15" fmla="*/ 6807214 w 12192000"/>
              <a:gd name="connsiteY15" fmla="*/ 2385736 h 6858000"/>
              <a:gd name="connsiteX16" fmla="*/ 6916405 w 12192000"/>
              <a:gd name="connsiteY16" fmla="*/ 2413862 h 6858000"/>
              <a:gd name="connsiteX17" fmla="*/ 6799770 w 12192000"/>
              <a:gd name="connsiteY17" fmla="*/ 2413862 h 6858000"/>
              <a:gd name="connsiteX18" fmla="*/ 6665762 w 12192000"/>
              <a:gd name="connsiteY18" fmla="*/ 2394561 h 6858000"/>
              <a:gd name="connsiteX19" fmla="*/ 6522933 w 12192000"/>
              <a:gd name="connsiteY19" fmla="*/ 2400626 h 6858000"/>
              <a:gd name="connsiteX20" fmla="*/ 6237275 w 12192000"/>
              <a:gd name="connsiteY20" fmla="*/ 2365057 h 6858000"/>
              <a:gd name="connsiteX21" fmla="*/ 6101338 w 12192000"/>
              <a:gd name="connsiteY21" fmla="*/ 2367538 h 6858000"/>
              <a:gd name="connsiteX22" fmla="*/ 6857121 w 12192000"/>
              <a:gd name="connsiteY22" fmla="*/ 2606875 h 6858000"/>
              <a:gd name="connsiteX23" fmla="*/ 6818519 w 12192000"/>
              <a:gd name="connsiteY23" fmla="*/ 2659539 h 6858000"/>
              <a:gd name="connsiteX24" fmla="*/ 6976790 w 12192000"/>
              <a:gd name="connsiteY24" fmla="*/ 2716892 h 6858000"/>
              <a:gd name="connsiteX25" fmla="*/ 7015669 w 12192000"/>
              <a:gd name="connsiteY25" fmla="*/ 2773693 h 6858000"/>
              <a:gd name="connsiteX26" fmla="*/ 6966864 w 12192000"/>
              <a:gd name="connsiteY26" fmla="*/ 2768730 h 6858000"/>
              <a:gd name="connsiteX27" fmla="*/ 6924953 w 12192000"/>
              <a:gd name="connsiteY27" fmla="*/ 2779483 h 6858000"/>
              <a:gd name="connsiteX28" fmla="*/ 6942323 w 12192000"/>
              <a:gd name="connsiteY28" fmla="*/ 2851726 h 6858000"/>
              <a:gd name="connsiteX29" fmla="*/ 7165943 w 12192000"/>
              <a:gd name="connsiteY29" fmla="*/ 2944924 h 6858000"/>
              <a:gd name="connsiteX30" fmla="*/ 7186071 w 12192000"/>
              <a:gd name="connsiteY30" fmla="*/ 2975254 h 6858000"/>
              <a:gd name="connsiteX31" fmla="*/ 7159325 w 12192000"/>
              <a:gd name="connsiteY31" fmla="*/ 2996762 h 6858000"/>
              <a:gd name="connsiteX32" fmla="*/ 7087082 w 12192000"/>
              <a:gd name="connsiteY32" fmla="*/ 3007790 h 6858000"/>
              <a:gd name="connsiteX33" fmla="*/ 7188276 w 12192000"/>
              <a:gd name="connsiteY33" fmla="*/ 3111191 h 6858000"/>
              <a:gd name="connsiteX34" fmla="*/ 7225225 w 12192000"/>
              <a:gd name="connsiteY34" fmla="*/ 3139866 h 6858000"/>
              <a:gd name="connsiteX35" fmla="*/ 7288368 w 12192000"/>
              <a:gd name="connsiteY35" fmla="*/ 3184260 h 6858000"/>
              <a:gd name="connsiteX36" fmla="*/ 7289471 w 12192000"/>
              <a:gd name="connsiteY36" fmla="*/ 3197771 h 6858000"/>
              <a:gd name="connsiteX37" fmla="*/ 7203442 w 12192000"/>
              <a:gd name="connsiteY37" fmla="*/ 3245472 h 6858000"/>
              <a:gd name="connsiteX38" fmla="*/ 7048205 w 12192000"/>
              <a:gd name="connsiteY38" fmla="*/ 3232512 h 6858000"/>
              <a:gd name="connsiteX39" fmla="*/ 7277614 w 12192000"/>
              <a:gd name="connsiteY39" fmla="*/ 3303652 h 6858000"/>
              <a:gd name="connsiteX40" fmla="*/ 6535066 w 12192000"/>
              <a:gd name="connsiteY40" fmla="*/ 3134077 h 6858000"/>
              <a:gd name="connsiteX41" fmla="*/ 6582492 w 12192000"/>
              <a:gd name="connsiteY41" fmla="*/ 3178469 h 6858000"/>
              <a:gd name="connsiteX42" fmla="*/ 6842233 w 12192000"/>
              <a:gd name="connsiteY42" fmla="*/ 3295379 h 6858000"/>
              <a:gd name="connsiteX43" fmla="*/ 6915853 w 12192000"/>
              <a:gd name="connsiteY43" fmla="*/ 3368725 h 6858000"/>
              <a:gd name="connsiteX44" fmla="*/ 6993058 w 12192000"/>
              <a:gd name="connsiteY44" fmla="*/ 3409257 h 6858000"/>
              <a:gd name="connsiteX45" fmla="*/ 7101421 w 12192000"/>
              <a:gd name="connsiteY45" fmla="*/ 3408430 h 6858000"/>
              <a:gd name="connsiteX46" fmla="*/ 7178350 w 12192000"/>
              <a:gd name="connsiteY46" fmla="*/ 3470746 h 6858000"/>
              <a:gd name="connsiteX47" fmla="*/ 7098112 w 12192000"/>
              <a:gd name="connsiteY47" fmla="*/ 3483982 h 6858000"/>
              <a:gd name="connsiteX48" fmla="*/ 7004088 w 12192000"/>
              <a:gd name="connsiteY48" fmla="*/ 3473780 h 6858000"/>
              <a:gd name="connsiteX49" fmla="*/ 6801147 w 12192000"/>
              <a:gd name="connsiteY49" fmla="*/ 3477087 h 6858000"/>
              <a:gd name="connsiteX50" fmla="*/ 6684788 w 12192000"/>
              <a:gd name="connsiteY50" fmla="*/ 3489220 h 6858000"/>
              <a:gd name="connsiteX51" fmla="*/ 6417328 w 12192000"/>
              <a:gd name="connsiteY51" fmla="*/ 3468539 h 6858000"/>
              <a:gd name="connsiteX52" fmla="*/ 6433045 w 12192000"/>
              <a:gd name="connsiteY52" fmla="*/ 3521481 h 6858000"/>
              <a:gd name="connsiteX53" fmla="*/ 6423117 w 12192000"/>
              <a:gd name="connsiteY53" fmla="*/ 3567527 h 6858000"/>
              <a:gd name="connsiteX54" fmla="*/ 6419258 w 12192000"/>
              <a:gd name="connsiteY54" fmla="*/ 3667620 h 6858000"/>
              <a:gd name="connsiteX55" fmla="*/ 6421740 w 12192000"/>
              <a:gd name="connsiteY55" fmla="*/ 3683888 h 6858000"/>
              <a:gd name="connsiteX56" fmla="*/ 6361906 w 12192000"/>
              <a:gd name="connsiteY56" fmla="*/ 3694366 h 6858000"/>
              <a:gd name="connsiteX57" fmla="*/ 6718429 w 12192000"/>
              <a:gd name="connsiteY57" fmla="*/ 3902544 h 6858000"/>
              <a:gd name="connsiteX58" fmla="*/ 6480195 w 12192000"/>
              <a:gd name="connsiteY58" fmla="*/ 3849603 h 6858000"/>
              <a:gd name="connsiteX59" fmla="*/ 6447934 w 12192000"/>
              <a:gd name="connsiteY59" fmla="*/ 3937011 h 6858000"/>
              <a:gd name="connsiteX60" fmla="*/ 6559882 w 12192000"/>
              <a:gd name="connsiteY60" fmla="*/ 4014767 h 6858000"/>
              <a:gd name="connsiteX61" fmla="*/ 6601241 w 12192000"/>
              <a:gd name="connsiteY61" fmla="*/ 4168626 h 6858000"/>
              <a:gd name="connsiteX62" fmla="*/ 6581113 w 12192000"/>
              <a:gd name="connsiteY62" fmla="*/ 4309250 h 6858000"/>
              <a:gd name="connsiteX63" fmla="*/ 6533136 w 12192000"/>
              <a:gd name="connsiteY63" fmla="*/ 4353918 h 6858000"/>
              <a:gd name="connsiteX64" fmla="*/ 6463651 w 12192000"/>
              <a:gd name="connsiteY64" fmla="*/ 4434156 h 6858000"/>
              <a:gd name="connsiteX65" fmla="*/ 6420637 w 12192000"/>
              <a:gd name="connsiteY65" fmla="*/ 4483787 h 6858000"/>
              <a:gd name="connsiteX66" fmla="*/ 6271190 w 12192000"/>
              <a:gd name="connsiteY66" fmla="*/ 4464487 h 6858000"/>
              <a:gd name="connsiteX67" fmla="*/ 6470545 w 12192000"/>
              <a:gd name="connsiteY67" fmla="*/ 4590498 h 6858000"/>
              <a:gd name="connsiteX68" fmla="*/ 6308965 w 12192000"/>
              <a:gd name="connsiteY68" fmla="*/ 4574780 h 6858000"/>
              <a:gd name="connsiteX69" fmla="*/ 6256301 w 12192000"/>
              <a:gd name="connsiteY69" fmla="*/ 4583603 h 6858000"/>
              <a:gd name="connsiteX70" fmla="*/ 6286354 w 12192000"/>
              <a:gd name="connsiteY70" fmla="*/ 4624412 h 6858000"/>
              <a:gd name="connsiteX71" fmla="*/ 6404920 w 12192000"/>
              <a:gd name="connsiteY71" fmla="*/ 4693621 h 6858000"/>
              <a:gd name="connsiteX72" fmla="*/ 6649220 w 12192000"/>
              <a:gd name="connsiteY72" fmla="*/ 4881120 h 6858000"/>
              <a:gd name="connsiteX73" fmla="*/ 6412640 w 12192000"/>
              <a:gd name="connsiteY73" fmla="*/ 4795092 h 6858000"/>
              <a:gd name="connsiteX74" fmla="*/ 6661902 w 12192000"/>
              <a:gd name="connsiteY74" fmla="*/ 4987828 h 6858000"/>
              <a:gd name="connsiteX75" fmla="*/ 6717325 w 12192000"/>
              <a:gd name="connsiteY75" fmla="*/ 5051798 h 6858000"/>
              <a:gd name="connsiteX76" fmla="*/ 6829272 w 12192000"/>
              <a:gd name="connsiteY76" fmla="*/ 5210619 h 6858000"/>
              <a:gd name="connsiteX77" fmla="*/ 6823757 w 12192000"/>
              <a:gd name="connsiteY77" fmla="*/ 5228542 h 6858000"/>
              <a:gd name="connsiteX78" fmla="*/ 6694439 w 12192000"/>
              <a:gd name="connsiteY78" fmla="*/ 5202899 h 6858000"/>
              <a:gd name="connsiteX79" fmla="*/ 6862085 w 12192000"/>
              <a:gd name="connsiteY79" fmla="*/ 5336355 h 6858000"/>
              <a:gd name="connsiteX80" fmla="*/ 7035246 w 12192000"/>
              <a:gd name="connsiteY80" fmla="*/ 5438926 h 6858000"/>
              <a:gd name="connsiteX81" fmla="*/ 6912268 w 12192000"/>
              <a:gd name="connsiteY81" fmla="*/ 5423210 h 6858000"/>
              <a:gd name="connsiteX82" fmla="*/ 6743244 w 12192000"/>
              <a:gd name="connsiteY82" fmla="*/ 5364479 h 6858000"/>
              <a:gd name="connsiteX83" fmla="*/ 6684513 w 12192000"/>
              <a:gd name="connsiteY83" fmla="*/ 5386538 h 6858000"/>
              <a:gd name="connsiteX84" fmla="*/ 6844713 w 12192000"/>
              <a:gd name="connsiteY84" fmla="*/ 5483595 h 6858000"/>
              <a:gd name="connsiteX85" fmla="*/ 6936533 w 12192000"/>
              <a:gd name="connsiteY85" fmla="*/ 5528541 h 6858000"/>
              <a:gd name="connsiteX86" fmla="*/ 6973204 w 12192000"/>
              <a:gd name="connsiteY86" fmla="*/ 5563007 h 6858000"/>
              <a:gd name="connsiteX87" fmla="*/ 7077983 w 12192000"/>
              <a:gd name="connsiteY87" fmla="*/ 5685983 h 6858000"/>
              <a:gd name="connsiteX88" fmla="*/ 7385702 w 12192000"/>
              <a:gd name="connsiteY88" fmla="*/ 5820265 h 6858000"/>
              <a:gd name="connsiteX89" fmla="*/ 7673565 w 12192000"/>
              <a:gd name="connsiteY89" fmla="*/ 5987085 h 6858000"/>
              <a:gd name="connsiteX90" fmla="*/ 7898289 w 12192000"/>
              <a:gd name="connsiteY90" fmla="*/ 6091035 h 6858000"/>
              <a:gd name="connsiteX91" fmla="*/ 8466299 w 12192000"/>
              <a:gd name="connsiteY91" fmla="*/ 6224765 h 6858000"/>
              <a:gd name="connsiteX92" fmla="*/ 10620599 w 12192000"/>
              <a:gd name="connsiteY92" fmla="*/ 5317605 h 6858000"/>
              <a:gd name="connsiteX93" fmla="*/ 10647894 w 12192000"/>
              <a:gd name="connsiteY93" fmla="*/ 5290581 h 6858000"/>
              <a:gd name="connsiteX94" fmla="*/ 10752398 w 12192000"/>
              <a:gd name="connsiteY94" fmla="*/ 5188838 h 6858000"/>
              <a:gd name="connsiteX95" fmla="*/ 10841186 w 12192000"/>
              <a:gd name="connsiteY95" fmla="*/ 5097293 h 6858000"/>
              <a:gd name="connsiteX96" fmla="*/ 10794861 w 12192000"/>
              <a:gd name="connsiteY96" fmla="*/ 5066412 h 6858000"/>
              <a:gd name="connsiteX97" fmla="*/ 10857454 w 12192000"/>
              <a:gd name="connsiteY97" fmla="*/ 4979004 h 6858000"/>
              <a:gd name="connsiteX98" fmla="*/ 11056532 w 12192000"/>
              <a:gd name="connsiteY98" fmla="*/ 4709613 h 6858000"/>
              <a:gd name="connsiteX99" fmla="*/ 11143939 w 12192000"/>
              <a:gd name="connsiteY99" fmla="*/ 4650332 h 6858000"/>
              <a:gd name="connsiteX100" fmla="*/ 11250372 w 12192000"/>
              <a:gd name="connsiteY100" fmla="*/ 4501160 h 6858000"/>
              <a:gd name="connsiteX101" fmla="*/ 11265538 w 12192000"/>
              <a:gd name="connsiteY101" fmla="*/ 4466694 h 6858000"/>
              <a:gd name="connsiteX102" fmla="*/ 11243755 w 12192000"/>
              <a:gd name="connsiteY102" fmla="*/ 4422850 h 6858000"/>
              <a:gd name="connsiteX103" fmla="*/ 11227486 w 12192000"/>
              <a:gd name="connsiteY103" fmla="*/ 4378734 h 6858000"/>
              <a:gd name="connsiteX104" fmla="*/ 11248718 w 12192000"/>
              <a:gd name="connsiteY104" fmla="*/ 4365774 h 6858000"/>
              <a:gd name="connsiteX105" fmla="*/ 11385204 w 12192000"/>
              <a:gd name="connsiteY105" fmla="*/ 4343440 h 6858000"/>
              <a:gd name="connsiteX106" fmla="*/ 11306070 w 12192000"/>
              <a:gd name="connsiteY106" fmla="*/ 4259618 h 6858000"/>
              <a:gd name="connsiteX107" fmla="*/ 11166550 w 12192000"/>
              <a:gd name="connsiteY107" fmla="*/ 4134711 h 6858000"/>
              <a:gd name="connsiteX108" fmla="*/ 11103130 w 12192000"/>
              <a:gd name="connsiteY108" fmla="*/ 4045924 h 6858000"/>
              <a:gd name="connsiteX109" fmla="*/ 11095686 w 12192000"/>
              <a:gd name="connsiteY109" fmla="*/ 3966514 h 6858000"/>
              <a:gd name="connsiteX110" fmla="*/ 10971054 w 12192000"/>
              <a:gd name="connsiteY110" fmla="*/ 3919640 h 6858000"/>
              <a:gd name="connsiteX111" fmla="*/ 11088241 w 12192000"/>
              <a:gd name="connsiteY111" fmla="*/ 3751718 h 6858000"/>
              <a:gd name="connsiteX112" fmla="*/ 11100098 w 12192000"/>
              <a:gd name="connsiteY112" fmla="*/ 3716977 h 6858000"/>
              <a:gd name="connsiteX113" fmla="*/ 11029786 w 12192000"/>
              <a:gd name="connsiteY113" fmla="*/ 3592621 h 6858000"/>
              <a:gd name="connsiteX114" fmla="*/ 11018206 w 12192000"/>
              <a:gd name="connsiteY114" fmla="*/ 3572767 h 6858000"/>
              <a:gd name="connsiteX115" fmla="*/ 10992287 w 12192000"/>
              <a:gd name="connsiteY115" fmla="*/ 3533061 h 6858000"/>
              <a:gd name="connsiteX116" fmla="*/ 10917838 w 12192000"/>
              <a:gd name="connsiteY116" fmla="*/ 3523410 h 6858000"/>
              <a:gd name="connsiteX117" fmla="*/ 10956441 w 12192000"/>
              <a:gd name="connsiteY117" fmla="*/ 3495287 h 6858000"/>
              <a:gd name="connsiteX118" fmla="*/ 11031442 w 12192000"/>
              <a:gd name="connsiteY118" fmla="*/ 3400159 h 6858000"/>
              <a:gd name="connsiteX119" fmla="*/ 10981533 w 12192000"/>
              <a:gd name="connsiteY119" fmla="*/ 3309166 h 6858000"/>
              <a:gd name="connsiteX120" fmla="*/ 10978225 w 12192000"/>
              <a:gd name="connsiteY120" fmla="*/ 3258982 h 6858000"/>
              <a:gd name="connsiteX121" fmla="*/ 11062322 w 12192000"/>
              <a:gd name="connsiteY121" fmla="*/ 3194737 h 6858000"/>
              <a:gd name="connsiteX122" fmla="*/ 11125742 w 12192000"/>
              <a:gd name="connsiteY122" fmla="*/ 3169370 h 6858000"/>
              <a:gd name="connsiteX123" fmla="*/ 11154968 w 12192000"/>
              <a:gd name="connsiteY123" fmla="*/ 3132974 h 6858000"/>
              <a:gd name="connsiteX124" fmla="*/ 11120502 w 12192000"/>
              <a:gd name="connsiteY124" fmla="*/ 3102642 h 6858000"/>
              <a:gd name="connsiteX125" fmla="*/ 10967470 w 12192000"/>
              <a:gd name="connsiteY125" fmla="*/ 3030401 h 6858000"/>
              <a:gd name="connsiteX126" fmla="*/ 11049914 w 12192000"/>
              <a:gd name="connsiteY126" fmla="*/ 2970015 h 6858000"/>
              <a:gd name="connsiteX127" fmla="*/ 10618944 w 12192000"/>
              <a:gd name="connsiteY127" fmla="*/ 2685183 h 6858000"/>
              <a:gd name="connsiteX128" fmla="*/ 10566830 w 12192000"/>
              <a:gd name="connsiteY128" fmla="*/ 2641617 h 6858000"/>
              <a:gd name="connsiteX129" fmla="*/ 10290271 w 12192000"/>
              <a:gd name="connsiteY129" fmla="*/ 2536011 h 6858000"/>
              <a:gd name="connsiteX130" fmla="*/ 10005715 w 12192000"/>
              <a:gd name="connsiteY130" fmla="*/ 2461288 h 6858000"/>
              <a:gd name="connsiteX131" fmla="*/ 10203414 w 12192000"/>
              <a:gd name="connsiteY131" fmla="*/ 2303568 h 6858000"/>
              <a:gd name="connsiteX132" fmla="*/ 9901487 w 12192000"/>
              <a:gd name="connsiteY132" fmla="*/ 2266895 h 6858000"/>
              <a:gd name="connsiteX133" fmla="*/ 9871984 w 12192000"/>
              <a:gd name="connsiteY133" fmla="*/ 2267999 h 6858000"/>
              <a:gd name="connsiteX134" fmla="*/ 9279158 w 12192000"/>
              <a:gd name="connsiteY134" fmla="*/ 2243734 h 6858000"/>
              <a:gd name="connsiteX135" fmla="*/ 8429350 w 12192000"/>
              <a:gd name="connsiteY135" fmla="*/ 2163219 h 6858000"/>
              <a:gd name="connsiteX136" fmla="*/ 7725955 w 12192000"/>
              <a:gd name="connsiteY136" fmla="*/ 2114967 h 6858000"/>
              <a:gd name="connsiteX137" fmla="*/ 6977065 w 12192000"/>
              <a:gd name="connsiteY137" fmla="*/ 2021218 h 6858000"/>
              <a:gd name="connsiteX138" fmla="*/ 6941221 w 12192000"/>
              <a:gd name="connsiteY138" fmla="*/ 2015186 h 6858000"/>
              <a:gd name="connsiteX139" fmla="*/ 0 w 12192000"/>
              <a:gd name="connsiteY139" fmla="*/ 0 h 6858000"/>
              <a:gd name="connsiteX140" fmla="*/ 12192000 w 12192000"/>
              <a:gd name="connsiteY140" fmla="*/ 0 h 6858000"/>
              <a:gd name="connsiteX141" fmla="*/ 12192000 w 12192000"/>
              <a:gd name="connsiteY141" fmla="*/ 6858000 h 6858000"/>
              <a:gd name="connsiteX142" fmla="*/ 0 w 12192000"/>
              <a:gd name="connsiteY142"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Lst>
            <a:rect l="l" t="t" r="r" b="b"/>
            <a:pathLst>
              <a:path w="12192000" h="6858000">
                <a:moveTo>
                  <a:pt x="6941221" y="2015186"/>
                </a:moveTo>
                <a:cubicBezTo>
                  <a:pt x="6929158" y="2014876"/>
                  <a:pt x="6917508" y="2018599"/>
                  <a:pt x="6907857" y="2033351"/>
                </a:cubicBezTo>
                <a:cubicBezTo>
                  <a:pt x="6959143" y="2072228"/>
                  <a:pt x="7024491" y="2057614"/>
                  <a:pt x="7093700" y="2101457"/>
                </a:cubicBezTo>
                <a:cubicBezTo>
                  <a:pt x="6981202" y="2087669"/>
                  <a:pt x="6892139" y="2076639"/>
                  <a:pt x="6803079" y="2065612"/>
                </a:cubicBezTo>
                <a:cubicBezTo>
                  <a:pt x="6801424" y="2073332"/>
                  <a:pt x="6799770" y="2081052"/>
                  <a:pt x="6798115" y="2088772"/>
                </a:cubicBezTo>
                <a:cubicBezTo>
                  <a:pt x="6911993" y="2105040"/>
                  <a:pt x="7017322" y="2146951"/>
                  <a:pt x="7128167" y="2176455"/>
                </a:cubicBezTo>
                <a:cubicBezTo>
                  <a:pt x="7117964" y="2194655"/>
                  <a:pt x="7107764" y="2191070"/>
                  <a:pt x="7098663" y="2189968"/>
                </a:cubicBezTo>
                <a:cubicBezTo>
                  <a:pt x="7039381" y="2182798"/>
                  <a:pt x="6980099" y="2175629"/>
                  <a:pt x="6923298" y="2156052"/>
                </a:cubicBezTo>
                <a:cubicBezTo>
                  <a:pt x="6910614" y="2151639"/>
                  <a:pt x="6895172" y="2151639"/>
                  <a:pt x="6888004" y="2164875"/>
                </a:cubicBezTo>
                <a:cubicBezTo>
                  <a:pt x="6877801" y="2183625"/>
                  <a:pt x="6892414" y="2195758"/>
                  <a:pt x="6905375" y="2205958"/>
                </a:cubicBezTo>
                <a:cubicBezTo>
                  <a:pt x="6927985" y="2223606"/>
                  <a:pt x="6955282" y="2218643"/>
                  <a:pt x="6981477" y="2221951"/>
                </a:cubicBezTo>
                <a:cubicBezTo>
                  <a:pt x="7051237" y="2230499"/>
                  <a:pt x="7084601" y="2257245"/>
                  <a:pt x="7100043" y="2318459"/>
                </a:cubicBezTo>
                <a:cubicBezTo>
                  <a:pt x="7038829" y="2293642"/>
                  <a:pt x="6979822" y="2324249"/>
                  <a:pt x="6920540" y="2306877"/>
                </a:cubicBezTo>
                <a:cubicBezTo>
                  <a:pt x="6905099" y="2302466"/>
                  <a:pt x="6880559" y="2309083"/>
                  <a:pt x="6888831" y="2330314"/>
                </a:cubicBezTo>
                <a:cubicBezTo>
                  <a:pt x="6896552" y="2350168"/>
                  <a:pt x="6922195" y="2364505"/>
                  <a:pt x="6876698" y="2360645"/>
                </a:cubicBezTo>
                <a:cubicBezTo>
                  <a:pt x="6844163" y="2357887"/>
                  <a:pt x="6780468" y="2380223"/>
                  <a:pt x="6807214" y="2385736"/>
                </a:cubicBezTo>
                <a:cubicBezTo>
                  <a:pt x="6840853" y="2392631"/>
                  <a:pt x="6873666" y="2402557"/>
                  <a:pt x="6916405" y="2413862"/>
                </a:cubicBezTo>
                <a:cubicBezTo>
                  <a:pt x="6869254" y="2432335"/>
                  <a:pt x="6835338" y="2428475"/>
                  <a:pt x="6799770" y="2413862"/>
                </a:cubicBezTo>
                <a:cubicBezTo>
                  <a:pt x="6756756" y="2396214"/>
                  <a:pt x="6700781" y="2374708"/>
                  <a:pt x="6665762" y="2394561"/>
                </a:cubicBezTo>
                <a:cubicBezTo>
                  <a:pt x="6613373" y="2424340"/>
                  <a:pt x="6569807" y="2405589"/>
                  <a:pt x="6522933" y="2400626"/>
                </a:cubicBezTo>
                <a:cubicBezTo>
                  <a:pt x="6427531" y="2390424"/>
                  <a:pt x="6332953" y="2373328"/>
                  <a:pt x="6237275" y="2365057"/>
                </a:cubicBezTo>
                <a:cubicBezTo>
                  <a:pt x="6198948" y="2361748"/>
                  <a:pt x="6157588" y="2346032"/>
                  <a:pt x="6101338" y="2367538"/>
                </a:cubicBezTo>
                <a:cubicBezTo>
                  <a:pt x="6356116" y="2477556"/>
                  <a:pt x="6629642" y="2470664"/>
                  <a:pt x="6857121" y="2606875"/>
                </a:cubicBezTo>
                <a:cubicBezTo>
                  <a:pt x="6847471" y="2619834"/>
                  <a:pt x="6798391" y="2656782"/>
                  <a:pt x="6818519" y="2659539"/>
                </a:cubicBezTo>
                <a:cubicBezTo>
                  <a:pt x="6875044" y="2667537"/>
                  <a:pt x="6925227" y="2694558"/>
                  <a:pt x="6976790" y="2716892"/>
                </a:cubicBezTo>
                <a:cubicBezTo>
                  <a:pt x="6999125" y="2726543"/>
                  <a:pt x="7026146" y="2739227"/>
                  <a:pt x="7015669" y="2773693"/>
                </a:cubicBezTo>
                <a:cubicBezTo>
                  <a:pt x="6996642" y="2783343"/>
                  <a:pt x="6982580" y="2769833"/>
                  <a:pt x="6966864" y="2768730"/>
                </a:cubicBezTo>
                <a:cubicBezTo>
                  <a:pt x="6950871" y="2767628"/>
                  <a:pt x="6915025" y="2774796"/>
                  <a:pt x="6924953" y="2779483"/>
                </a:cubicBezTo>
                <a:cubicBezTo>
                  <a:pt x="6970172" y="2800715"/>
                  <a:pt x="6888831" y="2851726"/>
                  <a:pt x="6942323" y="2851726"/>
                </a:cubicBezTo>
                <a:cubicBezTo>
                  <a:pt x="7031937" y="2852001"/>
                  <a:pt x="7079638" y="2942441"/>
                  <a:pt x="7165943" y="2944924"/>
                </a:cubicBezTo>
                <a:cubicBezTo>
                  <a:pt x="7179728" y="2945198"/>
                  <a:pt x="7186346" y="2961191"/>
                  <a:pt x="7186071" y="2975254"/>
                </a:cubicBezTo>
                <a:cubicBezTo>
                  <a:pt x="7186071" y="2992074"/>
                  <a:pt x="7173387" y="2995107"/>
                  <a:pt x="7159325" y="2996762"/>
                </a:cubicBezTo>
                <a:cubicBezTo>
                  <a:pt x="7137817" y="2999242"/>
                  <a:pt x="7115483" y="2975254"/>
                  <a:pt x="7087082" y="3007790"/>
                </a:cubicBezTo>
                <a:cubicBezTo>
                  <a:pt x="7138094" y="3026815"/>
                  <a:pt x="7189103" y="3045842"/>
                  <a:pt x="7188276" y="3111191"/>
                </a:cubicBezTo>
                <a:cubicBezTo>
                  <a:pt x="7188001" y="3128836"/>
                  <a:pt x="7209232" y="3135454"/>
                  <a:pt x="7225225" y="3139866"/>
                </a:cubicBezTo>
                <a:cubicBezTo>
                  <a:pt x="7251696" y="3147036"/>
                  <a:pt x="7274028" y="3159720"/>
                  <a:pt x="7288368" y="3184260"/>
                </a:cubicBezTo>
                <a:cubicBezTo>
                  <a:pt x="7288092" y="3188948"/>
                  <a:pt x="7287816" y="3193910"/>
                  <a:pt x="7289471" y="3197771"/>
                </a:cubicBezTo>
                <a:cubicBezTo>
                  <a:pt x="7284784" y="3257053"/>
                  <a:pt x="7246181" y="3255398"/>
                  <a:pt x="7203442" y="3245472"/>
                </a:cubicBezTo>
                <a:cubicBezTo>
                  <a:pt x="7152432" y="3233340"/>
                  <a:pt x="7101973" y="3211281"/>
                  <a:pt x="7048205" y="3232512"/>
                </a:cubicBezTo>
                <a:cubicBezTo>
                  <a:pt x="7124032" y="3260913"/>
                  <a:pt x="7206475" y="3263118"/>
                  <a:pt x="7277614" y="3303652"/>
                </a:cubicBezTo>
                <a:cubicBezTo>
                  <a:pt x="7017322" y="3311097"/>
                  <a:pt x="6787361" y="3183155"/>
                  <a:pt x="6535066" y="3134077"/>
                </a:cubicBezTo>
                <a:cubicBezTo>
                  <a:pt x="6543614" y="3166887"/>
                  <a:pt x="6564017" y="3173505"/>
                  <a:pt x="6582492" y="3178469"/>
                </a:cubicBezTo>
                <a:cubicBezTo>
                  <a:pt x="6675690" y="3203286"/>
                  <a:pt x="6757305" y="3252642"/>
                  <a:pt x="6842233" y="3295379"/>
                </a:cubicBezTo>
                <a:cubicBezTo>
                  <a:pt x="6877249" y="3313026"/>
                  <a:pt x="6902618" y="3330674"/>
                  <a:pt x="6915853" y="3368725"/>
                </a:cubicBezTo>
                <a:cubicBezTo>
                  <a:pt x="6927710" y="3403192"/>
                  <a:pt x="6950596" y="3419185"/>
                  <a:pt x="6993058" y="3409257"/>
                </a:cubicBezTo>
                <a:cubicBezTo>
                  <a:pt x="7027524" y="3400985"/>
                  <a:pt x="7065299" y="3405397"/>
                  <a:pt x="7101421" y="3408430"/>
                </a:cubicBezTo>
                <a:cubicBezTo>
                  <a:pt x="7143057" y="3411739"/>
                  <a:pt x="7189655" y="3450618"/>
                  <a:pt x="7178350" y="3470746"/>
                </a:cubicBezTo>
                <a:cubicBezTo>
                  <a:pt x="7159050" y="3504937"/>
                  <a:pt x="7126789" y="3487842"/>
                  <a:pt x="7098112" y="3483982"/>
                </a:cubicBezTo>
                <a:cubicBezTo>
                  <a:pt x="7065575" y="3479295"/>
                  <a:pt x="7005191" y="3469643"/>
                  <a:pt x="7004088" y="3473780"/>
                </a:cubicBezTo>
                <a:cubicBezTo>
                  <a:pt x="6982854" y="3559532"/>
                  <a:pt x="6833408" y="3484809"/>
                  <a:pt x="6801147" y="3477087"/>
                </a:cubicBezTo>
                <a:cubicBezTo>
                  <a:pt x="6760891" y="3467437"/>
                  <a:pt x="6723115" y="3485085"/>
                  <a:pt x="6684788" y="3489220"/>
                </a:cubicBezTo>
                <a:cubicBezTo>
                  <a:pt x="6650597" y="3493080"/>
                  <a:pt x="6457309" y="3504937"/>
                  <a:pt x="6417328" y="3468539"/>
                </a:cubicBezTo>
                <a:cubicBezTo>
                  <a:pt x="6411813" y="3496940"/>
                  <a:pt x="6423393" y="3508521"/>
                  <a:pt x="6433045" y="3521481"/>
                </a:cubicBezTo>
                <a:cubicBezTo>
                  <a:pt x="6446556" y="3539954"/>
                  <a:pt x="6448762" y="3552914"/>
                  <a:pt x="6423117" y="3567527"/>
                </a:cubicBezTo>
                <a:cubicBezTo>
                  <a:pt x="6350049" y="3609441"/>
                  <a:pt x="6351153" y="3610818"/>
                  <a:pt x="6419258" y="3667620"/>
                </a:cubicBezTo>
                <a:cubicBezTo>
                  <a:pt x="6422568" y="3670100"/>
                  <a:pt x="6421188" y="3678373"/>
                  <a:pt x="6421740" y="3683888"/>
                </a:cubicBezTo>
                <a:cubicBezTo>
                  <a:pt x="6403817" y="3692711"/>
                  <a:pt x="6382861" y="3670652"/>
                  <a:pt x="6361906" y="3694366"/>
                </a:cubicBezTo>
                <a:cubicBezTo>
                  <a:pt x="6453173" y="3798591"/>
                  <a:pt x="6592418" y="3824234"/>
                  <a:pt x="6718429" y="3902544"/>
                </a:cubicBezTo>
                <a:cubicBezTo>
                  <a:pt x="6616407" y="3928462"/>
                  <a:pt x="6555194" y="3838022"/>
                  <a:pt x="6480195" y="3849603"/>
                </a:cubicBezTo>
                <a:cubicBezTo>
                  <a:pt x="6442696" y="3878004"/>
                  <a:pt x="6554091" y="3923499"/>
                  <a:pt x="6447934" y="3937011"/>
                </a:cubicBezTo>
                <a:cubicBezTo>
                  <a:pt x="6493983" y="3961826"/>
                  <a:pt x="6528173" y="3986089"/>
                  <a:pt x="6559882" y="4014767"/>
                </a:cubicBezTo>
                <a:cubicBezTo>
                  <a:pt x="6616407" y="4066053"/>
                  <a:pt x="6627437" y="4099693"/>
                  <a:pt x="6601241" y="4168626"/>
                </a:cubicBezTo>
                <a:cubicBezTo>
                  <a:pt x="6584145" y="4213846"/>
                  <a:pt x="6559054" y="4255483"/>
                  <a:pt x="6581113" y="4309250"/>
                </a:cubicBezTo>
                <a:cubicBezTo>
                  <a:pt x="6596553" y="4346198"/>
                  <a:pt x="6590487" y="4370461"/>
                  <a:pt x="6533136" y="4353918"/>
                </a:cubicBezTo>
                <a:cubicBezTo>
                  <a:pt x="6471372" y="4336270"/>
                  <a:pt x="6448211" y="4369358"/>
                  <a:pt x="6463651" y="4434156"/>
                </a:cubicBezTo>
                <a:cubicBezTo>
                  <a:pt x="6473577" y="4475792"/>
                  <a:pt x="6463099" y="4488475"/>
                  <a:pt x="6420637" y="4483787"/>
                </a:cubicBezTo>
                <a:cubicBezTo>
                  <a:pt x="6373762" y="4478549"/>
                  <a:pt x="6329093" y="4451251"/>
                  <a:pt x="6271190" y="4464487"/>
                </a:cubicBezTo>
                <a:cubicBezTo>
                  <a:pt x="6317512" y="4540039"/>
                  <a:pt x="6416501" y="4518531"/>
                  <a:pt x="6470545" y="4590498"/>
                </a:cubicBezTo>
                <a:cubicBezTo>
                  <a:pt x="6406023" y="4590772"/>
                  <a:pt x="6356666" y="4590498"/>
                  <a:pt x="6308965" y="4574780"/>
                </a:cubicBezTo>
                <a:cubicBezTo>
                  <a:pt x="6289111" y="4568437"/>
                  <a:pt x="6267328" y="4561822"/>
                  <a:pt x="6256301" y="4583603"/>
                </a:cubicBezTo>
                <a:cubicBezTo>
                  <a:pt x="6243340" y="4609798"/>
                  <a:pt x="6270086" y="4619724"/>
                  <a:pt x="6286354" y="4624412"/>
                </a:cubicBezTo>
                <a:cubicBezTo>
                  <a:pt x="6332128" y="4637647"/>
                  <a:pt x="6367144" y="4669081"/>
                  <a:pt x="6404920" y="4693621"/>
                </a:cubicBezTo>
                <a:cubicBezTo>
                  <a:pt x="6487915" y="4747390"/>
                  <a:pt x="6578908" y="4792334"/>
                  <a:pt x="6649220" y="4881120"/>
                </a:cubicBezTo>
                <a:cubicBezTo>
                  <a:pt x="6560709" y="4858509"/>
                  <a:pt x="6494809" y="4805845"/>
                  <a:pt x="6412640" y="4795092"/>
                </a:cubicBezTo>
                <a:cubicBezTo>
                  <a:pt x="6483779" y="4875881"/>
                  <a:pt x="6575322" y="4929098"/>
                  <a:pt x="6661902" y="4987828"/>
                </a:cubicBezTo>
                <a:cubicBezTo>
                  <a:pt x="6686719" y="5004373"/>
                  <a:pt x="6711811" y="5015678"/>
                  <a:pt x="6717325" y="5051798"/>
                </a:cubicBezTo>
                <a:cubicBezTo>
                  <a:pt x="6728079" y="5121834"/>
                  <a:pt x="6760340" y="5179738"/>
                  <a:pt x="6829272" y="5210619"/>
                </a:cubicBezTo>
                <a:cubicBezTo>
                  <a:pt x="6829824" y="5210897"/>
                  <a:pt x="6825965" y="5221375"/>
                  <a:pt x="6823757" y="5228542"/>
                </a:cubicBezTo>
                <a:cubicBezTo>
                  <a:pt x="6781571" y="5230749"/>
                  <a:pt x="6748207" y="5189388"/>
                  <a:pt x="6694439" y="5202899"/>
                </a:cubicBezTo>
                <a:cubicBezTo>
                  <a:pt x="6746002" y="5259148"/>
                  <a:pt x="6789016" y="5309609"/>
                  <a:pt x="6862085" y="5336355"/>
                </a:cubicBezTo>
                <a:cubicBezTo>
                  <a:pt x="6920540" y="5357586"/>
                  <a:pt x="6992783" y="5369994"/>
                  <a:pt x="7035246" y="5438926"/>
                </a:cubicBezTo>
                <a:cubicBezTo>
                  <a:pt x="6985889" y="5452439"/>
                  <a:pt x="6949216" y="5435343"/>
                  <a:pt x="6912268" y="5423210"/>
                </a:cubicBezTo>
                <a:cubicBezTo>
                  <a:pt x="6855743" y="5404461"/>
                  <a:pt x="6799770" y="5383230"/>
                  <a:pt x="6743244" y="5364479"/>
                </a:cubicBezTo>
                <a:cubicBezTo>
                  <a:pt x="6721737" y="5357310"/>
                  <a:pt x="6698299" y="5352346"/>
                  <a:pt x="6684513" y="5386538"/>
                </a:cubicBezTo>
                <a:cubicBezTo>
                  <a:pt x="6756480" y="5393708"/>
                  <a:pt x="6799494" y="5440031"/>
                  <a:pt x="6844713" y="5483595"/>
                </a:cubicBezTo>
                <a:cubicBezTo>
                  <a:pt x="6870082" y="5508135"/>
                  <a:pt x="6890762" y="5540948"/>
                  <a:pt x="6936533" y="5528541"/>
                </a:cubicBezTo>
                <a:cubicBezTo>
                  <a:pt x="6960522" y="5521923"/>
                  <a:pt x="6975687" y="5540396"/>
                  <a:pt x="6973204" y="5563007"/>
                </a:cubicBezTo>
                <a:cubicBezTo>
                  <a:pt x="6964106" y="5642695"/>
                  <a:pt x="7020080" y="5670543"/>
                  <a:pt x="7077983" y="5685983"/>
                </a:cubicBezTo>
                <a:cubicBezTo>
                  <a:pt x="7187726" y="5714935"/>
                  <a:pt x="7278993" y="5783041"/>
                  <a:pt x="7385702" y="5820265"/>
                </a:cubicBezTo>
                <a:cubicBezTo>
                  <a:pt x="7489378" y="5856387"/>
                  <a:pt x="7569615" y="5942139"/>
                  <a:pt x="7673565" y="5987085"/>
                </a:cubicBezTo>
                <a:cubicBezTo>
                  <a:pt x="7748843" y="6019621"/>
                  <a:pt x="7820807" y="6061533"/>
                  <a:pt x="7898289" y="6091035"/>
                </a:cubicBezTo>
                <a:cubicBezTo>
                  <a:pt x="8081651" y="6160795"/>
                  <a:pt x="8268598" y="6216770"/>
                  <a:pt x="8466299" y="6224765"/>
                </a:cubicBezTo>
                <a:cubicBezTo>
                  <a:pt x="8629532" y="6231107"/>
                  <a:pt x="10045419" y="6225043"/>
                  <a:pt x="10620599" y="5317605"/>
                </a:cubicBezTo>
                <a:cubicBezTo>
                  <a:pt x="10631626" y="5313192"/>
                  <a:pt x="10644035" y="5301612"/>
                  <a:pt x="10647894" y="5290581"/>
                </a:cubicBezTo>
                <a:cubicBezTo>
                  <a:pt x="10666370" y="5239020"/>
                  <a:pt x="10711590" y="5216686"/>
                  <a:pt x="10752398" y="5188838"/>
                </a:cubicBezTo>
                <a:cubicBezTo>
                  <a:pt x="10788244" y="5164297"/>
                  <a:pt x="10826296" y="5138654"/>
                  <a:pt x="10841186" y="5097293"/>
                </a:cubicBezTo>
                <a:cubicBezTo>
                  <a:pt x="10860762" y="5042147"/>
                  <a:pt x="10805064" y="5087367"/>
                  <a:pt x="10794861" y="5066412"/>
                </a:cubicBezTo>
                <a:cubicBezTo>
                  <a:pt x="10816092" y="5037737"/>
                  <a:pt x="10848906" y="5011540"/>
                  <a:pt x="10857454" y="4979004"/>
                </a:cubicBezTo>
                <a:cubicBezTo>
                  <a:pt x="10888610" y="4861543"/>
                  <a:pt x="10955890" y="4776065"/>
                  <a:pt x="11056532" y="4709613"/>
                </a:cubicBezTo>
                <a:cubicBezTo>
                  <a:pt x="11085484" y="4690588"/>
                  <a:pt x="11104509" y="4655845"/>
                  <a:pt x="11143939" y="4650332"/>
                </a:cubicBezTo>
                <a:cubicBezTo>
                  <a:pt x="11231622" y="4638199"/>
                  <a:pt x="11204048" y="4543346"/>
                  <a:pt x="11250372" y="4501160"/>
                </a:cubicBezTo>
                <a:cubicBezTo>
                  <a:pt x="11259196" y="4493162"/>
                  <a:pt x="11267190" y="4477447"/>
                  <a:pt x="11265538" y="4466694"/>
                </a:cubicBezTo>
                <a:cubicBezTo>
                  <a:pt x="11263056" y="4451251"/>
                  <a:pt x="11252578" y="4436638"/>
                  <a:pt x="11243755" y="4422850"/>
                </a:cubicBezTo>
                <a:cubicBezTo>
                  <a:pt x="11234654" y="4409065"/>
                  <a:pt x="11220870" y="4396932"/>
                  <a:pt x="11227486" y="4378734"/>
                </a:cubicBezTo>
                <a:cubicBezTo>
                  <a:pt x="11230242" y="4371289"/>
                  <a:pt x="11228314" y="4345371"/>
                  <a:pt x="11248718" y="4365774"/>
                </a:cubicBezTo>
                <a:cubicBezTo>
                  <a:pt x="11304692" y="4421748"/>
                  <a:pt x="11337228" y="4368809"/>
                  <a:pt x="11385204" y="4343440"/>
                </a:cubicBezTo>
                <a:cubicBezTo>
                  <a:pt x="11346603" y="4317245"/>
                  <a:pt x="11311861" y="4298772"/>
                  <a:pt x="11306070" y="4259618"/>
                </a:cubicBezTo>
                <a:cubicBezTo>
                  <a:pt x="11294214" y="4178828"/>
                  <a:pt x="11243480" y="4141880"/>
                  <a:pt x="11166550" y="4134711"/>
                </a:cubicBezTo>
                <a:cubicBezTo>
                  <a:pt x="11194949" y="4056679"/>
                  <a:pt x="11194949" y="4056679"/>
                  <a:pt x="11103130" y="4045924"/>
                </a:cubicBezTo>
                <a:cubicBezTo>
                  <a:pt x="11138425" y="3996293"/>
                  <a:pt x="11138425" y="3983609"/>
                  <a:pt x="11095686" y="3966514"/>
                </a:cubicBezTo>
                <a:cubicBezTo>
                  <a:pt x="11054602" y="3950245"/>
                  <a:pt x="11009106" y="3944730"/>
                  <a:pt x="10971054" y="3919640"/>
                </a:cubicBezTo>
                <a:cubicBezTo>
                  <a:pt x="11006073" y="3856221"/>
                  <a:pt x="11015998" y="3782600"/>
                  <a:pt x="11088241" y="3751718"/>
                </a:cubicBezTo>
                <a:cubicBezTo>
                  <a:pt x="11099546" y="3747030"/>
                  <a:pt x="11107266" y="3728004"/>
                  <a:pt x="11100098" y="3716977"/>
                </a:cubicBezTo>
                <a:cubicBezTo>
                  <a:pt x="11073904" y="3676995"/>
                  <a:pt x="11111404" y="3601168"/>
                  <a:pt x="11029786" y="3592621"/>
                </a:cubicBezTo>
                <a:cubicBezTo>
                  <a:pt x="11019583" y="3591793"/>
                  <a:pt x="11010208" y="3583520"/>
                  <a:pt x="11018206" y="3572767"/>
                </a:cubicBezTo>
                <a:cubicBezTo>
                  <a:pt x="11045779" y="3535268"/>
                  <a:pt x="11012415" y="3537749"/>
                  <a:pt x="10992287" y="3533061"/>
                </a:cubicBezTo>
                <a:cubicBezTo>
                  <a:pt x="10968022" y="3527271"/>
                  <a:pt x="10940448" y="3543816"/>
                  <a:pt x="10917838" y="3523410"/>
                </a:cubicBezTo>
                <a:cubicBezTo>
                  <a:pt x="10923078" y="3501903"/>
                  <a:pt x="10942654" y="3502179"/>
                  <a:pt x="10956441" y="3495287"/>
                </a:cubicBezTo>
                <a:cubicBezTo>
                  <a:pt x="10996698" y="3475433"/>
                  <a:pt x="11029511" y="3451721"/>
                  <a:pt x="11031442" y="3400159"/>
                </a:cubicBezTo>
                <a:cubicBezTo>
                  <a:pt x="11032818" y="3358523"/>
                  <a:pt x="11037230" y="3321850"/>
                  <a:pt x="10981533" y="3309166"/>
                </a:cubicBezTo>
                <a:cubicBezTo>
                  <a:pt x="10958372" y="3303927"/>
                  <a:pt x="10964990" y="3273873"/>
                  <a:pt x="10978225" y="3258982"/>
                </a:cubicBezTo>
                <a:cubicBezTo>
                  <a:pt x="11001938" y="3232512"/>
                  <a:pt x="11021514" y="3197219"/>
                  <a:pt x="11062322" y="3194737"/>
                </a:cubicBezTo>
                <a:cubicBezTo>
                  <a:pt x="11087138" y="3193084"/>
                  <a:pt x="11106164" y="3182053"/>
                  <a:pt x="11125742" y="3169370"/>
                </a:cubicBezTo>
                <a:cubicBezTo>
                  <a:pt x="11139802" y="3160269"/>
                  <a:pt x="11156622" y="3152550"/>
                  <a:pt x="11154968" y="3132974"/>
                </a:cubicBezTo>
                <a:cubicBezTo>
                  <a:pt x="11153315" y="3114223"/>
                  <a:pt x="11137046" y="3106503"/>
                  <a:pt x="11120502" y="3102642"/>
                </a:cubicBezTo>
                <a:cubicBezTo>
                  <a:pt x="11065355" y="3090235"/>
                  <a:pt x="11013518" y="3072037"/>
                  <a:pt x="10967470" y="3030401"/>
                </a:cubicBezTo>
                <a:cubicBezTo>
                  <a:pt x="10998076" y="3008342"/>
                  <a:pt x="11027304" y="2992350"/>
                  <a:pt x="11049914" y="2970015"/>
                </a:cubicBezTo>
                <a:cubicBezTo>
                  <a:pt x="11104509" y="2915972"/>
                  <a:pt x="10642106" y="2745845"/>
                  <a:pt x="10618944" y="2685183"/>
                </a:cubicBezTo>
                <a:cubicBezTo>
                  <a:pt x="10611775" y="2666432"/>
                  <a:pt x="10587235" y="2647132"/>
                  <a:pt x="10566830" y="2641617"/>
                </a:cubicBezTo>
                <a:cubicBezTo>
                  <a:pt x="10471151" y="2615699"/>
                  <a:pt x="10388156" y="2557518"/>
                  <a:pt x="10290271" y="2536011"/>
                </a:cubicBezTo>
                <a:cubicBezTo>
                  <a:pt x="10197900" y="2515607"/>
                  <a:pt x="10106908" y="2488309"/>
                  <a:pt x="10005715" y="2461288"/>
                </a:cubicBezTo>
                <a:cubicBezTo>
                  <a:pt x="10067754" y="2393457"/>
                  <a:pt x="10177772" y="2401454"/>
                  <a:pt x="10203414" y="2303568"/>
                </a:cubicBezTo>
                <a:cubicBezTo>
                  <a:pt x="10103324" y="2278201"/>
                  <a:pt x="9997996" y="2307154"/>
                  <a:pt x="9901487" y="2266895"/>
                </a:cubicBezTo>
                <a:cubicBezTo>
                  <a:pt x="9893216" y="2263312"/>
                  <a:pt x="9881910" y="2266895"/>
                  <a:pt x="9871984" y="2267999"/>
                </a:cubicBezTo>
                <a:cubicBezTo>
                  <a:pt x="9673181" y="2289506"/>
                  <a:pt x="9475204" y="2270758"/>
                  <a:pt x="9279158" y="2243734"/>
                </a:cubicBezTo>
                <a:cubicBezTo>
                  <a:pt x="8996808" y="2205133"/>
                  <a:pt x="8713354" y="2180592"/>
                  <a:pt x="8429350" y="2163219"/>
                </a:cubicBezTo>
                <a:cubicBezTo>
                  <a:pt x="8194701" y="2148882"/>
                  <a:pt x="7959502" y="2142541"/>
                  <a:pt x="7725955" y="2114967"/>
                </a:cubicBezTo>
                <a:cubicBezTo>
                  <a:pt x="7476142" y="2085464"/>
                  <a:pt x="7226605" y="2052100"/>
                  <a:pt x="6977065" y="2021218"/>
                </a:cubicBezTo>
                <a:cubicBezTo>
                  <a:pt x="6965761" y="2019839"/>
                  <a:pt x="6953283" y="2015496"/>
                  <a:pt x="6941221" y="2015186"/>
                </a:cubicBezTo>
                <a:close/>
                <a:moveTo>
                  <a:pt x="0" y="0"/>
                </a:moveTo>
                <a:lnTo>
                  <a:pt x="12192000" y="0"/>
                </a:lnTo>
                <a:lnTo>
                  <a:pt x="12192000" y="6858000"/>
                </a:lnTo>
                <a:lnTo>
                  <a:pt x="0" y="6858000"/>
                </a:ln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 name="Title 1">
            <a:extLst>
              <a:ext uri="{FF2B5EF4-FFF2-40B4-BE49-F238E27FC236}">
                <a16:creationId xmlns:a16="http://schemas.microsoft.com/office/drawing/2014/main" id="{B79B2164-29D4-B08C-77B3-835DC4DFE96C}"/>
              </a:ext>
            </a:extLst>
          </p:cNvPr>
          <p:cNvSpPr>
            <a:spLocks noGrp="1"/>
          </p:cNvSpPr>
          <p:nvPr>
            <p:ph type="title"/>
          </p:nvPr>
        </p:nvSpPr>
        <p:spPr>
          <a:xfrm>
            <a:off x="838200" y="365125"/>
            <a:ext cx="10515600" cy="1325563"/>
          </a:xfrm>
        </p:spPr>
        <p:txBody>
          <a:bodyPr>
            <a:normAutofit/>
          </a:bodyPr>
          <a:lstStyle/>
          <a:p>
            <a:r>
              <a:rPr lang="en-US" b="1" dirty="0">
                <a:solidFill>
                  <a:srgbClr val="00B050"/>
                </a:solidFill>
              </a:rPr>
              <a:t>Visual Thinking Strategies (VTS)</a:t>
            </a:r>
          </a:p>
        </p:txBody>
      </p:sp>
      <p:sp>
        <p:nvSpPr>
          <p:cNvPr id="3" name="Content Placeholder 2">
            <a:extLst>
              <a:ext uri="{FF2B5EF4-FFF2-40B4-BE49-F238E27FC236}">
                <a16:creationId xmlns:a16="http://schemas.microsoft.com/office/drawing/2014/main" id="{54478315-0FE1-3E2A-CE34-C08D2CFA89D7}"/>
              </a:ext>
            </a:extLst>
          </p:cNvPr>
          <p:cNvSpPr>
            <a:spLocks noGrp="1"/>
          </p:cNvSpPr>
          <p:nvPr>
            <p:ph idx="1"/>
          </p:nvPr>
        </p:nvSpPr>
        <p:spPr>
          <a:xfrm>
            <a:off x="838201" y="2013625"/>
            <a:ext cx="4614759" cy="4163337"/>
          </a:xfrm>
        </p:spPr>
        <p:txBody>
          <a:bodyPr>
            <a:normAutofit/>
          </a:bodyPr>
          <a:lstStyle/>
          <a:p>
            <a:pPr marL="0" indent="0">
              <a:buNone/>
            </a:pPr>
            <a:r>
              <a:rPr lang="en-US" sz="3200" b="1" dirty="0">
                <a:solidFill>
                  <a:srgbClr val="002060"/>
                </a:solidFill>
              </a:rPr>
              <a:t>Hold a curious, nonjudgmental, appreciative stance throughout</a:t>
            </a:r>
          </a:p>
          <a:p>
            <a:pPr marL="0" indent="0">
              <a:buNone/>
            </a:pPr>
            <a:endParaRPr lang="en-US" sz="2000" dirty="0"/>
          </a:p>
        </p:txBody>
      </p:sp>
      <p:pic>
        <p:nvPicPr>
          <p:cNvPr id="16" name="Graphic 15" descr="Eyes">
            <a:extLst>
              <a:ext uri="{FF2B5EF4-FFF2-40B4-BE49-F238E27FC236}">
                <a16:creationId xmlns:a16="http://schemas.microsoft.com/office/drawing/2014/main" id="{4B11B544-9EFA-DB27-CA13-DEC810057A10}"/>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7455346" y="2766817"/>
            <a:ext cx="2751667" cy="2751667"/>
          </a:xfrm>
          <a:prstGeom prst="rect">
            <a:avLst/>
          </a:prstGeom>
        </p:spPr>
      </p:pic>
    </p:spTree>
    <p:extLst>
      <p:ext uri="{BB962C8B-B14F-4D97-AF65-F5344CB8AC3E}">
        <p14:creationId xmlns:p14="http://schemas.microsoft.com/office/powerpoint/2010/main" val="53257784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9" name="Rectangle 18">
            <a:extLst>
              <a:ext uri="{FF2B5EF4-FFF2-40B4-BE49-F238E27FC236}">
                <a16:creationId xmlns:a16="http://schemas.microsoft.com/office/drawing/2014/main" id="{F541DB91-0B10-46D9-B34B-7BFF9602606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Freeform: Shape 20">
            <a:extLst>
              <a:ext uri="{FF2B5EF4-FFF2-40B4-BE49-F238E27FC236}">
                <a16:creationId xmlns:a16="http://schemas.microsoft.com/office/drawing/2014/main" id="{9CF7FE1C-8BC5-4B0C-A2BC-93AB72C90FD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768100" y="-1"/>
            <a:ext cx="10423900" cy="5920155"/>
          </a:xfrm>
          <a:custGeom>
            <a:avLst/>
            <a:gdLst>
              <a:gd name="connsiteX0" fmla="*/ 10423900 w 10423900"/>
              <a:gd name="connsiteY0" fmla="*/ 0 h 5491534"/>
              <a:gd name="connsiteX1" fmla="*/ 3493157 w 10423900"/>
              <a:gd name="connsiteY1" fmla="*/ 0 h 5491534"/>
              <a:gd name="connsiteX2" fmla="*/ 3493018 w 10423900"/>
              <a:gd name="connsiteY2" fmla="*/ 31 h 5491534"/>
              <a:gd name="connsiteX3" fmla="*/ 3245493 w 10423900"/>
              <a:gd name="connsiteY3" fmla="*/ 104839 h 5491534"/>
              <a:gd name="connsiteX4" fmla="*/ 4434802 w 10423900"/>
              <a:gd name="connsiteY4" fmla="*/ 284558 h 5491534"/>
              <a:gd name="connsiteX5" fmla="*/ 4011937 w 10423900"/>
              <a:gd name="connsiteY5" fmla="*/ 395559 h 5491534"/>
              <a:gd name="connsiteX6" fmla="*/ 3573213 w 10423900"/>
              <a:gd name="connsiteY6" fmla="*/ 474847 h 5491534"/>
              <a:gd name="connsiteX7" fmla="*/ 3097489 w 10423900"/>
              <a:gd name="connsiteY7" fmla="*/ 532990 h 5491534"/>
              <a:gd name="connsiteX8" fmla="*/ 2664052 w 10423900"/>
              <a:gd name="connsiteY8" fmla="*/ 649279 h 5491534"/>
              <a:gd name="connsiteX9" fmla="*/ 3795218 w 10423900"/>
              <a:gd name="connsiteY9" fmla="*/ 696852 h 5491534"/>
              <a:gd name="connsiteX10" fmla="*/ 3208492 w 10423900"/>
              <a:gd name="connsiteY10" fmla="*/ 802568 h 5491534"/>
              <a:gd name="connsiteX11" fmla="*/ 2727483 w 10423900"/>
              <a:gd name="connsiteY11" fmla="*/ 939999 h 5491534"/>
              <a:gd name="connsiteX12" fmla="*/ 2389190 w 10423900"/>
              <a:gd name="connsiteY12" fmla="*/ 1003429 h 5491534"/>
              <a:gd name="connsiteX13" fmla="*/ 2029754 w 10423900"/>
              <a:gd name="connsiteY13" fmla="*/ 1019287 h 5491534"/>
              <a:gd name="connsiteX14" fmla="*/ 1945181 w 10423900"/>
              <a:gd name="connsiteY14" fmla="*/ 1119716 h 5491534"/>
              <a:gd name="connsiteX15" fmla="*/ 2056184 w 10423900"/>
              <a:gd name="connsiteY15" fmla="*/ 1225434 h 5491534"/>
              <a:gd name="connsiteX16" fmla="*/ 2225329 w 10423900"/>
              <a:gd name="connsiteY16" fmla="*/ 1236004 h 5491534"/>
              <a:gd name="connsiteX17" fmla="*/ 3234920 w 10423900"/>
              <a:gd name="connsiteY17" fmla="*/ 1262435 h 5491534"/>
              <a:gd name="connsiteX18" fmla="*/ 0 w 10423900"/>
              <a:gd name="connsiteY18" fmla="*/ 1495009 h 5491534"/>
              <a:gd name="connsiteX19" fmla="*/ 438724 w 10423900"/>
              <a:gd name="connsiteY19" fmla="*/ 1637728 h 5491534"/>
              <a:gd name="connsiteX20" fmla="*/ 586726 w 10423900"/>
              <a:gd name="connsiteY20" fmla="*/ 2028877 h 5491534"/>
              <a:gd name="connsiteX21" fmla="*/ 1125878 w 10423900"/>
              <a:gd name="connsiteY21" fmla="*/ 2250882 h 5491534"/>
              <a:gd name="connsiteX22" fmla="*/ 1474744 w 10423900"/>
              <a:gd name="connsiteY22" fmla="*/ 2330169 h 5491534"/>
              <a:gd name="connsiteX23" fmla="*/ 2272901 w 10423900"/>
              <a:gd name="connsiteY23" fmla="*/ 2446458 h 5491534"/>
              <a:gd name="connsiteX24" fmla="*/ 2389190 w 10423900"/>
              <a:gd name="connsiteY24" fmla="*/ 2636747 h 5491534"/>
              <a:gd name="connsiteX25" fmla="*/ 2489621 w 10423900"/>
              <a:gd name="connsiteY25" fmla="*/ 2848179 h 5491534"/>
              <a:gd name="connsiteX26" fmla="*/ 2701053 w 10423900"/>
              <a:gd name="connsiteY26" fmla="*/ 2985611 h 5491534"/>
              <a:gd name="connsiteX27" fmla="*/ 1057165 w 10423900"/>
              <a:gd name="connsiteY27" fmla="*/ 2964468 h 5491534"/>
              <a:gd name="connsiteX28" fmla="*/ 2912485 w 10423900"/>
              <a:gd name="connsiteY28" fmla="*/ 3408477 h 5491534"/>
              <a:gd name="connsiteX29" fmla="*/ 2748626 w 10423900"/>
              <a:gd name="connsiteY29" fmla="*/ 3582909 h 5491534"/>
              <a:gd name="connsiteX30" fmla="*/ 3763503 w 10423900"/>
              <a:gd name="connsiteY30" fmla="*/ 3820771 h 5491534"/>
              <a:gd name="connsiteX31" fmla="*/ 3219063 w 10423900"/>
              <a:gd name="connsiteY31" fmla="*/ 3847199 h 5491534"/>
              <a:gd name="connsiteX32" fmla="*/ 6385269 w 10423900"/>
              <a:gd name="connsiteY32" fmla="*/ 4840933 h 5491534"/>
              <a:gd name="connsiteX33" fmla="*/ 10285854 w 10423900"/>
              <a:gd name="connsiteY33" fmla="*/ 5471118 h 5491534"/>
              <a:gd name="connsiteX34" fmla="*/ 10423900 w 10423900"/>
              <a:gd name="connsiteY34" fmla="*/ 5491534 h 54915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10423900" h="5491534">
                <a:moveTo>
                  <a:pt x="10423900" y="0"/>
                </a:moveTo>
                <a:lnTo>
                  <a:pt x="3493157" y="0"/>
                </a:lnTo>
                <a:lnTo>
                  <a:pt x="3493018" y="31"/>
                </a:lnTo>
                <a:cubicBezTo>
                  <a:pt x="3414969" y="12668"/>
                  <a:pt x="3328744" y="21588"/>
                  <a:pt x="3245493" y="104839"/>
                </a:cubicBezTo>
                <a:cubicBezTo>
                  <a:pt x="3668357" y="162984"/>
                  <a:pt x="4075366" y="51981"/>
                  <a:pt x="4434802" y="284558"/>
                </a:cubicBezTo>
                <a:cubicBezTo>
                  <a:pt x="4302656" y="400846"/>
                  <a:pt x="4154654" y="374416"/>
                  <a:pt x="4011937" y="395559"/>
                </a:cubicBezTo>
                <a:cubicBezTo>
                  <a:pt x="3863934" y="416704"/>
                  <a:pt x="3721217" y="453704"/>
                  <a:pt x="3573213" y="474847"/>
                </a:cubicBezTo>
                <a:cubicBezTo>
                  <a:pt x="3414639" y="501275"/>
                  <a:pt x="3256063" y="506562"/>
                  <a:pt x="3097489" y="532990"/>
                </a:cubicBezTo>
                <a:cubicBezTo>
                  <a:pt x="2965345" y="554135"/>
                  <a:pt x="2822627" y="517133"/>
                  <a:pt x="2664052" y="649279"/>
                </a:cubicBezTo>
                <a:cubicBezTo>
                  <a:pt x="3055203" y="744424"/>
                  <a:pt x="3409352" y="601706"/>
                  <a:pt x="3795218" y="696852"/>
                </a:cubicBezTo>
                <a:cubicBezTo>
                  <a:pt x="3567928" y="781425"/>
                  <a:pt x="3382924" y="754995"/>
                  <a:pt x="3208492" y="802568"/>
                </a:cubicBezTo>
                <a:cubicBezTo>
                  <a:pt x="3049916" y="850140"/>
                  <a:pt x="2859627" y="797282"/>
                  <a:pt x="2727483" y="939999"/>
                </a:cubicBezTo>
                <a:cubicBezTo>
                  <a:pt x="2627052" y="1051000"/>
                  <a:pt x="2521336" y="1066858"/>
                  <a:pt x="2389190" y="1003429"/>
                </a:cubicBezTo>
                <a:cubicBezTo>
                  <a:pt x="2272901" y="945284"/>
                  <a:pt x="2146043" y="961142"/>
                  <a:pt x="2029754" y="1019287"/>
                </a:cubicBezTo>
                <a:cubicBezTo>
                  <a:pt x="1987468" y="1040430"/>
                  <a:pt x="1945181" y="1066858"/>
                  <a:pt x="1945181" y="1119716"/>
                </a:cubicBezTo>
                <a:cubicBezTo>
                  <a:pt x="1945181" y="1193719"/>
                  <a:pt x="1998039" y="1214862"/>
                  <a:pt x="2056184" y="1225434"/>
                </a:cubicBezTo>
                <a:cubicBezTo>
                  <a:pt x="2109042" y="1236004"/>
                  <a:pt x="2172471" y="1246577"/>
                  <a:pt x="2225329" y="1236004"/>
                </a:cubicBezTo>
                <a:cubicBezTo>
                  <a:pt x="2563622" y="1177861"/>
                  <a:pt x="2896629" y="1273005"/>
                  <a:pt x="3234920" y="1262435"/>
                </a:cubicBezTo>
                <a:cubicBezTo>
                  <a:pt x="2172471" y="1489724"/>
                  <a:pt x="1099450" y="1415723"/>
                  <a:pt x="0" y="1495009"/>
                </a:cubicBezTo>
                <a:cubicBezTo>
                  <a:pt x="142717" y="1653583"/>
                  <a:pt x="327721" y="1521439"/>
                  <a:pt x="438724" y="1637728"/>
                </a:cubicBezTo>
                <a:cubicBezTo>
                  <a:pt x="333006" y="1880875"/>
                  <a:pt x="375293" y="2013020"/>
                  <a:pt x="586726" y="2028877"/>
                </a:cubicBezTo>
                <a:cubicBezTo>
                  <a:pt x="792873" y="2044734"/>
                  <a:pt x="1014877" y="1960161"/>
                  <a:pt x="1125878" y="2250882"/>
                </a:cubicBezTo>
                <a:cubicBezTo>
                  <a:pt x="1157593" y="2340740"/>
                  <a:pt x="1353170" y="2314312"/>
                  <a:pt x="1474744" y="2330169"/>
                </a:cubicBezTo>
                <a:cubicBezTo>
                  <a:pt x="1739034" y="2367170"/>
                  <a:pt x="2019183" y="2330169"/>
                  <a:pt x="2272901" y="2446458"/>
                </a:cubicBezTo>
                <a:cubicBezTo>
                  <a:pt x="2373332" y="2488744"/>
                  <a:pt x="2442048" y="2520459"/>
                  <a:pt x="2389190" y="2636747"/>
                </a:cubicBezTo>
                <a:cubicBezTo>
                  <a:pt x="2336332" y="2758321"/>
                  <a:pt x="2405048" y="2800607"/>
                  <a:pt x="2489621" y="2848179"/>
                </a:cubicBezTo>
                <a:cubicBezTo>
                  <a:pt x="2553051" y="2885180"/>
                  <a:pt x="2648195" y="2874609"/>
                  <a:pt x="2701053" y="2985611"/>
                </a:cubicBezTo>
                <a:cubicBezTo>
                  <a:pt x="2146043" y="2969753"/>
                  <a:pt x="1606888" y="2879895"/>
                  <a:pt x="1057165" y="2964468"/>
                </a:cubicBezTo>
                <a:cubicBezTo>
                  <a:pt x="1659748" y="3175900"/>
                  <a:pt x="2320474" y="3165328"/>
                  <a:pt x="2912485" y="3408477"/>
                </a:cubicBezTo>
                <a:cubicBezTo>
                  <a:pt x="2891342" y="3493050"/>
                  <a:pt x="2753911" y="3456048"/>
                  <a:pt x="2748626" y="3582909"/>
                </a:cubicBezTo>
                <a:cubicBezTo>
                  <a:pt x="3060489" y="3715055"/>
                  <a:pt x="3435782" y="3625195"/>
                  <a:pt x="3763503" y="3820771"/>
                </a:cubicBezTo>
                <a:cubicBezTo>
                  <a:pt x="3573213" y="3910629"/>
                  <a:pt x="3398782" y="3762626"/>
                  <a:pt x="3219063" y="3847199"/>
                </a:cubicBezTo>
                <a:cubicBezTo>
                  <a:pt x="3277208" y="3974060"/>
                  <a:pt x="5909545" y="4756360"/>
                  <a:pt x="6385269" y="4840933"/>
                </a:cubicBezTo>
                <a:cubicBezTo>
                  <a:pt x="7171204" y="4982659"/>
                  <a:pt x="9157515" y="5302348"/>
                  <a:pt x="10285854" y="5471118"/>
                </a:cubicBezTo>
                <a:lnTo>
                  <a:pt x="10423900" y="5491534"/>
                </a:lnTo>
                <a:close/>
              </a:path>
            </a:pathLst>
          </a:custGeom>
          <a:solidFill>
            <a:schemeClr val="accent1">
              <a:alpha val="20000"/>
            </a:schemeClr>
          </a:solidFill>
          <a:ln w="32707" cap="flat">
            <a:noFill/>
            <a:prstDash val="solid"/>
            <a:miter/>
          </a:ln>
        </p:spPr>
        <p:txBody>
          <a:bodyPr wrap="square" rtlCol="0" anchor="ctr">
            <a:noAutofit/>
          </a:bodyPr>
          <a:lstStyle/>
          <a:p>
            <a:endParaRPr lang="en-US"/>
          </a:p>
        </p:txBody>
      </p:sp>
      <p:pic>
        <p:nvPicPr>
          <p:cNvPr id="16" name="Graphic 15" descr="Mute Speaker">
            <a:extLst>
              <a:ext uri="{FF2B5EF4-FFF2-40B4-BE49-F238E27FC236}">
                <a16:creationId xmlns:a16="http://schemas.microsoft.com/office/drawing/2014/main" id="{5A8DC129-6693-8889-2CD8-639C0001B34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073717" y="2782956"/>
            <a:ext cx="3449030" cy="3449030"/>
          </a:xfrm>
          <a:prstGeom prst="rect">
            <a:avLst/>
          </a:prstGeom>
        </p:spPr>
      </p:pic>
      <p:sp>
        <p:nvSpPr>
          <p:cNvPr id="3" name="Content Placeholder 2">
            <a:extLst>
              <a:ext uri="{FF2B5EF4-FFF2-40B4-BE49-F238E27FC236}">
                <a16:creationId xmlns:a16="http://schemas.microsoft.com/office/drawing/2014/main" id="{2A8B3540-8F06-F5CA-E7E3-738A2B978B7F}"/>
              </a:ext>
            </a:extLst>
          </p:cNvPr>
          <p:cNvSpPr>
            <a:spLocks noGrp="1"/>
          </p:cNvSpPr>
          <p:nvPr>
            <p:ph idx="1"/>
          </p:nvPr>
        </p:nvSpPr>
        <p:spPr>
          <a:xfrm>
            <a:off x="5526156" y="2055813"/>
            <a:ext cx="5827644" cy="4121149"/>
          </a:xfrm>
        </p:spPr>
        <p:txBody>
          <a:bodyPr vert="horz" lIns="91440" tIns="45720" rIns="91440" bIns="45720" rtlCol="0" anchor="t">
            <a:normAutofit/>
          </a:bodyPr>
          <a:lstStyle/>
          <a:p>
            <a:pPr marL="0" indent="0">
              <a:buNone/>
            </a:pPr>
            <a:r>
              <a:rPr lang="en-US" sz="3200" b="1" cap="all" dirty="0">
                <a:solidFill>
                  <a:srgbClr val="002060"/>
                </a:solidFill>
              </a:rPr>
              <a:t>Start with quiet looking…</a:t>
            </a:r>
          </a:p>
        </p:txBody>
      </p:sp>
    </p:spTree>
    <p:extLst>
      <p:ext uri="{BB962C8B-B14F-4D97-AF65-F5344CB8AC3E}">
        <p14:creationId xmlns:p14="http://schemas.microsoft.com/office/powerpoint/2010/main" val="321878694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2ED60D-CDF7-11AA-DA88-B050762392DE}"/>
              </a:ext>
            </a:extLst>
          </p:cNvPr>
          <p:cNvSpPr>
            <a:spLocks noGrp="1"/>
          </p:cNvSpPr>
          <p:nvPr>
            <p:ph type="title"/>
          </p:nvPr>
        </p:nvSpPr>
        <p:spPr>
          <a:xfrm>
            <a:off x="1185712" y="2103136"/>
            <a:ext cx="4773663" cy="3306031"/>
          </a:xfrm>
        </p:spPr>
        <p:txBody>
          <a:bodyPr vert="horz" lIns="91440" tIns="45720" rIns="91440" bIns="45720" rtlCol="0" anchor="b">
            <a:normAutofit fontScale="90000"/>
          </a:bodyPr>
          <a:lstStyle/>
          <a:p>
            <a:pPr algn="ctr">
              <a:lnSpc>
                <a:spcPct val="150000"/>
              </a:lnSpc>
            </a:pPr>
            <a:r>
              <a:rPr lang="en-US" sz="5200" b="1" dirty="0">
                <a:solidFill>
                  <a:srgbClr val="002060"/>
                </a:solidFill>
              </a:rPr>
              <a:t>1. </a:t>
            </a:r>
            <a:br>
              <a:rPr lang="en-US" sz="5200" dirty="0">
                <a:solidFill>
                  <a:srgbClr val="002060"/>
                </a:solidFill>
              </a:rPr>
            </a:br>
            <a:r>
              <a:rPr lang="en-US" sz="5200" b="1" dirty="0">
                <a:solidFill>
                  <a:srgbClr val="002060"/>
                </a:solidFill>
              </a:rPr>
              <a:t>What's going on in this picture?</a:t>
            </a:r>
            <a:br>
              <a:rPr lang="en-US" sz="4600" b="1" dirty="0"/>
            </a:br>
            <a:endParaRPr lang="en-US" sz="4600" dirty="0"/>
          </a:p>
        </p:txBody>
      </p:sp>
      <p:pic>
        <p:nvPicPr>
          <p:cNvPr id="291" name="Graphic 290" descr="Camera">
            <a:extLst>
              <a:ext uri="{FF2B5EF4-FFF2-40B4-BE49-F238E27FC236}">
                <a16:creationId xmlns:a16="http://schemas.microsoft.com/office/drawing/2014/main" id="{09FB465B-A3B0-87C2-32F4-EE145C9F857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441640" y="1245842"/>
            <a:ext cx="4517695" cy="4517695"/>
          </a:xfrm>
          <a:prstGeom prst="rect">
            <a:avLst/>
          </a:prstGeom>
        </p:spPr>
      </p:pic>
    </p:spTree>
    <p:extLst>
      <p:ext uri="{BB962C8B-B14F-4D97-AF65-F5344CB8AC3E}">
        <p14:creationId xmlns:p14="http://schemas.microsoft.com/office/powerpoint/2010/main" val="306745558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1BE77F-C84C-EBC2-4D63-070A9448B94E}"/>
              </a:ext>
            </a:extLst>
          </p:cNvPr>
          <p:cNvSpPr>
            <a:spLocks noGrp="1"/>
          </p:cNvSpPr>
          <p:nvPr>
            <p:ph type="title"/>
          </p:nvPr>
        </p:nvSpPr>
        <p:spPr>
          <a:xfrm>
            <a:off x="888968" y="1892465"/>
            <a:ext cx="5410953" cy="3969697"/>
          </a:xfrm>
        </p:spPr>
        <p:txBody>
          <a:bodyPr vert="horz" lIns="91440" tIns="45720" rIns="91440" bIns="45720" rtlCol="0" anchor="b">
            <a:normAutofit fontScale="90000"/>
          </a:bodyPr>
          <a:lstStyle/>
          <a:p>
            <a:pPr algn="ctr">
              <a:lnSpc>
                <a:spcPct val="150000"/>
              </a:lnSpc>
            </a:pPr>
            <a:r>
              <a:rPr lang="en-US" sz="4600" b="1" dirty="0">
                <a:solidFill>
                  <a:srgbClr val="002060"/>
                </a:solidFill>
              </a:rPr>
              <a:t>2. </a:t>
            </a:r>
            <a:br>
              <a:rPr lang="en-US" sz="4600" dirty="0">
                <a:solidFill>
                  <a:srgbClr val="002060"/>
                </a:solidFill>
              </a:rPr>
            </a:br>
            <a:r>
              <a:rPr lang="en-US" sz="4600" b="1" dirty="0">
                <a:solidFill>
                  <a:srgbClr val="002060"/>
                </a:solidFill>
              </a:rPr>
              <a:t>What do you see that makes you say…?</a:t>
            </a:r>
            <a:br>
              <a:rPr lang="en-US" sz="4600" b="1" dirty="0"/>
            </a:br>
            <a:endParaRPr lang="en-US" sz="4600" dirty="0"/>
          </a:p>
        </p:txBody>
      </p:sp>
      <p:pic>
        <p:nvPicPr>
          <p:cNvPr id="7" name="Graphic 6" descr="Moustache Face with Solid Fill">
            <a:extLst>
              <a:ext uri="{FF2B5EF4-FFF2-40B4-BE49-F238E27FC236}">
                <a16:creationId xmlns:a16="http://schemas.microsoft.com/office/drawing/2014/main" id="{0F495D3E-45A1-DA90-3348-CCCAAB7A64FE}"/>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441640" y="1245842"/>
            <a:ext cx="4517695" cy="4517695"/>
          </a:xfrm>
          <a:prstGeom prst="rect">
            <a:avLst/>
          </a:prstGeom>
        </p:spPr>
      </p:pic>
    </p:spTree>
    <p:extLst>
      <p:ext uri="{BB962C8B-B14F-4D97-AF65-F5344CB8AC3E}">
        <p14:creationId xmlns:p14="http://schemas.microsoft.com/office/powerpoint/2010/main" val="257637757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C5357A-D6A6-59E9-BC54-F643152EB0D8}"/>
              </a:ext>
            </a:extLst>
          </p:cNvPr>
          <p:cNvSpPr>
            <a:spLocks noGrp="1"/>
          </p:cNvSpPr>
          <p:nvPr>
            <p:ph type="title"/>
          </p:nvPr>
        </p:nvSpPr>
        <p:spPr>
          <a:xfrm>
            <a:off x="1138673" y="1439811"/>
            <a:ext cx="5147609" cy="4069617"/>
          </a:xfrm>
        </p:spPr>
        <p:txBody>
          <a:bodyPr vert="horz" lIns="91440" tIns="45720" rIns="91440" bIns="45720" rtlCol="0" anchor="b">
            <a:normAutofit fontScale="90000"/>
          </a:bodyPr>
          <a:lstStyle/>
          <a:p>
            <a:pPr algn="ctr">
              <a:lnSpc>
                <a:spcPct val="150000"/>
              </a:lnSpc>
            </a:pPr>
            <a:r>
              <a:rPr lang="en-US" sz="5400" b="1" dirty="0">
                <a:solidFill>
                  <a:srgbClr val="002060"/>
                </a:solidFill>
              </a:rPr>
              <a:t>3. </a:t>
            </a:r>
            <a:br>
              <a:rPr lang="en-US" sz="5400" dirty="0">
                <a:solidFill>
                  <a:srgbClr val="002060"/>
                </a:solidFill>
              </a:rPr>
            </a:br>
            <a:r>
              <a:rPr lang="en-US" sz="5400" b="1" dirty="0">
                <a:solidFill>
                  <a:srgbClr val="002060"/>
                </a:solidFill>
              </a:rPr>
              <a:t>What more can we find?</a:t>
            </a:r>
            <a:br>
              <a:rPr lang="en-US" sz="5400" b="1" dirty="0">
                <a:solidFill>
                  <a:srgbClr val="002060"/>
                </a:solidFill>
              </a:rPr>
            </a:br>
            <a:endParaRPr lang="en-US" sz="5400" dirty="0">
              <a:solidFill>
                <a:srgbClr val="002060"/>
              </a:solidFill>
            </a:endParaRPr>
          </a:p>
        </p:txBody>
      </p:sp>
      <p:pic>
        <p:nvPicPr>
          <p:cNvPr id="7" name="Graphic 6" descr="Checkmark">
            <a:extLst>
              <a:ext uri="{FF2B5EF4-FFF2-40B4-BE49-F238E27FC236}">
                <a16:creationId xmlns:a16="http://schemas.microsoft.com/office/drawing/2014/main" id="{C5729BFF-B926-6FBE-9253-43E83289E3BF}"/>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441640" y="1245842"/>
            <a:ext cx="4517695" cy="4517695"/>
          </a:xfrm>
          <a:prstGeom prst="rect">
            <a:avLst/>
          </a:prstGeom>
        </p:spPr>
      </p:pic>
    </p:spTree>
    <p:extLst>
      <p:ext uri="{BB962C8B-B14F-4D97-AF65-F5344CB8AC3E}">
        <p14:creationId xmlns:p14="http://schemas.microsoft.com/office/powerpoint/2010/main" val="213146967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14">
            <a:extLst>
              <a:ext uri="{FF2B5EF4-FFF2-40B4-BE49-F238E27FC236}">
                <a16:creationId xmlns:a16="http://schemas.microsoft.com/office/drawing/2014/main" id="{0E3596DD-156A-473E-9BB3-C6A29F7574E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Freeform: Shape 13">
            <a:extLst>
              <a:ext uri="{FF2B5EF4-FFF2-40B4-BE49-F238E27FC236}">
                <a16:creationId xmlns:a16="http://schemas.microsoft.com/office/drawing/2014/main" id="{2C46C4D6-C474-4E92-B52E-944C1118F7B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5962785" cy="6858000"/>
          </a:xfrm>
          <a:custGeom>
            <a:avLst/>
            <a:gdLst>
              <a:gd name="connsiteX0" fmla="*/ 1044839 w 5962785"/>
              <a:gd name="connsiteY0" fmla="*/ 0 h 6858000"/>
              <a:gd name="connsiteX1" fmla="*/ 5962785 w 5962785"/>
              <a:gd name="connsiteY1" fmla="*/ 0 h 6858000"/>
              <a:gd name="connsiteX2" fmla="*/ 5962785 w 5962785"/>
              <a:gd name="connsiteY2" fmla="*/ 6858000 h 6858000"/>
              <a:gd name="connsiteX3" fmla="*/ 1469886 w 5962785"/>
              <a:gd name="connsiteY3" fmla="*/ 6858000 h 6858000"/>
              <a:gd name="connsiteX4" fmla="*/ 1416006 w 5962785"/>
              <a:gd name="connsiteY4" fmla="*/ 6823984 h 6858000"/>
              <a:gd name="connsiteX5" fmla="*/ 1232473 w 5962785"/>
              <a:gd name="connsiteY5" fmla="*/ 6733873 h 6858000"/>
              <a:gd name="connsiteX6" fmla="*/ 1075471 w 5962785"/>
              <a:gd name="connsiteY6" fmla="*/ 6503186 h 6858000"/>
              <a:gd name="connsiteX7" fmla="*/ 1020229 w 5962785"/>
              <a:gd name="connsiteY7" fmla="*/ 6438306 h 6858000"/>
              <a:gd name="connsiteX8" fmla="*/ 883579 w 5962785"/>
              <a:gd name="connsiteY8" fmla="*/ 6351798 h 6858000"/>
              <a:gd name="connsiteX9" fmla="*/ 645167 w 5962785"/>
              <a:gd name="connsiteY9" fmla="*/ 6167969 h 6858000"/>
              <a:gd name="connsiteX10" fmla="*/ 732391 w 5962785"/>
              <a:gd name="connsiteY10" fmla="*/ 6124716 h 6858000"/>
              <a:gd name="connsiteX11" fmla="*/ 985339 w 5962785"/>
              <a:gd name="connsiteY11" fmla="*/ 6236455 h 6858000"/>
              <a:gd name="connsiteX12" fmla="*/ 1168509 w 5962785"/>
              <a:gd name="connsiteY12" fmla="*/ 6265291 h 6858000"/>
              <a:gd name="connsiteX13" fmla="*/ 909746 w 5962785"/>
              <a:gd name="connsiteY13" fmla="*/ 6070649 h 6858000"/>
              <a:gd name="connsiteX14" fmla="*/ 659704 w 5962785"/>
              <a:gd name="connsiteY14" fmla="*/ 5818335 h 6858000"/>
              <a:gd name="connsiteX15" fmla="*/ 851597 w 5962785"/>
              <a:gd name="connsiteY15" fmla="*/ 5865193 h 6858000"/>
              <a:gd name="connsiteX16" fmla="*/ 860319 w 5962785"/>
              <a:gd name="connsiteY16" fmla="*/ 5832753 h 6858000"/>
              <a:gd name="connsiteX17" fmla="*/ 691686 w 5962785"/>
              <a:gd name="connsiteY17" fmla="*/ 5533581 h 6858000"/>
              <a:gd name="connsiteX18" fmla="*/ 610278 w 5962785"/>
              <a:gd name="connsiteY18" fmla="*/ 5411029 h 6858000"/>
              <a:gd name="connsiteX19" fmla="*/ 238123 w 5962785"/>
              <a:gd name="connsiteY19" fmla="*/ 5046976 h 6858000"/>
              <a:gd name="connsiteX20" fmla="*/ 592833 w 5962785"/>
              <a:gd name="connsiteY20" fmla="*/ 5209177 h 6858000"/>
              <a:gd name="connsiteX21" fmla="*/ 226494 w 5962785"/>
              <a:gd name="connsiteY21" fmla="*/ 4855939 h 6858000"/>
              <a:gd name="connsiteX22" fmla="*/ 49139 w 5962785"/>
              <a:gd name="connsiteY22" fmla="*/ 4726177 h 6858000"/>
              <a:gd name="connsiteX23" fmla="*/ 5527 w 5962785"/>
              <a:gd name="connsiteY23" fmla="*/ 4650483 h 6858000"/>
              <a:gd name="connsiteX24" fmla="*/ 84029 w 5962785"/>
              <a:gd name="connsiteY24" fmla="*/ 4632460 h 6858000"/>
              <a:gd name="connsiteX25" fmla="*/ 325347 w 5962785"/>
              <a:gd name="connsiteY25" fmla="*/ 4661296 h 6858000"/>
              <a:gd name="connsiteX26" fmla="*/ 25879 w 5962785"/>
              <a:gd name="connsiteY26" fmla="*/ 4423401 h 6858000"/>
              <a:gd name="connsiteX27" fmla="*/ 249753 w 5962785"/>
              <a:gd name="connsiteY27" fmla="*/ 4459446 h 6858000"/>
              <a:gd name="connsiteX28" fmla="*/ 313718 w 5962785"/>
              <a:gd name="connsiteY28" fmla="*/ 4365729 h 6858000"/>
              <a:gd name="connsiteX29" fmla="*/ 418386 w 5962785"/>
              <a:gd name="connsiteY29" fmla="*/ 4214341 h 6858000"/>
              <a:gd name="connsiteX30" fmla="*/ 491072 w 5962785"/>
              <a:gd name="connsiteY30" fmla="*/ 4131438 h 6858000"/>
              <a:gd name="connsiteX31" fmla="*/ 520147 w 5962785"/>
              <a:gd name="connsiteY31" fmla="*/ 3864706 h 6858000"/>
              <a:gd name="connsiteX32" fmla="*/ 459090 w 5962785"/>
              <a:gd name="connsiteY32" fmla="*/ 3572743 h 6858000"/>
              <a:gd name="connsiteX33" fmla="*/ 290458 w 5962785"/>
              <a:gd name="connsiteY33" fmla="*/ 3424959 h 6858000"/>
              <a:gd name="connsiteX34" fmla="*/ 339884 w 5962785"/>
              <a:gd name="connsiteY34" fmla="*/ 3259153 h 6858000"/>
              <a:gd name="connsiteX35" fmla="*/ 697501 w 5962785"/>
              <a:gd name="connsiteY35" fmla="*/ 3360078 h 6858000"/>
              <a:gd name="connsiteX36" fmla="*/ 165437 w 5962785"/>
              <a:gd name="connsiteY36" fmla="*/ 2967190 h 6858000"/>
              <a:gd name="connsiteX37" fmla="*/ 255568 w 5962785"/>
              <a:gd name="connsiteY37" fmla="*/ 2949167 h 6858000"/>
              <a:gd name="connsiteX38" fmla="*/ 578296 w 5962785"/>
              <a:gd name="connsiteY38" fmla="*/ 2725691 h 6858000"/>
              <a:gd name="connsiteX39" fmla="*/ 595740 w 5962785"/>
              <a:gd name="connsiteY39" fmla="*/ 2714876 h 6858000"/>
              <a:gd name="connsiteX40" fmla="*/ 650982 w 5962785"/>
              <a:gd name="connsiteY40" fmla="*/ 2574301 h 6858000"/>
              <a:gd name="connsiteX41" fmla="*/ 825429 w 5962785"/>
              <a:gd name="connsiteY41" fmla="*/ 2552674 h 6858000"/>
              <a:gd name="connsiteX42" fmla="*/ 970802 w 5962785"/>
              <a:gd name="connsiteY42" fmla="*/ 2585115 h 6858000"/>
              <a:gd name="connsiteX43" fmla="*/ 1127805 w 5962785"/>
              <a:gd name="connsiteY43" fmla="*/ 2545465 h 6858000"/>
              <a:gd name="connsiteX44" fmla="*/ 1267362 w 5962785"/>
              <a:gd name="connsiteY44" fmla="*/ 2563488 h 6858000"/>
              <a:gd name="connsiteX45" fmla="*/ 1386568 w 5962785"/>
              <a:gd name="connsiteY45" fmla="*/ 2538257 h 6858000"/>
              <a:gd name="connsiteX46" fmla="*/ 1270270 w 5962785"/>
              <a:gd name="connsiteY46" fmla="*/ 2419309 h 6858000"/>
              <a:gd name="connsiteX47" fmla="*/ 1107453 w 5962785"/>
              <a:gd name="connsiteY47" fmla="*/ 2419309 h 6858000"/>
              <a:gd name="connsiteX48" fmla="*/ 991154 w 5962785"/>
              <a:gd name="connsiteY48" fmla="*/ 2343615 h 6858000"/>
              <a:gd name="connsiteX49" fmla="*/ 880671 w 5962785"/>
              <a:gd name="connsiteY49" fmla="*/ 2206645 h 6858000"/>
              <a:gd name="connsiteX50" fmla="*/ 491072 w 5962785"/>
              <a:gd name="connsiteY50" fmla="*/ 1986771 h 6858000"/>
              <a:gd name="connsiteX51" fmla="*/ 421293 w 5962785"/>
              <a:gd name="connsiteY51" fmla="*/ 1903868 h 6858000"/>
              <a:gd name="connsiteX52" fmla="*/ 1531941 w 5962785"/>
              <a:gd name="connsiteY52" fmla="*/ 2224667 h 6858000"/>
              <a:gd name="connsiteX53" fmla="*/ 1188861 w 5962785"/>
              <a:gd name="connsiteY53" fmla="*/ 2091301 h 6858000"/>
              <a:gd name="connsiteX54" fmla="*/ 1421458 w 5962785"/>
              <a:gd name="connsiteY54" fmla="*/ 2116532 h 6858000"/>
              <a:gd name="connsiteX55" fmla="*/ 1549386 w 5962785"/>
              <a:gd name="connsiteY55" fmla="*/ 2026420 h 6858000"/>
              <a:gd name="connsiteX56" fmla="*/ 1549386 w 5962785"/>
              <a:gd name="connsiteY56" fmla="*/ 1997584 h 6858000"/>
              <a:gd name="connsiteX57" fmla="*/ 1453440 w 5962785"/>
              <a:gd name="connsiteY57" fmla="*/ 1914682 h 6858000"/>
              <a:gd name="connsiteX58" fmla="*/ 1398198 w 5962785"/>
              <a:gd name="connsiteY58" fmla="*/ 1860614 h 6858000"/>
              <a:gd name="connsiteX59" fmla="*/ 1247011 w 5962785"/>
              <a:gd name="connsiteY59" fmla="*/ 1665972 h 6858000"/>
              <a:gd name="connsiteX60" fmla="*/ 1354586 w 5962785"/>
              <a:gd name="connsiteY60" fmla="*/ 1644345 h 6858000"/>
              <a:gd name="connsiteX61" fmla="*/ 1395290 w 5962785"/>
              <a:gd name="connsiteY61" fmla="*/ 1604696 h 6858000"/>
              <a:gd name="connsiteX62" fmla="*/ 1366216 w 5962785"/>
              <a:gd name="connsiteY62" fmla="*/ 1547025 h 6858000"/>
              <a:gd name="connsiteX63" fmla="*/ 1031858 w 5962785"/>
              <a:gd name="connsiteY63" fmla="*/ 1370405 h 6858000"/>
              <a:gd name="connsiteX64" fmla="*/ 1005692 w 5962785"/>
              <a:gd name="connsiteY64" fmla="*/ 1233435 h 6858000"/>
              <a:gd name="connsiteX65" fmla="*/ 1069655 w 5962785"/>
              <a:gd name="connsiteY65" fmla="*/ 1211808 h 6858000"/>
              <a:gd name="connsiteX66" fmla="*/ 1142342 w 5962785"/>
              <a:gd name="connsiteY66" fmla="*/ 1222621 h 6858000"/>
              <a:gd name="connsiteX67" fmla="*/ 1084193 w 5962785"/>
              <a:gd name="connsiteY67" fmla="*/ 1114487 h 6858000"/>
              <a:gd name="connsiteX68" fmla="*/ 848689 w 5962785"/>
              <a:gd name="connsiteY68" fmla="*/ 1006353 h 6858000"/>
              <a:gd name="connsiteX69" fmla="*/ 805077 w 5962785"/>
              <a:gd name="connsiteY69" fmla="*/ 948681 h 6858000"/>
              <a:gd name="connsiteX70" fmla="*/ 863226 w 5962785"/>
              <a:gd name="connsiteY70" fmla="*/ 919844 h 6858000"/>
              <a:gd name="connsiteX71" fmla="*/ 906838 w 5962785"/>
              <a:gd name="connsiteY71" fmla="*/ 909031 h 6858000"/>
              <a:gd name="connsiteX72" fmla="*/ 5527 w 5962785"/>
              <a:gd name="connsiteY72" fmla="*/ 458471 h 6858000"/>
              <a:gd name="connsiteX73" fmla="*/ 209049 w 5962785"/>
              <a:gd name="connsiteY73" fmla="*/ 454867 h 6858000"/>
              <a:gd name="connsiteX74" fmla="*/ 409664 w 5962785"/>
              <a:gd name="connsiteY74" fmla="*/ 526956 h 6858000"/>
              <a:gd name="connsiteX75" fmla="*/ 621908 w 5962785"/>
              <a:gd name="connsiteY75" fmla="*/ 516143 h 6858000"/>
              <a:gd name="connsiteX76" fmla="*/ 822522 w 5962785"/>
              <a:gd name="connsiteY76" fmla="*/ 552188 h 6858000"/>
              <a:gd name="connsiteX77" fmla="*/ 996969 w 5962785"/>
              <a:gd name="connsiteY77" fmla="*/ 552188 h 6858000"/>
              <a:gd name="connsiteX78" fmla="*/ 834151 w 5962785"/>
              <a:gd name="connsiteY78" fmla="*/ 498120 h 6858000"/>
              <a:gd name="connsiteX79" fmla="*/ 773095 w 5962785"/>
              <a:gd name="connsiteY79" fmla="*/ 408008 h 6858000"/>
              <a:gd name="connsiteX80" fmla="*/ 793447 w 5962785"/>
              <a:gd name="connsiteY80" fmla="*/ 325106 h 6858000"/>
              <a:gd name="connsiteX81" fmla="*/ 860319 w 5962785"/>
              <a:gd name="connsiteY81" fmla="*/ 350336 h 6858000"/>
              <a:gd name="connsiteX82" fmla="*/ 938820 w 5962785"/>
              <a:gd name="connsiteY82" fmla="*/ 444054 h 6858000"/>
              <a:gd name="connsiteX83" fmla="*/ 956265 w 5962785"/>
              <a:gd name="connsiteY83" fmla="*/ 386381 h 6858000"/>
              <a:gd name="connsiteX84" fmla="*/ 1002784 w 5962785"/>
              <a:gd name="connsiteY84" fmla="*/ 343127 h 6858000"/>
              <a:gd name="connsiteX85" fmla="*/ 1270270 w 5962785"/>
              <a:gd name="connsiteY85" fmla="*/ 364755 h 6858000"/>
              <a:gd name="connsiteX86" fmla="*/ 1092915 w 5962785"/>
              <a:gd name="connsiteY86" fmla="*/ 180926 h 6858000"/>
              <a:gd name="connsiteX87" fmla="*/ 979525 w 5962785"/>
              <a:gd name="connsiteY87" fmla="*/ 152090 h 6858000"/>
              <a:gd name="connsiteX88" fmla="*/ 953358 w 5962785"/>
              <a:gd name="connsiteY88" fmla="*/ 76396 h 6858000"/>
              <a:gd name="connsiteX89" fmla="*/ 1005692 w 5962785"/>
              <a:gd name="connsiteY89" fmla="*/ 58373 h 6858000"/>
              <a:gd name="connsiteX90" fmla="*/ 1267362 w 5962785"/>
              <a:gd name="connsiteY90" fmla="*/ 123254 h 6858000"/>
              <a:gd name="connsiteX91" fmla="*/ 1310975 w 5962785"/>
              <a:gd name="connsiteY91" fmla="*/ 98023 h 6858000"/>
              <a:gd name="connsiteX92" fmla="*/ 1159787 w 5962785"/>
              <a:gd name="connsiteY92" fmla="*/ 43505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Lst>
            <a:rect l="l" t="t" r="r" b="b"/>
            <a:pathLst>
              <a:path w="5962785" h="6858000">
                <a:moveTo>
                  <a:pt x="1044839" y="0"/>
                </a:moveTo>
                <a:lnTo>
                  <a:pt x="5962785" y="0"/>
                </a:lnTo>
                <a:lnTo>
                  <a:pt x="5962785" y="6858000"/>
                </a:lnTo>
                <a:lnTo>
                  <a:pt x="1469886" y="6858000"/>
                </a:lnTo>
                <a:lnTo>
                  <a:pt x="1416006" y="6823984"/>
                </a:lnTo>
                <a:cubicBezTo>
                  <a:pt x="1356767" y="6787940"/>
                  <a:pt x="1296437" y="6755500"/>
                  <a:pt x="1232473" y="6733873"/>
                </a:cubicBezTo>
                <a:cubicBezTo>
                  <a:pt x="1145250" y="6705037"/>
                  <a:pt x="1060933" y="6654575"/>
                  <a:pt x="1075471" y="6503186"/>
                </a:cubicBezTo>
                <a:cubicBezTo>
                  <a:pt x="1078378" y="6459932"/>
                  <a:pt x="1055118" y="6427493"/>
                  <a:pt x="1020229" y="6438306"/>
                </a:cubicBezTo>
                <a:cubicBezTo>
                  <a:pt x="953358" y="6459932"/>
                  <a:pt x="921375" y="6398656"/>
                  <a:pt x="883579" y="6351798"/>
                </a:cubicBezTo>
                <a:cubicBezTo>
                  <a:pt x="816707" y="6268895"/>
                  <a:pt x="752743" y="6182387"/>
                  <a:pt x="645167" y="6167969"/>
                </a:cubicBezTo>
                <a:cubicBezTo>
                  <a:pt x="665519" y="6103088"/>
                  <a:pt x="700408" y="6110298"/>
                  <a:pt x="732391" y="6124716"/>
                </a:cubicBezTo>
                <a:cubicBezTo>
                  <a:pt x="816707" y="6160761"/>
                  <a:pt x="901023" y="6200410"/>
                  <a:pt x="985339" y="6236455"/>
                </a:cubicBezTo>
                <a:cubicBezTo>
                  <a:pt x="1040581" y="6258081"/>
                  <a:pt x="1095822" y="6290522"/>
                  <a:pt x="1168509" y="6265291"/>
                </a:cubicBezTo>
                <a:cubicBezTo>
                  <a:pt x="1104545" y="6135530"/>
                  <a:pt x="996969" y="6110298"/>
                  <a:pt x="909746" y="6070649"/>
                </a:cubicBezTo>
                <a:cubicBezTo>
                  <a:pt x="802169" y="6020185"/>
                  <a:pt x="738206" y="5926470"/>
                  <a:pt x="659704" y="5818335"/>
                </a:cubicBezTo>
                <a:cubicBezTo>
                  <a:pt x="738206" y="5789500"/>
                  <a:pt x="787632" y="5868798"/>
                  <a:pt x="851597" y="5865193"/>
                </a:cubicBezTo>
                <a:cubicBezTo>
                  <a:pt x="854504" y="5854380"/>
                  <a:pt x="860319" y="5832753"/>
                  <a:pt x="860319" y="5832753"/>
                </a:cubicBezTo>
                <a:cubicBezTo>
                  <a:pt x="755650" y="5775081"/>
                  <a:pt x="709132" y="5666947"/>
                  <a:pt x="691686" y="5533581"/>
                </a:cubicBezTo>
                <a:cubicBezTo>
                  <a:pt x="685872" y="5465095"/>
                  <a:pt x="648075" y="5443468"/>
                  <a:pt x="610278" y="5411029"/>
                </a:cubicBezTo>
                <a:cubicBezTo>
                  <a:pt x="482350" y="5299289"/>
                  <a:pt x="345700" y="5198364"/>
                  <a:pt x="238123" y="5046976"/>
                </a:cubicBezTo>
                <a:cubicBezTo>
                  <a:pt x="363144" y="5064998"/>
                  <a:pt x="461997" y="5165924"/>
                  <a:pt x="592833" y="5209177"/>
                </a:cubicBezTo>
                <a:cubicBezTo>
                  <a:pt x="488165" y="5043371"/>
                  <a:pt x="351514" y="4956864"/>
                  <a:pt x="226494" y="4855939"/>
                </a:cubicBezTo>
                <a:cubicBezTo>
                  <a:pt x="168344" y="4809081"/>
                  <a:pt x="116011" y="4751408"/>
                  <a:pt x="49139" y="4726177"/>
                </a:cubicBezTo>
                <a:cubicBezTo>
                  <a:pt x="25879" y="4718968"/>
                  <a:pt x="-14825" y="4700947"/>
                  <a:pt x="5527" y="4650483"/>
                </a:cubicBezTo>
                <a:cubicBezTo>
                  <a:pt x="22972" y="4607230"/>
                  <a:pt x="54954" y="4621648"/>
                  <a:pt x="84029" y="4632460"/>
                </a:cubicBezTo>
                <a:cubicBezTo>
                  <a:pt x="153807" y="4661296"/>
                  <a:pt x="229401" y="4661296"/>
                  <a:pt x="325347" y="4661296"/>
                </a:cubicBezTo>
                <a:cubicBezTo>
                  <a:pt x="243939" y="4524326"/>
                  <a:pt x="95658" y="4567580"/>
                  <a:pt x="25879" y="4423401"/>
                </a:cubicBezTo>
                <a:cubicBezTo>
                  <a:pt x="113103" y="4398170"/>
                  <a:pt x="179975" y="4448632"/>
                  <a:pt x="249753" y="4459446"/>
                </a:cubicBezTo>
                <a:cubicBezTo>
                  <a:pt x="313718" y="4470259"/>
                  <a:pt x="328254" y="4445028"/>
                  <a:pt x="313718" y="4365729"/>
                </a:cubicBezTo>
                <a:cubicBezTo>
                  <a:pt x="290458" y="4243177"/>
                  <a:pt x="325347" y="4181900"/>
                  <a:pt x="418386" y="4214341"/>
                </a:cubicBezTo>
                <a:cubicBezTo>
                  <a:pt x="505609" y="4246781"/>
                  <a:pt x="514332" y="4199922"/>
                  <a:pt x="491072" y="4131438"/>
                </a:cubicBezTo>
                <a:cubicBezTo>
                  <a:pt x="456183" y="4030512"/>
                  <a:pt x="493979" y="3951214"/>
                  <a:pt x="520147" y="3864706"/>
                </a:cubicBezTo>
                <a:cubicBezTo>
                  <a:pt x="560851" y="3734945"/>
                  <a:pt x="543407" y="3670064"/>
                  <a:pt x="459090" y="3572743"/>
                </a:cubicBezTo>
                <a:cubicBezTo>
                  <a:pt x="409664" y="3518676"/>
                  <a:pt x="360236" y="3471818"/>
                  <a:pt x="290458" y="3424959"/>
                </a:cubicBezTo>
                <a:cubicBezTo>
                  <a:pt x="450368" y="3399728"/>
                  <a:pt x="284643" y="3313221"/>
                  <a:pt x="339884" y="3259153"/>
                </a:cubicBezTo>
                <a:cubicBezTo>
                  <a:pt x="453275" y="3237527"/>
                  <a:pt x="543407" y="3410542"/>
                  <a:pt x="697501" y="3360078"/>
                </a:cubicBezTo>
                <a:cubicBezTo>
                  <a:pt x="511425" y="3212294"/>
                  <a:pt x="302087" y="3165436"/>
                  <a:pt x="165437" y="2967190"/>
                </a:cubicBezTo>
                <a:cubicBezTo>
                  <a:pt x="197419" y="2923937"/>
                  <a:pt x="229401" y="2967190"/>
                  <a:pt x="255568" y="2949167"/>
                </a:cubicBezTo>
                <a:cubicBezTo>
                  <a:pt x="255568" y="2938354"/>
                  <a:pt x="560851" y="3006840"/>
                  <a:pt x="578296" y="2725691"/>
                </a:cubicBezTo>
                <a:cubicBezTo>
                  <a:pt x="584111" y="2725691"/>
                  <a:pt x="589926" y="2725691"/>
                  <a:pt x="595740" y="2714876"/>
                </a:cubicBezTo>
                <a:cubicBezTo>
                  <a:pt x="627722" y="2675228"/>
                  <a:pt x="598648" y="2581510"/>
                  <a:pt x="650982" y="2574301"/>
                </a:cubicBezTo>
                <a:cubicBezTo>
                  <a:pt x="709132" y="2567092"/>
                  <a:pt x="764373" y="2534653"/>
                  <a:pt x="825429" y="2552674"/>
                </a:cubicBezTo>
                <a:cubicBezTo>
                  <a:pt x="871949" y="2567092"/>
                  <a:pt x="921375" y="2585115"/>
                  <a:pt x="970802" y="2585115"/>
                </a:cubicBezTo>
                <a:cubicBezTo>
                  <a:pt x="1023136" y="2585115"/>
                  <a:pt x="1095822" y="2707668"/>
                  <a:pt x="1127805" y="2545465"/>
                </a:cubicBezTo>
                <a:cubicBezTo>
                  <a:pt x="1127805" y="2538257"/>
                  <a:pt x="1217936" y="2556280"/>
                  <a:pt x="1267362" y="2563488"/>
                </a:cubicBezTo>
                <a:cubicBezTo>
                  <a:pt x="1308067" y="2570698"/>
                  <a:pt x="1357494" y="2603137"/>
                  <a:pt x="1386568" y="2538257"/>
                </a:cubicBezTo>
                <a:cubicBezTo>
                  <a:pt x="1401105" y="2498607"/>
                  <a:pt x="1331326" y="2426518"/>
                  <a:pt x="1270270" y="2419309"/>
                </a:cubicBezTo>
                <a:cubicBezTo>
                  <a:pt x="1215029" y="2412101"/>
                  <a:pt x="1159787" y="2404892"/>
                  <a:pt x="1107453" y="2419309"/>
                </a:cubicBezTo>
                <a:cubicBezTo>
                  <a:pt x="1043489" y="2437331"/>
                  <a:pt x="1008599" y="2408495"/>
                  <a:pt x="991154" y="2343615"/>
                </a:cubicBezTo>
                <a:cubicBezTo>
                  <a:pt x="970802" y="2275131"/>
                  <a:pt x="933005" y="2239085"/>
                  <a:pt x="880671" y="2206645"/>
                </a:cubicBezTo>
                <a:cubicBezTo>
                  <a:pt x="752743" y="2127346"/>
                  <a:pt x="630630" y="2033629"/>
                  <a:pt x="491072" y="1986771"/>
                </a:cubicBezTo>
                <a:cubicBezTo>
                  <a:pt x="464905" y="1979562"/>
                  <a:pt x="432923" y="1965145"/>
                  <a:pt x="421293" y="1903868"/>
                </a:cubicBezTo>
                <a:cubicBezTo>
                  <a:pt x="799262" y="1997584"/>
                  <a:pt x="1142342" y="2239085"/>
                  <a:pt x="1531941" y="2224667"/>
                </a:cubicBezTo>
                <a:cubicBezTo>
                  <a:pt x="1427272" y="2148974"/>
                  <a:pt x="1302252" y="2145369"/>
                  <a:pt x="1188861" y="2091301"/>
                </a:cubicBezTo>
                <a:cubicBezTo>
                  <a:pt x="1270270" y="2051652"/>
                  <a:pt x="1345864" y="2094906"/>
                  <a:pt x="1421458" y="2116532"/>
                </a:cubicBezTo>
                <a:cubicBezTo>
                  <a:pt x="1485422" y="2134554"/>
                  <a:pt x="1543571" y="2138160"/>
                  <a:pt x="1549386" y="2026420"/>
                </a:cubicBezTo>
                <a:cubicBezTo>
                  <a:pt x="1549386" y="2015607"/>
                  <a:pt x="1549386" y="2008398"/>
                  <a:pt x="1549386" y="1997584"/>
                </a:cubicBezTo>
                <a:cubicBezTo>
                  <a:pt x="1526126" y="1950727"/>
                  <a:pt x="1494144" y="1929099"/>
                  <a:pt x="1453440" y="1914682"/>
                </a:cubicBezTo>
                <a:cubicBezTo>
                  <a:pt x="1430180" y="1907473"/>
                  <a:pt x="1398198" y="1893056"/>
                  <a:pt x="1398198" y="1860614"/>
                </a:cubicBezTo>
                <a:cubicBezTo>
                  <a:pt x="1401105" y="1738063"/>
                  <a:pt x="1322604" y="1702018"/>
                  <a:pt x="1247011" y="1665972"/>
                </a:cubicBezTo>
                <a:cubicBezTo>
                  <a:pt x="1287715" y="1604696"/>
                  <a:pt x="1322604" y="1647950"/>
                  <a:pt x="1354586" y="1644345"/>
                </a:cubicBezTo>
                <a:cubicBezTo>
                  <a:pt x="1374939" y="1640741"/>
                  <a:pt x="1395290" y="1637138"/>
                  <a:pt x="1395290" y="1604696"/>
                </a:cubicBezTo>
                <a:cubicBezTo>
                  <a:pt x="1395290" y="1579465"/>
                  <a:pt x="1386568" y="1547025"/>
                  <a:pt x="1366216" y="1547025"/>
                </a:cubicBezTo>
                <a:cubicBezTo>
                  <a:pt x="1238288" y="1543420"/>
                  <a:pt x="1165601" y="1370405"/>
                  <a:pt x="1031858" y="1370405"/>
                </a:cubicBezTo>
                <a:cubicBezTo>
                  <a:pt x="950450" y="1370405"/>
                  <a:pt x="1072563" y="1273083"/>
                  <a:pt x="1005692" y="1233435"/>
                </a:cubicBezTo>
                <a:cubicBezTo>
                  <a:pt x="991154" y="1222621"/>
                  <a:pt x="1046396" y="1208203"/>
                  <a:pt x="1069655" y="1211808"/>
                </a:cubicBezTo>
                <a:cubicBezTo>
                  <a:pt x="1092915" y="1215412"/>
                  <a:pt x="1113268" y="1240644"/>
                  <a:pt x="1142342" y="1222621"/>
                </a:cubicBezTo>
                <a:cubicBezTo>
                  <a:pt x="1156879" y="1157741"/>
                  <a:pt x="1119082" y="1132510"/>
                  <a:pt x="1084193" y="1114487"/>
                </a:cubicBezTo>
                <a:cubicBezTo>
                  <a:pt x="1008599" y="1071234"/>
                  <a:pt x="933005" y="1020771"/>
                  <a:pt x="848689" y="1006353"/>
                </a:cubicBezTo>
                <a:cubicBezTo>
                  <a:pt x="819615" y="1002748"/>
                  <a:pt x="802169" y="984726"/>
                  <a:pt x="805077" y="948681"/>
                </a:cubicBezTo>
                <a:cubicBezTo>
                  <a:pt x="810892" y="901822"/>
                  <a:pt x="839967" y="916240"/>
                  <a:pt x="863226" y="919844"/>
                </a:cubicBezTo>
                <a:cubicBezTo>
                  <a:pt x="877764" y="923450"/>
                  <a:pt x="892301" y="934263"/>
                  <a:pt x="906838" y="909031"/>
                </a:cubicBezTo>
                <a:cubicBezTo>
                  <a:pt x="566666" y="653113"/>
                  <a:pt x="386404" y="667532"/>
                  <a:pt x="5527" y="458471"/>
                </a:cubicBezTo>
                <a:cubicBezTo>
                  <a:pt x="89843" y="418822"/>
                  <a:pt x="150900" y="447658"/>
                  <a:pt x="209049" y="454867"/>
                </a:cubicBezTo>
                <a:cubicBezTo>
                  <a:pt x="354422" y="472890"/>
                  <a:pt x="264290" y="505329"/>
                  <a:pt x="409664" y="526956"/>
                </a:cubicBezTo>
                <a:cubicBezTo>
                  <a:pt x="479443" y="537770"/>
                  <a:pt x="543407" y="573815"/>
                  <a:pt x="621908" y="516143"/>
                </a:cubicBezTo>
                <a:cubicBezTo>
                  <a:pt x="674242" y="476494"/>
                  <a:pt x="758558" y="519747"/>
                  <a:pt x="822522" y="552188"/>
                </a:cubicBezTo>
                <a:cubicBezTo>
                  <a:pt x="874856" y="581024"/>
                  <a:pt x="927190" y="588232"/>
                  <a:pt x="996969" y="552188"/>
                </a:cubicBezTo>
                <a:cubicBezTo>
                  <a:pt x="933005" y="530562"/>
                  <a:pt x="883579" y="512539"/>
                  <a:pt x="834151" y="498120"/>
                </a:cubicBezTo>
                <a:cubicBezTo>
                  <a:pt x="793447" y="487307"/>
                  <a:pt x="770187" y="462076"/>
                  <a:pt x="773095" y="408008"/>
                </a:cubicBezTo>
                <a:cubicBezTo>
                  <a:pt x="773095" y="379172"/>
                  <a:pt x="764373" y="339523"/>
                  <a:pt x="793447" y="325106"/>
                </a:cubicBezTo>
                <a:cubicBezTo>
                  <a:pt x="816707" y="310688"/>
                  <a:pt x="848689" y="325106"/>
                  <a:pt x="860319" y="350336"/>
                </a:cubicBezTo>
                <a:cubicBezTo>
                  <a:pt x="874856" y="397195"/>
                  <a:pt x="889393" y="440449"/>
                  <a:pt x="938820" y="444054"/>
                </a:cubicBezTo>
                <a:cubicBezTo>
                  <a:pt x="1005692" y="451262"/>
                  <a:pt x="967894" y="422426"/>
                  <a:pt x="956265" y="386381"/>
                </a:cubicBezTo>
                <a:cubicBezTo>
                  <a:pt x="944635" y="346733"/>
                  <a:pt x="979525" y="335919"/>
                  <a:pt x="1002784" y="343127"/>
                </a:cubicBezTo>
                <a:cubicBezTo>
                  <a:pt x="1090008" y="375569"/>
                  <a:pt x="1180139" y="317897"/>
                  <a:pt x="1270270" y="364755"/>
                </a:cubicBezTo>
                <a:cubicBezTo>
                  <a:pt x="1247011" y="249411"/>
                  <a:pt x="1197583" y="198949"/>
                  <a:pt x="1092915" y="180926"/>
                </a:cubicBezTo>
                <a:cubicBezTo>
                  <a:pt x="1055118" y="177322"/>
                  <a:pt x="1014414" y="184530"/>
                  <a:pt x="979525" y="152090"/>
                </a:cubicBezTo>
                <a:cubicBezTo>
                  <a:pt x="959172" y="134068"/>
                  <a:pt x="938820" y="112441"/>
                  <a:pt x="953358" y="76396"/>
                </a:cubicBezTo>
                <a:cubicBezTo>
                  <a:pt x="962080" y="51165"/>
                  <a:pt x="985339" y="51165"/>
                  <a:pt x="1005692" y="58373"/>
                </a:cubicBezTo>
                <a:cubicBezTo>
                  <a:pt x="1090008" y="98023"/>
                  <a:pt x="1180139" y="108837"/>
                  <a:pt x="1267362" y="123254"/>
                </a:cubicBezTo>
                <a:cubicBezTo>
                  <a:pt x="1281900" y="126859"/>
                  <a:pt x="1296437" y="134068"/>
                  <a:pt x="1310975" y="98023"/>
                </a:cubicBezTo>
                <a:cubicBezTo>
                  <a:pt x="1260095" y="81803"/>
                  <a:pt x="1209941" y="62879"/>
                  <a:pt x="1159787" y="43505"/>
                </a:cubicBezTo>
                <a:close/>
              </a:path>
            </a:pathLst>
          </a:custGeom>
          <a:solidFill>
            <a:schemeClr val="accent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 name="Title 1">
            <a:extLst>
              <a:ext uri="{FF2B5EF4-FFF2-40B4-BE49-F238E27FC236}">
                <a16:creationId xmlns:a16="http://schemas.microsoft.com/office/drawing/2014/main" id="{9B4BD825-75F2-A5BE-9127-FC51B5A05576}"/>
              </a:ext>
            </a:extLst>
          </p:cNvPr>
          <p:cNvSpPr>
            <a:spLocks noGrp="1"/>
          </p:cNvSpPr>
          <p:nvPr>
            <p:ph type="title"/>
          </p:nvPr>
        </p:nvSpPr>
        <p:spPr>
          <a:xfrm>
            <a:off x="838201" y="643467"/>
            <a:ext cx="3888526" cy="1800526"/>
          </a:xfrm>
        </p:spPr>
        <p:txBody>
          <a:bodyPr>
            <a:normAutofit/>
          </a:bodyPr>
          <a:lstStyle/>
          <a:p>
            <a:r>
              <a:rPr lang="en-US" b="1"/>
              <a:t>Visual Thinking Strategies</a:t>
            </a:r>
            <a:endParaRPr lang="en-US" dirty="0"/>
          </a:p>
        </p:txBody>
      </p:sp>
      <p:sp>
        <p:nvSpPr>
          <p:cNvPr id="3" name="Content Placeholder 2">
            <a:extLst>
              <a:ext uri="{FF2B5EF4-FFF2-40B4-BE49-F238E27FC236}">
                <a16:creationId xmlns:a16="http://schemas.microsoft.com/office/drawing/2014/main" id="{3C55AA58-1A76-B0A3-A06D-4DE3FE24A963}"/>
              </a:ext>
            </a:extLst>
          </p:cNvPr>
          <p:cNvSpPr>
            <a:spLocks noGrp="1"/>
          </p:cNvSpPr>
          <p:nvPr>
            <p:ph idx="1"/>
          </p:nvPr>
        </p:nvSpPr>
        <p:spPr>
          <a:xfrm>
            <a:off x="838201" y="2623381"/>
            <a:ext cx="3888528" cy="3553581"/>
          </a:xfrm>
        </p:spPr>
        <p:txBody>
          <a:bodyPr>
            <a:normAutofit/>
          </a:bodyPr>
          <a:lstStyle/>
          <a:p>
            <a:pPr marL="0" indent="0">
              <a:buNone/>
            </a:pPr>
            <a:r>
              <a:rPr lang="en-GB" b="1" dirty="0">
                <a:solidFill>
                  <a:srgbClr val="002060"/>
                </a:solidFill>
              </a:rPr>
              <a:t>Paraphrase each comment</a:t>
            </a:r>
            <a:endParaRPr lang="en-IN" b="1" dirty="0">
              <a:solidFill>
                <a:srgbClr val="002060"/>
              </a:solidFill>
            </a:endParaRPr>
          </a:p>
          <a:p>
            <a:pPr marL="0" indent="0">
              <a:buNone/>
            </a:pPr>
            <a:endParaRPr lang="en-US" sz="2000" dirty="0"/>
          </a:p>
        </p:txBody>
      </p:sp>
      <p:pic>
        <p:nvPicPr>
          <p:cNvPr id="9" name="Graphic 8" descr="Chat Bubble">
            <a:extLst>
              <a:ext uri="{FF2B5EF4-FFF2-40B4-BE49-F238E27FC236}">
                <a16:creationId xmlns:a16="http://schemas.microsoft.com/office/drawing/2014/main" id="{77CC59BB-1E37-F198-42B3-1F1E246E77D9}"/>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800986" y="1069398"/>
            <a:ext cx="4747547" cy="4747547"/>
          </a:xfrm>
          <a:prstGeom prst="rect">
            <a:avLst/>
          </a:prstGeom>
        </p:spPr>
      </p:pic>
    </p:spTree>
    <p:extLst>
      <p:ext uri="{BB962C8B-B14F-4D97-AF65-F5344CB8AC3E}">
        <p14:creationId xmlns:p14="http://schemas.microsoft.com/office/powerpoint/2010/main" val="50773643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D3BF84E1-3A56-C53E-DC88-FCF5AD6FE186}"/>
            </a:ext>
          </a:extLst>
        </p:cNvPr>
        <p:cNvGrpSpPr/>
        <p:nvPr/>
      </p:nvGrpSpPr>
      <p:grpSpPr>
        <a:xfrm>
          <a:off x="0" y="0"/>
          <a:ext cx="0" cy="0"/>
          <a:chOff x="0" y="0"/>
          <a:chExt cx="0" cy="0"/>
        </a:xfrm>
      </p:grpSpPr>
      <p:sp useBgFill="1">
        <p:nvSpPr>
          <p:cNvPr id="21" name="Rectangle 20">
            <a:extLst>
              <a:ext uri="{FF2B5EF4-FFF2-40B4-BE49-F238E27FC236}">
                <a16:creationId xmlns:a16="http://schemas.microsoft.com/office/drawing/2014/main" id="{FEC7823C-FDD6-429C-986C-063FDEBF9EA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Freeform: Shape 22">
            <a:extLst>
              <a:ext uri="{FF2B5EF4-FFF2-40B4-BE49-F238E27FC236}">
                <a16:creationId xmlns:a16="http://schemas.microsoft.com/office/drawing/2014/main" id="{9CF7FE1C-8BC5-4B0C-A2BC-93AB72C90FD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768100" y="-1"/>
            <a:ext cx="10423900" cy="5920155"/>
          </a:xfrm>
          <a:custGeom>
            <a:avLst/>
            <a:gdLst>
              <a:gd name="connsiteX0" fmla="*/ 10423900 w 10423900"/>
              <a:gd name="connsiteY0" fmla="*/ 0 h 5491534"/>
              <a:gd name="connsiteX1" fmla="*/ 3493157 w 10423900"/>
              <a:gd name="connsiteY1" fmla="*/ 0 h 5491534"/>
              <a:gd name="connsiteX2" fmla="*/ 3493018 w 10423900"/>
              <a:gd name="connsiteY2" fmla="*/ 31 h 5491534"/>
              <a:gd name="connsiteX3" fmla="*/ 3245493 w 10423900"/>
              <a:gd name="connsiteY3" fmla="*/ 104839 h 5491534"/>
              <a:gd name="connsiteX4" fmla="*/ 4434802 w 10423900"/>
              <a:gd name="connsiteY4" fmla="*/ 284558 h 5491534"/>
              <a:gd name="connsiteX5" fmla="*/ 4011937 w 10423900"/>
              <a:gd name="connsiteY5" fmla="*/ 395559 h 5491534"/>
              <a:gd name="connsiteX6" fmla="*/ 3573213 w 10423900"/>
              <a:gd name="connsiteY6" fmla="*/ 474847 h 5491534"/>
              <a:gd name="connsiteX7" fmla="*/ 3097489 w 10423900"/>
              <a:gd name="connsiteY7" fmla="*/ 532990 h 5491534"/>
              <a:gd name="connsiteX8" fmla="*/ 2664052 w 10423900"/>
              <a:gd name="connsiteY8" fmla="*/ 649279 h 5491534"/>
              <a:gd name="connsiteX9" fmla="*/ 3795218 w 10423900"/>
              <a:gd name="connsiteY9" fmla="*/ 696852 h 5491534"/>
              <a:gd name="connsiteX10" fmla="*/ 3208492 w 10423900"/>
              <a:gd name="connsiteY10" fmla="*/ 802568 h 5491534"/>
              <a:gd name="connsiteX11" fmla="*/ 2727483 w 10423900"/>
              <a:gd name="connsiteY11" fmla="*/ 939999 h 5491534"/>
              <a:gd name="connsiteX12" fmla="*/ 2389190 w 10423900"/>
              <a:gd name="connsiteY12" fmla="*/ 1003429 h 5491534"/>
              <a:gd name="connsiteX13" fmla="*/ 2029754 w 10423900"/>
              <a:gd name="connsiteY13" fmla="*/ 1019287 h 5491534"/>
              <a:gd name="connsiteX14" fmla="*/ 1945181 w 10423900"/>
              <a:gd name="connsiteY14" fmla="*/ 1119716 h 5491534"/>
              <a:gd name="connsiteX15" fmla="*/ 2056184 w 10423900"/>
              <a:gd name="connsiteY15" fmla="*/ 1225434 h 5491534"/>
              <a:gd name="connsiteX16" fmla="*/ 2225329 w 10423900"/>
              <a:gd name="connsiteY16" fmla="*/ 1236004 h 5491534"/>
              <a:gd name="connsiteX17" fmla="*/ 3234920 w 10423900"/>
              <a:gd name="connsiteY17" fmla="*/ 1262435 h 5491534"/>
              <a:gd name="connsiteX18" fmla="*/ 0 w 10423900"/>
              <a:gd name="connsiteY18" fmla="*/ 1495009 h 5491534"/>
              <a:gd name="connsiteX19" fmla="*/ 438724 w 10423900"/>
              <a:gd name="connsiteY19" fmla="*/ 1637728 h 5491534"/>
              <a:gd name="connsiteX20" fmla="*/ 586726 w 10423900"/>
              <a:gd name="connsiteY20" fmla="*/ 2028877 h 5491534"/>
              <a:gd name="connsiteX21" fmla="*/ 1125878 w 10423900"/>
              <a:gd name="connsiteY21" fmla="*/ 2250882 h 5491534"/>
              <a:gd name="connsiteX22" fmla="*/ 1474744 w 10423900"/>
              <a:gd name="connsiteY22" fmla="*/ 2330169 h 5491534"/>
              <a:gd name="connsiteX23" fmla="*/ 2272901 w 10423900"/>
              <a:gd name="connsiteY23" fmla="*/ 2446458 h 5491534"/>
              <a:gd name="connsiteX24" fmla="*/ 2389190 w 10423900"/>
              <a:gd name="connsiteY24" fmla="*/ 2636747 h 5491534"/>
              <a:gd name="connsiteX25" fmla="*/ 2489621 w 10423900"/>
              <a:gd name="connsiteY25" fmla="*/ 2848179 h 5491534"/>
              <a:gd name="connsiteX26" fmla="*/ 2701053 w 10423900"/>
              <a:gd name="connsiteY26" fmla="*/ 2985611 h 5491534"/>
              <a:gd name="connsiteX27" fmla="*/ 1057165 w 10423900"/>
              <a:gd name="connsiteY27" fmla="*/ 2964468 h 5491534"/>
              <a:gd name="connsiteX28" fmla="*/ 2912485 w 10423900"/>
              <a:gd name="connsiteY28" fmla="*/ 3408477 h 5491534"/>
              <a:gd name="connsiteX29" fmla="*/ 2748626 w 10423900"/>
              <a:gd name="connsiteY29" fmla="*/ 3582909 h 5491534"/>
              <a:gd name="connsiteX30" fmla="*/ 3763503 w 10423900"/>
              <a:gd name="connsiteY30" fmla="*/ 3820771 h 5491534"/>
              <a:gd name="connsiteX31" fmla="*/ 3219063 w 10423900"/>
              <a:gd name="connsiteY31" fmla="*/ 3847199 h 5491534"/>
              <a:gd name="connsiteX32" fmla="*/ 6385269 w 10423900"/>
              <a:gd name="connsiteY32" fmla="*/ 4840933 h 5491534"/>
              <a:gd name="connsiteX33" fmla="*/ 10285854 w 10423900"/>
              <a:gd name="connsiteY33" fmla="*/ 5471118 h 5491534"/>
              <a:gd name="connsiteX34" fmla="*/ 10423900 w 10423900"/>
              <a:gd name="connsiteY34" fmla="*/ 5491534 h 54915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10423900" h="5491534">
                <a:moveTo>
                  <a:pt x="10423900" y="0"/>
                </a:moveTo>
                <a:lnTo>
                  <a:pt x="3493157" y="0"/>
                </a:lnTo>
                <a:lnTo>
                  <a:pt x="3493018" y="31"/>
                </a:lnTo>
                <a:cubicBezTo>
                  <a:pt x="3414969" y="12668"/>
                  <a:pt x="3328744" y="21588"/>
                  <a:pt x="3245493" y="104839"/>
                </a:cubicBezTo>
                <a:cubicBezTo>
                  <a:pt x="3668357" y="162984"/>
                  <a:pt x="4075366" y="51981"/>
                  <a:pt x="4434802" y="284558"/>
                </a:cubicBezTo>
                <a:cubicBezTo>
                  <a:pt x="4302656" y="400846"/>
                  <a:pt x="4154654" y="374416"/>
                  <a:pt x="4011937" y="395559"/>
                </a:cubicBezTo>
                <a:cubicBezTo>
                  <a:pt x="3863934" y="416704"/>
                  <a:pt x="3721217" y="453704"/>
                  <a:pt x="3573213" y="474847"/>
                </a:cubicBezTo>
                <a:cubicBezTo>
                  <a:pt x="3414639" y="501275"/>
                  <a:pt x="3256063" y="506562"/>
                  <a:pt x="3097489" y="532990"/>
                </a:cubicBezTo>
                <a:cubicBezTo>
                  <a:pt x="2965345" y="554135"/>
                  <a:pt x="2822627" y="517133"/>
                  <a:pt x="2664052" y="649279"/>
                </a:cubicBezTo>
                <a:cubicBezTo>
                  <a:pt x="3055203" y="744424"/>
                  <a:pt x="3409352" y="601706"/>
                  <a:pt x="3795218" y="696852"/>
                </a:cubicBezTo>
                <a:cubicBezTo>
                  <a:pt x="3567928" y="781425"/>
                  <a:pt x="3382924" y="754995"/>
                  <a:pt x="3208492" y="802568"/>
                </a:cubicBezTo>
                <a:cubicBezTo>
                  <a:pt x="3049916" y="850140"/>
                  <a:pt x="2859627" y="797282"/>
                  <a:pt x="2727483" y="939999"/>
                </a:cubicBezTo>
                <a:cubicBezTo>
                  <a:pt x="2627052" y="1051000"/>
                  <a:pt x="2521336" y="1066858"/>
                  <a:pt x="2389190" y="1003429"/>
                </a:cubicBezTo>
                <a:cubicBezTo>
                  <a:pt x="2272901" y="945284"/>
                  <a:pt x="2146043" y="961142"/>
                  <a:pt x="2029754" y="1019287"/>
                </a:cubicBezTo>
                <a:cubicBezTo>
                  <a:pt x="1987468" y="1040430"/>
                  <a:pt x="1945181" y="1066858"/>
                  <a:pt x="1945181" y="1119716"/>
                </a:cubicBezTo>
                <a:cubicBezTo>
                  <a:pt x="1945181" y="1193719"/>
                  <a:pt x="1998039" y="1214862"/>
                  <a:pt x="2056184" y="1225434"/>
                </a:cubicBezTo>
                <a:cubicBezTo>
                  <a:pt x="2109042" y="1236004"/>
                  <a:pt x="2172471" y="1246577"/>
                  <a:pt x="2225329" y="1236004"/>
                </a:cubicBezTo>
                <a:cubicBezTo>
                  <a:pt x="2563622" y="1177861"/>
                  <a:pt x="2896629" y="1273005"/>
                  <a:pt x="3234920" y="1262435"/>
                </a:cubicBezTo>
                <a:cubicBezTo>
                  <a:pt x="2172471" y="1489724"/>
                  <a:pt x="1099450" y="1415723"/>
                  <a:pt x="0" y="1495009"/>
                </a:cubicBezTo>
                <a:cubicBezTo>
                  <a:pt x="142717" y="1653583"/>
                  <a:pt x="327721" y="1521439"/>
                  <a:pt x="438724" y="1637728"/>
                </a:cubicBezTo>
                <a:cubicBezTo>
                  <a:pt x="333006" y="1880875"/>
                  <a:pt x="375293" y="2013020"/>
                  <a:pt x="586726" y="2028877"/>
                </a:cubicBezTo>
                <a:cubicBezTo>
                  <a:pt x="792873" y="2044734"/>
                  <a:pt x="1014877" y="1960161"/>
                  <a:pt x="1125878" y="2250882"/>
                </a:cubicBezTo>
                <a:cubicBezTo>
                  <a:pt x="1157593" y="2340740"/>
                  <a:pt x="1353170" y="2314312"/>
                  <a:pt x="1474744" y="2330169"/>
                </a:cubicBezTo>
                <a:cubicBezTo>
                  <a:pt x="1739034" y="2367170"/>
                  <a:pt x="2019183" y="2330169"/>
                  <a:pt x="2272901" y="2446458"/>
                </a:cubicBezTo>
                <a:cubicBezTo>
                  <a:pt x="2373332" y="2488744"/>
                  <a:pt x="2442048" y="2520459"/>
                  <a:pt x="2389190" y="2636747"/>
                </a:cubicBezTo>
                <a:cubicBezTo>
                  <a:pt x="2336332" y="2758321"/>
                  <a:pt x="2405048" y="2800607"/>
                  <a:pt x="2489621" y="2848179"/>
                </a:cubicBezTo>
                <a:cubicBezTo>
                  <a:pt x="2553051" y="2885180"/>
                  <a:pt x="2648195" y="2874609"/>
                  <a:pt x="2701053" y="2985611"/>
                </a:cubicBezTo>
                <a:cubicBezTo>
                  <a:pt x="2146043" y="2969753"/>
                  <a:pt x="1606888" y="2879895"/>
                  <a:pt x="1057165" y="2964468"/>
                </a:cubicBezTo>
                <a:cubicBezTo>
                  <a:pt x="1659748" y="3175900"/>
                  <a:pt x="2320474" y="3165328"/>
                  <a:pt x="2912485" y="3408477"/>
                </a:cubicBezTo>
                <a:cubicBezTo>
                  <a:pt x="2891342" y="3493050"/>
                  <a:pt x="2753911" y="3456048"/>
                  <a:pt x="2748626" y="3582909"/>
                </a:cubicBezTo>
                <a:cubicBezTo>
                  <a:pt x="3060489" y="3715055"/>
                  <a:pt x="3435782" y="3625195"/>
                  <a:pt x="3763503" y="3820771"/>
                </a:cubicBezTo>
                <a:cubicBezTo>
                  <a:pt x="3573213" y="3910629"/>
                  <a:pt x="3398782" y="3762626"/>
                  <a:pt x="3219063" y="3847199"/>
                </a:cubicBezTo>
                <a:cubicBezTo>
                  <a:pt x="3277208" y="3974060"/>
                  <a:pt x="5909545" y="4756360"/>
                  <a:pt x="6385269" y="4840933"/>
                </a:cubicBezTo>
                <a:cubicBezTo>
                  <a:pt x="7171204" y="4982659"/>
                  <a:pt x="9157515" y="5302348"/>
                  <a:pt x="10285854" y="5471118"/>
                </a:cubicBezTo>
                <a:lnTo>
                  <a:pt x="10423900" y="5491534"/>
                </a:lnTo>
                <a:close/>
              </a:path>
            </a:pathLst>
          </a:custGeom>
          <a:solidFill>
            <a:schemeClr val="accent1">
              <a:alpha val="20000"/>
            </a:schemeClr>
          </a:solidFill>
          <a:ln w="32707" cap="flat">
            <a:noFill/>
            <a:prstDash val="solid"/>
            <a:miter/>
          </a:ln>
        </p:spPr>
        <p:txBody>
          <a:bodyPr wrap="square" rtlCol="0" anchor="ctr">
            <a:noAutofit/>
          </a:bodyPr>
          <a:lstStyle/>
          <a:p>
            <a:endParaRPr lang="en-US"/>
          </a:p>
        </p:txBody>
      </p:sp>
      <p:sp>
        <p:nvSpPr>
          <p:cNvPr id="25" name="Freeform: Shape 24">
            <a:extLst>
              <a:ext uri="{FF2B5EF4-FFF2-40B4-BE49-F238E27FC236}">
                <a16:creationId xmlns:a16="http://schemas.microsoft.com/office/drawing/2014/main" id="{B0651F5E-0457-4065-ACB2-8B81590C204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1050098" flipH="1" flipV="1">
            <a:off x="-160709" y="3977842"/>
            <a:ext cx="7507400" cy="3166385"/>
          </a:xfrm>
          <a:custGeom>
            <a:avLst/>
            <a:gdLst>
              <a:gd name="connsiteX0" fmla="*/ 5497485 w 7507400"/>
              <a:gd name="connsiteY0" fmla="*/ 2912009 h 3166385"/>
              <a:gd name="connsiteX1" fmla="*/ 7034681 w 7507400"/>
              <a:gd name="connsiteY1" fmla="*/ 3151263 h 3166385"/>
              <a:gd name="connsiteX2" fmla="*/ 7137723 w 7507400"/>
              <a:gd name="connsiteY2" fmla="*/ 3166385 h 3166385"/>
              <a:gd name="connsiteX3" fmla="*/ 7507400 w 7507400"/>
              <a:gd name="connsiteY3" fmla="*/ 875071 h 3166385"/>
              <a:gd name="connsiteX4" fmla="*/ 2083578 w 7507400"/>
              <a:gd name="connsiteY4" fmla="*/ 0 h 3166385"/>
              <a:gd name="connsiteX5" fmla="*/ 2023081 w 7507400"/>
              <a:gd name="connsiteY5" fmla="*/ 5468 h 3166385"/>
              <a:gd name="connsiteX6" fmla="*/ 1865374 w 7507400"/>
              <a:gd name="connsiteY6" fmla="*/ 76313 h 3166385"/>
              <a:gd name="connsiteX7" fmla="*/ 1634010 w 7507400"/>
              <a:gd name="connsiteY7" fmla="*/ 119359 h 3166385"/>
              <a:gd name="connsiteX8" fmla="*/ 1388186 w 7507400"/>
              <a:gd name="connsiteY8" fmla="*/ 130121 h 3166385"/>
              <a:gd name="connsiteX9" fmla="*/ 1330344 w 7507400"/>
              <a:gd name="connsiteY9" fmla="*/ 198275 h 3166385"/>
              <a:gd name="connsiteX10" fmla="*/ 1406262 w 7507400"/>
              <a:gd name="connsiteY10" fmla="*/ 270018 h 3166385"/>
              <a:gd name="connsiteX11" fmla="*/ 1521942 w 7507400"/>
              <a:gd name="connsiteY11" fmla="*/ 277191 h 3166385"/>
              <a:gd name="connsiteX12" fmla="*/ 2212420 w 7507400"/>
              <a:gd name="connsiteY12" fmla="*/ 295128 h 3166385"/>
              <a:gd name="connsiteX13" fmla="*/ 0 w 7507400"/>
              <a:gd name="connsiteY13" fmla="*/ 452960 h 3166385"/>
              <a:gd name="connsiteX14" fmla="*/ 300051 w 7507400"/>
              <a:gd name="connsiteY14" fmla="*/ 549813 h 3166385"/>
              <a:gd name="connsiteX15" fmla="*/ 401272 w 7507400"/>
              <a:gd name="connsiteY15" fmla="*/ 815258 h 3166385"/>
              <a:gd name="connsiteX16" fmla="*/ 770008 w 7507400"/>
              <a:gd name="connsiteY16" fmla="*/ 965917 h 3166385"/>
              <a:gd name="connsiteX17" fmla="*/ 1008605 w 7507400"/>
              <a:gd name="connsiteY17" fmla="*/ 1019724 h 3166385"/>
              <a:gd name="connsiteX18" fmla="*/ 1554478 w 7507400"/>
              <a:gd name="connsiteY18" fmla="*/ 1098641 h 3166385"/>
              <a:gd name="connsiteX19" fmla="*/ 1634010 w 7507400"/>
              <a:gd name="connsiteY19" fmla="*/ 1227777 h 3166385"/>
              <a:gd name="connsiteX20" fmla="*/ 1702696 w 7507400"/>
              <a:gd name="connsiteY20" fmla="*/ 1371261 h 3166385"/>
              <a:gd name="connsiteX21" fmla="*/ 1847299 w 7507400"/>
              <a:gd name="connsiteY21" fmla="*/ 1464526 h 3166385"/>
              <a:gd name="connsiteX22" fmla="*/ 723015 w 7507400"/>
              <a:gd name="connsiteY22" fmla="*/ 1450177 h 3166385"/>
              <a:gd name="connsiteX23" fmla="*/ 1991901 w 7507400"/>
              <a:gd name="connsiteY23" fmla="*/ 1751495 h 3166385"/>
              <a:gd name="connsiteX24" fmla="*/ 1879835 w 7507400"/>
              <a:gd name="connsiteY24" fmla="*/ 1869870 h 3166385"/>
              <a:gd name="connsiteX25" fmla="*/ 2573927 w 7507400"/>
              <a:gd name="connsiteY25" fmla="*/ 2031290 h 3166385"/>
              <a:gd name="connsiteX26" fmla="*/ 2201575 w 7507400"/>
              <a:gd name="connsiteY26" fmla="*/ 2049225 h 3166385"/>
              <a:gd name="connsiteX27" fmla="*/ 4367000 w 7507400"/>
              <a:gd name="connsiteY27" fmla="*/ 2723602 h 3166385"/>
              <a:gd name="connsiteX28" fmla="*/ 5497485 w 7507400"/>
              <a:gd name="connsiteY28" fmla="*/ 2912009 h 316638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7507400" h="3166385">
                <a:moveTo>
                  <a:pt x="5497485" y="2912009"/>
                </a:moveTo>
                <a:cubicBezTo>
                  <a:pt x="6033497" y="2998226"/>
                  <a:pt x="6619155" y="3089592"/>
                  <a:pt x="7034681" y="3151263"/>
                </a:cubicBezTo>
                <a:lnTo>
                  <a:pt x="7137723" y="3166385"/>
                </a:lnTo>
                <a:lnTo>
                  <a:pt x="7507400" y="875071"/>
                </a:lnTo>
                <a:lnTo>
                  <a:pt x="2083578" y="0"/>
                </a:lnTo>
                <a:lnTo>
                  <a:pt x="2023081" y="5468"/>
                </a:lnTo>
                <a:cubicBezTo>
                  <a:pt x="1965692" y="12642"/>
                  <a:pt x="1910562" y="27887"/>
                  <a:pt x="1865374" y="76313"/>
                </a:cubicBezTo>
                <a:cubicBezTo>
                  <a:pt x="1796688" y="151642"/>
                  <a:pt x="1724387" y="162404"/>
                  <a:pt x="1634010" y="119359"/>
                </a:cubicBezTo>
                <a:cubicBezTo>
                  <a:pt x="1554478" y="79900"/>
                  <a:pt x="1467718" y="90662"/>
                  <a:pt x="1388186" y="130121"/>
                </a:cubicBezTo>
                <a:cubicBezTo>
                  <a:pt x="1359266" y="144469"/>
                  <a:pt x="1330344" y="162404"/>
                  <a:pt x="1330344" y="198275"/>
                </a:cubicBezTo>
                <a:cubicBezTo>
                  <a:pt x="1330344" y="248495"/>
                  <a:pt x="1366496" y="262843"/>
                  <a:pt x="1406262" y="270018"/>
                </a:cubicBezTo>
                <a:cubicBezTo>
                  <a:pt x="1442412" y="277191"/>
                  <a:pt x="1485792" y="284366"/>
                  <a:pt x="1521942" y="277191"/>
                </a:cubicBezTo>
                <a:cubicBezTo>
                  <a:pt x="1753307" y="237734"/>
                  <a:pt x="1981057" y="302301"/>
                  <a:pt x="2212420" y="295128"/>
                </a:cubicBezTo>
                <a:cubicBezTo>
                  <a:pt x="1485792" y="449373"/>
                  <a:pt x="751934" y="399154"/>
                  <a:pt x="0" y="452960"/>
                </a:cubicBezTo>
                <a:cubicBezTo>
                  <a:pt x="97608" y="560573"/>
                  <a:pt x="224135" y="470896"/>
                  <a:pt x="300051" y="549813"/>
                </a:cubicBezTo>
                <a:cubicBezTo>
                  <a:pt x="227750" y="714820"/>
                  <a:pt x="256671" y="804497"/>
                  <a:pt x="401272" y="815258"/>
                </a:cubicBezTo>
                <a:cubicBezTo>
                  <a:pt x="542261" y="826019"/>
                  <a:pt x="694093" y="768625"/>
                  <a:pt x="770008" y="965917"/>
                </a:cubicBezTo>
                <a:cubicBezTo>
                  <a:pt x="791699" y="1026898"/>
                  <a:pt x="925458" y="1008963"/>
                  <a:pt x="1008605" y="1019724"/>
                </a:cubicBezTo>
                <a:cubicBezTo>
                  <a:pt x="1189357" y="1044833"/>
                  <a:pt x="1380957" y="1019724"/>
                  <a:pt x="1554478" y="1098641"/>
                </a:cubicBezTo>
                <a:cubicBezTo>
                  <a:pt x="1623165" y="1127337"/>
                  <a:pt x="1670160" y="1148860"/>
                  <a:pt x="1634010" y="1227777"/>
                </a:cubicBezTo>
                <a:cubicBezTo>
                  <a:pt x="1597859" y="1310280"/>
                  <a:pt x="1644855" y="1338976"/>
                  <a:pt x="1702696" y="1371261"/>
                </a:cubicBezTo>
                <a:cubicBezTo>
                  <a:pt x="1746077" y="1396370"/>
                  <a:pt x="1811148" y="1389197"/>
                  <a:pt x="1847299" y="1464526"/>
                </a:cubicBezTo>
                <a:cubicBezTo>
                  <a:pt x="1467717" y="1453764"/>
                  <a:pt x="1098981" y="1392783"/>
                  <a:pt x="723015" y="1450177"/>
                </a:cubicBezTo>
                <a:cubicBezTo>
                  <a:pt x="1135131" y="1593662"/>
                  <a:pt x="1587014" y="1586487"/>
                  <a:pt x="1991901" y="1751495"/>
                </a:cubicBezTo>
                <a:cubicBezTo>
                  <a:pt x="1977441" y="1808889"/>
                  <a:pt x="1883449" y="1783778"/>
                  <a:pt x="1879835" y="1869870"/>
                </a:cubicBezTo>
                <a:cubicBezTo>
                  <a:pt x="2093123" y="1959548"/>
                  <a:pt x="2349794" y="1898566"/>
                  <a:pt x="2573927" y="2031290"/>
                </a:cubicBezTo>
                <a:cubicBezTo>
                  <a:pt x="2443785" y="2092271"/>
                  <a:pt x="2324488" y="1991831"/>
                  <a:pt x="2201575" y="2049225"/>
                </a:cubicBezTo>
                <a:cubicBezTo>
                  <a:pt x="2241342" y="2135316"/>
                  <a:pt x="4041644" y="2666208"/>
                  <a:pt x="4367000" y="2723602"/>
                </a:cubicBezTo>
                <a:cubicBezTo>
                  <a:pt x="4615085" y="2767993"/>
                  <a:pt x="5038048" y="2838109"/>
                  <a:pt x="5497485" y="2912009"/>
                </a:cubicBezTo>
                <a:close/>
              </a:path>
            </a:pathLst>
          </a:custGeom>
          <a:solidFill>
            <a:schemeClr val="accent1">
              <a:alpha val="20000"/>
            </a:schemeClr>
          </a:solidFill>
          <a:ln w="32707" cap="flat">
            <a:noFill/>
            <a:prstDash val="solid"/>
            <a:miter/>
          </a:ln>
        </p:spPr>
        <p:txBody>
          <a:bodyPr wrap="square" rtlCol="0" anchor="ctr">
            <a:noAutofit/>
          </a:bodyPr>
          <a:lstStyle/>
          <a:p>
            <a:endParaRPr lang="en-US"/>
          </a:p>
        </p:txBody>
      </p:sp>
      <p:sp>
        <p:nvSpPr>
          <p:cNvPr id="2" name="Title 1">
            <a:extLst>
              <a:ext uri="{FF2B5EF4-FFF2-40B4-BE49-F238E27FC236}">
                <a16:creationId xmlns:a16="http://schemas.microsoft.com/office/drawing/2014/main" id="{F60E809B-B071-B642-7F52-3CF341BC1EF9}"/>
              </a:ext>
            </a:extLst>
          </p:cNvPr>
          <p:cNvSpPr>
            <a:spLocks noGrp="1"/>
          </p:cNvSpPr>
          <p:nvPr>
            <p:ph type="ctrTitle"/>
          </p:nvPr>
        </p:nvSpPr>
        <p:spPr>
          <a:xfrm>
            <a:off x="5751094" y="1058780"/>
            <a:ext cx="5602705" cy="3092116"/>
          </a:xfrm>
        </p:spPr>
        <p:txBody>
          <a:bodyPr anchor="ctr">
            <a:normAutofit/>
          </a:bodyPr>
          <a:lstStyle/>
          <a:p>
            <a:r>
              <a:rPr lang="en-US" sz="3800" b="1"/>
              <a:t>“DISEASE &amp; SUFFERING” – FROM THE EYES OF A PATIENT &amp; CAREGIVER</a:t>
            </a:r>
            <a:br>
              <a:rPr lang="en-US" sz="3800"/>
            </a:br>
            <a:endParaRPr lang="en-US" sz="3800" b="1"/>
          </a:p>
        </p:txBody>
      </p:sp>
    </p:spTree>
    <p:extLst>
      <p:ext uri="{BB962C8B-B14F-4D97-AF65-F5344CB8AC3E}">
        <p14:creationId xmlns:p14="http://schemas.microsoft.com/office/powerpoint/2010/main" val="47278175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9ED993-F3AB-A627-991C-ED6A8231A980}"/>
              </a:ext>
            </a:extLst>
          </p:cNvPr>
          <p:cNvSpPr>
            <a:spLocks noGrp="1"/>
          </p:cNvSpPr>
          <p:nvPr>
            <p:ph type="title"/>
          </p:nvPr>
        </p:nvSpPr>
        <p:spPr/>
        <p:txBody>
          <a:bodyPr>
            <a:normAutofit/>
          </a:bodyPr>
          <a:lstStyle/>
          <a:p>
            <a:pPr algn="l"/>
            <a:r>
              <a:rPr lang="en-US" b="1" dirty="0"/>
              <a:t>ART 1</a:t>
            </a:r>
          </a:p>
        </p:txBody>
      </p:sp>
      <p:sp>
        <p:nvSpPr>
          <p:cNvPr id="3" name="Content Placeholder 2">
            <a:extLst>
              <a:ext uri="{FF2B5EF4-FFF2-40B4-BE49-F238E27FC236}">
                <a16:creationId xmlns:a16="http://schemas.microsoft.com/office/drawing/2014/main" id="{0710A882-94C4-F2A8-5051-0BC1D9A49A0A}"/>
              </a:ext>
            </a:extLst>
          </p:cNvPr>
          <p:cNvSpPr>
            <a:spLocks noGrp="1"/>
          </p:cNvSpPr>
          <p:nvPr>
            <p:ph idx="1"/>
          </p:nvPr>
        </p:nvSpPr>
        <p:spPr>
          <a:xfrm>
            <a:off x="356260" y="2075542"/>
            <a:ext cx="2967511" cy="4096657"/>
          </a:xfrm>
        </p:spPr>
        <p:txBody>
          <a:bodyPr>
            <a:normAutofit/>
          </a:bodyPr>
          <a:lstStyle/>
          <a:p>
            <a:pPr marL="0" indent="0">
              <a:buNone/>
            </a:pPr>
            <a:r>
              <a:rPr lang="en-US" b="1" i="0" dirty="0">
                <a:solidFill>
                  <a:schemeClr val="accent6">
                    <a:lumMod val="50000"/>
                  </a:schemeClr>
                </a:solidFill>
                <a:effectLst/>
              </a:rPr>
              <a:t>The Field Hospital By </a:t>
            </a:r>
            <a:r>
              <a:rPr lang="en-US" b="1" i="0" u="none" strike="noStrike" dirty="0">
                <a:solidFill>
                  <a:schemeClr val="accent6">
                    <a:lumMod val="50000"/>
                  </a:schemeClr>
                </a:solidFill>
                <a:effectLst/>
                <a:hlinkClick r:id="rId3">
                  <a:extLst>
                    <a:ext uri="{A12FA001-AC4F-418D-AE19-62706E023703}">
                      <ahyp:hlinkClr xmlns:ahyp="http://schemas.microsoft.com/office/drawing/2018/hyperlinkcolor" val="tx"/>
                    </a:ext>
                  </a:extLst>
                </a:hlinkClick>
              </a:rPr>
              <a:t>Eastman Johnson</a:t>
            </a:r>
            <a:r>
              <a:rPr lang="en-US" b="1" i="0" dirty="0">
                <a:solidFill>
                  <a:schemeClr val="accent6">
                    <a:lumMod val="50000"/>
                  </a:schemeClr>
                </a:solidFill>
                <a:effectLst/>
              </a:rPr>
              <a:t> (American, 1824–1906) 1867</a:t>
            </a:r>
            <a:endParaRPr lang="en-US" b="1" dirty="0">
              <a:solidFill>
                <a:schemeClr val="accent6">
                  <a:lumMod val="50000"/>
                </a:schemeClr>
              </a:solidFill>
            </a:endParaRPr>
          </a:p>
        </p:txBody>
      </p:sp>
      <p:pic>
        <p:nvPicPr>
          <p:cNvPr id="4" name="Content Placeholder 4" descr="A person lying in a bed&#10;&#10;Description automatically generated">
            <a:extLst>
              <a:ext uri="{FF2B5EF4-FFF2-40B4-BE49-F238E27FC236}">
                <a16:creationId xmlns:a16="http://schemas.microsoft.com/office/drawing/2014/main" id="{357690C3-6D8A-517C-DD10-ACBD2EA64A22}"/>
              </a:ext>
            </a:extLst>
          </p:cNvPr>
          <p:cNvPicPr>
            <a:picLocks noChangeAspect="1"/>
          </p:cNvPicPr>
          <p:nvPr/>
        </p:nvPicPr>
        <p:blipFill>
          <a:blip r:embed="rId4"/>
          <a:stretch>
            <a:fillRect/>
          </a:stretch>
        </p:blipFill>
        <p:spPr>
          <a:xfrm>
            <a:off x="3843649" y="-56437"/>
            <a:ext cx="8348351" cy="6970874"/>
          </a:xfrm>
          <a:prstGeom prst="rect">
            <a:avLst/>
          </a:prstGeom>
        </p:spPr>
      </p:pic>
    </p:spTree>
    <p:extLst>
      <p:ext uri="{BB962C8B-B14F-4D97-AF65-F5344CB8AC3E}">
        <p14:creationId xmlns:p14="http://schemas.microsoft.com/office/powerpoint/2010/main" val="18006837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3" name="Rectangle 12">
            <a:extLst>
              <a:ext uri="{FF2B5EF4-FFF2-40B4-BE49-F238E27FC236}">
                <a16:creationId xmlns:a16="http://schemas.microsoft.com/office/drawing/2014/main" id="{08953E74-D241-4DDF-8508-F0365EA13A9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Freeform: Shape 10">
            <a:extLst>
              <a:ext uri="{FF2B5EF4-FFF2-40B4-BE49-F238E27FC236}">
                <a16:creationId xmlns:a16="http://schemas.microsoft.com/office/drawing/2014/main" id="{5C3C901A-B2F4-4A3C-BCDD-7C8D587ECA2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0"/>
            <a:ext cx="12192000" cy="2371134"/>
          </a:xfrm>
          <a:custGeom>
            <a:avLst/>
            <a:gdLst>
              <a:gd name="connsiteX0" fmla="*/ 0 w 12192000"/>
              <a:gd name="connsiteY0" fmla="*/ 0 h 2515690"/>
              <a:gd name="connsiteX1" fmla="*/ 170442 w 12192000"/>
              <a:gd name="connsiteY1" fmla="*/ 96074 h 2515690"/>
              <a:gd name="connsiteX2" fmla="*/ 424739 w 12192000"/>
              <a:gd name="connsiteY2" fmla="*/ 224865 h 2515690"/>
              <a:gd name="connsiteX3" fmla="*/ 748273 w 12192000"/>
              <a:gd name="connsiteY3" fmla="*/ 373939 h 2515690"/>
              <a:gd name="connsiteX4" fmla="*/ 1037058 w 12192000"/>
              <a:gd name="connsiteY4" fmla="*/ 499994 h 2515690"/>
              <a:gd name="connsiteX5" fmla="*/ 1101312 w 12192000"/>
              <a:gd name="connsiteY5" fmla="*/ 428540 h 2515690"/>
              <a:gd name="connsiteX6" fmla="*/ 1367071 w 12192000"/>
              <a:gd name="connsiteY6" fmla="*/ 516118 h 2515690"/>
              <a:gd name="connsiteX7" fmla="*/ 2189943 w 12192000"/>
              <a:gd name="connsiteY7" fmla="*/ 794533 h 2515690"/>
              <a:gd name="connsiteX8" fmla="*/ 2390329 w 12192000"/>
              <a:gd name="connsiteY8" fmla="*/ 920897 h 2515690"/>
              <a:gd name="connsiteX9" fmla="*/ 2459570 w 12192000"/>
              <a:gd name="connsiteY9" fmla="*/ 983740 h 2515690"/>
              <a:gd name="connsiteX10" fmla="*/ 2503252 w 12192000"/>
              <a:gd name="connsiteY10" fmla="*/ 1000151 h 2515690"/>
              <a:gd name="connsiteX11" fmla="*/ 2503252 w 12192000"/>
              <a:gd name="connsiteY11" fmla="*/ 1008273 h 2515690"/>
              <a:gd name="connsiteX12" fmla="*/ 2511191 w 12192000"/>
              <a:gd name="connsiteY12" fmla="*/ 1009499 h 2515690"/>
              <a:gd name="connsiteX13" fmla="*/ 2565029 w 12192000"/>
              <a:gd name="connsiteY13" fmla="*/ 1015977 h 2515690"/>
              <a:gd name="connsiteX14" fmla="*/ 2593745 w 12192000"/>
              <a:gd name="connsiteY14" fmla="*/ 1019963 h 2515690"/>
              <a:gd name="connsiteX15" fmla="*/ 2591015 w 12192000"/>
              <a:gd name="connsiteY15" fmla="*/ 1019651 h 2515690"/>
              <a:gd name="connsiteX16" fmla="*/ 2590137 w 12192000"/>
              <a:gd name="connsiteY16" fmla="*/ 1019549 h 2515690"/>
              <a:gd name="connsiteX17" fmla="*/ 2589021 w 12192000"/>
              <a:gd name="connsiteY17" fmla="*/ 1019424 h 2515690"/>
              <a:gd name="connsiteX18" fmla="*/ 2591015 w 12192000"/>
              <a:gd name="connsiteY18" fmla="*/ 1019651 h 2515690"/>
              <a:gd name="connsiteX19" fmla="*/ 2602385 w 12192000"/>
              <a:gd name="connsiteY19" fmla="*/ 1020975 h 2515690"/>
              <a:gd name="connsiteX20" fmla="*/ 2614445 w 12192000"/>
              <a:gd name="connsiteY20" fmla="*/ 1022389 h 2515690"/>
              <a:gd name="connsiteX21" fmla="*/ 2614445 w 12192000"/>
              <a:gd name="connsiteY21" fmla="*/ 1020966 h 2515690"/>
              <a:gd name="connsiteX22" fmla="*/ 2676661 w 12192000"/>
              <a:gd name="connsiteY22" fmla="*/ 1029355 h 2515690"/>
              <a:gd name="connsiteX23" fmla="*/ 2788597 w 12192000"/>
              <a:gd name="connsiteY23" fmla="*/ 1048926 h 2515690"/>
              <a:gd name="connsiteX24" fmla="*/ 2812742 w 12192000"/>
              <a:gd name="connsiteY24" fmla="*/ 1057667 h 2515690"/>
              <a:gd name="connsiteX25" fmla="*/ 2970201 w 12192000"/>
              <a:gd name="connsiteY25" fmla="*/ 949091 h 2515690"/>
              <a:gd name="connsiteX26" fmla="*/ 3030610 w 12192000"/>
              <a:gd name="connsiteY26" fmla="*/ 1049340 h 2515690"/>
              <a:gd name="connsiteX27" fmla="*/ 3058913 w 12192000"/>
              <a:gd name="connsiteY27" fmla="*/ 1048085 h 2515690"/>
              <a:gd name="connsiteX28" fmla="*/ 3072697 w 12192000"/>
              <a:gd name="connsiteY28" fmla="*/ 1045316 h 2515690"/>
              <a:gd name="connsiteX29" fmla="*/ 3083305 w 12192000"/>
              <a:gd name="connsiteY29" fmla="*/ 1040550 h 2515690"/>
              <a:gd name="connsiteX30" fmla="*/ 3125603 w 12192000"/>
              <a:gd name="connsiteY30" fmla="*/ 1004583 h 2515690"/>
              <a:gd name="connsiteX31" fmla="*/ 3385106 w 12192000"/>
              <a:gd name="connsiteY31" fmla="*/ 1042233 h 2515690"/>
              <a:gd name="connsiteX32" fmla="*/ 3424945 w 12192000"/>
              <a:gd name="connsiteY32" fmla="*/ 1065268 h 2515690"/>
              <a:gd name="connsiteX33" fmla="*/ 3436948 w 12192000"/>
              <a:gd name="connsiteY33" fmla="*/ 1068018 h 2515690"/>
              <a:gd name="connsiteX34" fmla="*/ 3466714 w 12192000"/>
              <a:gd name="connsiteY34" fmla="*/ 1063419 h 2515690"/>
              <a:gd name="connsiteX35" fmla="*/ 3550909 w 12192000"/>
              <a:gd name="connsiteY35" fmla="*/ 1044511 h 2515690"/>
              <a:gd name="connsiteX36" fmla="*/ 3555900 w 12192000"/>
              <a:gd name="connsiteY36" fmla="*/ 1041996 h 2515690"/>
              <a:gd name="connsiteX37" fmla="*/ 3625978 w 12192000"/>
              <a:gd name="connsiteY37" fmla="*/ 1023459 h 2515690"/>
              <a:gd name="connsiteX38" fmla="*/ 3632465 w 12192000"/>
              <a:gd name="connsiteY38" fmla="*/ 1023522 h 2515690"/>
              <a:gd name="connsiteX39" fmla="*/ 3649063 w 12192000"/>
              <a:gd name="connsiteY39" fmla="*/ 1018726 h 2515690"/>
              <a:gd name="connsiteX40" fmla="*/ 3805954 w 12192000"/>
              <a:gd name="connsiteY40" fmla="*/ 917517 h 2515690"/>
              <a:gd name="connsiteX41" fmla="*/ 4020506 w 12192000"/>
              <a:gd name="connsiteY41" fmla="*/ 816231 h 2515690"/>
              <a:gd name="connsiteX42" fmla="*/ 4233682 w 12192000"/>
              <a:gd name="connsiteY42" fmla="*/ 799511 h 2515690"/>
              <a:gd name="connsiteX43" fmla="*/ 4306552 w 12192000"/>
              <a:gd name="connsiteY43" fmla="*/ 610207 h 2515690"/>
              <a:gd name="connsiteX44" fmla="*/ 4816604 w 12192000"/>
              <a:gd name="connsiteY44" fmla="*/ 773163 h 2515690"/>
              <a:gd name="connsiteX45" fmla="*/ 4916502 w 12192000"/>
              <a:gd name="connsiteY45" fmla="*/ 788104 h 2515690"/>
              <a:gd name="connsiteX46" fmla="*/ 5224415 w 12192000"/>
              <a:gd name="connsiteY46" fmla="*/ 674418 h 2515690"/>
              <a:gd name="connsiteX47" fmla="*/ 5274077 w 12192000"/>
              <a:gd name="connsiteY47" fmla="*/ 655978 h 2515690"/>
              <a:gd name="connsiteX48" fmla="*/ 5371217 w 12192000"/>
              <a:gd name="connsiteY48" fmla="*/ 614372 h 2515690"/>
              <a:gd name="connsiteX49" fmla="*/ 5364523 w 12192000"/>
              <a:gd name="connsiteY49" fmla="*/ 502501 h 2515690"/>
              <a:gd name="connsiteX50" fmla="*/ 5457871 w 12192000"/>
              <a:gd name="connsiteY50" fmla="*/ 558285 h 2515690"/>
              <a:gd name="connsiteX51" fmla="*/ 5750580 w 12192000"/>
              <a:gd name="connsiteY51" fmla="*/ 663503 h 2515690"/>
              <a:gd name="connsiteX52" fmla="*/ 5976618 w 12192000"/>
              <a:gd name="connsiteY52" fmla="*/ 582652 h 2515690"/>
              <a:gd name="connsiteX53" fmla="*/ 6009346 w 12192000"/>
              <a:gd name="connsiteY53" fmla="*/ 559470 h 2515690"/>
              <a:gd name="connsiteX54" fmla="*/ 6069735 w 12192000"/>
              <a:gd name="connsiteY54" fmla="*/ 587803 h 2515690"/>
              <a:gd name="connsiteX55" fmla="*/ 6270319 w 12192000"/>
              <a:gd name="connsiteY55" fmla="*/ 643982 h 2515690"/>
              <a:gd name="connsiteX56" fmla="*/ 6406781 w 12192000"/>
              <a:gd name="connsiteY56" fmla="*/ 672327 h 2515690"/>
              <a:gd name="connsiteX57" fmla="*/ 6469508 w 12192000"/>
              <a:gd name="connsiteY57" fmla="*/ 708574 h 2515690"/>
              <a:gd name="connsiteX58" fmla="*/ 6515869 w 12192000"/>
              <a:gd name="connsiteY58" fmla="*/ 715738 h 2515690"/>
              <a:gd name="connsiteX59" fmla="*/ 6725938 w 12192000"/>
              <a:gd name="connsiteY59" fmla="*/ 691128 h 2515690"/>
              <a:gd name="connsiteX60" fmla="*/ 6778240 w 12192000"/>
              <a:gd name="connsiteY60" fmla="*/ 678998 h 2515690"/>
              <a:gd name="connsiteX61" fmla="*/ 6806944 w 12192000"/>
              <a:gd name="connsiteY61" fmla="*/ 646178 h 2515690"/>
              <a:gd name="connsiteX62" fmla="*/ 6830632 w 12192000"/>
              <a:gd name="connsiteY62" fmla="*/ 633915 h 2515690"/>
              <a:gd name="connsiteX63" fmla="*/ 6858072 w 12192000"/>
              <a:gd name="connsiteY63" fmla="*/ 646178 h 2515690"/>
              <a:gd name="connsiteX64" fmla="*/ 6891322 w 12192000"/>
              <a:gd name="connsiteY64" fmla="*/ 678998 h 2515690"/>
              <a:gd name="connsiteX65" fmla="*/ 6951905 w 12192000"/>
              <a:gd name="connsiteY65" fmla="*/ 691128 h 2515690"/>
              <a:gd name="connsiteX66" fmla="*/ 7195246 w 12192000"/>
              <a:gd name="connsiteY66" fmla="*/ 715738 h 2515690"/>
              <a:gd name="connsiteX67" fmla="*/ 7248949 w 12192000"/>
              <a:gd name="connsiteY67" fmla="*/ 708574 h 2515690"/>
              <a:gd name="connsiteX68" fmla="*/ 7321609 w 12192000"/>
              <a:gd name="connsiteY68" fmla="*/ 672327 h 2515690"/>
              <a:gd name="connsiteX69" fmla="*/ 7479684 w 12192000"/>
              <a:gd name="connsiteY69" fmla="*/ 643982 h 2515690"/>
              <a:gd name="connsiteX70" fmla="*/ 7712035 w 12192000"/>
              <a:gd name="connsiteY70" fmla="*/ 587803 h 2515690"/>
              <a:gd name="connsiteX71" fmla="*/ 7781987 w 12192000"/>
              <a:gd name="connsiteY71" fmla="*/ 559470 h 2515690"/>
              <a:gd name="connsiteX72" fmla="*/ 7819900 w 12192000"/>
              <a:gd name="connsiteY72" fmla="*/ 582652 h 2515690"/>
              <a:gd name="connsiteX73" fmla="*/ 8081736 w 12192000"/>
              <a:gd name="connsiteY73" fmla="*/ 663503 h 2515690"/>
              <a:gd name="connsiteX74" fmla="*/ 8420801 w 12192000"/>
              <a:gd name="connsiteY74" fmla="*/ 558285 h 2515690"/>
              <a:gd name="connsiteX75" fmla="*/ 8528933 w 12192000"/>
              <a:gd name="connsiteY75" fmla="*/ 502501 h 2515690"/>
              <a:gd name="connsiteX76" fmla="*/ 8521178 w 12192000"/>
              <a:gd name="connsiteY76" fmla="*/ 614372 h 2515690"/>
              <a:gd name="connsiteX77" fmla="*/ 8633702 w 12192000"/>
              <a:gd name="connsiteY77" fmla="*/ 655978 h 2515690"/>
              <a:gd name="connsiteX78" fmla="*/ 8691231 w 12192000"/>
              <a:gd name="connsiteY78" fmla="*/ 674418 h 2515690"/>
              <a:gd name="connsiteX79" fmla="*/ 9047908 w 12192000"/>
              <a:gd name="connsiteY79" fmla="*/ 788104 h 2515690"/>
              <a:gd name="connsiteX80" fmla="*/ 9163628 w 12192000"/>
              <a:gd name="connsiteY80" fmla="*/ 773163 h 2515690"/>
              <a:gd name="connsiteX81" fmla="*/ 9754459 w 12192000"/>
              <a:gd name="connsiteY81" fmla="*/ 610207 h 2515690"/>
              <a:gd name="connsiteX82" fmla="*/ 9838868 w 12192000"/>
              <a:gd name="connsiteY82" fmla="*/ 799511 h 2515690"/>
              <a:gd name="connsiteX83" fmla="*/ 10085808 w 12192000"/>
              <a:gd name="connsiteY83" fmla="*/ 816231 h 2515690"/>
              <a:gd name="connsiteX84" fmla="*/ 10334338 w 12192000"/>
              <a:gd name="connsiteY84" fmla="*/ 917517 h 2515690"/>
              <a:gd name="connsiteX85" fmla="*/ 10516076 w 12192000"/>
              <a:gd name="connsiteY85" fmla="*/ 1018726 h 2515690"/>
              <a:gd name="connsiteX86" fmla="*/ 10535302 w 12192000"/>
              <a:gd name="connsiteY86" fmla="*/ 1023522 h 2515690"/>
              <a:gd name="connsiteX87" fmla="*/ 10542819 w 12192000"/>
              <a:gd name="connsiteY87" fmla="*/ 1023458 h 2515690"/>
              <a:gd name="connsiteX88" fmla="*/ 10623994 w 12192000"/>
              <a:gd name="connsiteY88" fmla="*/ 1041996 h 2515690"/>
              <a:gd name="connsiteX89" fmla="*/ 10629774 w 12192000"/>
              <a:gd name="connsiteY89" fmla="*/ 1044511 h 2515690"/>
              <a:gd name="connsiteX90" fmla="*/ 10727305 w 12192000"/>
              <a:gd name="connsiteY90" fmla="*/ 1063419 h 2515690"/>
              <a:gd name="connsiteX91" fmla="*/ 10761785 w 12192000"/>
              <a:gd name="connsiteY91" fmla="*/ 1068017 h 2515690"/>
              <a:gd name="connsiteX92" fmla="*/ 10775688 w 12192000"/>
              <a:gd name="connsiteY92" fmla="*/ 1065268 h 2515690"/>
              <a:gd name="connsiteX93" fmla="*/ 10821837 w 12192000"/>
              <a:gd name="connsiteY93" fmla="*/ 1042232 h 2515690"/>
              <a:gd name="connsiteX94" fmla="*/ 11122438 w 12192000"/>
              <a:gd name="connsiteY94" fmla="*/ 1004583 h 2515690"/>
              <a:gd name="connsiteX95" fmla="*/ 11171433 w 12192000"/>
              <a:gd name="connsiteY95" fmla="*/ 1040550 h 2515690"/>
              <a:gd name="connsiteX96" fmla="*/ 11183724 w 12192000"/>
              <a:gd name="connsiteY96" fmla="*/ 1045316 h 2515690"/>
              <a:gd name="connsiteX97" fmla="*/ 11199690 w 12192000"/>
              <a:gd name="connsiteY97" fmla="*/ 1048085 h 2515690"/>
              <a:gd name="connsiteX98" fmla="*/ 11232475 w 12192000"/>
              <a:gd name="connsiteY98" fmla="*/ 1049340 h 2515690"/>
              <a:gd name="connsiteX99" fmla="*/ 11302451 w 12192000"/>
              <a:gd name="connsiteY99" fmla="*/ 949091 h 2515690"/>
              <a:gd name="connsiteX100" fmla="*/ 11484849 w 12192000"/>
              <a:gd name="connsiteY100" fmla="*/ 1057667 h 2515690"/>
              <a:gd name="connsiteX101" fmla="*/ 11512818 w 12192000"/>
              <a:gd name="connsiteY101" fmla="*/ 1048926 h 2515690"/>
              <a:gd name="connsiteX102" fmla="*/ 11642481 w 12192000"/>
              <a:gd name="connsiteY102" fmla="*/ 1029355 h 2515690"/>
              <a:gd name="connsiteX103" fmla="*/ 11714551 w 12192000"/>
              <a:gd name="connsiteY103" fmla="*/ 1020966 h 2515690"/>
              <a:gd name="connsiteX104" fmla="*/ 11714551 w 12192000"/>
              <a:gd name="connsiteY104" fmla="*/ 1022389 h 2515690"/>
              <a:gd name="connsiteX105" fmla="*/ 11728519 w 12192000"/>
              <a:gd name="connsiteY105" fmla="*/ 1020975 h 2515690"/>
              <a:gd name="connsiteX106" fmla="*/ 11741691 w 12192000"/>
              <a:gd name="connsiteY106" fmla="*/ 1019651 h 2515690"/>
              <a:gd name="connsiteX107" fmla="*/ 11743999 w 12192000"/>
              <a:gd name="connsiteY107" fmla="*/ 1019424 h 2515690"/>
              <a:gd name="connsiteX108" fmla="*/ 11742709 w 12192000"/>
              <a:gd name="connsiteY108" fmla="*/ 1019549 h 2515690"/>
              <a:gd name="connsiteX109" fmla="*/ 11741691 w 12192000"/>
              <a:gd name="connsiteY109" fmla="*/ 1019651 h 2515690"/>
              <a:gd name="connsiteX110" fmla="*/ 11738529 w 12192000"/>
              <a:gd name="connsiteY110" fmla="*/ 1019963 h 2515690"/>
              <a:gd name="connsiteX111" fmla="*/ 11771791 w 12192000"/>
              <a:gd name="connsiteY111" fmla="*/ 1015977 h 2515690"/>
              <a:gd name="connsiteX112" fmla="*/ 11834157 w 12192000"/>
              <a:gd name="connsiteY112" fmla="*/ 1009499 h 2515690"/>
              <a:gd name="connsiteX113" fmla="*/ 11843354 w 12192000"/>
              <a:gd name="connsiteY113" fmla="*/ 1008273 h 2515690"/>
              <a:gd name="connsiteX114" fmla="*/ 11843354 w 12192000"/>
              <a:gd name="connsiteY114" fmla="*/ 1000151 h 2515690"/>
              <a:gd name="connsiteX115" fmla="*/ 11893955 w 12192000"/>
              <a:gd name="connsiteY115" fmla="*/ 983740 h 2515690"/>
              <a:gd name="connsiteX116" fmla="*/ 11974160 w 12192000"/>
              <a:gd name="connsiteY116" fmla="*/ 920897 h 2515690"/>
              <a:gd name="connsiteX117" fmla="*/ 12143531 w 12192000"/>
              <a:gd name="connsiteY117" fmla="*/ 823664 h 2515690"/>
              <a:gd name="connsiteX118" fmla="*/ 12192000 w 12192000"/>
              <a:gd name="connsiteY118" fmla="*/ 801163 h 2515690"/>
              <a:gd name="connsiteX119" fmla="*/ 12192000 w 12192000"/>
              <a:gd name="connsiteY119" fmla="*/ 2515690 h 2515690"/>
              <a:gd name="connsiteX120" fmla="*/ 0 w 12192000"/>
              <a:gd name="connsiteY120" fmla="*/ 2515690 h 25156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Lst>
            <a:rect l="l" t="t" r="r" b="b"/>
            <a:pathLst>
              <a:path w="12192000" h="2515690">
                <a:moveTo>
                  <a:pt x="0" y="0"/>
                </a:moveTo>
                <a:lnTo>
                  <a:pt x="170442" y="96074"/>
                </a:lnTo>
                <a:cubicBezTo>
                  <a:pt x="323315" y="179510"/>
                  <a:pt x="418777" y="223899"/>
                  <a:pt x="424739" y="224865"/>
                </a:cubicBezTo>
                <a:cubicBezTo>
                  <a:pt x="573781" y="248496"/>
                  <a:pt x="654649" y="314572"/>
                  <a:pt x="748273" y="373939"/>
                </a:cubicBezTo>
                <a:cubicBezTo>
                  <a:pt x="830321" y="425631"/>
                  <a:pt x="917271" y="480784"/>
                  <a:pt x="1037058" y="499994"/>
                </a:cubicBezTo>
                <a:cubicBezTo>
                  <a:pt x="1195925" y="525362"/>
                  <a:pt x="1048105" y="445478"/>
                  <a:pt x="1101312" y="428540"/>
                </a:cubicBezTo>
                <a:cubicBezTo>
                  <a:pt x="1188473" y="458169"/>
                  <a:pt x="1274625" y="505369"/>
                  <a:pt x="1367071" y="516118"/>
                </a:cubicBezTo>
                <a:cubicBezTo>
                  <a:pt x="1701323" y="554463"/>
                  <a:pt x="1964451" y="648887"/>
                  <a:pt x="2189943" y="794533"/>
                </a:cubicBezTo>
                <a:cubicBezTo>
                  <a:pt x="2255082" y="836300"/>
                  <a:pt x="2357481" y="862342"/>
                  <a:pt x="2390329" y="920897"/>
                </a:cubicBezTo>
                <a:cubicBezTo>
                  <a:pt x="2406050" y="949359"/>
                  <a:pt x="2430126" y="969285"/>
                  <a:pt x="2459570" y="983740"/>
                </a:cubicBezTo>
                <a:lnTo>
                  <a:pt x="2503252" y="1000151"/>
                </a:lnTo>
                <a:lnTo>
                  <a:pt x="2503252" y="1008273"/>
                </a:lnTo>
                <a:lnTo>
                  <a:pt x="2511191" y="1009499"/>
                </a:lnTo>
                <a:cubicBezTo>
                  <a:pt x="2529847" y="1011974"/>
                  <a:pt x="2562849" y="1015701"/>
                  <a:pt x="2565029" y="1015977"/>
                </a:cubicBezTo>
                <a:cubicBezTo>
                  <a:pt x="2610845" y="1021778"/>
                  <a:pt x="2601577" y="1020837"/>
                  <a:pt x="2593745" y="1019963"/>
                </a:cubicBezTo>
                <a:lnTo>
                  <a:pt x="2591015" y="1019651"/>
                </a:lnTo>
                <a:lnTo>
                  <a:pt x="2590137" y="1019549"/>
                </a:lnTo>
                <a:cubicBezTo>
                  <a:pt x="2588203" y="1019326"/>
                  <a:pt x="2588125" y="1019321"/>
                  <a:pt x="2589021" y="1019424"/>
                </a:cubicBezTo>
                <a:lnTo>
                  <a:pt x="2591015" y="1019651"/>
                </a:lnTo>
                <a:lnTo>
                  <a:pt x="2602385" y="1020975"/>
                </a:lnTo>
                <a:lnTo>
                  <a:pt x="2614445" y="1022389"/>
                </a:lnTo>
                <a:lnTo>
                  <a:pt x="2614445" y="1020966"/>
                </a:lnTo>
                <a:lnTo>
                  <a:pt x="2676661" y="1029355"/>
                </a:lnTo>
                <a:cubicBezTo>
                  <a:pt x="2715592" y="1034194"/>
                  <a:pt x="2753901" y="1039695"/>
                  <a:pt x="2788597" y="1048926"/>
                </a:cubicBezTo>
                <a:lnTo>
                  <a:pt x="2812742" y="1057667"/>
                </a:lnTo>
                <a:lnTo>
                  <a:pt x="2970201" y="949091"/>
                </a:lnTo>
                <a:cubicBezTo>
                  <a:pt x="3052785" y="982961"/>
                  <a:pt x="2996105" y="1020057"/>
                  <a:pt x="3030610" y="1049340"/>
                </a:cubicBezTo>
                <a:cubicBezTo>
                  <a:pt x="3039005" y="1048442"/>
                  <a:pt x="3049621" y="1048500"/>
                  <a:pt x="3058913" y="1048085"/>
                </a:cubicBezTo>
                <a:lnTo>
                  <a:pt x="3072697" y="1045316"/>
                </a:lnTo>
                <a:lnTo>
                  <a:pt x="3083305" y="1040550"/>
                </a:lnTo>
                <a:lnTo>
                  <a:pt x="3125603" y="1004583"/>
                </a:lnTo>
                <a:cubicBezTo>
                  <a:pt x="3221669" y="925596"/>
                  <a:pt x="3242489" y="937564"/>
                  <a:pt x="3385106" y="1042233"/>
                </a:cubicBezTo>
                <a:cubicBezTo>
                  <a:pt x="3399403" y="1052670"/>
                  <a:pt x="3412529" y="1060209"/>
                  <a:pt x="3424945" y="1065268"/>
                </a:cubicBezTo>
                <a:lnTo>
                  <a:pt x="3436948" y="1068018"/>
                </a:lnTo>
                <a:lnTo>
                  <a:pt x="3466714" y="1063419"/>
                </a:lnTo>
                <a:lnTo>
                  <a:pt x="3550909" y="1044511"/>
                </a:lnTo>
                <a:lnTo>
                  <a:pt x="3555900" y="1041996"/>
                </a:lnTo>
                <a:cubicBezTo>
                  <a:pt x="3573827" y="1033454"/>
                  <a:pt x="3594382" y="1025941"/>
                  <a:pt x="3625978" y="1023459"/>
                </a:cubicBezTo>
                <a:lnTo>
                  <a:pt x="3632465" y="1023522"/>
                </a:lnTo>
                <a:lnTo>
                  <a:pt x="3649063" y="1018726"/>
                </a:lnTo>
                <a:cubicBezTo>
                  <a:pt x="3741849" y="989371"/>
                  <a:pt x="3810578" y="953657"/>
                  <a:pt x="3805954" y="917517"/>
                </a:cubicBezTo>
                <a:cubicBezTo>
                  <a:pt x="4031729" y="953901"/>
                  <a:pt x="4031729" y="953901"/>
                  <a:pt x="4020506" y="816231"/>
                </a:cubicBezTo>
                <a:cubicBezTo>
                  <a:pt x="4171643" y="865324"/>
                  <a:pt x="4206308" y="864422"/>
                  <a:pt x="4233682" y="799511"/>
                </a:cubicBezTo>
                <a:cubicBezTo>
                  <a:pt x="4260226" y="737017"/>
                  <a:pt x="4254728" y="668575"/>
                  <a:pt x="4306552" y="610207"/>
                </a:cubicBezTo>
                <a:cubicBezTo>
                  <a:pt x="4495313" y="657923"/>
                  <a:pt x="4699922" y="667347"/>
                  <a:pt x="4816604" y="773163"/>
                </a:cubicBezTo>
                <a:cubicBezTo>
                  <a:pt x="4834734" y="789836"/>
                  <a:pt x="4890507" y="799946"/>
                  <a:pt x="4916502" y="788104"/>
                </a:cubicBezTo>
                <a:cubicBezTo>
                  <a:pt x="5013526" y="746101"/>
                  <a:pt x="5238129" y="796871"/>
                  <a:pt x="5224415" y="674418"/>
                </a:cubicBezTo>
                <a:cubicBezTo>
                  <a:pt x="5223051" y="659300"/>
                  <a:pt x="5240524" y="644890"/>
                  <a:pt x="5274077" y="655978"/>
                </a:cubicBezTo>
                <a:cubicBezTo>
                  <a:pt x="5388582" y="694066"/>
                  <a:pt x="5367022" y="644784"/>
                  <a:pt x="5371217" y="614372"/>
                </a:cubicBezTo>
                <a:cubicBezTo>
                  <a:pt x="5375856" y="577567"/>
                  <a:pt x="5319010" y="537578"/>
                  <a:pt x="5364523" y="502501"/>
                </a:cubicBezTo>
                <a:cubicBezTo>
                  <a:pt x="5425408" y="508891"/>
                  <a:pt x="5433299" y="538191"/>
                  <a:pt x="5457871" y="558285"/>
                </a:cubicBezTo>
                <a:cubicBezTo>
                  <a:pt x="5530352" y="617005"/>
                  <a:pt x="5609566" y="664386"/>
                  <a:pt x="5750580" y="663503"/>
                </a:cubicBezTo>
                <a:cubicBezTo>
                  <a:pt x="5864519" y="662926"/>
                  <a:pt x="5966527" y="666650"/>
                  <a:pt x="5976618" y="582652"/>
                </a:cubicBezTo>
                <a:cubicBezTo>
                  <a:pt x="5978145" y="569455"/>
                  <a:pt x="5990792" y="562346"/>
                  <a:pt x="6009346" y="559470"/>
                </a:cubicBezTo>
                <a:cubicBezTo>
                  <a:pt x="6030639" y="568485"/>
                  <a:pt x="6052592" y="577083"/>
                  <a:pt x="6069735" y="587803"/>
                </a:cubicBezTo>
                <a:cubicBezTo>
                  <a:pt x="6126182" y="623812"/>
                  <a:pt x="6196945" y="634730"/>
                  <a:pt x="6270319" y="643982"/>
                </a:cubicBezTo>
                <a:cubicBezTo>
                  <a:pt x="6317101" y="649940"/>
                  <a:pt x="6363466" y="657107"/>
                  <a:pt x="6406781" y="672327"/>
                </a:cubicBezTo>
                <a:cubicBezTo>
                  <a:pt x="6433586" y="681598"/>
                  <a:pt x="6454928" y="693402"/>
                  <a:pt x="6469508" y="708574"/>
                </a:cubicBezTo>
                <a:cubicBezTo>
                  <a:pt x="6482729" y="721786"/>
                  <a:pt x="6496225" y="725422"/>
                  <a:pt x="6515869" y="715738"/>
                </a:cubicBezTo>
                <a:cubicBezTo>
                  <a:pt x="6572200" y="688353"/>
                  <a:pt x="6639257" y="676241"/>
                  <a:pt x="6725938" y="691128"/>
                </a:cubicBezTo>
                <a:cubicBezTo>
                  <a:pt x="6752109" y="695629"/>
                  <a:pt x="6772625" y="691505"/>
                  <a:pt x="6778240" y="678998"/>
                </a:cubicBezTo>
                <a:cubicBezTo>
                  <a:pt x="6784286" y="665981"/>
                  <a:pt x="6794269" y="655280"/>
                  <a:pt x="6806944" y="646178"/>
                </a:cubicBezTo>
                <a:lnTo>
                  <a:pt x="6830632" y="633915"/>
                </a:lnTo>
                <a:lnTo>
                  <a:pt x="6858072" y="646178"/>
                </a:lnTo>
                <a:cubicBezTo>
                  <a:pt x="6872754" y="655280"/>
                  <a:pt x="6884317" y="665981"/>
                  <a:pt x="6891322" y="678998"/>
                </a:cubicBezTo>
                <a:cubicBezTo>
                  <a:pt x="6897826" y="691505"/>
                  <a:pt x="6921592" y="695629"/>
                  <a:pt x="6951905" y="691128"/>
                </a:cubicBezTo>
                <a:cubicBezTo>
                  <a:pt x="7052317" y="676241"/>
                  <a:pt x="7129994" y="688353"/>
                  <a:pt x="7195246" y="715738"/>
                </a:cubicBezTo>
                <a:cubicBezTo>
                  <a:pt x="7217999" y="725422"/>
                  <a:pt x="7233634" y="721786"/>
                  <a:pt x="7248949" y="708574"/>
                </a:cubicBezTo>
                <a:cubicBezTo>
                  <a:pt x="7265838" y="693402"/>
                  <a:pt x="7290560" y="681598"/>
                  <a:pt x="7321609" y="672327"/>
                </a:cubicBezTo>
                <a:cubicBezTo>
                  <a:pt x="7371785" y="657107"/>
                  <a:pt x="7425493" y="649940"/>
                  <a:pt x="7479684" y="643982"/>
                </a:cubicBezTo>
                <a:cubicBezTo>
                  <a:pt x="7564679" y="634730"/>
                  <a:pt x="7646649" y="623812"/>
                  <a:pt x="7712035" y="587803"/>
                </a:cubicBezTo>
                <a:cubicBezTo>
                  <a:pt x="7731892" y="577083"/>
                  <a:pt x="7757322" y="568485"/>
                  <a:pt x="7781987" y="559470"/>
                </a:cubicBezTo>
                <a:cubicBezTo>
                  <a:pt x="7803481" y="562346"/>
                  <a:pt x="7818130" y="569455"/>
                  <a:pt x="7819900" y="582652"/>
                </a:cubicBezTo>
                <a:cubicBezTo>
                  <a:pt x="7831588" y="666650"/>
                  <a:pt x="7949751" y="662926"/>
                  <a:pt x="8081736" y="663503"/>
                </a:cubicBezTo>
                <a:cubicBezTo>
                  <a:pt x="8245081" y="664386"/>
                  <a:pt x="8336842" y="617005"/>
                  <a:pt x="8420801" y="558285"/>
                </a:cubicBezTo>
                <a:cubicBezTo>
                  <a:pt x="8449265" y="538191"/>
                  <a:pt x="8458404" y="508890"/>
                  <a:pt x="8528933" y="502501"/>
                </a:cubicBezTo>
                <a:cubicBezTo>
                  <a:pt x="8581654" y="537578"/>
                  <a:pt x="8515805" y="577567"/>
                  <a:pt x="8521178" y="614372"/>
                </a:cubicBezTo>
                <a:cubicBezTo>
                  <a:pt x="8526038" y="644784"/>
                  <a:pt x="8501063" y="694066"/>
                  <a:pt x="8633702" y="655978"/>
                </a:cubicBezTo>
                <a:cubicBezTo>
                  <a:pt x="8672570" y="644890"/>
                  <a:pt x="8692811" y="659300"/>
                  <a:pt x="8691231" y="674418"/>
                </a:cubicBezTo>
                <a:cubicBezTo>
                  <a:pt x="8675345" y="796871"/>
                  <a:pt x="8935518" y="746101"/>
                  <a:pt x="9047908" y="788104"/>
                </a:cubicBezTo>
                <a:cubicBezTo>
                  <a:pt x="9078021" y="799946"/>
                  <a:pt x="9142627" y="789836"/>
                  <a:pt x="9163628" y="773163"/>
                </a:cubicBezTo>
                <a:cubicBezTo>
                  <a:pt x="9298789" y="667347"/>
                  <a:pt x="9535801" y="657923"/>
                  <a:pt x="9754459" y="610207"/>
                </a:cubicBezTo>
                <a:cubicBezTo>
                  <a:pt x="9814490" y="668575"/>
                  <a:pt x="9808123" y="737017"/>
                  <a:pt x="9838868" y="799511"/>
                </a:cubicBezTo>
                <a:cubicBezTo>
                  <a:pt x="9870579" y="864422"/>
                  <a:pt x="9910733" y="865324"/>
                  <a:pt x="10085808" y="816231"/>
                </a:cubicBezTo>
                <a:cubicBezTo>
                  <a:pt x="10072804" y="953901"/>
                  <a:pt x="10072804" y="953901"/>
                  <a:pt x="10334338" y="917517"/>
                </a:cubicBezTo>
                <a:cubicBezTo>
                  <a:pt x="10328982" y="953657"/>
                  <a:pt x="10408594" y="989371"/>
                  <a:pt x="10516076" y="1018726"/>
                </a:cubicBezTo>
                <a:lnTo>
                  <a:pt x="10535302" y="1023522"/>
                </a:lnTo>
                <a:lnTo>
                  <a:pt x="10542819" y="1023458"/>
                </a:lnTo>
                <a:cubicBezTo>
                  <a:pt x="10579419" y="1025941"/>
                  <a:pt x="10603227" y="1033454"/>
                  <a:pt x="10623994" y="1041996"/>
                </a:cubicBezTo>
                <a:lnTo>
                  <a:pt x="10629774" y="1044511"/>
                </a:lnTo>
                <a:lnTo>
                  <a:pt x="10727305" y="1063419"/>
                </a:lnTo>
                <a:lnTo>
                  <a:pt x="10761785" y="1068017"/>
                </a:lnTo>
                <a:lnTo>
                  <a:pt x="10775688" y="1065268"/>
                </a:lnTo>
                <a:cubicBezTo>
                  <a:pt x="10790070" y="1060209"/>
                  <a:pt x="10805275" y="1052670"/>
                  <a:pt x="10821837" y="1042232"/>
                </a:cubicBezTo>
                <a:cubicBezTo>
                  <a:pt x="10987041" y="937564"/>
                  <a:pt x="11011156" y="925596"/>
                  <a:pt x="11122438" y="1004583"/>
                </a:cubicBezTo>
                <a:lnTo>
                  <a:pt x="11171433" y="1040550"/>
                </a:lnTo>
                <a:lnTo>
                  <a:pt x="11183724" y="1045316"/>
                </a:lnTo>
                <a:lnTo>
                  <a:pt x="11199690" y="1048085"/>
                </a:lnTo>
                <a:cubicBezTo>
                  <a:pt x="11210452" y="1048499"/>
                  <a:pt x="11222752" y="1048442"/>
                  <a:pt x="11232475" y="1049340"/>
                </a:cubicBezTo>
                <a:cubicBezTo>
                  <a:pt x="11272445" y="1020057"/>
                  <a:pt x="11206789" y="982961"/>
                  <a:pt x="11302451" y="949091"/>
                </a:cubicBezTo>
                <a:lnTo>
                  <a:pt x="11484849" y="1057667"/>
                </a:lnTo>
                <a:lnTo>
                  <a:pt x="11512818" y="1048926"/>
                </a:lnTo>
                <a:cubicBezTo>
                  <a:pt x="11553007" y="1039695"/>
                  <a:pt x="11597385" y="1034194"/>
                  <a:pt x="11642481" y="1029355"/>
                </a:cubicBezTo>
                <a:lnTo>
                  <a:pt x="11714551" y="1020966"/>
                </a:lnTo>
                <a:lnTo>
                  <a:pt x="11714551" y="1022389"/>
                </a:lnTo>
                <a:lnTo>
                  <a:pt x="11728519" y="1020975"/>
                </a:lnTo>
                <a:lnTo>
                  <a:pt x="11741691" y="1019651"/>
                </a:lnTo>
                <a:lnTo>
                  <a:pt x="11743999" y="1019424"/>
                </a:lnTo>
                <a:cubicBezTo>
                  <a:pt x="11745037" y="1019320"/>
                  <a:pt x="11744948" y="1019326"/>
                  <a:pt x="11742709" y="1019549"/>
                </a:cubicBezTo>
                <a:lnTo>
                  <a:pt x="11741691" y="1019651"/>
                </a:lnTo>
                <a:lnTo>
                  <a:pt x="11738529" y="1019963"/>
                </a:lnTo>
                <a:cubicBezTo>
                  <a:pt x="11729455" y="1020837"/>
                  <a:pt x="11718720" y="1021778"/>
                  <a:pt x="11771791" y="1015977"/>
                </a:cubicBezTo>
                <a:cubicBezTo>
                  <a:pt x="11774317" y="1015701"/>
                  <a:pt x="11812546" y="1011974"/>
                  <a:pt x="11834157" y="1009499"/>
                </a:cubicBezTo>
                <a:lnTo>
                  <a:pt x="11843354" y="1008273"/>
                </a:lnTo>
                <a:lnTo>
                  <a:pt x="11843354" y="1000151"/>
                </a:lnTo>
                <a:lnTo>
                  <a:pt x="11893955" y="983740"/>
                </a:lnTo>
                <a:cubicBezTo>
                  <a:pt x="11928061" y="969285"/>
                  <a:pt x="11955951" y="949359"/>
                  <a:pt x="11974160" y="920897"/>
                </a:cubicBezTo>
                <a:cubicBezTo>
                  <a:pt x="12002698" y="876981"/>
                  <a:pt x="12076554" y="851353"/>
                  <a:pt x="12143531" y="823664"/>
                </a:cubicBezTo>
                <a:lnTo>
                  <a:pt x="12192000" y="801163"/>
                </a:lnTo>
                <a:lnTo>
                  <a:pt x="12192000" y="2515690"/>
                </a:lnTo>
                <a:lnTo>
                  <a:pt x="0" y="2515690"/>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 name="Title 1">
            <a:extLst>
              <a:ext uri="{FF2B5EF4-FFF2-40B4-BE49-F238E27FC236}">
                <a16:creationId xmlns:a16="http://schemas.microsoft.com/office/drawing/2014/main" id="{49028819-73E3-A4C2-6442-24554FC0CA45}"/>
              </a:ext>
            </a:extLst>
          </p:cNvPr>
          <p:cNvSpPr>
            <a:spLocks noGrp="1"/>
          </p:cNvSpPr>
          <p:nvPr>
            <p:ph type="title"/>
          </p:nvPr>
        </p:nvSpPr>
        <p:spPr>
          <a:xfrm>
            <a:off x="838200" y="365125"/>
            <a:ext cx="10515600" cy="930275"/>
          </a:xfrm>
        </p:spPr>
        <p:txBody>
          <a:bodyPr>
            <a:normAutofit/>
          </a:bodyPr>
          <a:lstStyle/>
          <a:p>
            <a:r>
              <a:rPr lang="en-US" b="1" dirty="0">
                <a:solidFill>
                  <a:schemeClr val="bg1"/>
                </a:solidFill>
              </a:rPr>
              <a:t>Learning Objectives</a:t>
            </a:r>
          </a:p>
        </p:txBody>
      </p:sp>
      <p:sp>
        <p:nvSpPr>
          <p:cNvPr id="6" name="TextBox 5">
            <a:extLst>
              <a:ext uri="{FF2B5EF4-FFF2-40B4-BE49-F238E27FC236}">
                <a16:creationId xmlns:a16="http://schemas.microsoft.com/office/drawing/2014/main" id="{1D99B918-C665-0A2D-9FF9-93CB98183979}"/>
              </a:ext>
            </a:extLst>
          </p:cNvPr>
          <p:cNvSpPr txBox="1"/>
          <p:nvPr/>
        </p:nvSpPr>
        <p:spPr>
          <a:xfrm>
            <a:off x="838200" y="2103261"/>
            <a:ext cx="8436439" cy="461665"/>
          </a:xfrm>
          <a:prstGeom prst="rect">
            <a:avLst/>
          </a:prstGeom>
          <a:noFill/>
        </p:spPr>
        <p:txBody>
          <a:bodyPr wrap="square">
            <a:spAutoFit/>
          </a:bodyPr>
          <a:lstStyle/>
          <a:p>
            <a:r>
              <a:rPr lang="en-US" sz="2400" b="1" dirty="0"/>
              <a:t>By the end of this session, students will be able to</a:t>
            </a:r>
          </a:p>
        </p:txBody>
      </p:sp>
      <p:graphicFrame>
        <p:nvGraphicFramePr>
          <p:cNvPr id="17" name="Content Placeholder 3">
            <a:extLst>
              <a:ext uri="{FF2B5EF4-FFF2-40B4-BE49-F238E27FC236}">
                <a16:creationId xmlns:a16="http://schemas.microsoft.com/office/drawing/2014/main" id="{4D9D2AFC-1026-B3BD-38EA-84AA0897316F}"/>
              </a:ext>
            </a:extLst>
          </p:cNvPr>
          <p:cNvGraphicFramePr>
            <a:graphicFrameLocks noGrp="1"/>
          </p:cNvGraphicFramePr>
          <p:nvPr>
            <p:ph idx="1"/>
            <p:extLst>
              <p:ext uri="{D42A27DB-BD31-4B8C-83A1-F6EECF244321}">
                <p14:modId xmlns:p14="http://schemas.microsoft.com/office/powerpoint/2010/main" val="1483130024"/>
              </p:ext>
            </p:extLst>
          </p:nvPr>
        </p:nvGraphicFramePr>
        <p:xfrm>
          <a:off x="838200" y="2011680"/>
          <a:ext cx="10515600" cy="416052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39413422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680F96-9636-6939-A2FA-5739C8165F00}"/>
              </a:ext>
            </a:extLst>
          </p:cNvPr>
          <p:cNvSpPr>
            <a:spLocks noGrp="1"/>
          </p:cNvSpPr>
          <p:nvPr>
            <p:ph type="title"/>
          </p:nvPr>
        </p:nvSpPr>
        <p:spPr/>
        <p:txBody>
          <a:bodyPr/>
          <a:lstStyle/>
          <a:p>
            <a:r>
              <a:rPr lang="en-US" b="1" dirty="0"/>
              <a:t>ART 2</a:t>
            </a:r>
            <a:endParaRPr lang="en-US" dirty="0"/>
          </a:p>
        </p:txBody>
      </p:sp>
      <p:pic>
        <p:nvPicPr>
          <p:cNvPr id="1026" name="Picture 2" descr="The Sick Child, 1885 by Edvard Munch">
            <a:extLst>
              <a:ext uri="{FF2B5EF4-FFF2-40B4-BE49-F238E27FC236}">
                <a16:creationId xmlns:a16="http://schemas.microsoft.com/office/drawing/2014/main" id="{755C7C33-64E8-B7F7-0F1F-86A6CDC7E613}"/>
              </a:ext>
            </a:extLst>
          </p:cNvPr>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5280720" y="0"/>
            <a:ext cx="6640124" cy="6872529"/>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C38D7A5D-C060-EF46-5A43-4E58DFA162C8}"/>
              </a:ext>
            </a:extLst>
          </p:cNvPr>
          <p:cNvSpPr txBox="1"/>
          <p:nvPr/>
        </p:nvSpPr>
        <p:spPr>
          <a:xfrm>
            <a:off x="271156" y="2055813"/>
            <a:ext cx="2258290" cy="1815882"/>
          </a:xfrm>
          <a:prstGeom prst="rect">
            <a:avLst/>
          </a:prstGeom>
          <a:noFill/>
        </p:spPr>
        <p:txBody>
          <a:bodyPr wrap="square">
            <a:spAutoFit/>
          </a:bodyPr>
          <a:lstStyle/>
          <a:p>
            <a:pPr algn="ctr"/>
            <a:r>
              <a:rPr lang="en-US" sz="2800" b="1" i="0" dirty="0">
                <a:solidFill>
                  <a:schemeClr val="accent6">
                    <a:lumMod val="50000"/>
                  </a:schemeClr>
                </a:solidFill>
                <a:effectLst/>
              </a:rPr>
              <a:t>The Sick Child, 1885 by Edvard Munch</a:t>
            </a:r>
          </a:p>
        </p:txBody>
      </p:sp>
    </p:spTree>
    <p:extLst>
      <p:ext uri="{BB962C8B-B14F-4D97-AF65-F5344CB8AC3E}">
        <p14:creationId xmlns:p14="http://schemas.microsoft.com/office/powerpoint/2010/main" val="131728513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C7C7CA-4714-CB1E-13BB-FE240BB6766A}"/>
              </a:ext>
            </a:extLst>
          </p:cNvPr>
          <p:cNvSpPr>
            <a:spLocks noGrp="1"/>
          </p:cNvSpPr>
          <p:nvPr>
            <p:ph type="title"/>
          </p:nvPr>
        </p:nvSpPr>
        <p:spPr/>
        <p:txBody>
          <a:bodyPr/>
          <a:lstStyle/>
          <a:p>
            <a:r>
              <a:rPr lang="en-US" b="1" dirty="0"/>
              <a:t>ART 3</a:t>
            </a:r>
          </a:p>
        </p:txBody>
      </p:sp>
      <p:sp>
        <p:nvSpPr>
          <p:cNvPr id="3" name="Content Placeholder 2">
            <a:extLst>
              <a:ext uri="{FF2B5EF4-FFF2-40B4-BE49-F238E27FC236}">
                <a16:creationId xmlns:a16="http://schemas.microsoft.com/office/drawing/2014/main" id="{FC85F59F-B1EC-F46A-27A6-833DAA12B223}"/>
              </a:ext>
            </a:extLst>
          </p:cNvPr>
          <p:cNvSpPr>
            <a:spLocks noGrp="1"/>
          </p:cNvSpPr>
          <p:nvPr>
            <p:ph idx="1"/>
          </p:nvPr>
        </p:nvSpPr>
        <p:spPr>
          <a:xfrm>
            <a:off x="838200" y="2011680"/>
            <a:ext cx="2656114" cy="4160520"/>
          </a:xfrm>
        </p:spPr>
        <p:txBody>
          <a:bodyPr>
            <a:normAutofit/>
          </a:bodyPr>
          <a:lstStyle/>
          <a:p>
            <a:pPr marL="0" indent="0">
              <a:buNone/>
            </a:pPr>
            <a:r>
              <a:rPr lang="en-US" b="1" i="0" dirty="0">
                <a:solidFill>
                  <a:schemeClr val="accent6">
                    <a:lumMod val="50000"/>
                  </a:schemeClr>
                </a:solidFill>
                <a:effectLst/>
              </a:rPr>
              <a:t>La </a:t>
            </a:r>
            <a:r>
              <a:rPr lang="en-US" b="1" i="0" dirty="0" err="1">
                <a:solidFill>
                  <a:schemeClr val="accent6">
                    <a:lumMod val="50000"/>
                  </a:schemeClr>
                </a:solidFill>
                <a:effectLst/>
              </a:rPr>
              <a:t>Miseria</a:t>
            </a:r>
            <a:r>
              <a:rPr lang="en-US" b="1" i="0" dirty="0">
                <a:solidFill>
                  <a:schemeClr val="accent6">
                    <a:lumMod val="50000"/>
                  </a:schemeClr>
                </a:solidFill>
                <a:effectLst/>
              </a:rPr>
              <a:t> (1886). Cristobal Rojas</a:t>
            </a:r>
            <a:endParaRPr lang="en-US" b="1" dirty="0">
              <a:solidFill>
                <a:schemeClr val="accent6">
                  <a:lumMod val="50000"/>
                </a:schemeClr>
              </a:solidFill>
            </a:endParaRPr>
          </a:p>
        </p:txBody>
      </p:sp>
      <p:pic>
        <p:nvPicPr>
          <p:cNvPr id="2050" name="Picture 2">
            <a:extLst>
              <a:ext uri="{FF2B5EF4-FFF2-40B4-BE49-F238E27FC236}">
                <a16:creationId xmlns:a16="http://schemas.microsoft.com/office/drawing/2014/main" id="{6CC8F687-CCE7-5E70-6516-1851A6A3712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756533" y="0"/>
            <a:ext cx="8423275"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47675461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C061DF-E60D-7DAC-11E1-6F0E452CFBEA}"/>
              </a:ext>
            </a:extLst>
          </p:cNvPr>
          <p:cNvSpPr>
            <a:spLocks noGrp="1"/>
          </p:cNvSpPr>
          <p:nvPr>
            <p:ph type="title"/>
          </p:nvPr>
        </p:nvSpPr>
        <p:spPr/>
        <p:txBody>
          <a:bodyPr/>
          <a:lstStyle/>
          <a:p>
            <a:r>
              <a:rPr lang="en-US" b="1" dirty="0"/>
              <a:t>ART 4</a:t>
            </a:r>
          </a:p>
        </p:txBody>
      </p:sp>
      <p:sp>
        <p:nvSpPr>
          <p:cNvPr id="3" name="Content Placeholder 2">
            <a:extLst>
              <a:ext uri="{FF2B5EF4-FFF2-40B4-BE49-F238E27FC236}">
                <a16:creationId xmlns:a16="http://schemas.microsoft.com/office/drawing/2014/main" id="{6FA5AC6C-5AB7-54DF-F132-B1F98B9D2010}"/>
              </a:ext>
            </a:extLst>
          </p:cNvPr>
          <p:cNvSpPr>
            <a:spLocks noGrp="1"/>
          </p:cNvSpPr>
          <p:nvPr>
            <p:ph idx="1"/>
          </p:nvPr>
        </p:nvSpPr>
        <p:spPr>
          <a:xfrm>
            <a:off x="838200" y="2011680"/>
            <a:ext cx="3554186" cy="4160520"/>
          </a:xfrm>
        </p:spPr>
        <p:txBody>
          <a:bodyPr>
            <a:normAutofit/>
          </a:bodyPr>
          <a:lstStyle/>
          <a:p>
            <a:pPr marL="0" indent="0">
              <a:buNone/>
            </a:pPr>
            <a:r>
              <a:rPr lang="en-US" b="1" i="0" dirty="0">
                <a:solidFill>
                  <a:schemeClr val="accent6">
                    <a:lumMod val="50000"/>
                  </a:schemeClr>
                </a:solidFill>
                <a:effectLst/>
                <a:latin typeface="Inter"/>
              </a:rPr>
              <a:t>The Yellow Jaundice, </a:t>
            </a:r>
            <a:r>
              <a:rPr lang="en-US" b="1" i="0" dirty="0" err="1">
                <a:solidFill>
                  <a:schemeClr val="accent6">
                    <a:lumMod val="50000"/>
                  </a:schemeClr>
                </a:solidFill>
                <a:effectLst/>
                <a:latin typeface="Inter"/>
              </a:rPr>
              <a:t>Coloured</a:t>
            </a:r>
            <a:r>
              <a:rPr lang="en-US" b="1" i="0" dirty="0">
                <a:solidFill>
                  <a:schemeClr val="accent6">
                    <a:lumMod val="50000"/>
                  </a:schemeClr>
                </a:solidFill>
                <a:effectLst/>
                <a:latin typeface="Inter"/>
              </a:rPr>
              <a:t> lithograph, 1835.</a:t>
            </a:r>
            <a:endParaRPr lang="en-US" dirty="0">
              <a:solidFill>
                <a:schemeClr val="accent6">
                  <a:lumMod val="50000"/>
                </a:schemeClr>
              </a:solidFill>
            </a:endParaRPr>
          </a:p>
        </p:txBody>
      </p:sp>
      <p:pic>
        <p:nvPicPr>
          <p:cNvPr id="3076" name="Picture 4" descr="A man surrounded by a feast while professing to have no appetite, his doctor observing how yellow he and his surroundings appear; suggesting the man's jaundiced view of life. Coloured lithograph, 1835.">
            <a:extLst>
              <a:ext uri="{FF2B5EF4-FFF2-40B4-BE49-F238E27FC236}">
                <a16:creationId xmlns:a16="http://schemas.microsoft.com/office/drawing/2014/main" id="{849F1F18-6FE3-03B2-1929-C9C04B4D166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392386" y="0"/>
            <a:ext cx="7603671" cy="693382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34104388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E26FA5-04A9-2459-C7B4-496EB504FB04}"/>
              </a:ext>
            </a:extLst>
          </p:cNvPr>
          <p:cNvSpPr>
            <a:spLocks noGrp="1"/>
          </p:cNvSpPr>
          <p:nvPr>
            <p:ph type="title"/>
          </p:nvPr>
        </p:nvSpPr>
        <p:spPr/>
        <p:txBody>
          <a:bodyPr/>
          <a:lstStyle/>
          <a:p>
            <a:r>
              <a:rPr lang="en-US" b="1" dirty="0"/>
              <a:t>ART 5</a:t>
            </a:r>
          </a:p>
        </p:txBody>
      </p:sp>
      <p:sp>
        <p:nvSpPr>
          <p:cNvPr id="3" name="Content Placeholder 2">
            <a:extLst>
              <a:ext uri="{FF2B5EF4-FFF2-40B4-BE49-F238E27FC236}">
                <a16:creationId xmlns:a16="http://schemas.microsoft.com/office/drawing/2014/main" id="{FF1D28DD-3A1E-8BA0-4A6B-AFEF913319BD}"/>
              </a:ext>
            </a:extLst>
          </p:cNvPr>
          <p:cNvSpPr>
            <a:spLocks noGrp="1"/>
          </p:cNvSpPr>
          <p:nvPr>
            <p:ph idx="1"/>
          </p:nvPr>
        </p:nvSpPr>
        <p:spPr>
          <a:xfrm>
            <a:off x="838200" y="2011680"/>
            <a:ext cx="2705100" cy="4160520"/>
          </a:xfrm>
        </p:spPr>
        <p:txBody>
          <a:bodyPr/>
          <a:lstStyle/>
          <a:p>
            <a:pPr marL="0" indent="0">
              <a:buNone/>
            </a:pPr>
            <a:r>
              <a:rPr lang="en-US" b="1" dirty="0">
                <a:solidFill>
                  <a:schemeClr val="accent6">
                    <a:lumMod val="50000"/>
                  </a:schemeClr>
                </a:solidFill>
              </a:rPr>
              <a:t>Pavel </a:t>
            </a:r>
            <a:r>
              <a:rPr lang="en-US" b="1" dirty="0" err="1">
                <a:solidFill>
                  <a:schemeClr val="accent6">
                    <a:lumMod val="50000"/>
                  </a:schemeClr>
                </a:solidFill>
              </a:rPr>
              <a:t>Fedotov’s</a:t>
            </a:r>
            <a:r>
              <a:rPr lang="en-US" b="1" dirty="0">
                <a:solidFill>
                  <a:schemeClr val="accent6">
                    <a:lumMod val="50000"/>
                  </a:schemeClr>
                </a:solidFill>
              </a:rPr>
              <a:t>, mid 19</a:t>
            </a:r>
            <a:r>
              <a:rPr lang="en-US" b="1" baseline="30000" dirty="0">
                <a:solidFill>
                  <a:schemeClr val="accent6">
                    <a:lumMod val="50000"/>
                  </a:schemeClr>
                </a:solidFill>
              </a:rPr>
              <a:t>th</a:t>
            </a:r>
            <a:r>
              <a:rPr lang="en-US" b="1" dirty="0">
                <a:solidFill>
                  <a:schemeClr val="accent6">
                    <a:lumMod val="50000"/>
                  </a:schemeClr>
                </a:solidFill>
              </a:rPr>
              <a:t> century</a:t>
            </a:r>
          </a:p>
        </p:txBody>
      </p:sp>
      <p:pic>
        <p:nvPicPr>
          <p:cNvPr id="4100" name="Picture 4">
            <a:extLst>
              <a:ext uri="{FF2B5EF4-FFF2-40B4-BE49-F238E27FC236}">
                <a16:creationId xmlns:a16="http://schemas.microsoft.com/office/drawing/2014/main" id="{F3F9B206-7878-E623-4DC7-7CB2C7F3E5C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543300" y="0"/>
            <a:ext cx="8482013"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64044869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01F7E1-A524-34C0-17A7-E734A1F17C7A}"/>
              </a:ext>
            </a:extLst>
          </p:cNvPr>
          <p:cNvSpPr>
            <a:spLocks noGrp="1"/>
          </p:cNvSpPr>
          <p:nvPr>
            <p:ph type="title"/>
          </p:nvPr>
        </p:nvSpPr>
        <p:spPr/>
        <p:txBody>
          <a:bodyPr/>
          <a:lstStyle/>
          <a:p>
            <a:r>
              <a:rPr lang="en-US" b="1" dirty="0"/>
              <a:t>ART 6</a:t>
            </a:r>
          </a:p>
        </p:txBody>
      </p:sp>
      <p:sp>
        <p:nvSpPr>
          <p:cNvPr id="3" name="Content Placeholder 2">
            <a:extLst>
              <a:ext uri="{FF2B5EF4-FFF2-40B4-BE49-F238E27FC236}">
                <a16:creationId xmlns:a16="http://schemas.microsoft.com/office/drawing/2014/main" id="{E45D10EC-51F1-9CE2-D620-51EAE9AA753E}"/>
              </a:ext>
            </a:extLst>
          </p:cNvPr>
          <p:cNvSpPr>
            <a:spLocks noGrp="1"/>
          </p:cNvSpPr>
          <p:nvPr>
            <p:ph idx="1"/>
          </p:nvPr>
        </p:nvSpPr>
        <p:spPr>
          <a:xfrm>
            <a:off x="838200" y="2011680"/>
            <a:ext cx="4060371" cy="4160520"/>
          </a:xfrm>
        </p:spPr>
        <p:txBody>
          <a:bodyPr/>
          <a:lstStyle/>
          <a:p>
            <a:pPr marL="0" indent="0">
              <a:buNone/>
            </a:pPr>
            <a:r>
              <a:rPr lang="en-US" b="1" i="1" dirty="0">
                <a:solidFill>
                  <a:srgbClr val="7030A0"/>
                </a:solidFill>
                <a:effectLst/>
              </a:rPr>
              <a:t>Inheritance</a:t>
            </a:r>
            <a:r>
              <a:rPr lang="en-US" b="1" i="0" dirty="0">
                <a:solidFill>
                  <a:srgbClr val="7030A0"/>
                </a:solidFill>
                <a:effectLst/>
              </a:rPr>
              <a:t> (Munch), 1877-1899</a:t>
            </a:r>
          </a:p>
        </p:txBody>
      </p:sp>
      <p:sp>
        <p:nvSpPr>
          <p:cNvPr id="4" name="Rectangle 2">
            <a:extLst>
              <a:ext uri="{FF2B5EF4-FFF2-40B4-BE49-F238E27FC236}">
                <a16:creationId xmlns:a16="http://schemas.microsoft.com/office/drawing/2014/main" id="{B4C9B074-B164-65DC-00D8-24FB07222C2B}"/>
              </a:ext>
            </a:extLst>
          </p:cNvPr>
          <p:cNvSpPr>
            <a:spLocks noChangeArrowheads="1"/>
          </p:cNvSpPr>
          <p:nvPr/>
        </p:nvSpPr>
        <p:spPr bwMode="auto">
          <a:xfrm>
            <a:off x="6390141" y="33717"/>
            <a:ext cx="13989147" cy="457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en-US"/>
          </a:p>
        </p:txBody>
      </p:sp>
      <p:pic>
        <p:nvPicPr>
          <p:cNvPr id="2049" name="Picture 3" descr="A painting of a person holding a baby&#10;&#10;Description automatically generated">
            <a:extLst>
              <a:ext uri="{FF2B5EF4-FFF2-40B4-BE49-F238E27FC236}">
                <a16:creationId xmlns:a16="http://schemas.microsoft.com/office/drawing/2014/main" id="{907711DF-0C0B-5395-1A31-62661DA34DEC}"/>
              </a:ext>
            </a:extLst>
          </p:cNvPr>
          <p:cNvPicPr>
            <a:picLocks noChangeAspect="1" noChangeArrowheads="1"/>
          </p:cNvPicPr>
          <p:nvPr/>
        </p:nvPicPr>
        <p:blipFill>
          <a:blip r:embed="rId3" r:link="rId4">
            <a:extLst>
              <a:ext uri="{28A0092B-C50C-407E-A947-70E740481C1C}">
                <a14:useLocalDpi xmlns:a14="http://schemas.microsoft.com/office/drawing/2010/main" val="0"/>
              </a:ext>
            </a:extLst>
          </a:blip>
          <a:srcRect/>
          <a:stretch>
            <a:fillRect/>
          </a:stretch>
        </p:blipFill>
        <p:spPr bwMode="auto">
          <a:xfrm>
            <a:off x="6390141" y="33717"/>
            <a:ext cx="5624803" cy="679056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03075338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4C9982-48CD-8EE2-04C1-EAA510F4F2C2}"/>
              </a:ext>
            </a:extLst>
          </p:cNvPr>
          <p:cNvSpPr>
            <a:spLocks noGrp="1"/>
          </p:cNvSpPr>
          <p:nvPr>
            <p:ph type="title"/>
          </p:nvPr>
        </p:nvSpPr>
        <p:spPr/>
        <p:txBody>
          <a:bodyPr/>
          <a:lstStyle/>
          <a:p>
            <a:r>
              <a:rPr lang="en-US" b="1" dirty="0"/>
              <a:t>ART 7</a:t>
            </a:r>
          </a:p>
        </p:txBody>
      </p:sp>
      <p:sp>
        <p:nvSpPr>
          <p:cNvPr id="3" name="Content Placeholder 2">
            <a:extLst>
              <a:ext uri="{FF2B5EF4-FFF2-40B4-BE49-F238E27FC236}">
                <a16:creationId xmlns:a16="http://schemas.microsoft.com/office/drawing/2014/main" id="{8D0AC75B-2BC8-0BCB-693E-AAE3290E6199}"/>
              </a:ext>
            </a:extLst>
          </p:cNvPr>
          <p:cNvSpPr>
            <a:spLocks noGrp="1"/>
          </p:cNvSpPr>
          <p:nvPr>
            <p:ph idx="1"/>
          </p:nvPr>
        </p:nvSpPr>
        <p:spPr>
          <a:xfrm>
            <a:off x="397328" y="2055813"/>
            <a:ext cx="2803072" cy="4160520"/>
          </a:xfrm>
        </p:spPr>
        <p:txBody>
          <a:bodyPr>
            <a:normAutofit/>
          </a:bodyPr>
          <a:lstStyle/>
          <a:p>
            <a:pPr marL="0" indent="0">
              <a:buNone/>
            </a:pPr>
            <a:r>
              <a:rPr lang="en-US" b="1" i="0" dirty="0">
                <a:solidFill>
                  <a:srgbClr val="6B6B6B"/>
                </a:solidFill>
                <a:effectLst/>
              </a:rPr>
              <a:t>Death and the Maiden (Schiele) 1915</a:t>
            </a:r>
            <a:endParaRPr lang="en-US" b="1" dirty="0"/>
          </a:p>
        </p:txBody>
      </p:sp>
      <p:pic>
        <p:nvPicPr>
          <p:cNvPr id="6150" name="Picture 6">
            <a:extLst>
              <a:ext uri="{FF2B5EF4-FFF2-40B4-BE49-F238E27FC236}">
                <a16:creationId xmlns:a16="http://schemas.microsoft.com/office/drawing/2014/main" id="{C506C909-10FD-8F93-B575-38B3C5C198DB}"/>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041775" y="0"/>
            <a:ext cx="8150225"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24160906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0237EC-A010-42F1-DA47-6A411BA81416}"/>
              </a:ext>
            </a:extLst>
          </p:cNvPr>
          <p:cNvSpPr>
            <a:spLocks noGrp="1"/>
          </p:cNvSpPr>
          <p:nvPr>
            <p:ph type="title"/>
          </p:nvPr>
        </p:nvSpPr>
        <p:spPr/>
        <p:txBody>
          <a:bodyPr/>
          <a:lstStyle/>
          <a:p>
            <a:r>
              <a:rPr lang="en-US" b="1" dirty="0"/>
              <a:t>ART 8</a:t>
            </a:r>
          </a:p>
        </p:txBody>
      </p:sp>
      <p:sp>
        <p:nvSpPr>
          <p:cNvPr id="3" name="Content Placeholder 2">
            <a:extLst>
              <a:ext uri="{FF2B5EF4-FFF2-40B4-BE49-F238E27FC236}">
                <a16:creationId xmlns:a16="http://schemas.microsoft.com/office/drawing/2014/main" id="{B5C6C80B-CC7A-9165-94B6-939BE0614EEB}"/>
              </a:ext>
            </a:extLst>
          </p:cNvPr>
          <p:cNvSpPr>
            <a:spLocks noGrp="1"/>
          </p:cNvSpPr>
          <p:nvPr>
            <p:ph idx="1"/>
          </p:nvPr>
        </p:nvSpPr>
        <p:spPr>
          <a:xfrm>
            <a:off x="838200" y="2055812"/>
            <a:ext cx="4778829" cy="4116387"/>
          </a:xfrm>
        </p:spPr>
        <p:txBody>
          <a:bodyPr/>
          <a:lstStyle/>
          <a:p>
            <a:pPr marL="0" indent="0">
              <a:buNone/>
            </a:pPr>
            <a:r>
              <a:rPr lang="en-US" b="1" dirty="0">
                <a:solidFill>
                  <a:srgbClr val="7030A0"/>
                </a:solidFill>
              </a:rPr>
              <a:t>Frida Kahlo “The Broken Column” (1944)</a:t>
            </a:r>
          </a:p>
        </p:txBody>
      </p:sp>
      <p:pic>
        <p:nvPicPr>
          <p:cNvPr id="7170" name="Picture 2">
            <a:extLst>
              <a:ext uri="{FF2B5EF4-FFF2-40B4-BE49-F238E27FC236}">
                <a16:creationId xmlns:a16="http://schemas.microsoft.com/office/drawing/2014/main" id="{89FB2861-1F57-6B2B-2D8F-3CCF32A343C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096000" y="0"/>
            <a:ext cx="5791200"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47322103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2CBE1E-5721-1501-901A-70EE35E9FE5C}"/>
              </a:ext>
            </a:extLst>
          </p:cNvPr>
          <p:cNvSpPr>
            <a:spLocks noGrp="1"/>
          </p:cNvSpPr>
          <p:nvPr>
            <p:ph type="title"/>
          </p:nvPr>
        </p:nvSpPr>
        <p:spPr/>
        <p:txBody>
          <a:bodyPr/>
          <a:lstStyle/>
          <a:p>
            <a:r>
              <a:rPr lang="en-US" b="1" dirty="0"/>
              <a:t>ART 9</a:t>
            </a:r>
          </a:p>
        </p:txBody>
      </p:sp>
      <p:sp>
        <p:nvSpPr>
          <p:cNvPr id="3" name="Content Placeholder 2">
            <a:extLst>
              <a:ext uri="{FF2B5EF4-FFF2-40B4-BE49-F238E27FC236}">
                <a16:creationId xmlns:a16="http://schemas.microsoft.com/office/drawing/2014/main" id="{70F3F6BA-7EFE-DAEC-2EDB-E564F99DF737}"/>
              </a:ext>
            </a:extLst>
          </p:cNvPr>
          <p:cNvSpPr>
            <a:spLocks noGrp="1"/>
          </p:cNvSpPr>
          <p:nvPr>
            <p:ph idx="1"/>
          </p:nvPr>
        </p:nvSpPr>
        <p:spPr>
          <a:xfrm>
            <a:off x="838200" y="2011680"/>
            <a:ext cx="3670005" cy="4160520"/>
          </a:xfrm>
        </p:spPr>
        <p:txBody>
          <a:bodyPr/>
          <a:lstStyle/>
          <a:p>
            <a:pPr marL="0" indent="0">
              <a:buNone/>
            </a:pPr>
            <a:r>
              <a:rPr lang="en-US" b="1" dirty="0">
                <a:latin typeface="Calibri" panose="020F0502020204030204" pitchFamily="34" charset="0"/>
                <a:cs typeface="Calibri" panose="020F0502020204030204" pitchFamily="34" charset="0"/>
              </a:rPr>
              <a:t>Egon Schiele – </a:t>
            </a:r>
            <a:r>
              <a:rPr lang="en-US" b="1" i="1" dirty="0">
                <a:latin typeface="Calibri" panose="020F0502020204030204" pitchFamily="34" charset="0"/>
                <a:cs typeface="Calibri" panose="020F0502020204030204" pitchFamily="34" charset="0"/>
              </a:rPr>
              <a:t>Self-Portrait with Hands on Chest</a:t>
            </a:r>
            <a:r>
              <a:rPr lang="en-US" b="1" dirty="0">
                <a:latin typeface="Calibri" panose="020F0502020204030204" pitchFamily="34" charset="0"/>
                <a:cs typeface="Calibri" panose="020F0502020204030204" pitchFamily="34" charset="0"/>
              </a:rPr>
              <a:t> (1910)</a:t>
            </a:r>
            <a:endParaRPr lang="en-US" b="1" dirty="0">
              <a:solidFill>
                <a:srgbClr val="7030A0"/>
              </a:solidFill>
              <a:latin typeface="Calibri" panose="020F0502020204030204" pitchFamily="34" charset="0"/>
              <a:cs typeface="Calibri" panose="020F0502020204030204" pitchFamily="34" charset="0"/>
            </a:endParaRPr>
          </a:p>
        </p:txBody>
      </p:sp>
      <p:pic>
        <p:nvPicPr>
          <p:cNvPr id="4" name="Picture 2">
            <a:extLst>
              <a:ext uri="{FF2B5EF4-FFF2-40B4-BE49-F238E27FC236}">
                <a16:creationId xmlns:a16="http://schemas.microsoft.com/office/drawing/2014/main" id="{BBB1B780-87B9-C897-CF91-95621EB2D53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434263" y="0"/>
            <a:ext cx="3919537"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9689195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8D6AD7-6630-F482-EFEF-79C34F7A825D}"/>
              </a:ext>
            </a:extLst>
          </p:cNvPr>
          <p:cNvSpPr>
            <a:spLocks noGrp="1"/>
          </p:cNvSpPr>
          <p:nvPr>
            <p:ph type="title"/>
          </p:nvPr>
        </p:nvSpPr>
        <p:spPr/>
        <p:txBody>
          <a:bodyPr/>
          <a:lstStyle/>
          <a:p>
            <a:r>
              <a:rPr lang="en-US" b="1" dirty="0"/>
              <a:t>ART 10</a:t>
            </a:r>
          </a:p>
        </p:txBody>
      </p:sp>
      <p:sp>
        <p:nvSpPr>
          <p:cNvPr id="3" name="Content Placeholder 2">
            <a:extLst>
              <a:ext uri="{FF2B5EF4-FFF2-40B4-BE49-F238E27FC236}">
                <a16:creationId xmlns:a16="http://schemas.microsoft.com/office/drawing/2014/main" id="{7F1E65C0-7EF2-43B3-9C5C-7C97ED7E66FB}"/>
              </a:ext>
            </a:extLst>
          </p:cNvPr>
          <p:cNvSpPr>
            <a:spLocks noGrp="1"/>
          </p:cNvSpPr>
          <p:nvPr>
            <p:ph idx="1"/>
          </p:nvPr>
        </p:nvSpPr>
        <p:spPr>
          <a:xfrm>
            <a:off x="838200" y="2011680"/>
            <a:ext cx="3627474" cy="4160520"/>
          </a:xfrm>
        </p:spPr>
        <p:txBody>
          <a:bodyPr/>
          <a:lstStyle/>
          <a:p>
            <a:pPr marL="0" indent="0">
              <a:buNone/>
            </a:pPr>
            <a:r>
              <a:rPr lang="en-US" b="1" dirty="0">
                <a:solidFill>
                  <a:srgbClr val="7030A0"/>
                </a:solidFill>
              </a:rPr>
              <a:t>The Family / 1918 — Egon Schiele</a:t>
            </a:r>
          </a:p>
        </p:txBody>
      </p:sp>
      <p:pic>
        <p:nvPicPr>
          <p:cNvPr id="2050" name="Picture 2">
            <a:extLst>
              <a:ext uri="{FF2B5EF4-FFF2-40B4-BE49-F238E27FC236}">
                <a16:creationId xmlns:a16="http://schemas.microsoft.com/office/drawing/2014/main" id="{080A5333-C420-2F72-3395-DFBA0CA1DD1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895850" y="0"/>
            <a:ext cx="7296150"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36922015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4A1574-8B9A-B71B-0BD6-24376B363ACF}"/>
              </a:ext>
            </a:extLst>
          </p:cNvPr>
          <p:cNvSpPr>
            <a:spLocks noGrp="1"/>
          </p:cNvSpPr>
          <p:nvPr>
            <p:ph type="title"/>
          </p:nvPr>
        </p:nvSpPr>
        <p:spPr/>
        <p:txBody>
          <a:bodyPr/>
          <a:lstStyle/>
          <a:p>
            <a:r>
              <a:rPr lang="en-US" b="1" dirty="0"/>
              <a:t>ART 11</a:t>
            </a:r>
          </a:p>
        </p:txBody>
      </p:sp>
      <p:sp>
        <p:nvSpPr>
          <p:cNvPr id="3" name="Content Placeholder 2">
            <a:extLst>
              <a:ext uri="{FF2B5EF4-FFF2-40B4-BE49-F238E27FC236}">
                <a16:creationId xmlns:a16="http://schemas.microsoft.com/office/drawing/2014/main" id="{9CB0C829-B25E-A521-3C0E-BD6CACBE524B}"/>
              </a:ext>
            </a:extLst>
          </p:cNvPr>
          <p:cNvSpPr>
            <a:spLocks noGrp="1"/>
          </p:cNvSpPr>
          <p:nvPr>
            <p:ph idx="1"/>
          </p:nvPr>
        </p:nvSpPr>
        <p:spPr>
          <a:xfrm>
            <a:off x="838200" y="2011680"/>
            <a:ext cx="2330302" cy="4160520"/>
          </a:xfrm>
        </p:spPr>
        <p:txBody>
          <a:bodyPr/>
          <a:lstStyle/>
          <a:p>
            <a:pPr marL="0" indent="0">
              <a:buNone/>
            </a:pPr>
            <a:r>
              <a:rPr lang="en-US" b="1" dirty="0">
                <a:solidFill>
                  <a:schemeClr val="accent5">
                    <a:lumMod val="50000"/>
                  </a:schemeClr>
                </a:solidFill>
              </a:rPr>
              <a:t>John Bond Francisco, The Sick Child, 1893</a:t>
            </a:r>
          </a:p>
        </p:txBody>
      </p:sp>
      <p:pic>
        <p:nvPicPr>
          <p:cNvPr id="7170" name="Picture 2" descr="sickness in art: John Bond Francisco, The Sick Child, 1893, Smithsonian American Art Museum, Washington, DC, USA. Museum’s website.&#10;">
            <a:extLst>
              <a:ext uri="{FF2B5EF4-FFF2-40B4-BE49-F238E27FC236}">
                <a16:creationId xmlns:a16="http://schemas.microsoft.com/office/drawing/2014/main" id="{18B42272-1340-3C4C-20A3-6910A9DD26B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574351" y="76126"/>
            <a:ext cx="8617649" cy="6416749"/>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562635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7718681-A12E-49D6-9925-DD7C68176D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FBD77573-9EF2-4C35-8285-A1CF6FBB0E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 y="0"/>
            <a:ext cx="5511704" cy="6858000"/>
          </a:xfrm>
          <a:custGeom>
            <a:avLst/>
            <a:gdLst>
              <a:gd name="connsiteX0" fmla="*/ 5511704 w 5511704"/>
              <a:gd name="connsiteY0" fmla="*/ 0 h 6886576"/>
              <a:gd name="connsiteX1" fmla="*/ 1008599 w 5511704"/>
              <a:gd name="connsiteY1" fmla="*/ 0 h 6886576"/>
              <a:gd name="connsiteX2" fmla="*/ 1310975 w 5511704"/>
              <a:gd name="connsiteY2" fmla="*/ 110728 h 6886576"/>
              <a:gd name="connsiteX3" fmla="*/ 1267362 w 5511704"/>
              <a:gd name="connsiteY3" fmla="*/ 135731 h 6886576"/>
              <a:gd name="connsiteX4" fmla="*/ 1005692 w 5511704"/>
              <a:gd name="connsiteY4" fmla="*/ 71437 h 6886576"/>
              <a:gd name="connsiteX5" fmla="*/ 953358 w 5511704"/>
              <a:gd name="connsiteY5" fmla="*/ 89297 h 6886576"/>
              <a:gd name="connsiteX6" fmla="*/ 979525 w 5511704"/>
              <a:gd name="connsiteY6" fmla="*/ 164307 h 6886576"/>
              <a:gd name="connsiteX7" fmla="*/ 1092915 w 5511704"/>
              <a:gd name="connsiteY7" fmla="*/ 192882 h 6886576"/>
              <a:gd name="connsiteX8" fmla="*/ 1270270 w 5511704"/>
              <a:gd name="connsiteY8" fmla="*/ 375047 h 6886576"/>
              <a:gd name="connsiteX9" fmla="*/ 1002784 w 5511704"/>
              <a:gd name="connsiteY9" fmla="*/ 353615 h 6886576"/>
              <a:gd name="connsiteX10" fmla="*/ 956265 w 5511704"/>
              <a:gd name="connsiteY10" fmla="*/ 396479 h 6886576"/>
              <a:gd name="connsiteX11" fmla="*/ 938820 w 5511704"/>
              <a:gd name="connsiteY11" fmla="*/ 453629 h 6886576"/>
              <a:gd name="connsiteX12" fmla="*/ 860319 w 5511704"/>
              <a:gd name="connsiteY12" fmla="*/ 360759 h 6886576"/>
              <a:gd name="connsiteX13" fmla="*/ 793447 w 5511704"/>
              <a:gd name="connsiteY13" fmla="*/ 335757 h 6886576"/>
              <a:gd name="connsiteX14" fmla="*/ 773095 w 5511704"/>
              <a:gd name="connsiteY14" fmla="*/ 417910 h 6886576"/>
              <a:gd name="connsiteX15" fmla="*/ 834151 w 5511704"/>
              <a:gd name="connsiteY15" fmla="*/ 507206 h 6886576"/>
              <a:gd name="connsiteX16" fmla="*/ 996969 w 5511704"/>
              <a:gd name="connsiteY16" fmla="*/ 560785 h 6886576"/>
              <a:gd name="connsiteX17" fmla="*/ 822522 w 5511704"/>
              <a:gd name="connsiteY17" fmla="*/ 560785 h 6886576"/>
              <a:gd name="connsiteX18" fmla="*/ 621908 w 5511704"/>
              <a:gd name="connsiteY18" fmla="*/ 525066 h 6886576"/>
              <a:gd name="connsiteX19" fmla="*/ 409664 w 5511704"/>
              <a:gd name="connsiteY19" fmla="*/ 535781 h 6886576"/>
              <a:gd name="connsiteX20" fmla="*/ 209049 w 5511704"/>
              <a:gd name="connsiteY20" fmla="*/ 464344 h 6886576"/>
              <a:gd name="connsiteX21" fmla="*/ 5527 w 5511704"/>
              <a:gd name="connsiteY21" fmla="*/ 467916 h 6886576"/>
              <a:gd name="connsiteX22" fmla="*/ 906838 w 5511704"/>
              <a:gd name="connsiteY22" fmla="*/ 914400 h 6886576"/>
              <a:gd name="connsiteX23" fmla="*/ 863226 w 5511704"/>
              <a:gd name="connsiteY23" fmla="*/ 925116 h 6886576"/>
              <a:gd name="connsiteX24" fmla="*/ 805077 w 5511704"/>
              <a:gd name="connsiteY24" fmla="*/ 953691 h 6886576"/>
              <a:gd name="connsiteX25" fmla="*/ 848689 w 5511704"/>
              <a:gd name="connsiteY25" fmla="*/ 1010841 h 6886576"/>
              <a:gd name="connsiteX26" fmla="*/ 1084193 w 5511704"/>
              <a:gd name="connsiteY26" fmla="*/ 1117997 h 6886576"/>
              <a:gd name="connsiteX27" fmla="*/ 1142342 w 5511704"/>
              <a:gd name="connsiteY27" fmla="*/ 1225153 h 6886576"/>
              <a:gd name="connsiteX28" fmla="*/ 1069655 w 5511704"/>
              <a:gd name="connsiteY28" fmla="*/ 1214438 h 6886576"/>
              <a:gd name="connsiteX29" fmla="*/ 1005692 w 5511704"/>
              <a:gd name="connsiteY29" fmla="*/ 1235869 h 6886576"/>
              <a:gd name="connsiteX30" fmla="*/ 1031858 w 5511704"/>
              <a:gd name="connsiteY30" fmla="*/ 1371600 h 6886576"/>
              <a:gd name="connsiteX31" fmla="*/ 1366216 w 5511704"/>
              <a:gd name="connsiteY31" fmla="*/ 1546622 h 6886576"/>
              <a:gd name="connsiteX32" fmla="*/ 1395290 w 5511704"/>
              <a:gd name="connsiteY32" fmla="*/ 1603772 h 6886576"/>
              <a:gd name="connsiteX33" fmla="*/ 1354586 w 5511704"/>
              <a:gd name="connsiteY33" fmla="*/ 1643063 h 6886576"/>
              <a:gd name="connsiteX34" fmla="*/ 1247011 w 5511704"/>
              <a:gd name="connsiteY34" fmla="*/ 1664494 h 6886576"/>
              <a:gd name="connsiteX35" fmla="*/ 1398198 w 5511704"/>
              <a:gd name="connsiteY35" fmla="*/ 1857375 h 6886576"/>
              <a:gd name="connsiteX36" fmla="*/ 1453440 w 5511704"/>
              <a:gd name="connsiteY36" fmla="*/ 1910954 h 6886576"/>
              <a:gd name="connsiteX37" fmla="*/ 1549386 w 5511704"/>
              <a:gd name="connsiteY37" fmla="*/ 1993106 h 6886576"/>
              <a:gd name="connsiteX38" fmla="*/ 1549386 w 5511704"/>
              <a:gd name="connsiteY38" fmla="*/ 2021681 h 6886576"/>
              <a:gd name="connsiteX39" fmla="*/ 1421458 w 5511704"/>
              <a:gd name="connsiteY39" fmla="*/ 2110978 h 6886576"/>
              <a:gd name="connsiteX40" fmla="*/ 1188861 w 5511704"/>
              <a:gd name="connsiteY40" fmla="*/ 2085976 h 6886576"/>
              <a:gd name="connsiteX41" fmla="*/ 1531941 w 5511704"/>
              <a:gd name="connsiteY41" fmla="*/ 2218135 h 6886576"/>
              <a:gd name="connsiteX42" fmla="*/ 421293 w 5511704"/>
              <a:gd name="connsiteY42" fmla="*/ 1900238 h 6886576"/>
              <a:gd name="connsiteX43" fmla="*/ 491072 w 5511704"/>
              <a:gd name="connsiteY43" fmla="*/ 1982391 h 6886576"/>
              <a:gd name="connsiteX44" fmla="*/ 880671 w 5511704"/>
              <a:gd name="connsiteY44" fmla="*/ 2200276 h 6886576"/>
              <a:gd name="connsiteX45" fmla="*/ 991154 w 5511704"/>
              <a:gd name="connsiteY45" fmla="*/ 2336007 h 6886576"/>
              <a:gd name="connsiteX46" fmla="*/ 1107453 w 5511704"/>
              <a:gd name="connsiteY46" fmla="*/ 2411016 h 6886576"/>
              <a:gd name="connsiteX47" fmla="*/ 1270270 w 5511704"/>
              <a:gd name="connsiteY47" fmla="*/ 2411016 h 6886576"/>
              <a:gd name="connsiteX48" fmla="*/ 1386568 w 5511704"/>
              <a:gd name="connsiteY48" fmla="*/ 2528889 h 6886576"/>
              <a:gd name="connsiteX49" fmla="*/ 1267362 w 5511704"/>
              <a:gd name="connsiteY49" fmla="*/ 2553891 h 6886576"/>
              <a:gd name="connsiteX50" fmla="*/ 1127805 w 5511704"/>
              <a:gd name="connsiteY50" fmla="*/ 2536032 h 6886576"/>
              <a:gd name="connsiteX51" fmla="*/ 970802 w 5511704"/>
              <a:gd name="connsiteY51" fmla="*/ 2575322 h 6886576"/>
              <a:gd name="connsiteX52" fmla="*/ 825429 w 5511704"/>
              <a:gd name="connsiteY52" fmla="*/ 2543176 h 6886576"/>
              <a:gd name="connsiteX53" fmla="*/ 650982 w 5511704"/>
              <a:gd name="connsiteY53" fmla="*/ 2564607 h 6886576"/>
              <a:gd name="connsiteX54" fmla="*/ 595740 w 5511704"/>
              <a:gd name="connsiteY54" fmla="*/ 2703909 h 6886576"/>
              <a:gd name="connsiteX55" fmla="*/ 578296 w 5511704"/>
              <a:gd name="connsiteY55" fmla="*/ 2714626 h 6886576"/>
              <a:gd name="connsiteX56" fmla="*/ 255568 w 5511704"/>
              <a:gd name="connsiteY56" fmla="*/ 2936081 h 6886576"/>
              <a:gd name="connsiteX57" fmla="*/ 165437 w 5511704"/>
              <a:gd name="connsiteY57" fmla="*/ 2953941 h 6886576"/>
              <a:gd name="connsiteX58" fmla="*/ 697501 w 5511704"/>
              <a:gd name="connsiteY58" fmla="*/ 3343275 h 6886576"/>
              <a:gd name="connsiteX59" fmla="*/ 339884 w 5511704"/>
              <a:gd name="connsiteY59" fmla="*/ 3243263 h 6886576"/>
              <a:gd name="connsiteX60" fmla="*/ 290458 w 5511704"/>
              <a:gd name="connsiteY60" fmla="*/ 3407569 h 6886576"/>
              <a:gd name="connsiteX61" fmla="*/ 459090 w 5511704"/>
              <a:gd name="connsiteY61" fmla="*/ 3554016 h 6886576"/>
              <a:gd name="connsiteX62" fmla="*/ 520147 w 5511704"/>
              <a:gd name="connsiteY62" fmla="*/ 3843338 h 6886576"/>
              <a:gd name="connsiteX63" fmla="*/ 491072 w 5511704"/>
              <a:gd name="connsiteY63" fmla="*/ 4107657 h 6886576"/>
              <a:gd name="connsiteX64" fmla="*/ 418386 w 5511704"/>
              <a:gd name="connsiteY64" fmla="*/ 4189810 h 6886576"/>
              <a:gd name="connsiteX65" fmla="*/ 313718 w 5511704"/>
              <a:gd name="connsiteY65" fmla="*/ 4339829 h 6886576"/>
              <a:gd name="connsiteX66" fmla="*/ 249753 w 5511704"/>
              <a:gd name="connsiteY66" fmla="*/ 4432698 h 6886576"/>
              <a:gd name="connsiteX67" fmla="*/ 25879 w 5511704"/>
              <a:gd name="connsiteY67" fmla="*/ 4396979 h 6886576"/>
              <a:gd name="connsiteX68" fmla="*/ 325347 w 5511704"/>
              <a:gd name="connsiteY68" fmla="*/ 4632722 h 6886576"/>
              <a:gd name="connsiteX69" fmla="*/ 84029 w 5511704"/>
              <a:gd name="connsiteY69" fmla="*/ 4604147 h 6886576"/>
              <a:gd name="connsiteX70" fmla="*/ 5527 w 5511704"/>
              <a:gd name="connsiteY70" fmla="*/ 4622007 h 6886576"/>
              <a:gd name="connsiteX71" fmla="*/ 49139 w 5511704"/>
              <a:gd name="connsiteY71" fmla="*/ 4697016 h 6886576"/>
              <a:gd name="connsiteX72" fmla="*/ 226494 w 5511704"/>
              <a:gd name="connsiteY72" fmla="*/ 4825604 h 6886576"/>
              <a:gd name="connsiteX73" fmla="*/ 592833 w 5511704"/>
              <a:gd name="connsiteY73" fmla="*/ 5175647 h 6886576"/>
              <a:gd name="connsiteX74" fmla="*/ 238123 w 5511704"/>
              <a:gd name="connsiteY74" fmla="*/ 5014913 h 6886576"/>
              <a:gd name="connsiteX75" fmla="*/ 610278 w 5511704"/>
              <a:gd name="connsiteY75" fmla="*/ 5375673 h 6886576"/>
              <a:gd name="connsiteX76" fmla="*/ 691686 w 5511704"/>
              <a:gd name="connsiteY76" fmla="*/ 5497116 h 6886576"/>
              <a:gd name="connsiteX77" fmla="*/ 860319 w 5511704"/>
              <a:gd name="connsiteY77" fmla="*/ 5793582 h 6886576"/>
              <a:gd name="connsiteX78" fmla="*/ 851597 w 5511704"/>
              <a:gd name="connsiteY78" fmla="*/ 5825729 h 6886576"/>
              <a:gd name="connsiteX79" fmla="*/ 659704 w 5511704"/>
              <a:gd name="connsiteY79" fmla="*/ 5779295 h 6886576"/>
              <a:gd name="connsiteX80" fmla="*/ 909746 w 5511704"/>
              <a:gd name="connsiteY80" fmla="*/ 6029326 h 6886576"/>
              <a:gd name="connsiteX81" fmla="*/ 1168509 w 5511704"/>
              <a:gd name="connsiteY81" fmla="*/ 6222207 h 6886576"/>
              <a:gd name="connsiteX82" fmla="*/ 985339 w 5511704"/>
              <a:gd name="connsiteY82" fmla="*/ 6193632 h 6886576"/>
              <a:gd name="connsiteX83" fmla="*/ 732391 w 5511704"/>
              <a:gd name="connsiteY83" fmla="*/ 6082904 h 6886576"/>
              <a:gd name="connsiteX84" fmla="*/ 645167 w 5511704"/>
              <a:gd name="connsiteY84" fmla="*/ 6125766 h 6886576"/>
              <a:gd name="connsiteX85" fmla="*/ 883579 w 5511704"/>
              <a:gd name="connsiteY85" fmla="*/ 6307932 h 6886576"/>
              <a:gd name="connsiteX86" fmla="*/ 1020229 w 5511704"/>
              <a:gd name="connsiteY86" fmla="*/ 6393657 h 6886576"/>
              <a:gd name="connsiteX87" fmla="*/ 1075471 w 5511704"/>
              <a:gd name="connsiteY87" fmla="*/ 6457950 h 6886576"/>
              <a:gd name="connsiteX88" fmla="*/ 1232473 w 5511704"/>
              <a:gd name="connsiteY88" fmla="*/ 6686551 h 6886576"/>
              <a:gd name="connsiteX89" fmla="*/ 1592997 w 5511704"/>
              <a:gd name="connsiteY89" fmla="*/ 6886576 h 6886576"/>
              <a:gd name="connsiteX90" fmla="*/ 5511704 w 5511704"/>
              <a:gd name="connsiteY90" fmla="*/ 6886576 h 68865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Lst>
            <a:rect l="l" t="t" r="r" b="b"/>
            <a:pathLst>
              <a:path w="5511704" h="6886576">
                <a:moveTo>
                  <a:pt x="5511704" y="0"/>
                </a:moveTo>
                <a:lnTo>
                  <a:pt x="1008599" y="0"/>
                </a:lnTo>
                <a:cubicBezTo>
                  <a:pt x="1110360" y="35719"/>
                  <a:pt x="1209214" y="78581"/>
                  <a:pt x="1310975" y="110728"/>
                </a:cubicBezTo>
                <a:cubicBezTo>
                  <a:pt x="1296437" y="146447"/>
                  <a:pt x="1281900" y="139303"/>
                  <a:pt x="1267362" y="135731"/>
                </a:cubicBezTo>
                <a:cubicBezTo>
                  <a:pt x="1180139" y="121445"/>
                  <a:pt x="1090008" y="110728"/>
                  <a:pt x="1005692" y="71437"/>
                </a:cubicBezTo>
                <a:cubicBezTo>
                  <a:pt x="985339" y="64294"/>
                  <a:pt x="962080" y="64294"/>
                  <a:pt x="953358" y="89297"/>
                </a:cubicBezTo>
                <a:cubicBezTo>
                  <a:pt x="938820" y="125016"/>
                  <a:pt x="959172" y="146447"/>
                  <a:pt x="979525" y="164307"/>
                </a:cubicBezTo>
                <a:cubicBezTo>
                  <a:pt x="1014414" y="196453"/>
                  <a:pt x="1055118" y="189310"/>
                  <a:pt x="1092915" y="192882"/>
                </a:cubicBezTo>
                <a:cubicBezTo>
                  <a:pt x="1197583" y="210741"/>
                  <a:pt x="1247011" y="260747"/>
                  <a:pt x="1270270" y="375047"/>
                </a:cubicBezTo>
                <a:cubicBezTo>
                  <a:pt x="1180139" y="328613"/>
                  <a:pt x="1090008" y="385763"/>
                  <a:pt x="1002784" y="353615"/>
                </a:cubicBezTo>
                <a:cubicBezTo>
                  <a:pt x="979525" y="346472"/>
                  <a:pt x="944635" y="357188"/>
                  <a:pt x="956265" y="396479"/>
                </a:cubicBezTo>
                <a:cubicBezTo>
                  <a:pt x="967894" y="432198"/>
                  <a:pt x="1005692" y="460772"/>
                  <a:pt x="938820" y="453629"/>
                </a:cubicBezTo>
                <a:cubicBezTo>
                  <a:pt x="889393" y="450056"/>
                  <a:pt x="874856" y="407194"/>
                  <a:pt x="860319" y="360759"/>
                </a:cubicBezTo>
                <a:cubicBezTo>
                  <a:pt x="848689" y="335757"/>
                  <a:pt x="816707" y="321469"/>
                  <a:pt x="793447" y="335757"/>
                </a:cubicBezTo>
                <a:cubicBezTo>
                  <a:pt x="764373" y="350044"/>
                  <a:pt x="773095" y="389335"/>
                  <a:pt x="773095" y="417910"/>
                </a:cubicBezTo>
                <a:cubicBezTo>
                  <a:pt x="770187" y="471488"/>
                  <a:pt x="793447" y="496491"/>
                  <a:pt x="834151" y="507206"/>
                </a:cubicBezTo>
                <a:cubicBezTo>
                  <a:pt x="883579" y="521494"/>
                  <a:pt x="933005" y="539354"/>
                  <a:pt x="996969" y="560785"/>
                </a:cubicBezTo>
                <a:cubicBezTo>
                  <a:pt x="927190" y="596503"/>
                  <a:pt x="874856" y="589360"/>
                  <a:pt x="822522" y="560785"/>
                </a:cubicBezTo>
                <a:cubicBezTo>
                  <a:pt x="758558" y="528637"/>
                  <a:pt x="674242" y="485775"/>
                  <a:pt x="621908" y="525066"/>
                </a:cubicBezTo>
                <a:cubicBezTo>
                  <a:pt x="543407" y="582216"/>
                  <a:pt x="479443" y="546497"/>
                  <a:pt x="409664" y="535781"/>
                </a:cubicBezTo>
                <a:cubicBezTo>
                  <a:pt x="264290" y="514350"/>
                  <a:pt x="354422" y="482204"/>
                  <a:pt x="209049" y="464344"/>
                </a:cubicBezTo>
                <a:cubicBezTo>
                  <a:pt x="150900" y="457200"/>
                  <a:pt x="89843" y="428625"/>
                  <a:pt x="5527" y="467916"/>
                </a:cubicBezTo>
                <a:cubicBezTo>
                  <a:pt x="386404" y="675085"/>
                  <a:pt x="566666" y="660797"/>
                  <a:pt x="906838" y="914400"/>
                </a:cubicBezTo>
                <a:cubicBezTo>
                  <a:pt x="892301" y="939404"/>
                  <a:pt x="877764" y="928688"/>
                  <a:pt x="863226" y="925116"/>
                </a:cubicBezTo>
                <a:cubicBezTo>
                  <a:pt x="839967" y="921544"/>
                  <a:pt x="810892" y="907256"/>
                  <a:pt x="805077" y="953691"/>
                </a:cubicBezTo>
                <a:cubicBezTo>
                  <a:pt x="802169" y="989410"/>
                  <a:pt x="819615" y="1007269"/>
                  <a:pt x="848689" y="1010841"/>
                </a:cubicBezTo>
                <a:cubicBezTo>
                  <a:pt x="933005" y="1025129"/>
                  <a:pt x="1008599" y="1075135"/>
                  <a:pt x="1084193" y="1117997"/>
                </a:cubicBezTo>
                <a:cubicBezTo>
                  <a:pt x="1119082" y="1135857"/>
                  <a:pt x="1156879" y="1160860"/>
                  <a:pt x="1142342" y="1225153"/>
                </a:cubicBezTo>
                <a:cubicBezTo>
                  <a:pt x="1113268" y="1243013"/>
                  <a:pt x="1092915" y="1218009"/>
                  <a:pt x="1069655" y="1214438"/>
                </a:cubicBezTo>
                <a:cubicBezTo>
                  <a:pt x="1046396" y="1210866"/>
                  <a:pt x="991154" y="1225153"/>
                  <a:pt x="1005692" y="1235869"/>
                </a:cubicBezTo>
                <a:cubicBezTo>
                  <a:pt x="1072563" y="1275159"/>
                  <a:pt x="950450" y="1371600"/>
                  <a:pt x="1031858" y="1371600"/>
                </a:cubicBezTo>
                <a:cubicBezTo>
                  <a:pt x="1165601" y="1371600"/>
                  <a:pt x="1238288" y="1543050"/>
                  <a:pt x="1366216" y="1546622"/>
                </a:cubicBezTo>
                <a:cubicBezTo>
                  <a:pt x="1386568" y="1546622"/>
                  <a:pt x="1395290" y="1578770"/>
                  <a:pt x="1395290" y="1603772"/>
                </a:cubicBezTo>
                <a:cubicBezTo>
                  <a:pt x="1395290" y="1635920"/>
                  <a:pt x="1374939" y="1639491"/>
                  <a:pt x="1354586" y="1643063"/>
                </a:cubicBezTo>
                <a:cubicBezTo>
                  <a:pt x="1322604" y="1646635"/>
                  <a:pt x="1287715" y="1603772"/>
                  <a:pt x="1247011" y="1664494"/>
                </a:cubicBezTo>
                <a:cubicBezTo>
                  <a:pt x="1322604" y="1700213"/>
                  <a:pt x="1401105" y="1735932"/>
                  <a:pt x="1398198" y="1857375"/>
                </a:cubicBezTo>
                <a:cubicBezTo>
                  <a:pt x="1398198" y="1889523"/>
                  <a:pt x="1430180" y="1903810"/>
                  <a:pt x="1453440" y="1910954"/>
                </a:cubicBezTo>
                <a:cubicBezTo>
                  <a:pt x="1494144" y="1925241"/>
                  <a:pt x="1526126" y="1946673"/>
                  <a:pt x="1549386" y="1993106"/>
                </a:cubicBezTo>
                <a:cubicBezTo>
                  <a:pt x="1549386" y="2003822"/>
                  <a:pt x="1549386" y="2010966"/>
                  <a:pt x="1549386" y="2021681"/>
                </a:cubicBezTo>
                <a:cubicBezTo>
                  <a:pt x="1543571" y="2132410"/>
                  <a:pt x="1485422" y="2128838"/>
                  <a:pt x="1421458" y="2110978"/>
                </a:cubicBezTo>
                <a:cubicBezTo>
                  <a:pt x="1345864" y="2089547"/>
                  <a:pt x="1270270" y="2046685"/>
                  <a:pt x="1188861" y="2085976"/>
                </a:cubicBezTo>
                <a:cubicBezTo>
                  <a:pt x="1302252" y="2139554"/>
                  <a:pt x="1427272" y="2143126"/>
                  <a:pt x="1531941" y="2218135"/>
                </a:cubicBezTo>
                <a:cubicBezTo>
                  <a:pt x="1142342" y="2232422"/>
                  <a:pt x="799262" y="1993106"/>
                  <a:pt x="421293" y="1900238"/>
                </a:cubicBezTo>
                <a:cubicBezTo>
                  <a:pt x="432923" y="1960960"/>
                  <a:pt x="464905" y="1975247"/>
                  <a:pt x="491072" y="1982391"/>
                </a:cubicBezTo>
                <a:cubicBezTo>
                  <a:pt x="630630" y="2028825"/>
                  <a:pt x="752743" y="2121695"/>
                  <a:pt x="880671" y="2200276"/>
                </a:cubicBezTo>
                <a:cubicBezTo>
                  <a:pt x="933005" y="2232422"/>
                  <a:pt x="970802" y="2268142"/>
                  <a:pt x="991154" y="2336007"/>
                </a:cubicBezTo>
                <a:cubicBezTo>
                  <a:pt x="1008599" y="2400300"/>
                  <a:pt x="1043489" y="2428875"/>
                  <a:pt x="1107453" y="2411016"/>
                </a:cubicBezTo>
                <a:cubicBezTo>
                  <a:pt x="1159787" y="2396729"/>
                  <a:pt x="1215029" y="2403873"/>
                  <a:pt x="1270270" y="2411016"/>
                </a:cubicBezTo>
                <a:cubicBezTo>
                  <a:pt x="1331326" y="2418160"/>
                  <a:pt x="1401105" y="2489597"/>
                  <a:pt x="1386568" y="2528889"/>
                </a:cubicBezTo>
                <a:cubicBezTo>
                  <a:pt x="1357494" y="2593182"/>
                  <a:pt x="1308067" y="2561035"/>
                  <a:pt x="1267362" y="2553891"/>
                </a:cubicBezTo>
                <a:cubicBezTo>
                  <a:pt x="1217936" y="2546748"/>
                  <a:pt x="1127805" y="2528889"/>
                  <a:pt x="1127805" y="2536032"/>
                </a:cubicBezTo>
                <a:cubicBezTo>
                  <a:pt x="1095822" y="2696766"/>
                  <a:pt x="1023136" y="2575322"/>
                  <a:pt x="970802" y="2575322"/>
                </a:cubicBezTo>
                <a:cubicBezTo>
                  <a:pt x="921375" y="2575322"/>
                  <a:pt x="871949" y="2557463"/>
                  <a:pt x="825429" y="2543176"/>
                </a:cubicBezTo>
                <a:cubicBezTo>
                  <a:pt x="764373" y="2525316"/>
                  <a:pt x="709132" y="2557463"/>
                  <a:pt x="650982" y="2564607"/>
                </a:cubicBezTo>
                <a:cubicBezTo>
                  <a:pt x="598648" y="2571751"/>
                  <a:pt x="627722" y="2664620"/>
                  <a:pt x="595740" y="2703909"/>
                </a:cubicBezTo>
                <a:cubicBezTo>
                  <a:pt x="589926" y="2714626"/>
                  <a:pt x="584111" y="2714626"/>
                  <a:pt x="578296" y="2714626"/>
                </a:cubicBezTo>
                <a:cubicBezTo>
                  <a:pt x="560851" y="2993232"/>
                  <a:pt x="255568" y="2925366"/>
                  <a:pt x="255568" y="2936081"/>
                </a:cubicBezTo>
                <a:cubicBezTo>
                  <a:pt x="229401" y="2953941"/>
                  <a:pt x="197419" y="2911079"/>
                  <a:pt x="165437" y="2953941"/>
                </a:cubicBezTo>
                <a:cubicBezTo>
                  <a:pt x="302087" y="3150394"/>
                  <a:pt x="511425" y="3196828"/>
                  <a:pt x="697501" y="3343275"/>
                </a:cubicBezTo>
                <a:cubicBezTo>
                  <a:pt x="543407" y="3393282"/>
                  <a:pt x="453275" y="3221832"/>
                  <a:pt x="339884" y="3243263"/>
                </a:cubicBezTo>
                <a:cubicBezTo>
                  <a:pt x="284643" y="3296842"/>
                  <a:pt x="450368" y="3382566"/>
                  <a:pt x="290458" y="3407569"/>
                </a:cubicBezTo>
                <a:cubicBezTo>
                  <a:pt x="360236" y="3454004"/>
                  <a:pt x="409664" y="3500439"/>
                  <a:pt x="459090" y="3554016"/>
                </a:cubicBezTo>
                <a:cubicBezTo>
                  <a:pt x="543407" y="3650457"/>
                  <a:pt x="560851" y="3714751"/>
                  <a:pt x="520147" y="3843338"/>
                </a:cubicBezTo>
                <a:cubicBezTo>
                  <a:pt x="493979" y="3929063"/>
                  <a:pt x="456183" y="4007645"/>
                  <a:pt x="491072" y="4107657"/>
                </a:cubicBezTo>
                <a:cubicBezTo>
                  <a:pt x="514332" y="4175522"/>
                  <a:pt x="505609" y="4221957"/>
                  <a:pt x="418386" y="4189810"/>
                </a:cubicBezTo>
                <a:cubicBezTo>
                  <a:pt x="325347" y="4157663"/>
                  <a:pt x="290458" y="4218386"/>
                  <a:pt x="313718" y="4339829"/>
                </a:cubicBezTo>
                <a:cubicBezTo>
                  <a:pt x="328254" y="4418410"/>
                  <a:pt x="313718" y="4443413"/>
                  <a:pt x="249753" y="4432698"/>
                </a:cubicBezTo>
                <a:cubicBezTo>
                  <a:pt x="179975" y="4421982"/>
                  <a:pt x="113103" y="4371976"/>
                  <a:pt x="25879" y="4396979"/>
                </a:cubicBezTo>
                <a:cubicBezTo>
                  <a:pt x="95658" y="4539854"/>
                  <a:pt x="243939" y="4496991"/>
                  <a:pt x="325347" y="4632722"/>
                </a:cubicBezTo>
                <a:cubicBezTo>
                  <a:pt x="229401" y="4632722"/>
                  <a:pt x="153807" y="4632722"/>
                  <a:pt x="84029" y="4604147"/>
                </a:cubicBezTo>
                <a:cubicBezTo>
                  <a:pt x="54954" y="4593433"/>
                  <a:pt x="22972" y="4579145"/>
                  <a:pt x="5527" y="4622007"/>
                </a:cubicBezTo>
                <a:cubicBezTo>
                  <a:pt x="-14826" y="4672014"/>
                  <a:pt x="25879" y="4689872"/>
                  <a:pt x="49139" y="4697016"/>
                </a:cubicBezTo>
                <a:cubicBezTo>
                  <a:pt x="116011" y="4722019"/>
                  <a:pt x="168344" y="4779170"/>
                  <a:pt x="226494" y="4825604"/>
                </a:cubicBezTo>
                <a:cubicBezTo>
                  <a:pt x="351514" y="4925616"/>
                  <a:pt x="488165" y="5011341"/>
                  <a:pt x="592833" y="5175647"/>
                </a:cubicBezTo>
                <a:cubicBezTo>
                  <a:pt x="461997" y="5132785"/>
                  <a:pt x="363144" y="5032772"/>
                  <a:pt x="238123" y="5014913"/>
                </a:cubicBezTo>
                <a:cubicBezTo>
                  <a:pt x="345700" y="5164932"/>
                  <a:pt x="482350" y="5264944"/>
                  <a:pt x="610278" y="5375673"/>
                </a:cubicBezTo>
                <a:cubicBezTo>
                  <a:pt x="648075" y="5407819"/>
                  <a:pt x="685872" y="5429250"/>
                  <a:pt x="691686" y="5497116"/>
                </a:cubicBezTo>
                <a:cubicBezTo>
                  <a:pt x="709132" y="5629276"/>
                  <a:pt x="755650" y="5736432"/>
                  <a:pt x="860319" y="5793582"/>
                </a:cubicBezTo>
                <a:cubicBezTo>
                  <a:pt x="860319" y="5793582"/>
                  <a:pt x="854504" y="5815013"/>
                  <a:pt x="851597" y="5825729"/>
                </a:cubicBezTo>
                <a:cubicBezTo>
                  <a:pt x="787632" y="5829301"/>
                  <a:pt x="738206" y="5750720"/>
                  <a:pt x="659704" y="5779295"/>
                </a:cubicBezTo>
                <a:cubicBezTo>
                  <a:pt x="738206" y="5886451"/>
                  <a:pt x="802169" y="5979319"/>
                  <a:pt x="909746" y="6029326"/>
                </a:cubicBezTo>
                <a:cubicBezTo>
                  <a:pt x="996969" y="6068616"/>
                  <a:pt x="1104545" y="6093620"/>
                  <a:pt x="1168509" y="6222207"/>
                </a:cubicBezTo>
                <a:cubicBezTo>
                  <a:pt x="1095822" y="6247210"/>
                  <a:pt x="1040581" y="6215063"/>
                  <a:pt x="985339" y="6193632"/>
                </a:cubicBezTo>
                <a:cubicBezTo>
                  <a:pt x="901023" y="6157913"/>
                  <a:pt x="816707" y="6118623"/>
                  <a:pt x="732391" y="6082904"/>
                </a:cubicBezTo>
                <a:cubicBezTo>
                  <a:pt x="700408" y="6068616"/>
                  <a:pt x="665519" y="6061472"/>
                  <a:pt x="645167" y="6125766"/>
                </a:cubicBezTo>
                <a:cubicBezTo>
                  <a:pt x="752743" y="6140053"/>
                  <a:pt x="816707" y="6225779"/>
                  <a:pt x="883579" y="6307932"/>
                </a:cubicBezTo>
                <a:cubicBezTo>
                  <a:pt x="921375" y="6354366"/>
                  <a:pt x="953358" y="6415088"/>
                  <a:pt x="1020229" y="6393657"/>
                </a:cubicBezTo>
                <a:cubicBezTo>
                  <a:pt x="1055118" y="6382942"/>
                  <a:pt x="1078378" y="6415088"/>
                  <a:pt x="1075471" y="6457950"/>
                </a:cubicBezTo>
                <a:cubicBezTo>
                  <a:pt x="1060933" y="6607970"/>
                  <a:pt x="1145250" y="6657976"/>
                  <a:pt x="1232473" y="6686551"/>
                </a:cubicBezTo>
                <a:cubicBezTo>
                  <a:pt x="1360401" y="6729413"/>
                  <a:pt x="1473792" y="6815138"/>
                  <a:pt x="1592997" y="6886576"/>
                </a:cubicBezTo>
                <a:lnTo>
                  <a:pt x="5511704" y="6886576"/>
                </a:lnTo>
                <a:close/>
              </a:path>
            </a:pathLst>
          </a:custGeom>
          <a:solidFill>
            <a:schemeClr val="accent1"/>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8DE66E54-F580-9612-E830-1B74D3F44635}"/>
              </a:ext>
            </a:extLst>
          </p:cNvPr>
          <p:cNvSpPr>
            <a:spLocks noGrp="1"/>
          </p:cNvSpPr>
          <p:nvPr>
            <p:ph type="title"/>
          </p:nvPr>
        </p:nvSpPr>
        <p:spPr>
          <a:xfrm>
            <a:off x="838200" y="713312"/>
            <a:ext cx="3461084" cy="5431376"/>
          </a:xfrm>
        </p:spPr>
        <p:txBody>
          <a:bodyPr>
            <a:normAutofit/>
          </a:bodyPr>
          <a:lstStyle/>
          <a:p>
            <a:r>
              <a:rPr lang="en-US" b="1">
                <a:solidFill>
                  <a:srgbClr val="FFFFFF"/>
                </a:solidFill>
              </a:rPr>
              <a:t>Instructions</a:t>
            </a:r>
          </a:p>
        </p:txBody>
      </p:sp>
      <p:sp>
        <p:nvSpPr>
          <p:cNvPr id="3" name="Content Placeholder 2">
            <a:extLst>
              <a:ext uri="{FF2B5EF4-FFF2-40B4-BE49-F238E27FC236}">
                <a16:creationId xmlns:a16="http://schemas.microsoft.com/office/drawing/2014/main" id="{6490A26C-6929-0772-5804-9AD8F067D049}"/>
              </a:ext>
            </a:extLst>
          </p:cNvPr>
          <p:cNvSpPr>
            <a:spLocks noGrp="1"/>
          </p:cNvSpPr>
          <p:nvPr>
            <p:ph idx="1"/>
          </p:nvPr>
        </p:nvSpPr>
        <p:spPr>
          <a:xfrm>
            <a:off x="5427023" y="320634"/>
            <a:ext cx="6448302" cy="6424550"/>
          </a:xfrm>
        </p:spPr>
        <p:txBody>
          <a:bodyPr anchor="ctr">
            <a:normAutofit fontScale="92500" lnSpcReduction="20000"/>
          </a:bodyPr>
          <a:lstStyle/>
          <a:p>
            <a:pPr marL="342900" marR="0" lvl="0" indent="-342900">
              <a:spcBef>
                <a:spcPts val="0"/>
              </a:spcBef>
              <a:spcAft>
                <a:spcPts val="0"/>
              </a:spcAft>
              <a:buFont typeface="+mj-lt"/>
              <a:buAutoNum type="arabicPeriod"/>
            </a:pPr>
            <a:r>
              <a:rPr lang="en-US" kern="100" dirty="0">
                <a:effectLst/>
                <a:latin typeface="Calibri" panose="020F0502020204030204" pitchFamily="34" charset="0"/>
                <a:ea typeface="Aptos" panose="020B0004020202020204" pitchFamily="34" charset="0"/>
                <a:cs typeface="Calibri" panose="020F0502020204030204" pitchFamily="34" charset="0"/>
              </a:rPr>
              <a:t>Students will be divided into small groups of </a:t>
            </a:r>
            <a:r>
              <a:rPr lang="en-US" b="1" kern="100" dirty="0">
                <a:effectLst/>
                <a:latin typeface="Calibri" panose="020F0502020204030204" pitchFamily="34" charset="0"/>
                <a:ea typeface="Aptos" panose="020B0004020202020204" pitchFamily="34" charset="0"/>
                <a:cs typeface="Calibri" panose="020F0502020204030204" pitchFamily="34" charset="0"/>
              </a:rPr>
              <a:t>five</a:t>
            </a:r>
            <a:r>
              <a:rPr lang="en-US" kern="100" dirty="0">
                <a:effectLst/>
                <a:latin typeface="Calibri" panose="020F0502020204030204" pitchFamily="34" charset="0"/>
                <a:ea typeface="Aptos" panose="020B0004020202020204" pitchFamily="34" charset="0"/>
                <a:cs typeface="Calibri" panose="020F0502020204030204" pitchFamily="34" charset="0"/>
              </a:rPr>
              <a:t> in each. There will be a total of </a:t>
            </a:r>
            <a:r>
              <a:rPr lang="en-US" b="1" kern="100" dirty="0">
                <a:effectLst/>
                <a:latin typeface="Calibri" panose="020F0502020204030204" pitchFamily="34" charset="0"/>
                <a:ea typeface="Aptos" panose="020B0004020202020204" pitchFamily="34" charset="0"/>
                <a:cs typeface="Calibri" panose="020F0502020204030204" pitchFamily="34" charset="0"/>
              </a:rPr>
              <a:t>30 groups.</a:t>
            </a:r>
            <a:endParaRPr lang="en-US" kern="100" dirty="0">
              <a:effectLst/>
              <a:latin typeface="Calibri" panose="020F0502020204030204" pitchFamily="34" charset="0"/>
              <a:ea typeface="Aptos" panose="020B0004020202020204" pitchFamily="34" charset="0"/>
              <a:cs typeface="Calibri" panose="020F0502020204030204" pitchFamily="34" charset="0"/>
            </a:endParaRPr>
          </a:p>
          <a:p>
            <a:pPr marL="342900" marR="0" lvl="0" indent="-342900">
              <a:spcBef>
                <a:spcPts val="0"/>
              </a:spcBef>
              <a:spcAft>
                <a:spcPts val="0"/>
              </a:spcAft>
              <a:buFont typeface="+mj-lt"/>
              <a:buAutoNum type="arabicPeriod"/>
            </a:pPr>
            <a:r>
              <a:rPr lang="en-US" kern="100" dirty="0">
                <a:effectLst/>
                <a:latin typeface="Calibri" panose="020F0502020204030204" pitchFamily="34" charset="0"/>
                <a:ea typeface="Aptos" panose="020B0004020202020204" pitchFamily="34" charset="0"/>
                <a:cs typeface="Calibri" panose="020F0502020204030204" pitchFamily="34" charset="0"/>
              </a:rPr>
              <a:t>Each group will be allotted a faculty facilitator to guide the process. </a:t>
            </a:r>
          </a:p>
          <a:p>
            <a:pPr marL="342900" marR="0" lvl="0" indent="-342900">
              <a:spcBef>
                <a:spcPts val="0"/>
              </a:spcBef>
              <a:spcAft>
                <a:spcPts val="0"/>
              </a:spcAft>
              <a:buFont typeface="+mj-lt"/>
              <a:buAutoNum type="arabicPeriod"/>
            </a:pPr>
            <a:r>
              <a:rPr lang="en-US" kern="100" dirty="0">
                <a:effectLst/>
                <a:latin typeface="Calibri" panose="020F0502020204030204" pitchFamily="34" charset="0"/>
                <a:ea typeface="Aptos" panose="020B0004020202020204" pitchFamily="34" charset="0"/>
                <a:cs typeface="Calibri" panose="020F0502020204030204" pitchFamily="34" charset="0"/>
              </a:rPr>
              <a:t>This activity consists of four parts: </a:t>
            </a:r>
            <a:r>
              <a:rPr lang="en-US" b="1" kern="100" dirty="0">
                <a:solidFill>
                  <a:schemeClr val="accent5">
                    <a:lumMod val="50000"/>
                  </a:schemeClr>
                </a:solidFill>
                <a:effectLst/>
                <a:latin typeface="Calibri" panose="020F0502020204030204" pitchFamily="34" charset="0"/>
                <a:ea typeface="Aptos" panose="020B0004020202020204" pitchFamily="34" charset="0"/>
                <a:cs typeface="Calibri" panose="020F0502020204030204" pitchFamily="34" charset="0"/>
              </a:rPr>
              <a:t>Visual Thinking Strategies (VTS) session, Structured Peer Roleplay, Group Reflection , followed by Plenary Session</a:t>
            </a:r>
          </a:p>
          <a:p>
            <a:pPr marL="342900" marR="0" lvl="0" indent="-342900">
              <a:spcBef>
                <a:spcPts val="0"/>
              </a:spcBef>
              <a:spcAft>
                <a:spcPts val="0"/>
              </a:spcAft>
              <a:buFont typeface="+mj-lt"/>
              <a:buAutoNum type="arabicPeriod"/>
            </a:pPr>
            <a:r>
              <a:rPr lang="en-US" kern="100" dirty="0">
                <a:effectLst/>
                <a:latin typeface="Calibri" panose="020F0502020204030204" pitchFamily="34" charset="0"/>
                <a:ea typeface="Aptos" panose="020B0004020202020204" pitchFamily="34" charset="0"/>
                <a:cs typeface="Calibri" panose="020F0502020204030204" pitchFamily="34" charset="0"/>
              </a:rPr>
              <a:t>The total time for the activity is </a:t>
            </a:r>
            <a:r>
              <a:rPr lang="en-US" b="1" kern="100" dirty="0">
                <a:effectLst/>
                <a:latin typeface="Calibri" panose="020F0502020204030204" pitchFamily="34" charset="0"/>
                <a:ea typeface="Aptos" panose="020B0004020202020204" pitchFamily="34" charset="0"/>
                <a:cs typeface="Calibri" panose="020F0502020204030204" pitchFamily="34" charset="0"/>
              </a:rPr>
              <a:t>180 minutes.</a:t>
            </a:r>
            <a:r>
              <a:rPr lang="en-US" kern="100" dirty="0">
                <a:effectLst/>
                <a:latin typeface="Calibri" panose="020F0502020204030204" pitchFamily="34" charset="0"/>
                <a:ea typeface="Aptos" panose="020B0004020202020204" pitchFamily="34" charset="0"/>
                <a:cs typeface="Calibri" panose="020F0502020204030204" pitchFamily="34" charset="0"/>
              </a:rPr>
              <a:t> The time will be divided as follows:</a:t>
            </a:r>
          </a:p>
          <a:p>
            <a:pPr marL="457200" marR="0">
              <a:spcBef>
                <a:spcPts val="0"/>
              </a:spcBef>
              <a:spcAft>
                <a:spcPts val="0"/>
              </a:spcAft>
            </a:pPr>
            <a:r>
              <a:rPr lang="en-US" b="1" kern="100" dirty="0">
                <a:effectLst/>
                <a:latin typeface="Calibri" panose="020F0502020204030204" pitchFamily="34" charset="0"/>
                <a:ea typeface="Aptos" panose="020B0004020202020204" pitchFamily="34" charset="0"/>
                <a:cs typeface="Calibri" panose="020F0502020204030204" pitchFamily="34" charset="0"/>
              </a:rPr>
              <a:t>Visual Thinking Strategies (VTS) session: 30 minutes</a:t>
            </a:r>
            <a:endParaRPr lang="en-US" kern="100" dirty="0">
              <a:effectLst/>
              <a:latin typeface="Calibri" panose="020F0502020204030204" pitchFamily="34" charset="0"/>
              <a:ea typeface="Aptos" panose="020B0004020202020204" pitchFamily="34" charset="0"/>
              <a:cs typeface="Calibri" panose="020F0502020204030204" pitchFamily="34" charset="0"/>
            </a:endParaRPr>
          </a:p>
          <a:p>
            <a:pPr marL="457200" marR="0">
              <a:spcBef>
                <a:spcPts val="0"/>
              </a:spcBef>
              <a:spcAft>
                <a:spcPts val="0"/>
              </a:spcAft>
            </a:pPr>
            <a:r>
              <a:rPr lang="en-US" b="1" kern="100" dirty="0">
                <a:effectLst/>
                <a:latin typeface="Calibri" panose="020F0502020204030204" pitchFamily="34" charset="0"/>
                <a:ea typeface="Aptos" panose="020B0004020202020204" pitchFamily="34" charset="0"/>
                <a:cs typeface="Calibri" panose="020F0502020204030204" pitchFamily="34" charset="0"/>
              </a:rPr>
              <a:t>Structured Peer Roleplay: 45 minutes.</a:t>
            </a:r>
            <a:endParaRPr lang="en-US" kern="100" dirty="0">
              <a:effectLst/>
              <a:latin typeface="Calibri" panose="020F0502020204030204" pitchFamily="34" charset="0"/>
              <a:ea typeface="Aptos" panose="020B0004020202020204" pitchFamily="34" charset="0"/>
              <a:cs typeface="Calibri" panose="020F0502020204030204" pitchFamily="34" charset="0"/>
            </a:endParaRPr>
          </a:p>
          <a:p>
            <a:pPr marL="457200" marR="0">
              <a:spcBef>
                <a:spcPts val="0"/>
              </a:spcBef>
              <a:spcAft>
                <a:spcPts val="800"/>
              </a:spcAft>
            </a:pPr>
            <a:r>
              <a:rPr lang="en-US" b="1" kern="100" dirty="0">
                <a:effectLst/>
                <a:latin typeface="Calibri" panose="020F0502020204030204" pitchFamily="34" charset="0"/>
                <a:ea typeface="Aptos" panose="020B0004020202020204" pitchFamily="34" charset="0"/>
                <a:cs typeface="Calibri" panose="020F0502020204030204" pitchFamily="34" charset="0"/>
              </a:rPr>
              <a:t>Group Reflection: 25 minutes</a:t>
            </a:r>
          </a:p>
          <a:p>
            <a:pPr marL="457200" marR="0">
              <a:spcBef>
                <a:spcPts val="0"/>
              </a:spcBef>
              <a:spcAft>
                <a:spcPts val="800"/>
              </a:spcAft>
            </a:pPr>
            <a:r>
              <a:rPr lang="en-US" b="1" kern="100" dirty="0">
                <a:latin typeface="Calibri" panose="020F0502020204030204" pitchFamily="34" charset="0"/>
                <a:ea typeface="Aptos" panose="020B0004020202020204" pitchFamily="34" charset="0"/>
                <a:cs typeface="Calibri" panose="020F0502020204030204" pitchFamily="34" charset="0"/>
              </a:rPr>
              <a:t>Plenary Session &amp; post session assessment: 60-80 minutes</a:t>
            </a:r>
            <a:endParaRPr lang="en-US" kern="100" dirty="0">
              <a:effectLst/>
              <a:latin typeface="Calibri" panose="020F0502020204030204" pitchFamily="34" charset="0"/>
              <a:ea typeface="Aptos" panose="020B0004020202020204" pitchFamily="34" charset="0"/>
              <a:cs typeface="Calibri" panose="020F0502020204030204" pitchFamily="34" charset="0"/>
            </a:endParaRPr>
          </a:p>
        </p:txBody>
      </p:sp>
    </p:spTree>
    <p:extLst>
      <p:ext uri="{BB962C8B-B14F-4D97-AF65-F5344CB8AC3E}">
        <p14:creationId xmlns:p14="http://schemas.microsoft.com/office/powerpoint/2010/main" val="221169299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EDBF96B-78F7-4143-F505-7D461148BD4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613A836-4C35-1E26-2342-E92313855641}"/>
              </a:ext>
            </a:extLst>
          </p:cNvPr>
          <p:cNvSpPr>
            <a:spLocks noGrp="1"/>
          </p:cNvSpPr>
          <p:nvPr>
            <p:ph type="title"/>
          </p:nvPr>
        </p:nvSpPr>
        <p:spPr/>
        <p:txBody>
          <a:bodyPr/>
          <a:lstStyle/>
          <a:p>
            <a:r>
              <a:rPr lang="en-US" b="1" dirty="0"/>
              <a:t>ART 12</a:t>
            </a:r>
          </a:p>
        </p:txBody>
      </p:sp>
      <p:sp>
        <p:nvSpPr>
          <p:cNvPr id="3" name="Content Placeholder 2">
            <a:extLst>
              <a:ext uri="{FF2B5EF4-FFF2-40B4-BE49-F238E27FC236}">
                <a16:creationId xmlns:a16="http://schemas.microsoft.com/office/drawing/2014/main" id="{FA4C4FC9-98EE-37BF-FD21-94BBEC83F041}"/>
              </a:ext>
            </a:extLst>
          </p:cNvPr>
          <p:cNvSpPr>
            <a:spLocks noGrp="1"/>
          </p:cNvSpPr>
          <p:nvPr>
            <p:ph idx="1"/>
          </p:nvPr>
        </p:nvSpPr>
        <p:spPr>
          <a:xfrm>
            <a:off x="838200" y="2011680"/>
            <a:ext cx="3776330" cy="4160520"/>
          </a:xfrm>
        </p:spPr>
        <p:txBody>
          <a:bodyPr/>
          <a:lstStyle/>
          <a:p>
            <a:pPr marL="0" indent="0">
              <a:buNone/>
            </a:pPr>
            <a:r>
              <a:rPr lang="en-US" b="1" dirty="0">
                <a:solidFill>
                  <a:schemeClr val="accent5">
                    <a:lumMod val="50000"/>
                  </a:schemeClr>
                </a:solidFill>
              </a:rPr>
              <a:t>Christian </a:t>
            </a:r>
            <a:r>
              <a:rPr lang="en-US" b="1" dirty="0" err="1">
                <a:solidFill>
                  <a:schemeClr val="accent5">
                    <a:lumMod val="50000"/>
                  </a:schemeClr>
                </a:solidFill>
              </a:rPr>
              <a:t>Krohg</a:t>
            </a:r>
            <a:r>
              <a:rPr lang="en-US" b="1" dirty="0">
                <a:solidFill>
                  <a:schemeClr val="accent5">
                    <a:lumMod val="50000"/>
                  </a:schemeClr>
                </a:solidFill>
              </a:rPr>
              <a:t>, Sick Girl, 1880–1881</a:t>
            </a:r>
          </a:p>
        </p:txBody>
      </p:sp>
      <p:pic>
        <p:nvPicPr>
          <p:cNvPr id="5122" name="Picture 2" descr="sickness in art: Christian Krohg, Sick Girl, 1880–1881, National Museum of Art, Architecture and Design, Oslo, Norway. Museum’s website.&#10;">
            <a:extLst>
              <a:ext uri="{FF2B5EF4-FFF2-40B4-BE49-F238E27FC236}">
                <a16:creationId xmlns:a16="http://schemas.microsoft.com/office/drawing/2014/main" id="{B76B06DE-2B1D-B9C8-7AF3-A2E0BE618320}"/>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24341"/>
          <a:stretch/>
        </p:blipFill>
        <p:spPr bwMode="auto">
          <a:xfrm>
            <a:off x="5170483" y="0"/>
            <a:ext cx="7021517"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359544125"/>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EA38A0B-6F65-1CE1-DA84-AED1404EE78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1FD2036-77C8-8888-89D8-5A1DB81D93C7}"/>
              </a:ext>
            </a:extLst>
          </p:cNvPr>
          <p:cNvSpPr>
            <a:spLocks noGrp="1"/>
          </p:cNvSpPr>
          <p:nvPr>
            <p:ph type="title"/>
          </p:nvPr>
        </p:nvSpPr>
        <p:spPr/>
        <p:txBody>
          <a:bodyPr/>
          <a:lstStyle/>
          <a:p>
            <a:r>
              <a:rPr lang="en-US" b="1" dirty="0"/>
              <a:t>ART 13</a:t>
            </a:r>
          </a:p>
        </p:txBody>
      </p:sp>
      <p:sp>
        <p:nvSpPr>
          <p:cNvPr id="3" name="Content Placeholder 2">
            <a:extLst>
              <a:ext uri="{FF2B5EF4-FFF2-40B4-BE49-F238E27FC236}">
                <a16:creationId xmlns:a16="http://schemas.microsoft.com/office/drawing/2014/main" id="{9182E131-574F-077B-0A51-BA27DBBAB8E6}"/>
              </a:ext>
            </a:extLst>
          </p:cNvPr>
          <p:cNvSpPr>
            <a:spLocks noGrp="1"/>
          </p:cNvSpPr>
          <p:nvPr>
            <p:ph idx="1"/>
          </p:nvPr>
        </p:nvSpPr>
        <p:spPr>
          <a:xfrm>
            <a:off x="838200" y="2011680"/>
            <a:ext cx="4414284" cy="4160520"/>
          </a:xfrm>
        </p:spPr>
        <p:txBody>
          <a:bodyPr/>
          <a:lstStyle/>
          <a:p>
            <a:r>
              <a:rPr lang="en-US" b="1" dirty="0" err="1">
                <a:solidFill>
                  <a:schemeClr val="accent5">
                    <a:lumMod val="50000"/>
                  </a:schemeClr>
                </a:solidFill>
              </a:rPr>
              <a:t>Gabriël</a:t>
            </a:r>
            <a:r>
              <a:rPr lang="en-US" b="1" dirty="0">
                <a:solidFill>
                  <a:schemeClr val="accent5">
                    <a:lumMod val="50000"/>
                  </a:schemeClr>
                </a:solidFill>
              </a:rPr>
              <a:t> </a:t>
            </a:r>
            <a:r>
              <a:rPr lang="en-US" b="1" dirty="0" err="1">
                <a:solidFill>
                  <a:schemeClr val="accent5">
                    <a:lumMod val="50000"/>
                  </a:schemeClr>
                </a:solidFill>
              </a:rPr>
              <a:t>Metsu</a:t>
            </a:r>
            <a:r>
              <a:rPr lang="en-US" b="1" dirty="0">
                <a:solidFill>
                  <a:schemeClr val="accent5">
                    <a:lumMod val="50000"/>
                  </a:schemeClr>
                </a:solidFill>
              </a:rPr>
              <a:t>, The Sick Child, ca 1663–1664,</a:t>
            </a:r>
          </a:p>
        </p:txBody>
      </p:sp>
      <p:pic>
        <p:nvPicPr>
          <p:cNvPr id="4098" name="Picture 2" descr="sickness in art: Gabriël Metsu, The Sick Child, ca 1663–1664, Rijksmuseum, Amsterdam, Netherlands. Museum’s website.&#10;">
            <a:extLst>
              <a:ext uri="{FF2B5EF4-FFF2-40B4-BE49-F238E27FC236}">
                <a16:creationId xmlns:a16="http://schemas.microsoft.com/office/drawing/2014/main" id="{77F085B6-DEF5-FE9A-7F9E-C2612FFBF7D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961888" y="0"/>
            <a:ext cx="6096000"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50224015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787A82F-CC5C-EE34-5775-560B46D9AD2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69A6FA3-A8F5-79CE-FE09-08119DAB1986}"/>
              </a:ext>
            </a:extLst>
          </p:cNvPr>
          <p:cNvSpPr>
            <a:spLocks noGrp="1"/>
          </p:cNvSpPr>
          <p:nvPr>
            <p:ph type="title"/>
          </p:nvPr>
        </p:nvSpPr>
        <p:spPr/>
        <p:txBody>
          <a:bodyPr/>
          <a:lstStyle/>
          <a:p>
            <a:r>
              <a:rPr lang="en-US" b="1" dirty="0"/>
              <a:t>ART 14</a:t>
            </a:r>
          </a:p>
        </p:txBody>
      </p:sp>
      <p:sp>
        <p:nvSpPr>
          <p:cNvPr id="3" name="Content Placeholder 2">
            <a:extLst>
              <a:ext uri="{FF2B5EF4-FFF2-40B4-BE49-F238E27FC236}">
                <a16:creationId xmlns:a16="http://schemas.microsoft.com/office/drawing/2014/main" id="{F254E5E2-3EFB-F28A-1C44-5217BA2FA2BA}"/>
              </a:ext>
            </a:extLst>
          </p:cNvPr>
          <p:cNvSpPr>
            <a:spLocks noGrp="1"/>
          </p:cNvSpPr>
          <p:nvPr>
            <p:ph idx="1"/>
          </p:nvPr>
        </p:nvSpPr>
        <p:spPr>
          <a:xfrm>
            <a:off x="668079" y="2055813"/>
            <a:ext cx="2630487" cy="4160520"/>
          </a:xfrm>
        </p:spPr>
        <p:txBody>
          <a:bodyPr/>
          <a:lstStyle/>
          <a:p>
            <a:pPr marL="0" indent="0">
              <a:buNone/>
            </a:pPr>
            <a:r>
              <a:rPr lang="en-US" b="1" dirty="0">
                <a:solidFill>
                  <a:schemeClr val="accent5">
                    <a:lumMod val="50000"/>
                  </a:schemeClr>
                </a:solidFill>
              </a:rPr>
              <a:t>Frida Kahlo, Henry Ford Hospital, 1932,</a:t>
            </a:r>
          </a:p>
        </p:txBody>
      </p:sp>
      <p:pic>
        <p:nvPicPr>
          <p:cNvPr id="6146" name="Picture 2" descr="sickness in art: Frida Kahlo, Henry Ford Hospital, 1932, Museo Dolores Olmedo, Mexico, Mexico. Artist’s website.&#10;">
            <a:extLst>
              <a:ext uri="{FF2B5EF4-FFF2-40B4-BE49-F238E27FC236}">
                <a16:creationId xmlns:a16="http://schemas.microsoft.com/office/drawing/2014/main" id="{4D12C456-E3B9-5A08-C7A7-759F0FEF1DCC}"/>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468687" y="0"/>
            <a:ext cx="8723313"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955997271"/>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BABA745-35B0-39F7-4118-9DE81C22208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458CF4D-56FC-3F4E-FFF1-2DCD43B855B2}"/>
              </a:ext>
            </a:extLst>
          </p:cNvPr>
          <p:cNvSpPr>
            <a:spLocks noGrp="1"/>
          </p:cNvSpPr>
          <p:nvPr>
            <p:ph type="title"/>
          </p:nvPr>
        </p:nvSpPr>
        <p:spPr/>
        <p:txBody>
          <a:bodyPr/>
          <a:lstStyle/>
          <a:p>
            <a:r>
              <a:rPr lang="en-US" b="1" dirty="0"/>
              <a:t>ART 15</a:t>
            </a:r>
          </a:p>
        </p:txBody>
      </p:sp>
      <p:sp>
        <p:nvSpPr>
          <p:cNvPr id="5" name="TextBox 4">
            <a:extLst>
              <a:ext uri="{FF2B5EF4-FFF2-40B4-BE49-F238E27FC236}">
                <a16:creationId xmlns:a16="http://schemas.microsoft.com/office/drawing/2014/main" id="{766C497B-DFB9-EC21-FC62-3CD1CA5CA556}"/>
              </a:ext>
            </a:extLst>
          </p:cNvPr>
          <p:cNvSpPr txBox="1"/>
          <p:nvPr/>
        </p:nvSpPr>
        <p:spPr>
          <a:xfrm>
            <a:off x="390660" y="2055813"/>
            <a:ext cx="4819293" cy="2246769"/>
          </a:xfrm>
          <a:prstGeom prst="rect">
            <a:avLst/>
          </a:prstGeom>
          <a:noFill/>
        </p:spPr>
        <p:txBody>
          <a:bodyPr wrap="square">
            <a:spAutoFit/>
          </a:bodyPr>
          <a:lstStyle/>
          <a:p>
            <a:r>
              <a:rPr lang="en-US" sz="2800" b="1" i="0" dirty="0">
                <a:solidFill>
                  <a:schemeClr val="accent5">
                    <a:lumMod val="50000"/>
                  </a:schemeClr>
                </a:solidFill>
                <a:effectLst/>
              </a:rPr>
              <a:t>Jan Steen, </a:t>
            </a:r>
            <a:r>
              <a:rPr lang="en-US" sz="2800" b="1" i="1" u="none" strike="noStrike" dirty="0">
                <a:solidFill>
                  <a:schemeClr val="accent5">
                    <a:lumMod val="50000"/>
                  </a:schemeClr>
                </a:solidFill>
                <a:effectLst/>
              </a:rPr>
              <a:t>The Sick Woman</a:t>
            </a:r>
            <a:r>
              <a:rPr lang="en-US" sz="2800" b="1" i="0" dirty="0">
                <a:solidFill>
                  <a:schemeClr val="accent5">
                    <a:lumMod val="50000"/>
                  </a:schemeClr>
                </a:solidFill>
                <a:effectLst/>
              </a:rPr>
              <a:t>, ca. 1660, Museum </a:t>
            </a:r>
            <a:r>
              <a:rPr lang="en-US" sz="2800" b="1" i="0" dirty="0" err="1">
                <a:solidFill>
                  <a:schemeClr val="accent5">
                    <a:lumMod val="50000"/>
                  </a:schemeClr>
                </a:solidFill>
                <a:effectLst/>
              </a:rPr>
              <a:t>Boijmans</a:t>
            </a:r>
            <a:r>
              <a:rPr lang="en-US" sz="2800" b="1" i="0" dirty="0">
                <a:solidFill>
                  <a:schemeClr val="accent5">
                    <a:lumMod val="50000"/>
                  </a:schemeClr>
                </a:solidFill>
                <a:effectLst/>
              </a:rPr>
              <a:t> van </a:t>
            </a:r>
            <a:r>
              <a:rPr lang="en-US" sz="2800" b="1" i="0" dirty="0" err="1">
                <a:solidFill>
                  <a:schemeClr val="accent5">
                    <a:lumMod val="50000"/>
                  </a:schemeClr>
                </a:solidFill>
                <a:effectLst/>
              </a:rPr>
              <a:t>Beuningen</a:t>
            </a:r>
            <a:r>
              <a:rPr lang="en-US" sz="2800" b="1" i="0" dirty="0">
                <a:solidFill>
                  <a:schemeClr val="accent5">
                    <a:lumMod val="50000"/>
                  </a:schemeClr>
                </a:solidFill>
                <a:effectLst/>
              </a:rPr>
              <a:t>, Rotterdam, Netherlands</a:t>
            </a:r>
            <a:endParaRPr lang="en-US" sz="2800" b="1" dirty="0">
              <a:solidFill>
                <a:schemeClr val="accent5">
                  <a:lumMod val="50000"/>
                </a:schemeClr>
              </a:solidFill>
            </a:endParaRPr>
          </a:p>
        </p:txBody>
      </p:sp>
      <p:sp>
        <p:nvSpPr>
          <p:cNvPr id="3" name="Content Placeholder 2">
            <a:extLst>
              <a:ext uri="{FF2B5EF4-FFF2-40B4-BE49-F238E27FC236}">
                <a16:creationId xmlns:a16="http://schemas.microsoft.com/office/drawing/2014/main" id="{CE3E7695-2D8E-589A-3444-30D0397AFD75}"/>
              </a:ext>
            </a:extLst>
          </p:cNvPr>
          <p:cNvSpPr>
            <a:spLocks noGrp="1"/>
          </p:cNvSpPr>
          <p:nvPr>
            <p:ph idx="1"/>
          </p:nvPr>
        </p:nvSpPr>
        <p:spPr/>
        <p:txBody>
          <a:bodyPr/>
          <a:lstStyle/>
          <a:p>
            <a:endParaRPr lang="en-US"/>
          </a:p>
        </p:txBody>
      </p:sp>
      <p:sp>
        <p:nvSpPr>
          <p:cNvPr id="4" name="Rectangle 2">
            <a:extLst>
              <a:ext uri="{FF2B5EF4-FFF2-40B4-BE49-F238E27FC236}">
                <a16:creationId xmlns:a16="http://schemas.microsoft.com/office/drawing/2014/main" id="{9AD29DB7-19EF-BB60-5B35-B3B9F35F578D}"/>
              </a:ext>
            </a:extLst>
          </p:cNvPr>
          <p:cNvSpPr>
            <a:spLocks noChangeArrowheads="1"/>
          </p:cNvSpPr>
          <p:nvPr/>
        </p:nvSpPr>
        <p:spPr bwMode="auto">
          <a:xfrm>
            <a:off x="5857740" y="-1"/>
            <a:ext cx="11273969" cy="457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en-US"/>
          </a:p>
        </p:txBody>
      </p:sp>
      <p:pic>
        <p:nvPicPr>
          <p:cNvPr id="1025" name="Picture 4" descr="A painting of a person sitting at a table&#10;&#10;Description automatically generated">
            <a:extLst>
              <a:ext uri="{FF2B5EF4-FFF2-40B4-BE49-F238E27FC236}">
                <a16:creationId xmlns:a16="http://schemas.microsoft.com/office/drawing/2014/main" id="{E1BC3EC0-36C2-615B-2EBF-D1BD6C950845}"/>
              </a:ext>
            </a:extLst>
          </p:cNvPr>
          <p:cNvPicPr>
            <a:picLocks noChangeAspect="1" noChangeArrowheads="1"/>
          </p:cNvPicPr>
          <p:nvPr/>
        </p:nvPicPr>
        <p:blipFill>
          <a:blip r:embed="rId3" r:link="rId4">
            <a:extLst>
              <a:ext uri="{28A0092B-C50C-407E-A947-70E740481C1C}">
                <a14:useLocalDpi xmlns:a14="http://schemas.microsoft.com/office/drawing/2010/main" val="0"/>
              </a:ext>
            </a:extLst>
          </a:blip>
          <a:srcRect/>
          <a:stretch>
            <a:fillRect/>
          </a:stretch>
        </p:blipFill>
        <p:spPr bwMode="auto">
          <a:xfrm>
            <a:off x="5857740" y="0"/>
            <a:ext cx="5556229" cy="662473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27000060"/>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9BBA93B3-FC15-CF24-67A3-2A356DF3FAF2}"/>
            </a:ext>
          </a:extLst>
        </p:cNvPr>
        <p:cNvGrpSpPr/>
        <p:nvPr/>
      </p:nvGrpSpPr>
      <p:grpSpPr>
        <a:xfrm>
          <a:off x="0" y="0"/>
          <a:ext cx="0" cy="0"/>
          <a:chOff x="0" y="0"/>
          <a:chExt cx="0" cy="0"/>
        </a:xfrm>
      </p:grpSpPr>
      <p:sp useBgFill="1">
        <p:nvSpPr>
          <p:cNvPr id="13" name="Rectangle 12">
            <a:extLst>
              <a:ext uri="{FF2B5EF4-FFF2-40B4-BE49-F238E27FC236}">
                <a16:creationId xmlns:a16="http://schemas.microsoft.com/office/drawing/2014/main" id="{626F9BE5-5B21-D008-EE86-F16C13C63A2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entury Gothic"/>
              <a:ea typeface="+mn-ea"/>
              <a:cs typeface="+mn-cs"/>
            </a:endParaRPr>
          </a:p>
        </p:txBody>
      </p:sp>
      <p:sp>
        <p:nvSpPr>
          <p:cNvPr id="14" name="Freeform: Shape 10">
            <a:extLst>
              <a:ext uri="{FF2B5EF4-FFF2-40B4-BE49-F238E27FC236}">
                <a16:creationId xmlns:a16="http://schemas.microsoft.com/office/drawing/2014/main" id="{2A0E98FC-0107-A768-E203-CAF6FFB1490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0" y="0"/>
            <a:ext cx="12192000" cy="2371134"/>
          </a:xfrm>
          <a:custGeom>
            <a:avLst/>
            <a:gdLst>
              <a:gd name="connsiteX0" fmla="*/ 0 w 12192000"/>
              <a:gd name="connsiteY0" fmla="*/ 0 h 2515690"/>
              <a:gd name="connsiteX1" fmla="*/ 170442 w 12192000"/>
              <a:gd name="connsiteY1" fmla="*/ 96074 h 2515690"/>
              <a:gd name="connsiteX2" fmla="*/ 424739 w 12192000"/>
              <a:gd name="connsiteY2" fmla="*/ 224865 h 2515690"/>
              <a:gd name="connsiteX3" fmla="*/ 748273 w 12192000"/>
              <a:gd name="connsiteY3" fmla="*/ 373939 h 2515690"/>
              <a:gd name="connsiteX4" fmla="*/ 1037058 w 12192000"/>
              <a:gd name="connsiteY4" fmla="*/ 499994 h 2515690"/>
              <a:gd name="connsiteX5" fmla="*/ 1101312 w 12192000"/>
              <a:gd name="connsiteY5" fmla="*/ 428540 h 2515690"/>
              <a:gd name="connsiteX6" fmla="*/ 1367071 w 12192000"/>
              <a:gd name="connsiteY6" fmla="*/ 516118 h 2515690"/>
              <a:gd name="connsiteX7" fmla="*/ 2189943 w 12192000"/>
              <a:gd name="connsiteY7" fmla="*/ 794533 h 2515690"/>
              <a:gd name="connsiteX8" fmla="*/ 2390329 w 12192000"/>
              <a:gd name="connsiteY8" fmla="*/ 920897 h 2515690"/>
              <a:gd name="connsiteX9" fmla="*/ 2459570 w 12192000"/>
              <a:gd name="connsiteY9" fmla="*/ 983740 h 2515690"/>
              <a:gd name="connsiteX10" fmla="*/ 2503252 w 12192000"/>
              <a:gd name="connsiteY10" fmla="*/ 1000151 h 2515690"/>
              <a:gd name="connsiteX11" fmla="*/ 2503252 w 12192000"/>
              <a:gd name="connsiteY11" fmla="*/ 1008273 h 2515690"/>
              <a:gd name="connsiteX12" fmla="*/ 2511191 w 12192000"/>
              <a:gd name="connsiteY12" fmla="*/ 1009499 h 2515690"/>
              <a:gd name="connsiteX13" fmla="*/ 2565029 w 12192000"/>
              <a:gd name="connsiteY13" fmla="*/ 1015977 h 2515690"/>
              <a:gd name="connsiteX14" fmla="*/ 2593745 w 12192000"/>
              <a:gd name="connsiteY14" fmla="*/ 1019963 h 2515690"/>
              <a:gd name="connsiteX15" fmla="*/ 2591015 w 12192000"/>
              <a:gd name="connsiteY15" fmla="*/ 1019651 h 2515690"/>
              <a:gd name="connsiteX16" fmla="*/ 2590137 w 12192000"/>
              <a:gd name="connsiteY16" fmla="*/ 1019549 h 2515690"/>
              <a:gd name="connsiteX17" fmla="*/ 2589021 w 12192000"/>
              <a:gd name="connsiteY17" fmla="*/ 1019424 h 2515690"/>
              <a:gd name="connsiteX18" fmla="*/ 2591015 w 12192000"/>
              <a:gd name="connsiteY18" fmla="*/ 1019651 h 2515690"/>
              <a:gd name="connsiteX19" fmla="*/ 2602385 w 12192000"/>
              <a:gd name="connsiteY19" fmla="*/ 1020975 h 2515690"/>
              <a:gd name="connsiteX20" fmla="*/ 2614445 w 12192000"/>
              <a:gd name="connsiteY20" fmla="*/ 1022389 h 2515690"/>
              <a:gd name="connsiteX21" fmla="*/ 2614445 w 12192000"/>
              <a:gd name="connsiteY21" fmla="*/ 1020966 h 2515690"/>
              <a:gd name="connsiteX22" fmla="*/ 2676661 w 12192000"/>
              <a:gd name="connsiteY22" fmla="*/ 1029355 h 2515690"/>
              <a:gd name="connsiteX23" fmla="*/ 2788597 w 12192000"/>
              <a:gd name="connsiteY23" fmla="*/ 1048926 h 2515690"/>
              <a:gd name="connsiteX24" fmla="*/ 2812742 w 12192000"/>
              <a:gd name="connsiteY24" fmla="*/ 1057667 h 2515690"/>
              <a:gd name="connsiteX25" fmla="*/ 2970201 w 12192000"/>
              <a:gd name="connsiteY25" fmla="*/ 949091 h 2515690"/>
              <a:gd name="connsiteX26" fmla="*/ 3030610 w 12192000"/>
              <a:gd name="connsiteY26" fmla="*/ 1049340 h 2515690"/>
              <a:gd name="connsiteX27" fmla="*/ 3058913 w 12192000"/>
              <a:gd name="connsiteY27" fmla="*/ 1048085 h 2515690"/>
              <a:gd name="connsiteX28" fmla="*/ 3072697 w 12192000"/>
              <a:gd name="connsiteY28" fmla="*/ 1045316 h 2515690"/>
              <a:gd name="connsiteX29" fmla="*/ 3083305 w 12192000"/>
              <a:gd name="connsiteY29" fmla="*/ 1040550 h 2515690"/>
              <a:gd name="connsiteX30" fmla="*/ 3125603 w 12192000"/>
              <a:gd name="connsiteY30" fmla="*/ 1004583 h 2515690"/>
              <a:gd name="connsiteX31" fmla="*/ 3385106 w 12192000"/>
              <a:gd name="connsiteY31" fmla="*/ 1042233 h 2515690"/>
              <a:gd name="connsiteX32" fmla="*/ 3424945 w 12192000"/>
              <a:gd name="connsiteY32" fmla="*/ 1065268 h 2515690"/>
              <a:gd name="connsiteX33" fmla="*/ 3436948 w 12192000"/>
              <a:gd name="connsiteY33" fmla="*/ 1068018 h 2515690"/>
              <a:gd name="connsiteX34" fmla="*/ 3466714 w 12192000"/>
              <a:gd name="connsiteY34" fmla="*/ 1063419 h 2515690"/>
              <a:gd name="connsiteX35" fmla="*/ 3550909 w 12192000"/>
              <a:gd name="connsiteY35" fmla="*/ 1044511 h 2515690"/>
              <a:gd name="connsiteX36" fmla="*/ 3555900 w 12192000"/>
              <a:gd name="connsiteY36" fmla="*/ 1041996 h 2515690"/>
              <a:gd name="connsiteX37" fmla="*/ 3625978 w 12192000"/>
              <a:gd name="connsiteY37" fmla="*/ 1023459 h 2515690"/>
              <a:gd name="connsiteX38" fmla="*/ 3632465 w 12192000"/>
              <a:gd name="connsiteY38" fmla="*/ 1023522 h 2515690"/>
              <a:gd name="connsiteX39" fmla="*/ 3649063 w 12192000"/>
              <a:gd name="connsiteY39" fmla="*/ 1018726 h 2515690"/>
              <a:gd name="connsiteX40" fmla="*/ 3805954 w 12192000"/>
              <a:gd name="connsiteY40" fmla="*/ 917517 h 2515690"/>
              <a:gd name="connsiteX41" fmla="*/ 4020506 w 12192000"/>
              <a:gd name="connsiteY41" fmla="*/ 816231 h 2515690"/>
              <a:gd name="connsiteX42" fmla="*/ 4233682 w 12192000"/>
              <a:gd name="connsiteY42" fmla="*/ 799511 h 2515690"/>
              <a:gd name="connsiteX43" fmla="*/ 4306552 w 12192000"/>
              <a:gd name="connsiteY43" fmla="*/ 610207 h 2515690"/>
              <a:gd name="connsiteX44" fmla="*/ 4816604 w 12192000"/>
              <a:gd name="connsiteY44" fmla="*/ 773163 h 2515690"/>
              <a:gd name="connsiteX45" fmla="*/ 4916502 w 12192000"/>
              <a:gd name="connsiteY45" fmla="*/ 788104 h 2515690"/>
              <a:gd name="connsiteX46" fmla="*/ 5224415 w 12192000"/>
              <a:gd name="connsiteY46" fmla="*/ 674418 h 2515690"/>
              <a:gd name="connsiteX47" fmla="*/ 5274077 w 12192000"/>
              <a:gd name="connsiteY47" fmla="*/ 655978 h 2515690"/>
              <a:gd name="connsiteX48" fmla="*/ 5371217 w 12192000"/>
              <a:gd name="connsiteY48" fmla="*/ 614372 h 2515690"/>
              <a:gd name="connsiteX49" fmla="*/ 5364523 w 12192000"/>
              <a:gd name="connsiteY49" fmla="*/ 502501 h 2515690"/>
              <a:gd name="connsiteX50" fmla="*/ 5457871 w 12192000"/>
              <a:gd name="connsiteY50" fmla="*/ 558285 h 2515690"/>
              <a:gd name="connsiteX51" fmla="*/ 5750580 w 12192000"/>
              <a:gd name="connsiteY51" fmla="*/ 663503 h 2515690"/>
              <a:gd name="connsiteX52" fmla="*/ 5976618 w 12192000"/>
              <a:gd name="connsiteY52" fmla="*/ 582652 h 2515690"/>
              <a:gd name="connsiteX53" fmla="*/ 6009346 w 12192000"/>
              <a:gd name="connsiteY53" fmla="*/ 559470 h 2515690"/>
              <a:gd name="connsiteX54" fmla="*/ 6069735 w 12192000"/>
              <a:gd name="connsiteY54" fmla="*/ 587803 h 2515690"/>
              <a:gd name="connsiteX55" fmla="*/ 6270319 w 12192000"/>
              <a:gd name="connsiteY55" fmla="*/ 643982 h 2515690"/>
              <a:gd name="connsiteX56" fmla="*/ 6406781 w 12192000"/>
              <a:gd name="connsiteY56" fmla="*/ 672327 h 2515690"/>
              <a:gd name="connsiteX57" fmla="*/ 6469508 w 12192000"/>
              <a:gd name="connsiteY57" fmla="*/ 708574 h 2515690"/>
              <a:gd name="connsiteX58" fmla="*/ 6515869 w 12192000"/>
              <a:gd name="connsiteY58" fmla="*/ 715738 h 2515690"/>
              <a:gd name="connsiteX59" fmla="*/ 6725938 w 12192000"/>
              <a:gd name="connsiteY59" fmla="*/ 691128 h 2515690"/>
              <a:gd name="connsiteX60" fmla="*/ 6778240 w 12192000"/>
              <a:gd name="connsiteY60" fmla="*/ 678998 h 2515690"/>
              <a:gd name="connsiteX61" fmla="*/ 6806944 w 12192000"/>
              <a:gd name="connsiteY61" fmla="*/ 646178 h 2515690"/>
              <a:gd name="connsiteX62" fmla="*/ 6830632 w 12192000"/>
              <a:gd name="connsiteY62" fmla="*/ 633915 h 2515690"/>
              <a:gd name="connsiteX63" fmla="*/ 6858072 w 12192000"/>
              <a:gd name="connsiteY63" fmla="*/ 646178 h 2515690"/>
              <a:gd name="connsiteX64" fmla="*/ 6891322 w 12192000"/>
              <a:gd name="connsiteY64" fmla="*/ 678998 h 2515690"/>
              <a:gd name="connsiteX65" fmla="*/ 6951905 w 12192000"/>
              <a:gd name="connsiteY65" fmla="*/ 691128 h 2515690"/>
              <a:gd name="connsiteX66" fmla="*/ 7195246 w 12192000"/>
              <a:gd name="connsiteY66" fmla="*/ 715738 h 2515690"/>
              <a:gd name="connsiteX67" fmla="*/ 7248949 w 12192000"/>
              <a:gd name="connsiteY67" fmla="*/ 708574 h 2515690"/>
              <a:gd name="connsiteX68" fmla="*/ 7321609 w 12192000"/>
              <a:gd name="connsiteY68" fmla="*/ 672327 h 2515690"/>
              <a:gd name="connsiteX69" fmla="*/ 7479684 w 12192000"/>
              <a:gd name="connsiteY69" fmla="*/ 643982 h 2515690"/>
              <a:gd name="connsiteX70" fmla="*/ 7712035 w 12192000"/>
              <a:gd name="connsiteY70" fmla="*/ 587803 h 2515690"/>
              <a:gd name="connsiteX71" fmla="*/ 7781987 w 12192000"/>
              <a:gd name="connsiteY71" fmla="*/ 559470 h 2515690"/>
              <a:gd name="connsiteX72" fmla="*/ 7819900 w 12192000"/>
              <a:gd name="connsiteY72" fmla="*/ 582652 h 2515690"/>
              <a:gd name="connsiteX73" fmla="*/ 8081736 w 12192000"/>
              <a:gd name="connsiteY73" fmla="*/ 663503 h 2515690"/>
              <a:gd name="connsiteX74" fmla="*/ 8420801 w 12192000"/>
              <a:gd name="connsiteY74" fmla="*/ 558285 h 2515690"/>
              <a:gd name="connsiteX75" fmla="*/ 8528933 w 12192000"/>
              <a:gd name="connsiteY75" fmla="*/ 502501 h 2515690"/>
              <a:gd name="connsiteX76" fmla="*/ 8521178 w 12192000"/>
              <a:gd name="connsiteY76" fmla="*/ 614372 h 2515690"/>
              <a:gd name="connsiteX77" fmla="*/ 8633702 w 12192000"/>
              <a:gd name="connsiteY77" fmla="*/ 655978 h 2515690"/>
              <a:gd name="connsiteX78" fmla="*/ 8691231 w 12192000"/>
              <a:gd name="connsiteY78" fmla="*/ 674418 h 2515690"/>
              <a:gd name="connsiteX79" fmla="*/ 9047908 w 12192000"/>
              <a:gd name="connsiteY79" fmla="*/ 788104 h 2515690"/>
              <a:gd name="connsiteX80" fmla="*/ 9163628 w 12192000"/>
              <a:gd name="connsiteY80" fmla="*/ 773163 h 2515690"/>
              <a:gd name="connsiteX81" fmla="*/ 9754459 w 12192000"/>
              <a:gd name="connsiteY81" fmla="*/ 610207 h 2515690"/>
              <a:gd name="connsiteX82" fmla="*/ 9838868 w 12192000"/>
              <a:gd name="connsiteY82" fmla="*/ 799511 h 2515690"/>
              <a:gd name="connsiteX83" fmla="*/ 10085808 w 12192000"/>
              <a:gd name="connsiteY83" fmla="*/ 816231 h 2515690"/>
              <a:gd name="connsiteX84" fmla="*/ 10334338 w 12192000"/>
              <a:gd name="connsiteY84" fmla="*/ 917517 h 2515690"/>
              <a:gd name="connsiteX85" fmla="*/ 10516076 w 12192000"/>
              <a:gd name="connsiteY85" fmla="*/ 1018726 h 2515690"/>
              <a:gd name="connsiteX86" fmla="*/ 10535302 w 12192000"/>
              <a:gd name="connsiteY86" fmla="*/ 1023522 h 2515690"/>
              <a:gd name="connsiteX87" fmla="*/ 10542819 w 12192000"/>
              <a:gd name="connsiteY87" fmla="*/ 1023458 h 2515690"/>
              <a:gd name="connsiteX88" fmla="*/ 10623994 w 12192000"/>
              <a:gd name="connsiteY88" fmla="*/ 1041996 h 2515690"/>
              <a:gd name="connsiteX89" fmla="*/ 10629774 w 12192000"/>
              <a:gd name="connsiteY89" fmla="*/ 1044511 h 2515690"/>
              <a:gd name="connsiteX90" fmla="*/ 10727305 w 12192000"/>
              <a:gd name="connsiteY90" fmla="*/ 1063419 h 2515690"/>
              <a:gd name="connsiteX91" fmla="*/ 10761785 w 12192000"/>
              <a:gd name="connsiteY91" fmla="*/ 1068017 h 2515690"/>
              <a:gd name="connsiteX92" fmla="*/ 10775688 w 12192000"/>
              <a:gd name="connsiteY92" fmla="*/ 1065268 h 2515690"/>
              <a:gd name="connsiteX93" fmla="*/ 10821837 w 12192000"/>
              <a:gd name="connsiteY93" fmla="*/ 1042232 h 2515690"/>
              <a:gd name="connsiteX94" fmla="*/ 11122438 w 12192000"/>
              <a:gd name="connsiteY94" fmla="*/ 1004583 h 2515690"/>
              <a:gd name="connsiteX95" fmla="*/ 11171433 w 12192000"/>
              <a:gd name="connsiteY95" fmla="*/ 1040550 h 2515690"/>
              <a:gd name="connsiteX96" fmla="*/ 11183724 w 12192000"/>
              <a:gd name="connsiteY96" fmla="*/ 1045316 h 2515690"/>
              <a:gd name="connsiteX97" fmla="*/ 11199690 w 12192000"/>
              <a:gd name="connsiteY97" fmla="*/ 1048085 h 2515690"/>
              <a:gd name="connsiteX98" fmla="*/ 11232475 w 12192000"/>
              <a:gd name="connsiteY98" fmla="*/ 1049340 h 2515690"/>
              <a:gd name="connsiteX99" fmla="*/ 11302451 w 12192000"/>
              <a:gd name="connsiteY99" fmla="*/ 949091 h 2515690"/>
              <a:gd name="connsiteX100" fmla="*/ 11484849 w 12192000"/>
              <a:gd name="connsiteY100" fmla="*/ 1057667 h 2515690"/>
              <a:gd name="connsiteX101" fmla="*/ 11512818 w 12192000"/>
              <a:gd name="connsiteY101" fmla="*/ 1048926 h 2515690"/>
              <a:gd name="connsiteX102" fmla="*/ 11642481 w 12192000"/>
              <a:gd name="connsiteY102" fmla="*/ 1029355 h 2515690"/>
              <a:gd name="connsiteX103" fmla="*/ 11714551 w 12192000"/>
              <a:gd name="connsiteY103" fmla="*/ 1020966 h 2515690"/>
              <a:gd name="connsiteX104" fmla="*/ 11714551 w 12192000"/>
              <a:gd name="connsiteY104" fmla="*/ 1022389 h 2515690"/>
              <a:gd name="connsiteX105" fmla="*/ 11728519 w 12192000"/>
              <a:gd name="connsiteY105" fmla="*/ 1020975 h 2515690"/>
              <a:gd name="connsiteX106" fmla="*/ 11741691 w 12192000"/>
              <a:gd name="connsiteY106" fmla="*/ 1019651 h 2515690"/>
              <a:gd name="connsiteX107" fmla="*/ 11743999 w 12192000"/>
              <a:gd name="connsiteY107" fmla="*/ 1019424 h 2515690"/>
              <a:gd name="connsiteX108" fmla="*/ 11742709 w 12192000"/>
              <a:gd name="connsiteY108" fmla="*/ 1019549 h 2515690"/>
              <a:gd name="connsiteX109" fmla="*/ 11741691 w 12192000"/>
              <a:gd name="connsiteY109" fmla="*/ 1019651 h 2515690"/>
              <a:gd name="connsiteX110" fmla="*/ 11738529 w 12192000"/>
              <a:gd name="connsiteY110" fmla="*/ 1019963 h 2515690"/>
              <a:gd name="connsiteX111" fmla="*/ 11771791 w 12192000"/>
              <a:gd name="connsiteY111" fmla="*/ 1015977 h 2515690"/>
              <a:gd name="connsiteX112" fmla="*/ 11834157 w 12192000"/>
              <a:gd name="connsiteY112" fmla="*/ 1009499 h 2515690"/>
              <a:gd name="connsiteX113" fmla="*/ 11843354 w 12192000"/>
              <a:gd name="connsiteY113" fmla="*/ 1008273 h 2515690"/>
              <a:gd name="connsiteX114" fmla="*/ 11843354 w 12192000"/>
              <a:gd name="connsiteY114" fmla="*/ 1000151 h 2515690"/>
              <a:gd name="connsiteX115" fmla="*/ 11893955 w 12192000"/>
              <a:gd name="connsiteY115" fmla="*/ 983740 h 2515690"/>
              <a:gd name="connsiteX116" fmla="*/ 11974160 w 12192000"/>
              <a:gd name="connsiteY116" fmla="*/ 920897 h 2515690"/>
              <a:gd name="connsiteX117" fmla="*/ 12143531 w 12192000"/>
              <a:gd name="connsiteY117" fmla="*/ 823664 h 2515690"/>
              <a:gd name="connsiteX118" fmla="*/ 12192000 w 12192000"/>
              <a:gd name="connsiteY118" fmla="*/ 801163 h 2515690"/>
              <a:gd name="connsiteX119" fmla="*/ 12192000 w 12192000"/>
              <a:gd name="connsiteY119" fmla="*/ 2515690 h 2515690"/>
              <a:gd name="connsiteX120" fmla="*/ 0 w 12192000"/>
              <a:gd name="connsiteY120" fmla="*/ 2515690 h 25156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Lst>
            <a:rect l="l" t="t" r="r" b="b"/>
            <a:pathLst>
              <a:path w="12192000" h="2515690">
                <a:moveTo>
                  <a:pt x="0" y="0"/>
                </a:moveTo>
                <a:lnTo>
                  <a:pt x="170442" y="96074"/>
                </a:lnTo>
                <a:cubicBezTo>
                  <a:pt x="323315" y="179510"/>
                  <a:pt x="418777" y="223899"/>
                  <a:pt x="424739" y="224865"/>
                </a:cubicBezTo>
                <a:cubicBezTo>
                  <a:pt x="573781" y="248496"/>
                  <a:pt x="654649" y="314572"/>
                  <a:pt x="748273" y="373939"/>
                </a:cubicBezTo>
                <a:cubicBezTo>
                  <a:pt x="830321" y="425631"/>
                  <a:pt x="917271" y="480784"/>
                  <a:pt x="1037058" y="499994"/>
                </a:cubicBezTo>
                <a:cubicBezTo>
                  <a:pt x="1195925" y="525362"/>
                  <a:pt x="1048105" y="445478"/>
                  <a:pt x="1101312" y="428540"/>
                </a:cubicBezTo>
                <a:cubicBezTo>
                  <a:pt x="1188473" y="458169"/>
                  <a:pt x="1274625" y="505369"/>
                  <a:pt x="1367071" y="516118"/>
                </a:cubicBezTo>
                <a:cubicBezTo>
                  <a:pt x="1701323" y="554463"/>
                  <a:pt x="1964451" y="648887"/>
                  <a:pt x="2189943" y="794533"/>
                </a:cubicBezTo>
                <a:cubicBezTo>
                  <a:pt x="2255082" y="836300"/>
                  <a:pt x="2357481" y="862342"/>
                  <a:pt x="2390329" y="920897"/>
                </a:cubicBezTo>
                <a:cubicBezTo>
                  <a:pt x="2406050" y="949359"/>
                  <a:pt x="2430126" y="969285"/>
                  <a:pt x="2459570" y="983740"/>
                </a:cubicBezTo>
                <a:lnTo>
                  <a:pt x="2503252" y="1000151"/>
                </a:lnTo>
                <a:lnTo>
                  <a:pt x="2503252" y="1008273"/>
                </a:lnTo>
                <a:lnTo>
                  <a:pt x="2511191" y="1009499"/>
                </a:lnTo>
                <a:cubicBezTo>
                  <a:pt x="2529847" y="1011974"/>
                  <a:pt x="2562849" y="1015701"/>
                  <a:pt x="2565029" y="1015977"/>
                </a:cubicBezTo>
                <a:cubicBezTo>
                  <a:pt x="2610845" y="1021778"/>
                  <a:pt x="2601577" y="1020837"/>
                  <a:pt x="2593745" y="1019963"/>
                </a:cubicBezTo>
                <a:lnTo>
                  <a:pt x="2591015" y="1019651"/>
                </a:lnTo>
                <a:lnTo>
                  <a:pt x="2590137" y="1019549"/>
                </a:lnTo>
                <a:cubicBezTo>
                  <a:pt x="2588203" y="1019326"/>
                  <a:pt x="2588125" y="1019321"/>
                  <a:pt x="2589021" y="1019424"/>
                </a:cubicBezTo>
                <a:lnTo>
                  <a:pt x="2591015" y="1019651"/>
                </a:lnTo>
                <a:lnTo>
                  <a:pt x="2602385" y="1020975"/>
                </a:lnTo>
                <a:lnTo>
                  <a:pt x="2614445" y="1022389"/>
                </a:lnTo>
                <a:lnTo>
                  <a:pt x="2614445" y="1020966"/>
                </a:lnTo>
                <a:lnTo>
                  <a:pt x="2676661" y="1029355"/>
                </a:lnTo>
                <a:cubicBezTo>
                  <a:pt x="2715592" y="1034194"/>
                  <a:pt x="2753901" y="1039695"/>
                  <a:pt x="2788597" y="1048926"/>
                </a:cubicBezTo>
                <a:lnTo>
                  <a:pt x="2812742" y="1057667"/>
                </a:lnTo>
                <a:lnTo>
                  <a:pt x="2970201" y="949091"/>
                </a:lnTo>
                <a:cubicBezTo>
                  <a:pt x="3052785" y="982961"/>
                  <a:pt x="2996105" y="1020057"/>
                  <a:pt x="3030610" y="1049340"/>
                </a:cubicBezTo>
                <a:cubicBezTo>
                  <a:pt x="3039005" y="1048442"/>
                  <a:pt x="3049621" y="1048500"/>
                  <a:pt x="3058913" y="1048085"/>
                </a:cubicBezTo>
                <a:lnTo>
                  <a:pt x="3072697" y="1045316"/>
                </a:lnTo>
                <a:lnTo>
                  <a:pt x="3083305" y="1040550"/>
                </a:lnTo>
                <a:lnTo>
                  <a:pt x="3125603" y="1004583"/>
                </a:lnTo>
                <a:cubicBezTo>
                  <a:pt x="3221669" y="925596"/>
                  <a:pt x="3242489" y="937564"/>
                  <a:pt x="3385106" y="1042233"/>
                </a:cubicBezTo>
                <a:cubicBezTo>
                  <a:pt x="3399403" y="1052670"/>
                  <a:pt x="3412529" y="1060209"/>
                  <a:pt x="3424945" y="1065268"/>
                </a:cubicBezTo>
                <a:lnTo>
                  <a:pt x="3436948" y="1068018"/>
                </a:lnTo>
                <a:lnTo>
                  <a:pt x="3466714" y="1063419"/>
                </a:lnTo>
                <a:lnTo>
                  <a:pt x="3550909" y="1044511"/>
                </a:lnTo>
                <a:lnTo>
                  <a:pt x="3555900" y="1041996"/>
                </a:lnTo>
                <a:cubicBezTo>
                  <a:pt x="3573827" y="1033454"/>
                  <a:pt x="3594382" y="1025941"/>
                  <a:pt x="3625978" y="1023459"/>
                </a:cubicBezTo>
                <a:lnTo>
                  <a:pt x="3632465" y="1023522"/>
                </a:lnTo>
                <a:lnTo>
                  <a:pt x="3649063" y="1018726"/>
                </a:lnTo>
                <a:cubicBezTo>
                  <a:pt x="3741849" y="989371"/>
                  <a:pt x="3810578" y="953657"/>
                  <a:pt x="3805954" y="917517"/>
                </a:cubicBezTo>
                <a:cubicBezTo>
                  <a:pt x="4031729" y="953901"/>
                  <a:pt x="4031729" y="953901"/>
                  <a:pt x="4020506" y="816231"/>
                </a:cubicBezTo>
                <a:cubicBezTo>
                  <a:pt x="4171643" y="865324"/>
                  <a:pt x="4206308" y="864422"/>
                  <a:pt x="4233682" y="799511"/>
                </a:cubicBezTo>
                <a:cubicBezTo>
                  <a:pt x="4260226" y="737017"/>
                  <a:pt x="4254728" y="668575"/>
                  <a:pt x="4306552" y="610207"/>
                </a:cubicBezTo>
                <a:cubicBezTo>
                  <a:pt x="4495313" y="657923"/>
                  <a:pt x="4699922" y="667347"/>
                  <a:pt x="4816604" y="773163"/>
                </a:cubicBezTo>
                <a:cubicBezTo>
                  <a:pt x="4834734" y="789836"/>
                  <a:pt x="4890507" y="799946"/>
                  <a:pt x="4916502" y="788104"/>
                </a:cubicBezTo>
                <a:cubicBezTo>
                  <a:pt x="5013526" y="746101"/>
                  <a:pt x="5238129" y="796871"/>
                  <a:pt x="5224415" y="674418"/>
                </a:cubicBezTo>
                <a:cubicBezTo>
                  <a:pt x="5223051" y="659300"/>
                  <a:pt x="5240524" y="644890"/>
                  <a:pt x="5274077" y="655978"/>
                </a:cubicBezTo>
                <a:cubicBezTo>
                  <a:pt x="5388582" y="694066"/>
                  <a:pt x="5367022" y="644784"/>
                  <a:pt x="5371217" y="614372"/>
                </a:cubicBezTo>
                <a:cubicBezTo>
                  <a:pt x="5375856" y="577567"/>
                  <a:pt x="5319010" y="537578"/>
                  <a:pt x="5364523" y="502501"/>
                </a:cubicBezTo>
                <a:cubicBezTo>
                  <a:pt x="5425408" y="508891"/>
                  <a:pt x="5433299" y="538191"/>
                  <a:pt x="5457871" y="558285"/>
                </a:cubicBezTo>
                <a:cubicBezTo>
                  <a:pt x="5530352" y="617005"/>
                  <a:pt x="5609566" y="664386"/>
                  <a:pt x="5750580" y="663503"/>
                </a:cubicBezTo>
                <a:cubicBezTo>
                  <a:pt x="5864519" y="662926"/>
                  <a:pt x="5966527" y="666650"/>
                  <a:pt x="5976618" y="582652"/>
                </a:cubicBezTo>
                <a:cubicBezTo>
                  <a:pt x="5978145" y="569455"/>
                  <a:pt x="5990792" y="562346"/>
                  <a:pt x="6009346" y="559470"/>
                </a:cubicBezTo>
                <a:cubicBezTo>
                  <a:pt x="6030639" y="568485"/>
                  <a:pt x="6052592" y="577083"/>
                  <a:pt x="6069735" y="587803"/>
                </a:cubicBezTo>
                <a:cubicBezTo>
                  <a:pt x="6126182" y="623812"/>
                  <a:pt x="6196945" y="634730"/>
                  <a:pt x="6270319" y="643982"/>
                </a:cubicBezTo>
                <a:cubicBezTo>
                  <a:pt x="6317101" y="649940"/>
                  <a:pt x="6363466" y="657107"/>
                  <a:pt x="6406781" y="672327"/>
                </a:cubicBezTo>
                <a:cubicBezTo>
                  <a:pt x="6433586" y="681598"/>
                  <a:pt x="6454928" y="693402"/>
                  <a:pt x="6469508" y="708574"/>
                </a:cubicBezTo>
                <a:cubicBezTo>
                  <a:pt x="6482729" y="721786"/>
                  <a:pt x="6496225" y="725422"/>
                  <a:pt x="6515869" y="715738"/>
                </a:cubicBezTo>
                <a:cubicBezTo>
                  <a:pt x="6572200" y="688353"/>
                  <a:pt x="6639257" y="676241"/>
                  <a:pt x="6725938" y="691128"/>
                </a:cubicBezTo>
                <a:cubicBezTo>
                  <a:pt x="6752109" y="695629"/>
                  <a:pt x="6772625" y="691505"/>
                  <a:pt x="6778240" y="678998"/>
                </a:cubicBezTo>
                <a:cubicBezTo>
                  <a:pt x="6784286" y="665981"/>
                  <a:pt x="6794269" y="655280"/>
                  <a:pt x="6806944" y="646178"/>
                </a:cubicBezTo>
                <a:lnTo>
                  <a:pt x="6830632" y="633915"/>
                </a:lnTo>
                <a:lnTo>
                  <a:pt x="6858072" y="646178"/>
                </a:lnTo>
                <a:cubicBezTo>
                  <a:pt x="6872754" y="655280"/>
                  <a:pt x="6884317" y="665981"/>
                  <a:pt x="6891322" y="678998"/>
                </a:cubicBezTo>
                <a:cubicBezTo>
                  <a:pt x="6897826" y="691505"/>
                  <a:pt x="6921592" y="695629"/>
                  <a:pt x="6951905" y="691128"/>
                </a:cubicBezTo>
                <a:cubicBezTo>
                  <a:pt x="7052317" y="676241"/>
                  <a:pt x="7129994" y="688353"/>
                  <a:pt x="7195246" y="715738"/>
                </a:cubicBezTo>
                <a:cubicBezTo>
                  <a:pt x="7217999" y="725422"/>
                  <a:pt x="7233634" y="721786"/>
                  <a:pt x="7248949" y="708574"/>
                </a:cubicBezTo>
                <a:cubicBezTo>
                  <a:pt x="7265838" y="693402"/>
                  <a:pt x="7290560" y="681598"/>
                  <a:pt x="7321609" y="672327"/>
                </a:cubicBezTo>
                <a:cubicBezTo>
                  <a:pt x="7371785" y="657107"/>
                  <a:pt x="7425493" y="649940"/>
                  <a:pt x="7479684" y="643982"/>
                </a:cubicBezTo>
                <a:cubicBezTo>
                  <a:pt x="7564679" y="634730"/>
                  <a:pt x="7646649" y="623812"/>
                  <a:pt x="7712035" y="587803"/>
                </a:cubicBezTo>
                <a:cubicBezTo>
                  <a:pt x="7731892" y="577083"/>
                  <a:pt x="7757322" y="568485"/>
                  <a:pt x="7781987" y="559470"/>
                </a:cubicBezTo>
                <a:cubicBezTo>
                  <a:pt x="7803481" y="562346"/>
                  <a:pt x="7818130" y="569455"/>
                  <a:pt x="7819900" y="582652"/>
                </a:cubicBezTo>
                <a:cubicBezTo>
                  <a:pt x="7831588" y="666650"/>
                  <a:pt x="7949751" y="662926"/>
                  <a:pt x="8081736" y="663503"/>
                </a:cubicBezTo>
                <a:cubicBezTo>
                  <a:pt x="8245081" y="664386"/>
                  <a:pt x="8336842" y="617005"/>
                  <a:pt x="8420801" y="558285"/>
                </a:cubicBezTo>
                <a:cubicBezTo>
                  <a:pt x="8449265" y="538191"/>
                  <a:pt x="8458404" y="508890"/>
                  <a:pt x="8528933" y="502501"/>
                </a:cubicBezTo>
                <a:cubicBezTo>
                  <a:pt x="8581654" y="537578"/>
                  <a:pt x="8515805" y="577567"/>
                  <a:pt x="8521178" y="614372"/>
                </a:cubicBezTo>
                <a:cubicBezTo>
                  <a:pt x="8526038" y="644784"/>
                  <a:pt x="8501063" y="694066"/>
                  <a:pt x="8633702" y="655978"/>
                </a:cubicBezTo>
                <a:cubicBezTo>
                  <a:pt x="8672570" y="644890"/>
                  <a:pt x="8692811" y="659300"/>
                  <a:pt x="8691231" y="674418"/>
                </a:cubicBezTo>
                <a:cubicBezTo>
                  <a:pt x="8675345" y="796871"/>
                  <a:pt x="8935518" y="746101"/>
                  <a:pt x="9047908" y="788104"/>
                </a:cubicBezTo>
                <a:cubicBezTo>
                  <a:pt x="9078021" y="799946"/>
                  <a:pt x="9142627" y="789836"/>
                  <a:pt x="9163628" y="773163"/>
                </a:cubicBezTo>
                <a:cubicBezTo>
                  <a:pt x="9298789" y="667347"/>
                  <a:pt x="9535801" y="657923"/>
                  <a:pt x="9754459" y="610207"/>
                </a:cubicBezTo>
                <a:cubicBezTo>
                  <a:pt x="9814490" y="668575"/>
                  <a:pt x="9808123" y="737017"/>
                  <a:pt x="9838868" y="799511"/>
                </a:cubicBezTo>
                <a:cubicBezTo>
                  <a:pt x="9870579" y="864422"/>
                  <a:pt x="9910733" y="865324"/>
                  <a:pt x="10085808" y="816231"/>
                </a:cubicBezTo>
                <a:cubicBezTo>
                  <a:pt x="10072804" y="953901"/>
                  <a:pt x="10072804" y="953901"/>
                  <a:pt x="10334338" y="917517"/>
                </a:cubicBezTo>
                <a:cubicBezTo>
                  <a:pt x="10328982" y="953657"/>
                  <a:pt x="10408594" y="989371"/>
                  <a:pt x="10516076" y="1018726"/>
                </a:cubicBezTo>
                <a:lnTo>
                  <a:pt x="10535302" y="1023522"/>
                </a:lnTo>
                <a:lnTo>
                  <a:pt x="10542819" y="1023458"/>
                </a:lnTo>
                <a:cubicBezTo>
                  <a:pt x="10579419" y="1025941"/>
                  <a:pt x="10603227" y="1033454"/>
                  <a:pt x="10623994" y="1041996"/>
                </a:cubicBezTo>
                <a:lnTo>
                  <a:pt x="10629774" y="1044511"/>
                </a:lnTo>
                <a:lnTo>
                  <a:pt x="10727305" y="1063419"/>
                </a:lnTo>
                <a:lnTo>
                  <a:pt x="10761785" y="1068017"/>
                </a:lnTo>
                <a:lnTo>
                  <a:pt x="10775688" y="1065268"/>
                </a:lnTo>
                <a:cubicBezTo>
                  <a:pt x="10790070" y="1060209"/>
                  <a:pt x="10805275" y="1052670"/>
                  <a:pt x="10821837" y="1042232"/>
                </a:cubicBezTo>
                <a:cubicBezTo>
                  <a:pt x="10987041" y="937564"/>
                  <a:pt x="11011156" y="925596"/>
                  <a:pt x="11122438" y="1004583"/>
                </a:cubicBezTo>
                <a:lnTo>
                  <a:pt x="11171433" y="1040550"/>
                </a:lnTo>
                <a:lnTo>
                  <a:pt x="11183724" y="1045316"/>
                </a:lnTo>
                <a:lnTo>
                  <a:pt x="11199690" y="1048085"/>
                </a:lnTo>
                <a:cubicBezTo>
                  <a:pt x="11210452" y="1048499"/>
                  <a:pt x="11222752" y="1048442"/>
                  <a:pt x="11232475" y="1049340"/>
                </a:cubicBezTo>
                <a:cubicBezTo>
                  <a:pt x="11272445" y="1020057"/>
                  <a:pt x="11206789" y="982961"/>
                  <a:pt x="11302451" y="949091"/>
                </a:cubicBezTo>
                <a:lnTo>
                  <a:pt x="11484849" y="1057667"/>
                </a:lnTo>
                <a:lnTo>
                  <a:pt x="11512818" y="1048926"/>
                </a:lnTo>
                <a:cubicBezTo>
                  <a:pt x="11553007" y="1039695"/>
                  <a:pt x="11597385" y="1034194"/>
                  <a:pt x="11642481" y="1029355"/>
                </a:cubicBezTo>
                <a:lnTo>
                  <a:pt x="11714551" y="1020966"/>
                </a:lnTo>
                <a:lnTo>
                  <a:pt x="11714551" y="1022389"/>
                </a:lnTo>
                <a:lnTo>
                  <a:pt x="11728519" y="1020975"/>
                </a:lnTo>
                <a:lnTo>
                  <a:pt x="11741691" y="1019651"/>
                </a:lnTo>
                <a:lnTo>
                  <a:pt x="11743999" y="1019424"/>
                </a:lnTo>
                <a:cubicBezTo>
                  <a:pt x="11745037" y="1019320"/>
                  <a:pt x="11744948" y="1019326"/>
                  <a:pt x="11742709" y="1019549"/>
                </a:cubicBezTo>
                <a:lnTo>
                  <a:pt x="11741691" y="1019651"/>
                </a:lnTo>
                <a:lnTo>
                  <a:pt x="11738529" y="1019963"/>
                </a:lnTo>
                <a:cubicBezTo>
                  <a:pt x="11729455" y="1020837"/>
                  <a:pt x="11718720" y="1021778"/>
                  <a:pt x="11771791" y="1015977"/>
                </a:cubicBezTo>
                <a:cubicBezTo>
                  <a:pt x="11774317" y="1015701"/>
                  <a:pt x="11812546" y="1011974"/>
                  <a:pt x="11834157" y="1009499"/>
                </a:cubicBezTo>
                <a:lnTo>
                  <a:pt x="11843354" y="1008273"/>
                </a:lnTo>
                <a:lnTo>
                  <a:pt x="11843354" y="1000151"/>
                </a:lnTo>
                <a:lnTo>
                  <a:pt x="11893955" y="983740"/>
                </a:lnTo>
                <a:cubicBezTo>
                  <a:pt x="11928061" y="969285"/>
                  <a:pt x="11955951" y="949359"/>
                  <a:pt x="11974160" y="920897"/>
                </a:cubicBezTo>
                <a:cubicBezTo>
                  <a:pt x="12002698" y="876981"/>
                  <a:pt x="12076554" y="851353"/>
                  <a:pt x="12143531" y="823664"/>
                </a:cubicBezTo>
                <a:lnTo>
                  <a:pt x="12192000" y="801163"/>
                </a:lnTo>
                <a:lnTo>
                  <a:pt x="12192000" y="2515690"/>
                </a:lnTo>
                <a:lnTo>
                  <a:pt x="0" y="2515690"/>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entury Gothic"/>
              <a:ea typeface="+mn-ea"/>
              <a:cs typeface="+mn-cs"/>
            </a:endParaRPr>
          </a:p>
        </p:txBody>
      </p:sp>
      <p:sp>
        <p:nvSpPr>
          <p:cNvPr id="2" name="Title 1">
            <a:extLst>
              <a:ext uri="{FF2B5EF4-FFF2-40B4-BE49-F238E27FC236}">
                <a16:creationId xmlns:a16="http://schemas.microsoft.com/office/drawing/2014/main" id="{521CDB77-14A1-D614-5DF8-7945EF0247A1}"/>
              </a:ext>
            </a:extLst>
          </p:cNvPr>
          <p:cNvSpPr>
            <a:spLocks noGrp="1"/>
          </p:cNvSpPr>
          <p:nvPr>
            <p:ph type="title"/>
          </p:nvPr>
        </p:nvSpPr>
        <p:spPr>
          <a:xfrm>
            <a:off x="838200" y="365125"/>
            <a:ext cx="10515600" cy="930275"/>
          </a:xfrm>
        </p:spPr>
        <p:txBody>
          <a:bodyPr>
            <a:normAutofit/>
          </a:bodyPr>
          <a:lstStyle/>
          <a:p>
            <a:r>
              <a:rPr lang="en-US" b="1" dirty="0">
                <a:solidFill>
                  <a:schemeClr val="bg1"/>
                </a:solidFill>
              </a:rPr>
              <a:t>Learning Objectives</a:t>
            </a:r>
          </a:p>
        </p:txBody>
      </p:sp>
      <p:sp>
        <p:nvSpPr>
          <p:cNvPr id="6" name="TextBox 5">
            <a:extLst>
              <a:ext uri="{FF2B5EF4-FFF2-40B4-BE49-F238E27FC236}">
                <a16:creationId xmlns:a16="http://schemas.microsoft.com/office/drawing/2014/main" id="{56048A9E-448D-DDD2-6D78-6B27C6BE739D}"/>
              </a:ext>
            </a:extLst>
          </p:cNvPr>
          <p:cNvSpPr txBox="1"/>
          <p:nvPr/>
        </p:nvSpPr>
        <p:spPr>
          <a:xfrm>
            <a:off x="838200" y="2103261"/>
            <a:ext cx="8436439"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400" b="1" i="0" u="none" strike="noStrike" kern="1200" cap="none" spc="0" normalizeH="0" baseline="0" noProof="0" dirty="0">
                <a:ln>
                  <a:noFill/>
                </a:ln>
                <a:solidFill>
                  <a:prstClr val="black"/>
                </a:solidFill>
                <a:effectLst/>
                <a:uLnTx/>
                <a:uFillTx/>
                <a:latin typeface="Century Gothic"/>
                <a:ea typeface="+mn-ea"/>
                <a:cs typeface="+mn-cs"/>
              </a:rPr>
              <a:t>By the end of this session, students will be able to</a:t>
            </a:r>
          </a:p>
        </p:txBody>
      </p:sp>
      <p:graphicFrame>
        <p:nvGraphicFramePr>
          <p:cNvPr id="17" name="Content Placeholder 3">
            <a:extLst>
              <a:ext uri="{FF2B5EF4-FFF2-40B4-BE49-F238E27FC236}">
                <a16:creationId xmlns:a16="http://schemas.microsoft.com/office/drawing/2014/main" id="{7E57BAC6-6F7D-129B-EB55-DBCD6D4512B3}"/>
              </a:ext>
            </a:extLst>
          </p:cNvPr>
          <p:cNvGraphicFramePr>
            <a:graphicFrameLocks noGrp="1"/>
          </p:cNvGraphicFramePr>
          <p:nvPr>
            <p:ph idx="1"/>
          </p:nvPr>
        </p:nvGraphicFramePr>
        <p:xfrm>
          <a:off x="838200" y="2011680"/>
          <a:ext cx="10515600" cy="416052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144464344"/>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449E9D1C-15F8-6343-A65F-67506C852797}"/>
            </a:ext>
          </a:extLst>
        </p:cNvPr>
        <p:cNvGrpSpPr/>
        <p:nvPr/>
      </p:nvGrpSpPr>
      <p:grpSpPr>
        <a:xfrm>
          <a:off x="0" y="0"/>
          <a:ext cx="0" cy="0"/>
          <a:chOff x="0" y="0"/>
          <a:chExt cx="0" cy="0"/>
        </a:xfrm>
      </p:grpSpPr>
      <p:sp>
        <p:nvSpPr>
          <p:cNvPr id="10" name="Graphic 1">
            <a:extLst>
              <a:ext uri="{FF2B5EF4-FFF2-40B4-BE49-F238E27FC236}">
                <a16:creationId xmlns:a16="http://schemas.microsoft.com/office/drawing/2014/main" id="{7DC8027A-C719-F8E0-05D5-CDA045D0958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V="1">
            <a:off x="2599854" y="527562"/>
            <a:ext cx="6992292" cy="5102484"/>
          </a:xfrm>
          <a:custGeom>
            <a:avLst/>
            <a:gdLst/>
            <a:ahLst/>
            <a:cxnLst/>
            <a:rect l="l" t="t" r="r" b="b"/>
            <a:pathLst>
              <a:path w="6886274" h="5025119">
                <a:moveTo>
                  <a:pt x="5458905" y="754119"/>
                </a:moveTo>
                <a:cubicBezTo>
                  <a:pt x="5417216" y="775336"/>
                  <a:pt x="4594585" y="1111088"/>
                  <a:pt x="3455557" y="1027709"/>
                </a:cubicBezTo>
                <a:cubicBezTo>
                  <a:pt x="3415356" y="1024731"/>
                  <a:pt x="3377389" y="1022869"/>
                  <a:pt x="3338677" y="1021381"/>
                </a:cubicBezTo>
                <a:cubicBezTo>
                  <a:pt x="2996224" y="1006119"/>
                  <a:pt x="2660100" y="998674"/>
                  <a:pt x="2518280" y="980435"/>
                </a:cubicBezTo>
                <a:cubicBezTo>
                  <a:pt x="2407355" y="965918"/>
                  <a:pt x="1840075" y="843082"/>
                  <a:pt x="1673687" y="739229"/>
                </a:cubicBezTo>
                <a:cubicBezTo>
                  <a:pt x="1503578" y="632771"/>
                  <a:pt x="1343146" y="515146"/>
                  <a:pt x="1183459" y="397149"/>
                </a:cubicBezTo>
                <a:cubicBezTo>
                  <a:pt x="1114224" y="346153"/>
                  <a:pt x="1040522" y="299624"/>
                  <a:pt x="977987" y="241184"/>
                </a:cubicBezTo>
                <a:cubicBezTo>
                  <a:pt x="915453" y="182372"/>
                  <a:pt x="855896" y="121326"/>
                  <a:pt x="788150" y="66980"/>
                </a:cubicBezTo>
                <a:cubicBezTo>
                  <a:pt x="768794" y="51346"/>
                  <a:pt x="749438" y="34596"/>
                  <a:pt x="721148" y="31990"/>
                </a:cubicBezTo>
                <a:cubicBezTo>
                  <a:pt x="714820" y="31246"/>
                  <a:pt x="708120" y="31618"/>
                  <a:pt x="701792" y="32362"/>
                </a:cubicBezTo>
                <a:cubicBezTo>
                  <a:pt x="694720" y="33107"/>
                  <a:pt x="689136" y="36829"/>
                  <a:pt x="686530" y="43157"/>
                </a:cubicBezTo>
                <a:cubicBezTo>
                  <a:pt x="683925" y="50230"/>
                  <a:pt x="688392" y="54324"/>
                  <a:pt x="693603" y="58046"/>
                </a:cubicBezTo>
                <a:cubicBezTo>
                  <a:pt x="697325" y="60652"/>
                  <a:pt x="701047" y="64747"/>
                  <a:pt x="705886" y="65491"/>
                </a:cubicBezTo>
                <a:cubicBezTo>
                  <a:pt x="736782" y="69958"/>
                  <a:pt x="748321" y="92664"/>
                  <a:pt x="762838" y="112764"/>
                </a:cubicBezTo>
                <a:cubicBezTo>
                  <a:pt x="769166" y="121326"/>
                  <a:pt x="775866" y="128026"/>
                  <a:pt x="764327" y="140309"/>
                </a:cubicBezTo>
                <a:cubicBezTo>
                  <a:pt x="754277" y="151104"/>
                  <a:pt x="764699" y="156688"/>
                  <a:pt x="775121" y="159666"/>
                </a:cubicBezTo>
                <a:cubicBezTo>
                  <a:pt x="789638" y="163760"/>
                  <a:pt x="806761" y="163016"/>
                  <a:pt x="823139" y="176416"/>
                </a:cubicBezTo>
                <a:cubicBezTo>
                  <a:pt x="761721" y="177533"/>
                  <a:pt x="735665" y="142171"/>
                  <a:pt x="707748" y="109414"/>
                </a:cubicBezTo>
                <a:cubicBezTo>
                  <a:pt x="697325" y="97503"/>
                  <a:pt x="690253" y="83358"/>
                  <a:pt x="681319" y="69958"/>
                </a:cubicBezTo>
                <a:cubicBezTo>
                  <a:pt x="670152" y="53580"/>
                  <a:pt x="657124" y="52835"/>
                  <a:pt x="640746" y="67352"/>
                </a:cubicBezTo>
                <a:cubicBezTo>
                  <a:pt x="626229" y="80380"/>
                  <a:pt x="619157" y="79264"/>
                  <a:pt x="614318" y="61396"/>
                </a:cubicBezTo>
                <a:cubicBezTo>
                  <a:pt x="606873" y="33479"/>
                  <a:pt x="589750" y="13751"/>
                  <a:pt x="560716" y="3701"/>
                </a:cubicBezTo>
                <a:cubicBezTo>
                  <a:pt x="554388" y="1467"/>
                  <a:pt x="546572" y="-3372"/>
                  <a:pt x="540616" y="3701"/>
                </a:cubicBezTo>
                <a:cubicBezTo>
                  <a:pt x="535405" y="9656"/>
                  <a:pt x="539871" y="16729"/>
                  <a:pt x="543594" y="21940"/>
                </a:cubicBezTo>
                <a:cubicBezTo>
                  <a:pt x="550294" y="31246"/>
                  <a:pt x="556250" y="40179"/>
                  <a:pt x="558855" y="51346"/>
                </a:cubicBezTo>
                <a:cubicBezTo>
                  <a:pt x="560716" y="58791"/>
                  <a:pt x="562578" y="66980"/>
                  <a:pt x="557366" y="72563"/>
                </a:cubicBezTo>
                <a:cubicBezTo>
                  <a:pt x="535777" y="96386"/>
                  <a:pt x="551411" y="107553"/>
                  <a:pt x="570022" y="120209"/>
                </a:cubicBezTo>
                <a:cubicBezTo>
                  <a:pt x="595706" y="137332"/>
                  <a:pt x="605756" y="162643"/>
                  <a:pt x="599801" y="192794"/>
                </a:cubicBezTo>
                <a:cubicBezTo>
                  <a:pt x="597567" y="205078"/>
                  <a:pt x="599056" y="212522"/>
                  <a:pt x="614318" y="212150"/>
                </a:cubicBezTo>
                <a:cubicBezTo>
                  <a:pt x="620273" y="212150"/>
                  <a:pt x="621762" y="216245"/>
                  <a:pt x="623996" y="220711"/>
                </a:cubicBezTo>
                <a:cubicBezTo>
                  <a:pt x="671641" y="326053"/>
                  <a:pt x="740504" y="418366"/>
                  <a:pt x="821278" y="503235"/>
                </a:cubicBezTo>
                <a:cubicBezTo>
                  <a:pt x="886791" y="572098"/>
                  <a:pt x="959004" y="634260"/>
                  <a:pt x="1033822" y="694562"/>
                </a:cubicBezTo>
                <a:cubicBezTo>
                  <a:pt x="1036055" y="696423"/>
                  <a:pt x="1038289" y="698656"/>
                  <a:pt x="1039406" y="702378"/>
                </a:cubicBezTo>
                <a:cubicBezTo>
                  <a:pt x="1004044" y="694934"/>
                  <a:pt x="973521" y="679672"/>
                  <a:pt x="944114" y="662550"/>
                </a:cubicBezTo>
                <a:cubicBezTo>
                  <a:pt x="865946" y="617138"/>
                  <a:pt x="800061" y="558325"/>
                  <a:pt x="733432" y="500629"/>
                </a:cubicBezTo>
                <a:cubicBezTo>
                  <a:pt x="692858" y="465267"/>
                  <a:pt x="651169" y="431022"/>
                  <a:pt x="606501" y="399755"/>
                </a:cubicBezTo>
                <a:cubicBezTo>
                  <a:pt x="599056" y="394543"/>
                  <a:pt x="593845" y="387843"/>
                  <a:pt x="588634" y="381143"/>
                </a:cubicBezTo>
                <a:cubicBezTo>
                  <a:pt x="585656" y="377421"/>
                  <a:pt x="581934" y="374071"/>
                  <a:pt x="575978" y="375560"/>
                </a:cubicBezTo>
                <a:cubicBezTo>
                  <a:pt x="568533" y="377421"/>
                  <a:pt x="567789" y="383004"/>
                  <a:pt x="567044" y="388588"/>
                </a:cubicBezTo>
                <a:cubicBezTo>
                  <a:pt x="564811" y="406455"/>
                  <a:pt x="569650" y="422461"/>
                  <a:pt x="578956" y="437722"/>
                </a:cubicBezTo>
                <a:cubicBezTo>
                  <a:pt x="603151" y="476806"/>
                  <a:pt x="638885" y="506957"/>
                  <a:pt x="675736" y="535619"/>
                </a:cubicBezTo>
                <a:cubicBezTo>
                  <a:pt x="723381" y="572470"/>
                  <a:pt x="769538" y="610810"/>
                  <a:pt x="811600" y="652872"/>
                </a:cubicBezTo>
                <a:cubicBezTo>
                  <a:pt x="814578" y="655850"/>
                  <a:pt x="820161" y="657711"/>
                  <a:pt x="818300" y="666272"/>
                </a:cubicBezTo>
                <a:cubicBezTo>
                  <a:pt x="791872" y="646544"/>
                  <a:pt x="766932" y="627188"/>
                  <a:pt x="741621" y="608576"/>
                </a:cubicBezTo>
                <a:cubicBezTo>
                  <a:pt x="716681" y="589965"/>
                  <a:pt x="691369" y="571353"/>
                  <a:pt x="666430" y="553114"/>
                </a:cubicBezTo>
                <a:cubicBezTo>
                  <a:pt x="660474" y="548647"/>
                  <a:pt x="654146" y="542319"/>
                  <a:pt x="645585" y="547903"/>
                </a:cubicBezTo>
                <a:cubicBezTo>
                  <a:pt x="636652" y="553486"/>
                  <a:pt x="637768" y="562792"/>
                  <a:pt x="640002" y="570236"/>
                </a:cubicBezTo>
                <a:cubicBezTo>
                  <a:pt x="647074" y="592198"/>
                  <a:pt x="659358" y="611554"/>
                  <a:pt x="675736" y="628677"/>
                </a:cubicBezTo>
                <a:cubicBezTo>
                  <a:pt x="731570" y="685256"/>
                  <a:pt x="795966" y="734018"/>
                  <a:pt x="855896" y="786875"/>
                </a:cubicBezTo>
                <a:cubicBezTo>
                  <a:pt x="888280" y="815537"/>
                  <a:pt x="918058" y="846060"/>
                  <a:pt x="946348" y="877699"/>
                </a:cubicBezTo>
                <a:cubicBezTo>
                  <a:pt x="952676" y="884772"/>
                  <a:pt x="952303" y="891472"/>
                  <a:pt x="950442" y="899661"/>
                </a:cubicBezTo>
                <a:cubicBezTo>
                  <a:pt x="942998" y="932790"/>
                  <a:pt x="954537" y="943957"/>
                  <a:pt x="991760" y="937629"/>
                </a:cubicBezTo>
                <a:cubicBezTo>
                  <a:pt x="1003299" y="935767"/>
                  <a:pt x="1011116" y="937629"/>
                  <a:pt x="1018188" y="945445"/>
                </a:cubicBezTo>
                <a:cubicBezTo>
                  <a:pt x="1103802" y="1042225"/>
                  <a:pt x="1205048" y="1123744"/>
                  <a:pt x="1315601" y="1196329"/>
                </a:cubicBezTo>
                <a:cubicBezTo>
                  <a:pt x="1360641" y="1225735"/>
                  <a:pt x="1407170" y="1253653"/>
                  <a:pt x="1454443" y="1279709"/>
                </a:cubicBezTo>
                <a:cubicBezTo>
                  <a:pt x="1454443" y="1281570"/>
                  <a:pt x="1454443" y="1283804"/>
                  <a:pt x="1454443" y="1285665"/>
                </a:cubicBezTo>
                <a:cubicBezTo>
                  <a:pt x="1454071" y="1288270"/>
                  <a:pt x="1453699" y="1289759"/>
                  <a:pt x="1453327" y="1291993"/>
                </a:cubicBezTo>
                <a:cubicBezTo>
                  <a:pt x="1386697" y="1251792"/>
                  <a:pt x="1320812" y="1210474"/>
                  <a:pt x="1256416" y="1166923"/>
                </a:cubicBezTo>
                <a:cubicBezTo>
                  <a:pt x="1081840" y="1048926"/>
                  <a:pt x="915080" y="922367"/>
                  <a:pt x="745715" y="798786"/>
                </a:cubicBezTo>
                <a:cubicBezTo>
                  <a:pt x="688764" y="757096"/>
                  <a:pt x="643724" y="703867"/>
                  <a:pt x="592356" y="656966"/>
                </a:cubicBezTo>
                <a:cubicBezTo>
                  <a:pt x="558111" y="625699"/>
                  <a:pt x="525354" y="592943"/>
                  <a:pt x="485526" y="567259"/>
                </a:cubicBezTo>
                <a:cubicBezTo>
                  <a:pt x="469148" y="556836"/>
                  <a:pt x="452025" y="547530"/>
                  <a:pt x="430063" y="550136"/>
                </a:cubicBezTo>
                <a:cubicBezTo>
                  <a:pt x="421502" y="551253"/>
                  <a:pt x="411824" y="553486"/>
                  <a:pt x="408846" y="563164"/>
                </a:cubicBezTo>
                <a:cubicBezTo>
                  <a:pt x="406240" y="572842"/>
                  <a:pt x="414057" y="577309"/>
                  <a:pt x="421130" y="581403"/>
                </a:cubicBezTo>
                <a:cubicBezTo>
                  <a:pt x="422991" y="582520"/>
                  <a:pt x="424852" y="584009"/>
                  <a:pt x="426713" y="584009"/>
                </a:cubicBezTo>
                <a:cubicBezTo>
                  <a:pt x="462075" y="586242"/>
                  <a:pt x="470264" y="614532"/>
                  <a:pt x="487015" y="635005"/>
                </a:cubicBezTo>
                <a:cubicBezTo>
                  <a:pt x="492226" y="641333"/>
                  <a:pt x="492598" y="647661"/>
                  <a:pt x="487015" y="655105"/>
                </a:cubicBezTo>
                <a:cubicBezTo>
                  <a:pt x="476964" y="668505"/>
                  <a:pt x="484037" y="674461"/>
                  <a:pt x="497437" y="678183"/>
                </a:cubicBezTo>
                <a:cubicBezTo>
                  <a:pt x="510837" y="681906"/>
                  <a:pt x="525354" y="683022"/>
                  <a:pt x="539871" y="691584"/>
                </a:cubicBezTo>
                <a:cubicBezTo>
                  <a:pt x="516793" y="698656"/>
                  <a:pt x="500787" y="691212"/>
                  <a:pt x="485898" y="681906"/>
                </a:cubicBezTo>
                <a:cubicBezTo>
                  <a:pt x="452397" y="661433"/>
                  <a:pt x="430808" y="631282"/>
                  <a:pt x="410335" y="600387"/>
                </a:cubicBezTo>
                <a:cubicBezTo>
                  <a:pt x="406240" y="594431"/>
                  <a:pt x="402890" y="587731"/>
                  <a:pt x="397307" y="582892"/>
                </a:cubicBezTo>
                <a:cubicBezTo>
                  <a:pt x="386884" y="573214"/>
                  <a:pt x="375717" y="572098"/>
                  <a:pt x="363062" y="584009"/>
                </a:cubicBezTo>
                <a:cubicBezTo>
                  <a:pt x="346311" y="599643"/>
                  <a:pt x="340356" y="598526"/>
                  <a:pt x="334772" y="578426"/>
                </a:cubicBezTo>
                <a:cubicBezTo>
                  <a:pt x="327327" y="551253"/>
                  <a:pt x="310577" y="532269"/>
                  <a:pt x="281915" y="522219"/>
                </a:cubicBezTo>
                <a:cubicBezTo>
                  <a:pt x="275960" y="519985"/>
                  <a:pt x="269632" y="517007"/>
                  <a:pt x="263304" y="521846"/>
                </a:cubicBezTo>
                <a:cubicBezTo>
                  <a:pt x="256604" y="527430"/>
                  <a:pt x="261070" y="533013"/>
                  <a:pt x="263676" y="538225"/>
                </a:cubicBezTo>
                <a:cubicBezTo>
                  <a:pt x="267398" y="546414"/>
                  <a:pt x="271865" y="554603"/>
                  <a:pt x="275215" y="563164"/>
                </a:cubicBezTo>
                <a:cubicBezTo>
                  <a:pt x="281171" y="576937"/>
                  <a:pt x="282288" y="591454"/>
                  <a:pt x="271121" y="604854"/>
                </a:cubicBezTo>
                <a:cubicBezTo>
                  <a:pt x="262931" y="614532"/>
                  <a:pt x="263676" y="620860"/>
                  <a:pt x="274471" y="627560"/>
                </a:cubicBezTo>
                <a:cubicBezTo>
                  <a:pt x="309088" y="648405"/>
                  <a:pt x="331050" y="675578"/>
                  <a:pt x="319138" y="718012"/>
                </a:cubicBezTo>
                <a:cubicBezTo>
                  <a:pt x="317277" y="723968"/>
                  <a:pt x="319511" y="729924"/>
                  <a:pt x="326583" y="729551"/>
                </a:cubicBezTo>
                <a:cubicBezTo>
                  <a:pt x="342217" y="728435"/>
                  <a:pt x="344822" y="738113"/>
                  <a:pt x="349289" y="748163"/>
                </a:cubicBezTo>
                <a:cubicBezTo>
                  <a:pt x="392840" y="844571"/>
                  <a:pt x="455747" y="928695"/>
                  <a:pt x="528332" y="1007608"/>
                </a:cubicBezTo>
                <a:cubicBezTo>
                  <a:pt x="600173" y="1085777"/>
                  <a:pt x="680947" y="1155756"/>
                  <a:pt x="766932" y="1222758"/>
                </a:cubicBezTo>
                <a:cubicBezTo>
                  <a:pt x="742737" y="1220524"/>
                  <a:pt x="711470" y="1206752"/>
                  <a:pt x="681319" y="1190746"/>
                </a:cubicBezTo>
                <a:cubicBezTo>
                  <a:pt x="601662" y="1147939"/>
                  <a:pt x="536149" y="1089871"/>
                  <a:pt x="469520" y="1032920"/>
                </a:cubicBezTo>
                <a:cubicBezTo>
                  <a:pt x="422991" y="993091"/>
                  <a:pt x="377579" y="952146"/>
                  <a:pt x="325466" y="917900"/>
                </a:cubicBezTo>
                <a:cubicBezTo>
                  <a:pt x="319511" y="914178"/>
                  <a:pt x="315416" y="909339"/>
                  <a:pt x="312066" y="903383"/>
                </a:cubicBezTo>
                <a:cubicBezTo>
                  <a:pt x="309088" y="898172"/>
                  <a:pt x="304621" y="893333"/>
                  <a:pt x="296805" y="895566"/>
                </a:cubicBezTo>
                <a:cubicBezTo>
                  <a:pt x="288988" y="898172"/>
                  <a:pt x="288243" y="904872"/>
                  <a:pt x="288243" y="910828"/>
                </a:cubicBezTo>
                <a:cubicBezTo>
                  <a:pt x="289360" y="933162"/>
                  <a:pt x="295688" y="953262"/>
                  <a:pt x="309460" y="971129"/>
                </a:cubicBezTo>
                <a:cubicBezTo>
                  <a:pt x="336261" y="1006864"/>
                  <a:pt x="371995" y="1034781"/>
                  <a:pt x="407729" y="1062698"/>
                </a:cubicBezTo>
                <a:cubicBezTo>
                  <a:pt x="457236" y="1101038"/>
                  <a:pt x="503021" y="1142728"/>
                  <a:pt x="544338" y="1189257"/>
                </a:cubicBezTo>
                <a:cubicBezTo>
                  <a:pt x="514560" y="1166551"/>
                  <a:pt x="484781" y="1143472"/>
                  <a:pt x="454630" y="1120766"/>
                </a:cubicBezTo>
                <a:cubicBezTo>
                  <a:pt x="431924" y="1103644"/>
                  <a:pt x="408474" y="1087265"/>
                  <a:pt x="385396" y="1070515"/>
                </a:cubicBezTo>
                <a:cubicBezTo>
                  <a:pt x="379812" y="1066421"/>
                  <a:pt x="373856" y="1061954"/>
                  <a:pt x="366040" y="1067537"/>
                </a:cubicBezTo>
                <a:cubicBezTo>
                  <a:pt x="358967" y="1072376"/>
                  <a:pt x="360084" y="1079449"/>
                  <a:pt x="361573" y="1086149"/>
                </a:cubicBezTo>
                <a:cubicBezTo>
                  <a:pt x="367156" y="1112577"/>
                  <a:pt x="382790" y="1133794"/>
                  <a:pt x="402146" y="1152778"/>
                </a:cubicBezTo>
                <a:cubicBezTo>
                  <a:pt x="425596" y="1175484"/>
                  <a:pt x="450164" y="1197074"/>
                  <a:pt x="475475" y="1218663"/>
                </a:cubicBezTo>
                <a:cubicBezTo>
                  <a:pt x="448303" y="1212707"/>
                  <a:pt x="421130" y="1206752"/>
                  <a:pt x="393957" y="1201913"/>
                </a:cubicBezTo>
                <a:cubicBezTo>
                  <a:pt x="406240" y="1245091"/>
                  <a:pt x="434902" y="1253653"/>
                  <a:pt x="460586" y="1260353"/>
                </a:cubicBezTo>
                <a:cubicBezTo>
                  <a:pt x="495204" y="1268914"/>
                  <a:pt x="528332" y="1279709"/>
                  <a:pt x="561089" y="1291993"/>
                </a:cubicBezTo>
                <a:cubicBezTo>
                  <a:pt x="574861" y="1304276"/>
                  <a:pt x="588634" y="1316188"/>
                  <a:pt x="602034" y="1328843"/>
                </a:cubicBezTo>
                <a:cubicBezTo>
                  <a:pt x="615807" y="1341872"/>
                  <a:pt x="628835" y="1354900"/>
                  <a:pt x="641863" y="1368672"/>
                </a:cubicBezTo>
                <a:cubicBezTo>
                  <a:pt x="651169" y="1378722"/>
                  <a:pt x="662335" y="1387284"/>
                  <a:pt x="651541" y="1404406"/>
                </a:cubicBezTo>
                <a:cubicBezTo>
                  <a:pt x="646702" y="1412223"/>
                  <a:pt x="678341" y="1454658"/>
                  <a:pt x="688392" y="1457263"/>
                </a:cubicBezTo>
                <a:cubicBezTo>
                  <a:pt x="689881" y="1457635"/>
                  <a:pt x="691369" y="1458008"/>
                  <a:pt x="692486" y="1458008"/>
                </a:cubicBezTo>
                <a:cubicBezTo>
                  <a:pt x="714076" y="1456519"/>
                  <a:pt x="718915" y="1469175"/>
                  <a:pt x="719287" y="1485181"/>
                </a:cubicBezTo>
                <a:cubicBezTo>
                  <a:pt x="719659" y="1500814"/>
                  <a:pt x="715937" y="1520170"/>
                  <a:pt x="745343" y="1512353"/>
                </a:cubicBezTo>
                <a:cubicBezTo>
                  <a:pt x="748693" y="1511609"/>
                  <a:pt x="749438" y="1513842"/>
                  <a:pt x="750926" y="1516448"/>
                </a:cubicBezTo>
                <a:cubicBezTo>
                  <a:pt x="782938" y="1583077"/>
                  <a:pt x="836912" y="1634445"/>
                  <a:pt x="890141" y="1685813"/>
                </a:cubicBezTo>
                <a:cubicBezTo>
                  <a:pt x="893119" y="1688419"/>
                  <a:pt x="896097" y="1691024"/>
                  <a:pt x="899074" y="1693630"/>
                </a:cubicBezTo>
                <a:cubicBezTo>
                  <a:pt x="843240" y="1680602"/>
                  <a:pt x="658985" y="1663851"/>
                  <a:pt x="605012" y="1669435"/>
                </a:cubicBezTo>
                <a:cubicBezTo>
                  <a:pt x="556994" y="1674274"/>
                  <a:pt x="285638" y="1593128"/>
                  <a:pt x="229431" y="1545110"/>
                </a:cubicBezTo>
                <a:cubicBezTo>
                  <a:pt x="221614" y="1582705"/>
                  <a:pt x="238364" y="1597594"/>
                  <a:pt x="251765" y="1614717"/>
                </a:cubicBezTo>
                <a:cubicBezTo>
                  <a:pt x="270748" y="1638912"/>
                  <a:pt x="273726" y="1656035"/>
                  <a:pt x="237992" y="1675391"/>
                </a:cubicBezTo>
                <a:cubicBezTo>
                  <a:pt x="135628" y="1730481"/>
                  <a:pt x="136745" y="1732342"/>
                  <a:pt x="232781" y="1807160"/>
                </a:cubicBezTo>
                <a:cubicBezTo>
                  <a:pt x="237248" y="1810511"/>
                  <a:pt x="235014" y="1821305"/>
                  <a:pt x="236131" y="1828750"/>
                </a:cubicBezTo>
                <a:cubicBezTo>
                  <a:pt x="211191" y="1839917"/>
                  <a:pt x="181785" y="1810883"/>
                  <a:pt x="152007" y="1842150"/>
                </a:cubicBezTo>
                <a:cubicBezTo>
                  <a:pt x="280426" y="1979503"/>
                  <a:pt x="475848" y="2110157"/>
                  <a:pt x="653030" y="2213265"/>
                </a:cubicBezTo>
                <a:cubicBezTo>
                  <a:pt x="509721" y="2247138"/>
                  <a:pt x="423735" y="2128024"/>
                  <a:pt x="318394" y="2143285"/>
                </a:cubicBezTo>
                <a:cubicBezTo>
                  <a:pt x="265909" y="2180508"/>
                  <a:pt x="422246" y="2240810"/>
                  <a:pt x="272982" y="2258305"/>
                </a:cubicBezTo>
                <a:cubicBezTo>
                  <a:pt x="337750" y="2291061"/>
                  <a:pt x="385768" y="2323073"/>
                  <a:pt x="430435" y="2360668"/>
                </a:cubicBezTo>
                <a:cubicBezTo>
                  <a:pt x="509721" y="2428042"/>
                  <a:pt x="525354" y="2472710"/>
                  <a:pt x="488876" y="2563162"/>
                </a:cubicBezTo>
                <a:cubicBezTo>
                  <a:pt x="464681" y="2622719"/>
                  <a:pt x="429691" y="2677437"/>
                  <a:pt x="460586" y="2748533"/>
                </a:cubicBezTo>
                <a:cubicBezTo>
                  <a:pt x="481803" y="2797295"/>
                  <a:pt x="473614" y="2829307"/>
                  <a:pt x="393212" y="2807345"/>
                </a:cubicBezTo>
                <a:cubicBezTo>
                  <a:pt x="306483" y="2783895"/>
                  <a:pt x="273726" y="2827818"/>
                  <a:pt x="295688" y="2913059"/>
                </a:cubicBezTo>
                <a:cubicBezTo>
                  <a:pt x="309833" y="2967777"/>
                  <a:pt x="294943" y="2984900"/>
                  <a:pt x="235386" y="2978572"/>
                </a:cubicBezTo>
                <a:cubicBezTo>
                  <a:pt x="169501" y="2971499"/>
                  <a:pt x="106967" y="2935765"/>
                  <a:pt x="25448" y="2952888"/>
                </a:cubicBezTo>
                <a:cubicBezTo>
                  <a:pt x="90588" y="3052646"/>
                  <a:pt x="229803" y="3024356"/>
                  <a:pt x="305738" y="3119275"/>
                </a:cubicBezTo>
                <a:cubicBezTo>
                  <a:pt x="215286" y="3119647"/>
                  <a:pt x="146051" y="3119275"/>
                  <a:pt x="79049" y="3098430"/>
                </a:cubicBezTo>
                <a:cubicBezTo>
                  <a:pt x="51132" y="3089869"/>
                  <a:pt x="20609" y="3081308"/>
                  <a:pt x="4975" y="3109969"/>
                </a:cubicBezTo>
                <a:cubicBezTo>
                  <a:pt x="-13636" y="3144587"/>
                  <a:pt x="24331" y="3157615"/>
                  <a:pt x="47037" y="3163943"/>
                </a:cubicBezTo>
                <a:cubicBezTo>
                  <a:pt x="111061" y="3181438"/>
                  <a:pt x="160196" y="3222755"/>
                  <a:pt x="213425" y="3255139"/>
                </a:cubicBezTo>
                <a:cubicBezTo>
                  <a:pt x="329933" y="3326236"/>
                  <a:pt x="457981" y="3385420"/>
                  <a:pt x="556622" y="3502301"/>
                </a:cubicBezTo>
                <a:cubicBezTo>
                  <a:pt x="432669" y="3472523"/>
                  <a:pt x="339983" y="3402915"/>
                  <a:pt x="224592" y="3388771"/>
                </a:cubicBezTo>
                <a:cubicBezTo>
                  <a:pt x="324722" y="3495601"/>
                  <a:pt x="453142" y="3565208"/>
                  <a:pt x="574861" y="3643004"/>
                </a:cubicBezTo>
                <a:cubicBezTo>
                  <a:pt x="609479" y="3664966"/>
                  <a:pt x="644841" y="3679855"/>
                  <a:pt x="652657" y="3727501"/>
                </a:cubicBezTo>
                <a:cubicBezTo>
                  <a:pt x="667919" y="3819814"/>
                  <a:pt x="712959" y="3896494"/>
                  <a:pt x="810111" y="3937067"/>
                </a:cubicBezTo>
                <a:cubicBezTo>
                  <a:pt x="810856" y="3937439"/>
                  <a:pt x="805644" y="3951212"/>
                  <a:pt x="802294" y="3960890"/>
                </a:cubicBezTo>
                <a:cubicBezTo>
                  <a:pt x="743110" y="3963868"/>
                  <a:pt x="696581" y="3909149"/>
                  <a:pt x="620646" y="3927017"/>
                </a:cubicBezTo>
                <a:cubicBezTo>
                  <a:pt x="692858" y="4001091"/>
                  <a:pt x="753532" y="4067720"/>
                  <a:pt x="856268" y="4103082"/>
                </a:cubicBezTo>
                <a:cubicBezTo>
                  <a:pt x="938531" y="4131372"/>
                  <a:pt x="1040150" y="4147377"/>
                  <a:pt x="1099707" y="4238574"/>
                </a:cubicBezTo>
                <a:cubicBezTo>
                  <a:pt x="1030472" y="4256441"/>
                  <a:pt x="978732" y="4234107"/>
                  <a:pt x="926992" y="4218102"/>
                </a:cubicBezTo>
                <a:cubicBezTo>
                  <a:pt x="847334" y="4193534"/>
                  <a:pt x="769166" y="4165617"/>
                  <a:pt x="689508" y="4140677"/>
                </a:cubicBezTo>
                <a:cubicBezTo>
                  <a:pt x="659358" y="4131372"/>
                  <a:pt x="626229" y="4124299"/>
                  <a:pt x="606873" y="4169711"/>
                </a:cubicBezTo>
                <a:cubicBezTo>
                  <a:pt x="707748" y="4179389"/>
                  <a:pt x="768421" y="4240435"/>
                  <a:pt x="831701" y="4297759"/>
                </a:cubicBezTo>
                <a:cubicBezTo>
                  <a:pt x="867435" y="4330143"/>
                  <a:pt x="896469" y="4373322"/>
                  <a:pt x="960493" y="4356944"/>
                </a:cubicBezTo>
                <a:cubicBezTo>
                  <a:pt x="994366" y="4348382"/>
                  <a:pt x="1015955" y="4372578"/>
                  <a:pt x="1012233" y="4402356"/>
                </a:cubicBezTo>
                <a:cubicBezTo>
                  <a:pt x="999577" y="4507325"/>
                  <a:pt x="1078118" y="4544176"/>
                  <a:pt x="1159636" y="4564276"/>
                </a:cubicBezTo>
                <a:cubicBezTo>
                  <a:pt x="1313740" y="4602616"/>
                  <a:pt x="1442160" y="4692324"/>
                  <a:pt x="1592169" y="4741458"/>
                </a:cubicBezTo>
                <a:cubicBezTo>
                  <a:pt x="1738083" y="4789104"/>
                  <a:pt x="2833187" y="5010209"/>
                  <a:pt x="3110499" y="5032171"/>
                </a:cubicBezTo>
                <a:cubicBezTo>
                  <a:pt x="4807501" y="5166546"/>
                  <a:pt x="6028047" y="4106432"/>
                  <a:pt x="6033630" y="4091915"/>
                </a:cubicBezTo>
                <a:cubicBezTo>
                  <a:pt x="6059314" y="4023797"/>
                  <a:pt x="6122965" y="3994390"/>
                  <a:pt x="6180661" y="3957912"/>
                </a:cubicBezTo>
                <a:cubicBezTo>
                  <a:pt x="6230913" y="3925900"/>
                  <a:pt x="6284514" y="3892027"/>
                  <a:pt x="6305359" y="3837309"/>
                </a:cubicBezTo>
                <a:cubicBezTo>
                  <a:pt x="6332904" y="3764724"/>
                  <a:pt x="6254735" y="3824281"/>
                  <a:pt x="6240218" y="3796364"/>
                </a:cubicBezTo>
                <a:cubicBezTo>
                  <a:pt x="6269997" y="3758768"/>
                  <a:pt x="6316153" y="3724151"/>
                  <a:pt x="6328437" y="3681344"/>
                </a:cubicBezTo>
                <a:cubicBezTo>
                  <a:pt x="6372361" y="3526496"/>
                  <a:pt x="6466907" y="3413710"/>
                  <a:pt x="6608355" y="3326236"/>
                </a:cubicBezTo>
                <a:cubicBezTo>
                  <a:pt x="6648928" y="3300924"/>
                  <a:pt x="6675729" y="3255512"/>
                  <a:pt x="6731191" y="3248067"/>
                </a:cubicBezTo>
                <a:cubicBezTo>
                  <a:pt x="6854400" y="3232061"/>
                  <a:pt x="6815315" y="3106992"/>
                  <a:pt x="6880456" y="3051529"/>
                </a:cubicBezTo>
                <a:cubicBezTo>
                  <a:pt x="6892739" y="3041107"/>
                  <a:pt x="6903907" y="2777939"/>
                  <a:pt x="6901673" y="2763795"/>
                </a:cubicBezTo>
                <a:cubicBezTo>
                  <a:pt x="6898323" y="2743322"/>
                  <a:pt x="6883806" y="2966288"/>
                  <a:pt x="6871150" y="2948421"/>
                </a:cubicBezTo>
                <a:cubicBezTo>
                  <a:pt x="6858494" y="2930182"/>
                  <a:pt x="6839138" y="2914176"/>
                  <a:pt x="6848444" y="2890353"/>
                </a:cubicBezTo>
                <a:cubicBezTo>
                  <a:pt x="6852166" y="2880303"/>
                  <a:pt x="6849561" y="2846058"/>
                  <a:pt x="6878223" y="2873230"/>
                </a:cubicBezTo>
                <a:cubicBezTo>
                  <a:pt x="6956763" y="2946932"/>
                  <a:pt x="6870778" y="2578051"/>
                  <a:pt x="6762459" y="2568745"/>
                </a:cubicBezTo>
                <a:cubicBezTo>
                  <a:pt x="6801915" y="2465637"/>
                  <a:pt x="6801915" y="2465637"/>
                  <a:pt x="6673123" y="2451493"/>
                </a:cubicBezTo>
                <a:cubicBezTo>
                  <a:pt x="6722630" y="2385980"/>
                  <a:pt x="6722630" y="2369229"/>
                  <a:pt x="6662700" y="2346896"/>
                </a:cubicBezTo>
                <a:cubicBezTo>
                  <a:pt x="6605005" y="2325306"/>
                  <a:pt x="6540981" y="2318234"/>
                  <a:pt x="6487752" y="2285105"/>
                </a:cubicBezTo>
                <a:cubicBezTo>
                  <a:pt x="6536887" y="2201353"/>
                  <a:pt x="6550659" y="2104573"/>
                  <a:pt x="6652278" y="2063628"/>
                </a:cubicBezTo>
                <a:cubicBezTo>
                  <a:pt x="6668284" y="2057300"/>
                  <a:pt x="6679079" y="2031988"/>
                  <a:pt x="6668656" y="2017843"/>
                </a:cubicBezTo>
                <a:cubicBezTo>
                  <a:pt x="6631805" y="1965359"/>
                  <a:pt x="6684662" y="1864856"/>
                  <a:pt x="6570015" y="1854062"/>
                </a:cubicBezTo>
                <a:cubicBezTo>
                  <a:pt x="6555870" y="1852573"/>
                  <a:pt x="6542842" y="1842150"/>
                  <a:pt x="6554009" y="1827633"/>
                </a:cubicBezTo>
                <a:cubicBezTo>
                  <a:pt x="6592349" y="1778126"/>
                  <a:pt x="6545820" y="1781476"/>
                  <a:pt x="6517531" y="1775149"/>
                </a:cubicBezTo>
                <a:cubicBezTo>
                  <a:pt x="6483285" y="1767704"/>
                  <a:pt x="6444573" y="1789293"/>
                  <a:pt x="6412934" y="1762493"/>
                </a:cubicBezTo>
                <a:cubicBezTo>
                  <a:pt x="6420378" y="1734203"/>
                  <a:pt x="6447923" y="1734575"/>
                  <a:pt x="6467279" y="1725642"/>
                </a:cubicBezTo>
                <a:cubicBezTo>
                  <a:pt x="6523858" y="1699213"/>
                  <a:pt x="6570015" y="1667946"/>
                  <a:pt x="6572621" y="1600200"/>
                </a:cubicBezTo>
                <a:cubicBezTo>
                  <a:pt x="6574854" y="1545482"/>
                  <a:pt x="6580810" y="1497092"/>
                  <a:pt x="6502641" y="1480341"/>
                </a:cubicBezTo>
                <a:cubicBezTo>
                  <a:pt x="6490358" y="1477736"/>
                  <a:pt x="6484030" y="1470664"/>
                  <a:pt x="6481796" y="1461358"/>
                </a:cubicBezTo>
                <a:cubicBezTo>
                  <a:pt x="6490730" y="1452424"/>
                  <a:pt x="6499291" y="1443118"/>
                  <a:pt x="6509713" y="1436418"/>
                </a:cubicBezTo>
                <a:cubicBezTo>
                  <a:pt x="6544703" y="1414457"/>
                  <a:pt x="6556615" y="1382072"/>
                  <a:pt x="6567037" y="1348199"/>
                </a:cubicBezTo>
                <a:cubicBezTo>
                  <a:pt x="6573737" y="1326610"/>
                  <a:pt x="6581554" y="1305393"/>
                  <a:pt x="6596816" y="1286781"/>
                </a:cubicBezTo>
                <a:cubicBezTo>
                  <a:pt x="6606122" y="1275242"/>
                  <a:pt x="6617661" y="1266681"/>
                  <a:pt x="6632178" y="1261842"/>
                </a:cubicBezTo>
                <a:cubicBezTo>
                  <a:pt x="6644833" y="1257375"/>
                  <a:pt x="6648556" y="1251419"/>
                  <a:pt x="6639994" y="1240625"/>
                </a:cubicBezTo>
                <a:cubicBezTo>
                  <a:pt x="6615799" y="1209729"/>
                  <a:pt x="6606122" y="1175856"/>
                  <a:pt x="6622127" y="1136400"/>
                </a:cubicBezTo>
                <a:cubicBezTo>
                  <a:pt x="6626967" y="1124489"/>
                  <a:pt x="6623617" y="1114066"/>
                  <a:pt x="6612077" y="1109599"/>
                </a:cubicBezTo>
                <a:cubicBezTo>
                  <a:pt x="6564059" y="1090616"/>
                  <a:pt x="6552148" y="1046692"/>
                  <a:pt x="6531675" y="1009469"/>
                </a:cubicBezTo>
                <a:cubicBezTo>
                  <a:pt x="6502641" y="956612"/>
                  <a:pt x="6476213" y="902639"/>
                  <a:pt x="6456113" y="845315"/>
                </a:cubicBezTo>
                <a:cubicBezTo>
                  <a:pt x="6444201" y="811070"/>
                  <a:pt x="6432662" y="777197"/>
                  <a:pt x="6440851" y="739229"/>
                </a:cubicBezTo>
                <a:cubicBezTo>
                  <a:pt x="6442712" y="729924"/>
                  <a:pt x="6439362" y="722107"/>
                  <a:pt x="6434523" y="715034"/>
                </a:cubicBezTo>
                <a:cubicBezTo>
                  <a:pt x="6414050" y="684139"/>
                  <a:pt x="6416656" y="651383"/>
                  <a:pt x="6432290" y="617510"/>
                </a:cubicBezTo>
                <a:cubicBezTo>
                  <a:pt x="6441968" y="597037"/>
                  <a:pt x="6440851" y="594431"/>
                  <a:pt x="6416284" y="595176"/>
                </a:cubicBezTo>
                <a:cubicBezTo>
                  <a:pt x="6366405" y="596293"/>
                  <a:pt x="6316898" y="598154"/>
                  <a:pt x="6267763" y="591826"/>
                </a:cubicBezTo>
                <a:cubicBezTo>
                  <a:pt x="6212673" y="584753"/>
                  <a:pt x="6194806" y="568375"/>
                  <a:pt x="6236496" y="521102"/>
                </a:cubicBezTo>
                <a:cubicBezTo>
                  <a:pt x="6245430" y="511052"/>
                  <a:pt x="6253246" y="499885"/>
                  <a:pt x="6257341" y="487229"/>
                </a:cubicBezTo>
                <a:cubicBezTo>
                  <a:pt x="6260319" y="477179"/>
                  <a:pt x="6257713" y="470106"/>
                  <a:pt x="6248780" y="465267"/>
                </a:cubicBezTo>
                <a:cubicBezTo>
                  <a:pt x="6238357" y="459312"/>
                  <a:pt x="6232774" y="467501"/>
                  <a:pt x="6226818" y="473456"/>
                </a:cubicBezTo>
                <a:cubicBezTo>
                  <a:pt x="6194434" y="505468"/>
                  <a:pt x="6153861" y="527430"/>
                  <a:pt x="6115149" y="551625"/>
                </a:cubicBezTo>
                <a:cubicBezTo>
                  <a:pt x="6059686" y="586615"/>
                  <a:pt x="6001246" y="617510"/>
                  <a:pt x="5951739" y="659944"/>
                </a:cubicBezTo>
                <a:cubicBezTo>
                  <a:pt x="5939084" y="670739"/>
                  <a:pt x="5918611" y="662550"/>
                  <a:pt x="5917122" y="644310"/>
                </a:cubicBezTo>
                <a:cubicBezTo>
                  <a:pt x="5915633" y="626071"/>
                  <a:pt x="5905583" y="626071"/>
                  <a:pt x="5890694" y="630538"/>
                </a:cubicBezTo>
                <a:cubicBezTo>
                  <a:pt x="5872826" y="635749"/>
                  <a:pt x="5854959" y="640960"/>
                  <a:pt x="5837464" y="646916"/>
                </a:cubicBezTo>
                <a:cubicBezTo>
                  <a:pt x="5819225" y="653244"/>
                  <a:pt x="5811036" y="666644"/>
                  <a:pt x="5809175" y="683395"/>
                </a:cubicBezTo>
                <a:cubicBezTo>
                  <a:pt x="5808430" y="689723"/>
                  <a:pt x="5808803" y="697539"/>
                  <a:pt x="5815503" y="698656"/>
                </a:cubicBezTo>
                <a:cubicBezTo>
                  <a:pt x="5843048" y="703495"/>
                  <a:pt x="5755201" y="682278"/>
                  <a:pt x="5746268" y="667389"/>
                </a:cubicBezTo>
                <a:cubicBezTo>
                  <a:pt x="5745896" y="666644"/>
                  <a:pt x="5525907" y="720246"/>
                  <a:pt x="5458905" y="754119"/>
                </a:cubicBezTo>
                <a:close/>
                <a:moveTo>
                  <a:pt x="885302" y="1333310"/>
                </a:moveTo>
                <a:cubicBezTo>
                  <a:pt x="877857" y="1326982"/>
                  <a:pt x="870040" y="1321027"/>
                  <a:pt x="862596" y="1314326"/>
                </a:cubicBezTo>
                <a:cubicBezTo>
                  <a:pt x="863712" y="1312837"/>
                  <a:pt x="865201" y="1311349"/>
                  <a:pt x="866318" y="1309860"/>
                </a:cubicBezTo>
                <a:cubicBezTo>
                  <a:pt x="881580" y="1320282"/>
                  <a:pt x="896841" y="1330705"/>
                  <a:pt x="912103" y="1341127"/>
                </a:cubicBezTo>
                <a:cubicBezTo>
                  <a:pt x="903541" y="1338522"/>
                  <a:pt x="894235" y="1335916"/>
                  <a:pt x="885302" y="1333310"/>
                </a:cubicBezTo>
                <a:close/>
                <a:moveTo>
                  <a:pt x="1140280" y="787619"/>
                </a:moveTo>
                <a:cubicBezTo>
                  <a:pt x="1231849" y="850154"/>
                  <a:pt x="1323418" y="913061"/>
                  <a:pt x="1414987" y="975596"/>
                </a:cubicBezTo>
                <a:cubicBezTo>
                  <a:pt x="1413498" y="977085"/>
                  <a:pt x="1412381" y="978574"/>
                  <a:pt x="1410892" y="980063"/>
                </a:cubicBezTo>
                <a:cubicBezTo>
                  <a:pt x="1310390" y="927206"/>
                  <a:pt x="1215471" y="868394"/>
                  <a:pt x="1140280" y="787619"/>
                </a:cubicBezTo>
                <a:close/>
              </a:path>
            </a:pathLst>
          </a:custGeom>
          <a:solidFill>
            <a:schemeClr val="accent1">
              <a:alpha val="20000"/>
            </a:schemeClr>
          </a:solidFill>
          <a:ln w="32707" cap="flat">
            <a:noFill/>
            <a:prstDash val="solid"/>
            <a:miter/>
          </a:ln>
        </p:spPr>
        <p:txBody>
          <a:bodyPr rtlCol="0" anchor="ct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entury Gothic"/>
              <a:ea typeface="+mn-ea"/>
              <a:cs typeface="+mn-cs"/>
            </a:endParaRPr>
          </a:p>
        </p:txBody>
      </p:sp>
      <p:sp useBgFill="1">
        <p:nvSpPr>
          <p:cNvPr id="12" name="Rectangle 11">
            <a:extLst>
              <a:ext uri="{FF2B5EF4-FFF2-40B4-BE49-F238E27FC236}">
                <a16:creationId xmlns:a16="http://schemas.microsoft.com/office/drawing/2014/main" id="{77EF089B-C54A-636E-F601-81F7571DBF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entury Gothic"/>
              <a:ea typeface="+mn-ea"/>
              <a:cs typeface="+mn-cs"/>
            </a:endParaRPr>
          </a:p>
        </p:txBody>
      </p:sp>
      <p:sp>
        <p:nvSpPr>
          <p:cNvPr id="14" name="Rectangle 13">
            <a:extLst>
              <a:ext uri="{FF2B5EF4-FFF2-40B4-BE49-F238E27FC236}">
                <a16:creationId xmlns:a16="http://schemas.microsoft.com/office/drawing/2014/main" id="{2BD8447E-09D3-4B6E-3969-31CCC7D1C0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12192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entury Gothic"/>
              <a:ea typeface="+mn-ea"/>
              <a:cs typeface="+mn-cs"/>
            </a:endParaRPr>
          </a:p>
        </p:txBody>
      </p:sp>
      <p:sp>
        <p:nvSpPr>
          <p:cNvPr id="16" name="Freeform: Shape 15">
            <a:extLst>
              <a:ext uri="{FF2B5EF4-FFF2-40B4-BE49-F238E27FC236}">
                <a16:creationId xmlns:a16="http://schemas.microsoft.com/office/drawing/2014/main" id="{2C47BD7C-4B62-3CB8-BEB2-ED2E62555DA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12192000" cy="6858000"/>
          </a:xfrm>
          <a:custGeom>
            <a:avLst/>
            <a:gdLst>
              <a:gd name="connsiteX0" fmla="*/ 0 w 12192000"/>
              <a:gd name="connsiteY0" fmla="*/ 0 h 6858000"/>
              <a:gd name="connsiteX1" fmla="*/ 7136182 w 12192000"/>
              <a:gd name="connsiteY1" fmla="*/ 0 h 6858000"/>
              <a:gd name="connsiteX2" fmla="*/ 7136182 w 12192000"/>
              <a:gd name="connsiteY2" fmla="*/ 335 h 6858000"/>
              <a:gd name="connsiteX3" fmla="*/ 7215619 w 12192000"/>
              <a:gd name="connsiteY3" fmla="*/ 2368586 h 6858000"/>
              <a:gd name="connsiteX4" fmla="*/ 7295436 w 12192000"/>
              <a:gd name="connsiteY4" fmla="*/ 3753611 h 6858000"/>
              <a:gd name="connsiteX5" fmla="*/ 7397299 w 12192000"/>
              <a:gd name="connsiteY5" fmla="*/ 4072305 h 6858000"/>
              <a:gd name="connsiteX6" fmla="*/ 7445569 w 12192000"/>
              <a:gd name="connsiteY6" fmla="*/ 4526719 h 6858000"/>
              <a:gd name="connsiteX7" fmla="*/ 7531468 w 12192000"/>
              <a:gd name="connsiteY7" fmla="*/ 5116854 h 6858000"/>
              <a:gd name="connsiteX8" fmla="*/ 7590760 w 12192000"/>
              <a:gd name="connsiteY8" fmla="*/ 5630249 h 6858000"/>
              <a:gd name="connsiteX9" fmla="*/ 7884185 w 12192000"/>
              <a:gd name="connsiteY9" fmla="*/ 5724081 h 6858000"/>
              <a:gd name="connsiteX10" fmla="*/ 8115655 w 12192000"/>
              <a:gd name="connsiteY10" fmla="*/ 5424488 h 6858000"/>
              <a:gd name="connsiteX11" fmla="*/ 8264267 w 12192000"/>
              <a:gd name="connsiteY11" fmla="*/ 5616845 h 6858000"/>
              <a:gd name="connsiteX12" fmla="*/ 8453928 w 12192000"/>
              <a:gd name="connsiteY12" fmla="*/ 5348754 h 6858000"/>
              <a:gd name="connsiteX13" fmla="*/ 8615844 w 12192000"/>
              <a:gd name="connsiteY13" fmla="*/ 5190580 h 6858000"/>
              <a:gd name="connsiteX14" fmla="*/ 8701363 w 12192000"/>
              <a:gd name="connsiteY14" fmla="*/ 4645684 h 6858000"/>
              <a:gd name="connsiteX15" fmla="*/ 8801704 w 12192000"/>
              <a:gd name="connsiteY15" fmla="*/ 4490862 h 6858000"/>
              <a:gd name="connsiteX16" fmla="*/ 8859097 w 12192000"/>
              <a:gd name="connsiteY16" fmla="*/ 4649036 h 6858000"/>
              <a:gd name="connsiteX17" fmla="*/ 8816528 w 12192000"/>
              <a:gd name="connsiteY17" fmla="*/ 5258608 h 6858000"/>
              <a:gd name="connsiteX18" fmla="*/ 8908507 w 12192000"/>
              <a:gd name="connsiteY18" fmla="*/ 5148354 h 6858000"/>
              <a:gd name="connsiteX19" fmla="*/ 9112612 w 12192000"/>
              <a:gd name="connsiteY19" fmla="*/ 4460032 h 6858000"/>
              <a:gd name="connsiteX20" fmla="*/ 9242220 w 12192000"/>
              <a:gd name="connsiteY20" fmla="*/ 4342071 h 6858000"/>
              <a:gd name="connsiteX21" fmla="*/ 9341422 w 12192000"/>
              <a:gd name="connsiteY21" fmla="*/ 4562911 h 6858000"/>
              <a:gd name="connsiteX22" fmla="*/ 9480152 w 12192000"/>
              <a:gd name="connsiteY22" fmla="*/ 5150031 h 6858000"/>
              <a:gd name="connsiteX23" fmla="*/ 9561110 w 12192000"/>
              <a:gd name="connsiteY23" fmla="*/ 4866524 h 6858000"/>
              <a:gd name="connsiteX24" fmla="*/ 9881520 w 12192000"/>
              <a:gd name="connsiteY24" fmla="*/ 4313922 h 6858000"/>
              <a:gd name="connsiteX25" fmla="*/ 10094366 w 12192000"/>
              <a:gd name="connsiteY25" fmla="*/ 4813241 h 6858000"/>
              <a:gd name="connsiteX26" fmla="*/ 10237276 w 12192000"/>
              <a:gd name="connsiteY26" fmla="*/ 4416132 h 6858000"/>
              <a:gd name="connsiteX27" fmla="*/ 10324315 w 12192000"/>
              <a:gd name="connsiteY27" fmla="*/ 4322299 h 6858000"/>
              <a:gd name="connsiteX28" fmla="*/ 10344080 w 12192000"/>
              <a:gd name="connsiteY28" fmla="*/ 4373907 h 6858000"/>
              <a:gd name="connsiteX29" fmla="*/ 10527280 w 12192000"/>
              <a:gd name="connsiteY29" fmla="*/ 3490211 h 6858000"/>
              <a:gd name="connsiteX30" fmla="*/ 10594174 w 12192000"/>
              <a:gd name="connsiteY30" fmla="*/ 3861183 h 6858000"/>
              <a:gd name="connsiteX31" fmla="*/ 11258180 w 12192000"/>
              <a:gd name="connsiteY31" fmla="*/ 1488576 h 6858000"/>
              <a:gd name="connsiteX32" fmla="*/ 11362322 w 12192000"/>
              <a:gd name="connsiteY32" fmla="*/ 0 h 6858000"/>
              <a:gd name="connsiteX33" fmla="*/ 12192000 w 12192000"/>
              <a:gd name="connsiteY33" fmla="*/ 0 h 6858000"/>
              <a:gd name="connsiteX34" fmla="*/ 12192000 w 12192000"/>
              <a:gd name="connsiteY34" fmla="*/ 6858000 h 6858000"/>
              <a:gd name="connsiteX35" fmla="*/ 0 w 12192000"/>
              <a:gd name="connsiteY35"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2192000" h="6858000">
                <a:moveTo>
                  <a:pt x="0" y="0"/>
                </a:moveTo>
                <a:lnTo>
                  <a:pt x="7136182" y="0"/>
                </a:lnTo>
                <a:lnTo>
                  <a:pt x="7136182" y="335"/>
                </a:lnTo>
                <a:cubicBezTo>
                  <a:pt x="7149485" y="1194346"/>
                  <a:pt x="7215999" y="2368586"/>
                  <a:pt x="7215619" y="2368586"/>
                </a:cubicBezTo>
                <a:cubicBezTo>
                  <a:pt x="7215999" y="2370261"/>
                  <a:pt x="7261609" y="3524058"/>
                  <a:pt x="7295436" y="3753611"/>
                </a:cubicBezTo>
                <a:cubicBezTo>
                  <a:pt x="7329643" y="3986516"/>
                  <a:pt x="7366892" y="3841746"/>
                  <a:pt x="7397299" y="4072305"/>
                </a:cubicBezTo>
                <a:cubicBezTo>
                  <a:pt x="7410602" y="4226792"/>
                  <a:pt x="7396538" y="4381615"/>
                  <a:pt x="7445569" y="4526719"/>
                </a:cubicBezTo>
                <a:cubicBezTo>
                  <a:pt x="7442148" y="4749905"/>
                  <a:pt x="7507522" y="4896349"/>
                  <a:pt x="7531468" y="5116854"/>
                </a:cubicBezTo>
                <a:cubicBezTo>
                  <a:pt x="7542490" y="5292454"/>
                  <a:pt x="7518165" y="5467049"/>
                  <a:pt x="7590760" y="5630249"/>
                </a:cubicBezTo>
                <a:cubicBezTo>
                  <a:pt x="7648913" y="5755916"/>
                  <a:pt x="7723029" y="5854440"/>
                  <a:pt x="7884185" y="5724081"/>
                </a:cubicBezTo>
                <a:cubicBezTo>
                  <a:pt x="7883045" y="5562555"/>
                  <a:pt x="8152523" y="5586684"/>
                  <a:pt x="8115655" y="5424488"/>
                </a:cubicBezTo>
                <a:cubicBezTo>
                  <a:pt x="8237281" y="5459341"/>
                  <a:pt x="8173428" y="5573280"/>
                  <a:pt x="8264267" y="5616845"/>
                </a:cubicBezTo>
                <a:cubicBezTo>
                  <a:pt x="8342565" y="5535411"/>
                  <a:pt x="8290493" y="5372882"/>
                  <a:pt x="8453928" y="5348754"/>
                </a:cubicBezTo>
                <a:cubicBezTo>
                  <a:pt x="8621165" y="5384611"/>
                  <a:pt x="8603300" y="5278045"/>
                  <a:pt x="8615844" y="5190580"/>
                </a:cubicBezTo>
                <a:cubicBezTo>
                  <a:pt x="8640930" y="4983479"/>
                  <a:pt x="8661074" y="4848093"/>
                  <a:pt x="8701363" y="4645684"/>
                </a:cubicBezTo>
                <a:cubicBezTo>
                  <a:pt x="8712764" y="4595082"/>
                  <a:pt x="8689960" y="4479468"/>
                  <a:pt x="8801704" y="4490862"/>
                </a:cubicBezTo>
                <a:cubicBezTo>
                  <a:pt x="8887983" y="4501920"/>
                  <a:pt x="8855296" y="4593407"/>
                  <a:pt x="8859097" y="4649036"/>
                </a:cubicBezTo>
                <a:cubicBezTo>
                  <a:pt x="8892544" y="4963372"/>
                  <a:pt x="8818808" y="4944941"/>
                  <a:pt x="8816528" y="5258608"/>
                </a:cubicBezTo>
                <a:cubicBezTo>
                  <a:pt x="8816147" y="5271006"/>
                  <a:pt x="8871260" y="5282066"/>
                  <a:pt x="8908507" y="5148354"/>
                </a:cubicBezTo>
                <a:cubicBezTo>
                  <a:pt x="8981484" y="4884620"/>
                  <a:pt x="9068522" y="4676850"/>
                  <a:pt x="9112612" y="4460032"/>
                </a:cubicBezTo>
                <a:cubicBezTo>
                  <a:pt x="9165063" y="4506612"/>
                  <a:pt x="9210294" y="4296495"/>
                  <a:pt x="9242220" y="4342071"/>
                </a:cubicBezTo>
                <a:cubicBezTo>
                  <a:pt x="9257044" y="4418812"/>
                  <a:pt x="9283648" y="4492872"/>
                  <a:pt x="9341422" y="4562911"/>
                </a:cubicBezTo>
                <a:cubicBezTo>
                  <a:pt x="9391213" y="4774703"/>
                  <a:pt x="9336860" y="4972085"/>
                  <a:pt x="9480152" y="5150031"/>
                </a:cubicBezTo>
                <a:cubicBezTo>
                  <a:pt x="9480152" y="5150031"/>
                  <a:pt x="9482432" y="5095407"/>
                  <a:pt x="9561110" y="4866524"/>
                </a:cubicBezTo>
                <a:cubicBezTo>
                  <a:pt x="9624583" y="4682212"/>
                  <a:pt x="9705921" y="4777385"/>
                  <a:pt x="9881520" y="4313922"/>
                </a:cubicBezTo>
                <a:cubicBezTo>
                  <a:pt x="9929790" y="4492202"/>
                  <a:pt x="9821466" y="4720414"/>
                  <a:pt x="10094366" y="4813241"/>
                </a:cubicBezTo>
                <a:cubicBezTo>
                  <a:pt x="10147197" y="4677855"/>
                  <a:pt x="10106528" y="4511974"/>
                  <a:pt x="10237276" y="4416132"/>
                </a:cubicBezTo>
                <a:cubicBezTo>
                  <a:pt x="10275285" y="4388317"/>
                  <a:pt x="10302651" y="4356481"/>
                  <a:pt x="10324315" y="4322299"/>
                </a:cubicBezTo>
                <a:cubicBezTo>
                  <a:pt x="10330777" y="4339726"/>
                  <a:pt x="10337619" y="4357821"/>
                  <a:pt x="10344080" y="4373907"/>
                </a:cubicBezTo>
                <a:cubicBezTo>
                  <a:pt x="10370306" y="4346763"/>
                  <a:pt x="10519678" y="3662796"/>
                  <a:pt x="10527280" y="3490211"/>
                </a:cubicBezTo>
                <a:cubicBezTo>
                  <a:pt x="10565288" y="3612863"/>
                  <a:pt x="10594174" y="3861183"/>
                  <a:pt x="10594174" y="3861183"/>
                </a:cubicBezTo>
                <a:cubicBezTo>
                  <a:pt x="10594174" y="3861183"/>
                  <a:pt x="10758371" y="3809910"/>
                  <a:pt x="11258180" y="1488576"/>
                </a:cubicBezTo>
                <a:cubicBezTo>
                  <a:pt x="11297708" y="1305268"/>
                  <a:pt x="11334195" y="675255"/>
                  <a:pt x="11362322" y="0"/>
                </a:cubicBezTo>
                <a:lnTo>
                  <a:pt x="12192000" y="0"/>
                </a:lnTo>
                <a:lnTo>
                  <a:pt x="12192000" y="6858000"/>
                </a:lnTo>
                <a:lnTo>
                  <a:pt x="0" y="6858000"/>
                </a:lnTo>
                <a:close/>
              </a:path>
            </a:pathLst>
          </a:cu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entury Gothic"/>
              <a:ea typeface="+mn-ea"/>
              <a:cs typeface="+mn-cs"/>
            </a:endParaRPr>
          </a:p>
        </p:txBody>
      </p:sp>
      <p:sp>
        <p:nvSpPr>
          <p:cNvPr id="2" name="Title 1">
            <a:extLst>
              <a:ext uri="{FF2B5EF4-FFF2-40B4-BE49-F238E27FC236}">
                <a16:creationId xmlns:a16="http://schemas.microsoft.com/office/drawing/2014/main" id="{A01F7F3E-3BF4-4089-EAFD-FF17DBE6A084}"/>
              </a:ext>
            </a:extLst>
          </p:cNvPr>
          <p:cNvSpPr>
            <a:spLocks noGrp="1"/>
          </p:cNvSpPr>
          <p:nvPr>
            <p:ph type="title"/>
          </p:nvPr>
        </p:nvSpPr>
        <p:spPr>
          <a:xfrm>
            <a:off x="6096000" y="1406005"/>
            <a:ext cx="5257800" cy="2806704"/>
          </a:xfrm>
        </p:spPr>
        <p:txBody>
          <a:bodyPr vert="horz" lIns="91440" tIns="45720" rIns="91440" bIns="45720" rtlCol="0" anchor="b">
            <a:normAutofit/>
          </a:bodyPr>
          <a:lstStyle/>
          <a:p>
            <a:r>
              <a:rPr lang="en-US" sz="4800" i="1" dirty="0">
                <a:solidFill>
                  <a:srgbClr val="FFFFFF"/>
                </a:solidFill>
              </a:rPr>
              <a:t>Thank you</a:t>
            </a:r>
          </a:p>
        </p:txBody>
      </p:sp>
      <p:pic>
        <p:nvPicPr>
          <p:cNvPr id="7" name="Graphic 6" descr="Smiling Face with No Fill">
            <a:extLst>
              <a:ext uri="{FF2B5EF4-FFF2-40B4-BE49-F238E27FC236}">
                <a16:creationId xmlns:a16="http://schemas.microsoft.com/office/drawing/2014/main" id="{65006B1B-4F4B-851F-9BB3-FC8701BCF710}"/>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846791" y="676274"/>
            <a:ext cx="2743201" cy="2743201"/>
          </a:xfrm>
          <a:prstGeom prst="rect">
            <a:avLst/>
          </a:prstGeom>
        </p:spPr>
      </p:pic>
    </p:spTree>
    <p:extLst>
      <p:ext uri="{BB962C8B-B14F-4D97-AF65-F5344CB8AC3E}">
        <p14:creationId xmlns:p14="http://schemas.microsoft.com/office/powerpoint/2010/main" val="1078713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FBE20309-1FB9-4818-BAFA-9C4C053417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Freeform: Shape 9">
            <a:extLst>
              <a:ext uri="{FF2B5EF4-FFF2-40B4-BE49-F238E27FC236}">
                <a16:creationId xmlns:a16="http://schemas.microsoft.com/office/drawing/2014/main" id="{FBD77573-9EF2-4C35-8285-A1CF6FBB0E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 y="0"/>
            <a:ext cx="5511704" cy="6858000"/>
          </a:xfrm>
          <a:custGeom>
            <a:avLst/>
            <a:gdLst>
              <a:gd name="connsiteX0" fmla="*/ 5511704 w 5511704"/>
              <a:gd name="connsiteY0" fmla="*/ 0 h 6886576"/>
              <a:gd name="connsiteX1" fmla="*/ 1008599 w 5511704"/>
              <a:gd name="connsiteY1" fmla="*/ 0 h 6886576"/>
              <a:gd name="connsiteX2" fmla="*/ 1310975 w 5511704"/>
              <a:gd name="connsiteY2" fmla="*/ 110728 h 6886576"/>
              <a:gd name="connsiteX3" fmla="*/ 1267362 w 5511704"/>
              <a:gd name="connsiteY3" fmla="*/ 135731 h 6886576"/>
              <a:gd name="connsiteX4" fmla="*/ 1005692 w 5511704"/>
              <a:gd name="connsiteY4" fmla="*/ 71437 h 6886576"/>
              <a:gd name="connsiteX5" fmla="*/ 953358 w 5511704"/>
              <a:gd name="connsiteY5" fmla="*/ 89297 h 6886576"/>
              <a:gd name="connsiteX6" fmla="*/ 979525 w 5511704"/>
              <a:gd name="connsiteY6" fmla="*/ 164307 h 6886576"/>
              <a:gd name="connsiteX7" fmla="*/ 1092915 w 5511704"/>
              <a:gd name="connsiteY7" fmla="*/ 192882 h 6886576"/>
              <a:gd name="connsiteX8" fmla="*/ 1270270 w 5511704"/>
              <a:gd name="connsiteY8" fmla="*/ 375047 h 6886576"/>
              <a:gd name="connsiteX9" fmla="*/ 1002784 w 5511704"/>
              <a:gd name="connsiteY9" fmla="*/ 353615 h 6886576"/>
              <a:gd name="connsiteX10" fmla="*/ 956265 w 5511704"/>
              <a:gd name="connsiteY10" fmla="*/ 396479 h 6886576"/>
              <a:gd name="connsiteX11" fmla="*/ 938820 w 5511704"/>
              <a:gd name="connsiteY11" fmla="*/ 453629 h 6886576"/>
              <a:gd name="connsiteX12" fmla="*/ 860319 w 5511704"/>
              <a:gd name="connsiteY12" fmla="*/ 360759 h 6886576"/>
              <a:gd name="connsiteX13" fmla="*/ 793447 w 5511704"/>
              <a:gd name="connsiteY13" fmla="*/ 335757 h 6886576"/>
              <a:gd name="connsiteX14" fmla="*/ 773095 w 5511704"/>
              <a:gd name="connsiteY14" fmla="*/ 417910 h 6886576"/>
              <a:gd name="connsiteX15" fmla="*/ 834151 w 5511704"/>
              <a:gd name="connsiteY15" fmla="*/ 507206 h 6886576"/>
              <a:gd name="connsiteX16" fmla="*/ 996969 w 5511704"/>
              <a:gd name="connsiteY16" fmla="*/ 560785 h 6886576"/>
              <a:gd name="connsiteX17" fmla="*/ 822522 w 5511704"/>
              <a:gd name="connsiteY17" fmla="*/ 560785 h 6886576"/>
              <a:gd name="connsiteX18" fmla="*/ 621908 w 5511704"/>
              <a:gd name="connsiteY18" fmla="*/ 525066 h 6886576"/>
              <a:gd name="connsiteX19" fmla="*/ 409664 w 5511704"/>
              <a:gd name="connsiteY19" fmla="*/ 535781 h 6886576"/>
              <a:gd name="connsiteX20" fmla="*/ 209049 w 5511704"/>
              <a:gd name="connsiteY20" fmla="*/ 464344 h 6886576"/>
              <a:gd name="connsiteX21" fmla="*/ 5527 w 5511704"/>
              <a:gd name="connsiteY21" fmla="*/ 467916 h 6886576"/>
              <a:gd name="connsiteX22" fmla="*/ 906838 w 5511704"/>
              <a:gd name="connsiteY22" fmla="*/ 914400 h 6886576"/>
              <a:gd name="connsiteX23" fmla="*/ 863226 w 5511704"/>
              <a:gd name="connsiteY23" fmla="*/ 925116 h 6886576"/>
              <a:gd name="connsiteX24" fmla="*/ 805077 w 5511704"/>
              <a:gd name="connsiteY24" fmla="*/ 953691 h 6886576"/>
              <a:gd name="connsiteX25" fmla="*/ 848689 w 5511704"/>
              <a:gd name="connsiteY25" fmla="*/ 1010841 h 6886576"/>
              <a:gd name="connsiteX26" fmla="*/ 1084193 w 5511704"/>
              <a:gd name="connsiteY26" fmla="*/ 1117997 h 6886576"/>
              <a:gd name="connsiteX27" fmla="*/ 1142342 w 5511704"/>
              <a:gd name="connsiteY27" fmla="*/ 1225153 h 6886576"/>
              <a:gd name="connsiteX28" fmla="*/ 1069655 w 5511704"/>
              <a:gd name="connsiteY28" fmla="*/ 1214438 h 6886576"/>
              <a:gd name="connsiteX29" fmla="*/ 1005692 w 5511704"/>
              <a:gd name="connsiteY29" fmla="*/ 1235869 h 6886576"/>
              <a:gd name="connsiteX30" fmla="*/ 1031858 w 5511704"/>
              <a:gd name="connsiteY30" fmla="*/ 1371600 h 6886576"/>
              <a:gd name="connsiteX31" fmla="*/ 1366216 w 5511704"/>
              <a:gd name="connsiteY31" fmla="*/ 1546622 h 6886576"/>
              <a:gd name="connsiteX32" fmla="*/ 1395290 w 5511704"/>
              <a:gd name="connsiteY32" fmla="*/ 1603772 h 6886576"/>
              <a:gd name="connsiteX33" fmla="*/ 1354586 w 5511704"/>
              <a:gd name="connsiteY33" fmla="*/ 1643063 h 6886576"/>
              <a:gd name="connsiteX34" fmla="*/ 1247011 w 5511704"/>
              <a:gd name="connsiteY34" fmla="*/ 1664494 h 6886576"/>
              <a:gd name="connsiteX35" fmla="*/ 1398198 w 5511704"/>
              <a:gd name="connsiteY35" fmla="*/ 1857375 h 6886576"/>
              <a:gd name="connsiteX36" fmla="*/ 1453440 w 5511704"/>
              <a:gd name="connsiteY36" fmla="*/ 1910954 h 6886576"/>
              <a:gd name="connsiteX37" fmla="*/ 1549386 w 5511704"/>
              <a:gd name="connsiteY37" fmla="*/ 1993106 h 6886576"/>
              <a:gd name="connsiteX38" fmla="*/ 1549386 w 5511704"/>
              <a:gd name="connsiteY38" fmla="*/ 2021681 h 6886576"/>
              <a:gd name="connsiteX39" fmla="*/ 1421458 w 5511704"/>
              <a:gd name="connsiteY39" fmla="*/ 2110978 h 6886576"/>
              <a:gd name="connsiteX40" fmla="*/ 1188861 w 5511704"/>
              <a:gd name="connsiteY40" fmla="*/ 2085976 h 6886576"/>
              <a:gd name="connsiteX41" fmla="*/ 1531941 w 5511704"/>
              <a:gd name="connsiteY41" fmla="*/ 2218135 h 6886576"/>
              <a:gd name="connsiteX42" fmla="*/ 421293 w 5511704"/>
              <a:gd name="connsiteY42" fmla="*/ 1900238 h 6886576"/>
              <a:gd name="connsiteX43" fmla="*/ 491072 w 5511704"/>
              <a:gd name="connsiteY43" fmla="*/ 1982391 h 6886576"/>
              <a:gd name="connsiteX44" fmla="*/ 880671 w 5511704"/>
              <a:gd name="connsiteY44" fmla="*/ 2200276 h 6886576"/>
              <a:gd name="connsiteX45" fmla="*/ 991154 w 5511704"/>
              <a:gd name="connsiteY45" fmla="*/ 2336007 h 6886576"/>
              <a:gd name="connsiteX46" fmla="*/ 1107453 w 5511704"/>
              <a:gd name="connsiteY46" fmla="*/ 2411016 h 6886576"/>
              <a:gd name="connsiteX47" fmla="*/ 1270270 w 5511704"/>
              <a:gd name="connsiteY47" fmla="*/ 2411016 h 6886576"/>
              <a:gd name="connsiteX48" fmla="*/ 1386568 w 5511704"/>
              <a:gd name="connsiteY48" fmla="*/ 2528889 h 6886576"/>
              <a:gd name="connsiteX49" fmla="*/ 1267362 w 5511704"/>
              <a:gd name="connsiteY49" fmla="*/ 2553891 h 6886576"/>
              <a:gd name="connsiteX50" fmla="*/ 1127805 w 5511704"/>
              <a:gd name="connsiteY50" fmla="*/ 2536032 h 6886576"/>
              <a:gd name="connsiteX51" fmla="*/ 970802 w 5511704"/>
              <a:gd name="connsiteY51" fmla="*/ 2575322 h 6886576"/>
              <a:gd name="connsiteX52" fmla="*/ 825429 w 5511704"/>
              <a:gd name="connsiteY52" fmla="*/ 2543176 h 6886576"/>
              <a:gd name="connsiteX53" fmla="*/ 650982 w 5511704"/>
              <a:gd name="connsiteY53" fmla="*/ 2564607 h 6886576"/>
              <a:gd name="connsiteX54" fmla="*/ 595740 w 5511704"/>
              <a:gd name="connsiteY54" fmla="*/ 2703909 h 6886576"/>
              <a:gd name="connsiteX55" fmla="*/ 578296 w 5511704"/>
              <a:gd name="connsiteY55" fmla="*/ 2714626 h 6886576"/>
              <a:gd name="connsiteX56" fmla="*/ 255568 w 5511704"/>
              <a:gd name="connsiteY56" fmla="*/ 2936081 h 6886576"/>
              <a:gd name="connsiteX57" fmla="*/ 165437 w 5511704"/>
              <a:gd name="connsiteY57" fmla="*/ 2953941 h 6886576"/>
              <a:gd name="connsiteX58" fmla="*/ 697501 w 5511704"/>
              <a:gd name="connsiteY58" fmla="*/ 3343275 h 6886576"/>
              <a:gd name="connsiteX59" fmla="*/ 339884 w 5511704"/>
              <a:gd name="connsiteY59" fmla="*/ 3243263 h 6886576"/>
              <a:gd name="connsiteX60" fmla="*/ 290458 w 5511704"/>
              <a:gd name="connsiteY60" fmla="*/ 3407569 h 6886576"/>
              <a:gd name="connsiteX61" fmla="*/ 459090 w 5511704"/>
              <a:gd name="connsiteY61" fmla="*/ 3554016 h 6886576"/>
              <a:gd name="connsiteX62" fmla="*/ 520147 w 5511704"/>
              <a:gd name="connsiteY62" fmla="*/ 3843338 h 6886576"/>
              <a:gd name="connsiteX63" fmla="*/ 491072 w 5511704"/>
              <a:gd name="connsiteY63" fmla="*/ 4107657 h 6886576"/>
              <a:gd name="connsiteX64" fmla="*/ 418386 w 5511704"/>
              <a:gd name="connsiteY64" fmla="*/ 4189810 h 6886576"/>
              <a:gd name="connsiteX65" fmla="*/ 313718 w 5511704"/>
              <a:gd name="connsiteY65" fmla="*/ 4339829 h 6886576"/>
              <a:gd name="connsiteX66" fmla="*/ 249753 w 5511704"/>
              <a:gd name="connsiteY66" fmla="*/ 4432698 h 6886576"/>
              <a:gd name="connsiteX67" fmla="*/ 25879 w 5511704"/>
              <a:gd name="connsiteY67" fmla="*/ 4396979 h 6886576"/>
              <a:gd name="connsiteX68" fmla="*/ 325347 w 5511704"/>
              <a:gd name="connsiteY68" fmla="*/ 4632722 h 6886576"/>
              <a:gd name="connsiteX69" fmla="*/ 84029 w 5511704"/>
              <a:gd name="connsiteY69" fmla="*/ 4604147 h 6886576"/>
              <a:gd name="connsiteX70" fmla="*/ 5527 w 5511704"/>
              <a:gd name="connsiteY70" fmla="*/ 4622007 h 6886576"/>
              <a:gd name="connsiteX71" fmla="*/ 49139 w 5511704"/>
              <a:gd name="connsiteY71" fmla="*/ 4697016 h 6886576"/>
              <a:gd name="connsiteX72" fmla="*/ 226494 w 5511704"/>
              <a:gd name="connsiteY72" fmla="*/ 4825604 h 6886576"/>
              <a:gd name="connsiteX73" fmla="*/ 592833 w 5511704"/>
              <a:gd name="connsiteY73" fmla="*/ 5175647 h 6886576"/>
              <a:gd name="connsiteX74" fmla="*/ 238123 w 5511704"/>
              <a:gd name="connsiteY74" fmla="*/ 5014913 h 6886576"/>
              <a:gd name="connsiteX75" fmla="*/ 610278 w 5511704"/>
              <a:gd name="connsiteY75" fmla="*/ 5375673 h 6886576"/>
              <a:gd name="connsiteX76" fmla="*/ 691686 w 5511704"/>
              <a:gd name="connsiteY76" fmla="*/ 5497116 h 6886576"/>
              <a:gd name="connsiteX77" fmla="*/ 860319 w 5511704"/>
              <a:gd name="connsiteY77" fmla="*/ 5793582 h 6886576"/>
              <a:gd name="connsiteX78" fmla="*/ 851597 w 5511704"/>
              <a:gd name="connsiteY78" fmla="*/ 5825729 h 6886576"/>
              <a:gd name="connsiteX79" fmla="*/ 659704 w 5511704"/>
              <a:gd name="connsiteY79" fmla="*/ 5779295 h 6886576"/>
              <a:gd name="connsiteX80" fmla="*/ 909746 w 5511704"/>
              <a:gd name="connsiteY80" fmla="*/ 6029326 h 6886576"/>
              <a:gd name="connsiteX81" fmla="*/ 1168509 w 5511704"/>
              <a:gd name="connsiteY81" fmla="*/ 6222207 h 6886576"/>
              <a:gd name="connsiteX82" fmla="*/ 985339 w 5511704"/>
              <a:gd name="connsiteY82" fmla="*/ 6193632 h 6886576"/>
              <a:gd name="connsiteX83" fmla="*/ 732391 w 5511704"/>
              <a:gd name="connsiteY83" fmla="*/ 6082904 h 6886576"/>
              <a:gd name="connsiteX84" fmla="*/ 645167 w 5511704"/>
              <a:gd name="connsiteY84" fmla="*/ 6125766 h 6886576"/>
              <a:gd name="connsiteX85" fmla="*/ 883579 w 5511704"/>
              <a:gd name="connsiteY85" fmla="*/ 6307932 h 6886576"/>
              <a:gd name="connsiteX86" fmla="*/ 1020229 w 5511704"/>
              <a:gd name="connsiteY86" fmla="*/ 6393657 h 6886576"/>
              <a:gd name="connsiteX87" fmla="*/ 1075471 w 5511704"/>
              <a:gd name="connsiteY87" fmla="*/ 6457950 h 6886576"/>
              <a:gd name="connsiteX88" fmla="*/ 1232473 w 5511704"/>
              <a:gd name="connsiteY88" fmla="*/ 6686551 h 6886576"/>
              <a:gd name="connsiteX89" fmla="*/ 1592997 w 5511704"/>
              <a:gd name="connsiteY89" fmla="*/ 6886576 h 6886576"/>
              <a:gd name="connsiteX90" fmla="*/ 5511704 w 5511704"/>
              <a:gd name="connsiteY90" fmla="*/ 6886576 h 68865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Lst>
            <a:rect l="l" t="t" r="r" b="b"/>
            <a:pathLst>
              <a:path w="5511704" h="6886576">
                <a:moveTo>
                  <a:pt x="5511704" y="0"/>
                </a:moveTo>
                <a:lnTo>
                  <a:pt x="1008599" y="0"/>
                </a:lnTo>
                <a:cubicBezTo>
                  <a:pt x="1110360" y="35719"/>
                  <a:pt x="1209214" y="78581"/>
                  <a:pt x="1310975" y="110728"/>
                </a:cubicBezTo>
                <a:cubicBezTo>
                  <a:pt x="1296437" y="146447"/>
                  <a:pt x="1281900" y="139303"/>
                  <a:pt x="1267362" y="135731"/>
                </a:cubicBezTo>
                <a:cubicBezTo>
                  <a:pt x="1180139" y="121445"/>
                  <a:pt x="1090008" y="110728"/>
                  <a:pt x="1005692" y="71437"/>
                </a:cubicBezTo>
                <a:cubicBezTo>
                  <a:pt x="985339" y="64294"/>
                  <a:pt x="962080" y="64294"/>
                  <a:pt x="953358" y="89297"/>
                </a:cubicBezTo>
                <a:cubicBezTo>
                  <a:pt x="938820" y="125016"/>
                  <a:pt x="959172" y="146447"/>
                  <a:pt x="979525" y="164307"/>
                </a:cubicBezTo>
                <a:cubicBezTo>
                  <a:pt x="1014414" y="196453"/>
                  <a:pt x="1055118" y="189310"/>
                  <a:pt x="1092915" y="192882"/>
                </a:cubicBezTo>
                <a:cubicBezTo>
                  <a:pt x="1197583" y="210741"/>
                  <a:pt x="1247011" y="260747"/>
                  <a:pt x="1270270" y="375047"/>
                </a:cubicBezTo>
                <a:cubicBezTo>
                  <a:pt x="1180139" y="328613"/>
                  <a:pt x="1090008" y="385763"/>
                  <a:pt x="1002784" y="353615"/>
                </a:cubicBezTo>
                <a:cubicBezTo>
                  <a:pt x="979525" y="346472"/>
                  <a:pt x="944635" y="357188"/>
                  <a:pt x="956265" y="396479"/>
                </a:cubicBezTo>
                <a:cubicBezTo>
                  <a:pt x="967894" y="432198"/>
                  <a:pt x="1005692" y="460772"/>
                  <a:pt x="938820" y="453629"/>
                </a:cubicBezTo>
                <a:cubicBezTo>
                  <a:pt x="889393" y="450056"/>
                  <a:pt x="874856" y="407194"/>
                  <a:pt x="860319" y="360759"/>
                </a:cubicBezTo>
                <a:cubicBezTo>
                  <a:pt x="848689" y="335757"/>
                  <a:pt x="816707" y="321469"/>
                  <a:pt x="793447" y="335757"/>
                </a:cubicBezTo>
                <a:cubicBezTo>
                  <a:pt x="764373" y="350044"/>
                  <a:pt x="773095" y="389335"/>
                  <a:pt x="773095" y="417910"/>
                </a:cubicBezTo>
                <a:cubicBezTo>
                  <a:pt x="770187" y="471488"/>
                  <a:pt x="793447" y="496491"/>
                  <a:pt x="834151" y="507206"/>
                </a:cubicBezTo>
                <a:cubicBezTo>
                  <a:pt x="883579" y="521494"/>
                  <a:pt x="933005" y="539354"/>
                  <a:pt x="996969" y="560785"/>
                </a:cubicBezTo>
                <a:cubicBezTo>
                  <a:pt x="927190" y="596503"/>
                  <a:pt x="874856" y="589360"/>
                  <a:pt x="822522" y="560785"/>
                </a:cubicBezTo>
                <a:cubicBezTo>
                  <a:pt x="758558" y="528637"/>
                  <a:pt x="674242" y="485775"/>
                  <a:pt x="621908" y="525066"/>
                </a:cubicBezTo>
                <a:cubicBezTo>
                  <a:pt x="543407" y="582216"/>
                  <a:pt x="479443" y="546497"/>
                  <a:pt x="409664" y="535781"/>
                </a:cubicBezTo>
                <a:cubicBezTo>
                  <a:pt x="264290" y="514350"/>
                  <a:pt x="354422" y="482204"/>
                  <a:pt x="209049" y="464344"/>
                </a:cubicBezTo>
                <a:cubicBezTo>
                  <a:pt x="150900" y="457200"/>
                  <a:pt x="89843" y="428625"/>
                  <a:pt x="5527" y="467916"/>
                </a:cubicBezTo>
                <a:cubicBezTo>
                  <a:pt x="386404" y="675085"/>
                  <a:pt x="566666" y="660797"/>
                  <a:pt x="906838" y="914400"/>
                </a:cubicBezTo>
                <a:cubicBezTo>
                  <a:pt x="892301" y="939404"/>
                  <a:pt x="877764" y="928688"/>
                  <a:pt x="863226" y="925116"/>
                </a:cubicBezTo>
                <a:cubicBezTo>
                  <a:pt x="839967" y="921544"/>
                  <a:pt x="810892" y="907256"/>
                  <a:pt x="805077" y="953691"/>
                </a:cubicBezTo>
                <a:cubicBezTo>
                  <a:pt x="802169" y="989410"/>
                  <a:pt x="819615" y="1007269"/>
                  <a:pt x="848689" y="1010841"/>
                </a:cubicBezTo>
                <a:cubicBezTo>
                  <a:pt x="933005" y="1025129"/>
                  <a:pt x="1008599" y="1075135"/>
                  <a:pt x="1084193" y="1117997"/>
                </a:cubicBezTo>
                <a:cubicBezTo>
                  <a:pt x="1119082" y="1135857"/>
                  <a:pt x="1156879" y="1160860"/>
                  <a:pt x="1142342" y="1225153"/>
                </a:cubicBezTo>
                <a:cubicBezTo>
                  <a:pt x="1113268" y="1243013"/>
                  <a:pt x="1092915" y="1218009"/>
                  <a:pt x="1069655" y="1214438"/>
                </a:cubicBezTo>
                <a:cubicBezTo>
                  <a:pt x="1046396" y="1210866"/>
                  <a:pt x="991154" y="1225153"/>
                  <a:pt x="1005692" y="1235869"/>
                </a:cubicBezTo>
                <a:cubicBezTo>
                  <a:pt x="1072563" y="1275159"/>
                  <a:pt x="950450" y="1371600"/>
                  <a:pt x="1031858" y="1371600"/>
                </a:cubicBezTo>
                <a:cubicBezTo>
                  <a:pt x="1165601" y="1371600"/>
                  <a:pt x="1238288" y="1543050"/>
                  <a:pt x="1366216" y="1546622"/>
                </a:cubicBezTo>
                <a:cubicBezTo>
                  <a:pt x="1386568" y="1546622"/>
                  <a:pt x="1395290" y="1578770"/>
                  <a:pt x="1395290" y="1603772"/>
                </a:cubicBezTo>
                <a:cubicBezTo>
                  <a:pt x="1395290" y="1635920"/>
                  <a:pt x="1374939" y="1639491"/>
                  <a:pt x="1354586" y="1643063"/>
                </a:cubicBezTo>
                <a:cubicBezTo>
                  <a:pt x="1322604" y="1646635"/>
                  <a:pt x="1287715" y="1603772"/>
                  <a:pt x="1247011" y="1664494"/>
                </a:cubicBezTo>
                <a:cubicBezTo>
                  <a:pt x="1322604" y="1700213"/>
                  <a:pt x="1401105" y="1735932"/>
                  <a:pt x="1398198" y="1857375"/>
                </a:cubicBezTo>
                <a:cubicBezTo>
                  <a:pt x="1398198" y="1889523"/>
                  <a:pt x="1430180" y="1903810"/>
                  <a:pt x="1453440" y="1910954"/>
                </a:cubicBezTo>
                <a:cubicBezTo>
                  <a:pt x="1494144" y="1925241"/>
                  <a:pt x="1526126" y="1946673"/>
                  <a:pt x="1549386" y="1993106"/>
                </a:cubicBezTo>
                <a:cubicBezTo>
                  <a:pt x="1549386" y="2003822"/>
                  <a:pt x="1549386" y="2010966"/>
                  <a:pt x="1549386" y="2021681"/>
                </a:cubicBezTo>
                <a:cubicBezTo>
                  <a:pt x="1543571" y="2132410"/>
                  <a:pt x="1485422" y="2128838"/>
                  <a:pt x="1421458" y="2110978"/>
                </a:cubicBezTo>
                <a:cubicBezTo>
                  <a:pt x="1345864" y="2089547"/>
                  <a:pt x="1270270" y="2046685"/>
                  <a:pt x="1188861" y="2085976"/>
                </a:cubicBezTo>
                <a:cubicBezTo>
                  <a:pt x="1302252" y="2139554"/>
                  <a:pt x="1427272" y="2143126"/>
                  <a:pt x="1531941" y="2218135"/>
                </a:cubicBezTo>
                <a:cubicBezTo>
                  <a:pt x="1142342" y="2232422"/>
                  <a:pt x="799262" y="1993106"/>
                  <a:pt x="421293" y="1900238"/>
                </a:cubicBezTo>
                <a:cubicBezTo>
                  <a:pt x="432923" y="1960960"/>
                  <a:pt x="464905" y="1975247"/>
                  <a:pt x="491072" y="1982391"/>
                </a:cubicBezTo>
                <a:cubicBezTo>
                  <a:pt x="630630" y="2028825"/>
                  <a:pt x="752743" y="2121695"/>
                  <a:pt x="880671" y="2200276"/>
                </a:cubicBezTo>
                <a:cubicBezTo>
                  <a:pt x="933005" y="2232422"/>
                  <a:pt x="970802" y="2268142"/>
                  <a:pt x="991154" y="2336007"/>
                </a:cubicBezTo>
                <a:cubicBezTo>
                  <a:pt x="1008599" y="2400300"/>
                  <a:pt x="1043489" y="2428875"/>
                  <a:pt x="1107453" y="2411016"/>
                </a:cubicBezTo>
                <a:cubicBezTo>
                  <a:pt x="1159787" y="2396729"/>
                  <a:pt x="1215029" y="2403873"/>
                  <a:pt x="1270270" y="2411016"/>
                </a:cubicBezTo>
                <a:cubicBezTo>
                  <a:pt x="1331326" y="2418160"/>
                  <a:pt x="1401105" y="2489597"/>
                  <a:pt x="1386568" y="2528889"/>
                </a:cubicBezTo>
                <a:cubicBezTo>
                  <a:pt x="1357494" y="2593182"/>
                  <a:pt x="1308067" y="2561035"/>
                  <a:pt x="1267362" y="2553891"/>
                </a:cubicBezTo>
                <a:cubicBezTo>
                  <a:pt x="1217936" y="2546748"/>
                  <a:pt x="1127805" y="2528889"/>
                  <a:pt x="1127805" y="2536032"/>
                </a:cubicBezTo>
                <a:cubicBezTo>
                  <a:pt x="1095822" y="2696766"/>
                  <a:pt x="1023136" y="2575322"/>
                  <a:pt x="970802" y="2575322"/>
                </a:cubicBezTo>
                <a:cubicBezTo>
                  <a:pt x="921375" y="2575322"/>
                  <a:pt x="871949" y="2557463"/>
                  <a:pt x="825429" y="2543176"/>
                </a:cubicBezTo>
                <a:cubicBezTo>
                  <a:pt x="764373" y="2525316"/>
                  <a:pt x="709132" y="2557463"/>
                  <a:pt x="650982" y="2564607"/>
                </a:cubicBezTo>
                <a:cubicBezTo>
                  <a:pt x="598648" y="2571751"/>
                  <a:pt x="627722" y="2664620"/>
                  <a:pt x="595740" y="2703909"/>
                </a:cubicBezTo>
                <a:cubicBezTo>
                  <a:pt x="589926" y="2714626"/>
                  <a:pt x="584111" y="2714626"/>
                  <a:pt x="578296" y="2714626"/>
                </a:cubicBezTo>
                <a:cubicBezTo>
                  <a:pt x="560851" y="2993232"/>
                  <a:pt x="255568" y="2925366"/>
                  <a:pt x="255568" y="2936081"/>
                </a:cubicBezTo>
                <a:cubicBezTo>
                  <a:pt x="229401" y="2953941"/>
                  <a:pt x="197419" y="2911079"/>
                  <a:pt x="165437" y="2953941"/>
                </a:cubicBezTo>
                <a:cubicBezTo>
                  <a:pt x="302087" y="3150394"/>
                  <a:pt x="511425" y="3196828"/>
                  <a:pt x="697501" y="3343275"/>
                </a:cubicBezTo>
                <a:cubicBezTo>
                  <a:pt x="543407" y="3393282"/>
                  <a:pt x="453275" y="3221832"/>
                  <a:pt x="339884" y="3243263"/>
                </a:cubicBezTo>
                <a:cubicBezTo>
                  <a:pt x="284643" y="3296842"/>
                  <a:pt x="450368" y="3382566"/>
                  <a:pt x="290458" y="3407569"/>
                </a:cubicBezTo>
                <a:cubicBezTo>
                  <a:pt x="360236" y="3454004"/>
                  <a:pt x="409664" y="3500439"/>
                  <a:pt x="459090" y="3554016"/>
                </a:cubicBezTo>
                <a:cubicBezTo>
                  <a:pt x="543407" y="3650457"/>
                  <a:pt x="560851" y="3714751"/>
                  <a:pt x="520147" y="3843338"/>
                </a:cubicBezTo>
                <a:cubicBezTo>
                  <a:pt x="493979" y="3929063"/>
                  <a:pt x="456183" y="4007645"/>
                  <a:pt x="491072" y="4107657"/>
                </a:cubicBezTo>
                <a:cubicBezTo>
                  <a:pt x="514332" y="4175522"/>
                  <a:pt x="505609" y="4221957"/>
                  <a:pt x="418386" y="4189810"/>
                </a:cubicBezTo>
                <a:cubicBezTo>
                  <a:pt x="325347" y="4157663"/>
                  <a:pt x="290458" y="4218386"/>
                  <a:pt x="313718" y="4339829"/>
                </a:cubicBezTo>
                <a:cubicBezTo>
                  <a:pt x="328254" y="4418410"/>
                  <a:pt x="313718" y="4443413"/>
                  <a:pt x="249753" y="4432698"/>
                </a:cubicBezTo>
                <a:cubicBezTo>
                  <a:pt x="179975" y="4421982"/>
                  <a:pt x="113103" y="4371976"/>
                  <a:pt x="25879" y="4396979"/>
                </a:cubicBezTo>
                <a:cubicBezTo>
                  <a:pt x="95658" y="4539854"/>
                  <a:pt x="243939" y="4496991"/>
                  <a:pt x="325347" y="4632722"/>
                </a:cubicBezTo>
                <a:cubicBezTo>
                  <a:pt x="229401" y="4632722"/>
                  <a:pt x="153807" y="4632722"/>
                  <a:pt x="84029" y="4604147"/>
                </a:cubicBezTo>
                <a:cubicBezTo>
                  <a:pt x="54954" y="4593433"/>
                  <a:pt x="22972" y="4579145"/>
                  <a:pt x="5527" y="4622007"/>
                </a:cubicBezTo>
                <a:cubicBezTo>
                  <a:pt x="-14826" y="4672014"/>
                  <a:pt x="25879" y="4689872"/>
                  <a:pt x="49139" y="4697016"/>
                </a:cubicBezTo>
                <a:cubicBezTo>
                  <a:pt x="116011" y="4722019"/>
                  <a:pt x="168344" y="4779170"/>
                  <a:pt x="226494" y="4825604"/>
                </a:cubicBezTo>
                <a:cubicBezTo>
                  <a:pt x="351514" y="4925616"/>
                  <a:pt x="488165" y="5011341"/>
                  <a:pt x="592833" y="5175647"/>
                </a:cubicBezTo>
                <a:cubicBezTo>
                  <a:pt x="461997" y="5132785"/>
                  <a:pt x="363144" y="5032772"/>
                  <a:pt x="238123" y="5014913"/>
                </a:cubicBezTo>
                <a:cubicBezTo>
                  <a:pt x="345700" y="5164932"/>
                  <a:pt x="482350" y="5264944"/>
                  <a:pt x="610278" y="5375673"/>
                </a:cubicBezTo>
                <a:cubicBezTo>
                  <a:pt x="648075" y="5407819"/>
                  <a:pt x="685872" y="5429250"/>
                  <a:pt x="691686" y="5497116"/>
                </a:cubicBezTo>
                <a:cubicBezTo>
                  <a:pt x="709132" y="5629276"/>
                  <a:pt x="755650" y="5736432"/>
                  <a:pt x="860319" y="5793582"/>
                </a:cubicBezTo>
                <a:cubicBezTo>
                  <a:pt x="860319" y="5793582"/>
                  <a:pt x="854504" y="5815013"/>
                  <a:pt x="851597" y="5825729"/>
                </a:cubicBezTo>
                <a:cubicBezTo>
                  <a:pt x="787632" y="5829301"/>
                  <a:pt x="738206" y="5750720"/>
                  <a:pt x="659704" y="5779295"/>
                </a:cubicBezTo>
                <a:cubicBezTo>
                  <a:pt x="738206" y="5886451"/>
                  <a:pt x="802169" y="5979319"/>
                  <a:pt x="909746" y="6029326"/>
                </a:cubicBezTo>
                <a:cubicBezTo>
                  <a:pt x="996969" y="6068616"/>
                  <a:pt x="1104545" y="6093620"/>
                  <a:pt x="1168509" y="6222207"/>
                </a:cubicBezTo>
                <a:cubicBezTo>
                  <a:pt x="1095822" y="6247210"/>
                  <a:pt x="1040581" y="6215063"/>
                  <a:pt x="985339" y="6193632"/>
                </a:cubicBezTo>
                <a:cubicBezTo>
                  <a:pt x="901023" y="6157913"/>
                  <a:pt x="816707" y="6118623"/>
                  <a:pt x="732391" y="6082904"/>
                </a:cubicBezTo>
                <a:cubicBezTo>
                  <a:pt x="700408" y="6068616"/>
                  <a:pt x="665519" y="6061472"/>
                  <a:pt x="645167" y="6125766"/>
                </a:cubicBezTo>
                <a:cubicBezTo>
                  <a:pt x="752743" y="6140053"/>
                  <a:pt x="816707" y="6225779"/>
                  <a:pt x="883579" y="6307932"/>
                </a:cubicBezTo>
                <a:cubicBezTo>
                  <a:pt x="921375" y="6354366"/>
                  <a:pt x="953358" y="6415088"/>
                  <a:pt x="1020229" y="6393657"/>
                </a:cubicBezTo>
                <a:cubicBezTo>
                  <a:pt x="1055118" y="6382942"/>
                  <a:pt x="1078378" y="6415088"/>
                  <a:pt x="1075471" y="6457950"/>
                </a:cubicBezTo>
                <a:cubicBezTo>
                  <a:pt x="1060933" y="6607970"/>
                  <a:pt x="1145250" y="6657976"/>
                  <a:pt x="1232473" y="6686551"/>
                </a:cubicBezTo>
                <a:cubicBezTo>
                  <a:pt x="1360401" y="6729413"/>
                  <a:pt x="1473792" y="6815138"/>
                  <a:pt x="1592997" y="6886576"/>
                </a:cubicBezTo>
                <a:lnTo>
                  <a:pt x="5511704" y="6886576"/>
                </a:lnTo>
                <a:close/>
              </a:path>
            </a:pathLst>
          </a:custGeom>
          <a:solidFill>
            <a:schemeClr val="accent1">
              <a:alpha val="20000"/>
            </a:schemeClr>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E265FA82-B204-E7D1-843D-31A7EAA1883B}"/>
              </a:ext>
            </a:extLst>
          </p:cNvPr>
          <p:cNvSpPr>
            <a:spLocks noGrp="1"/>
          </p:cNvSpPr>
          <p:nvPr>
            <p:ph type="title"/>
          </p:nvPr>
        </p:nvSpPr>
        <p:spPr>
          <a:xfrm>
            <a:off x="838200" y="713312"/>
            <a:ext cx="3524250" cy="5431376"/>
          </a:xfrm>
        </p:spPr>
        <p:txBody>
          <a:bodyPr>
            <a:normAutofit/>
          </a:bodyPr>
          <a:lstStyle/>
          <a:p>
            <a:r>
              <a:rPr lang="en-US" b="1" dirty="0"/>
              <a:t>Instructions</a:t>
            </a:r>
          </a:p>
        </p:txBody>
      </p:sp>
      <p:sp>
        <p:nvSpPr>
          <p:cNvPr id="3" name="Content Placeholder 2">
            <a:extLst>
              <a:ext uri="{FF2B5EF4-FFF2-40B4-BE49-F238E27FC236}">
                <a16:creationId xmlns:a16="http://schemas.microsoft.com/office/drawing/2014/main" id="{A3150D43-E28C-6EA9-7F0D-6662021A41CF}"/>
              </a:ext>
            </a:extLst>
          </p:cNvPr>
          <p:cNvSpPr>
            <a:spLocks noGrp="1"/>
          </p:cNvSpPr>
          <p:nvPr>
            <p:ph idx="1"/>
          </p:nvPr>
        </p:nvSpPr>
        <p:spPr>
          <a:xfrm>
            <a:off x="5427023" y="237506"/>
            <a:ext cx="6531429" cy="6460177"/>
          </a:xfrm>
        </p:spPr>
        <p:txBody>
          <a:bodyPr anchor="ctr">
            <a:noAutofit/>
          </a:bodyPr>
          <a:lstStyle/>
          <a:p>
            <a:pPr>
              <a:spcBef>
                <a:spcPts val="0"/>
              </a:spcBef>
            </a:pPr>
            <a:r>
              <a:rPr lang="en-US" sz="2600" kern="100" dirty="0">
                <a:effectLst/>
                <a:latin typeface="Calibri" panose="020F0502020204030204" pitchFamily="34" charset="0"/>
                <a:ea typeface="Aptos" panose="020B0004020202020204" pitchFamily="34" charset="0"/>
                <a:cs typeface="Calibri" panose="020F0502020204030204" pitchFamily="34" charset="0"/>
              </a:rPr>
              <a:t>The faculty in each group will facilitate the VTS session.</a:t>
            </a:r>
          </a:p>
          <a:p>
            <a:pPr>
              <a:spcBef>
                <a:spcPts val="0"/>
              </a:spcBef>
            </a:pPr>
            <a:r>
              <a:rPr lang="en-US" sz="2600" kern="100" dirty="0">
                <a:effectLst/>
                <a:latin typeface="Calibri" panose="020F0502020204030204" pitchFamily="34" charset="0"/>
                <a:ea typeface="Aptos" panose="020B0004020202020204" pitchFamily="34" charset="0"/>
                <a:cs typeface="Calibri" panose="020F0502020204030204" pitchFamily="34" charset="0"/>
              </a:rPr>
              <a:t>Each group will be given a file consisting of the following: </a:t>
            </a:r>
          </a:p>
          <a:p>
            <a:pPr lvl="1">
              <a:spcBef>
                <a:spcPts val="0"/>
              </a:spcBef>
            </a:pPr>
            <a:r>
              <a:rPr lang="en-US" sz="2200" kern="100" dirty="0">
                <a:solidFill>
                  <a:srgbClr val="002060"/>
                </a:solidFill>
                <a:effectLst/>
                <a:latin typeface="Calibri" panose="020F0502020204030204" pitchFamily="34" charset="0"/>
                <a:ea typeface="Aptos" panose="020B0004020202020204" pitchFamily="34" charset="0"/>
                <a:cs typeface="Calibri" panose="020F0502020204030204" pitchFamily="34" charset="0"/>
              </a:rPr>
              <a:t>Artwork, </a:t>
            </a:r>
          </a:p>
          <a:p>
            <a:pPr lvl="1">
              <a:spcBef>
                <a:spcPts val="0"/>
              </a:spcBef>
            </a:pPr>
            <a:r>
              <a:rPr lang="en-US" sz="2200" kern="100" dirty="0">
                <a:solidFill>
                  <a:srgbClr val="002060"/>
                </a:solidFill>
                <a:effectLst/>
                <a:latin typeface="Calibri" panose="020F0502020204030204" pitchFamily="34" charset="0"/>
                <a:ea typeface="Aptos" panose="020B0004020202020204" pitchFamily="34" charset="0"/>
                <a:cs typeface="Calibri" panose="020F0502020204030204" pitchFamily="34" charset="0"/>
              </a:rPr>
              <a:t>Structured Peer Roleplay </a:t>
            </a:r>
            <a:r>
              <a:rPr lang="en-US" sz="2200" kern="100" dirty="0">
                <a:solidFill>
                  <a:srgbClr val="002060"/>
                </a:solidFill>
                <a:latin typeface="Calibri" panose="020F0502020204030204" pitchFamily="34" charset="0"/>
                <a:ea typeface="Aptos" panose="020B0004020202020204" pitchFamily="34" charset="0"/>
                <a:cs typeface="Calibri" panose="020F0502020204030204" pitchFamily="34" charset="0"/>
              </a:rPr>
              <a:t>materials with</a:t>
            </a:r>
            <a:endParaRPr lang="en-US" sz="2200" kern="100" dirty="0">
              <a:solidFill>
                <a:srgbClr val="002060"/>
              </a:solidFill>
              <a:effectLst/>
              <a:latin typeface="Calibri" panose="020F0502020204030204" pitchFamily="34" charset="0"/>
              <a:ea typeface="Aptos" panose="020B0004020202020204" pitchFamily="34" charset="0"/>
              <a:cs typeface="Calibri" panose="020F0502020204030204" pitchFamily="34" charset="0"/>
            </a:endParaRPr>
          </a:p>
          <a:p>
            <a:pPr lvl="1">
              <a:spcBef>
                <a:spcPts val="0"/>
              </a:spcBef>
            </a:pPr>
            <a:r>
              <a:rPr lang="en-US" sz="2200" kern="100" dirty="0">
                <a:solidFill>
                  <a:srgbClr val="002060"/>
                </a:solidFill>
                <a:effectLst/>
                <a:latin typeface="Calibri" panose="020F0502020204030204" pitchFamily="34" charset="0"/>
                <a:ea typeface="Aptos" panose="020B0004020202020204" pitchFamily="34" charset="0"/>
                <a:cs typeface="Calibri" panose="020F0502020204030204" pitchFamily="34" charset="0"/>
              </a:rPr>
              <a:t>learning objectives, </a:t>
            </a:r>
          </a:p>
          <a:p>
            <a:pPr lvl="1">
              <a:spcBef>
                <a:spcPts val="0"/>
              </a:spcBef>
            </a:pPr>
            <a:r>
              <a:rPr lang="en-US" sz="2200" kern="100" dirty="0">
                <a:solidFill>
                  <a:srgbClr val="002060"/>
                </a:solidFill>
                <a:effectLst/>
                <a:latin typeface="Calibri" panose="020F0502020204030204" pitchFamily="34" charset="0"/>
                <a:ea typeface="Aptos" panose="020B0004020202020204" pitchFamily="34" charset="0"/>
                <a:cs typeface="Calibri" panose="020F0502020204030204" pitchFamily="34" charset="0"/>
              </a:rPr>
              <a:t>clinical case scenario, </a:t>
            </a:r>
          </a:p>
          <a:p>
            <a:pPr lvl="1">
              <a:spcBef>
                <a:spcPts val="0"/>
              </a:spcBef>
            </a:pPr>
            <a:r>
              <a:rPr lang="en-US" sz="2200" kern="100" dirty="0">
                <a:solidFill>
                  <a:srgbClr val="002060"/>
                </a:solidFill>
                <a:effectLst/>
                <a:latin typeface="Calibri" panose="020F0502020204030204" pitchFamily="34" charset="0"/>
                <a:ea typeface="Aptos" panose="020B0004020202020204" pitchFamily="34" charset="0"/>
                <a:cs typeface="Calibri" panose="020F0502020204030204" pitchFamily="34" charset="0"/>
              </a:rPr>
              <a:t>roles in </a:t>
            </a:r>
            <a:r>
              <a:rPr lang="en-US" sz="2200" kern="100" dirty="0">
                <a:solidFill>
                  <a:srgbClr val="002060"/>
                </a:solidFill>
                <a:latin typeface="Calibri" panose="020F0502020204030204" pitchFamily="34" charset="0"/>
                <a:ea typeface="Aptos" panose="020B0004020202020204" pitchFamily="34" charset="0"/>
                <a:cs typeface="Calibri" panose="020F0502020204030204" pitchFamily="34" charset="0"/>
              </a:rPr>
              <a:t>roleplay</a:t>
            </a:r>
            <a:r>
              <a:rPr lang="en-US" sz="2200" kern="100" dirty="0">
                <a:solidFill>
                  <a:srgbClr val="002060"/>
                </a:solidFill>
                <a:effectLst/>
                <a:latin typeface="Calibri" panose="020F0502020204030204" pitchFamily="34" charset="0"/>
                <a:ea typeface="Aptos" panose="020B0004020202020204" pitchFamily="34" charset="0"/>
                <a:cs typeface="Calibri" panose="020F0502020204030204" pitchFamily="34" charset="0"/>
              </a:rPr>
              <a:t>, key clinical and </a:t>
            </a:r>
          </a:p>
          <a:p>
            <a:pPr lvl="1">
              <a:spcBef>
                <a:spcPts val="0"/>
              </a:spcBef>
            </a:pPr>
            <a:r>
              <a:rPr lang="en-US" sz="2200" kern="100" dirty="0">
                <a:solidFill>
                  <a:srgbClr val="002060"/>
                </a:solidFill>
                <a:effectLst/>
                <a:latin typeface="Calibri" panose="020F0502020204030204" pitchFamily="34" charset="0"/>
                <a:ea typeface="Aptos" panose="020B0004020202020204" pitchFamily="34" charset="0"/>
                <a:cs typeface="Calibri" panose="020F0502020204030204" pitchFamily="34" charset="0"/>
              </a:rPr>
              <a:t>biochemical points to discuss, </a:t>
            </a:r>
          </a:p>
          <a:p>
            <a:pPr lvl="1">
              <a:spcBef>
                <a:spcPts val="0"/>
              </a:spcBef>
            </a:pPr>
            <a:r>
              <a:rPr lang="en-US" sz="2200" kern="100" dirty="0">
                <a:solidFill>
                  <a:srgbClr val="002060"/>
                </a:solidFill>
                <a:effectLst/>
                <a:latin typeface="Calibri" panose="020F0502020204030204" pitchFamily="34" charset="0"/>
                <a:ea typeface="Aptos" panose="020B0004020202020204" pitchFamily="34" charset="0"/>
                <a:cs typeface="Calibri" panose="020F0502020204030204" pitchFamily="34" charset="0"/>
              </a:rPr>
              <a:t>dilemma to resolve and reflection questions.</a:t>
            </a:r>
          </a:p>
          <a:p>
            <a:pPr>
              <a:spcBef>
                <a:spcPts val="0"/>
              </a:spcBef>
            </a:pPr>
            <a:r>
              <a:rPr lang="en-US" sz="2600" kern="100" dirty="0">
                <a:effectLst/>
                <a:latin typeface="Calibri" panose="020F0502020204030204" pitchFamily="34" charset="0"/>
                <a:ea typeface="Aptos" panose="020B0004020202020204" pitchFamily="34" charset="0"/>
                <a:cs typeface="Calibri" panose="020F0502020204030204" pitchFamily="34" charset="0"/>
              </a:rPr>
              <a:t>This will be followed by </a:t>
            </a:r>
            <a:r>
              <a:rPr lang="en-US" sz="2600" b="1" kern="100" dirty="0">
                <a:effectLst/>
                <a:latin typeface="Calibri" panose="020F0502020204030204" pitchFamily="34" charset="0"/>
                <a:ea typeface="Aptos" panose="020B0004020202020204" pitchFamily="34" charset="0"/>
                <a:cs typeface="Calibri" panose="020F0502020204030204" pitchFamily="34" charset="0"/>
              </a:rPr>
              <a:t>description of five roles in the Structured peer roleplay.</a:t>
            </a:r>
          </a:p>
        </p:txBody>
      </p:sp>
    </p:spTree>
    <p:extLst>
      <p:ext uri="{BB962C8B-B14F-4D97-AF65-F5344CB8AC3E}">
        <p14:creationId xmlns:p14="http://schemas.microsoft.com/office/powerpoint/2010/main" val="13610705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FBE20309-1FB9-4818-BAFA-9C4C053417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Freeform: Shape 9">
            <a:extLst>
              <a:ext uri="{FF2B5EF4-FFF2-40B4-BE49-F238E27FC236}">
                <a16:creationId xmlns:a16="http://schemas.microsoft.com/office/drawing/2014/main" id="{FBD77573-9EF2-4C35-8285-A1CF6FBB0E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 y="0"/>
            <a:ext cx="5511704" cy="6858000"/>
          </a:xfrm>
          <a:custGeom>
            <a:avLst/>
            <a:gdLst>
              <a:gd name="connsiteX0" fmla="*/ 5511704 w 5511704"/>
              <a:gd name="connsiteY0" fmla="*/ 0 h 6886576"/>
              <a:gd name="connsiteX1" fmla="*/ 1008599 w 5511704"/>
              <a:gd name="connsiteY1" fmla="*/ 0 h 6886576"/>
              <a:gd name="connsiteX2" fmla="*/ 1310975 w 5511704"/>
              <a:gd name="connsiteY2" fmla="*/ 110728 h 6886576"/>
              <a:gd name="connsiteX3" fmla="*/ 1267362 w 5511704"/>
              <a:gd name="connsiteY3" fmla="*/ 135731 h 6886576"/>
              <a:gd name="connsiteX4" fmla="*/ 1005692 w 5511704"/>
              <a:gd name="connsiteY4" fmla="*/ 71437 h 6886576"/>
              <a:gd name="connsiteX5" fmla="*/ 953358 w 5511704"/>
              <a:gd name="connsiteY5" fmla="*/ 89297 h 6886576"/>
              <a:gd name="connsiteX6" fmla="*/ 979525 w 5511704"/>
              <a:gd name="connsiteY6" fmla="*/ 164307 h 6886576"/>
              <a:gd name="connsiteX7" fmla="*/ 1092915 w 5511704"/>
              <a:gd name="connsiteY7" fmla="*/ 192882 h 6886576"/>
              <a:gd name="connsiteX8" fmla="*/ 1270270 w 5511704"/>
              <a:gd name="connsiteY8" fmla="*/ 375047 h 6886576"/>
              <a:gd name="connsiteX9" fmla="*/ 1002784 w 5511704"/>
              <a:gd name="connsiteY9" fmla="*/ 353615 h 6886576"/>
              <a:gd name="connsiteX10" fmla="*/ 956265 w 5511704"/>
              <a:gd name="connsiteY10" fmla="*/ 396479 h 6886576"/>
              <a:gd name="connsiteX11" fmla="*/ 938820 w 5511704"/>
              <a:gd name="connsiteY11" fmla="*/ 453629 h 6886576"/>
              <a:gd name="connsiteX12" fmla="*/ 860319 w 5511704"/>
              <a:gd name="connsiteY12" fmla="*/ 360759 h 6886576"/>
              <a:gd name="connsiteX13" fmla="*/ 793447 w 5511704"/>
              <a:gd name="connsiteY13" fmla="*/ 335757 h 6886576"/>
              <a:gd name="connsiteX14" fmla="*/ 773095 w 5511704"/>
              <a:gd name="connsiteY14" fmla="*/ 417910 h 6886576"/>
              <a:gd name="connsiteX15" fmla="*/ 834151 w 5511704"/>
              <a:gd name="connsiteY15" fmla="*/ 507206 h 6886576"/>
              <a:gd name="connsiteX16" fmla="*/ 996969 w 5511704"/>
              <a:gd name="connsiteY16" fmla="*/ 560785 h 6886576"/>
              <a:gd name="connsiteX17" fmla="*/ 822522 w 5511704"/>
              <a:gd name="connsiteY17" fmla="*/ 560785 h 6886576"/>
              <a:gd name="connsiteX18" fmla="*/ 621908 w 5511704"/>
              <a:gd name="connsiteY18" fmla="*/ 525066 h 6886576"/>
              <a:gd name="connsiteX19" fmla="*/ 409664 w 5511704"/>
              <a:gd name="connsiteY19" fmla="*/ 535781 h 6886576"/>
              <a:gd name="connsiteX20" fmla="*/ 209049 w 5511704"/>
              <a:gd name="connsiteY20" fmla="*/ 464344 h 6886576"/>
              <a:gd name="connsiteX21" fmla="*/ 5527 w 5511704"/>
              <a:gd name="connsiteY21" fmla="*/ 467916 h 6886576"/>
              <a:gd name="connsiteX22" fmla="*/ 906838 w 5511704"/>
              <a:gd name="connsiteY22" fmla="*/ 914400 h 6886576"/>
              <a:gd name="connsiteX23" fmla="*/ 863226 w 5511704"/>
              <a:gd name="connsiteY23" fmla="*/ 925116 h 6886576"/>
              <a:gd name="connsiteX24" fmla="*/ 805077 w 5511704"/>
              <a:gd name="connsiteY24" fmla="*/ 953691 h 6886576"/>
              <a:gd name="connsiteX25" fmla="*/ 848689 w 5511704"/>
              <a:gd name="connsiteY25" fmla="*/ 1010841 h 6886576"/>
              <a:gd name="connsiteX26" fmla="*/ 1084193 w 5511704"/>
              <a:gd name="connsiteY26" fmla="*/ 1117997 h 6886576"/>
              <a:gd name="connsiteX27" fmla="*/ 1142342 w 5511704"/>
              <a:gd name="connsiteY27" fmla="*/ 1225153 h 6886576"/>
              <a:gd name="connsiteX28" fmla="*/ 1069655 w 5511704"/>
              <a:gd name="connsiteY28" fmla="*/ 1214438 h 6886576"/>
              <a:gd name="connsiteX29" fmla="*/ 1005692 w 5511704"/>
              <a:gd name="connsiteY29" fmla="*/ 1235869 h 6886576"/>
              <a:gd name="connsiteX30" fmla="*/ 1031858 w 5511704"/>
              <a:gd name="connsiteY30" fmla="*/ 1371600 h 6886576"/>
              <a:gd name="connsiteX31" fmla="*/ 1366216 w 5511704"/>
              <a:gd name="connsiteY31" fmla="*/ 1546622 h 6886576"/>
              <a:gd name="connsiteX32" fmla="*/ 1395290 w 5511704"/>
              <a:gd name="connsiteY32" fmla="*/ 1603772 h 6886576"/>
              <a:gd name="connsiteX33" fmla="*/ 1354586 w 5511704"/>
              <a:gd name="connsiteY33" fmla="*/ 1643063 h 6886576"/>
              <a:gd name="connsiteX34" fmla="*/ 1247011 w 5511704"/>
              <a:gd name="connsiteY34" fmla="*/ 1664494 h 6886576"/>
              <a:gd name="connsiteX35" fmla="*/ 1398198 w 5511704"/>
              <a:gd name="connsiteY35" fmla="*/ 1857375 h 6886576"/>
              <a:gd name="connsiteX36" fmla="*/ 1453440 w 5511704"/>
              <a:gd name="connsiteY36" fmla="*/ 1910954 h 6886576"/>
              <a:gd name="connsiteX37" fmla="*/ 1549386 w 5511704"/>
              <a:gd name="connsiteY37" fmla="*/ 1993106 h 6886576"/>
              <a:gd name="connsiteX38" fmla="*/ 1549386 w 5511704"/>
              <a:gd name="connsiteY38" fmla="*/ 2021681 h 6886576"/>
              <a:gd name="connsiteX39" fmla="*/ 1421458 w 5511704"/>
              <a:gd name="connsiteY39" fmla="*/ 2110978 h 6886576"/>
              <a:gd name="connsiteX40" fmla="*/ 1188861 w 5511704"/>
              <a:gd name="connsiteY40" fmla="*/ 2085976 h 6886576"/>
              <a:gd name="connsiteX41" fmla="*/ 1531941 w 5511704"/>
              <a:gd name="connsiteY41" fmla="*/ 2218135 h 6886576"/>
              <a:gd name="connsiteX42" fmla="*/ 421293 w 5511704"/>
              <a:gd name="connsiteY42" fmla="*/ 1900238 h 6886576"/>
              <a:gd name="connsiteX43" fmla="*/ 491072 w 5511704"/>
              <a:gd name="connsiteY43" fmla="*/ 1982391 h 6886576"/>
              <a:gd name="connsiteX44" fmla="*/ 880671 w 5511704"/>
              <a:gd name="connsiteY44" fmla="*/ 2200276 h 6886576"/>
              <a:gd name="connsiteX45" fmla="*/ 991154 w 5511704"/>
              <a:gd name="connsiteY45" fmla="*/ 2336007 h 6886576"/>
              <a:gd name="connsiteX46" fmla="*/ 1107453 w 5511704"/>
              <a:gd name="connsiteY46" fmla="*/ 2411016 h 6886576"/>
              <a:gd name="connsiteX47" fmla="*/ 1270270 w 5511704"/>
              <a:gd name="connsiteY47" fmla="*/ 2411016 h 6886576"/>
              <a:gd name="connsiteX48" fmla="*/ 1386568 w 5511704"/>
              <a:gd name="connsiteY48" fmla="*/ 2528889 h 6886576"/>
              <a:gd name="connsiteX49" fmla="*/ 1267362 w 5511704"/>
              <a:gd name="connsiteY49" fmla="*/ 2553891 h 6886576"/>
              <a:gd name="connsiteX50" fmla="*/ 1127805 w 5511704"/>
              <a:gd name="connsiteY50" fmla="*/ 2536032 h 6886576"/>
              <a:gd name="connsiteX51" fmla="*/ 970802 w 5511704"/>
              <a:gd name="connsiteY51" fmla="*/ 2575322 h 6886576"/>
              <a:gd name="connsiteX52" fmla="*/ 825429 w 5511704"/>
              <a:gd name="connsiteY52" fmla="*/ 2543176 h 6886576"/>
              <a:gd name="connsiteX53" fmla="*/ 650982 w 5511704"/>
              <a:gd name="connsiteY53" fmla="*/ 2564607 h 6886576"/>
              <a:gd name="connsiteX54" fmla="*/ 595740 w 5511704"/>
              <a:gd name="connsiteY54" fmla="*/ 2703909 h 6886576"/>
              <a:gd name="connsiteX55" fmla="*/ 578296 w 5511704"/>
              <a:gd name="connsiteY55" fmla="*/ 2714626 h 6886576"/>
              <a:gd name="connsiteX56" fmla="*/ 255568 w 5511704"/>
              <a:gd name="connsiteY56" fmla="*/ 2936081 h 6886576"/>
              <a:gd name="connsiteX57" fmla="*/ 165437 w 5511704"/>
              <a:gd name="connsiteY57" fmla="*/ 2953941 h 6886576"/>
              <a:gd name="connsiteX58" fmla="*/ 697501 w 5511704"/>
              <a:gd name="connsiteY58" fmla="*/ 3343275 h 6886576"/>
              <a:gd name="connsiteX59" fmla="*/ 339884 w 5511704"/>
              <a:gd name="connsiteY59" fmla="*/ 3243263 h 6886576"/>
              <a:gd name="connsiteX60" fmla="*/ 290458 w 5511704"/>
              <a:gd name="connsiteY60" fmla="*/ 3407569 h 6886576"/>
              <a:gd name="connsiteX61" fmla="*/ 459090 w 5511704"/>
              <a:gd name="connsiteY61" fmla="*/ 3554016 h 6886576"/>
              <a:gd name="connsiteX62" fmla="*/ 520147 w 5511704"/>
              <a:gd name="connsiteY62" fmla="*/ 3843338 h 6886576"/>
              <a:gd name="connsiteX63" fmla="*/ 491072 w 5511704"/>
              <a:gd name="connsiteY63" fmla="*/ 4107657 h 6886576"/>
              <a:gd name="connsiteX64" fmla="*/ 418386 w 5511704"/>
              <a:gd name="connsiteY64" fmla="*/ 4189810 h 6886576"/>
              <a:gd name="connsiteX65" fmla="*/ 313718 w 5511704"/>
              <a:gd name="connsiteY65" fmla="*/ 4339829 h 6886576"/>
              <a:gd name="connsiteX66" fmla="*/ 249753 w 5511704"/>
              <a:gd name="connsiteY66" fmla="*/ 4432698 h 6886576"/>
              <a:gd name="connsiteX67" fmla="*/ 25879 w 5511704"/>
              <a:gd name="connsiteY67" fmla="*/ 4396979 h 6886576"/>
              <a:gd name="connsiteX68" fmla="*/ 325347 w 5511704"/>
              <a:gd name="connsiteY68" fmla="*/ 4632722 h 6886576"/>
              <a:gd name="connsiteX69" fmla="*/ 84029 w 5511704"/>
              <a:gd name="connsiteY69" fmla="*/ 4604147 h 6886576"/>
              <a:gd name="connsiteX70" fmla="*/ 5527 w 5511704"/>
              <a:gd name="connsiteY70" fmla="*/ 4622007 h 6886576"/>
              <a:gd name="connsiteX71" fmla="*/ 49139 w 5511704"/>
              <a:gd name="connsiteY71" fmla="*/ 4697016 h 6886576"/>
              <a:gd name="connsiteX72" fmla="*/ 226494 w 5511704"/>
              <a:gd name="connsiteY72" fmla="*/ 4825604 h 6886576"/>
              <a:gd name="connsiteX73" fmla="*/ 592833 w 5511704"/>
              <a:gd name="connsiteY73" fmla="*/ 5175647 h 6886576"/>
              <a:gd name="connsiteX74" fmla="*/ 238123 w 5511704"/>
              <a:gd name="connsiteY74" fmla="*/ 5014913 h 6886576"/>
              <a:gd name="connsiteX75" fmla="*/ 610278 w 5511704"/>
              <a:gd name="connsiteY75" fmla="*/ 5375673 h 6886576"/>
              <a:gd name="connsiteX76" fmla="*/ 691686 w 5511704"/>
              <a:gd name="connsiteY76" fmla="*/ 5497116 h 6886576"/>
              <a:gd name="connsiteX77" fmla="*/ 860319 w 5511704"/>
              <a:gd name="connsiteY77" fmla="*/ 5793582 h 6886576"/>
              <a:gd name="connsiteX78" fmla="*/ 851597 w 5511704"/>
              <a:gd name="connsiteY78" fmla="*/ 5825729 h 6886576"/>
              <a:gd name="connsiteX79" fmla="*/ 659704 w 5511704"/>
              <a:gd name="connsiteY79" fmla="*/ 5779295 h 6886576"/>
              <a:gd name="connsiteX80" fmla="*/ 909746 w 5511704"/>
              <a:gd name="connsiteY80" fmla="*/ 6029326 h 6886576"/>
              <a:gd name="connsiteX81" fmla="*/ 1168509 w 5511704"/>
              <a:gd name="connsiteY81" fmla="*/ 6222207 h 6886576"/>
              <a:gd name="connsiteX82" fmla="*/ 985339 w 5511704"/>
              <a:gd name="connsiteY82" fmla="*/ 6193632 h 6886576"/>
              <a:gd name="connsiteX83" fmla="*/ 732391 w 5511704"/>
              <a:gd name="connsiteY83" fmla="*/ 6082904 h 6886576"/>
              <a:gd name="connsiteX84" fmla="*/ 645167 w 5511704"/>
              <a:gd name="connsiteY84" fmla="*/ 6125766 h 6886576"/>
              <a:gd name="connsiteX85" fmla="*/ 883579 w 5511704"/>
              <a:gd name="connsiteY85" fmla="*/ 6307932 h 6886576"/>
              <a:gd name="connsiteX86" fmla="*/ 1020229 w 5511704"/>
              <a:gd name="connsiteY86" fmla="*/ 6393657 h 6886576"/>
              <a:gd name="connsiteX87" fmla="*/ 1075471 w 5511704"/>
              <a:gd name="connsiteY87" fmla="*/ 6457950 h 6886576"/>
              <a:gd name="connsiteX88" fmla="*/ 1232473 w 5511704"/>
              <a:gd name="connsiteY88" fmla="*/ 6686551 h 6886576"/>
              <a:gd name="connsiteX89" fmla="*/ 1592997 w 5511704"/>
              <a:gd name="connsiteY89" fmla="*/ 6886576 h 6886576"/>
              <a:gd name="connsiteX90" fmla="*/ 5511704 w 5511704"/>
              <a:gd name="connsiteY90" fmla="*/ 6886576 h 68865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Lst>
            <a:rect l="l" t="t" r="r" b="b"/>
            <a:pathLst>
              <a:path w="5511704" h="6886576">
                <a:moveTo>
                  <a:pt x="5511704" y="0"/>
                </a:moveTo>
                <a:lnTo>
                  <a:pt x="1008599" y="0"/>
                </a:lnTo>
                <a:cubicBezTo>
                  <a:pt x="1110360" y="35719"/>
                  <a:pt x="1209214" y="78581"/>
                  <a:pt x="1310975" y="110728"/>
                </a:cubicBezTo>
                <a:cubicBezTo>
                  <a:pt x="1296437" y="146447"/>
                  <a:pt x="1281900" y="139303"/>
                  <a:pt x="1267362" y="135731"/>
                </a:cubicBezTo>
                <a:cubicBezTo>
                  <a:pt x="1180139" y="121445"/>
                  <a:pt x="1090008" y="110728"/>
                  <a:pt x="1005692" y="71437"/>
                </a:cubicBezTo>
                <a:cubicBezTo>
                  <a:pt x="985339" y="64294"/>
                  <a:pt x="962080" y="64294"/>
                  <a:pt x="953358" y="89297"/>
                </a:cubicBezTo>
                <a:cubicBezTo>
                  <a:pt x="938820" y="125016"/>
                  <a:pt x="959172" y="146447"/>
                  <a:pt x="979525" y="164307"/>
                </a:cubicBezTo>
                <a:cubicBezTo>
                  <a:pt x="1014414" y="196453"/>
                  <a:pt x="1055118" y="189310"/>
                  <a:pt x="1092915" y="192882"/>
                </a:cubicBezTo>
                <a:cubicBezTo>
                  <a:pt x="1197583" y="210741"/>
                  <a:pt x="1247011" y="260747"/>
                  <a:pt x="1270270" y="375047"/>
                </a:cubicBezTo>
                <a:cubicBezTo>
                  <a:pt x="1180139" y="328613"/>
                  <a:pt x="1090008" y="385763"/>
                  <a:pt x="1002784" y="353615"/>
                </a:cubicBezTo>
                <a:cubicBezTo>
                  <a:pt x="979525" y="346472"/>
                  <a:pt x="944635" y="357188"/>
                  <a:pt x="956265" y="396479"/>
                </a:cubicBezTo>
                <a:cubicBezTo>
                  <a:pt x="967894" y="432198"/>
                  <a:pt x="1005692" y="460772"/>
                  <a:pt x="938820" y="453629"/>
                </a:cubicBezTo>
                <a:cubicBezTo>
                  <a:pt x="889393" y="450056"/>
                  <a:pt x="874856" y="407194"/>
                  <a:pt x="860319" y="360759"/>
                </a:cubicBezTo>
                <a:cubicBezTo>
                  <a:pt x="848689" y="335757"/>
                  <a:pt x="816707" y="321469"/>
                  <a:pt x="793447" y="335757"/>
                </a:cubicBezTo>
                <a:cubicBezTo>
                  <a:pt x="764373" y="350044"/>
                  <a:pt x="773095" y="389335"/>
                  <a:pt x="773095" y="417910"/>
                </a:cubicBezTo>
                <a:cubicBezTo>
                  <a:pt x="770187" y="471488"/>
                  <a:pt x="793447" y="496491"/>
                  <a:pt x="834151" y="507206"/>
                </a:cubicBezTo>
                <a:cubicBezTo>
                  <a:pt x="883579" y="521494"/>
                  <a:pt x="933005" y="539354"/>
                  <a:pt x="996969" y="560785"/>
                </a:cubicBezTo>
                <a:cubicBezTo>
                  <a:pt x="927190" y="596503"/>
                  <a:pt x="874856" y="589360"/>
                  <a:pt x="822522" y="560785"/>
                </a:cubicBezTo>
                <a:cubicBezTo>
                  <a:pt x="758558" y="528637"/>
                  <a:pt x="674242" y="485775"/>
                  <a:pt x="621908" y="525066"/>
                </a:cubicBezTo>
                <a:cubicBezTo>
                  <a:pt x="543407" y="582216"/>
                  <a:pt x="479443" y="546497"/>
                  <a:pt x="409664" y="535781"/>
                </a:cubicBezTo>
                <a:cubicBezTo>
                  <a:pt x="264290" y="514350"/>
                  <a:pt x="354422" y="482204"/>
                  <a:pt x="209049" y="464344"/>
                </a:cubicBezTo>
                <a:cubicBezTo>
                  <a:pt x="150900" y="457200"/>
                  <a:pt x="89843" y="428625"/>
                  <a:pt x="5527" y="467916"/>
                </a:cubicBezTo>
                <a:cubicBezTo>
                  <a:pt x="386404" y="675085"/>
                  <a:pt x="566666" y="660797"/>
                  <a:pt x="906838" y="914400"/>
                </a:cubicBezTo>
                <a:cubicBezTo>
                  <a:pt x="892301" y="939404"/>
                  <a:pt x="877764" y="928688"/>
                  <a:pt x="863226" y="925116"/>
                </a:cubicBezTo>
                <a:cubicBezTo>
                  <a:pt x="839967" y="921544"/>
                  <a:pt x="810892" y="907256"/>
                  <a:pt x="805077" y="953691"/>
                </a:cubicBezTo>
                <a:cubicBezTo>
                  <a:pt x="802169" y="989410"/>
                  <a:pt x="819615" y="1007269"/>
                  <a:pt x="848689" y="1010841"/>
                </a:cubicBezTo>
                <a:cubicBezTo>
                  <a:pt x="933005" y="1025129"/>
                  <a:pt x="1008599" y="1075135"/>
                  <a:pt x="1084193" y="1117997"/>
                </a:cubicBezTo>
                <a:cubicBezTo>
                  <a:pt x="1119082" y="1135857"/>
                  <a:pt x="1156879" y="1160860"/>
                  <a:pt x="1142342" y="1225153"/>
                </a:cubicBezTo>
                <a:cubicBezTo>
                  <a:pt x="1113268" y="1243013"/>
                  <a:pt x="1092915" y="1218009"/>
                  <a:pt x="1069655" y="1214438"/>
                </a:cubicBezTo>
                <a:cubicBezTo>
                  <a:pt x="1046396" y="1210866"/>
                  <a:pt x="991154" y="1225153"/>
                  <a:pt x="1005692" y="1235869"/>
                </a:cubicBezTo>
                <a:cubicBezTo>
                  <a:pt x="1072563" y="1275159"/>
                  <a:pt x="950450" y="1371600"/>
                  <a:pt x="1031858" y="1371600"/>
                </a:cubicBezTo>
                <a:cubicBezTo>
                  <a:pt x="1165601" y="1371600"/>
                  <a:pt x="1238288" y="1543050"/>
                  <a:pt x="1366216" y="1546622"/>
                </a:cubicBezTo>
                <a:cubicBezTo>
                  <a:pt x="1386568" y="1546622"/>
                  <a:pt x="1395290" y="1578770"/>
                  <a:pt x="1395290" y="1603772"/>
                </a:cubicBezTo>
                <a:cubicBezTo>
                  <a:pt x="1395290" y="1635920"/>
                  <a:pt x="1374939" y="1639491"/>
                  <a:pt x="1354586" y="1643063"/>
                </a:cubicBezTo>
                <a:cubicBezTo>
                  <a:pt x="1322604" y="1646635"/>
                  <a:pt x="1287715" y="1603772"/>
                  <a:pt x="1247011" y="1664494"/>
                </a:cubicBezTo>
                <a:cubicBezTo>
                  <a:pt x="1322604" y="1700213"/>
                  <a:pt x="1401105" y="1735932"/>
                  <a:pt x="1398198" y="1857375"/>
                </a:cubicBezTo>
                <a:cubicBezTo>
                  <a:pt x="1398198" y="1889523"/>
                  <a:pt x="1430180" y="1903810"/>
                  <a:pt x="1453440" y="1910954"/>
                </a:cubicBezTo>
                <a:cubicBezTo>
                  <a:pt x="1494144" y="1925241"/>
                  <a:pt x="1526126" y="1946673"/>
                  <a:pt x="1549386" y="1993106"/>
                </a:cubicBezTo>
                <a:cubicBezTo>
                  <a:pt x="1549386" y="2003822"/>
                  <a:pt x="1549386" y="2010966"/>
                  <a:pt x="1549386" y="2021681"/>
                </a:cubicBezTo>
                <a:cubicBezTo>
                  <a:pt x="1543571" y="2132410"/>
                  <a:pt x="1485422" y="2128838"/>
                  <a:pt x="1421458" y="2110978"/>
                </a:cubicBezTo>
                <a:cubicBezTo>
                  <a:pt x="1345864" y="2089547"/>
                  <a:pt x="1270270" y="2046685"/>
                  <a:pt x="1188861" y="2085976"/>
                </a:cubicBezTo>
                <a:cubicBezTo>
                  <a:pt x="1302252" y="2139554"/>
                  <a:pt x="1427272" y="2143126"/>
                  <a:pt x="1531941" y="2218135"/>
                </a:cubicBezTo>
                <a:cubicBezTo>
                  <a:pt x="1142342" y="2232422"/>
                  <a:pt x="799262" y="1993106"/>
                  <a:pt x="421293" y="1900238"/>
                </a:cubicBezTo>
                <a:cubicBezTo>
                  <a:pt x="432923" y="1960960"/>
                  <a:pt x="464905" y="1975247"/>
                  <a:pt x="491072" y="1982391"/>
                </a:cubicBezTo>
                <a:cubicBezTo>
                  <a:pt x="630630" y="2028825"/>
                  <a:pt x="752743" y="2121695"/>
                  <a:pt x="880671" y="2200276"/>
                </a:cubicBezTo>
                <a:cubicBezTo>
                  <a:pt x="933005" y="2232422"/>
                  <a:pt x="970802" y="2268142"/>
                  <a:pt x="991154" y="2336007"/>
                </a:cubicBezTo>
                <a:cubicBezTo>
                  <a:pt x="1008599" y="2400300"/>
                  <a:pt x="1043489" y="2428875"/>
                  <a:pt x="1107453" y="2411016"/>
                </a:cubicBezTo>
                <a:cubicBezTo>
                  <a:pt x="1159787" y="2396729"/>
                  <a:pt x="1215029" y="2403873"/>
                  <a:pt x="1270270" y="2411016"/>
                </a:cubicBezTo>
                <a:cubicBezTo>
                  <a:pt x="1331326" y="2418160"/>
                  <a:pt x="1401105" y="2489597"/>
                  <a:pt x="1386568" y="2528889"/>
                </a:cubicBezTo>
                <a:cubicBezTo>
                  <a:pt x="1357494" y="2593182"/>
                  <a:pt x="1308067" y="2561035"/>
                  <a:pt x="1267362" y="2553891"/>
                </a:cubicBezTo>
                <a:cubicBezTo>
                  <a:pt x="1217936" y="2546748"/>
                  <a:pt x="1127805" y="2528889"/>
                  <a:pt x="1127805" y="2536032"/>
                </a:cubicBezTo>
                <a:cubicBezTo>
                  <a:pt x="1095822" y="2696766"/>
                  <a:pt x="1023136" y="2575322"/>
                  <a:pt x="970802" y="2575322"/>
                </a:cubicBezTo>
                <a:cubicBezTo>
                  <a:pt x="921375" y="2575322"/>
                  <a:pt x="871949" y="2557463"/>
                  <a:pt x="825429" y="2543176"/>
                </a:cubicBezTo>
                <a:cubicBezTo>
                  <a:pt x="764373" y="2525316"/>
                  <a:pt x="709132" y="2557463"/>
                  <a:pt x="650982" y="2564607"/>
                </a:cubicBezTo>
                <a:cubicBezTo>
                  <a:pt x="598648" y="2571751"/>
                  <a:pt x="627722" y="2664620"/>
                  <a:pt x="595740" y="2703909"/>
                </a:cubicBezTo>
                <a:cubicBezTo>
                  <a:pt x="589926" y="2714626"/>
                  <a:pt x="584111" y="2714626"/>
                  <a:pt x="578296" y="2714626"/>
                </a:cubicBezTo>
                <a:cubicBezTo>
                  <a:pt x="560851" y="2993232"/>
                  <a:pt x="255568" y="2925366"/>
                  <a:pt x="255568" y="2936081"/>
                </a:cubicBezTo>
                <a:cubicBezTo>
                  <a:pt x="229401" y="2953941"/>
                  <a:pt x="197419" y="2911079"/>
                  <a:pt x="165437" y="2953941"/>
                </a:cubicBezTo>
                <a:cubicBezTo>
                  <a:pt x="302087" y="3150394"/>
                  <a:pt x="511425" y="3196828"/>
                  <a:pt x="697501" y="3343275"/>
                </a:cubicBezTo>
                <a:cubicBezTo>
                  <a:pt x="543407" y="3393282"/>
                  <a:pt x="453275" y="3221832"/>
                  <a:pt x="339884" y="3243263"/>
                </a:cubicBezTo>
                <a:cubicBezTo>
                  <a:pt x="284643" y="3296842"/>
                  <a:pt x="450368" y="3382566"/>
                  <a:pt x="290458" y="3407569"/>
                </a:cubicBezTo>
                <a:cubicBezTo>
                  <a:pt x="360236" y="3454004"/>
                  <a:pt x="409664" y="3500439"/>
                  <a:pt x="459090" y="3554016"/>
                </a:cubicBezTo>
                <a:cubicBezTo>
                  <a:pt x="543407" y="3650457"/>
                  <a:pt x="560851" y="3714751"/>
                  <a:pt x="520147" y="3843338"/>
                </a:cubicBezTo>
                <a:cubicBezTo>
                  <a:pt x="493979" y="3929063"/>
                  <a:pt x="456183" y="4007645"/>
                  <a:pt x="491072" y="4107657"/>
                </a:cubicBezTo>
                <a:cubicBezTo>
                  <a:pt x="514332" y="4175522"/>
                  <a:pt x="505609" y="4221957"/>
                  <a:pt x="418386" y="4189810"/>
                </a:cubicBezTo>
                <a:cubicBezTo>
                  <a:pt x="325347" y="4157663"/>
                  <a:pt x="290458" y="4218386"/>
                  <a:pt x="313718" y="4339829"/>
                </a:cubicBezTo>
                <a:cubicBezTo>
                  <a:pt x="328254" y="4418410"/>
                  <a:pt x="313718" y="4443413"/>
                  <a:pt x="249753" y="4432698"/>
                </a:cubicBezTo>
                <a:cubicBezTo>
                  <a:pt x="179975" y="4421982"/>
                  <a:pt x="113103" y="4371976"/>
                  <a:pt x="25879" y="4396979"/>
                </a:cubicBezTo>
                <a:cubicBezTo>
                  <a:pt x="95658" y="4539854"/>
                  <a:pt x="243939" y="4496991"/>
                  <a:pt x="325347" y="4632722"/>
                </a:cubicBezTo>
                <a:cubicBezTo>
                  <a:pt x="229401" y="4632722"/>
                  <a:pt x="153807" y="4632722"/>
                  <a:pt x="84029" y="4604147"/>
                </a:cubicBezTo>
                <a:cubicBezTo>
                  <a:pt x="54954" y="4593433"/>
                  <a:pt x="22972" y="4579145"/>
                  <a:pt x="5527" y="4622007"/>
                </a:cubicBezTo>
                <a:cubicBezTo>
                  <a:pt x="-14826" y="4672014"/>
                  <a:pt x="25879" y="4689872"/>
                  <a:pt x="49139" y="4697016"/>
                </a:cubicBezTo>
                <a:cubicBezTo>
                  <a:pt x="116011" y="4722019"/>
                  <a:pt x="168344" y="4779170"/>
                  <a:pt x="226494" y="4825604"/>
                </a:cubicBezTo>
                <a:cubicBezTo>
                  <a:pt x="351514" y="4925616"/>
                  <a:pt x="488165" y="5011341"/>
                  <a:pt x="592833" y="5175647"/>
                </a:cubicBezTo>
                <a:cubicBezTo>
                  <a:pt x="461997" y="5132785"/>
                  <a:pt x="363144" y="5032772"/>
                  <a:pt x="238123" y="5014913"/>
                </a:cubicBezTo>
                <a:cubicBezTo>
                  <a:pt x="345700" y="5164932"/>
                  <a:pt x="482350" y="5264944"/>
                  <a:pt x="610278" y="5375673"/>
                </a:cubicBezTo>
                <a:cubicBezTo>
                  <a:pt x="648075" y="5407819"/>
                  <a:pt x="685872" y="5429250"/>
                  <a:pt x="691686" y="5497116"/>
                </a:cubicBezTo>
                <a:cubicBezTo>
                  <a:pt x="709132" y="5629276"/>
                  <a:pt x="755650" y="5736432"/>
                  <a:pt x="860319" y="5793582"/>
                </a:cubicBezTo>
                <a:cubicBezTo>
                  <a:pt x="860319" y="5793582"/>
                  <a:pt x="854504" y="5815013"/>
                  <a:pt x="851597" y="5825729"/>
                </a:cubicBezTo>
                <a:cubicBezTo>
                  <a:pt x="787632" y="5829301"/>
                  <a:pt x="738206" y="5750720"/>
                  <a:pt x="659704" y="5779295"/>
                </a:cubicBezTo>
                <a:cubicBezTo>
                  <a:pt x="738206" y="5886451"/>
                  <a:pt x="802169" y="5979319"/>
                  <a:pt x="909746" y="6029326"/>
                </a:cubicBezTo>
                <a:cubicBezTo>
                  <a:pt x="996969" y="6068616"/>
                  <a:pt x="1104545" y="6093620"/>
                  <a:pt x="1168509" y="6222207"/>
                </a:cubicBezTo>
                <a:cubicBezTo>
                  <a:pt x="1095822" y="6247210"/>
                  <a:pt x="1040581" y="6215063"/>
                  <a:pt x="985339" y="6193632"/>
                </a:cubicBezTo>
                <a:cubicBezTo>
                  <a:pt x="901023" y="6157913"/>
                  <a:pt x="816707" y="6118623"/>
                  <a:pt x="732391" y="6082904"/>
                </a:cubicBezTo>
                <a:cubicBezTo>
                  <a:pt x="700408" y="6068616"/>
                  <a:pt x="665519" y="6061472"/>
                  <a:pt x="645167" y="6125766"/>
                </a:cubicBezTo>
                <a:cubicBezTo>
                  <a:pt x="752743" y="6140053"/>
                  <a:pt x="816707" y="6225779"/>
                  <a:pt x="883579" y="6307932"/>
                </a:cubicBezTo>
                <a:cubicBezTo>
                  <a:pt x="921375" y="6354366"/>
                  <a:pt x="953358" y="6415088"/>
                  <a:pt x="1020229" y="6393657"/>
                </a:cubicBezTo>
                <a:cubicBezTo>
                  <a:pt x="1055118" y="6382942"/>
                  <a:pt x="1078378" y="6415088"/>
                  <a:pt x="1075471" y="6457950"/>
                </a:cubicBezTo>
                <a:cubicBezTo>
                  <a:pt x="1060933" y="6607970"/>
                  <a:pt x="1145250" y="6657976"/>
                  <a:pt x="1232473" y="6686551"/>
                </a:cubicBezTo>
                <a:cubicBezTo>
                  <a:pt x="1360401" y="6729413"/>
                  <a:pt x="1473792" y="6815138"/>
                  <a:pt x="1592997" y="6886576"/>
                </a:cubicBezTo>
                <a:lnTo>
                  <a:pt x="5511704" y="6886576"/>
                </a:lnTo>
                <a:close/>
              </a:path>
            </a:pathLst>
          </a:custGeom>
          <a:solidFill>
            <a:schemeClr val="accent1">
              <a:alpha val="20000"/>
            </a:schemeClr>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E265FA82-B204-E7D1-843D-31A7EAA1883B}"/>
              </a:ext>
            </a:extLst>
          </p:cNvPr>
          <p:cNvSpPr>
            <a:spLocks noGrp="1"/>
          </p:cNvSpPr>
          <p:nvPr>
            <p:ph type="title"/>
          </p:nvPr>
        </p:nvSpPr>
        <p:spPr>
          <a:xfrm>
            <a:off x="838200" y="713312"/>
            <a:ext cx="3524250" cy="5431376"/>
          </a:xfrm>
        </p:spPr>
        <p:txBody>
          <a:bodyPr>
            <a:normAutofit/>
          </a:bodyPr>
          <a:lstStyle/>
          <a:p>
            <a:r>
              <a:rPr lang="en-US" b="1" dirty="0"/>
              <a:t>Instructions:</a:t>
            </a:r>
            <a:br>
              <a:rPr lang="en-US" b="1" dirty="0"/>
            </a:br>
            <a:r>
              <a:rPr lang="en-US" b="1" dirty="0">
                <a:solidFill>
                  <a:srgbClr val="00B050"/>
                </a:solidFill>
              </a:rPr>
              <a:t>VTS</a:t>
            </a:r>
          </a:p>
        </p:txBody>
      </p:sp>
      <p:sp>
        <p:nvSpPr>
          <p:cNvPr id="3" name="Content Placeholder 2">
            <a:extLst>
              <a:ext uri="{FF2B5EF4-FFF2-40B4-BE49-F238E27FC236}">
                <a16:creationId xmlns:a16="http://schemas.microsoft.com/office/drawing/2014/main" id="{A3150D43-E28C-6EA9-7F0D-6662021A41CF}"/>
              </a:ext>
            </a:extLst>
          </p:cNvPr>
          <p:cNvSpPr>
            <a:spLocks noGrp="1"/>
          </p:cNvSpPr>
          <p:nvPr>
            <p:ph idx="1"/>
          </p:nvPr>
        </p:nvSpPr>
        <p:spPr>
          <a:xfrm>
            <a:off x="5427023" y="237506"/>
            <a:ext cx="6531429" cy="6460177"/>
          </a:xfrm>
        </p:spPr>
        <p:txBody>
          <a:bodyPr anchor="ctr">
            <a:noAutofit/>
          </a:bodyPr>
          <a:lstStyle/>
          <a:p>
            <a:pPr>
              <a:spcBef>
                <a:spcPts val="0"/>
              </a:spcBef>
              <a:spcAft>
                <a:spcPts val="800"/>
              </a:spcAft>
            </a:pPr>
            <a:r>
              <a:rPr lang="en-US" sz="2600" kern="100" dirty="0">
                <a:effectLst/>
                <a:latin typeface="Calibri" panose="020F0502020204030204" pitchFamily="34" charset="0"/>
                <a:ea typeface="Aptos" panose="020B0004020202020204" pitchFamily="34" charset="0"/>
                <a:cs typeface="Calibri" panose="020F0502020204030204" pitchFamily="34" charset="0"/>
              </a:rPr>
              <a:t>The session starts with VTS. </a:t>
            </a:r>
          </a:p>
          <a:p>
            <a:pPr>
              <a:spcBef>
                <a:spcPts val="0"/>
              </a:spcBef>
              <a:spcAft>
                <a:spcPts val="800"/>
              </a:spcAft>
            </a:pPr>
            <a:r>
              <a:rPr lang="en-US" sz="2600" kern="100">
                <a:effectLst/>
                <a:latin typeface="Calibri" panose="020F0502020204030204" pitchFamily="34" charset="0"/>
                <a:ea typeface="Aptos" panose="020B0004020202020204" pitchFamily="34" charset="0"/>
                <a:cs typeface="Calibri" panose="020F0502020204030204" pitchFamily="34" charset="0"/>
              </a:rPr>
              <a:t>Facilitators will instruct the students about VTS and its process, followed by an actual VTS session. </a:t>
            </a:r>
            <a:endParaRPr lang="en-US" sz="2600" kern="100" dirty="0">
              <a:effectLst/>
              <a:latin typeface="Calibri" panose="020F0502020204030204" pitchFamily="34" charset="0"/>
              <a:ea typeface="Aptos" panose="020B0004020202020204" pitchFamily="34" charset="0"/>
              <a:cs typeface="Calibri" panose="020F0502020204030204" pitchFamily="34" charset="0"/>
            </a:endParaRPr>
          </a:p>
          <a:p>
            <a:pPr>
              <a:spcBef>
                <a:spcPts val="0"/>
              </a:spcBef>
              <a:spcAft>
                <a:spcPts val="800"/>
              </a:spcAft>
            </a:pPr>
            <a:r>
              <a:rPr lang="en-US" sz="2600" kern="100" dirty="0">
                <a:effectLst/>
                <a:latin typeface="Calibri" panose="020F0502020204030204" pitchFamily="34" charset="0"/>
                <a:ea typeface="Aptos" panose="020B0004020202020204" pitchFamily="34" charset="0"/>
                <a:cs typeface="Calibri" panose="020F0502020204030204" pitchFamily="34" charset="0"/>
              </a:rPr>
              <a:t>This activity will be conducted for 30 minutes. </a:t>
            </a:r>
          </a:p>
        </p:txBody>
      </p:sp>
    </p:spTree>
    <p:extLst>
      <p:ext uri="{BB962C8B-B14F-4D97-AF65-F5344CB8AC3E}">
        <p14:creationId xmlns:p14="http://schemas.microsoft.com/office/powerpoint/2010/main" val="14648315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7718681-A12E-49D6-9925-DD7C68176D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FBD77573-9EF2-4C35-8285-A1CF6FBB0E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 y="0"/>
            <a:ext cx="5511704" cy="6858000"/>
          </a:xfrm>
          <a:custGeom>
            <a:avLst/>
            <a:gdLst>
              <a:gd name="connsiteX0" fmla="*/ 5511704 w 5511704"/>
              <a:gd name="connsiteY0" fmla="*/ 0 h 6886576"/>
              <a:gd name="connsiteX1" fmla="*/ 1008599 w 5511704"/>
              <a:gd name="connsiteY1" fmla="*/ 0 h 6886576"/>
              <a:gd name="connsiteX2" fmla="*/ 1310975 w 5511704"/>
              <a:gd name="connsiteY2" fmla="*/ 110728 h 6886576"/>
              <a:gd name="connsiteX3" fmla="*/ 1267362 w 5511704"/>
              <a:gd name="connsiteY3" fmla="*/ 135731 h 6886576"/>
              <a:gd name="connsiteX4" fmla="*/ 1005692 w 5511704"/>
              <a:gd name="connsiteY4" fmla="*/ 71437 h 6886576"/>
              <a:gd name="connsiteX5" fmla="*/ 953358 w 5511704"/>
              <a:gd name="connsiteY5" fmla="*/ 89297 h 6886576"/>
              <a:gd name="connsiteX6" fmla="*/ 979525 w 5511704"/>
              <a:gd name="connsiteY6" fmla="*/ 164307 h 6886576"/>
              <a:gd name="connsiteX7" fmla="*/ 1092915 w 5511704"/>
              <a:gd name="connsiteY7" fmla="*/ 192882 h 6886576"/>
              <a:gd name="connsiteX8" fmla="*/ 1270270 w 5511704"/>
              <a:gd name="connsiteY8" fmla="*/ 375047 h 6886576"/>
              <a:gd name="connsiteX9" fmla="*/ 1002784 w 5511704"/>
              <a:gd name="connsiteY9" fmla="*/ 353615 h 6886576"/>
              <a:gd name="connsiteX10" fmla="*/ 956265 w 5511704"/>
              <a:gd name="connsiteY10" fmla="*/ 396479 h 6886576"/>
              <a:gd name="connsiteX11" fmla="*/ 938820 w 5511704"/>
              <a:gd name="connsiteY11" fmla="*/ 453629 h 6886576"/>
              <a:gd name="connsiteX12" fmla="*/ 860319 w 5511704"/>
              <a:gd name="connsiteY12" fmla="*/ 360759 h 6886576"/>
              <a:gd name="connsiteX13" fmla="*/ 793447 w 5511704"/>
              <a:gd name="connsiteY13" fmla="*/ 335757 h 6886576"/>
              <a:gd name="connsiteX14" fmla="*/ 773095 w 5511704"/>
              <a:gd name="connsiteY14" fmla="*/ 417910 h 6886576"/>
              <a:gd name="connsiteX15" fmla="*/ 834151 w 5511704"/>
              <a:gd name="connsiteY15" fmla="*/ 507206 h 6886576"/>
              <a:gd name="connsiteX16" fmla="*/ 996969 w 5511704"/>
              <a:gd name="connsiteY16" fmla="*/ 560785 h 6886576"/>
              <a:gd name="connsiteX17" fmla="*/ 822522 w 5511704"/>
              <a:gd name="connsiteY17" fmla="*/ 560785 h 6886576"/>
              <a:gd name="connsiteX18" fmla="*/ 621908 w 5511704"/>
              <a:gd name="connsiteY18" fmla="*/ 525066 h 6886576"/>
              <a:gd name="connsiteX19" fmla="*/ 409664 w 5511704"/>
              <a:gd name="connsiteY19" fmla="*/ 535781 h 6886576"/>
              <a:gd name="connsiteX20" fmla="*/ 209049 w 5511704"/>
              <a:gd name="connsiteY20" fmla="*/ 464344 h 6886576"/>
              <a:gd name="connsiteX21" fmla="*/ 5527 w 5511704"/>
              <a:gd name="connsiteY21" fmla="*/ 467916 h 6886576"/>
              <a:gd name="connsiteX22" fmla="*/ 906838 w 5511704"/>
              <a:gd name="connsiteY22" fmla="*/ 914400 h 6886576"/>
              <a:gd name="connsiteX23" fmla="*/ 863226 w 5511704"/>
              <a:gd name="connsiteY23" fmla="*/ 925116 h 6886576"/>
              <a:gd name="connsiteX24" fmla="*/ 805077 w 5511704"/>
              <a:gd name="connsiteY24" fmla="*/ 953691 h 6886576"/>
              <a:gd name="connsiteX25" fmla="*/ 848689 w 5511704"/>
              <a:gd name="connsiteY25" fmla="*/ 1010841 h 6886576"/>
              <a:gd name="connsiteX26" fmla="*/ 1084193 w 5511704"/>
              <a:gd name="connsiteY26" fmla="*/ 1117997 h 6886576"/>
              <a:gd name="connsiteX27" fmla="*/ 1142342 w 5511704"/>
              <a:gd name="connsiteY27" fmla="*/ 1225153 h 6886576"/>
              <a:gd name="connsiteX28" fmla="*/ 1069655 w 5511704"/>
              <a:gd name="connsiteY28" fmla="*/ 1214438 h 6886576"/>
              <a:gd name="connsiteX29" fmla="*/ 1005692 w 5511704"/>
              <a:gd name="connsiteY29" fmla="*/ 1235869 h 6886576"/>
              <a:gd name="connsiteX30" fmla="*/ 1031858 w 5511704"/>
              <a:gd name="connsiteY30" fmla="*/ 1371600 h 6886576"/>
              <a:gd name="connsiteX31" fmla="*/ 1366216 w 5511704"/>
              <a:gd name="connsiteY31" fmla="*/ 1546622 h 6886576"/>
              <a:gd name="connsiteX32" fmla="*/ 1395290 w 5511704"/>
              <a:gd name="connsiteY32" fmla="*/ 1603772 h 6886576"/>
              <a:gd name="connsiteX33" fmla="*/ 1354586 w 5511704"/>
              <a:gd name="connsiteY33" fmla="*/ 1643063 h 6886576"/>
              <a:gd name="connsiteX34" fmla="*/ 1247011 w 5511704"/>
              <a:gd name="connsiteY34" fmla="*/ 1664494 h 6886576"/>
              <a:gd name="connsiteX35" fmla="*/ 1398198 w 5511704"/>
              <a:gd name="connsiteY35" fmla="*/ 1857375 h 6886576"/>
              <a:gd name="connsiteX36" fmla="*/ 1453440 w 5511704"/>
              <a:gd name="connsiteY36" fmla="*/ 1910954 h 6886576"/>
              <a:gd name="connsiteX37" fmla="*/ 1549386 w 5511704"/>
              <a:gd name="connsiteY37" fmla="*/ 1993106 h 6886576"/>
              <a:gd name="connsiteX38" fmla="*/ 1549386 w 5511704"/>
              <a:gd name="connsiteY38" fmla="*/ 2021681 h 6886576"/>
              <a:gd name="connsiteX39" fmla="*/ 1421458 w 5511704"/>
              <a:gd name="connsiteY39" fmla="*/ 2110978 h 6886576"/>
              <a:gd name="connsiteX40" fmla="*/ 1188861 w 5511704"/>
              <a:gd name="connsiteY40" fmla="*/ 2085976 h 6886576"/>
              <a:gd name="connsiteX41" fmla="*/ 1531941 w 5511704"/>
              <a:gd name="connsiteY41" fmla="*/ 2218135 h 6886576"/>
              <a:gd name="connsiteX42" fmla="*/ 421293 w 5511704"/>
              <a:gd name="connsiteY42" fmla="*/ 1900238 h 6886576"/>
              <a:gd name="connsiteX43" fmla="*/ 491072 w 5511704"/>
              <a:gd name="connsiteY43" fmla="*/ 1982391 h 6886576"/>
              <a:gd name="connsiteX44" fmla="*/ 880671 w 5511704"/>
              <a:gd name="connsiteY44" fmla="*/ 2200276 h 6886576"/>
              <a:gd name="connsiteX45" fmla="*/ 991154 w 5511704"/>
              <a:gd name="connsiteY45" fmla="*/ 2336007 h 6886576"/>
              <a:gd name="connsiteX46" fmla="*/ 1107453 w 5511704"/>
              <a:gd name="connsiteY46" fmla="*/ 2411016 h 6886576"/>
              <a:gd name="connsiteX47" fmla="*/ 1270270 w 5511704"/>
              <a:gd name="connsiteY47" fmla="*/ 2411016 h 6886576"/>
              <a:gd name="connsiteX48" fmla="*/ 1386568 w 5511704"/>
              <a:gd name="connsiteY48" fmla="*/ 2528889 h 6886576"/>
              <a:gd name="connsiteX49" fmla="*/ 1267362 w 5511704"/>
              <a:gd name="connsiteY49" fmla="*/ 2553891 h 6886576"/>
              <a:gd name="connsiteX50" fmla="*/ 1127805 w 5511704"/>
              <a:gd name="connsiteY50" fmla="*/ 2536032 h 6886576"/>
              <a:gd name="connsiteX51" fmla="*/ 970802 w 5511704"/>
              <a:gd name="connsiteY51" fmla="*/ 2575322 h 6886576"/>
              <a:gd name="connsiteX52" fmla="*/ 825429 w 5511704"/>
              <a:gd name="connsiteY52" fmla="*/ 2543176 h 6886576"/>
              <a:gd name="connsiteX53" fmla="*/ 650982 w 5511704"/>
              <a:gd name="connsiteY53" fmla="*/ 2564607 h 6886576"/>
              <a:gd name="connsiteX54" fmla="*/ 595740 w 5511704"/>
              <a:gd name="connsiteY54" fmla="*/ 2703909 h 6886576"/>
              <a:gd name="connsiteX55" fmla="*/ 578296 w 5511704"/>
              <a:gd name="connsiteY55" fmla="*/ 2714626 h 6886576"/>
              <a:gd name="connsiteX56" fmla="*/ 255568 w 5511704"/>
              <a:gd name="connsiteY56" fmla="*/ 2936081 h 6886576"/>
              <a:gd name="connsiteX57" fmla="*/ 165437 w 5511704"/>
              <a:gd name="connsiteY57" fmla="*/ 2953941 h 6886576"/>
              <a:gd name="connsiteX58" fmla="*/ 697501 w 5511704"/>
              <a:gd name="connsiteY58" fmla="*/ 3343275 h 6886576"/>
              <a:gd name="connsiteX59" fmla="*/ 339884 w 5511704"/>
              <a:gd name="connsiteY59" fmla="*/ 3243263 h 6886576"/>
              <a:gd name="connsiteX60" fmla="*/ 290458 w 5511704"/>
              <a:gd name="connsiteY60" fmla="*/ 3407569 h 6886576"/>
              <a:gd name="connsiteX61" fmla="*/ 459090 w 5511704"/>
              <a:gd name="connsiteY61" fmla="*/ 3554016 h 6886576"/>
              <a:gd name="connsiteX62" fmla="*/ 520147 w 5511704"/>
              <a:gd name="connsiteY62" fmla="*/ 3843338 h 6886576"/>
              <a:gd name="connsiteX63" fmla="*/ 491072 w 5511704"/>
              <a:gd name="connsiteY63" fmla="*/ 4107657 h 6886576"/>
              <a:gd name="connsiteX64" fmla="*/ 418386 w 5511704"/>
              <a:gd name="connsiteY64" fmla="*/ 4189810 h 6886576"/>
              <a:gd name="connsiteX65" fmla="*/ 313718 w 5511704"/>
              <a:gd name="connsiteY65" fmla="*/ 4339829 h 6886576"/>
              <a:gd name="connsiteX66" fmla="*/ 249753 w 5511704"/>
              <a:gd name="connsiteY66" fmla="*/ 4432698 h 6886576"/>
              <a:gd name="connsiteX67" fmla="*/ 25879 w 5511704"/>
              <a:gd name="connsiteY67" fmla="*/ 4396979 h 6886576"/>
              <a:gd name="connsiteX68" fmla="*/ 325347 w 5511704"/>
              <a:gd name="connsiteY68" fmla="*/ 4632722 h 6886576"/>
              <a:gd name="connsiteX69" fmla="*/ 84029 w 5511704"/>
              <a:gd name="connsiteY69" fmla="*/ 4604147 h 6886576"/>
              <a:gd name="connsiteX70" fmla="*/ 5527 w 5511704"/>
              <a:gd name="connsiteY70" fmla="*/ 4622007 h 6886576"/>
              <a:gd name="connsiteX71" fmla="*/ 49139 w 5511704"/>
              <a:gd name="connsiteY71" fmla="*/ 4697016 h 6886576"/>
              <a:gd name="connsiteX72" fmla="*/ 226494 w 5511704"/>
              <a:gd name="connsiteY72" fmla="*/ 4825604 h 6886576"/>
              <a:gd name="connsiteX73" fmla="*/ 592833 w 5511704"/>
              <a:gd name="connsiteY73" fmla="*/ 5175647 h 6886576"/>
              <a:gd name="connsiteX74" fmla="*/ 238123 w 5511704"/>
              <a:gd name="connsiteY74" fmla="*/ 5014913 h 6886576"/>
              <a:gd name="connsiteX75" fmla="*/ 610278 w 5511704"/>
              <a:gd name="connsiteY75" fmla="*/ 5375673 h 6886576"/>
              <a:gd name="connsiteX76" fmla="*/ 691686 w 5511704"/>
              <a:gd name="connsiteY76" fmla="*/ 5497116 h 6886576"/>
              <a:gd name="connsiteX77" fmla="*/ 860319 w 5511704"/>
              <a:gd name="connsiteY77" fmla="*/ 5793582 h 6886576"/>
              <a:gd name="connsiteX78" fmla="*/ 851597 w 5511704"/>
              <a:gd name="connsiteY78" fmla="*/ 5825729 h 6886576"/>
              <a:gd name="connsiteX79" fmla="*/ 659704 w 5511704"/>
              <a:gd name="connsiteY79" fmla="*/ 5779295 h 6886576"/>
              <a:gd name="connsiteX80" fmla="*/ 909746 w 5511704"/>
              <a:gd name="connsiteY80" fmla="*/ 6029326 h 6886576"/>
              <a:gd name="connsiteX81" fmla="*/ 1168509 w 5511704"/>
              <a:gd name="connsiteY81" fmla="*/ 6222207 h 6886576"/>
              <a:gd name="connsiteX82" fmla="*/ 985339 w 5511704"/>
              <a:gd name="connsiteY82" fmla="*/ 6193632 h 6886576"/>
              <a:gd name="connsiteX83" fmla="*/ 732391 w 5511704"/>
              <a:gd name="connsiteY83" fmla="*/ 6082904 h 6886576"/>
              <a:gd name="connsiteX84" fmla="*/ 645167 w 5511704"/>
              <a:gd name="connsiteY84" fmla="*/ 6125766 h 6886576"/>
              <a:gd name="connsiteX85" fmla="*/ 883579 w 5511704"/>
              <a:gd name="connsiteY85" fmla="*/ 6307932 h 6886576"/>
              <a:gd name="connsiteX86" fmla="*/ 1020229 w 5511704"/>
              <a:gd name="connsiteY86" fmla="*/ 6393657 h 6886576"/>
              <a:gd name="connsiteX87" fmla="*/ 1075471 w 5511704"/>
              <a:gd name="connsiteY87" fmla="*/ 6457950 h 6886576"/>
              <a:gd name="connsiteX88" fmla="*/ 1232473 w 5511704"/>
              <a:gd name="connsiteY88" fmla="*/ 6686551 h 6886576"/>
              <a:gd name="connsiteX89" fmla="*/ 1592997 w 5511704"/>
              <a:gd name="connsiteY89" fmla="*/ 6886576 h 6886576"/>
              <a:gd name="connsiteX90" fmla="*/ 5511704 w 5511704"/>
              <a:gd name="connsiteY90" fmla="*/ 6886576 h 68865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Lst>
            <a:rect l="l" t="t" r="r" b="b"/>
            <a:pathLst>
              <a:path w="5511704" h="6886576">
                <a:moveTo>
                  <a:pt x="5511704" y="0"/>
                </a:moveTo>
                <a:lnTo>
                  <a:pt x="1008599" y="0"/>
                </a:lnTo>
                <a:cubicBezTo>
                  <a:pt x="1110360" y="35719"/>
                  <a:pt x="1209214" y="78581"/>
                  <a:pt x="1310975" y="110728"/>
                </a:cubicBezTo>
                <a:cubicBezTo>
                  <a:pt x="1296437" y="146447"/>
                  <a:pt x="1281900" y="139303"/>
                  <a:pt x="1267362" y="135731"/>
                </a:cubicBezTo>
                <a:cubicBezTo>
                  <a:pt x="1180139" y="121445"/>
                  <a:pt x="1090008" y="110728"/>
                  <a:pt x="1005692" y="71437"/>
                </a:cubicBezTo>
                <a:cubicBezTo>
                  <a:pt x="985339" y="64294"/>
                  <a:pt x="962080" y="64294"/>
                  <a:pt x="953358" y="89297"/>
                </a:cubicBezTo>
                <a:cubicBezTo>
                  <a:pt x="938820" y="125016"/>
                  <a:pt x="959172" y="146447"/>
                  <a:pt x="979525" y="164307"/>
                </a:cubicBezTo>
                <a:cubicBezTo>
                  <a:pt x="1014414" y="196453"/>
                  <a:pt x="1055118" y="189310"/>
                  <a:pt x="1092915" y="192882"/>
                </a:cubicBezTo>
                <a:cubicBezTo>
                  <a:pt x="1197583" y="210741"/>
                  <a:pt x="1247011" y="260747"/>
                  <a:pt x="1270270" y="375047"/>
                </a:cubicBezTo>
                <a:cubicBezTo>
                  <a:pt x="1180139" y="328613"/>
                  <a:pt x="1090008" y="385763"/>
                  <a:pt x="1002784" y="353615"/>
                </a:cubicBezTo>
                <a:cubicBezTo>
                  <a:pt x="979525" y="346472"/>
                  <a:pt x="944635" y="357188"/>
                  <a:pt x="956265" y="396479"/>
                </a:cubicBezTo>
                <a:cubicBezTo>
                  <a:pt x="967894" y="432198"/>
                  <a:pt x="1005692" y="460772"/>
                  <a:pt x="938820" y="453629"/>
                </a:cubicBezTo>
                <a:cubicBezTo>
                  <a:pt x="889393" y="450056"/>
                  <a:pt x="874856" y="407194"/>
                  <a:pt x="860319" y="360759"/>
                </a:cubicBezTo>
                <a:cubicBezTo>
                  <a:pt x="848689" y="335757"/>
                  <a:pt x="816707" y="321469"/>
                  <a:pt x="793447" y="335757"/>
                </a:cubicBezTo>
                <a:cubicBezTo>
                  <a:pt x="764373" y="350044"/>
                  <a:pt x="773095" y="389335"/>
                  <a:pt x="773095" y="417910"/>
                </a:cubicBezTo>
                <a:cubicBezTo>
                  <a:pt x="770187" y="471488"/>
                  <a:pt x="793447" y="496491"/>
                  <a:pt x="834151" y="507206"/>
                </a:cubicBezTo>
                <a:cubicBezTo>
                  <a:pt x="883579" y="521494"/>
                  <a:pt x="933005" y="539354"/>
                  <a:pt x="996969" y="560785"/>
                </a:cubicBezTo>
                <a:cubicBezTo>
                  <a:pt x="927190" y="596503"/>
                  <a:pt x="874856" y="589360"/>
                  <a:pt x="822522" y="560785"/>
                </a:cubicBezTo>
                <a:cubicBezTo>
                  <a:pt x="758558" y="528637"/>
                  <a:pt x="674242" y="485775"/>
                  <a:pt x="621908" y="525066"/>
                </a:cubicBezTo>
                <a:cubicBezTo>
                  <a:pt x="543407" y="582216"/>
                  <a:pt x="479443" y="546497"/>
                  <a:pt x="409664" y="535781"/>
                </a:cubicBezTo>
                <a:cubicBezTo>
                  <a:pt x="264290" y="514350"/>
                  <a:pt x="354422" y="482204"/>
                  <a:pt x="209049" y="464344"/>
                </a:cubicBezTo>
                <a:cubicBezTo>
                  <a:pt x="150900" y="457200"/>
                  <a:pt x="89843" y="428625"/>
                  <a:pt x="5527" y="467916"/>
                </a:cubicBezTo>
                <a:cubicBezTo>
                  <a:pt x="386404" y="675085"/>
                  <a:pt x="566666" y="660797"/>
                  <a:pt x="906838" y="914400"/>
                </a:cubicBezTo>
                <a:cubicBezTo>
                  <a:pt x="892301" y="939404"/>
                  <a:pt x="877764" y="928688"/>
                  <a:pt x="863226" y="925116"/>
                </a:cubicBezTo>
                <a:cubicBezTo>
                  <a:pt x="839967" y="921544"/>
                  <a:pt x="810892" y="907256"/>
                  <a:pt x="805077" y="953691"/>
                </a:cubicBezTo>
                <a:cubicBezTo>
                  <a:pt x="802169" y="989410"/>
                  <a:pt x="819615" y="1007269"/>
                  <a:pt x="848689" y="1010841"/>
                </a:cubicBezTo>
                <a:cubicBezTo>
                  <a:pt x="933005" y="1025129"/>
                  <a:pt x="1008599" y="1075135"/>
                  <a:pt x="1084193" y="1117997"/>
                </a:cubicBezTo>
                <a:cubicBezTo>
                  <a:pt x="1119082" y="1135857"/>
                  <a:pt x="1156879" y="1160860"/>
                  <a:pt x="1142342" y="1225153"/>
                </a:cubicBezTo>
                <a:cubicBezTo>
                  <a:pt x="1113268" y="1243013"/>
                  <a:pt x="1092915" y="1218009"/>
                  <a:pt x="1069655" y="1214438"/>
                </a:cubicBezTo>
                <a:cubicBezTo>
                  <a:pt x="1046396" y="1210866"/>
                  <a:pt x="991154" y="1225153"/>
                  <a:pt x="1005692" y="1235869"/>
                </a:cubicBezTo>
                <a:cubicBezTo>
                  <a:pt x="1072563" y="1275159"/>
                  <a:pt x="950450" y="1371600"/>
                  <a:pt x="1031858" y="1371600"/>
                </a:cubicBezTo>
                <a:cubicBezTo>
                  <a:pt x="1165601" y="1371600"/>
                  <a:pt x="1238288" y="1543050"/>
                  <a:pt x="1366216" y="1546622"/>
                </a:cubicBezTo>
                <a:cubicBezTo>
                  <a:pt x="1386568" y="1546622"/>
                  <a:pt x="1395290" y="1578770"/>
                  <a:pt x="1395290" y="1603772"/>
                </a:cubicBezTo>
                <a:cubicBezTo>
                  <a:pt x="1395290" y="1635920"/>
                  <a:pt x="1374939" y="1639491"/>
                  <a:pt x="1354586" y="1643063"/>
                </a:cubicBezTo>
                <a:cubicBezTo>
                  <a:pt x="1322604" y="1646635"/>
                  <a:pt x="1287715" y="1603772"/>
                  <a:pt x="1247011" y="1664494"/>
                </a:cubicBezTo>
                <a:cubicBezTo>
                  <a:pt x="1322604" y="1700213"/>
                  <a:pt x="1401105" y="1735932"/>
                  <a:pt x="1398198" y="1857375"/>
                </a:cubicBezTo>
                <a:cubicBezTo>
                  <a:pt x="1398198" y="1889523"/>
                  <a:pt x="1430180" y="1903810"/>
                  <a:pt x="1453440" y="1910954"/>
                </a:cubicBezTo>
                <a:cubicBezTo>
                  <a:pt x="1494144" y="1925241"/>
                  <a:pt x="1526126" y="1946673"/>
                  <a:pt x="1549386" y="1993106"/>
                </a:cubicBezTo>
                <a:cubicBezTo>
                  <a:pt x="1549386" y="2003822"/>
                  <a:pt x="1549386" y="2010966"/>
                  <a:pt x="1549386" y="2021681"/>
                </a:cubicBezTo>
                <a:cubicBezTo>
                  <a:pt x="1543571" y="2132410"/>
                  <a:pt x="1485422" y="2128838"/>
                  <a:pt x="1421458" y="2110978"/>
                </a:cubicBezTo>
                <a:cubicBezTo>
                  <a:pt x="1345864" y="2089547"/>
                  <a:pt x="1270270" y="2046685"/>
                  <a:pt x="1188861" y="2085976"/>
                </a:cubicBezTo>
                <a:cubicBezTo>
                  <a:pt x="1302252" y="2139554"/>
                  <a:pt x="1427272" y="2143126"/>
                  <a:pt x="1531941" y="2218135"/>
                </a:cubicBezTo>
                <a:cubicBezTo>
                  <a:pt x="1142342" y="2232422"/>
                  <a:pt x="799262" y="1993106"/>
                  <a:pt x="421293" y="1900238"/>
                </a:cubicBezTo>
                <a:cubicBezTo>
                  <a:pt x="432923" y="1960960"/>
                  <a:pt x="464905" y="1975247"/>
                  <a:pt x="491072" y="1982391"/>
                </a:cubicBezTo>
                <a:cubicBezTo>
                  <a:pt x="630630" y="2028825"/>
                  <a:pt x="752743" y="2121695"/>
                  <a:pt x="880671" y="2200276"/>
                </a:cubicBezTo>
                <a:cubicBezTo>
                  <a:pt x="933005" y="2232422"/>
                  <a:pt x="970802" y="2268142"/>
                  <a:pt x="991154" y="2336007"/>
                </a:cubicBezTo>
                <a:cubicBezTo>
                  <a:pt x="1008599" y="2400300"/>
                  <a:pt x="1043489" y="2428875"/>
                  <a:pt x="1107453" y="2411016"/>
                </a:cubicBezTo>
                <a:cubicBezTo>
                  <a:pt x="1159787" y="2396729"/>
                  <a:pt x="1215029" y="2403873"/>
                  <a:pt x="1270270" y="2411016"/>
                </a:cubicBezTo>
                <a:cubicBezTo>
                  <a:pt x="1331326" y="2418160"/>
                  <a:pt x="1401105" y="2489597"/>
                  <a:pt x="1386568" y="2528889"/>
                </a:cubicBezTo>
                <a:cubicBezTo>
                  <a:pt x="1357494" y="2593182"/>
                  <a:pt x="1308067" y="2561035"/>
                  <a:pt x="1267362" y="2553891"/>
                </a:cubicBezTo>
                <a:cubicBezTo>
                  <a:pt x="1217936" y="2546748"/>
                  <a:pt x="1127805" y="2528889"/>
                  <a:pt x="1127805" y="2536032"/>
                </a:cubicBezTo>
                <a:cubicBezTo>
                  <a:pt x="1095822" y="2696766"/>
                  <a:pt x="1023136" y="2575322"/>
                  <a:pt x="970802" y="2575322"/>
                </a:cubicBezTo>
                <a:cubicBezTo>
                  <a:pt x="921375" y="2575322"/>
                  <a:pt x="871949" y="2557463"/>
                  <a:pt x="825429" y="2543176"/>
                </a:cubicBezTo>
                <a:cubicBezTo>
                  <a:pt x="764373" y="2525316"/>
                  <a:pt x="709132" y="2557463"/>
                  <a:pt x="650982" y="2564607"/>
                </a:cubicBezTo>
                <a:cubicBezTo>
                  <a:pt x="598648" y="2571751"/>
                  <a:pt x="627722" y="2664620"/>
                  <a:pt x="595740" y="2703909"/>
                </a:cubicBezTo>
                <a:cubicBezTo>
                  <a:pt x="589926" y="2714626"/>
                  <a:pt x="584111" y="2714626"/>
                  <a:pt x="578296" y="2714626"/>
                </a:cubicBezTo>
                <a:cubicBezTo>
                  <a:pt x="560851" y="2993232"/>
                  <a:pt x="255568" y="2925366"/>
                  <a:pt x="255568" y="2936081"/>
                </a:cubicBezTo>
                <a:cubicBezTo>
                  <a:pt x="229401" y="2953941"/>
                  <a:pt x="197419" y="2911079"/>
                  <a:pt x="165437" y="2953941"/>
                </a:cubicBezTo>
                <a:cubicBezTo>
                  <a:pt x="302087" y="3150394"/>
                  <a:pt x="511425" y="3196828"/>
                  <a:pt x="697501" y="3343275"/>
                </a:cubicBezTo>
                <a:cubicBezTo>
                  <a:pt x="543407" y="3393282"/>
                  <a:pt x="453275" y="3221832"/>
                  <a:pt x="339884" y="3243263"/>
                </a:cubicBezTo>
                <a:cubicBezTo>
                  <a:pt x="284643" y="3296842"/>
                  <a:pt x="450368" y="3382566"/>
                  <a:pt x="290458" y="3407569"/>
                </a:cubicBezTo>
                <a:cubicBezTo>
                  <a:pt x="360236" y="3454004"/>
                  <a:pt x="409664" y="3500439"/>
                  <a:pt x="459090" y="3554016"/>
                </a:cubicBezTo>
                <a:cubicBezTo>
                  <a:pt x="543407" y="3650457"/>
                  <a:pt x="560851" y="3714751"/>
                  <a:pt x="520147" y="3843338"/>
                </a:cubicBezTo>
                <a:cubicBezTo>
                  <a:pt x="493979" y="3929063"/>
                  <a:pt x="456183" y="4007645"/>
                  <a:pt x="491072" y="4107657"/>
                </a:cubicBezTo>
                <a:cubicBezTo>
                  <a:pt x="514332" y="4175522"/>
                  <a:pt x="505609" y="4221957"/>
                  <a:pt x="418386" y="4189810"/>
                </a:cubicBezTo>
                <a:cubicBezTo>
                  <a:pt x="325347" y="4157663"/>
                  <a:pt x="290458" y="4218386"/>
                  <a:pt x="313718" y="4339829"/>
                </a:cubicBezTo>
                <a:cubicBezTo>
                  <a:pt x="328254" y="4418410"/>
                  <a:pt x="313718" y="4443413"/>
                  <a:pt x="249753" y="4432698"/>
                </a:cubicBezTo>
                <a:cubicBezTo>
                  <a:pt x="179975" y="4421982"/>
                  <a:pt x="113103" y="4371976"/>
                  <a:pt x="25879" y="4396979"/>
                </a:cubicBezTo>
                <a:cubicBezTo>
                  <a:pt x="95658" y="4539854"/>
                  <a:pt x="243939" y="4496991"/>
                  <a:pt x="325347" y="4632722"/>
                </a:cubicBezTo>
                <a:cubicBezTo>
                  <a:pt x="229401" y="4632722"/>
                  <a:pt x="153807" y="4632722"/>
                  <a:pt x="84029" y="4604147"/>
                </a:cubicBezTo>
                <a:cubicBezTo>
                  <a:pt x="54954" y="4593433"/>
                  <a:pt x="22972" y="4579145"/>
                  <a:pt x="5527" y="4622007"/>
                </a:cubicBezTo>
                <a:cubicBezTo>
                  <a:pt x="-14826" y="4672014"/>
                  <a:pt x="25879" y="4689872"/>
                  <a:pt x="49139" y="4697016"/>
                </a:cubicBezTo>
                <a:cubicBezTo>
                  <a:pt x="116011" y="4722019"/>
                  <a:pt x="168344" y="4779170"/>
                  <a:pt x="226494" y="4825604"/>
                </a:cubicBezTo>
                <a:cubicBezTo>
                  <a:pt x="351514" y="4925616"/>
                  <a:pt x="488165" y="5011341"/>
                  <a:pt x="592833" y="5175647"/>
                </a:cubicBezTo>
                <a:cubicBezTo>
                  <a:pt x="461997" y="5132785"/>
                  <a:pt x="363144" y="5032772"/>
                  <a:pt x="238123" y="5014913"/>
                </a:cubicBezTo>
                <a:cubicBezTo>
                  <a:pt x="345700" y="5164932"/>
                  <a:pt x="482350" y="5264944"/>
                  <a:pt x="610278" y="5375673"/>
                </a:cubicBezTo>
                <a:cubicBezTo>
                  <a:pt x="648075" y="5407819"/>
                  <a:pt x="685872" y="5429250"/>
                  <a:pt x="691686" y="5497116"/>
                </a:cubicBezTo>
                <a:cubicBezTo>
                  <a:pt x="709132" y="5629276"/>
                  <a:pt x="755650" y="5736432"/>
                  <a:pt x="860319" y="5793582"/>
                </a:cubicBezTo>
                <a:cubicBezTo>
                  <a:pt x="860319" y="5793582"/>
                  <a:pt x="854504" y="5815013"/>
                  <a:pt x="851597" y="5825729"/>
                </a:cubicBezTo>
                <a:cubicBezTo>
                  <a:pt x="787632" y="5829301"/>
                  <a:pt x="738206" y="5750720"/>
                  <a:pt x="659704" y="5779295"/>
                </a:cubicBezTo>
                <a:cubicBezTo>
                  <a:pt x="738206" y="5886451"/>
                  <a:pt x="802169" y="5979319"/>
                  <a:pt x="909746" y="6029326"/>
                </a:cubicBezTo>
                <a:cubicBezTo>
                  <a:pt x="996969" y="6068616"/>
                  <a:pt x="1104545" y="6093620"/>
                  <a:pt x="1168509" y="6222207"/>
                </a:cubicBezTo>
                <a:cubicBezTo>
                  <a:pt x="1095822" y="6247210"/>
                  <a:pt x="1040581" y="6215063"/>
                  <a:pt x="985339" y="6193632"/>
                </a:cubicBezTo>
                <a:cubicBezTo>
                  <a:pt x="901023" y="6157913"/>
                  <a:pt x="816707" y="6118623"/>
                  <a:pt x="732391" y="6082904"/>
                </a:cubicBezTo>
                <a:cubicBezTo>
                  <a:pt x="700408" y="6068616"/>
                  <a:pt x="665519" y="6061472"/>
                  <a:pt x="645167" y="6125766"/>
                </a:cubicBezTo>
                <a:cubicBezTo>
                  <a:pt x="752743" y="6140053"/>
                  <a:pt x="816707" y="6225779"/>
                  <a:pt x="883579" y="6307932"/>
                </a:cubicBezTo>
                <a:cubicBezTo>
                  <a:pt x="921375" y="6354366"/>
                  <a:pt x="953358" y="6415088"/>
                  <a:pt x="1020229" y="6393657"/>
                </a:cubicBezTo>
                <a:cubicBezTo>
                  <a:pt x="1055118" y="6382942"/>
                  <a:pt x="1078378" y="6415088"/>
                  <a:pt x="1075471" y="6457950"/>
                </a:cubicBezTo>
                <a:cubicBezTo>
                  <a:pt x="1060933" y="6607970"/>
                  <a:pt x="1145250" y="6657976"/>
                  <a:pt x="1232473" y="6686551"/>
                </a:cubicBezTo>
                <a:cubicBezTo>
                  <a:pt x="1360401" y="6729413"/>
                  <a:pt x="1473792" y="6815138"/>
                  <a:pt x="1592997" y="6886576"/>
                </a:cubicBezTo>
                <a:lnTo>
                  <a:pt x="5511704" y="6886576"/>
                </a:lnTo>
                <a:close/>
              </a:path>
            </a:pathLst>
          </a:custGeom>
          <a:solidFill>
            <a:schemeClr val="accent1"/>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1BD74D6E-70B2-1BFA-A72D-6F85D18D337D}"/>
              </a:ext>
            </a:extLst>
          </p:cNvPr>
          <p:cNvSpPr>
            <a:spLocks noGrp="1"/>
          </p:cNvSpPr>
          <p:nvPr>
            <p:ph type="title"/>
          </p:nvPr>
        </p:nvSpPr>
        <p:spPr>
          <a:xfrm>
            <a:off x="838200" y="713312"/>
            <a:ext cx="3461084" cy="5431376"/>
          </a:xfrm>
        </p:spPr>
        <p:txBody>
          <a:bodyPr>
            <a:normAutofit/>
          </a:bodyPr>
          <a:lstStyle/>
          <a:p>
            <a:r>
              <a:rPr lang="en-US" b="1" dirty="0">
                <a:solidFill>
                  <a:srgbClr val="FFFFFF"/>
                </a:solidFill>
              </a:rPr>
              <a:t>Instructions:</a:t>
            </a:r>
            <a:br>
              <a:rPr lang="en-US" b="1" dirty="0">
                <a:solidFill>
                  <a:srgbClr val="FFFFFF"/>
                </a:solidFill>
              </a:rPr>
            </a:br>
            <a:r>
              <a:rPr lang="en-US" b="1" dirty="0">
                <a:solidFill>
                  <a:srgbClr val="FFFF00"/>
                </a:solidFill>
              </a:rPr>
              <a:t>Structured peer roleplay</a:t>
            </a:r>
          </a:p>
        </p:txBody>
      </p:sp>
      <p:sp>
        <p:nvSpPr>
          <p:cNvPr id="3" name="Content Placeholder 2">
            <a:extLst>
              <a:ext uri="{FF2B5EF4-FFF2-40B4-BE49-F238E27FC236}">
                <a16:creationId xmlns:a16="http://schemas.microsoft.com/office/drawing/2014/main" id="{F921B2F2-72C7-5D29-AEAA-48DD55C0F26A}"/>
              </a:ext>
            </a:extLst>
          </p:cNvPr>
          <p:cNvSpPr>
            <a:spLocks noGrp="1"/>
          </p:cNvSpPr>
          <p:nvPr>
            <p:ph idx="1"/>
          </p:nvPr>
        </p:nvSpPr>
        <p:spPr>
          <a:xfrm>
            <a:off x="5942852" y="986445"/>
            <a:ext cx="5980924" cy="5431376"/>
          </a:xfrm>
        </p:spPr>
        <p:txBody>
          <a:bodyPr anchor="ctr">
            <a:noAutofit/>
          </a:bodyPr>
          <a:lstStyle/>
          <a:p>
            <a:pPr>
              <a:spcBef>
                <a:spcPts val="0"/>
              </a:spcBef>
            </a:pPr>
            <a:r>
              <a:rPr lang="en-US" sz="2600" kern="100" dirty="0">
                <a:effectLst/>
                <a:latin typeface="Calibri" panose="020F0502020204030204" pitchFamily="34" charset="0"/>
                <a:ea typeface="Aptos" panose="020B0004020202020204" pitchFamily="34" charset="0"/>
                <a:cs typeface="Calibri" panose="020F0502020204030204" pitchFamily="34" charset="0"/>
              </a:rPr>
              <a:t>After the VTS session, the groups will engage in the </a:t>
            </a:r>
            <a:r>
              <a:rPr lang="en-US" sz="2600" kern="100" dirty="0">
                <a:solidFill>
                  <a:srgbClr val="FF0000"/>
                </a:solidFill>
                <a:effectLst/>
                <a:latin typeface="Calibri" panose="020F0502020204030204" pitchFamily="34" charset="0"/>
                <a:ea typeface="Aptos" panose="020B0004020202020204" pitchFamily="34" charset="0"/>
                <a:cs typeface="Calibri" panose="020F0502020204030204" pitchFamily="34" charset="0"/>
              </a:rPr>
              <a:t>structured peer roleplay. </a:t>
            </a:r>
          </a:p>
          <a:p>
            <a:pPr>
              <a:spcBef>
                <a:spcPts val="0"/>
              </a:spcBef>
            </a:pPr>
            <a:r>
              <a:rPr lang="en-US" sz="2600" kern="100" dirty="0">
                <a:effectLst/>
                <a:latin typeface="Calibri" panose="020F0502020204030204" pitchFamily="34" charset="0"/>
                <a:ea typeface="Aptos" panose="020B0004020202020204" pitchFamily="34" charset="0"/>
                <a:cs typeface="Calibri" panose="020F0502020204030204" pitchFamily="34" charset="0"/>
              </a:rPr>
              <a:t>Every group will have 5 students and will work with one clinical scenario given in the file.</a:t>
            </a:r>
          </a:p>
          <a:p>
            <a:pPr>
              <a:spcBef>
                <a:spcPts val="0"/>
              </a:spcBef>
            </a:pPr>
            <a:r>
              <a:rPr lang="en-US" sz="2600" kern="100" dirty="0">
                <a:effectLst/>
                <a:latin typeface="Calibri" panose="020F0502020204030204" pitchFamily="34" charset="0"/>
                <a:ea typeface="Aptos" panose="020B0004020202020204" pitchFamily="34" charset="0"/>
                <a:cs typeface="Calibri" panose="020F0502020204030204" pitchFamily="34" charset="0"/>
              </a:rPr>
              <a:t>One textbook per group is permitted</a:t>
            </a:r>
          </a:p>
          <a:p>
            <a:pPr>
              <a:spcBef>
                <a:spcPts val="0"/>
              </a:spcBef>
            </a:pPr>
            <a:r>
              <a:rPr lang="en-US" sz="2600" kern="100" dirty="0">
                <a:effectLst/>
                <a:latin typeface="Calibri" panose="020F0502020204030204" pitchFamily="34" charset="0"/>
                <a:ea typeface="Aptos" panose="020B0004020202020204" pitchFamily="34" charset="0"/>
                <a:cs typeface="Calibri" panose="020F0502020204030204" pitchFamily="34" charset="0"/>
              </a:rPr>
              <a:t>Every student in the group will be given a specific role in the roleplay (e.g. Physician, patient, student, caregiver, friend, lab assistant etc.):  This can be done by volunteering or random allocation by the faculty.</a:t>
            </a:r>
          </a:p>
          <a:p>
            <a:pPr>
              <a:spcBef>
                <a:spcPts val="0"/>
              </a:spcBef>
              <a:spcAft>
                <a:spcPts val="800"/>
              </a:spcAft>
            </a:pPr>
            <a:r>
              <a:rPr lang="en-US" sz="2600" kern="100" dirty="0">
                <a:effectLst/>
                <a:latin typeface="Calibri" panose="020F0502020204030204" pitchFamily="34" charset="0"/>
                <a:ea typeface="Aptos" panose="020B0004020202020204" pitchFamily="34" charset="0"/>
                <a:cs typeface="Calibri" panose="020F0502020204030204" pitchFamily="34" charset="0"/>
              </a:rPr>
              <a:t>Students are expected to act and interact based on their assigned roles, </a:t>
            </a:r>
            <a:r>
              <a:rPr lang="en-US" sz="2600" kern="100" dirty="0">
                <a:latin typeface="Calibri" panose="020F0502020204030204" pitchFamily="34" charset="0"/>
                <a:ea typeface="Aptos" panose="020B0004020202020204" pitchFamily="34" charset="0"/>
                <a:cs typeface="Calibri" panose="020F0502020204030204" pitchFamily="34" charset="0"/>
              </a:rPr>
              <a:t>becoming</a:t>
            </a:r>
            <a:r>
              <a:rPr lang="en-US" sz="2600" kern="100" dirty="0">
                <a:effectLst/>
                <a:latin typeface="Calibri" panose="020F0502020204030204" pitchFamily="34" charset="0"/>
                <a:ea typeface="Aptos" panose="020B0004020202020204" pitchFamily="34" charset="0"/>
                <a:cs typeface="Calibri" panose="020F0502020204030204" pitchFamily="34" charset="0"/>
              </a:rPr>
              <a:t> as their character in a real clinical situation and resolve the dilemmas. </a:t>
            </a:r>
          </a:p>
          <a:p>
            <a:pPr marL="0" indent="0">
              <a:buNone/>
            </a:pPr>
            <a:endParaRPr lang="en-US" sz="26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4052398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7718681-A12E-49D6-9925-DD7C68176D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10" name="Freeform: Shape 9">
            <a:extLst>
              <a:ext uri="{FF2B5EF4-FFF2-40B4-BE49-F238E27FC236}">
                <a16:creationId xmlns:a16="http://schemas.microsoft.com/office/drawing/2014/main" id="{FBD77573-9EF2-4C35-8285-A1CF6FBB0E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 y="0"/>
            <a:ext cx="5511704" cy="6858000"/>
          </a:xfrm>
          <a:custGeom>
            <a:avLst/>
            <a:gdLst>
              <a:gd name="connsiteX0" fmla="*/ 5511704 w 5511704"/>
              <a:gd name="connsiteY0" fmla="*/ 0 h 6886576"/>
              <a:gd name="connsiteX1" fmla="*/ 1008599 w 5511704"/>
              <a:gd name="connsiteY1" fmla="*/ 0 h 6886576"/>
              <a:gd name="connsiteX2" fmla="*/ 1310975 w 5511704"/>
              <a:gd name="connsiteY2" fmla="*/ 110728 h 6886576"/>
              <a:gd name="connsiteX3" fmla="*/ 1267362 w 5511704"/>
              <a:gd name="connsiteY3" fmla="*/ 135731 h 6886576"/>
              <a:gd name="connsiteX4" fmla="*/ 1005692 w 5511704"/>
              <a:gd name="connsiteY4" fmla="*/ 71437 h 6886576"/>
              <a:gd name="connsiteX5" fmla="*/ 953358 w 5511704"/>
              <a:gd name="connsiteY5" fmla="*/ 89297 h 6886576"/>
              <a:gd name="connsiteX6" fmla="*/ 979525 w 5511704"/>
              <a:gd name="connsiteY6" fmla="*/ 164307 h 6886576"/>
              <a:gd name="connsiteX7" fmla="*/ 1092915 w 5511704"/>
              <a:gd name="connsiteY7" fmla="*/ 192882 h 6886576"/>
              <a:gd name="connsiteX8" fmla="*/ 1270270 w 5511704"/>
              <a:gd name="connsiteY8" fmla="*/ 375047 h 6886576"/>
              <a:gd name="connsiteX9" fmla="*/ 1002784 w 5511704"/>
              <a:gd name="connsiteY9" fmla="*/ 353615 h 6886576"/>
              <a:gd name="connsiteX10" fmla="*/ 956265 w 5511704"/>
              <a:gd name="connsiteY10" fmla="*/ 396479 h 6886576"/>
              <a:gd name="connsiteX11" fmla="*/ 938820 w 5511704"/>
              <a:gd name="connsiteY11" fmla="*/ 453629 h 6886576"/>
              <a:gd name="connsiteX12" fmla="*/ 860319 w 5511704"/>
              <a:gd name="connsiteY12" fmla="*/ 360759 h 6886576"/>
              <a:gd name="connsiteX13" fmla="*/ 793447 w 5511704"/>
              <a:gd name="connsiteY13" fmla="*/ 335757 h 6886576"/>
              <a:gd name="connsiteX14" fmla="*/ 773095 w 5511704"/>
              <a:gd name="connsiteY14" fmla="*/ 417910 h 6886576"/>
              <a:gd name="connsiteX15" fmla="*/ 834151 w 5511704"/>
              <a:gd name="connsiteY15" fmla="*/ 507206 h 6886576"/>
              <a:gd name="connsiteX16" fmla="*/ 996969 w 5511704"/>
              <a:gd name="connsiteY16" fmla="*/ 560785 h 6886576"/>
              <a:gd name="connsiteX17" fmla="*/ 822522 w 5511704"/>
              <a:gd name="connsiteY17" fmla="*/ 560785 h 6886576"/>
              <a:gd name="connsiteX18" fmla="*/ 621908 w 5511704"/>
              <a:gd name="connsiteY18" fmla="*/ 525066 h 6886576"/>
              <a:gd name="connsiteX19" fmla="*/ 409664 w 5511704"/>
              <a:gd name="connsiteY19" fmla="*/ 535781 h 6886576"/>
              <a:gd name="connsiteX20" fmla="*/ 209049 w 5511704"/>
              <a:gd name="connsiteY20" fmla="*/ 464344 h 6886576"/>
              <a:gd name="connsiteX21" fmla="*/ 5527 w 5511704"/>
              <a:gd name="connsiteY21" fmla="*/ 467916 h 6886576"/>
              <a:gd name="connsiteX22" fmla="*/ 906838 w 5511704"/>
              <a:gd name="connsiteY22" fmla="*/ 914400 h 6886576"/>
              <a:gd name="connsiteX23" fmla="*/ 863226 w 5511704"/>
              <a:gd name="connsiteY23" fmla="*/ 925116 h 6886576"/>
              <a:gd name="connsiteX24" fmla="*/ 805077 w 5511704"/>
              <a:gd name="connsiteY24" fmla="*/ 953691 h 6886576"/>
              <a:gd name="connsiteX25" fmla="*/ 848689 w 5511704"/>
              <a:gd name="connsiteY25" fmla="*/ 1010841 h 6886576"/>
              <a:gd name="connsiteX26" fmla="*/ 1084193 w 5511704"/>
              <a:gd name="connsiteY26" fmla="*/ 1117997 h 6886576"/>
              <a:gd name="connsiteX27" fmla="*/ 1142342 w 5511704"/>
              <a:gd name="connsiteY27" fmla="*/ 1225153 h 6886576"/>
              <a:gd name="connsiteX28" fmla="*/ 1069655 w 5511704"/>
              <a:gd name="connsiteY28" fmla="*/ 1214438 h 6886576"/>
              <a:gd name="connsiteX29" fmla="*/ 1005692 w 5511704"/>
              <a:gd name="connsiteY29" fmla="*/ 1235869 h 6886576"/>
              <a:gd name="connsiteX30" fmla="*/ 1031858 w 5511704"/>
              <a:gd name="connsiteY30" fmla="*/ 1371600 h 6886576"/>
              <a:gd name="connsiteX31" fmla="*/ 1366216 w 5511704"/>
              <a:gd name="connsiteY31" fmla="*/ 1546622 h 6886576"/>
              <a:gd name="connsiteX32" fmla="*/ 1395290 w 5511704"/>
              <a:gd name="connsiteY32" fmla="*/ 1603772 h 6886576"/>
              <a:gd name="connsiteX33" fmla="*/ 1354586 w 5511704"/>
              <a:gd name="connsiteY33" fmla="*/ 1643063 h 6886576"/>
              <a:gd name="connsiteX34" fmla="*/ 1247011 w 5511704"/>
              <a:gd name="connsiteY34" fmla="*/ 1664494 h 6886576"/>
              <a:gd name="connsiteX35" fmla="*/ 1398198 w 5511704"/>
              <a:gd name="connsiteY35" fmla="*/ 1857375 h 6886576"/>
              <a:gd name="connsiteX36" fmla="*/ 1453440 w 5511704"/>
              <a:gd name="connsiteY36" fmla="*/ 1910954 h 6886576"/>
              <a:gd name="connsiteX37" fmla="*/ 1549386 w 5511704"/>
              <a:gd name="connsiteY37" fmla="*/ 1993106 h 6886576"/>
              <a:gd name="connsiteX38" fmla="*/ 1549386 w 5511704"/>
              <a:gd name="connsiteY38" fmla="*/ 2021681 h 6886576"/>
              <a:gd name="connsiteX39" fmla="*/ 1421458 w 5511704"/>
              <a:gd name="connsiteY39" fmla="*/ 2110978 h 6886576"/>
              <a:gd name="connsiteX40" fmla="*/ 1188861 w 5511704"/>
              <a:gd name="connsiteY40" fmla="*/ 2085976 h 6886576"/>
              <a:gd name="connsiteX41" fmla="*/ 1531941 w 5511704"/>
              <a:gd name="connsiteY41" fmla="*/ 2218135 h 6886576"/>
              <a:gd name="connsiteX42" fmla="*/ 421293 w 5511704"/>
              <a:gd name="connsiteY42" fmla="*/ 1900238 h 6886576"/>
              <a:gd name="connsiteX43" fmla="*/ 491072 w 5511704"/>
              <a:gd name="connsiteY43" fmla="*/ 1982391 h 6886576"/>
              <a:gd name="connsiteX44" fmla="*/ 880671 w 5511704"/>
              <a:gd name="connsiteY44" fmla="*/ 2200276 h 6886576"/>
              <a:gd name="connsiteX45" fmla="*/ 991154 w 5511704"/>
              <a:gd name="connsiteY45" fmla="*/ 2336007 h 6886576"/>
              <a:gd name="connsiteX46" fmla="*/ 1107453 w 5511704"/>
              <a:gd name="connsiteY46" fmla="*/ 2411016 h 6886576"/>
              <a:gd name="connsiteX47" fmla="*/ 1270270 w 5511704"/>
              <a:gd name="connsiteY47" fmla="*/ 2411016 h 6886576"/>
              <a:gd name="connsiteX48" fmla="*/ 1386568 w 5511704"/>
              <a:gd name="connsiteY48" fmla="*/ 2528889 h 6886576"/>
              <a:gd name="connsiteX49" fmla="*/ 1267362 w 5511704"/>
              <a:gd name="connsiteY49" fmla="*/ 2553891 h 6886576"/>
              <a:gd name="connsiteX50" fmla="*/ 1127805 w 5511704"/>
              <a:gd name="connsiteY50" fmla="*/ 2536032 h 6886576"/>
              <a:gd name="connsiteX51" fmla="*/ 970802 w 5511704"/>
              <a:gd name="connsiteY51" fmla="*/ 2575322 h 6886576"/>
              <a:gd name="connsiteX52" fmla="*/ 825429 w 5511704"/>
              <a:gd name="connsiteY52" fmla="*/ 2543176 h 6886576"/>
              <a:gd name="connsiteX53" fmla="*/ 650982 w 5511704"/>
              <a:gd name="connsiteY53" fmla="*/ 2564607 h 6886576"/>
              <a:gd name="connsiteX54" fmla="*/ 595740 w 5511704"/>
              <a:gd name="connsiteY54" fmla="*/ 2703909 h 6886576"/>
              <a:gd name="connsiteX55" fmla="*/ 578296 w 5511704"/>
              <a:gd name="connsiteY55" fmla="*/ 2714626 h 6886576"/>
              <a:gd name="connsiteX56" fmla="*/ 255568 w 5511704"/>
              <a:gd name="connsiteY56" fmla="*/ 2936081 h 6886576"/>
              <a:gd name="connsiteX57" fmla="*/ 165437 w 5511704"/>
              <a:gd name="connsiteY57" fmla="*/ 2953941 h 6886576"/>
              <a:gd name="connsiteX58" fmla="*/ 697501 w 5511704"/>
              <a:gd name="connsiteY58" fmla="*/ 3343275 h 6886576"/>
              <a:gd name="connsiteX59" fmla="*/ 339884 w 5511704"/>
              <a:gd name="connsiteY59" fmla="*/ 3243263 h 6886576"/>
              <a:gd name="connsiteX60" fmla="*/ 290458 w 5511704"/>
              <a:gd name="connsiteY60" fmla="*/ 3407569 h 6886576"/>
              <a:gd name="connsiteX61" fmla="*/ 459090 w 5511704"/>
              <a:gd name="connsiteY61" fmla="*/ 3554016 h 6886576"/>
              <a:gd name="connsiteX62" fmla="*/ 520147 w 5511704"/>
              <a:gd name="connsiteY62" fmla="*/ 3843338 h 6886576"/>
              <a:gd name="connsiteX63" fmla="*/ 491072 w 5511704"/>
              <a:gd name="connsiteY63" fmla="*/ 4107657 h 6886576"/>
              <a:gd name="connsiteX64" fmla="*/ 418386 w 5511704"/>
              <a:gd name="connsiteY64" fmla="*/ 4189810 h 6886576"/>
              <a:gd name="connsiteX65" fmla="*/ 313718 w 5511704"/>
              <a:gd name="connsiteY65" fmla="*/ 4339829 h 6886576"/>
              <a:gd name="connsiteX66" fmla="*/ 249753 w 5511704"/>
              <a:gd name="connsiteY66" fmla="*/ 4432698 h 6886576"/>
              <a:gd name="connsiteX67" fmla="*/ 25879 w 5511704"/>
              <a:gd name="connsiteY67" fmla="*/ 4396979 h 6886576"/>
              <a:gd name="connsiteX68" fmla="*/ 325347 w 5511704"/>
              <a:gd name="connsiteY68" fmla="*/ 4632722 h 6886576"/>
              <a:gd name="connsiteX69" fmla="*/ 84029 w 5511704"/>
              <a:gd name="connsiteY69" fmla="*/ 4604147 h 6886576"/>
              <a:gd name="connsiteX70" fmla="*/ 5527 w 5511704"/>
              <a:gd name="connsiteY70" fmla="*/ 4622007 h 6886576"/>
              <a:gd name="connsiteX71" fmla="*/ 49139 w 5511704"/>
              <a:gd name="connsiteY71" fmla="*/ 4697016 h 6886576"/>
              <a:gd name="connsiteX72" fmla="*/ 226494 w 5511704"/>
              <a:gd name="connsiteY72" fmla="*/ 4825604 h 6886576"/>
              <a:gd name="connsiteX73" fmla="*/ 592833 w 5511704"/>
              <a:gd name="connsiteY73" fmla="*/ 5175647 h 6886576"/>
              <a:gd name="connsiteX74" fmla="*/ 238123 w 5511704"/>
              <a:gd name="connsiteY74" fmla="*/ 5014913 h 6886576"/>
              <a:gd name="connsiteX75" fmla="*/ 610278 w 5511704"/>
              <a:gd name="connsiteY75" fmla="*/ 5375673 h 6886576"/>
              <a:gd name="connsiteX76" fmla="*/ 691686 w 5511704"/>
              <a:gd name="connsiteY76" fmla="*/ 5497116 h 6886576"/>
              <a:gd name="connsiteX77" fmla="*/ 860319 w 5511704"/>
              <a:gd name="connsiteY77" fmla="*/ 5793582 h 6886576"/>
              <a:gd name="connsiteX78" fmla="*/ 851597 w 5511704"/>
              <a:gd name="connsiteY78" fmla="*/ 5825729 h 6886576"/>
              <a:gd name="connsiteX79" fmla="*/ 659704 w 5511704"/>
              <a:gd name="connsiteY79" fmla="*/ 5779295 h 6886576"/>
              <a:gd name="connsiteX80" fmla="*/ 909746 w 5511704"/>
              <a:gd name="connsiteY80" fmla="*/ 6029326 h 6886576"/>
              <a:gd name="connsiteX81" fmla="*/ 1168509 w 5511704"/>
              <a:gd name="connsiteY81" fmla="*/ 6222207 h 6886576"/>
              <a:gd name="connsiteX82" fmla="*/ 985339 w 5511704"/>
              <a:gd name="connsiteY82" fmla="*/ 6193632 h 6886576"/>
              <a:gd name="connsiteX83" fmla="*/ 732391 w 5511704"/>
              <a:gd name="connsiteY83" fmla="*/ 6082904 h 6886576"/>
              <a:gd name="connsiteX84" fmla="*/ 645167 w 5511704"/>
              <a:gd name="connsiteY84" fmla="*/ 6125766 h 6886576"/>
              <a:gd name="connsiteX85" fmla="*/ 883579 w 5511704"/>
              <a:gd name="connsiteY85" fmla="*/ 6307932 h 6886576"/>
              <a:gd name="connsiteX86" fmla="*/ 1020229 w 5511704"/>
              <a:gd name="connsiteY86" fmla="*/ 6393657 h 6886576"/>
              <a:gd name="connsiteX87" fmla="*/ 1075471 w 5511704"/>
              <a:gd name="connsiteY87" fmla="*/ 6457950 h 6886576"/>
              <a:gd name="connsiteX88" fmla="*/ 1232473 w 5511704"/>
              <a:gd name="connsiteY88" fmla="*/ 6686551 h 6886576"/>
              <a:gd name="connsiteX89" fmla="*/ 1592997 w 5511704"/>
              <a:gd name="connsiteY89" fmla="*/ 6886576 h 6886576"/>
              <a:gd name="connsiteX90" fmla="*/ 5511704 w 5511704"/>
              <a:gd name="connsiteY90" fmla="*/ 6886576 h 68865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Lst>
            <a:rect l="l" t="t" r="r" b="b"/>
            <a:pathLst>
              <a:path w="5511704" h="6886576">
                <a:moveTo>
                  <a:pt x="5511704" y="0"/>
                </a:moveTo>
                <a:lnTo>
                  <a:pt x="1008599" y="0"/>
                </a:lnTo>
                <a:cubicBezTo>
                  <a:pt x="1110360" y="35719"/>
                  <a:pt x="1209214" y="78581"/>
                  <a:pt x="1310975" y="110728"/>
                </a:cubicBezTo>
                <a:cubicBezTo>
                  <a:pt x="1296437" y="146447"/>
                  <a:pt x="1281900" y="139303"/>
                  <a:pt x="1267362" y="135731"/>
                </a:cubicBezTo>
                <a:cubicBezTo>
                  <a:pt x="1180139" y="121445"/>
                  <a:pt x="1090008" y="110728"/>
                  <a:pt x="1005692" y="71437"/>
                </a:cubicBezTo>
                <a:cubicBezTo>
                  <a:pt x="985339" y="64294"/>
                  <a:pt x="962080" y="64294"/>
                  <a:pt x="953358" y="89297"/>
                </a:cubicBezTo>
                <a:cubicBezTo>
                  <a:pt x="938820" y="125016"/>
                  <a:pt x="959172" y="146447"/>
                  <a:pt x="979525" y="164307"/>
                </a:cubicBezTo>
                <a:cubicBezTo>
                  <a:pt x="1014414" y="196453"/>
                  <a:pt x="1055118" y="189310"/>
                  <a:pt x="1092915" y="192882"/>
                </a:cubicBezTo>
                <a:cubicBezTo>
                  <a:pt x="1197583" y="210741"/>
                  <a:pt x="1247011" y="260747"/>
                  <a:pt x="1270270" y="375047"/>
                </a:cubicBezTo>
                <a:cubicBezTo>
                  <a:pt x="1180139" y="328613"/>
                  <a:pt x="1090008" y="385763"/>
                  <a:pt x="1002784" y="353615"/>
                </a:cubicBezTo>
                <a:cubicBezTo>
                  <a:pt x="979525" y="346472"/>
                  <a:pt x="944635" y="357188"/>
                  <a:pt x="956265" y="396479"/>
                </a:cubicBezTo>
                <a:cubicBezTo>
                  <a:pt x="967894" y="432198"/>
                  <a:pt x="1005692" y="460772"/>
                  <a:pt x="938820" y="453629"/>
                </a:cubicBezTo>
                <a:cubicBezTo>
                  <a:pt x="889393" y="450056"/>
                  <a:pt x="874856" y="407194"/>
                  <a:pt x="860319" y="360759"/>
                </a:cubicBezTo>
                <a:cubicBezTo>
                  <a:pt x="848689" y="335757"/>
                  <a:pt x="816707" y="321469"/>
                  <a:pt x="793447" y="335757"/>
                </a:cubicBezTo>
                <a:cubicBezTo>
                  <a:pt x="764373" y="350044"/>
                  <a:pt x="773095" y="389335"/>
                  <a:pt x="773095" y="417910"/>
                </a:cubicBezTo>
                <a:cubicBezTo>
                  <a:pt x="770187" y="471488"/>
                  <a:pt x="793447" y="496491"/>
                  <a:pt x="834151" y="507206"/>
                </a:cubicBezTo>
                <a:cubicBezTo>
                  <a:pt x="883579" y="521494"/>
                  <a:pt x="933005" y="539354"/>
                  <a:pt x="996969" y="560785"/>
                </a:cubicBezTo>
                <a:cubicBezTo>
                  <a:pt x="927190" y="596503"/>
                  <a:pt x="874856" y="589360"/>
                  <a:pt x="822522" y="560785"/>
                </a:cubicBezTo>
                <a:cubicBezTo>
                  <a:pt x="758558" y="528637"/>
                  <a:pt x="674242" y="485775"/>
                  <a:pt x="621908" y="525066"/>
                </a:cubicBezTo>
                <a:cubicBezTo>
                  <a:pt x="543407" y="582216"/>
                  <a:pt x="479443" y="546497"/>
                  <a:pt x="409664" y="535781"/>
                </a:cubicBezTo>
                <a:cubicBezTo>
                  <a:pt x="264290" y="514350"/>
                  <a:pt x="354422" y="482204"/>
                  <a:pt x="209049" y="464344"/>
                </a:cubicBezTo>
                <a:cubicBezTo>
                  <a:pt x="150900" y="457200"/>
                  <a:pt x="89843" y="428625"/>
                  <a:pt x="5527" y="467916"/>
                </a:cubicBezTo>
                <a:cubicBezTo>
                  <a:pt x="386404" y="675085"/>
                  <a:pt x="566666" y="660797"/>
                  <a:pt x="906838" y="914400"/>
                </a:cubicBezTo>
                <a:cubicBezTo>
                  <a:pt x="892301" y="939404"/>
                  <a:pt x="877764" y="928688"/>
                  <a:pt x="863226" y="925116"/>
                </a:cubicBezTo>
                <a:cubicBezTo>
                  <a:pt x="839967" y="921544"/>
                  <a:pt x="810892" y="907256"/>
                  <a:pt x="805077" y="953691"/>
                </a:cubicBezTo>
                <a:cubicBezTo>
                  <a:pt x="802169" y="989410"/>
                  <a:pt x="819615" y="1007269"/>
                  <a:pt x="848689" y="1010841"/>
                </a:cubicBezTo>
                <a:cubicBezTo>
                  <a:pt x="933005" y="1025129"/>
                  <a:pt x="1008599" y="1075135"/>
                  <a:pt x="1084193" y="1117997"/>
                </a:cubicBezTo>
                <a:cubicBezTo>
                  <a:pt x="1119082" y="1135857"/>
                  <a:pt x="1156879" y="1160860"/>
                  <a:pt x="1142342" y="1225153"/>
                </a:cubicBezTo>
                <a:cubicBezTo>
                  <a:pt x="1113268" y="1243013"/>
                  <a:pt x="1092915" y="1218009"/>
                  <a:pt x="1069655" y="1214438"/>
                </a:cubicBezTo>
                <a:cubicBezTo>
                  <a:pt x="1046396" y="1210866"/>
                  <a:pt x="991154" y="1225153"/>
                  <a:pt x="1005692" y="1235869"/>
                </a:cubicBezTo>
                <a:cubicBezTo>
                  <a:pt x="1072563" y="1275159"/>
                  <a:pt x="950450" y="1371600"/>
                  <a:pt x="1031858" y="1371600"/>
                </a:cubicBezTo>
                <a:cubicBezTo>
                  <a:pt x="1165601" y="1371600"/>
                  <a:pt x="1238288" y="1543050"/>
                  <a:pt x="1366216" y="1546622"/>
                </a:cubicBezTo>
                <a:cubicBezTo>
                  <a:pt x="1386568" y="1546622"/>
                  <a:pt x="1395290" y="1578770"/>
                  <a:pt x="1395290" y="1603772"/>
                </a:cubicBezTo>
                <a:cubicBezTo>
                  <a:pt x="1395290" y="1635920"/>
                  <a:pt x="1374939" y="1639491"/>
                  <a:pt x="1354586" y="1643063"/>
                </a:cubicBezTo>
                <a:cubicBezTo>
                  <a:pt x="1322604" y="1646635"/>
                  <a:pt x="1287715" y="1603772"/>
                  <a:pt x="1247011" y="1664494"/>
                </a:cubicBezTo>
                <a:cubicBezTo>
                  <a:pt x="1322604" y="1700213"/>
                  <a:pt x="1401105" y="1735932"/>
                  <a:pt x="1398198" y="1857375"/>
                </a:cubicBezTo>
                <a:cubicBezTo>
                  <a:pt x="1398198" y="1889523"/>
                  <a:pt x="1430180" y="1903810"/>
                  <a:pt x="1453440" y="1910954"/>
                </a:cubicBezTo>
                <a:cubicBezTo>
                  <a:pt x="1494144" y="1925241"/>
                  <a:pt x="1526126" y="1946673"/>
                  <a:pt x="1549386" y="1993106"/>
                </a:cubicBezTo>
                <a:cubicBezTo>
                  <a:pt x="1549386" y="2003822"/>
                  <a:pt x="1549386" y="2010966"/>
                  <a:pt x="1549386" y="2021681"/>
                </a:cubicBezTo>
                <a:cubicBezTo>
                  <a:pt x="1543571" y="2132410"/>
                  <a:pt x="1485422" y="2128838"/>
                  <a:pt x="1421458" y="2110978"/>
                </a:cubicBezTo>
                <a:cubicBezTo>
                  <a:pt x="1345864" y="2089547"/>
                  <a:pt x="1270270" y="2046685"/>
                  <a:pt x="1188861" y="2085976"/>
                </a:cubicBezTo>
                <a:cubicBezTo>
                  <a:pt x="1302252" y="2139554"/>
                  <a:pt x="1427272" y="2143126"/>
                  <a:pt x="1531941" y="2218135"/>
                </a:cubicBezTo>
                <a:cubicBezTo>
                  <a:pt x="1142342" y="2232422"/>
                  <a:pt x="799262" y="1993106"/>
                  <a:pt x="421293" y="1900238"/>
                </a:cubicBezTo>
                <a:cubicBezTo>
                  <a:pt x="432923" y="1960960"/>
                  <a:pt x="464905" y="1975247"/>
                  <a:pt x="491072" y="1982391"/>
                </a:cubicBezTo>
                <a:cubicBezTo>
                  <a:pt x="630630" y="2028825"/>
                  <a:pt x="752743" y="2121695"/>
                  <a:pt x="880671" y="2200276"/>
                </a:cubicBezTo>
                <a:cubicBezTo>
                  <a:pt x="933005" y="2232422"/>
                  <a:pt x="970802" y="2268142"/>
                  <a:pt x="991154" y="2336007"/>
                </a:cubicBezTo>
                <a:cubicBezTo>
                  <a:pt x="1008599" y="2400300"/>
                  <a:pt x="1043489" y="2428875"/>
                  <a:pt x="1107453" y="2411016"/>
                </a:cubicBezTo>
                <a:cubicBezTo>
                  <a:pt x="1159787" y="2396729"/>
                  <a:pt x="1215029" y="2403873"/>
                  <a:pt x="1270270" y="2411016"/>
                </a:cubicBezTo>
                <a:cubicBezTo>
                  <a:pt x="1331326" y="2418160"/>
                  <a:pt x="1401105" y="2489597"/>
                  <a:pt x="1386568" y="2528889"/>
                </a:cubicBezTo>
                <a:cubicBezTo>
                  <a:pt x="1357494" y="2593182"/>
                  <a:pt x="1308067" y="2561035"/>
                  <a:pt x="1267362" y="2553891"/>
                </a:cubicBezTo>
                <a:cubicBezTo>
                  <a:pt x="1217936" y="2546748"/>
                  <a:pt x="1127805" y="2528889"/>
                  <a:pt x="1127805" y="2536032"/>
                </a:cubicBezTo>
                <a:cubicBezTo>
                  <a:pt x="1095822" y="2696766"/>
                  <a:pt x="1023136" y="2575322"/>
                  <a:pt x="970802" y="2575322"/>
                </a:cubicBezTo>
                <a:cubicBezTo>
                  <a:pt x="921375" y="2575322"/>
                  <a:pt x="871949" y="2557463"/>
                  <a:pt x="825429" y="2543176"/>
                </a:cubicBezTo>
                <a:cubicBezTo>
                  <a:pt x="764373" y="2525316"/>
                  <a:pt x="709132" y="2557463"/>
                  <a:pt x="650982" y="2564607"/>
                </a:cubicBezTo>
                <a:cubicBezTo>
                  <a:pt x="598648" y="2571751"/>
                  <a:pt x="627722" y="2664620"/>
                  <a:pt x="595740" y="2703909"/>
                </a:cubicBezTo>
                <a:cubicBezTo>
                  <a:pt x="589926" y="2714626"/>
                  <a:pt x="584111" y="2714626"/>
                  <a:pt x="578296" y="2714626"/>
                </a:cubicBezTo>
                <a:cubicBezTo>
                  <a:pt x="560851" y="2993232"/>
                  <a:pt x="255568" y="2925366"/>
                  <a:pt x="255568" y="2936081"/>
                </a:cubicBezTo>
                <a:cubicBezTo>
                  <a:pt x="229401" y="2953941"/>
                  <a:pt x="197419" y="2911079"/>
                  <a:pt x="165437" y="2953941"/>
                </a:cubicBezTo>
                <a:cubicBezTo>
                  <a:pt x="302087" y="3150394"/>
                  <a:pt x="511425" y="3196828"/>
                  <a:pt x="697501" y="3343275"/>
                </a:cubicBezTo>
                <a:cubicBezTo>
                  <a:pt x="543407" y="3393282"/>
                  <a:pt x="453275" y="3221832"/>
                  <a:pt x="339884" y="3243263"/>
                </a:cubicBezTo>
                <a:cubicBezTo>
                  <a:pt x="284643" y="3296842"/>
                  <a:pt x="450368" y="3382566"/>
                  <a:pt x="290458" y="3407569"/>
                </a:cubicBezTo>
                <a:cubicBezTo>
                  <a:pt x="360236" y="3454004"/>
                  <a:pt x="409664" y="3500439"/>
                  <a:pt x="459090" y="3554016"/>
                </a:cubicBezTo>
                <a:cubicBezTo>
                  <a:pt x="543407" y="3650457"/>
                  <a:pt x="560851" y="3714751"/>
                  <a:pt x="520147" y="3843338"/>
                </a:cubicBezTo>
                <a:cubicBezTo>
                  <a:pt x="493979" y="3929063"/>
                  <a:pt x="456183" y="4007645"/>
                  <a:pt x="491072" y="4107657"/>
                </a:cubicBezTo>
                <a:cubicBezTo>
                  <a:pt x="514332" y="4175522"/>
                  <a:pt x="505609" y="4221957"/>
                  <a:pt x="418386" y="4189810"/>
                </a:cubicBezTo>
                <a:cubicBezTo>
                  <a:pt x="325347" y="4157663"/>
                  <a:pt x="290458" y="4218386"/>
                  <a:pt x="313718" y="4339829"/>
                </a:cubicBezTo>
                <a:cubicBezTo>
                  <a:pt x="328254" y="4418410"/>
                  <a:pt x="313718" y="4443413"/>
                  <a:pt x="249753" y="4432698"/>
                </a:cubicBezTo>
                <a:cubicBezTo>
                  <a:pt x="179975" y="4421982"/>
                  <a:pt x="113103" y="4371976"/>
                  <a:pt x="25879" y="4396979"/>
                </a:cubicBezTo>
                <a:cubicBezTo>
                  <a:pt x="95658" y="4539854"/>
                  <a:pt x="243939" y="4496991"/>
                  <a:pt x="325347" y="4632722"/>
                </a:cubicBezTo>
                <a:cubicBezTo>
                  <a:pt x="229401" y="4632722"/>
                  <a:pt x="153807" y="4632722"/>
                  <a:pt x="84029" y="4604147"/>
                </a:cubicBezTo>
                <a:cubicBezTo>
                  <a:pt x="54954" y="4593433"/>
                  <a:pt x="22972" y="4579145"/>
                  <a:pt x="5527" y="4622007"/>
                </a:cubicBezTo>
                <a:cubicBezTo>
                  <a:pt x="-14826" y="4672014"/>
                  <a:pt x="25879" y="4689872"/>
                  <a:pt x="49139" y="4697016"/>
                </a:cubicBezTo>
                <a:cubicBezTo>
                  <a:pt x="116011" y="4722019"/>
                  <a:pt x="168344" y="4779170"/>
                  <a:pt x="226494" y="4825604"/>
                </a:cubicBezTo>
                <a:cubicBezTo>
                  <a:pt x="351514" y="4925616"/>
                  <a:pt x="488165" y="5011341"/>
                  <a:pt x="592833" y="5175647"/>
                </a:cubicBezTo>
                <a:cubicBezTo>
                  <a:pt x="461997" y="5132785"/>
                  <a:pt x="363144" y="5032772"/>
                  <a:pt x="238123" y="5014913"/>
                </a:cubicBezTo>
                <a:cubicBezTo>
                  <a:pt x="345700" y="5164932"/>
                  <a:pt x="482350" y="5264944"/>
                  <a:pt x="610278" y="5375673"/>
                </a:cubicBezTo>
                <a:cubicBezTo>
                  <a:pt x="648075" y="5407819"/>
                  <a:pt x="685872" y="5429250"/>
                  <a:pt x="691686" y="5497116"/>
                </a:cubicBezTo>
                <a:cubicBezTo>
                  <a:pt x="709132" y="5629276"/>
                  <a:pt x="755650" y="5736432"/>
                  <a:pt x="860319" y="5793582"/>
                </a:cubicBezTo>
                <a:cubicBezTo>
                  <a:pt x="860319" y="5793582"/>
                  <a:pt x="854504" y="5815013"/>
                  <a:pt x="851597" y="5825729"/>
                </a:cubicBezTo>
                <a:cubicBezTo>
                  <a:pt x="787632" y="5829301"/>
                  <a:pt x="738206" y="5750720"/>
                  <a:pt x="659704" y="5779295"/>
                </a:cubicBezTo>
                <a:cubicBezTo>
                  <a:pt x="738206" y="5886451"/>
                  <a:pt x="802169" y="5979319"/>
                  <a:pt x="909746" y="6029326"/>
                </a:cubicBezTo>
                <a:cubicBezTo>
                  <a:pt x="996969" y="6068616"/>
                  <a:pt x="1104545" y="6093620"/>
                  <a:pt x="1168509" y="6222207"/>
                </a:cubicBezTo>
                <a:cubicBezTo>
                  <a:pt x="1095822" y="6247210"/>
                  <a:pt x="1040581" y="6215063"/>
                  <a:pt x="985339" y="6193632"/>
                </a:cubicBezTo>
                <a:cubicBezTo>
                  <a:pt x="901023" y="6157913"/>
                  <a:pt x="816707" y="6118623"/>
                  <a:pt x="732391" y="6082904"/>
                </a:cubicBezTo>
                <a:cubicBezTo>
                  <a:pt x="700408" y="6068616"/>
                  <a:pt x="665519" y="6061472"/>
                  <a:pt x="645167" y="6125766"/>
                </a:cubicBezTo>
                <a:cubicBezTo>
                  <a:pt x="752743" y="6140053"/>
                  <a:pt x="816707" y="6225779"/>
                  <a:pt x="883579" y="6307932"/>
                </a:cubicBezTo>
                <a:cubicBezTo>
                  <a:pt x="921375" y="6354366"/>
                  <a:pt x="953358" y="6415088"/>
                  <a:pt x="1020229" y="6393657"/>
                </a:cubicBezTo>
                <a:cubicBezTo>
                  <a:pt x="1055118" y="6382942"/>
                  <a:pt x="1078378" y="6415088"/>
                  <a:pt x="1075471" y="6457950"/>
                </a:cubicBezTo>
                <a:cubicBezTo>
                  <a:pt x="1060933" y="6607970"/>
                  <a:pt x="1145250" y="6657976"/>
                  <a:pt x="1232473" y="6686551"/>
                </a:cubicBezTo>
                <a:cubicBezTo>
                  <a:pt x="1360401" y="6729413"/>
                  <a:pt x="1473792" y="6815138"/>
                  <a:pt x="1592997" y="6886576"/>
                </a:cubicBezTo>
                <a:lnTo>
                  <a:pt x="5511704" y="6886576"/>
                </a:lnTo>
                <a:close/>
              </a:path>
            </a:pathLst>
          </a:custGeom>
          <a:solidFill>
            <a:schemeClr val="accent1"/>
          </a:solidFill>
          <a:ln w="32707" cap="flat">
            <a:noFill/>
            <a:prstDash val="solid"/>
            <a:miter/>
          </a:ln>
        </p:spPr>
        <p:txBody>
          <a:bodyPr rtlCol="0" anchor="ctr"/>
          <a:lstStyle/>
          <a:p>
            <a:endParaRPr lang="en-US" dirty="0">
              <a:solidFill>
                <a:prstClr val="black"/>
              </a:solidFill>
            </a:endParaRPr>
          </a:p>
        </p:txBody>
      </p:sp>
      <p:sp>
        <p:nvSpPr>
          <p:cNvPr id="2" name="Title 1">
            <a:extLst>
              <a:ext uri="{FF2B5EF4-FFF2-40B4-BE49-F238E27FC236}">
                <a16:creationId xmlns:a16="http://schemas.microsoft.com/office/drawing/2014/main" id="{1BD74D6E-70B2-1BFA-A72D-6F85D18D337D}"/>
              </a:ext>
            </a:extLst>
          </p:cNvPr>
          <p:cNvSpPr>
            <a:spLocks noGrp="1"/>
          </p:cNvSpPr>
          <p:nvPr>
            <p:ph type="title"/>
          </p:nvPr>
        </p:nvSpPr>
        <p:spPr>
          <a:xfrm>
            <a:off x="838200" y="713312"/>
            <a:ext cx="3461084" cy="5431376"/>
          </a:xfrm>
        </p:spPr>
        <p:txBody>
          <a:bodyPr>
            <a:normAutofit/>
          </a:bodyPr>
          <a:lstStyle/>
          <a:p>
            <a:r>
              <a:rPr lang="en-US" b="1" dirty="0">
                <a:solidFill>
                  <a:srgbClr val="FFFFFF"/>
                </a:solidFill>
              </a:rPr>
              <a:t>Instructions:</a:t>
            </a:r>
            <a:br>
              <a:rPr lang="en-US" b="1" dirty="0">
                <a:solidFill>
                  <a:srgbClr val="FFFFFF"/>
                </a:solidFill>
              </a:rPr>
            </a:br>
            <a:r>
              <a:rPr lang="en-US" b="1" dirty="0">
                <a:solidFill>
                  <a:srgbClr val="FFFF00"/>
                </a:solidFill>
              </a:rPr>
              <a:t>Structured peer roleplay</a:t>
            </a:r>
          </a:p>
        </p:txBody>
      </p:sp>
      <p:sp>
        <p:nvSpPr>
          <p:cNvPr id="9" name="Content Placeholder 2">
            <a:extLst>
              <a:ext uri="{FF2B5EF4-FFF2-40B4-BE49-F238E27FC236}">
                <a16:creationId xmlns:a16="http://schemas.microsoft.com/office/drawing/2014/main" id="{97122641-785B-043A-20C9-7CA7133EFC69}"/>
              </a:ext>
            </a:extLst>
          </p:cNvPr>
          <p:cNvSpPr>
            <a:spLocks noGrp="1"/>
          </p:cNvSpPr>
          <p:nvPr>
            <p:ph idx="1"/>
          </p:nvPr>
        </p:nvSpPr>
        <p:spPr>
          <a:xfrm>
            <a:off x="5511705" y="713312"/>
            <a:ext cx="6399246" cy="5936869"/>
          </a:xfrm>
        </p:spPr>
        <p:txBody>
          <a:bodyPr anchor="ctr">
            <a:noAutofit/>
          </a:bodyPr>
          <a:lstStyle/>
          <a:p>
            <a:pPr>
              <a:lnSpc>
                <a:spcPct val="90000"/>
              </a:lnSpc>
              <a:spcBef>
                <a:spcPts val="0"/>
              </a:spcBef>
            </a:pPr>
            <a:r>
              <a:rPr lang="en-US" sz="2500" kern="100" dirty="0">
                <a:effectLst/>
                <a:latin typeface="Calibri" panose="020F0502020204030204" pitchFamily="34" charset="0"/>
                <a:ea typeface="Aptos" panose="020B0004020202020204" pitchFamily="34" charset="0"/>
                <a:cs typeface="Calibri" panose="020F0502020204030204" pitchFamily="34" charset="0"/>
              </a:rPr>
              <a:t>In the unlikely situation of a group falling short of a member for the 5 roles, the facilitator</a:t>
            </a:r>
            <a:r>
              <a:rPr lang="en-US" sz="2500" kern="100" dirty="0">
                <a:latin typeface="Calibri" panose="020F0502020204030204" pitchFamily="34" charset="0"/>
                <a:ea typeface="Aptos" panose="020B0004020202020204" pitchFamily="34" charset="0"/>
                <a:cs typeface="Calibri" panose="020F0502020204030204" pitchFamily="34" charset="0"/>
              </a:rPr>
              <a:t> </a:t>
            </a:r>
            <a:r>
              <a:rPr lang="en-US" sz="2500" kern="100" dirty="0">
                <a:effectLst/>
                <a:latin typeface="Calibri" panose="020F0502020204030204" pitchFamily="34" charset="0"/>
                <a:ea typeface="Aptos" panose="020B0004020202020204" pitchFamily="34" charset="0"/>
                <a:cs typeface="Calibri" panose="020F0502020204030204" pitchFamily="34" charset="0"/>
              </a:rPr>
              <a:t>can play a role to accommodate. </a:t>
            </a:r>
          </a:p>
          <a:p>
            <a:pPr>
              <a:lnSpc>
                <a:spcPct val="90000"/>
              </a:lnSpc>
              <a:spcBef>
                <a:spcPts val="0"/>
              </a:spcBef>
            </a:pPr>
            <a:endParaRPr lang="en-US" sz="2500" kern="100" dirty="0">
              <a:effectLst/>
              <a:latin typeface="Calibri" panose="020F0502020204030204" pitchFamily="34" charset="0"/>
              <a:ea typeface="Aptos" panose="020B0004020202020204" pitchFamily="34" charset="0"/>
              <a:cs typeface="Calibri" panose="020F0502020204030204" pitchFamily="34" charset="0"/>
            </a:endParaRPr>
          </a:p>
          <a:p>
            <a:pPr>
              <a:lnSpc>
                <a:spcPct val="90000"/>
              </a:lnSpc>
              <a:spcBef>
                <a:spcPts val="0"/>
              </a:spcBef>
            </a:pPr>
            <a:r>
              <a:rPr lang="en-US" sz="2500" kern="100" dirty="0">
                <a:effectLst/>
                <a:latin typeface="Calibri" panose="020F0502020204030204" pitchFamily="34" charset="0"/>
                <a:ea typeface="Aptos" panose="020B0004020202020204" pitchFamily="34" charset="0"/>
                <a:cs typeface="Calibri" panose="020F0502020204030204" pitchFamily="34" charset="0"/>
              </a:rPr>
              <a:t>If more than 1 member are lacking, the groups can accommodate within themselves to have a student play dual role. </a:t>
            </a:r>
          </a:p>
          <a:p>
            <a:pPr>
              <a:lnSpc>
                <a:spcPct val="90000"/>
              </a:lnSpc>
              <a:spcBef>
                <a:spcPts val="0"/>
              </a:spcBef>
            </a:pPr>
            <a:endParaRPr lang="en-US" sz="2500" kern="100" dirty="0">
              <a:effectLst/>
              <a:latin typeface="Calibri" panose="020F0502020204030204" pitchFamily="34" charset="0"/>
              <a:ea typeface="Aptos" panose="020B0004020202020204" pitchFamily="34" charset="0"/>
              <a:cs typeface="Calibri" panose="020F0502020204030204" pitchFamily="34" charset="0"/>
            </a:endParaRPr>
          </a:p>
          <a:p>
            <a:pPr>
              <a:lnSpc>
                <a:spcPct val="90000"/>
              </a:lnSpc>
              <a:spcBef>
                <a:spcPts val="0"/>
              </a:spcBef>
            </a:pPr>
            <a:r>
              <a:rPr lang="en-US" sz="2500" kern="100" dirty="0">
                <a:effectLst/>
                <a:latin typeface="Calibri" panose="020F0502020204030204" pitchFamily="34" charset="0"/>
                <a:ea typeface="Aptos" panose="020B0004020202020204" pitchFamily="34" charset="0"/>
                <a:cs typeface="Calibri" panose="020F0502020204030204" pitchFamily="34" charset="0"/>
              </a:rPr>
              <a:t>The aim of the </a:t>
            </a:r>
            <a:r>
              <a:rPr lang="en-US" sz="2500" kern="100" dirty="0">
                <a:latin typeface="Calibri" panose="020F0502020204030204" pitchFamily="34" charset="0"/>
                <a:ea typeface="Aptos" panose="020B0004020202020204" pitchFamily="34" charset="0"/>
                <a:cs typeface="Calibri" panose="020F0502020204030204" pitchFamily="34" charset="0"/>
              </a:rPr>
              <a:t>activity is to promote </a:t>
            </a:r>
            <a:r>
              <a:rPr lang="en-US" sz="2500" kern="100" dirty="0">
                <a:effectLst/>
                <a:latin typeface="Calibri" panose="020F0502020204030204" pitchFamily="34" charset="0"/>
                <a:ea typeface="Aptos" panose="020B0004020202020204" pitchFamily="34" charset="0"/>
                <a:cs typeface="Calibri" panose="020F0502020204030204" pitchFamily="34" charset="0"/>
              </a:rPr>
              <a:t>communication, empathy, teamwork, and clinical reasoning.</a:t>
            </a:r>
          </a:p>
          <a:p>
            <a:pPr>
              <a:lnSpc>
                <a:spcPct val="90000"/>
              </a:lnSpc>
            </a:pPr>
            <a:endParaRPr lang="en-US" sz="2500" dirty="0"/>
          </a:p>
        </p:txBody>
      </p:sp>
    </p:spTree>
    <p:extLst>
      <p:ext uri="{BB962C8B-B14F-4D97-AF65-F5344CB8AC3E}">
        <p14:creationId xmlns:p14="http://schemas.microsoft.com/office/powerpoint/2010/main" val="23115823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7718681-A12E-49D6-9925-DD7C68176D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10" name="Freeform: Shape 9">
            <a:extLst>
              <a:ext uri="{FF2B5EF4-FFF2-40B4-BE49-F238E27FC236}">
                <a16:creationId xmlns:a16="http://schemas.microsoft.com/office/drawing/2014/main" id="{FBD77573-9EF2-4C35-8285-A1CF6FBB0E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 y="0"/>
            <a:ext cx="5511704" cy="6858000"/>
          </a:xfrm>
          <a:custGeom>
            <a:avLst/>
            <a:gdLst>
              <a:gd name="connsiteX0" fmla="*/ 5511704 w 5511704"/>
              <a:gd name="connsiteY0" fmla="*/ 0 h 6886576"/>
              <a:gd name="connsiteX1" fmla="*/ 1008599 w 5511704"/>
              <a:gd name="connsiteY1" fmla="*/ 0 h 6886576"/>
              <a:gd name="connsiteX2" fmla="*/ 1310975 w 5511704"/>
              <a:gd name="connsiteY2" fmla="*/ 110728 h 6886576"/>
              <a:gd name="connsiteX3" fmla="*/ 1267362 w 5511704"/>
              <a:gd name="connsiteY3" fmla="*/ 135731 h 6886576"/>
              <a:gd name="connsiteX4" fmla="*/ 1005692 w 5511704"/>
              <a:gd name="connsiteY4" fmla="*/ 71437 h 6886576"/>
              <a:gd name="connsiteX5" fmla="*/ 953358 w 5511704"/>
              <a:gd name="connsiteY5" fmla="*/ 89297 h 6886576"/>
              <a:gd name="connsiteX6" fmla="*/ 979525 w 5511704"/>
              <a:gd name="connsiteY6" fmla="*/ 164307 h 6886576"/>
              <a:gd name="connsiteX7" fmla="*/ 1092915 w 5511704"/>
              <a:gd name="connsiteY7" fmla="*/ 192882 h 6886576"/>
              <a:gd name="connsiteX8" fmla="*/ 1270270 w 5511704"/>
              <a:gd name="connsiteY8" fmla="*/ 375047 h 6886576"/>
              <a:gd name="connsiteX9" fmla="*/ 1002784 w 5511704"/>
              <a:gd name="connsiteY9" fmla="*/ 353615 h 6886576"/>
              <a:gd name="connsiteX10" fmla="*/ 956265 w 5511704"/>
              <a:gd name="connsiteY10" fmla="*/ 396479 h 6886576"/>
              <a:gd name="connsiteX11" fmla="*/ 938820 w 5511704"/>
              <a:gd name="connsiteY11" fmla="*/ 453629 h 6886576"/>
              <a:gd name="connsiteX12" fmla="*/ 860319 w 5511704"/>
              <a:gd name="connsiteY12" fmla="*/ 360759 h 6886576"/>
              <a:gd name="connsiteX13" fmla="*/ 793447 w 5511704"/>
              <a:gd name="connsiteY13" fmla="*/ 335757 h 6886576"/>
              <a:gd name="connsiteX14" fmla="*/ 773095 w 5511704"/>
              <a:gd name="connsiteY14" fmla="*/ 417910 h 6886576"/>
              <a:gd name="connsiteX15" fmla="*/ 834151 w 5511704"/>
              <a:gd name="connsiteY15" fmla="*/ 507206 h 6886576"/>
              <a:gd name="connsiteX16" fmla="*/ 996969 w 5511704"/>
              <a:gd name="connsiteY16" fmla="*/ 560785 h 6886576"/>
              <a:gd name="connsiteX17" fmla="*/ 822522 w 5511704"/>
              <a:gd name="connsiteY17" fmla="*/ 560785 h 6886576"/>
              <a:gd name="connsiteX18" fmla="*/ 621908 w 5511704"/>
              <a:gd name="connsiteY18" fmla="*/ 525066 h 6886576"/>
              <a:gd name="connsiteX19" fmla="*/ 409664 w 5511704"/>
              <a:gd name="connsiteY19" fmla="*/ 535781 h 6886576"/>
              <a:gd name="connsiteX20" fmla="*/ 209049 w 5511704"/>
              <a:gd name="connsiteY20" fmla="*/ 464344 h 6886576"/>
              <a:gd name="connsiteX21" fmla="*/ 5527 w 5511704"/>
              <a:gd name="connsiteY21" fmla="*/ 467916 h 6886576"/>
              <a:gd name="connsiteX22" fmla="*/ 906838 w 5511704"/>
              <a:gd name="connsiteY22" fmla="*/ 914400 h 6886576"/>
              <a:gd name="connsiteX23" fmla="*/ 863226 w 5511704"/>
              <a:gd name="connsiteY23" fmla="*/ 925116 h 6886576"/>
              <a:gd name="connsiteX24" fmla="*/ 805077 w 5511704"/>
              <a:gd name="connsiteY24" fmla="*/ 953691 h 6886576"/>
              <a:gd name="connsiteX25" fmla="*/ 848689 w 5511704"/>
              <a:gd name="connsiteY25" fmla="*/ 1010841 h 6886576"/>
              <a:gd name="connsiteX26" fmla="*/ 1084193 w 5511704"/>
              <a:gd name="connsiteY26" fmla="*/ 1117997 h 6886576"/>
              <a:gd name="connsiteX27" fmla="*/ 1142342 w 5511704"/>
              <a:gd name="connsiteY27" fmla="*/ 1225153 h 6886576"/>
              <a:gd name="connsiteX28" fmla="*/ 1069655 w 5511704"/>
              <a:gd name="connsiteY28" fmla="*/ 1214438 h 6886576"/>
              <a:gd name="connsiteX29" fmla="*/ 1005692 w 5511704"/>
              <a:gd name="connsiteY29" fmla="*/ 1235869 h 6886576"/>
              <a:gd name="connsiteX30" fmla="*/ 1031858 w 5511704"/>
              <a:gd name="connsiteY30" fmla="*/ 1371600 h 6886576"/>
              <a:gd name="connsiteX31" fmla="*/ 1366216 w 5511704"/>
              <a:gd name="connsiteY31" fmla="*/ 1546622 h 6886576"/>
              <a:gd name="connsiteX32" fmla="*/ 1395290 w 5511704"/>
              <a:gd name="connsiteY32" fmla="*/ 1603772 h 6886576"/>
              <a:gd name="connsiteX33" fmla="*/ 1354586 w 5511704"/>
              <a:gd name="connsiteY33" fmla="*/ 1643063 h 6886576"/>
              <a:gd name="connsiteX34" fmla="*/ 1247011 w 5511704"/>
              <a:gd name="connsiteY34" fmla="*/ 1664494 h 6886576"/>
              <a:gd name="connsiteX35" fmla="*/ 1398198 w 5511704"/>
              <a:gd name="connsiteY35" fmla="*/ 1857375 h 6886576"/>
              <a:gd name="connsiteX36" fmla="*/ 1453440 w 5511704"/>
              <a:gd name="connsiteY36" fmla="*/ 1910954 h 6886576"/>
              <a:gd name="connsiteX37" fmla="*/ 1549386 w 5511704"/>
              <a:gd name="connsiteY37" fmla="*/ 1993106 h 6886576"/>
              <a:gd name="connsiteX38" fmla="*/ 1549386 w 5511704"/>
              <a:gd name="connsiteY38" fmla="*/ 2021681 h 6886576"/>
              <a:gd name="connsiteX39" fmla="*/ 1421458 w 5511704"/>
              <a:gd name="connsiteY39" fmla="*/ 2110978 h 6886576"/>
              <a:gd name="connsiteX40" fmla="*/ 1188861 w 5511704"/>
              <a:gd name="connsiteY40" fmla="*/ 2085976 h 6886576"/>
              <a:gd name="connsiteX41" fmla="*/ 1531941 w 5511704"/>
              <a:gd name="connsiteY41" fmla="*/ 2218135 h 6886576"/>
              <a:gd name="connsiteX42" fmla="*/ 421293 w 5511704"/>
              <a:gd name="connsiteY42" fmla="*/ 1900238 h 6886576"/>
              <a:gd name="connsiteX43" fmla="*/ 491072 w 5511704"/>
              <a:gd name="connsiteY43" fmla="*/ 1982391 h 6886576"/>
              <a:gd name="connsiteX44" fmla="*/ 880671 w 5511704"/>
              <a:gd name="connsiteY44" fmla="*/ 2200276 h 6886576"/>
              <a:gd name="connsiteX45" fmla="*/ 991154 w 5511704"/>
              <a:gd name="connsiteY45" fmla="*/ 2336007 h 6886576"/>
              <a:gd name="connsiteX46" fmla="*/ 1107453 w 5511704"/>
              <a:gd name="connsiteY46" fmla="*/ 2411016 h 6886576"/>
              <a:gd name="connsiteX47" fmla="*/ 1270270 w 5511704"/>
              <a:gd name="connsiteY47" fmla="*/ 2411016 h 6886576"/>
              <a:gd name="connsiteX48" fmla="*/ 1386568 w 5511704"/>
              <a:gd name="connsiteY48" fmla="*/ 2528889 h 6886576"/>
              <a:gd name="connsiteX49" fmla="*/ 1267362 w 5511704"/>
              <a:gd name="connsiteY49" fmla="*/ 2553891 h 6886576"/>
              <a:gd name="connsiteX50" fmla="*/ 1127805 w 5511704"/>
              <a:gd name="connsiteY50" fmla="*/ 2536032 h 6886576"/>
              <a:gd name="connsiteX51" fmla="*/ 970802 w 5511704"/>
              <a:gd name="connsiteY51" fmla="*/ 2575322 h 6886576"/>
              <a:gd name="connsiteX52" fmla="*/ 825429 w 5511704"/>
              <a:gd name="connsiteY52" fmla="*/ 2543176 h 6886576"/>
              <a:gd name="connsiteX53" fmla="*/ 650982 w 5511704"/>
              <a:gd name="connsiteY53" fmla="*/ 2564607 h 6886576"/>
              <a:gd name="connsiteX54" fmla="*/ 595740 w 5511704"/>
              <a:gd name="connsiteY54" fmla="*/ 2703909 h 6886576"/>
              <a:gd name="connsiteX55" fmla="*/ 578296 w 5511704"/>
              <a:gd name="connsiteY55" fmla="*/ 2714626 h 6886576"/>
              <a:gd name="connsiteX56" fmla="*/ 255568 w 5511704"/>
              <a:gd name="connsiteY56" fmla="*/ 2936081 h 6886576"/>
              <a:gd name="connsiteX57" fmla="*/ 165437 w 5511704"/>
              <a:gd name="connsiteY57" fmla="*/ 2953941 h 6886576"/>
              <a:gd name="connsiteX58" fmla="*/ 697501 w 5511704"/>
              <a:gd name="connsiteY58" fmla="*/ 3343275 h 6886576"/>
              <a:gd name="connsiteX59" fmla="*/ 339884 w 5511704"/>
              <a:gd name="connsiteY59" fmla="*/ 3243263 h 6886576"/>
              <a:gd name="connsiteX60" fmla="*/ 290458 w 5511704"/>
              <a:gd name="connsiteY60" fmla="*/ 3407569 h 6886576"/>
              <a:gd name="connsiteX61" fmla="*/ 459090 w 5511704"/>
              <a:gd name="connsiteY61" fmla="*/ 3554016 h 6886576"/>
              <a:gd name="connsiteX62" fmla="*/ 520147 w 5511704"/>
              <a:gd name="connsiteY62" fmla="*/ 3843338 h 6886576"/>
              <a:gd name="connsiteX63" fmla="*/ 491072 w 5511704"/>
              <a:gd name="connsiteY63" fmla="*/ 4107657 h 6886576"/>
              <a:gd name="connsiteX64" fmla="*/ 418386 w 5511704"/>
              <a:gd name="connsiteY64" fmla="*/ 4189810 h 6886576"/>
              <a:gd name="connsiteX65" fmla="*/ 313718 w 5511704"/>
              <a:gd name="connsiteY65" fmla="*/ 4339829 h 6886576"/>
              <a:gd name="connsiteX66" fmla="*/ 249753 w 5511704"/>
              <a:gd name="connsiteY66" fmla="*/ 4432698 h 6886576"/>
              <a:gd name="connsiteX67" fmla="*/ 25879 w 5511704"/>
              <a:gd name="connsiteY67" fmla="*/ 4396979 h 6886576"/>
              <a:gd name="connsiteX68" fmla="*/ 325347 w 5511704"/>
              <a:gd name="connsiteY68" fmla="*/ 4632722 h 6886576"/>
              <a:gd name="connsiteX69" fmla="*/ 84029 w 5511704"/>
              <a:gd name="connsiteY69" fmla="*/ 4604147 h 6886576"/>
              <a:gd name="connsiteX70" fmla="*/ 5527 w 5511704"/>
              <a:gd name="connsiteY70" fmla="*/ 4622007 h 6886576"/>
              <a:gd name="connsiteX71" fmla="*/ 49139 w 5511704"/>
              <a:gd name="connsiteY71" fmla="*/ 4697016 h 6886576"/>
              <a:gd name="connsiteX72" fmla="*/ 226494 w 5511704"/>
              <a:gd name="connsiteY72" fmla="*/ 4825604 h 6886576"/>
              <a:gd name="connsiteX73" fmla="*/ 592833 w 5511704"/>
              <a:gd name="connsiteY73" fmla="*/ 5175647 h 6886576"/>
              <a:gd name="connsiteX74" fmla="*/ 238123 w 5511704"/>
              <a:gd name="connsiteY74" fmla="*/ 5014913 h 6886576"/>
              <a:gd name="connsiteX75" fmla="*/ 610278 w 5511704"/>
              <a:gd name="connsiteY75" fmla="*/ 5375673 h 6886576"/>
              <a:gd name="connsiteX76" fmla="*/ 691686 w 5511704"/>
              <a:gd name="connsiteY76" fmla="*/ 5497116 h 6886576"/>
              <a:gd name="connsiteX77" fmla="*/ 860319 w 5511704"/>
              <a:gd name="connsiteY77" fmla="*/ 5793582 h 6886576"/>
              <a:gd name="connsiteX78" fmla="*/ 851597 w 5511704"/>
              <a:gd name="connsiteY78" fmla="*/ 5825729 h 6886576"/>
              <a:gd name="connsiteX79" fmla="*/ 659704 w 5511704"/>
              <a:gd name="connsiteY79" fmla="*/ 5779295 h 6886576"/>
              <a:gd name="connsiteX80" fmla="*/ 909746 w 5511704"/>
              <a:gd name="connsiteY80" fmla="*/ 6029326 h 6886576"/>
              <a:gd name="connsiteX81" fmla="*/ 1168509 w 5511704"/>
              <a:gd name="connsiteY81" fmla="*/ 6222207 h 6886576"/>
              <a:gd name="connsiteX82" fmla="*/ 985339 w 5511704"/>
              <a:gd name="connsiteY82" fmla="*/ 6193632 h 6886576"/>
              <a:gd name="connsiteX83" fmla="*/ 732391 w 5511704"/>
              <a:gd name="connsiteY83" fmla="*/ 6082904 h 6886576"/>
              <a:gd name="connsiteX84" fmla="*/ 645167 w 5511704"/>
              <a:gd name="connsiteY84" fmla="*/ 6125766 h 6886576"/>
              <a:gd name="connsiteX85" fmla="*/ 883579 w 5511704"/>
              <a:gd name="connsiteY85" fmla="*/ 6307932 h 6886576"/>
              <a:gd name="connsiteX86" fmla="*/ 1020229 w 5511704"/>
              <a:gd name="connsiteY86" fmla="*/ 6393657 h 6886576"/>
              <a:gd name="connsiteX87" fmla="*/ 1075471 w 5511704"/>
              <a:gd name="connsiteY87" fmla="*/ 6457950 h 6886576"/>
              <a:gd name="connsiteX88" fmla="*/ 1232473 w 5511704"/>
              <a:gd name="connsiteY88" fmla="*/ 6686551 h 6886576"/>
              <a:gd name="connsiteX89" fmla="*/ 1592997 w 5511704"/>
              <a:gd name="connsiteY89" fmla="*/ 6886576 h 6886576"/>
              <a:gd name="connsiteX90" fmla="*/ 5511704 w 5511704"/>
              <a:gd name="connsiteY90" fmla="*/ 6886576 h 68865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Lst>
            <a:rect l="l" t="t" r="r" b="b"/>
            <a:pathLst>
              <a:path w="5511704" h="6886576">
                <a:moveTo>
                  <a:pt x="5511704" y="0"/>
                </a:moveTo>
                <a:lnTo>
                  <a:pt x="1008599" y="0"/>
                </a:lnTo>
                <a:cubicBezTo>
                  <a:pt x="1110360" y="35719"/>
                  <a:pt x="1209214" y="78581"/>
                  <a:pt x="1310975" y="110728"/>
                </a:cubicBezTo>
                <a:cubicBezTo>
                  <a:pt x="1296437" y="146447"/>
                  <a:pt x="1281900" y="139303"/>
                  <a:pt x="1267362" y="135731"/>
                </a:cubicBezTo>
                <a:cubicBezTo>
                  <a:pt x="1180139" y="121445"/>
                  <a:pt x="1090008" y="110728"/>
                  <a:pt x="1005692" y="71437"/>
                </a:cubicBezTo>
                <a:cubicBezTo>
                  <a:pt x="985339" y="64294"/>
                  <a:pt x="962080" y="64294"/>
                  <a:pt x="953358" y="89297"/>
                </a:cubicBezTo>
                <a:cubicBezTo>
                  <a:pt x="938820" y="125016"/>
                  <a:pt x="959172" y="146447"/>
                  <a:pt x="979525" y="164307"/>
                </a:cubicBezTo>
                <a:cubicBezTo>
                  <a:pt x="1014414" y="196453"/>
                  <a:pt x="1055118" y="189310"/>
                  <a:pt x="1092915" y="192882"/>
                </a:cubicBezTo>
                <a:cubicBezTo>
                  <a:pt x="1197583" y="210741"/>
                  <a:pt x="1247011" y="260747"/>
                  <a:pt x="1270270" y="375047"/>
                </a:cubicBezTo>
                <a:cubicBezTo>
                  <a:pt x="1180139" y="328613"/>
                  <a:pt x="1090008" y="385763"/>
                  <a:pt x="1002784" y="353615"/>
                </a:cubicBezTo>
                <a:cubicBezTo>
                  <a:pt x="979525" y="346472"/>
                  <a:pt x="944635" y="357188"/>
                  <a:pt x="956265" y="396479"/>
                </a:cubicBezTo>
                <a:cubicBezTo>
                  <a:pt x="967894" y="432198"/>
                  <a:pt x="1005692" y="460772"/>
                  <a:pt x="938820" y="453629"/>
                </a:cubicBezTo>
                <a:cubicBezTo>
                  <a:pt x="889393" y="450056"/>
                  <a:pt x="874856" y="407194"/>
                  <a:pt x="860319" y="360759"/>
                </a:cubicBezTo>
                <a:cubicBezTo>
                  <a:pt x="848689" y="335757"/>
                  <a:pt x="816707" y="321469"/>
                  <a:pt x="793447" y="335757"/>
                </a:cubicBezTo>
                <a:cubicBezTo>
                  <a:pt x="764373" y="350044"/>
                  <a:pt x="773095" y="389335"/>
                  <a:pt x="773095" y="417910"/>
                </a:cubicBezTo>
                <a:cubicBezTo>
                  <a:pt x="770187" y="471488"/>
                  <a:pt x="793447" y="496491"/>
                  <a:pt x="834151" y="507206"/>
                </a:cubicBezTo>
                <a:cubicBezTo>
                  <a:pt x="883579" y="521494"/>
                  <a:pt x="933005" y="539354"/>
                  <a:pt x="996969" y="560785"/>
                </a:cubicBezTo>
                <a:cubicBezTo>
                  <a:pt x="927190" y="596503"/>
                  <a:pt x="874856" y="589360"/>
                  <a:pt x="822522" y="560785"/>
                </a:cubicBezTo>
                <a:cubicBezTo>
                  <a:pt x="758558" y="528637"/>
                  <a:pt x="674242" y="485775"/>
                  <a:pt x="621908" y="525066"/>
                </a:cubicBezTo>
                <a:cubicBezTo>
                  <a:pt x="543407" y="582216"/>
                  <a:pt x="479443" y="546497"/>
                  <a:pt x="409664" y="535781"/>
                </a:cubicBezTo>
                <a:cubicBezTo>
                  <a:pt x="264290" y="514350"/>
                  <a:pt x="354422" y="482204"/>
                  <a:pt x="209049" y="464344"/>
                </a:cubicBezTo>
                <a:cubicBezTo>
                  <a:pt x="150900" y="457200"/>
                  <a:pt x="89843" y="428625"/>
                  <a:pt x="5527" y="467916"/>
                </a:cubicBezTo>
                <a:cubicBezTo>
                  <a:pt x="386404" y="675085"/>
                  <a:pt x="566666" y="660797"/>
                  <a:pt x="906838" y="914400"/>
                </a:cubicBezTo>
                <a:cubicBezTo>
                  <a:pt x="892301" y="939404"/>
                  <a:pt x="877764" y="928688"/>
                  <a:pt x="863226" y="925116"/>
                </a:cubicBezTo>
                <a:cubicBezTo>
                  <a:pt x="839967" y="921544"/>
                  <a:pt x="810892" y="907256"/>
                  <a:pt x="805077" y="953691"/>
                </a:cubicBezTo>
                <a:cubicBezTo>
                  <a:pt x="802169" y="989410"/>
                  <a:pt x="819615" y="1007269"/>
                  <a:pt x="848689" y="1010841"/>
                </a:cubicBezTo>
                <a:cubicBezTo>
                  <a:pt x="933005" y="1025129"/>
                  <a:pt x="1008599" y="1075135"/>
                  <a:pt x="1084193" y="1117997"/>
                </a:cubicBezTo>
                <a:cubicBezTo>
                  <a:pt x="1119082" y="1135857"/>
                  <a:pt x="1156879" y="1160860"/>
                  <a:pt x="1142342" y="1225153"/>
                </a:cubicBezTo>
                <a:cubicBezTo>
                  <a:pt x="1113268" y="1243013"/>
                  <a:pt x="1092915" y="1218009"/>
                  <a:pt x="1069655" y="1214438"/>
                </a:cubicBezTo>
                <a:cubicBezTo>
                  <a:pt x="1046396" y="1210866"/>
                  <a:pt x="991154" y="1225153"/>
                  <a:pt x="1005692" y="1235869"/>
                </a:cubicBezTo>
                <a:cubicBezTo>
                  <a:pt x="1072563" y="1275159"/>
                  <a:pt x="950450" y="1371600"/>
                  <a:pt x="1031858" y="1371600"/>
                </a:cubicBezTo>
                <a:cubicBezTo>
                  <a:pt x="1165601" y="1371600"/>
                  <a:pt x="1238288" y="1543050"/>
                  <a:pt x="1366216" y="1546622"/>
                </a:cubicBezTo>
                <a:cubicBezTo>
                  <a:pt x="1386568" y="1546622"/>
                  <a:pt x="1395290" y="1578770"/>
                  <a:pt x="1395290" y="1603772"/>
                </a:cubicBezTo>
                <a:cubicBezTo>
                  <a:pt x="1395290" y="1635920"/>
                  <a:pt x="1374939" y="1639491"/>
                  <a:pt x="1354586" y="1643063"/>
                </a:cubicBezTo>
                <a:cubicBezTo>
                  <a:pt x="1322604" y="1646635"/>
                  <a:pt x="1287715" y="1603772"/>
                  <a:pt x="1247011" y="1664494"/>
                </a:cubicBezTo>
                <a:cubicBezTo>
                  <a:pt x="1322604" y="1700213"/>
                  <a:pt x="1401105" y="1735932"/>
                  <a:pt x="1398198" y="1857375"/>
                </a:cubicBezTo>
                <a:cubicBezTo>
                  <a:pt x="1398198" y="1889523"/>
                  <a:pt x="1430180" y="1903810"/>
                  <a:pt x="1453440" y="1910954"/>
                </a:cubicBezTo>
                <a:cubicBezTo>
                  <a:pt x="1494144" y="1925241"/>
                  <a:pt x="1526126" y="1946673"/>
                  <a:pt x="1549386" y="1993106"/>
                </a:cubicBezTo>
                <a:cubicBezTo>
                  <a:pt x="1549386" y="2003822"/>
                  <a:pt x="1549386" y="2010966"/>
                  <a:pt x="1549386" y="2021681"/>
                </a:cubicBezTo>
                <a:cubicBezTo>
                  <a:pt x="1543571" y="2132410"/>
                  <a:pt x="1485422" y="2128838"/>
                  <a:pt x="1421458" y="2110978"/>
                </a:cubicBezTo>
                <a:cubicBezTo>
                  <a:pt x="1345864" y="2089547"/>
                  <a:pt x="1270270" y="2046685"/>
                  <a:pt x="1188861" y="2085976"/>
                </a:cubicBezTo>
                <a:cubicBezTo>
                  <a:pt x="1302252" y="2139554"/>
                  <a:pt x="1427272" y="2143126"/>
                  <a:pt x="1531941" y="2218135"/>
                </a:cubicBezTo>
                <a:cubicBezTo>
                  <a:pt x="1142342" y="2232422"/>
                  <a:pt x="799262" y="1993106"/>
                  <a:pt x="421293" y="1900238"/>
                </a:cubicBezTo>
                <a:cubicBezTo>
                  <a:pt x="432923" y="1960960"/>
                  <a:pt x="464905" y="1975247"/>
                  <a:pt x="491072" y="1982391"/>
                </a:cubicBezTo>
                <a:cubicBezTo>
                  <a:pt x="630630" y="2028825"/>
                  <a:pt x="752743" y="2121695"/>
                  <a:pt x="880671" y="2200276"/>
                </a:cubicBezTo>
                <a:cubicBezTo>
                  <a:pt x="933005" y="2232422"/>
                  <a:pt x="970802" y="2268142"/>
                  <a:pt x="991154" y="2336007"/>
                </a:cubicBezTo>
                <a:cubicBezTo>
                  <a:pt x="1008599" y="2400300"/>
                  <a:pt x="1043489" y="2428875"/>
                  <a:pt x="1107453" y="2411016"/>
                </a:cubicBezTo>
                <a:cubicBezTo>
                  <a:pt x="1159787" y="2396729"/>
                  <a:pt x="1215029" y="2403873"/>
                  <a:pt x="1270270" y="2411016"/>
                </a:cubicBezTo>
                <a:cubicBezTo>
                  <a:pt x="1331326" y="2418160"/>
                  <a:pt x="1401105" y="2489597"/>
                  <a:pt x="1386568" y="2528889"/>
                </a:cubicBezTo>
                <a:cubicBezTo>
                  <a:pt x="1357494" y="2593182"/>
                  <a:pt x="1308067" y="2561035"/>
                  <a:pt x="1267362" y="2553891"/>
                </a:cubicBezTo>
                <a:cubicBezTo>
                  <a:pt x="1217936" y="2546748"/>
                  <a:pt x="1127805" y="2528889"/>
                  <a:pt x="1127805" y="2536032"/>
                </a:cubicBezTo>
                <a:cubicBezTo>
                  <a:pt x="1095822" y="2696766"/>
                  <a:pt x="1023136" y="2575322"/>
                  <a:pt x="970802" y="2575322"/>
                </a:cubicBezTo>
                <a:cubicBezTo>
                  <a:pt x="921375" y="2575322"/>
                  <a:pt x="871949" y="2557463"/>
                  <a:pt x="825429" y="2543176"/>
                </a:cubicBezTo>
                <a:cubicBezTo>
                  <a:pt x="764373" y="2525316"/>
                  <a:pt x="709132" y="2557463"/>
                  <a:pt x="650982" y="2564607"/>
                </a:cubicBezTo>
                <a:cubicBezTo>
                  <a:pt x="598648" y="2571751"/>
                  <a:pt x="627722" y="2664620"/>
                  <a:pt x="595740" y="2703909"/>
                </a:cubicBezTo>
                <a:cubicBezTo>
                  <a:pt x="589926" y="2714626"/>
                  <a:pt x="584111" y="2714626"/>
                  <a:pt x="578296" y="2714626"/>
                </a:cubicBezTo>
                <a:cubicBezTo>
                  <a:pt x="560851" y="2993232"/>
                  <a:pt x="255568" y="2925366"/>
                  <a:pt x="255568" y="2936081"/>
                </a:cubicBezTo>
                <a:cubicBezTo>
                  <a:pt x="229401" y="2953941"/>
                  <a:pt x="197419" y="2911079"/>
                  <a:pt x="165437" y="2953941"/>
                </a:cubicBezTo>
                <a:cubicBezTo>
                  <a:pt x="302087" y="3150394"/>
                  <a:pt x="511425" y="3196828"/>
                  <a:pt x="697501" y="3343275"/>
                </a:cubicBezTo>
                <a:cubicBezTo>
                  <a:pt x="543407" y="3393282"/>
                  <a:pt x="453275" y="3221832"/>
                  <a:pt x="339884" y="3243263"/>
                </a:cubicBezTo>
                <a:cubicBezTo>
                  <a:pt x="284643" y="3296842"/>
                  <a:pt x="450368" y="3382566"/>
                  <a:pt x="290458" y="3407569"/>
                </a:cubicBezTo>
                <a:cubicBezTo>
                  <a:pt x="360236" y="3454004"/>
                  <a:pt x="409664" y="3500439"/>
                  <a:pt x="459090" y="3554016"/>
                </a:cubicBezTo>
                <a:cubicBezTo>
                  <a:pt x="543407" y="3650457"/>
                  <a:pt x="560851" y="3714751"/>
                  <a:pt x="520147" y="3843338"/>
                </a:cubicBezTo>
                <a:cubicBezTo>
                  <a:pt x="493979" y="3929063"/>
                  <a:pt x="456183" y="4007645"/>
                  <a:pt x="491072" y="4107657"/>
                </a:cubicBezTo>
                <a:cubicBezTo>
                  <a:pt x="514332" y="4175522"/>
                  <a:pt x="505609" y="4221957"/>
                  <a:pt x="418386" y="4189810"/>
                </a:cubicBezTo>
                <a:cubicBezTo>
                  <a:pt x="325347" y="4157663"/>
                  <a:pt x="290458" y="4218386"/>
                  <a:pt x="313718" y="4339829"/>
                </a:cubicBezTo>
                <a:cubicBezTo>
                  <a:pt x="328254" y="4418410"/>
                  <a:pt x="313718" y="4443413"/>
                  <a:pt x="249753" y="4432698"/>
                </a:cubicBezTo>
                <a:cubicBezTo>
                  <a:pt x="179975" y="4421982"/>
                  <a:pt x="113103" y="4371976"/>
                  <a:pt x="25879" y="4396979"/>
                </a:cubicBezTo>
                <a:cubicBezTo>
                  <a:pt x="95658" y="4539854"/>
                  <a:pt x="243939" y="4496991"/>
                  <a:pt x="325347" y="4632722"/>
                </a:cubicBezTo>
                <a:cubicBezTo>
                  <a:pt x="229401" y="4632722"/>
                  <a:pt x="153807" y="4632722"/>
                  <a:pt x="84029" y="4604147"/>
                </a:cubicBezTo>
                <a:cubicBezTo>
                  <a:pt x="54954" y="4593433"/>
                  <a:pt x="22972" y="4579145"/>
                  <a:pt x="5527" y="4622007"/>
                </a:cubicBezTo>
                <a:cubicBezTo>
                  <a:pt x="-14826" y="4672014"/>
                  <a:pt x="25879" y="4689872"/>
                  <a:pt x="49139" y="4697016"/>
                </a:cubicBezTo>
                <a:cubicBezTo>
                  <a:pt x="116011" y="4722019"/>
                  <a:pt x="168344" y="4779170"/>
                  <a:pt x="226494" y="4825604"/>
                </a:cubicBezTo>
                <a:cubicBezTo>
                  <a:pt x="351514" y="4925616"/>
                  <a:pt x="488165" y="5011341"/>
                  <a:pt x="592833" y="5175647"/>
                </a:cubicBezTo>
                <a:cubicBezTo>
                  <a:pt x="461997" y="5132785"/>
                  <a:pt x="363144" y="5032772"/>
                  <a:pt x="238123" y="5014913"/>
                </a:cubicBezTo>
                <a:cubicBezTo>
                  <a:pt x="345700" y="5164932"/>
                  <a:pt x="482350" y="5264944"/>
                  <a:pt x="610278" y="5375673"/>
                </a:cubicBezTo>
                <a:cubicBezTo>
                  <a:pt x="648075" y="5407819"/>
                  <a:pt x="685872" y="5429250"/>
                  <a:pt x="691686" y="5497116"/>
                </a:cubicBezTo>
                <a:cubicBezTo>
                  <a:pt x="709132" y="5629276"/>
                  <a:pt x="755650" y="5736432"/>
                  <a:pt x="860319" y="5793582"/>
                </a:cubicBezTo>
                <a:cubicBezTo>
                  <a:pt x="860319" y="5793582"/>
                  <a:pt x="854504" y="5815013"/>
                  <a:pt x="851597" y="5825729"/>
                </a:cubicBezTo>
                <a:cubicBezTo>
                  <a:pt x="787632" y="5829301"/>
                  <a:pt x="738206" y="5750720"/>
                  <a:pt x="659704" y="5779295"/>
                </a:cubicBezTo>
                <a:cubicBezTo>
                  <a:pt x="738206" y="5886451"/>
                  <a:pt x="802169" y="5979319"/>
                  <a:pt x="909746" y="6029326"/>
                </a:cubicBezTo>
                <a:cubicBezTo>
                  <a:pt x="996969" y="6068616"/>
                  <a:pt x="1104545" y="6093620"/>
                  <a:pt x="1168509" y="6222207"/>
                </a:cubicBezTo>
                <a:cubicBezTo>
                  <a:pt x="1095822" y="6247210"/>
                  <a:pt x="1040581" y="6215063"/>
                  <a:pt x="985339" y="6193632"/>
                </a:cubicBezTo>
                <a:cubicBezTo>
                  <a:pt x="901023" y="6157913"/>
                  <a:pt x="816707" y="6118623"/>
                  <a:pt x="732391" y="6082904"/>
                </a:cubicBezTo>
                <a:cubicBezTo>
                  <a:pt x="700408" y="6068616"/>
                  <a:pt x="665519" y="6061472"/>
                  <a:pt x="645167" y="6125766"/>
                </a:cubicBezTo>
                <a:cubicBezTo>
                  <a:pt x="752743" y="6140053"/>
                  <a:pt x="816707" y="6225779"/>
                  <a:pt x="883579" y="6307932"/>
                </a:cubicBezTo>
                <a:cubicBezTo>
                  <a:pt x="921375" y="6354366"/>
                  <a:pt x="953358" y="6415088"/>
                  <a:pt x="1020229" y="6393657"/>
                </a:cubicBezTo>
                <a:cubicBezTo>
                  <a:pt x="1055118" y="6382942"/>
                  <a:pt x="1078378" y="6415088"/>
                  <a:pt x="1075471" y="6457950"/>
                </a:cubicBezTo>
                <a:cubicBezTo>
                  <a:pt x="1060933" y="6607970"/>
                  <a:pt x="1145250" y="6657976"/>
                  <a:pt x="1232473" y="6686551"/>
                </a:cubicBezTo>
                <a:cubicBezTo>
                  <a:pt x="1360401" y="6729413"/>
                  <a:pt x="1473792" y="6815138"/>
                  <a:pt x="1592997" y="6886576"/>
                </a:cubicBezTo>
                <a:lnTo>
                  <a:pt x="5511704" y="6886576"/>
                </a:lnTo>
                <a:close/>
              </a:path>
            </a:pathLst>
          </a:custGeom>
          <a:solidFill>
            <a:schemeClr val="accent1"/>
          </a:solidFill>
          <a:ln w="32707" cap="flat">
            <a:noFill/>
            <a:prstDash val="solid"/>
            <a:miter/>
          </a:ln>
        </p:spPr>
        <p:txBody>
          <a:bodyPr rtlCol="0" anchor="ctr"/>
          <a:lstStyle/>
          <a:p>
            <a:endParaRPr lang="en-US" dirty="0">
              <a:solidFill>
                <a:prstClr val="black"/>
              </a:solidFill>
            </a:endParaRPr>
          </a:p>
        </p:txBody>
      </p:sp>
      <p:sp>
        <p:nvSpPr>
          <p:cNvPr id="2" name="Title 1">
            <a:extLst>
              <a:ext uri="{FF2B5EF4-FFF2-40B4-BE49-F238E27FC236}">
                <a16:creationId xmlns:a16="http://schemas.microsoft.com/office/drawing/2014/main" id="{1BD74D6E-70B2-1BFA-A72D-6F85D18D337D}"/>
              </a:ext>
            </a:extLst>
          </p:cNvPr>
          <p:cNvSpPr>
            <a:spLocks noGrp="1"/>
          </p:cNvSpPr>
          <p:nvPr>
            <p:ph type="title"/>
          </p:nvPr>
        </p:nvSpPr>
        <p:spPr>
          <a:xfrm>
            <a:off x="838200" y="713312"/>
            <a:ext cx="3461084" cy="5431376"/>
          </a:xfrm>
        </p:spPr>
        <p:txBody>
          <a:bodyPr>
            <a:normAutofit/>
          </a:bodyPr>
          <a:lstStyle/>
          <a:p>
            <a:r>
              <a:rPr lang="en-US" b="1" dirty="0">
                <a:solidFill>
                  <a:srgbClr val="FFFFFF"/>
                </a:solidFill>
              </a:rPr>
              <a:t>Instructions:</a:t>
            </a:r>
            <a:br>
              <a:rPr lang="en-US" b="1" dirty="0">
                <a:solidFill>
                  <a:srgbClr val="FFFFFF"/>
                </a:solidFill>
              </a:rPr>
            </a:br>
            <a:r>
              <a:rPr lang="en-US" b="1" dirty="0">
                <a:solidFill>
                  <a:srgbClr val="FFFF00"/>
                </a:solidFill>
              </a:rPr>
              <a:t>Structured peer roleplay</a:t>
            </a:r>
          </a:p>
        </p:txBody>
      </p:sp>
      <p:sp>
        <p:nvSpPr>
          <p:cNvPr id="7" name="Content Placeholder 2">
            <a:extLst>
              <a:ext uri="{FF2B5EF4-FFF2-40B4-BE49-F238E27FC236}">
                <a16:creationId xmlns:a16="http://schemas.microsoft.com/office/drawing/2014/main" id="{97122641-785B-043A-20C9-7CA7133EFC69}"/>
              </a:ext>
            </a:extLst>
          </p:cNvPr>
          <p:cNvSpPr>
            <a:spLocks noGrp="1"/>
          </p:cNvSpPr>
          <p:nvPr>
            <p:ph idx="1"/>
          </p:nvPr>
        </p:nvSpPr>
        <p:spPr>
          <a:xfrm>
            <a:off x="5511705" y="713312"/>
            <a:ext cx="6399246" cy="5936869"/>
          </a:xfrm>
        </p:spPr>
        <p:txBody>
          <a:bodyPr anchor="ctr">
            <a:noAutofit/>
          </a:bodyPr>
          <a:lstStyle/>
          <a:p>
            <a:pPr>
              <a:lnSpc>
                <a:spcPct val="90000"/>
              </a:lnSpc>
              <a:spcBef>
                <a:spcPts val="0"/>
              </a:spcBef>
            </a:pPr>
            <a:r>
              <a:rPr lang="en-US" sz="2500" kern="100" dirty="0">
                <a:effectLst/>
                <a:latin typeface="Calibri" panose="020F0502020204030204" pitchFamily="34" charset="0"/>
                <a:ea typeface="Aptos" panose="020B0004020202020204" pitchFamily="34" charset="0"/>
                <a:cs typeface="Calibri" panose="020F0502020204030204" pitchFamily="34" charset="0"/>
              </a:rPr>
              <a:t>This activity will be conducted for </a:t>
            </a:r>
            <a:r>
              <a:rPr lang="en-US" sz="2500" kern="100" dirty="0">
                <a:latin typeface="Calibri" panose="020F0502020204030204" pitchFamily="34" charset="0"/>
                <a:ea typeface="Aptos" panose="020B0004020202020204" pitchFamily="34" charset="0"/>
                <a:cs typeface="Calibri" panose="020F0502020204030204" pitchFamily="34" charset="0"/>
              </a:rPr>
              <a:t>45</a:t>
            </a:r>
            <a:r>
              <a:rPr lang="en-US" sz="2500" kern="100" dirty="0">
                <a:effectLst/>
                <a:latin typeface="Calibri" panose="020F0502020204030204" pitchFamily="34" charset="0"/>
                <a:ea typeface="Aptos" panose="020B0004020202020204" pitchFamily="34" charset="0"/>
                <a:cs typeface="Calibri" panose="020F0502020204030204" pitchFamily="34" charset="0"/>
              </a:rPr>
              <a:t> minutes.</a:t>
            </a:r>
          </a:p>
          <a:p>
            <a:pPr>
              <a:lnSpc>
                <a:spcPct val="90000"/>
              </a:lnSpc>
              <a:spcBef>
                <a:spcPts val="0"/>
              </a:spcBef>
            </a:pPr>
            <a:endParaRPr lang="en-US" sz="2500" kern="100" dirty="0">
              <a:effectLst/>
              <a:latin typeface="Calibri" panose="020F0502020204030204" pitchFamily="34" charset="0"/>
              <a:ea typeface="Aptos" panose="020B0004020202020204" pitchFamily="34" charset="0"/>
              <a:cs typeface="Calibri" panose="020F0502020204030204" pitchFamily="34" charset="0"/>
            </a:endParaRPr>
          </a:p>
          <a:p>
            <a:pPr>
              <a:lnSpc>
                <a:spcPct val="90000"/>
              </a:lnSpc>
              <a:spcBef>
                <a:spcPts val="0"/>
              </a:spcBef>
            </a:pPr>
            <a:r>
              <a:rPr lang="en-US" sz="2500" kern="100" dirty="0">
                <a:effectLst/>
                <a:latin typeface="Calibri" panose="020F0502020204030204" pitchFamily="34" charset="0"/>
                <a:ea typeface="Aptos" panose="020B0004020202020204" pitchFamily="34" charset="0"/>
                <a:cs typeface="Calibri" panose="020F0502020204030204" pitchFamily="34" charset="0"/>
              </a:rPr>
              <a:t>Take adequate time to understand your role and keep the conversation rich and engaging to make the </a:t>
            </a:r>
            <a:r>
              <a:rPr lang="en-US" sz="2500" kern="100" dirty="0">
                <a:latin typeface="Calibri" panose="020F0502020204030204" pitchFamily="34" charset="0"/>
                <a:ea typeface="Aptos" panose="020B0004020202020204" pitchFamily="34" charset="0"/>
                <a:cs typeface="Calibri" panose="020F0502020204030204" pitchFamily="34" charset="0"/>
              </a:rPr>
              <a:t>roleplay </a:t>
            </a:r>
            <a:r>
              <a:rPr lang="en-US" sz="2500" kern="100" dirty="0">
                <a:effectLst/>
                <a:latin typeface="Calibri" panose="020F0502020204030204" pitchFamily="34" charset="0"/>
                <a:ea typeface="Aptos" panose="020B0004020202020204" pitchFamily="34" charset="0"/>
                <a:cs typeface="Calibri" panose="020F0502020204030204" pitchFamily="34" charset="0"/>
              </a:rPr>
              <a:t> realistic and meaningful.</a:t>
            </a:r>
          </a:p>
          <a:p>
            <a:pPr>
              <a:lnSpc>
                <a:spcPct val="90000"/>
              </a:lnSpc>
              <a:spcBef>
                <a:spcPts val="0"/>
              </a:spcBef>
            </a:pPr>
            <a:endParaRPr lang="en-US" sz="2500" kern="100" dirty="0">
              <a:effectLst/>
              <a:latin typeface="Calibri" panose="020F0502020204030204" pitchFamily="34" charset="0"/>
              <a:ea typeface="Aptos" panose="020B0004020202020204" pitchFamily="34" charset="0"/>
              <a:cs typeface="Calibri" panose="020F0502020204030204" pitchFamily="34" charset="0"/>
            </a:endParaRPr>
          </a:p>
          <a:p>
            <a:pPr>
              <a:lnSpc>
                <a:spcPct val="90000"/>
              </a:lnSpc>
              <a:spcBef>
                <a:spcPts val="0"/>
              </a:spcBef>
              <a:spcAft>
                <a:spcPts val="800"/>
              </a:spcAft>
            </a:pPr>
            <a:r>
              <a:rPr lang="en-US" sz="2500" kern="100" dirty="0">
                <a:effectLst/>
                <a:latin typeface="Calibri" panose="020F0502020204030204" pitchFamily="34" charset="0"/>
                <a:ea typeface="Aptos" panose="020B0004020202020204" pitchFamily="34" charset="0"/>
                <a:cs typeface="Calibri" panose="020F0502020204030204" pitchFamily="34" charset="0"/>
              </a:rPr>
              <a:t>It is the responsibility of the faculty to facilitate this and ensure students are interacting as per their roles and cover all parts of the activity. </a:t>
            </a:r>
          </a:p>
          <a:p>
            <a:pPr>
              <a:lnSpc>
                <a:spcPct val="90000"/>
              </a:lnSpc>
            </a:pPr>
            <a:endParaRPr lang="en-US" sz="2500" dirty="0"/>
          </a:p>
        </p:txBody>
      </p:sp>
    </p:spTree>
    <p:extLst>
      <p:ext uri="{BB962C8B-B14F-4D97-AF65-F5344CB8AC3E}">
        <p14:creationId xmlns:p14="http://schemas.microsoft.com/office/powerpoint/2010/main" val="264983503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7718681-A12E-49D6-9925-DD7C68176D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FBD77573-9EF2-4C35-8285-A1CF6FBB0E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 y="0"/>
            <a:ext cx="5511704" cy="6858000"/>
          </a:xfrm>
          <a:custGeom>
            <a:avLst/>
            <a:gdLst>
              <a:gd name="connsiteX0" fmla="*/ 5511704 w 5511704"/>
              <a:gd name="connsiteY0" fmla="*/ 0 h 6886576"/>
              <a:gd name="connsiteX1" fmla="*/ 1008599 w 5511704"/>
              <a:gd name="connsiteY1" fmla="*/ 0 h 6886576"/>
              <a:gd name="connsiteX2" fmla="*/ 1310975 w 5511704"/>
              <a:gd name="connsiteY2" fmla="*/ 110728 h 6886576"/>
              <a:gd name="connsiteX3" fmla="*/ 1267362 w 5511704"/>
              <a:gd name="connsiteY3" fmla="*/ 135731 h 6886576"/>
              <a:gd name="connsiteX4" fmla="*/ 1005692 w 5511704"/>
              <a:gd name="connsiteY4" fmla="*/ 71437 h 6886576"/>
              <a:gd name="connsiteX5" fmla="*/ 953358 w 5511704"/>
              <a:gd name="connsiteY5" fmla="*/ 89297 h 6886576"/>
              <a:gd name="connsiteX6" fmla="*/ 979525 w 5511704"/>
              <a:gd name="connsiteY6" fmla="*/ 164307 h 6886576"/>
              <a:gd name="connsiteX7" fmla="*/ 1092915 w 5511704"/>
              <a:gd name="connsiteY7" fmla="*/ 192882 h 6886576"/>
              <a:gd name="connsiteX8" fmla="*/ 1270270 w 5511704"/>
              <a:gd name="connsiteY8" fmla="*/ 375047 h 6886576"/>
              <a:gd name="connsiteX9" fmla="*/ 1002784 w 5511704"/>
              <a:gd name="connsiteY9" fmla="*/ 353615 h 6886576"/>
              <a:gd name="connsiteX10" fmla="*/ 956265 w 5511704"/>
              <a:gd name="connsiteY10" fmla="*/ 396479 h 6886576"/>
              <a:gd name="connsiteX11" fmla="*/ 938820 w 5511704"/>
              <a:gd name="connsiteY11" fmla="*/ 453629 h 6886576"/>
              <a:gd name="connsiteX12" fmla="*/ 860319 w 5511704"/>
              <a:gd name="connsiteY12" fmla="*/ 360759 h 6886576"/>
              <a:gd name="connsiteX13" fmla="*/ 793447 w 5511704"/>
              <a:gd name="connsiteY13" fmla="*/ 335757 h 6886576"/>
              <a:gd name="connsiteX14" fmla="*/ 773095 w 5511704"/>
              <a:gd name="connsiteY14" fmla="*/ 417910 h 6886576"/>
              <a:gd name="connsiteX15" fmla="*/ 834151 w 5511704"/>
              <a:gd name="connsiteY15" fmla="*/ 507206 h 6886576"/>
              <a:gd name="connsiteX16" fmla="*/ 996969 w 5511704"/>
              <a:gd name="connsiteY16" fmla="*/ 560785 h 6886576"/>
              <a:gd name="connsiteX17" fmla="*/ 822522 w 5511704"/>
              <a:gd name="connsiteY17" fmla="*/ 560785 h 6886576"/>
              <a:gd name="connsiteX18" fmla="*/ 621908 w 5511704"/>
              <a:gd name="connsiteY18" fmla="*/ 525066 h 6886576"/>
              <a:gd name="connsiteX19" fmla="*/ 409664 w 5511704"/>
              <a:gd name="connsiteY19" fmla="*/ 535781 h 6886576"/>
              <a:gd name="connsiteX20" fmla="*/ 209049 w 5511704"/>
              <a:gd name="connsiteY20" fmla="*/ 464344 h 6886576"/>
              <a:gd name="connsiteX21" fmla="*/ 5527 w 5511704"/>
              <a:gd name="connsiteY21" fmla="*/ 467916 h 6886576"/>
              <a:gd name="connsiteX22" fmla="*/ 906838 w 5511704"/>
              <a:gd name="connsiteY22" fmla="*/ 914400 h 6886576"/>
              <a:gd name="connsiteX23" fmla="*/ 863226 w 5511704"/>
              <a:gd name="connsiteY23" fmla="*/ 925116 h 6886576"/>
              <a:gd name="connsiteX24" fmla="*/ 805077 w 5511704"/>
              <a:gd name="connsiteY24" fmla="*/ 953691 h 6886576"/>
              <a:gd name="connsiteX25" fmla="*/ 848689 w 5511704"/>
              <a:gd name="connsiteY25" fmla="*/ 1010841 h 6886576"/>
              <a:gd name="connsiteX26" fmla="*/ 1084193 w 5511704"/>
              <a:gd name="connsiteY26" fmla="*/ 1117997 h 6886576"/>
              <a:gd name="connsiteX27" fmla="*/ 1142342 w 5511704"/>
              <a:gd name="connsiteY27" fmla="*/ 1225153 h 6886576"/>
              <a:gd name="connsiteX28" fmla="*/ 1069655 w 5511704"/>
              <a:gd name="connsiteY28" fmla="*/ 1214438 h 6886576"/>
              <a:gd name="connsiteX29" fmla="*/ 1005692 w 5511704"/>
              <a:gd name="connsiteY29" fmla="*/ 1235869 h 6886576"/>
              <a:gd name="connsiteX30" fmla="*/ 1031858 w 5511704"/>
              <a:gd name="connsiteY30" fmla="*/ 1371600 h 6886576"/>
              <a:gd name="connsiteX31" fmla="*/ 1366216 w 5511704"/>
              <a:gd name="connsiteY31" fmla="*/ 1546622 h 6886576"/>
              <a:gd name="connsiteX32" fmla="*/ 1395290 w 5511704"/>
              <a:gd name="connsiteY32" fmla="*/ 1603772 h 6886576"/>
              <a:gd name="connsiteX33" fmla="*/ 1354586 w 5511704"/>
              <a:gd name="connsiteY33" fmla="*/ 1643063 h 6886576"/>
              <a:gd name="connsiteX34" fmla="*/ 1247011 w 5511704"/>
              <a:gd name="connsiteY34" fmla="*/ 1664494 h 6886576"/>
              <a:gd name="connsiteX35" fmla="*/ 1398198 w 5511704"/>
              <a:gd name="connsiteY35" fmla="*/ 1857375 h 6886576"/>
              <a:gd name="connsiteX36" fmla="*/ 1453440 w 5511704"/>
              <a:gd name="connsiteY36" fmla="*/ 1910954 h 6886576"/>
              <a:gd name="connsiteX37" fmla="*/ 1549386 w 5511704"/>
              <a:gd name="connsiteY37" fmla="*/ 1993106 h 6886576"/>
              <a:gd name="connsiteX38" fmla="*/ 1549386 w 5511704"/>
              <a:gd name="connsiteY38" fmla="*/ 2021681 h 6886576"/>
              <a:gd name="connsiteX39" fmla="*/ 1421458 w 5511704"/>
              <a:gd name="connsiteY39" fmla="*/ 2110978 h 6886576"/>
              <a:gd name="connsiteX40" fmla="*/ 1188861 w 5511704"/>
              <a:gd name="connsiteY40" fmla="*/ 2085976 h 6886576"/>
              <a:gd name="connsiteX41" fmla="*/ 1531941 w 5511704"/>
              <a:gd name="connsiteY41" fmla="*/ 2218135 h 6886576"/>
              <a:gd name="connsiteX42" fmla="*/ 421293 w 5511704"/>
              <a:gd name="connsiteY42" fmla="*/ 1900238 h 6886576"/>
              <a:gd name="connsiteX43" fmla="*/ 491072 w 5511704"/>
              <a:gd name="connsiteY43" fmla="*/ 1982391 h 6886576"/>
              <a:gd name="connsiteX44" fmla="*/ 880671 w 5511704"/>
              <a:gd name="connsiteY44" fmla="*/ 2200276 h 6886576"/>
              <a:gd name="connsiteX45" fmla="*/ 991154 w 5511704"/>
              <a:gd name="connsiteY45" fmla="*/ 2336007 h 6886576"/>
              <a:gd name="connsiteX46" fmla="*/ 1107453 w 5511704"/>
              <a:gd name="connsiteY46" fmla="*/ 2411016 h 6886576"/>
              <a:gd name="connsiteX47" fmla="*/ 1270270 w 5511704"/>
              <a:gd name="connsiteY47" fmla="*/ 2411016 h 6886576"/>
              <a:gd name="connsiteX48" fmla="*/ 1386568 w 5511704"/>
              <a:gd name="connsiteY48" fmla="*/ 2528889 h 6886576"/>
              <a:gd name="connsiteX49" fmla="*/ 1267362 w 5511704"/>
              <a:gd name="connsiteY49" fmla="*/ 2553891 h 6886576"/>
              <a:gd name="connsiteX50" fmla="*/ 1127805 w 5511704"/>
              <a:gd name="connsiteY50" fmla="*/ 2536032 h 6886576"/>
              <a:gd name="connsiteX51" fmla="*/ 970802 w 5511704"/>
              <a:gd name="connsiteY51" fmla="*/ 2575322 h 6886576"/>
              <a:gd name="connsiteX52" fmla="*/ 825429 w 5511704"/>
              <a:gd name="connsiteY52" fmla="*/ 2543176 h 6886576"/>
              <a:gd name="connsiteX53" fmla="*/ 650982 w 5511704"/>
              <a:gd name="connsiteY53" fmla="*/ 2564607 h 6886576"/>
              <a:gd name="connsiteX54" fmla="*/ 595740 w 5511704"/>
              <a:gd name="connsiteY54" fmla="*/ 2703909 h 6886576"/>
              <a:gd name="connsiteX55" fmla="*/ 578296 w 5511704"/>
              <a:gd name="connsiteY55" fmla="*/ 2714626 h 6886576"/>
              <a:gd name="connsiteX56" fmla="*/ 255568 w 5511704"/>
              <a:gd name="connsiteY56" fmla="*/ 2936081 h 6886576"/>
              <a:gd name="connsiteX57" fmla="*/ 165437 w 5511704"/>
              <a:gd name="connsiteY57" fmla="*/ 2953941 h 6886576"/>
              <a:gd name="connsiteX58" fmla="*/ 697501 w 5511704"/>
              <a:gd name="connsiteY58" fmla="*/ 3343275 h 6886576"/>
              <a:gd name="connsiteX59" fmla="*/ 339884 w 5511704"/>
              <a:gd name="connsiteY59" fmla="*/ 3243263 h 6886576"/>
              <a:gd name="connsiteX60" fmla="*/ 290458 w 5511704"/>
              <a:gd name="connsiteY60" fmla="*/ 3407569 h 6886576"/>
              <a:gd name="connsiteX61" fmla="*/ 459090 w 5511704"/>
              <a:gd name="connsiteY61" fmla="*/ 3554016 h 6886576"/>
              <a:gd name="connsiteX62" fmla="*/ 520147 w 5511704"/>
              <a:gd name="connsiteY62" fmla="*/ 3843338 h 6886576"/>
              <a:gd name="connsiteX63" fmla="*/ 491072 w 5511704"/>
              <a:gd name="connsiteY63" fmla="*/ 4107657 h 6886576"/>
              <a:gd name="connsiteX64" fmla="*/ 418386 w 5511704"/>
              <a:gd name="connsiteY64" fmla="*/ 4189810 h 6886576"/>
              <a:gd name="connsiteX65" fmla="*/ 313718 w 5511704"/>
              <a:gd name="connsiteY65" fmla="*/ 4339829 h 6886576"/>
              <a:gd name="connsiteX66" fmla="*/ 249753 w 5511704"/>
              <a:gd name="connsiteY66" fmla="*/ 4432698 h 6886576"/>
              <a:gd name="connsiteX67" fmla="*/ 25879 w 5511704"/>
              <a:gd name="connsiteY67" fmla="*/ 4396979 h 6886576"/>
              <a:gd name="connsiteX68" fmla="*/ 325347 w 5511704"/>
              <a:gd name="connsiteY68" fmla="*/ 4632722 h 6886576"/>
              <a:gd name="connsiteX69" fmla="*/ 84029 w 5511704"/>
              <a:gd name="connsiteY69" fmla="*/ 4604147 h 6886576"/>
              <a:gd name="connsiteX70" fmla="*/ 5527 w 5511704"/>
              <a:gd name="connsiteY70" fmla="*/ 4622007 h 6886576"/>
              <a:gd name="connsiteX71" fmla="*/ 49139 w 5511704"/>
              <a:gd name="connsiteY71" fmla="*/ 4697016 h 6886576"/>
              <a:gd name="connsiteX72" fmla="*/ 226494 w 5511704"/>
              <a:gd name="connsiteY72" fmla="*/ 4825604 h 6886576"/>
              <a:gd name="connsiteX73" fmla="*/ 592833 w 5511704"/>
              <a:gd name="connsiteY73" fmla="*/ 5175647 h 6886576"/>
              <a:gd name="connsiteX74" fmla="*/ 238123 w 5511704"/>
              <a:gd name="connsiteY74" fmla="*/ 5014913 h 6886576"/>
              <a:gd name="connsiteX75" fmla="*/ 610278 w 5511704"/>
              <a:gd name="connsiteY75" fmla="*/ 5375673 h 6886576"/>
              <a:gd name="connsiteX76" fmla="*/ 691686 w 5511704"/>
              <a:gd name="connsiteY76" fmla="*/ 5497116 h 6886576"/>
              <a:gd name="connsiteX77" fmla="*/ 860319 w 5511704"/>
              <a:gd name="connsiteY77" fmla="*/ 5793582 h 6886576"/>
              <a:gd name="connsiteX78" fmla="*/ 851597 w 5511704"/>
              <a:gd name="connsiteY78" fmla="*/ 5825729 h 6886576"/>
              <a:gd name="connsiteX79" fmla="*/ 659704 w 5511704"/>
              <a:gd name="connsiteY79" fmla="*/ 5779295 h 6886576"/>
              <a:gd name="connsiteX80" fmla="*/ 909746 w 5511704"/>
              <a:gd name="connsiteY80" fmla="*/ 6029326 h 6886576"/>
              <a:gd name="connsiteX81" fmla="*/ 1168509 w 5511704"/>
              <a:gd name="connsiteY81" fmla="*/ 6222207 h 6886576"/>
              <a:gd name="connsiteX82" fmla="*/ 985339 w 5511704"/>
              <a:gd name="connsiteY82" fmla="*/ 6193632 h 6886576"/>
              <a:gd name="connsiteX83" fmla="*/ 732391 w 5511704"/>
              <a:gd name="connsiteY83" fmla="*/ 6082904 h 6886576"/>
              <a:gd name="connsiteX84" fmla="*/ 645167 w 5511704"/>
              <a:gd name="connsiteY84" fmla="*/ 6125766 h 6886576"/>
              <a:gd name="connsiteX85" fmla="*/ 883579 w 5511704"/>
              <a:gd name="connsiteY85" fmla="*/ 6307932 h 6886576"/>
              <a:gd name="connsiteX86" fmla="*/ 1020229 w 5511704"/>
              <a:gd name="connsiteY86" fmla="*/ 6393657 h 6886576"/>
              <a:gd name="connsiteX87" fmla="*/ 1075471 w 5511704"/>
              <a:gd name="connsiteY87" fmla="*/ 6457950 h 6886576"/>
              <a:gd name="connsiteX88" fmla="*/ 1232473 w 5511704"/>
              <a:gd name="connsiteY88" fmla="*/ 6686551 h 6886576"/>
              <a:gd name="connsiteX89" fmla="*/ 1592997 w 5511704"/>
              <a:gd name="connsiteY89" fmla="*/ 6886576 h 6886576"/>
              <a:gd name="connsiteX90" fmla="*/ 5511704 w 5511704"/>
              <a:gd name="connsiteY90" fmla="*/ 6886576 h 68865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Lst>
            <a:rect l="l" t="t" r="r" b="b"/>
            <a:pathLst>
              <a:path w="5511704" h="6886576">
                <a:moveTo>
                  <a:pt x="5511704" y="0"/>
                </a:moveTo>
                <a:lnTo>
                  <a:pt x="1008599" y="0"/>
                </a:lnTo>
                <a:cubicBezTo>
                  <a:pt x="1110360" y="35719"/>
                  <a:pt x="1209214" y="78581"/>
                  <a:pt x="1310975" y="110728"/>
                </a:cubicBezTo>
                <a:cubicBezTo>
                  <a:pt x="1296437" y="146447"/>
                  <a:pt x="1281900" y="139303"/>
                  <a:pt x="1267362" y="135731"/>
                </a:cubicBezTo>
                <a:cubicBezTo>
                  <a:pt x="1180139" y="121445"/>
                  <a:pt x="1090008" y="110728"/>
                  <a:pt x="1005692" y="71437"/>
                </a:cubicBezTo>
                <a:cubicBezTo>
                  <a:pt x="985339" y="64294"/>
                  <a:pt x="962080" y="64294"/>
                  <a:pt x="953358" y="89297"/>
                </a:cubicBezTo>
                <a:cubicBezTo>
                  <a:pt x="938820" y="125016"/>
                  <a:pt x="959172" y="146447"/>
                  <a:pt x="979525" y="164307"/>
                </a:cubicBezTo>
                <a:cubicBezTo>
                  <a:pt x="1014414" y="196453"/>
                  <a:pt x="1055118" y="189310"/>
                  <a:pt x="1092915" y="192882"/>
                </a:cubicBezTo>
                <a:cubicBezTo>
                  <a:pt x="1197583" y="210741"/>
                  <a:pt x="1247011" y="260747"/>
                  <a:pt x="1270270" y="375047"/>
                </a:cubicBezTo>
                <a:cubicBezTo>
                  <a:pt x="1180139" y="328613"/>
                  <a:pt x="1090008" y="385763"/>
                  <a:pt x="1002784" y="353615"/>
                </a:cubicBezTo>
                <a:cubicBezTo>
                  <a:pt x="979525" y="346472"/>
                  <a:pt x="944635" y="357188"/>
                  <a:pt x="956265" y="396479"/>
                </a:cubicBezTo>
                <a:cubicBezTo>
                  <a:pt x="967894" y="432198"/>
                  <a:pt x="1005692" y="460772"/>
                  <a:pt x="938820" y="453629"/>
                </a:cubicBezTo>
                <a:cubicBezTo>
                  <a:pt x="889393" y="450056"/>
                  <a:pt x="874856" y="407194"/>
                  <a:pt x="860319" y="360759"/>
                </a:cubicBezTo>
                <a:cubicBezTo>
                  <a:pt x="848689" y="335757"/>
                  <a:pt x="816707" y="321469"/>
                  <a:pt x="793447" y="335757"/>
                </a:cubicBezTo>
                <a:cubicBezTo>
                  <a:pt x="764373" y="350044"/>
                  <a:pt x="773095" y="389335"/>
                  <a:pt x="773095" y="417910"/>
                </a:cubicBezTo>
                <a:cubicBezTo>
                  <a:pt x="770187" y="471488"/>
                  <a:pt x="793447" y="496491"/>
                  <a:pt x="834151" y="507206"/>
                </a:cubicBezTo>
                <a:cubicBezTo>
                  <a:pt x="883579" y="521494"/>
                  <a:pt x="933005" y="539354"/>
                  <a:pt x="996969" y="560785"/>
                </a:cubicBezTo>
                <a:cubicBezTo>
                  <a:pt x="927190" y="596503"/>
                  <a:pt x="874856" y="589360"/>
                  <a:pt x="822522" y="560785"/>
                </a:cubicBezTo>
                <a:cubicBezTo>
                  <a:pt x="758558" y="528637"/>
                  <a:pt x="674242" y="485775"/>
                  <a:pt x="621908" y="525066"/>
                </a:cubicBezTo>
                <a:cubicBezTo>
                  <a:pt x="543407" y="582216"/>
                  <a:pt x="479443" y="546497"/>
                  <a:pt x="409664" y="535781"/>
                </a:cubicBezTo>
                <a:cubicBezTo>
                  <a:pt x="264290" y="514350"/>
                  <a:pt x="354422" y="482204"/>
                  <a:pt x="209049" y="464344"/>
                </a:cubicBezTo>
                <a:cubicBezTo>
                  <a:pt x="150900" y="457200"/>
                  <a:pt x="89843" y="428625"/>
                  <a:pt x="5527" y="467916"/>
                </a:cubicBezTo>
                <a:cubicBezTo>
                  <a:pt x="386404" y="675085"/>
                  <a:pt x="566666" y="660797"/>
                  <a:pt x="906838" y="914400"/>
                </a:cubicBezTo>
                <a:cubicBezTo>
                  <a:pt x="892301" y="939404"/>
                  <a:pt x="877764" y="928688"/>
                  <a:pt x="863226" y="925116"/>
                </a:cubicBezTo>
                <a:cubicBezTo>
                  <a:pt x="839967" y="921544"/>
                  <a:pt x="810892" y="907256"/>
                  <a:pt x="805077" y="953691"/>
                </a:cubicBezTo>
                <a:cubicBezTo>
                  <a:pt x="802169" y="989410"/>
                  <a:pt x="819615" y="1007269"/>
                  <a:pt x="848689" y="1010841"/>
                </a:cubicBezTo>
                <a:cubicBezTo>
                  <a:pt x="933005" y="1025129"/>
                  <a:pt x="1008599" y="1075135"/>
                  <a:pt x="1084193" y="1117997"/>
                </a:cubicBezTo>
                <a:cubicBezTo>
                  <a:pt x="1119082" y="1135857"/>
                  <a:pt x="1156879" y="1160860"/>
                  <a:pt x="1142342" y="1225153"/>
                </a:cubicBezTo>
                <a:cubicBezTo>
                  <a:pt x="1113268" y="1243013"/>
                  <a:pt x="1092915" y="1218009"/>
                  <a:pt x="1069655" y="1214438"/>
                </a:cubicBezTo>
                <a:cubicBezTo>
                  <a:pt x="1046396" y="1210866"/>
                  <a:pt x="991154" y="1225153"/>
                  <a:pt x="1005692" y="1235869"/>
                </a:cubicBezTo>
                <a:cubicBezTo>
                  <a:pt x="1072563" y="1275159"/>
                  <a:pt x="950450" y="1371600"/>
                  <a:pt x="1031858" y="1371600"/>
                </a:cubicBezTo>
                <a:cubicBezTo>
                  <a:pt x="1165601" y="1371600"/>
                  <a:pt x="1238288" y="1543050"/>
                  <a:pt x="1366216" y="1546622"/>
                </a:cubicBezTo>
                <a:cubicBezTo>
                  <a:pt x="1386568" y="1546622"/>
                  <a:pt x="1395290" y="1578770"/>
                  <a:pt x="1395290" y="1603772"/>
                </a:cubicBezTo>
                <a:cubicBezTo>
                  <a:pt x="1395290" y="1635920"/>
                  <a:pt x="1374939" y="1639491"/>
                  <a:pt x="1354586" y="1643063"/>
                </a:cubicBezTo>
                <a:cubicBezTo>
                  <a:pt x="1322604" y="1646635"/>
                  <a:pt x="1287715" y="1603772"/>
                  <a:pt x="1247011" y="1664494"/>
                </a:cubicBezTo>
                <a:cubicBezTo>
                  <a:pt x="1322604" y="1700213"/>
                  <a:pt x="1401105" y="1735932"/>
                  <a:pt x="1398198" y="1857375"/>
                </a:cubicBezTo>
                <a:cubicBezTo>
                  <a:pt x="1398198" y="1889523"/>
                  <a:pt x="1430180" y="1903810"/>
                  <a:pt x="1453440" y="1910954"/>
                </a:cubicBezTo>
                <a:cubicBezTo>
                  <a:pt x="1494144" y="1925241"/>
                  <a:pt x="1526126" y="1946673"/>
                  <a:pt x="1549386" y="1993106"/>
                </a:cubicBezTo>
                <a:cubicBezTo>
                  <a:pt x="1549386" y="2003822"/>
                  <a:pt x="1549386" y="2010966"/>
                  <a:pt x="1549386" y="2021681"/>
                </a:cubicBezTo>
                <a:cubicBezTo>
                  <a:pt x="1543571" y="2132410"/>
                  <a:pt x="1485422" y="2128838"/>
                  <a:pt x="1421458" y="2110978"/>
                </a:cubicBezTo>
                <a:cubicBezTo>
                  <a:pt x="1345864" y="2089547"/>
                  <a:pt x="1270270" y="2046685"/>
                  <a:pt x="1188861" y="2085976"/>
                </a:cubicBezTo>
                <a:cubicBezTo>
                  <a:pt x="1302252" y="2139554"/>
                  <a:pt x="1427272" y="2143126"/>
                  <a:pt x="1531941" y="2218135"/>
                </a:cubicBezTo>
                <a:cubicBezTo>
                  <a:pt x="1142342" y="2232422"/>
                  <a:pt x="799262" y="1993106"/>
                  <a:pt x="421293" y="1900238"/>
                </a:cubicBezTo>
                <a:cubicBezTo>
                  <a:pt x="432923" y="1960960"/>
                  <a:pt x="464905" y="1975247"/>
                  <a:pt x="491072" y="1982391"/>
                </a:cubicBezTo>
                <a:cubicBezTo>
                  <a:pt x="630630" y="2028825"/>
                  <a:pt x="752743" y="2121695"/>
                  <a:pt x="880671" y="2200276"/>
                </a:cubicBezTo>
                <a:cubicBezTo>
                  <a:pt x="933005" y="2232422"/>
                  <a:pt x="970802" y="2268142"/>
                  <a:pt x="991154" y="2336007"/>
                </a:cubicBezTo>
                <a:cubicBezTo>
                  <a:pt x="1008599" y="2400300"/>
                  <a:pt x="1043489" y="2428875"/>
                  <a:pt x="1107453" y="2411016"/>
                </a:cubicBezTo>
                <a:cubicBezTo>
                  <a:pt x="1159787" y="2396729"/>
                  <a:pt x="1215029" y="2403873"/>
                  <a:pt x="1270270" y="2411016"/>
                </a:cubicBezTo>
                <a:cubicBezTo>
                  <a:pt x="1331326" y="2418160"/>
                  <a:pt x="1401105" y="2489597"/>
                  <a:pt x="1386568" y="2528889"/>
                </a:cubicBezTo>
                <a:cubicBezTo>
                  <a:pt x="1357494" y="2593182"/>
                  <a:pt x="1308067" y="2561035"/>
                  <a:pt x="1267362" y="2553891"/>
                </a:cubicBezTo>
                <a:cubicBezTo>
                  <a:pt x="1217936" y="2546748"/>
                  <a:pt x="1127805" y="2528889"/>
                  <a:pt x="1127805" y="2536032"/>
                </a:cubicBezTo>
                <a:cubicBezTo>
                  <a:pt x="1095822" y="2696766"/>
                  <a:pt x="1023136" y="2575322"/>
                  <a:pt x="970802" y="2575322"/>
                </a:cubicBezTo>
                <a:cubicBezTo>
                  <a:pt x="921375" y="2575322"/>
                  <a:pt x="871949" y="2557463"/>
                  <a:pt x="825429" y="2543176"/>
                </a:cubicBezTo>
                <a:cubicBezTo>
                  <a:pt x="764373" y="2525316"/>
                  <a:pt x="709132" y="2557463"/>
                  <a:pt x="650982" y="2564607"/>
                </a:cubicBezTo>
                <a:cubicBezTo>
                  <a:pt x="598648" y="2571751"/>
                  <a:pt x="627722" y="2664620"/>
                  <a:pt x="595740" y="2703909"/>
                </a:cubicBezTo>
                <a:cubicBezTo>
                  <a:pt x="589926" y="2714626"/>
                  <a:pt x="584111" y="2714626"/>
                  <a:pt x="578296" y="2714626"/>
                </a:cubicBezTo>
                <a:cubicBezTo>
                  <a:pt x="560851" y="2993232"/>
                  <a:pt x="255568" y="2925366"/>
                  <a:pt x="255568" y="2936081"/>
                </a:cubicBezTo>
                <a:cubicBezTo>
                  <a:pt x="229401" y="2953941"/>
                  <a:pt x="197419" y="2911079"/>
                  <a:pt x="165437" y="2953941"/>
                </a:cubicBezTo>
                <a:cubicBezTo>
                  <a:pt x="302087" y="3150394"/>
                  <a:pt x="511425" y="3196828"/>
                  <a:pt x="697501" y="3343275"/>
                </a:cubicBezTo>
                <a:cubicBezTo>
                  <a:pt x="543407" y="3393282"/>
                  <a:pt x="453275" y="3221832"/>
                  <a:pt x="339884" y="3243263"/>
                </a:cubicBezTo>
                <a:cubicBezTo>
                  <a:pt x="284643" y="3296842"/>
                  <a:pt x="450368" y="3382566"/>
                  <a:pt x="290458" y="3407569"/>
                </a:cubicBezTo>
                <a:cubicBezTo>
                  <a:pt x="360236" y="3454004"/>
                  <a:pt x="409664" y="3500439"/>
                  <a:pt x="459090" y="3554016"/>
                </a:cubicBezTo>
                <a:cubicBezTo>
                  <a:pt x="543407" y="3650457"/>
                  <a:pt x="560851" y="3714751"/>
                  <a:pt x="520147" y="3843338"/>
                </a:cubicBezTo>
                <a:cubicBezTo>
                  <a:pt x="493979" y="3929063"/>
                  <a:pt x="456183" y="4007645"/>
                  <a:pt x="491072" y="4107657"/>
                </a:cubicBezTo>
                <a:cubicBezTo>
                  <a:pt x="514332" y="4175522"/>
                  <a:pt x="505609" y="4221957"/>
                  <a:pt x="418386" y="4189810"/>
                </a:cubicBezTo>
                <a:cubicBezTo>
                  <a:pt x="325347" y="4157663"/>
                  <a:pt x="290458" y="4218386"/>
                  <a:pt x="313718" y="4339829"/>
                </a:cubicBezTo>
                <a:cubicBezTo>
                  <a:pt x="328254" y="4418410"/>
                  <a:pt x="313718" y="4443413"/>
                  <a:pt x="249753" y="4432698"/>
                </a:cubicBezTo>
                <a:cubicBezTo>
                  <a:pt x="179975" y="4421982"/>
                  <a:pt x="113103" y="4371976"/>
                  <a:pt x="25879" y="4396979"/>
                </a:cubicBezTo>
                <a:cubicBezTo>
                  <a:pt x="95658" y="4539854"/>
                  <a:pt x="243939" y="4496991"/>
                  <a:pt x="325347" y="4632722"/>
                </a:cubicBezTo>
                <a:cubicBezTo>
                  <a:pt x="229401" y="4632722"/>
                  <a:pt x="153807" y="4632722"/>
                  <a:pt x="84029" y="4604147"/>
                </a:cubicBezTo>
                <a:cubicBezTo>
                  <a:pt x="54954" y="4593433"/>
                  <a:pt x="22972" y="4579145"/>
                  <a:pt x="5527" y="4622007"/>
                </a:cubicBezTo>
                <a:cubicBezTo>
                  <a:pt x="-14826" y="4672014"/>
                  <a:pt x="25879" y="4689872"/>
                  <a:pt x="49139" y="4697016"/>
                </a:cubicBezTo>
                <a:cubicBezTo>
                  <a:pt x="116011" y="4722019"/>
                  <a:pt x="168344" y="4779170"/>
                  <a:pt x="226494" y="4825604"/>
                </a:cubicBezTo>
                <a:cubicBezTo>
                  <a:pt x="351514" y="4925616"/>
                  <a:pt x="488165" y="5011341"/>
                  <a:pt x="592833" y="5175647"/>
                </a:cubicBezTo>
                <a:cubicBezTo>
                  <a:pt x="461997" y="5132785"/>
                  <a:pt x="363144" y="5032772"/>
                  <a:pt x="238123" y="5014913"/>
                </a:cubicBezTo>
                <a:cubicBezTo>
                  <a:pt x="345700" y="5164932"/>
                  <a:pt x="482350" y="5264944"/>
                  <a:pt x="610278" y="5375673"/>
                </a:cubicBezTo>
                <a:cubicBezTo>
                  <a:pt x="648075" y="5407819"/>
                  <a:pt x="685872" y="5429250"/>
                  <a:pt x="691686" y="5497116"/>
                </a:cubicBezTo>
                <a:cubicBezTo>
                  <a:pt x="709132" y="5629276"/>
                  <a:pt x="755650" y="5736432"/>
                  <a:pt x="860319" y="5793582"/>
                </a:cubicBezTo>
                <a:cubicBezTo>
                  <a:pt x="860319" y="5793582"/>
                  <a:pt x="854504" y="5815013"/>
                  <a:pt x="851597" y="5825729"/>
                </a:cubicBezTo>
                <a:cubicBezTo>
                  <a:pt x="787632" y="5829301"/>
                  <a:pt x="738206" y="5750720"/>
                  <a:pt x="659704" y="5779295"/>
                </a:cubicBezTo>
                <a:cubicBezTo>
                  <a:pt x="738206" y="5886451"/>
                  <a:pt x="802169" y="5979319"/>
                  <a:pt x="909746" y="6029326"/>
                </a:cubicBezTo>
                <a:cubicBezTo>
                  <a:pt x="996969" y="6068616"/>
                  <a:pt x="1104545" y="6093620"/>
                  <a:pt x="1168509" y="6222207"/>
                </a:cubicBezTo>
                <a:cubicBezTo>
                  <a:pt x="1095822" y="6247210"/>
                  <a:pt x="1040581" y="6215063"/>
                  <a:pt x="985339" y="6193632"/>
                </a:cubicBezTo>
                <a:cubicBezTo>
                  <a:pt x="901023" y="6157913"/>
                  <a:pt x="816707" y="6118623"/>
                  <a:pt x="732391" y="6082904"/>
                </a:cubicBezTo>
                <a:cubicBezTo>
                  <a:pt x="700408" y="6068616"/>
                  <a:pt x="665519" y="6061472"/>
                  <a:pt x="645167" y="6125766"/>
                </a:cubicBezTo>
                <a:cubicBezTo>
                  <a:pt x="752743" y="6140053"/>
                  <a:pt x="816707" y="6225779"/>
                  <a:pt x="883579" y="6307932"/>
                </a:cubicBezTo>
                <a:cubicBezTo>
                  <a:pt x="921375" y="6354366"/>
                  <a:pt x="953358" y="6415088"/>
                  <a:pt x="1020229" y="6393657"/>
                </a:cubicBezTo>
                <a:cubicBezTo>
                  <a:pt x="1055118" y="6382942"/>
                  <a:pt x="1078378" y="6415088"/>
                  <a:pt x="1075471" y="6457950"/>
                </a:cubicBezTo>
                <a:cubicBezTo>
                  <a:pt x="1060933" y="6607970"/>
                  <a:pt x="1145250" y="6657976"/>
                  <a:pt x="1232473" y="6686551"/>
                </a:cubicBezTo>
                <a:cubicBezTo>
                  <a:pt x="1360401" y="6729413"/>
                  <a:pt x="1473792" y="6815138"/>
                  <a:pt x="1592997" y="6886576"/>
                </a:cubicBezTo>
                <a:lnTo>
                  <a:pt x="5511704" y="6886576"/>
                </a:lnTo>
                <a:close/>
              </a:path>
            </a:pathLst>
          </a:custGeom>
          <a:solidFill>
            <a:schemeClr val="accent1"/>
          </a:solidFill>
          <a:ln w="32707" cap="flat">
            <a:noFill/>
            <a:prstDash val="solid"/>
            <a:miter/>
          </a:ln>
        </p:spPr>
        <p:txBody>
          <a:bodyPr rtlCol="0" anchor="ctr"/>
          <a:lstStyle/>
          <a:p>
            <a:endParaRPr lang="en-US" dirty="0"/>
          </a:p>
        </p:txBody>
      </p:sp>
      <p:sp>
        <p:nvSpPr>
          <p:cNvPr id="2" name="Title 1">
            <a:extLst>
              <a:ext uri="{FF2B5EF4-FFF2-40B4-BE49-F238E27FC236}">
                <a16:creationId xmlns:a16="http://schemas.microsoft.com/office/drawing/2014/main" id="{F3AFC17F-A47A-A7D8-8D33-F2DC13DD4EA6}"/>
              </a:ext>
            </a:extLst>
          </p:cNvPr>
          <p:cNvSpPr>
            <a:spLocks noGrp="1"/>
          </p:cNvSpPr>
          <p:nvPr>
            <p:ph type="title"/>
          </p:nvPr>
        </p:nvSpPr>
        <p:spPr>
          <a:xfrm>
            <a:off x="838200" y="713312"/>
            <a:ext cx="3461084" cy="5431376"/>
          </a:xfrm>
        </p:spPr>
        <p:txBody>
          <a:bodyPr>
            <a:normAutofit/>
          </a:bodyPr>
          <a:lstStyle/>
          <a:p>
            <a:r>
              <a:rPr lang="en-US" b="1" dirty="0">
                <a:solidFill>
                  <a:srgbClr val="FFFFFF"/>
                </a:solidFill>
              </a:rPr>
              <a:t>Instructions:</a:t>
            </a:r>
            <a:br>
              <a:rPr lang="en-US" b="1" dirty="0">
                <a:solidFill>
                  <a:srgbClr val="FFFFFF"/>
                </a:solidFill>
              </a:rPr>
            </a:br>
            <a:r>
              <a:rPr lang="en-US" b="1" dirty="0">
                <a:solidFill>
                  <a:srgbClr val="FFC000"/>
                </a:solidFill>
              </a:rPr>
              <a:t>“I used to think, now I think and now I will….”</a:t>
            </a:r>
          </a:p>
        </p:txBody>
      </p:sp>
      <p:sp>
        <p:nvSpPr>
          <p:cNvPr id="3" name="Content Placeholder 2">
            <a:extLst>
              <a:ext uri="{FF2B5EF4-FFF2-40B4-BE49-F238E27FC236}">
                <a16:creationId xmlns:a16="http://schemas.microsoft.com/office/drawing/2014/main" id="{A5736F61-91AC-32AF-15B4-6D9043A6376B}"/>
              </a:ext>
            </a:extLst>
          </p:cNvPr>
          <p:cNvSpPr>
            <a:spLocks noGrp="1"/>
          </p:cNvSpPr>
          <p:nvPr>
            <p:ph idx="1"/>
          </p:nvPr>
        </p:nvSpPr>
        <p:spPr>
          <a:xfrm>
            <a:off x="5511705" y="536448"/>
            <a:ext cx="6388924" cy="6108192"/>
          </a:xfrm>
        </p:spPr>
        <p:txBody>
          <a:bodyPr anchor="ctr">
            <a:noAutofit/>
          </a:bodyPr>
          <a:lstStyle/>
          <a:p>
            <a:pPr>
              <a:spcBef>
                <a:spcPts val="0"/>
              </a:spcBef>
            </a:pPr>
            <a:r>
              <a:rPr lang="en-US" sz="2700" kern="100" dirty="0">
                <a:effectLst/>
                <a:latin typeface="Calibri" panose="020F0502020204030204" pitchFamily="34" charset="0"/>
                <a:ea typeface="Aptos" panose="020B0004020202020204" pitchFamily="34" charset="0"/>
                <a:cs typeface="Calibri" panose="020F0502020204030204" pitchFamily="34" charset="0"/>
              </a:rPr>
              <a:t>Following this, each group will reflect on the questions in the file given to you (25 minutes).</a:t>
            </a:r>
          </a:p>
          <a:p>
            <a:pPr>
              <a:spcBef>
                <a:spcPts val="0"/>
              </a:spcBef>
            </a:pPr>
            <a:endParaRPr lang="en-US" sz="2700" kern="100" dirty="0">
              <a:effectLst/>
              <a:latin typeface="Calibri" panose="020F0502020204030204" pitchFamily="34" charset="0"/>
              <a:ea typeface="Aptos" panose="020B0004020202020204" pitchFamily="34" charset="0"/>
              <a:cs typeface="Calibri" panose="020F0502020204030204" pitchFamily="34" charset="0"/>
            </a:endParaRPr>
          </a:p>
          <a:p>
            <a:pPr>
              <a:spcBef>
                <a:spcPts val="0"/>
              </a:spcBef>
            </a:pPr>
            <a:r>
              <a:rPr lang="en-US" sz="2700" kern="100" dirty="0">
                <a:effectLst/>
                <a:latin typeface="Calibri" panose="020F0502020204030204" pitchFamily="34" charset="0"/>
                <a:ea typeface="Aptos" panose="020B0004020202020204" pitchFamily="34" charset="0"/>
                <a:cs typeface="Calibri" panose="020F0502020204030204" pitchFamily="34" charset="0"/>
              </a:rPr>
              <a:t>This debriefing will be facilitated by the faculty. </a:t>
            </a:r>
          </a:p>
          <a:p>
            <a:pPr>
              <a:spcBef>
                <a:spcPts val="0"/>
              </a:spcBef>
            </a:pPr>
            <a:endParaRPr lang="en-US" sz="2700" kern="100" dirty="0">
              <a:effectLst/>
              <a:latin typeface="Calibri" panose="020F0502020204030204" pitchFamily="34" charset="0"/>
              <a:ea typeface="Aptos" panose="020B0004020202020204" pitchFamily="34" charset="0"/>
              <a:cs typeface="Calibri" panose="020F0502020204030204" pitchFamily="34" charset="0"/>
            </a:endParaRPr>
          </a:p>
          <a:p>
            <a:pPr>
              <a:spcBef>
                <a:spcPts val="0"/>
              </a:spcBef>
            </a:pPr>
            <a:r>
              <a:rPr lang="en-US" sz="2700" kern="100" dirty="0">
                <a:effectLst/>
                <a:latin typeface="Calibri" panose="020F0502020204030204" pitchFamily="34" charset="0"/>
                <a:ea typeface="Aptos" panose="020B0004020202020204" pitchFamily="34" charset="0"/>
                <a:cs typeface="Calibri" panose="020F0502020204030204" pitchFamily="34" charset="0"/>
              </a:rPr>
              <a:t>At the end of reflection, all students will fill in the online reflection form</a:t>
            </a:r>
          </a:p>
          <a:p>
            <a:pPr marL="0" indent="0">
              <a:spcBef>
                <a:spcPts val="0"/>
              </a:spcBef>
              <a:buNone/>
            </a:pPr>
            <a:r>
              <a:rPr lang="en-US" sz="2700" kern="100" dirty="0">
                <a:effectLst/>
                <a:latin typeface="Calibri" panose="020F0502020204030204" pitchFamily="34" charset="0"/>
                <a:ea typeface="Aptos" panose="020B0004020202020204" pitchFamily="34" charset="0"/>
                <a:cs typeface="Calibri" panose="020F0502020204030204" pitchFamily="34" charset="0"/>
              </a:rPr>
              <a:t> </a:t>
            </a:r>
          </a:p>
          <a:p>
            <a:pPr>
              <a:spcBef>
                <a:spcPts val="0"/>
              </a:spcBef>
            </a:pPr>
            <a:r>
              <a:rPr lang="en-US" sz="2700" kern="100" dirty="0">
                <a:effectLst/>
                <a:latin typeface="Calibri" panose="020F0502020204030204" pitchFamily="34" charset="0"/>
                <a:ea typeface="Aptos" panose="020B0004020202020204" pitchFamily="34" charset="0"/>
                <a:cs typeface="Calibri" panose="020F0502020204030204" pitchFamily="34" charset="0"/>
              </a:rPr>
              <a:t>The online form is the “</a:t>
            </a:r>
            <a:r>
              <a:rPr lang="en-US" sz="2700" b="1" kern="100" dirty="0">
                <a:effectLst/>
                <a:latin typeface="Calibri" panose="020F0502020204030204" pitchFamily="34" charset="0"/>
                <a:ea typeface="Aptos" panose="020B0004020202020204" pitchFamily="34" charset="0"/>
                <a:cs typeface="Calibri" panose="020F0502020204030204" pitchFamily="34" charset="0"/>
              </a:rPr>
              <a:t>I used to think, now I think and now I will…</a:t>
            </a:r>
            <a:r>
              <a:rPr lang="en-US" sz="2700" kern="100" dirty="0">
                <a:effectLst/>
                <a:latin typeface="Calibri" panose="020F0502020204030204" pitchFamily="34" charset="0"/>
                <a:ea typeface="Aptos" panose="020B0004020202020204" pitchFamily="34" charset="0"/>
                <a:cs typeface="Calibri" panose="020F0502020204030204" pitchFamily="34" charset="0"/>
              </a:rPr>
              <a:t>.” type of reflection. </a:t>
            </a:r>
          </a:p>
        </p:txBody>
      </p:sp>
    </p:spTree>
    <p:extLst>
      <p:ext uri="{BB962C8B-B14F-4D97-AF65-F5344CB8AC3E}">
        <p14:creationId xmlns:p14="http://schemas.microsoft.com/office/powerpoint/2010/main" val="1697015427"/>
      </p:ext>
    </p:extLst>
  </p:cSld>
  <p:clrMapOvr>
    <a:masterClrMapping/>
  </p:clrMapOvr>
</p:sld>
</file>

<file path=ppt/theme/theme1.xml><?xml version="1.0" encoding="utf-8"?>
<a:theme xmlns:a="http://schemas.openxmlformats.org/drawingml/2006/main" name="BrushVTI">
  <a:themeElements>
    <a:clrScheme name="Custom 17">
      <a:dk1>
        <a:sysClr val="windowText" lastClr="000000"/>
      </a:dk1>
      <a:lt1>
        <a:sysClr val="window" lastClr="FFFFFF"/>
      </a:lt1>
      <a:dk2>
        <a:srgbClr val="57495C"/>
      </a:dk2>
      <a:lt2>
        <a:srgbClr val="E7E6E6"/>
      </a:lt2>
      <a:accent1>
        <a:srgbClr val="F07C98"/>
      </a:accent1>
      <a:accent2>
        <a:srgbClr val="A6778D"/>
      </a:accent2>
      <a:accent3>
        <a:srgbClr val="768BA6"/>
      </a:accent3>
      <a:accent4>
        <a:srgbClr val="E8908B"/>
      </a:accent4>
      <a:accent5>
        <a:srgbClr val="C47A93"/>
      </a:accent5>
      <a:accent6>
        <a:srgbClr val="70A8DB"/>
      </a:accent6>
      <a:hlink>
        <a:srgbClr val="EB8067"/>
      </a:hlink>
      <a:folHlink>
        <a:srgbClr val="7BC7C0"/>
      </a:folHlink>
    </a:clrScheme>
    <a:fontScheme name="Custom 3">
      <a:majorFont>
        <a:latin typeface="Century Gothic"/>
        <a:ea typeface=""/>
        <a:cs typeface=""/>
      </a:majorFont>
      <a:minorFont>
        <a:latin typeface="Century Gothic"/>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BrushVTI" id="{7102FA3A-9D7B-4497-8C4B-FB535AAFDE06}" vid="{C6D41F62-6FAB-440A-BEC7-CB7BF190811F}"/>
    </a:ext>
  </a:extLst>
</a:theme>
</file>

<file path=ppt/theme/theme2.xml><?xml version="1.0" encoding="utf-8"?>
<a:theme xmlns:a="http://schemas.openxmlformats.org/drawingml/2006/main" name="1_BrushVTI">
  <a:themeElements>
    <a:clrScheme name="Custom 17">
      <a:dk1>
        <a:sysClr val="windowText" lastClr="000000"/>
      </a:dk1>
      <a:lt1>
        <a:sysClr val="window" lastClr="FFFFFF"/>
      </a:lt1>
      <a:dk2>
        <a:srgbClr val="57495C"/>
      </a:dk2>
      <a:lt2>
        <a:srgbClr val="E7E6E6"/>
      </a:lt2>
      <a:accent1>
        <a:srgbClr val="F07C98"/>
      </a:accent1>
      <a:accent2>
        <a:srgbClr val="A6778D"/>
      </a:accent2>
      <a:accent3>
        <a:srgbClr val="768BA6"/>
      </a:accent3>
      <a:accent4>
        <a:srgbClr val="E8908B"/>
      </a:accent4>
      <a:accent5>
        <a:srgbClr val="C47A93"/>
      </a:accent5>
      <a:accent6>
        <a:srgbClr val="70A8DB"/>
      </a:accent6>
      <a:hlink>
        <a:srgbClr val="EB8067"/>
      </a:hlink>
      <a:folHlink>
        <a:srgbClr val="7BC7C0"/>
      </a:folHlink>
    </a:clrScheme>
    <a:fontScheme name="Custom 3">
      <a:majorFont>
        <a:latin typeface="Century Gothic"/>
        <a:ea typeface=""/>
        <a:cs typeface=""/>
      </a:majorFont>
      <a:minorFont>
        <a:latin typeface="Century Gothic"/>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BrushVTI" id="{7102FA3A-9D7B-4497-8C4B-FB535AAFDE06}" vid="{C6D41F62-6FAB-440A-BEC7-CB7BF190811F}"/>
    </a:ext>
  </a:extLst>
</a:theme>
</file>

<file path=ppt/theme/theme3.xml><?xml version="1.0" encoding="utf-8"?>
<a:theme xmlns:a="http://schemas.openxmlformats.org/drawingml/2006/main" name="2_BrushVTI">
  <a:themeElements>
    <a:clrScheme name="Custom 17">
      <a:dk1>
        <a:sysClr val="windowText" lastClr="000000"/>
      </a:dk1>
      <a:lt1>
        <a:sysClr val="window" lastClr="FFFFFF"/>
      </a:lt1>
      <a:dk2>
        <a:srgbClr val="57495C"/>
      </a:dk2>
      <a:lt2>
        <a:srgbClr val="E7E6E6"/>
      </a:lt2>
      <a:accent1>
        <a:srgbClr val="F07C98"/>
      </a:accent1>
      <a:accent2>
        <a:srgbClr val="A6778D"/>
      </a:accent2>
      <a:accent3>
        <a:srgbClr val="768BA6"/>
      </a:accent3>
      <a:accent4>
        <a:srgbClr val="E8908B"/>
      </a:accent4>
      <a:accent5>
        <a:srgbClr val="C47A93"/>
      </a:accent5>
      <a:accent6>
        <a:srgbClr val="70A8DB"/>
      </a:accent6>
      <a:hlink>
        <a:srgbClr val="EB8067"/>
      </a:hlink>
      <a:folHlink>
        <a:srgbClr val="7BC7C0"/>
      </a:folHlink>
    </a:clrScheme>
    <a:fontScheme name="Custom 3">
      <a:majorFont>
        <a:latin typeface="Century Gothic"/>
        <a:ea typeface=""/>
        <a:cs typeface=""/>
      </a:majorFont>
      <a:minorFont>
        <a:latin typeface="Century Gothic"/>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BrushVTI" id="{7102FA3A-9D7B-4497-8C4B-FB535AAFDE06}" vid="{C6D41F62-6FAB-440A-BEC7-CB7BF190811F}"/>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670</TotalTime>
  <Words>2786</Words>
  <Application>Microsoft Macintosh PowerPoint</Application>
  <PresentationFormat>Widescreen</PresentationFormat>
  <Paragraphs>218</Paragraphs>
  <Slides>35</Slides>
  <Notes>35</Notes>
  <HiddenSlides>0</HiddenSlides>
  <MMClips>0</MMClips>
  <ScaleCrop>false</ScaleCrop>
  <HeadingPairs>
    <vt:vector size="6" baseType="variant">
      <vt:variant>
        <vt:lpstr>Fonts Used</vt:lpstr>
      </vt:variant>
      <vt:variant>
        <vt:i4>6</vt:i4>
      </vt:variant>
      <vt:variant>
        <vt:lpstr>Theme</vt:lpstr>
      </vt:variant>
      <vt:variant>
        <vt:i4>3</vt:i4>
      </vt:variant>
      <vt:variant>
        <vt:lpstr>Slide Titles</vt:lpstr>
      </vt:variant>
      <vt:variant>
        <vt:i4>35</vt:i4>
      </vt:variant>
    </vt:vector>
  </HeadingPairs>
  <TitlesOfParts>
    <vt:vector size="44" baseType="lpstr">
      <vt:lpstr>Aptos</vt:lpstr>
      <vt:lpstr>Arial</vt:lpstr>
      <vt:lpstr>Calibri</vt:lpstr>
      <vt:lpstr>Century Gothic</vt:lpstr>
      <vt:lpstr>Inter</vt:lpstr>
      <vt:lpstr>Times New Roman</vt:lpstr>
      <vt:lpstr>BrushVTI</vt:lpstr>
      <vt:lpstr>1_BrushVTI</vt:lpstr>
      <vt:lpstr>2_BrushVTI</vt:lpstr>
      <vt:lpstr>Art-Based Learning (ABL) for Early Clinical Exposure in Biochemistry </vt:lpstr>
      <vt:lpstr>Learning Objectives</vt:lpstr>
      <vt:lpstr>Instructions</vt:lpstr>
      <vt:lpstr>Instructions</vt:lpstr>
      <vt:lpstr>Instructions: VTS</vt:lpstr>
      <vt:lpstr>Instructions: Structured peer roleplay</vt:lpstr>
      <vt:lpstr>Instructions: Structured peer roleplay</vt:lpstr>
      <vt:lpstr>Instructions: Structured peer roleplay</vt:lpstr>
      <vt:lpstr>Instructions: “I used to think, now I think and now I will….”</vt:lpstr>
      <vt:lpstr>Instructions: “Session Feedback &amp; Confidence”</vt:lpstr>
      <vt:lpstr>Instructions: “Plenary Session”</vt:lpstr>
      <vt:lpstr>Visual Thinking Strategies (VTS)</vt:lpstr>
      <vt:lpstr>PowerPoint Presentation</vt:lpstr>
      <vt:lpstr>1.  What's going on in this picture? </vt:lpstr>
      <vt:lpstr>2.  What do you see that makes you say…? </vt:lpstr>
      <vt:lpstr>3.  What more can we find? </vt:lpstr>
      <vt:lpstr>Visual Thinking Strategies</vt:lpstr>
      <vt:lpstr>“DISEASE &amp; SUFFERING” – FROM THE EYES OF A PATIENT &amp; CAREGIVER </vt:lpstr>
      <vt:lpstr>ART 1</vt:lpstr>
      <vt:lpstr>ART 2</vt:lpstr>
      <vt:lpstr>ART 3</vt:lpstr>
      <vt:lpstr>ART 4</vt:lpstr>
      <vt:lpstr>ART 5</vt:lpstr>
      <vt:lpstr>ART 6</vt:lpstr>
      <vt:lpstr>ART 7</vt:lpstr>
      <vt:lpstr>ART 8</vt:lpstr>
      <vt:lpstr>ART 9</vt:lpstr>
      <vt:lpstr>ART 10</vt:lpstr>
      <vt:lpstr>ART 11</vt:lpstr>
      <vt:lpstr>ART 12</vt:lpstr>
      <vt:lpstr>ART 13</vt:lpstr>
      <vt:lpstr>ART 14</vt:lpstr>
      <vt:lpstr>ART 15</vt:lpstr>
      <vt:lpstr>Learning Objectives</vt:lpstr>
      <vt:lpstr>Thank you</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arly Clinical Exposure</dc:title>
  <dc:creator>DR. SKM</dc:creator>
  <cp:lastModifiedBy>Dr. SKM</cp:lastModifiedBy>
  <cp:revision>31</cp:revision>
  <dcterms:created xsi:type="dcterms:W3CDTF">2025-04-09T09:03:36Z</dcterms:created>
  <dcterms:modified xsi:type="dcterms:W3CDTF">2026-03-27T15:22:15Z</dcterms:modified>
</cp:coreProperties>
</file>